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1.xml" ContentType="application/vnd.openxmlformats-officedocument.drawingml.chartshapes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drawings/drawing2.xml" ContentType="application/vnd.openxmlformats-officedocument.drawingml.chartshapes+xml"/>
  <Override PartName="/ppt/charts/chart8.xml" ContentType="application/vnd.openxmlformats-officedocument.drawingml.chart+xml"/>
  <Override PartName="/ppt/drawings/drawing3.xml" ContentType="application/vnd.openxmlformats-officedocument.drawingml.chartshapes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chart45.xml" ContentType="application/vnd.openxmlformats-officedocument.drawingml.chart+xml"/>
  <Override PartName="/ppt/charts/chart46.xml" ContentType="application/vnd.openxmlformats-officedocument.drawingml.chart+xml"/>
  <Override PartName="/ppt/charts/chart47.xml" ContentType="application/vnd.openxmlformats-officedocument.drawingml.chart+xml"/>
  <Override PartName="/ppt/charts/chart48.xml" ContentType="application/vnd.openxmlformats-officedocument.drawingml.chart+xml"/>
  <Override PartName="/ppt/charts/chart49.xml" ContentType="application/vnd.openxmlformats-officedocument.drawingml.chart+xml"/>
  <Override PartName="/ppt/charts/chart50.xml" ContentType="application/vnd.openxmlformats-officedocument.drawingml.chart+xml"/>
  <Override PartName="/ppt/charts/chart51.xml" ContentType="application/vnd.openxmlformats-officedocument.drawingml.chart+xml"/>
  <Override PartName="/ppt/charts/chart52.xml" ContentType="application/vnd.openxmlformats-officedocument.drawingml.chart+xml"/>
  <Override PartName="/ppt/charts/chart53.xml" ContentType="application/vnd.openxmlformats-officedocument.drawingml.chart+xml"/>
  <Override PartName="/ppt/charts/chart54.xml" ContentType="application/vnd.openxmlformats-officedocument.drawingml.chart+xml"/>
  <Override PartName="/ppt/charts/chart55.xml" ContentType="application/vnd.openxmlformats-officedocument.drawingml.chart+xml"/>
  <Override PartName="/ppt/charts/chart56.xml" ContentType="application/vnd.openxmlformats-officedocument.drawingml.chart+xml"/>
  <Override PartName="/ppt/charts/chart57.xml" ContentType="application/vnd.openxmlformats-officedocument.drawingml.chart+xml"/>
  <Override PartName="/ppt/charts/chart58.xml" ContentType="application/vnd.openxmlformats-officedocument.drawingml.chart+xml"/>
  <Override PartName="/ppt/charts/chart59.xml" ContentType="application/vnd.openxmlformats-officedocument.drawingml.chart+xml"/>
  <Override PartName="/ppt/charts/chart60.xml" ContentType="application/vnd.openxmlformats-officedocument.drawingml.chart+xml"/>
  <Override PartName="/ppt/charts/chart61.xml" ContentType="application/vnd.openxmlformats-officedocument.drawingml.chart+xml"/>
  <Override PartName="/ppt/charts/chart62.xml" ContentType="application/vnd.openxmlformats-officedocument.drawingml.chart+xml"/>
  <Override PartName="/ppt/charts/chart63.xml" ContentType="application/vnd.openxmlformats-officedocument.drawingml.chart+xml"/>
  <Override PartName="/ppt/charts/chart64.xml" ContentType="application/vnd.openxmlformats-officedocument.drawingml.chart+xml"/>
  <Override PartName="/ppt/charts/chart65.xml" ContentType="application/vnd.openxmlformats-officedocument.drawingml.chart+xml"/>
  <Override PartName="/ppt/charts/chart66.xml" ContentType="application/vnd.openxmlformats-officedocument.drawingml.chart+xml"/>
  <Override PartName="/ppt/charts/chart67.xml" ContentType="application/vnd.openxmlformats-officedocument.drawingml.chart+xml"/>
  <Override PartName="/ppt/charts/chart68.xml" ContentType="application/vnd.openxmlformats-officedocument.drawingml.chart+xml"/>
  <Override PartName="/ppt/charts/chart69.xml" ContentType="application/vnd.openxmlformats-officedocument.drawingml.chart+xml"/>
  <Override PartName="/ppt/charts/chart70.xml" ContentType="application/vnd.openxmlformats-officedocument.drawingml.chart+xml"/>
  <Override PartName="/ppt/charts/chart71.xml" ContentType="application/vnd.openxmlformats-officedocument.drawingml.chart+xml"/>
  <Override PartName="/ppt/charts/chart72.xml" ContentType="application/vnd.openxmlformats-officedocument.drawingml.chart+xml"/>
  <Override PartName="/ppt/charts/chart73.xml" ContentType="application/vnd.openxmlformats-officedocument.drawingml.chart+xml"/>
  <Override PartName="/ppt/charts/chart74.xml" ContentType="application/vnd.openxmlformats-officedocument.drawingml.chart+xml"/>
  <Override PartName="/ppt/charts/chart75.xml" ContentType="application/vnd.openxmlformats-officedocument.drawingml.chart+xml"/>
  <Override PartName="/ppt/charts/chart76.xml" ContentType="application/vnd.openxmlformats-officedocument.drawingml.chart+xml"/>
  <Override PartName="/ppt/charts/chart77.xml" ContentType="application/vnd.openxmlformats-officedocument.drawingml.chart+xml"/>
  <Override PartName="/ppt/charts/chart78.xml" ContentType="application/vnd.openxmlformats-officedocument.drawingml.chart+xml"/>
  <Override PartName="/ppt/charts/chart79.xml" ContentType="application/vnd.openxmlformats-officedocument.drawingml.chart+xml"/>
  <Override PartName="/ppt/charts/chart80.xml" ContentType="application/vnd.openxmlformats-officedocument.drawingml.chart+xml"/>
  <Override PartName="/ppt/charts/chart81.xml" ContentType="application/vnd.openxmlformats-officedocument.drawingml.chart+xml"/>
  <Override PartName="/ppt/charts/chart82.xml" ContentType="application/vnd.openxmlformats-officedocument.drawingml.chart+xml"/>
  <Override PartName="/ppt/charts/chart83.xml" ContentType="application/vnd.openxmlformats-officedocument.drawingml.chart+xml"/>
  <Override PartName="/ppt/charts/chart84.xml" ContentType="application/vnd.openxmlformats-officedocument.drawingml.chart+xml"/>
  <Override PartName="/ppt/charts/chart85.xml" ContentType="application/vnd.openxmlformats-officedocument.drawingml.chart+xml"/>
  <Override PartName="/ppt/charts/chart86.xml" ContentType="application/vnd.openxmlformats-officedocument.drawingml.chart+xml"/>
  <Override PartName="/ppt/charts/chart87.xml" ContentType="application/vnd.openxmlformats-officedocument.drawingml.chart+xml"/>
  <Override PartName="/ppt/charts/chart88.xml" ContentType="application/vnd.openxmlformats-officedocument.drawingml.chart+xml"/>
  <Override PartName="/ppt/charts/chart89.xml" ContentType="application/vnd.openxmlformats-officedocument.drawingml.chart+xml"/>
  <Override PartName="/ppt/charts/chart90.xml" ContentType="application/vnd.openxmlformats-officedocument.drawingml.chart+xml"/>
  <Override PartName="/ppt/charts/chart91.xml" ContentType="application/vnd.openxmlformats-officedocument.drawingml.chart+xml"/>
  <Override PartName="/ppt/charts/chart92.xml" ContentType="application/vnd.openxmlformats-officedocument.drawingml.chart+xml"/>
  <Override PartName="/ppt/charts/chart93.xml" ContentType="application/vnd.openxmlformats-officedocument.drawingml.chart+xml"/>
  <Override PartName="/ppt/charts/chart94.xml" ContentType="application/vnd.openxmlformats-officedocument.drawingml.chart+xml"/>
  <Override PartName="/ppt/charts/chart95.xml" ContentType="application/vnd.openxmlformats-officedocument.drawingml.chart+xml"/>
  <Override PartName="/ppt/charts/chart96.xml" ContentType="application/vnd.openxmlformats-officedocument.drawingml.chart+xml"/>
  <Override PartName="/ppt/charts/chart97.xml" ContentType="application/vnd.openxmlformats-officedocument.drawingml.chart+xml"/>
  <Override PartName="/ppt/charts/chart98.xml" ContentType="application/vnd.openxmlformats-officedocument.drawingml.chart+xml"/>
  <Override PartName="/ppt/charts/chart99.xml" ContentType="application/vnd.openxmlformats-officedocument.drawingml.chart+xml"/>
  <Override PartName="/ppt/charts/chart100.xml" ContentType="application/vnd.openxmlformats-officedocument.drawingml.chart+xml"/>
  <Override PartName="/ppt/notesSlides/notesSlide1.xml" ContentType="application/vnd.openxmlformats-officedocument.presentationml.notesSlide+xml"/>
  <Override PartName="/ppt/charts/chart101.xml" ContentType="application/vnd.openxmlformats-officedocument.drawingml.chart+xml"/>
  <Override PartName="/ppt/charts/chart102.xml" ContentType="application/vnd.openxmlformats-officedocument.drawingml.chart+xml"/>
  <Override PartName="/ppt/charts/chart103.xml" ContentType="application/vnd.openxmlformats-officedocument.drawingml.chart+xml"/>
  <Override PartName="/ppt/charts/chart104.xml" ContentType="application/vnd.openxmlformats-officedocument.drawingml.chart+xml"/>
  <Override PartName="/ppt/charts/chart105.xml" ContentType="application/vnd.openxmlformats-officedocument.drawingml.chart+xml"/>
  <Override PartName="/ppt/charts/chart106.xml" ContentType="application/vnd.openxmlformats-officedocument.drawingml.chart+xml"/>
  <Override PartName="/ppt/charts/chart107.xml" ContentType="application/vnd.openxmlformats-officedocument.drawingml.chart+xml"/>
  <Override PartName="/ppt/charts/chart108.xml" ContentType="application/vnd.openxmlformats-officedocument.drawingml.chart+xml"/>
  <Override PartName="/ppt/charts/chart109.xml" ContentType="application/vnd.openxmlformats-officedocument.drawingml.chart+xml"/>
  <Override PartName="/ppt/charts/chart110.xml" ContentType="application/vnd.openxmlformats-officedocument.drawingml.chart+xml"/>
  <Override PartName="/ppt/charts/chart111.xml" ContentType="application/vnd.openxmlformats-officedocument.drawingml.chart+xml"/>
  <Override PartName="/ppt/charts/chart112.xml" ContentType="application/vnd.openxmlformats-officedocument.drawingml.chart+xml"/>
  <Override PartName="/ppt/charts/chart113.xml" ContentType="application/vnd.openxmlformats-officedocument.drawingml.chart+xml"/>
  <Override PartName="/ppt/charts/chart114.xml" ContentType="application/vnd.openxmlformats-officedocument.drawingml.chart+xml"/>
  <Override PartName="/ppt/charts/chart115.xml" ContentType="application/vnd.openxmlformats-officedocument.drawingml.chart+xml"/>
  <Override PartName="/ppt/charts/chart116.xml" ContentType="application/vnd.openxmlformats-officedocument.drawingml.chart+xml"/>
  <Override PartName="/ppt/charts/chart117.xml" ContentType="application/vnd.openxmlformats-officedocument.drawingml.chart+xml"/>
  <Override PartName="/ppt/charts/chart118.xml" ContentType="application/vnd.openxmlformats-officedocument.drawingml.chart+xml"/>
  <Override PartName="/ppt/charts/chart119.xml" ContentType="application/vnd.openxmlformats-officedocument.drawingml.chart+xml"/>
  <Override PartName="/ppt/charts/chart120.xml" ContentType="application/vnd.openxmlformats-officedocument.drawingml.chart+xml"/>
  <Override PartName="/ppt/notesSlides/notesSlide2.xml" ContentType="application/vnd.openxmlformats-officedocument.presentationml.notesSlide+xml"/>
  <Override PartName="/ppt/charts/chart121.xml" ContentType="application/vnd.openxmlformats-officedocument.drawingml.chart+xml"/>
  <Override PartName="/ppt/charts/chart122.xml" ContentType="application/vnd.openxmlformats-officedocument.drawingml.chart+xml"/>
  <Override PartName="/ppt/charts/chart123.xml" ContentType="application/vnd.openxmlformats-officedocument.drawingml.chart+xml"/>
  <Override PartName="/ppt/charts/chart124.xml" ContentType="application/vnd.openxmlformats-officedocument.drawingml.chart+xml"/>
  <Override PartName="/ppt/charts/chart125.xml" ContentType="application/vnd.openxmlformats-officedocument.drawingml.chart+xml"/>
  <Override PartName="/ppt/charts/chart126.xml" ContentType="application/vnd.openxmlformats-officedocument.drawingml.chart+xml"/>
  <Override PartName="/ppt/charts/chart127.xml" ContentType="application/vnd.openxmlformats-officedocument.drawingml.chart+xml"/>
  <Override PartName="/ppt/charts/chart128.xml" ContentType="application/vnd.openxmlformats-officedocument.drawingml.chart+xml"/>
  <Override PartName="/ppt/charts/chart129.xml" ContentType="application/vnd.openxmlformats-officedocument.drawingml.chart+xml"/>
  <Override PartName="/ppt/charts/chart130.xml" ContentType="application/vnd.openxmlformats-officedocument.drawingml.chart+xml"/>
  <Override PartName="/ppt/charts/chart131.xml" ContentType="application/vnd.openxmlformats-officedocument.drawingml.chart+xml"/>
  <Override PartName="/ppt/charts/chart132.xml" ContentType="application/vnd.openxmlformats-officedocument.drawingml.chart+xml"/>
  <Override PartName="/ppt/charts/chart133.xml" ContentType="application/vnd.openxmlformats-officedocument.drawingml.chart+xml"/>
  <Override PartName="/ppt/charts/chart134.xml" ContentType="application/vnd.openxmlformats-officedocument.drawingml.chart+xml"/>
  <Override PartName="/ppt/charts/chart135.xml" ContentType="application/vnd.openxmlformats-officedocument.drawingml.chart+xml"/>
  <Override PartName="/ppt/charts/chart136.xml" ContentType="application/vnd.openxmlformats-officedocument.drawingml.chart+xml"/>
  <Override PartName="/ppt/charts/chart137.xml" ContentType="application/vnd.openxmlformats-officedocument.drawingml.chart+xml"/>
  <Override PartName="/ppt/charts/chart13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sldIdLst>
    <p:sldId id="312" r:id="rId2"/>
    <p:sldId id="313" r:id="rId3"/>
    <p:sldId id="288" r:id="rId4"/>
    <p:sldId id="311" r:id="rId5"/>
    <p:sldId id="305" r:id="rId6"/>
    <p:sldId id="307" r:id="rId7"/>
    <p:sldId id="306" r:id="rId8"/>
    <p:sldId id="295" r:id="rId9"/>
    <p:sldId id="298" r:id="rId10"/>
    <p:sldId id="296" r:id="rId11"/>
    <p:sldId id="297" r:id="rId12"/>
    <p:sldId id="300" r:id="rId13"/>
    <p:sldId id="301" r:id="rId14"/>
    <p:sldId id="303" r:id="rId15"/>
    <p:sldId id="302" r:id="rId16"/>
    <p:sldId id="304" r:id="rId17"/>
  </p:sldIdLst>
  <p:sldSz cx="43205400" cy="32404050"/>
  <p:notesSz cx="6858000" cy="9144000"/>
  <p:defaultTextStyle>
    <a:defPPr>
      <a:defRPr lang="ko-KR"/>
    </a:defPPr>
    <a:lvl1pPr marL="0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1pPr>
    <a:lvl2pPr marL="2159859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2pPr>
    <a:lvl3pPr marL="4319718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3pPr>
    <a:lvl4pPr marL="6479577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4pPr>
    <a:lvl5pPr marL="8639440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5pPr>
    <a:lvl6pPr marL="10799299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6pPr>
    <a:lvl7pPr marL="12959158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7pPr>
    <a:lvl8pPr marL="15119017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8pPr>
    <a:lvl9pPr marL="17278876" algn="l" defTabSz="4319718" rtl="0" eaLnBrk="1" latinLnBrk="1" hangingPunct="1">
      <a:defRPr sz="8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6">
          <p15:clr>
            <a:srgbClr val="A4A3A4"/>
          </p15:clr>
        </p15:guide>
        <p15:guide id="2" pos="1360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밝은 스타일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0150" autoAdjust="0"/>
  </p:normalViewPr>
  <p:slideViewPr>
    <p:cSldViewPr>
      <p:cViewPr>
        <p:scale>
          <a:sx n="24" d="100"/>
          <a:sy n="24" d="100"/>
        </p:scale>
        <p:origin x="-1536" y="-72"/>
      </p:cViewPr>
      <p:guideLst>
        <p:guide orient="horz" pos="10206"/>
        <p:guide pos="1360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" d="100"/>
        <a:sy n="2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10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RVE4c.xlsx" TargetMode="External"/></Relationships>
</file>

<file path=ppt/charts/_rels/chart10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RVE8a.xlsx" TargetMode="External"/></Relationships>
</file>

<file path=ppt/charts/_rels/chart10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RVE8a.xlsx" TargetMode="External"/></Relationships>
</file>

<file path=ppt/charts/_rels/chart10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RVE8b.xlsx" TargetMode="External"/></Relationships>
</file>

<file path=ppt/charts/_rels/chart10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RVE8b.xlsx" TargetMode="External"/></Relationships>
</file>

<file path=ppt/charts/_rels/chart10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LKP2a.xlsx" TargetMode="External"/></Relationships>
</file>

<file path=ppt/charts/_rels/chart10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LKP2a.xlsx" TargetMode="External"/></Relationships>
</file>

<file path=ppt/charts/_rels/chart10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UXb.xlsx" TargetMode="External"/></Relationships>
</file>

<file path=ppt/charts/_rels/chart10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UXb.xlsx" TargetMode="External"/></Relationships>
</file>

<file path=ppt/charts/_rels/chart10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UXa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11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UXa.xlsx" TargetMode="External"/></Relationships>
</file>

<file path=ppt/charts/_rels/chart11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LKP2c.xlsx" TargetMode="External"/></Relationships>
</file>

<file path=ppt/charts/_rels/chart11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LKP2c.xlsx" TargetMode="External"/></Relationships>
</file>

<file path=ppt/charts/_rels/chart11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LHYa.xlsx" TargetMode="External"/></Relationships>
</file>

<file path=ppt/charts/_rels/chart11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LHYa.xlsx" TargetMode="External"/></Relationships>
</file>

<file path=ppt/charts/_rels/chart11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LHYb.xlsx" TargetMode="External"/></Relationships>
</file>

<file path=ppt/charts/_rels/chart11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LHYb.xlsx" TargetMode="External"/></Relationships>
</file>

<file path=ppt/charts/_rels/chart11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CA1.xlsx" TargetMode="External"/></Relationships>
</file>

<file path=ppt/charts/_rels/chart11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CA1.xlsx" TargetMode="External"/></Relationships>
</file>

<file path=ppt/charts/_rels/chart11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KP2b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12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KP2b.xlsx" TargetMode="External"/></Relationships>
</file>

<file path=ppt/charts/_rels/chart12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1a.xlsx" TargetMode="External"/></Relationships>
</file>

<file path=ppt/charts/_rels/chart12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1a.xlsx" TargetMode="External"/></Relationships>
</file>

<file path=ppt/charts/_rels/chart12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1b.xlsx" TargetMode="External"/></Relationships>
</file>

<file path=ppt/charts/_rels/chart12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1b.xlsx" TargetMode="External"/></Relationships>
</file>

<file path=ppt/charts/_rels/chart12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3a.xlsx" TargetMode="External"/></Relationships>
</file>

<file path=ppt/charts/_rels/chart12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3a.xlsx" TargetMode="External"/></Relationships>
</file>

<file path=ppt/charts/_rels/chart12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5a.xlsx" TargetMode="External"/></Relationships>
</file>

<file path=ppt/charts/_rels/chart12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5a.xlsx" TargetMode="External"/></Relationships>
</file>

<file path=ppt/charts/_rels/chart12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5b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13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5b.xlsx" TargetMode="External"/></Relationships>
</file>

<file path=ppt/charts/_rels/chart13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5c.xlsx" TargetMode="External"/></Relationships>
</file>

<file path=ppt/charts/_rels/chart13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5c.xlsx" TargetMode="External"/></Relationships>
</file>

<file path=ppt/charts/_rels/chart13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7a.xlsx" TargetMode="External"/></Relationships>
</file>

<file path=ppt/charts/_rels/chart13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7a.xlsx" TargetMode="External"/></Relationships>
</file>

<file path=ppt/charts/_rels/chart13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7b.xlsx" TargetMode="External"/></Relationships>
</file>

<file path=ppt/charts/_rels/chart13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7b.xlsx" TargetMode="External"/></Relationships>
</file>

<file path=ppt/charts/_rels/chart13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9a.xlsx" TargetMode="External"/></Relationships>
</file>

<file path=ppt/charts/_rels/chart13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RR9a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ELF3a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GI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PIF3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CRY2a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CRY1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phyB1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PHYAa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L:\QRT%20&#54588;&#48307;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RVE8a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RVE4a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ELF4a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UXa.xlsx" TargetMode="External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KP2a.xlsx" TargetMode="External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LHYa.xlsx" TargetMode="External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4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CCA1.xlsx" TargetMode="External"/></Relationships>
</file>

<file path=ppt/charts/_rels/chart4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BrPRR.xlsx" TargetMode="External"/></Relationships>
</file>

<file path=ppt/charts/_rels/chart49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50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5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5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5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5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5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5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5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5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5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PRR3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6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PRR9a.xlsx" TargetMode="External"/></Relationships>
</file>

<file path=ppt/charts/_rels/chart6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PRR7a.xlsx" TargetMode="External"/></Relationships>
</file>

<file path=ppt/charts/_rels/chart6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qRTresult\PRR5a.xlsx" TargetMode="External"/></Relationships>
</file>

<file path=ppt/charts/_rels/chart6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HYAa.xlsx" TargetMode="External"/></Relationships>
</file>

<file path=ppt/charts/_rels/chart6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HYAa.xlsx" TargetMode="External"/></Relationships>
</file>

<file path=ppt/charts/_rels/chart6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hyAb.xlsx" TargetMode="External"/></Relationships>
</file>

<file path=ppt/charts/_rels/chart6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hyAb.xlsx" TargetMode="External"/></Relationships>
</file>

<file path=ppt/charts/_rels/chart6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hyB1.xlsx" TargetMode="External"/></Relationships>
</file>

<file path=ppt/charts/_rels/chart6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hyB1.xlsx" TargetMode="External"/></Relationships>
</file>

<file path=ppt/charts/_rels/chart6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hyB2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7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hyB2.xlsx" TargetMode="External"/></Relationships>
</file>

<file path=ppt/charts/_rels/chart7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RY1.xlsx" TargetMode="External"/></Relationships>
</file>

<file path=ppt/charts/_rels/chart7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RY1.xlsx" TargetMode="External"/></Relationships>
</file>

<file path=ppt/charts/_rels/chart7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RY2a.xlsx" TargetMode="External"/></Relationships>
</file>

<file path=ppt/charts/_rels/chart7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RY2a.xlsx" TargetMode="External"/></Relationships>
</file>

<file path=ppt/charts/_rels/chart7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RY2b.xlsx" TargetMode="External"/></Relationships>
</file>

<file path=ppt/charts/_rels/chart7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RY2b.xlsx" TargetMode="External"/></Relationships>
</file>

<file path=ppt/charts/_rels/chart7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OP1b.xlsx" TargetMode="External"/></Relationships>
</file>

<file path=ppt/charts/_rels/chart7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COP1b.xlsx" TargetMode="External"/></Relationships>
</file>

<file path=ppt/charts/_rels/chart7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IF3a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D:\WORK\New\Circadian\RNAseq\paper\RNAseq%20paper\Brassica_circadian_manuscript\Brapa_circadian_normalized_FPKM.xlsx" TargetMode="External"/></Relationships>
</file>

<file path=ppt/charts/_rels/chart8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IF3a.xlsx" TargetMode="External"/></Relationships>
</file>

<file path=ppt/charts/_rels/chart81.xml.rels><?xml version="1.0" encoding="UTF-8" standalone="yes"?>
<Relationships xmlns="http://schemas.openxmlformats.org/package/2006/relationships"><Relationship Id="rId1" Type="http://schemas.openxmlformats.org/officeDocument/2006/relationships/oleObject" Target="file:///L:\QRT%20&#54588;&#48307;.xlsx" TargetMode="External"/></Relationships>
</file>

<file path=ppt/charts/_rels/chart82.xml.rels><?xml version="1.0" encoding="UTF-8" standalone="yes"?>
<Relationships xmlns="http://schemas.openxmlformats.org/package/2006/relationships"><Relationship Id="rId1" Type="http://schemas.openxmlformats.org/officeDocument/2006/relationships/oleObject" Target="file:///L:\QRT%20&#54588;&#48307;.xlsx" TargetMode="External"/></Relationships>
</file>

<file path=ppt/charts/_rels/chart8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IF3b-1.xlsx" TargetMode="External"/></Relationships>
</file>

<file path=ppt/charts/_rels/chart8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PIF3b-1.xlsx" TargetMode="External"/></Relationships>
</file>

<file path=ppt/charts/_rels/chart8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GI.xlsx" TargetMode="External"/></Relationships>
</file>

<file path=ppt/charts/_rels/chart8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GI.xlsx" TargetMode="External"/></Relationships>
</file>

<file path=ppt/charts/_rels/chart8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3a.xlsx" TargetMode="External"/></Relationships>
</file>

<file path=ppt/charts/_rels/chart8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3a.xlsx" TargetMode="External"/></Relationships>
</file>

<file path=ppt/charts/_rels/chart8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3b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AT_circadian_microarray.xlsx" TargetMode="External"/></Relationships>
</file>

<file path=ppt/charts/_rels/chart9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3b.xlsx" TargetMode="External"/></Relationships>
</file>

<file path=ppt/charts/_rels/chart9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4a.xlsx" TargetMode="External"/></Relationships>
</file>

<file path=ppt/charts/_rels/chart9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4a.xlsx" TargetMode="External"/></Relationships>
</file>

<file path=ppt/charts/_rels/chart9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4b.xlsx" TargetMode="External"/></Relationships>
</file>

<file path=ppt/charts/_rels/chart9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4b.xlsx" TargetMode="External"/></Relationships>
</file>

<file path=ppt/charts/_rels/chart9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4c.xlsx" TargetMode="External"/></Relationships>
</file>

<file path=ppt/charts/_rels/chart9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ELF4c.xlsx" TargetMode="External"/></Relationships>
</file>

<file path=ppt/charts/_rels/chart9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RVE4a.xlsx" TargetMode="External"/></Relationships>
</file>

<file path=ppt/charts/_rels/chart9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RVE4a.xlsx" TargetMode="External"/></Relationships>
</file>

<file path=ppt/charts/_rels/chart9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WORK\New\Circadian\RNAseq\paper\RNAseq%20paper\&#45936;&#51060;&#53552;&#48516;&#49437;\RVE4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PHYA ;At1g09570</a:t>
            </a:r>
          </a:p>
        </c:rich>
      </c:tx>
      <c:layout>
        <c:manualLayout>
          <c:xMode val="edge"/>
          <c:yMode val="edge"/>
          <c:x val="0.24581664962396471"/>
          <c:y val="5.499687609381524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60921348875072"/>
          <c:y val="5.3218997172357244E-2"/>
          <c:w val="0.76073165906735984"/>
          <c:h val="0.7854788834693396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2:$B$2</c:f>
              <c:strCache>
                <c:ptCount val="1"/>
                <c:pt idx="0">
                  <c:v>PHYA At1g0957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2:$V$2</c:f>
                <c:numCache>
                  <c:formatCode>General</c:formatCode>
                  <c:ptCount val="6"/>
                  <c:pt idx="0">
                    <c:v>2.1508688470218952E-2</c:v>
                  </c:pt>
                  <c:pt idx="1">
                    <c:v>8.9605459903554341E-2</c:v>
                  </c:pt>
                  <c:pt idx="2">
                    <c:v>0.19625863364979629</c:v>
                  </c:pt>
                  <c:pt idx="3">
                    <c:v>6.2794890400199352E-2</c:v>
                  </c:pt>
                  <c:pt idx="4">
                    <c:v>0.21059271703526972</c:v>
                  </c:pt>
                  <c:pt idx="5">
                    <c:v>7.0492055602188131E-2</c:v>
                  </c:pt>
                </c:numCache>
              </c:numRef>
            </c:plus>
            <c:minus>
              <c:numRef>
                <c:f>Sheet4!$Q$2:$V$2</c:f>
                <c:numCache>
                  <c:formatCode>General</c:formatCode>
                  <c:ptCount val="6"/>
                  <c:pt idx="0">
                    <c:v>2.1508688470218952E-2</c:v>
                  </c:pt>
                  <c:pt idx="1">
                    <c:v>8.9605459903554341E-2</c:v>
                  </c:pt>
                  <c:pt idx="2">
                    <c:v>0.19625863364979629</c:v>
                  </c:pt>
                  <c:pt idx="3">
                    <c:v>6.2794890400199352E-2</c:v>
                  </c:pt>
                  <c:pt idx="4">
                    <c:v>0.21059271703526972</c:v>
                  </c:pt>
                  <c:pt idx="5">
                    <c:v>7.0492055602188131E-2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2:$H$2</c:f>
              <c:numCache>
                <c:formatCode>General</c:formatCode>
                <c:ptCount val="6"/>
                <c:pt idx="0">
                  <c:v>10.12470954</c:v>
                </c:pt>
                <c:pt idx="1">
                  <c:v>9.2568198436666727</c:v>
                </c:pt>
                <c:pt idx="2">
                  <c:v>9.3869527626666667</c:v>
                </c:pt>
                <c:pt idx="3">
                  <c:v>8.7566633986666726</c:v>
                </c:pt>
                <c:pt idx="4">
                  <c:v>9.4306964293333326</c:v>
                </c:pt>
                <c:pt idx="5">
                  <c:v>9.775936048000012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356736"/>
        <c:axId val="216358272"/>
      </c:scatterChart>
      <c:valAx>
        <c:axId val="21635673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16358272"/>
        <c:crosses val="autoZero"/>
        <c:crossBetween val="midCat"/>
        <c:majorUnit val="4"/>
      </c:valAx>
      <c:valAx>
        <c:axId val="216358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1635673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PIF3 ; </a:t>
            </a:r>
            <a:r>
              <a:rPr lang="en-US" dirty="0"/>
              <a:t>At1g09530</a:t>
            </a:r>
          </a:p>
        </c:rich>
      </c:tx>
      <c:layout>
        <c:manualLayout>
          <c:xMode val="edge"/>
          <c:yMode val="edge"/>
          <c:x val="0.26883893981214163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546423674102279"/>
          <c:y val="5.1911637477632513E-2"/>
          <c:w val="0.84075023087102962"/>
          <c:h val="0.7978835684923895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7:$B$7</c:f>
              <c:strCache>
                <c:ptCount val="1"/>
                <c:pt idx="0">
                  <c:v>PIF3 At1g0953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7:$V$7</c:f>
                <c:numCache>
                  <c:formatCode>General</c:formatCode>
                  <c:ptCount val="6"/>
                  <c:pt idx="0">
                    <c:v>0.11925888557167295</c:v>
                  </c:pt>
                  <c:pt idx="1">
                    <c:v>0.37570618793660693</c:v>
                  </c:pt>
                  <c:pt idx="2">
                    <c:v>0.59645989244442965</c:v>
                  </c:pt>
                  <c:pt idx="3">
                    <c:v>1.2169959173745</c:v>
                  </c:pt>
                  <c:pt idx="4">
                    <c:v>0.79126007789207453</c:v>
                  </c:pt>
                  <c:pt idx="5">
                    <c:v>0.88689789188684576</c:v>
                  </c:pt>
                </c:numCache>
              </c:numRef>
            </c:plus>
            <c:minus>
              <c:numRef>
                <c:f>Sheet4!$Q$7:$V$7</c:f>
                <c:numCache>
                  <c:formatCode>General</c:formatCode>
                  <c:ptCount val="6"/>
                  <c:pt idx="0">
                    <c:v>0.11925888557167295</c:v>
                  </c:pt>
                  <c:pt idx="1">
                    <c:v>0.37570618793660693</c:v>
                  </c:pt>
                  <c:pt idx="2">
                    <c:v>0.59645989244442965</c:v>
                  </c:pt>
                  <c:pt idx="3">
                    <c:v>1.2169959173745</c:v>
                  </c:pt>
                  <c:pt idx="4">
                    <c:v>0.79126007789207453</c:v>
                  </c:pt>
                  <c:pt idx="5">
                    <c:v>0.88689789188684576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7:$H$7</c:f>
              <c:numCache>
                <c:formatCode>General</c:formatCode>
                <c:ptCount val="6"/>
                <c:pt idx="0">
                  <c:v>6.2649481250000001</c:v>
                </c:pt>
                <c:pt idx="1">
                  <c:v>6.7821408999999955</c:v>
                </c:pt>
                <c:pt idx="2">
                  <c:v>6.4337687680000064</c:v>
                </c:pt>
                <c:pt idx="3">
                  <c:v>5.8983112356666672</c:v>
                </c:pt>
                <c:pt idx="4">
                  <c:v>5.2943131313333334</c:v>
                </c:pt>
                <c:pt idx="5">
                  <c:v>5.093237926999994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665216"/>
        <c:axId val="250667008"/>
      </c:scatterChart>
      <c:valAx>
        <c:axId val="25066521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667008"/>
        <c:crosses val="autoZero"/>
        <c:crossBetween val="midCat"/>
        <c:majorUnit val="4"/>
      </c:valAx>
      <c:valAx>
        <c:axId val="250667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66521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24:$J$29</c:f>
                <c:numCache>
                  <c:formatCode>General</c:formatCode>
                  <c:ptCount val="6"/>
                  <c:pt idx="0">
                    <c:v>3.8795157704265851E-2</c:v>
                  </c:pt>
                  <c:pt idx="1">
                    <c:v>2.8091152391087281E-4</c:v>
                  </c:pt>
                  <c:pt idx="2">
                    <c:v>4.7888394251792329E-4</c:v>
                  </c:pt>
                  <c:pt idx="3">
                    <c:v>9.6247519067807876E-4</c:v>
                  </c:pt>
                  <c:pt idx="4">
                    <c:v>1.2002820255151826E-3</c:v>
                  </c:pt>
                  <c:pt idx="5">
                    <c:v>2.9977471341248528E-2</c:v>
                  </c:pt>
                </c:numCache>
              </c:numRef>
            </c:plus>
            <c:minus>
              <c:numRef>
                <c:f>Sheet4!$J$24:$J$29</c:f>
                <c:numCache>
                  <c:formatCode>General</c:formatCode>
                  <c:ptCount val="6"/>
                  <c:pt idx="0">
                    <c:v>3.8795157704265851E-2</c:v>
                  </c:pt>
                  <c:pt idx="1">
                    <c:v>2.8091152391087281E-4</c:v>
                  </c:pt>
                  <c:pt idx="2">
                    <c:v>4.7888394251792329E-4</c:v>
                  </c:pt>
                  <c:pt idx="3">
                    <c:v>9.6247519067807876E-4</c:v>
                  </c:pt>
                  <c:pt idx="4">
                    <c:v>1.2002820255151826E-3</c:v>
                  </c:pt>
                  <c:pt idx="5">
                    <c:v>2.9977471341248528E-2</c:v>
                  </c:pt>
                </c:numCache>
              </c:numRef>
            </c:minus>
          </c:errBars>
          <c:xVal>
            <c:numRef>
              <c:f>Sheet4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H$24:$H$29</c:f>
              <c:numCache>
                <c:formatCode>General</c:formatCode>
                <c:ptCount val="6"/>
                <c:pt idx="0">
                  <c:v>0.12712498849272624</c:v>
                </c:pt>
                <c:pt idx="1">
                  <c:v>4.038797082275191E-2</c:v>
                </c:pt>
                <c:pt idx="2">
                  <c:v>1.1327589249198003E-2</c:v>
                </c:pt>
                <c:pt idx="3">
                  <c:v>1.5119759616595523E-2</c:v>
                </c:pt>
                <c:pt idx="4">
                  <c:v>3.7373746738556292E-2</c:v>
                </c:pt>
                <c:pt idx="5">
                  <c:v>0.1669556324957215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011264"/>
        <c:axId val="254012800"/>
      </c:scatterChart>
      <c:valAx>
        <c:axId val="25401126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012800"/>
        <c:crosses val="autoZero"/>
        <c:crossBetween val="midCat"/>
        <c:majorUnit val="4"/>
      </c:valAx>
      <c:valAx>
        <c:axId val="254012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01126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1.7689387954430699E-2</c:v>
                  </c:pt>
                  <c:pt idx="1">
                    <c:v>2.9582493987335991E-3</c:v>
                  </c:pt>
                  <c:pt idx="2">
                    <c:v>1.4181829080002653E-5</c:v>
                  </c:pt>
                  <c:pt idx="3">
                    <c:v>5.4174165078793183E-6</c:v>
                  </c:pt>
                  <c:pt idx="4">
                    <c:v>2.9910157829464218E-4</c:v>
                  </c:pt>
                  <c:pt idx="5">
                    <c:v>8.900599477402904E-3</c:v>
                  </c:pt>
                  <c:pt idx="6">
                    <c:v>1.0743721338983138E-2</c:v>
                  </c:pt>
                  <c:pt idx="7">
                    <c:v>4.9905501328081838E-4</c:v>
                  </c:pt>
                  <c:pt idx="8">
                    <c:v>2.9051257807937935E-5</c:v>
                  </c:pt>
                  <c:pt idx="9">
                    <c:v>2.299088780965821E-5</c:v>
                  </c:pt>
                  <c:pt idx="10">
                    <c:v>7.3015975798408584E-4</c:v>
                  </c:pt>
                  <c:pt idx="11">
                    <c:v>3.4696610745718081E-3</c:v>
                  </c:pt>
                  <c:pt idx="12">
                    <c:v>2.7624886438344641E-3</c:v>
                  </c:pt>
                  <c:pt idx="13">
                    <c:v>4.5967751013850395E-4</c:v>
                  </c:pt>
                  <c:pt idx="14">
                    <c:v>8.3840477689572899E-5</c:v>
                  </c:pt>
                  <c:pt idx="15">
                    <c:v>9.3761331510925454E-5</c:v>
                  </c:pt>
                  <c:pt idx="16">
                    <c:v>6.1398257911805375E-4</c:v>
                  </c:pt>
                  <c:pt idx="17">
                    <c:v>1.3365190779493581E-3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1.7689387954430699E-2</c:v>
                  </c:pt>
                  <c:pt idx="1">
                    <c:v>2.9582493987335991E-3</c:v>
                  </c:pt>
                  <c:pt idx="2">
                    <c:v>1.4181829080002653E-5</c:v>
                  </c:pt>
                  <c:pt idx="3">
                    <c:v>5.4174165078793183E-6</c:v>
                  </c:pt>
                  <c:pt idx="4">
                    <c:v>2.9910157829464218E-4</c:v>
                  </c:pt>
                  <c:pt idx="5">
                    <c:v>8.900599477402904E-3</c:v>
                  </c:pt>
                  <c:pt idx="6">
                    <c:v>1.0743721338983138E-2</c:v>
                  </c:pt>
                  <c:pt idx="7">
                    <c:v>4.9905501328081838E-4</c:v>
                  </c:pt>
                  <c:pt idx="8">
                    <c:v>2.9051257807937935E-5</c:v>
                  </c:pt>
                  <c:pt idx="9">
                    <c:v>2.299088780965821E-5</c:v>
                  </c:pt>
                  <c:pt idx="10">
                    <c:v>7.3015975798408584E-4</c:v>
                  </c:pt>
                  <c:pt idx="11">
                    <c:v>3.4696610745718081E-3</c:v>
                  </c:pt>
                  <c:pt idx="12">
                    <c:v>2.7624886438344641E-3</c:v>
                  </c:pt>
                  <c:pt idx="13">
                    <c:v>4.5967751013850395E-4</c:v>
                  </c:pt>
                  <c:pt idx="14">
                    <c:v>8.3840477689572899E-5</c:v>
                  </c:pt>
                  <c:pt idx="15">
                    <c:v>9.3761331510925454E-5</c:v>
                  </c:pt>
                  <c:pt idx="16">
                    <c:v>6.1398257911805375E-4</c:v>
                  </c:pt>
                  <c:pt idx="17">
                    <c:v>1.3365190779493581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8.9179140231300663E-2</c:v>
                </c:pt>
                <c:pt idx="1">
                  <c:v>1.4470454142849715E-2</c:v>
                </c:pt>
                <c:pt idx="2">
                  <c:v>1.1017003430715901E-4</c:v>
                </c:pt>
                <c:pt idx="3">
                  <c:v>3.0361068462640125E-5</c:v>
                </c:pt>
                <c:pt idx="4">
                  <c:v>1.5920050402378873E-3</c:v>
                </c:pt>
                <c:pt idx="5">
                  <c:v>3.020861818877528E-2</c:v>
                </c:pt>
                <c:pt idx="6">
                  <c:v>4.3203638559072478E-2</c:v>
                </c:pt>
                <c:pt idx="7">
                  <c:v>1.125122080210034E-2</c:v>
                </c:pt>
                <c:pt idx="8">
                  <c:v>7.6553218271417189E-4</c:v>
                </c:pt>
                <c:pt idx="9">
                  <c:v>9.6730626941410737E-5</c:v>
                </c:pt>
                <c:pt idx="10">
                  <c:v>1.7915629427584241E-3</c:v>
                </c:pt>
                <c:pt idx="11">
                  <c:v>1.1570743797988068E-2</c:v>
                </c:pt>
                <c:pt idx="12">
                  <c:v>1.7472373407977762E-2</c:v>
                </c:pt>
                <c:pt idx="13">
                  <c:v>2.6424653536988984E-3</c:v>
                </c:pt>
                <c:pt idx="14">
                  <c:v>5.2311647675597347E-4</c:v>
                </c:pt>
                <c:pt idx="15">
                  <c:v>7.6304910093766146E-4</c:v>
                </c:pt>
                <c:pt idx="16">
                  <c:v>3.3974563228943086E-3</c:v>
                </c:pt>
                <c:pt idx="17">
                  <c:v>7.2375554917357534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931904"/>
        <c:axId val="253933440"/>
      </c:scatterChart>
      <c:valAx>
        <c:axId val="25393190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933440"/>
        <c:crosses val="autoZero"/>
        <c:crossBetween val="midCat"/>
        <c:majorUnit val="4"/>
      </c:valAx>
      <c:valAx>
        <c:axId val="25393344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93190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7.2723164855559921E-2</c:v>
                  </c:pt>
                  <c:pt idx="1">
                    <c:v>2.2130791541460403E-3</c:v>
                  </c:pt>
                  <c:pt idx="2">
                    <c:v>2.0344761022585581E-4</c:v>
                  </c:pt>
                  <c:pt idx="3">
                    <c:v>8.3770961562753262E-6</c:v>
                  </c:pt>
                  <c:pt idx="4">
                    <c:v>3.744178649739367E-5</c:v>
                  </c:pt>
                  <c:pt idx="5">
                    <c:v>1.0358465929719285E-3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7.2723164855559921E-2</c:v>
                  </c:pt>
                  <c:pt idx="1">
                    <c:v>2.2130791541460403E-3</c:v>
                  </c:pt>
                  <c:pt idx="2">
                    <c:v>2.0344761022585581E-4</c:v>
                  </c:pt>
                  <c:pt idx="3">
                    <c:v>8.3770961562753262E-6</c:v>
                  </c:pt>
                  <c:pt idx="4">
                    <c:v>3.744178649739367E-5</c:v>
                  </c:pt>
                  <c:pt idx="5">
                    <c:v>1.0358465929719285E-3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0.22551952835743191</c:v>
                </c:pt>
                <c:pt idx="1">
                  <c:v>1.4627568102359451E-2</c:v>
                </c:pt>
                <c:pt idx="2">
                  <c:v>6.8398009283679418E-4</c:v>
                </c:pt>
                <c:pt idx="3">
                  <c:v>4.7909029960954526E-5</c:v>
                </c:pt>
                <c:pt idx="4">
                  <c:v>2.0403051580360497E-4</c:v>
                </c:pt>
                <c:pt idx="5">
                  <c:v>1.3679257231974754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174720"/>
        <c:axId val="254176256"/>
      </c:scatterChart>
      <c:valAx>
        <c:axId val="25417472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176256"/>
        <c:crosses val="autoZero"/>
        <c:crossBetween val="midCat"/>
        <c:majorUnit val="4"/>
      </c:valAx>
      <c:valAx>
        <c:axId val="254176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17472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5.2899158045151718E-4</c:v>
                  </c:pt>
                  <c:pt idx="1">
                    <c:v>2.1710639931747538E-4</c:v>
                  </c:pt>
                  <c:pt idx="2">
                    <c:v>3.8083961057011425E-6</c:v>
                  </c:pt>
                  <c:pt idx="3">
                    <c:v>1.3352618409943368E-7</c:v>
                  </c:pt>
                  <c:pt idx="4">
                    <c:v>7.3492906781755513E-6</c:v>
                  </c:pt>
                  <c:pt idx="5">
                    <c:v>1.5437382377184947E-4</c:v>
                  </c:pt>
                  <c:pt idx="6">
                    <c:v>1.278330039711538E-4</c:v>
                  </c:pt>
                  <c:pt idx="7">
                    <c:v>3.7209046596314889E-5</c:v>
                  </c:pt>
                  <c:pt idx="8">
                    <c:v>8.1395287442607005E-6</c:v>
                  </c:pt>
                  <c:pt idx="9">
                    <c:v>2.7753846643145627E-7</c:v>
                  </c:pt>
                  <c:pt idx="10">
                    <c:v>8.3087426165325112E-6</c:v>
                  </c:pt>
                  <c:pt idx="11">
                    <c:v>3.3612770116795329E-5</c:v>
                  </c:pt>
                  <c:pt idx="12">
                    <c:v>1.0255202274949755E-4</c:v>
                  </c:pt>
                  <c:pt idx="13">
                    <c:v>1.8783473458024684E-5</c:v>
                  </c:pt>
                  <c:pt idx="14">
                    <c:v>1.702049950088589E-6</c:v>
                  </c:pt>
                  <c:pt idx="15">
                    <c:v>4.721457054984361E-7</c:v>
                  </c:pt>
                  <c:pt idx="16">
                    <c:v>1.4307235729929921E-5</c:v>
                  </c:pt>
                  <c:pt idx="17">
                    <c:v>2.3385063829691411E-5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5.2899158045151718E-4</c:v>
                  </c:pt>
                  <c:pt idx="1">
                    <c:v>2.1710639931747538E-4</c:v>
                  </c:pt>
                  <c:pt idx="2">
                    <c:v>3.8083961057011425E-6</c:v>
                  </c:pt>
                  <c:pt idx="3">
                    <c:v>1.3352618409943368E-7</c:v>
                  </c:pt>
                  <c:pt idx="4">
                    <c:v>7.3492906781755513E-6</c:v>
                  </c:pt>
                  <c:pt idx="5">
                    <c:v>1.5437382377184947E-4</c:v>
                  </c:pt>
                  <c:pt idx="6">
                    <c:v>1.278330039711538E-4</c:v>
                  </c:pt>
                  <c:pt idx="7">
                    <c:v>3.7209046596314889E-5</c:v>
                  </c:pt>
                  <c:pt idx="8">
                    <c:v>8.1395287442607005E-6</c:v>
                  </c:pt>
                  <c:pt idx="9">
                    <c:v>2.7753846643145627E-7</c:v>
                  </c:pt>
                  <c:pt idx="10">
                    <c:v>8.3087426165325112E-6</c:v>
                  </c:pt>
                  <c:pt idx="11">
                    <c:v>3.3612770116795329E-5</c:v>
                  </c:pt>
                  <c:pt idx="12">
                    <c:v>1.0255202274949755E-4</c:v>
                  </c:pt>
                  <c:pt idx="13">
                    <c:v>1.8783473458024684E-5</c:v>
                  </c:pt>
                  <c:pt idx="14">
                    <c:v>1.702049950088589E-6</c:v>
                  </c:pt>
                  <c:pt idx="15">
                    <c:v>4.721457054984361E-7</c:v>
                  </c:pt>
                  <c:pt idx="16">
                    <c:v>1.4307235729929921E-5</c:v>
                  </c:pt>
                  <c:pt idx="17">
                    <c:v>2.3385063829691411E-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2.1253777220985562E-3</c:v>
                </c:pt>
                <c:pt idx="1">
                  <c:v>5.4988682519029031E-4</c:v>
                </c:pt>
                <c:pt idx="2">
                  <c:v>2.4869406575579531E-5</c:v>
                </c:pt>
                <c:pt idx="3">
                  <c:v>1.7100764378679025E-6</c:v>
                </c:pt>
                <c:pt idx="4">
                  <c:v>4.1187956862352384E-5</c:v>
                </c:pt>
                <c:pt idx="5">
                  <c:v>7.6355916919979428E-4</c:v>
                </c:pt>
                <c:pt idx="6">
                  <c:v>1.0056755629071275E-3</c:v>
                </c:pt>
                <c:pt idx="7">
                  <c:v>3.3639160787128067E-4</c:v>
                </c:pt>
                <c:pt idx="8">
                  <c:v>8.6681369465857464E-5</c:v>
                </c:pt>
                <c:pt idx="9">
                  <c:v>1.7389390708248291E-6</c:v>
                </c:pt>
                <c:pt idx="10">
                  <c:v>3.0600279857408879E-5</c:v>
                </c:pt>
                <c:pt idx="11">
                  <c:v>2.4145653302214552E-4</c:v>
                </c:pt>
                <c:pt idx="12">
                  <c:v>1.4871694169785541E-3</c:v>
                </c:pt>
                <c:pt idx="13">
                  <c:v>1.8553643448761386E-4</c:v>
                </c:pt>
                <c:pt idx="14">
                  <c:v>2.1905684491466794E-5</c:v>
                </c:pt>
                <c:pt idx="15">
                  <c:v>1.2017769340251907E-5</c:v>
                </c:pt>
                <c:pt idx="16">
                  <c:v>1.4565242638730247E-4</c:v>
                </c:pt>
                <c:pt idx="17">
                  <c:v>4.5256745246468694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196736"/>
        <c:axId val="254210816"/>
      </c:scatterChart>
      <c:valAx>
        <c:axId val="25419673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210816"/>
        <c:crosses val="autoZero"/>
        <c:crossBetween val="midCat"/>
        <c:majorUnit val="4"/>
      </c:valAx>
      <c:valAx>
        <c:axId val="2542108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19673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1.1386697722574604E-3</c:v>
                  </c:pt>
                  <c:pt idx="1">
                    <c:v>1.4385793727711145E-4</c:v>
                  </c:pt>
                  <c:pt idx="2">
                    <c:v>5.6185437037320214E-6</c:v>
                  </c:pt>
                  <c:pt idx="3">
                    <c:v>1.6141315782663145E-7</c:v>
                  </c:pt>
                  <c:pt idx="4">
                    <c:v>9.8761550269811103E-6</c:v>
                  </c:pt>
                  <c:pt idx="5">
                    <c:v>5.3782029198714702E-5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1.1386697722574604E-3</c:v>
                  </c:pt>
                  <c:pt idx="1">
                    <c:v>1.4385793727711145E-4</c:v>
                  </c:pt>
                  <c:pt idx="2">
                    <c:v>5.6185437037320214E-6</c:v>
                  </c:pt>
                  <c:pt idx="3">
                    <c:v>1.6141315782663145E-7</c:v>
                  </c:pt>
                  <c:pt idx="4">
                    <c:v>9.8761550269811103E-6</c:v>
                  </c:pt>
                  <c:pt idx="5">
                    <c:v>5.3782029198714702E-5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4.0662048324949318E-3</c:v>
                </c:pt>
                <c:pt idx="1">
                  <c:v>7.265533639674443E-4</c:v>
                </c:pt>
                <c:pt idx="2">
                  <c:v>1.8464108544819984E-5</c:v>
                </c:pt>
                <c:pt idx="3">
                  <c:v>1.4671805444630812E-6</c:v>
                </c:pt>
                <c:pt idx="4">
                  <c:v>1.7664310907613794E-5</c:v>
                </c:pt>
                <c:pt idx="5">
                  <c:v>3.3495010934002996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497152"/>
        <c:axId val="254498688"/>
      </c:scatterChart>
      <c:valAx>
        <c:axId val="254497152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498688"/>
        <c:crosses val="autoZero"/>
        <c:crossBetween val="midCat"/>
        <c:majorUnit val="4"/>
      </c:valAx>
      <c:valAx>
        <c:axId val="25449868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49715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5470465229890737E-2"/>
          <c:y val="7.8925210745229221E-2"/>
          <c:w val="0.9226681053703315"/>
          <c:h val="0.71558030842843945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5.6702844677772111E-5</c:v>
                  </c:pt>
                  <c:pt idx="1">
                    <c:v>1.9292812941857881E-5</c:v>
                  </c:pt>
                  <c:pt idx="2">
                    <c:v>2.6652336000807349E-5</c:v>
                  </c:pt>
                  <c:pt idx="3">
                    <c:v>8.2922974142321025E-5</c:v>
                  </c:pt>
                  <c:pt idx="4">
                    <c:v>5.4369447707670019E-6</c:v>
                  </c:pt>
                  <c:pt idx="5">
                    <c:v>9.2255623737555288E-6</c:v>
                  </c:pt>
                  <c:pt idx="6">
                    <c:v>2.7512229286357489E-5</c:v>
                  </c:pt>
                  <c:pt idx="7">
                    <c:v>1.6135277740486606E-5</c:v>
                  </c:pt>
                  <c:pt idx="8">
                    <c:v>5.4587555835786128E-5</c:v>
                  </c:pt>
                  <c:pt idx="9">
                    <c:v>1.2226398477309507E-5</c:v>
                  </c:pt>
                  <c:pt idx="10">
                    <c:v>6.7921765609747138E-5</c:v>
                  </c:pt>
                  <c:pt idx="11">
                    <c:v>1.2108681454642601E-5</c:v>
                  </c:pt>
                  <c:pt idx="12">
                    <c:v>3.5622646257913617E-5</c:v>
                  </c:pt>
                  <c:pt idx="13">
                    <c:v>3.192391636618481E-5</c:v>
                  </c:pt>
                  <c:pt idx="14">
                    <c:v>3.5101192127536159E-5</c:v>
                  </c:pt>
                  <c:pt idx="15">
                    <c:v>8.1987603109898567E-6</c:v>
                  </c:pt>
                  <c:pt idx="16">
                    <c:v>3.1288468373010809E-5</c:v>
                  </c:pt>
                  <c:pt idx="17">
                    <c:v>2.7020953117413507E-5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5.6702844677772111E-5</c:v>
                  </c:pt>
                  <c:pt idx="1">
                    <c:v>1.9292812941857881E-5</c:v>
                  </c:pt>
                  <c:pt idx="2">
                    <c:v>2.6652336000807349E-5</c:v>
                  </c:pt>
                  <c:pt idx="3">
                    <c:v>8.2922974142321025E-5</c:v>
                  </c:pt>
                  <c:pt idx="4">
                    <c:v>5.4369447707670019E-6</c:v>
                  </c:pt>
                  <c:pt idx="5">
                    <c:v>9.2255623737555288E-6</c:v>
                  </c:pt>
                  <c:pt idx="6">
                    <c:v>2.7512229286357489E-5</c:v>
                  </c:pt>
                  <c:pt idx="7">
                    <c:v>1.6135277740486606E-5</c:v>
                  </c:pt>
                  <c:pt idx="8">
                    <c:v>5.4587555835786128E-5</c:v>
                  </c:pt>
                  <c:pt idx="9">
                    <c:v>1.2226398477309507E-5</c:v>
                  </c:pt>
                  <c:pt idx="10">
                    <c:v>6.7921765609747138E-5</c:v>
                  </c:pt>
                  <c:pt idx="11">
                    <c:v>1.2108681454642601E-5</c:v>
                  </c:pt>
                  <c:pt idx="12">
                    <c:v>3.5622646257913617E-5</c:v>
                  </c:pt>
                  <c:pt idx="13">
                    <c:v>3.192391636618481E-5</c:v>
                  </c:pt>
                  <c:pt idx="14">
                    <c:v>3.5101192127536159E-5</c:v>
                  </c:pt>
                  <c:pt idx="15">
                    <c:v>8.1987603109898567E-6</c:v>
                  </c:pt>
                  <c:pt idx="16">
                    <c:v>3.1288468373010809E-5</c:v>
                  </c:pt>
                  <c:pt idx="17">
                    <c:v>2.7020953117413507E-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3.2567726815715324E-4</c:v>
                </c:pt>
                <c:pt idx="1">
                  <c:v>3.376760549636555E-4</c:v>
                </c:pt>
                <c:pt idx="2">
                  <c:v>6.665480028369685E-4</c:v>
                </c:pt>
                <c:pt idx="3">
                  <c:v>4.8355592614159488E-4</c:v>
                </c:pt>
                <c:pt idx="4">
                  <c:v>4.2026093756854504E-4</c:v>
                </c:pt>
                <c:pt idx="5">
                  <c:v>3.8955965398703129E-4</c:v>
                </c:pt>
                <c:pt idx="6">
                  <c:v>4.6246745671987296E-4</c:v>
                </c:pt>
                <c:pt idx="7">
                  <c:v>4.4575838853632891E-4</c:v>
                </c:pt>
                <c:pt idx="8">
                  <c:v>1.1271056226975701E-3</c:v>
                </c:pt>
                <c:pt idx="9">
                  <c:v>2.6041654543537099E-4</c:v>
                </c:pt>
                <c:pt idx="10">
                  <c:v>5.4317329216997082E-4</c:v>
                </c:pt>
                <c:pt idx="11">
                  <c:v>2.7584184004980232E-4</c:v>
                </c:pt>
                <c:pt idx="12">
                  <c:v>9.824103233134953E-4</c:v>
                </c:pt>
                <c:pt idx="13">
                  <c:v>5.05156356645854E-4</c:v>
                </c:pt>
                <c:pt idx="14">
                  <c:v>6.3001145997769264E-4</c:v>
                </c:pt>
                <c:pt idx="15">
                  <c:v>9.8115384802872278E-4</c:v>
                </c:pt>
                <c:pt idx="16">
                  <c:v>8.691367992579869E-4</c:v>
                </c:pt>
                <c:pt idx="17">
                  <c:v>4.5197261286002849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519168"/>
        <c:axId val="254520704"/>
      </c:scatterChart>
      <c:valAx>
        <c:axId val="254519168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520704"/>
        <c:crosses val="autoZero"/>
        <c:crossBetween val="midCat"/>
        <c:majorUnit val="4"/>
      </c:valAx>
      <c:valAx>
        <c:axId val="2545207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51916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893441749366373"/>
          <c:y val="8.0021394227801843E-2"/>
          <c:w val="0.83589452593122726"/>
          <c:h val="0.71163003493439103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1.1504176279513937E-5</c:v>
                  </c:pt>
                  <c:pt idx="1">
                    <c:v>2.7757071545375349E-5</c:v>
                  </c:pt>
                  <c:pt idx="2">
                    <c:v>1.6605456930991102E-5</c:v>
                  </c:pt>
                  <c:pt idx="3">
                    <c:v>3.866309101976992E-5</c:v>
                  </c:pt>
                  <c:pt idx="4">
                    <c:v>1.690241766810942E-5</c:v>
                  </c:pt>
                  <c:pt idx="5">
                    <c:v>9.0899057825662768E-5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1.1504176279513937E-5</c:v>
                  </c:pt>
                  <c:pt idx="1">
                    <c:v>2.7757071545375349E-5</c:v>
                  </c:pt>
                  <c:pt idx="2">
                    <c:v>1.6605456930991102E-5</c:v>
                  </c:pt>
                  <c:pt idx="3">
                    <c:v>3.866309101976992E-5</c:v>
                  </c:pt>
                  <c:pt idx="4">
                    <c:v>1.690241766810942E-5</c:v>
                  </c:pt>
                  <c:pt idx="5">
                    <c:v>9.0899057825662768E-5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3.2553712511602625E-4</c:v>
                </c:pt>
                <c:pt idx="1">
                  <c:v>3.4109347231756884E-4</c:v>
                </c:pt>
                <c:pt idx="2">
                  <c:v>2.9124811502803812E-4</c:v>
                </c:pt>
                <c:pt idx="3">
                  <c:v>3.6108798669469828E-4</c:v>
                </c:pt>
                <c:pt idx="4">
                  <c:v>5.2629853965037226E-4</c:v>
                </c:pt>
                <c:pt idx="5">
                  <c:v>7.1202066138909025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548992"/>
        <c:axId val="254550784"/>
      </c:scatterChart>
      <c:valAx>
        <c:axId val="25454899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550784"/>
        <c:crosses val="autoZero"/>
        <c:crossBetween val="midCat"/>
        <c:majorUnit val="4"/>
      </c:valAx>
      <c:valAx>
        <c:axId val="254550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54899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0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L$24:$L$29</c:f>
                <c:numCache>
                  <c:formatCode>General</c:formatCode>
                  <c:ptCount val="6"/>
                  <c:pt idx="0">
                    <c:v>9.7682338038734094E-5</c:v>
                  </c:pt>
                  <c:pt idx="1">
                    <c:v>6.8109667907996062E-5</c:v>
                  </c:pt>
                  <c:pt idx="2">
                    <c:v>4.8059608352459867E-3</c:v>
                  </c:pt>
                  <c:pt idx="3">
                    <c:v>7.2856055260786335E-3</c:v>
                  </c:pt>
                  <c:pt idx="4">
                    <c:v>6.1356257125303832E-3</c:v>
                  </c:pt>
                  <c:pt idx="5">
                    <c:v>5.2374986958139899E-3</c:v>
                  </c:pt>
                </c:numCache>
              </c:numRef>
            </c:plus>
            <c:minus>
              <c:numRef>
                <c:f>Sheet4!$L$24:$L$29</c:f>
                <c:numCache>
                  <c:formatCode>General</c:formatCode>
                  <c:ptCount val="6"/>
                  <c:pt idx="0">
                    <c:v>9.7682338038734094E-5</c:v>
                  </c:pt>
                  <c:pt idx="1">
                    <c:v>6.8109667907996062E-5</c:v>
                  </c:pt>
                  <c:pt idx="2">
                    <c:v>4.8059608352459867E-3</c:v>
                  </c:pt>
                  <c:pt idx="3">
                    <c:v>7.2856055260786335E-3</c:v>
                  </c:pt>
                  <c:pt idx="4">
                    <c:v>6.1356257125303832E-3</c:v>
                  </c:pt>
                  <c:pt idx="5">
                    <c:v>5.2374986958139899E-3</c:v>
                  </c:pt>
                </c:numCache>
              </c:numRef>
            </c:minus>
          </c:errBars>
          <c:xVal>
            <c:numRef>
              <c:f>Sheet4!$I$24:$I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J$24:$J$29</c:f>
              <c:numCache>
                <c:formatCode>General</c:formatCode>
                <c:ptCount val="6"/>
                <c:pt idx="0">
                  <c:v>2.4365349325640002E-3</c:v>
                </c:pt>
                <c:pt idx="1">
                  <c:v>1.9827134803948017E-3</c:v>
                </c:pt>
                <c:pt idx="2">
                  <c:v>8.4466000042700023E-2</c:v>
                </c:pt>
                <c:pt idx="3">
                  <c:v>0.11030927182108954</c:v>
                </c:pt>
                <c:pt idx="4">
                  <c:v>7.2620936475309414E-2</c:v>
                </c:pt>
                <c:pt idx="5">
                  <c:v>3.7092511791038237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579072"/>
        <c:axId val="254580608"/>
      </c:scatterChart>
      <c:valAx>
        <c:axId val="254579072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580608"/>
        <c:crosses val="autoZero"/>
        <c:crossBetween val="midCat"/>
        <c:majorUnit val="4"/>
      </c:valAx>
      <c:valAx>
        <c:axId val="2545806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57907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L$5:$L$22</c:f>
                <c:numCache>
                  <c:formatCode>General</c:formatCode>
                  <c:ptCount val="18"/>
                  <c:pt idx="0">
                    <c:v>6.1314059011155747E-4</c:v>
                  </c:pt>
                  <c:pt idx="1">
                    <c:v>7.3346427003434078E-4</c:v>
                  </c:pt>
                  <c:pt idx="2">
                    <c:v>4.4113695099489139E-3</c:v>
                  </c:pt>
                  <c:pt idx="3">
                    <c:v>1.0039510057275599E-2</c:v>
                  </c:pt>
                  <c:pt idx="4">
                    <c:v>8.3907729941332609E-4</c:v>
                  </c:pt>
                  <c:pt idx="5">
                    <c:v>1.1550638378105857E-3</c:v>
                  </c:pt>
                  <c:pt idx="6">
                    <c:v>2.322783711007452E-4</c:v>
                  </c:pt>
                  <c:pt idx="7">
                    <c:v>7.6204756543513347E-4</c:v>
                  </c:pt>
                  <c:pt idx="8">
                    <c:v>4.4164415268200139E-3</c:v>
                  </c:pt>
                  <c:pt idx="9">
                    <c:v>1.4485689500880149E-2</c:v>
                  </c:pt>
                  <c:pt idx="10">
                    <c:v>1.5226871834301693E-2</c:v>
                  </c:pt>
                  <c:pt idx="11">
                    <c:v>2.4855457236377552E-3</c:v>
                  </c:pt>
                  <c:pt idx="12">
                    <c:v>6.1744141266033292E-4</c:v>
                  </c:pt>
                  <c:pt idx="13">
                    <c:v>1.6291342710464921E-3</c:v>
                  </c:pt>
                  <c:pt idx="14">
                    <c:v>3.7479979634013855E-3</c:v>
                  </c:pt>
                  <c:pt idx="15">
                    <c:v>3.0356401650298067E-3</c:v>
                  </c:pt>
                  <c:pt idx="16">
                    <c:v>7.8954574061118924E-4</c:v>
                  </c:pt>
                  <c:pt idx="17">
                    <c:v>1.9093028473180995E-3</c:v>
                  </c:pt>
                </c:numCache>
              </c:numRef>
            </c:plus>
            <c:minus>
              <c:numRef>
                <c:f>Sheet4!$L$5:$L$22</c:f>
                <c:numCache>
                  <c:formatCode>General</c:formatCode>
                  <c:ptCount val="18"/>
                  <c:pt idx="0">
                    <c:v>6.1314059011155747E-4</c:v>
                  </c:pt>
                  <c:pt idx="1">
                    <c:v>7.3346427003434078E-4</c:v>
                  </c:pt>
                  <c:pt idx="2">
                    <c:v>4.4113695099489139E-3</c:v>
                  </c:pt>
                  <c:pt idx="3">
                    <c:v>1.0039510057275599E-2</c:v>
                  </c:pt>
                  <c:pt idx="4">
                    <c:v>8.3907729941332609E-4</c:v>
                  </c:pt>
                  <c:pt idx="5">
                    <c:v>1.1550638378105857E-3</c:v>
                  </c:pt>
                  <c:pt idx="6">
                    <c:v>2.322783711007452E-4</c:v>
                  </c:pt>
                  <c:pt idx="7">
                    <c:v>7.6204756543513347E-4</c:v>
                  </c:pt>
                  <c:pt idx="8">
                    <c:v>4.4164415268200139E-3</c:v>
                  </c:pt>
                  <c:pt idx="9">
                    <c:v>1.4485689500880149E-2</c:v>
                  </c:pt>
                  <c:pt idx="10">
                    <c:v>1.5226871834301693E-2</c:v>
                  </c:pt>
                  <c:pt idx="11">
                    <c:v>2.4855457236377552E-3</c:v>
                  </c:pt>
                  <c:pt idx="12">
                    <c:v>6.1744141266033292E-4</c:v>
                  </c:pt>
                  <c:pt idx="13">
                    <c:v>1.6291342710464921E-3</c:v>
                  </c:pt>
                  <c:pt idx="14">
                    <c:v>3.7479979634013855E-3</c:v>
                  </c:pt>
                  <c:pt idx="15">
                    <c:v>3.0356401650298067E-3</c:v>
                  </c:pt>
                  <c:pt idx="16">
                    <c:v>7.8954574061118924E-4</c:v>
                  </c:pt>
                  <c:pt idx="17">
                    <c:v>1.9093028473180995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I$5:$I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J$5:$J$22</c:f>
              <c:numCache>
                <c:formatCode>General</c:formatCode>
                <c:ptCount val="18"/>
                <c:pt idx="0">
                  <c:v>2.7650769204011559E-3</c:v>
                </c:pt>
                <c:pt idx="1">
                  <c:v>2.4397188265653192E-3</c:v>
                </c:pt>
                <c:pt idx="2">
                  <c:v>0.1024234025705285</c:v>
                </c:pt>
                <c:pt idx="3">
                  <c:v>9.095823141235905E-2</c:v>
                </c:pt>
                <c:pt idx="4">
                  <c:v>2.9587703251247582E-2</c:v>
                </c:pt>
                <c:pt idx="5">
                  <c:v>1.0549813698706395E-2</c:v>
                </c:pt>
                <c:pt idx="6">
                  <c:v>4.7649229935091504E-3</c:v>
                </c:pt>
                <c:pt idx="7">
                  <c:v>7.7232227691725946E-3</c:v>
                </c:pt>
                <c:pt idx="8">
                  <c:v>9.2349052752218677E-2</c:v>
                </c:pt>
                <c:pt idx="9">
                  <c:v>0.1091711315165548</c:v>
                </c:pt>
                <c:pt idx="10">
                  <c:v>5.5361813713767222E-2</c:v>
                </c:pt>
                <c:pt idx="11">
                  <c:v>1.7714414740935425E-2</c:v>
                </c:pt>
                <c:pt idx="12">
                  <c:v>9.6577899670866746E-3</c:v>
                </c:pt>
                <c:pt idx="13">
                  <c:v>2.9115677561916638E-2</c:v>
                </c:pt>
                <c:pt idx="14">
                  <c:v>0.11783387046313464</c:v>
                </c:pt>
                <c:pt idx="15">
                  <c:v>0.10840253066170252</c:v>
                </c:pt>
                <c:pt idx="16">
                  <c:v>4.1440500548287476E-2</c:v>
                </c:pt>
                <c:pt idx="17">
                  <c:v>1.0575122705164275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613376"/>
        <c:axId val="254614912"/>
      </c:scatterChart>
      <c:valAx>
        <c:axId val="25461337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614912"/>
        <c:crosses val="autoZero"/>
        <c:crossBetween val="midCat"/>
        <c:majorUnit val="4"/>
      </c:valAx>
      <c:valAx>
        <c:axId val="2546149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61337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24:$J$29</c:f>
                <c:numCache>
                  <c:formatCode>General</c:formatCode>
                  <c:ptCount val="6"/>
                  <c:pt idx="0">
                    <c:v>1.3799958255106821E-4</c:v>
                  </c:pt>
                  <c:pt idx="1">
                    <c:v>1.3136099405024767E-6</c:v>
                  </c:pt>
                  <c:pt idx="2">
                    <c:v>3.1595448009173228E-4</c:v>
                  </c:pt>
                  <c:pt idx="3">
                    <c:v>4.6014300445021824E-3</c:v>
                  </c:pt>
                  <c:pt idx="4">
                    <c:v>4.8761063218311865E-3</c:v>
                  </c:pt>
                  <c:pt idx="5">
                    <c:v>3.4128112057907412E-3</c:v>
                  </c:pt>
                </c:numCache>
              </c:numRef>
            </c:plus>
            <c:minus>
              <c:numRef>
                <c:f>Sheet4!$J$24:$J$29</c:f>
                <c:numCache>
                  <c:formatCode>General</c:formatCode>
                  <c:ptCount val="6"/>
                  <c:pt idx="0">
                    <c:v>1.3799958255106821E-4</c:v>
                  </c:pt>
                  <c:pt idx="1">
                    <c:v>1.3136099405024767E-6</c:v>
                  </c:pt>
                  <c:pt idx="2">
                    <c:v>3.1595448009173228E-4</c:v>
                  </c:pt>
                  <c:pt idx="3">
                    <c:v>4.6014300445021824E-3</c:v>
                  </c:pt>
                  <c:pt idx="4">
                    <c:v>4.8761063218311865E-3</c:v>
                  </c:pt>
                  <c:pt idx="5">
                    <c:v>3.4128112057907412E-3</c:v>
                  </c:pt>
                </c:numCache>
              </c:numRef>
            </c:minus>
          </c:errBars>
          <c:xVal>
            <c:numRef>
              <c:f>Sheet4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H$24:$H$29</c:f>
              <c:numCache>
                <c:formatCode>General</c:formatCode>
                <c:ptCount val="6"/>
                <c:pt idx="0">
                  <c:v>7.0322511683056023E-4</c:v>
                </c:pt>
                <c:pt idx="1">
                  <c:v>2.8336489583679605E-5</c:v>
                </c:pt>
                <c:pt idx="2">
                  <c:v>4.1052087226791812E-3</c:v>
                </c:pt>
                <c:pt idx="3">
                  <c:v>3.400400520110744E-2</c:v>
                </c:pt>
                <c:pt idx="4">
                  <c:v>2.1668817494877438E-2</c:v>
                </c:pt>
                <c:pt idx="5">
                  <c:v>1.6370846392317701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635008"/>
        <c:axId val="254644992"/>
      </c:scatterChart>
      <c:valAx>
        <c:axId val="25463500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644992"/>
        <c:crosses val="autoZero"/>
        <c:crossBetween val="midCat"/>
        <c:majorUnit val="4"/>
      </c:valAx>
      <c:valAx>
        <c:axId val="254644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63500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GI </a:t>
            </a:r>
            <a:r>
              <a:rPr lang="en-US" dirty="0" smtClean="0"/>
              <a:t>; At1g22770</a:t>
            </a:r>
            <a:endParaRPr lang="en-US" dirty="0"/>
          </a:p>
        </c:rich>
      </c:tx>
      <c:layout>
        <c:manualLayout>
          <c:xMode val="edge"/>
          <c:yMode val="edge"/>
          <c:x val="0.27662003763613879"/>
          <c:y val="6.566941734606328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9.1106517935258091E-2"/>
          <c:y val="5.3901960065902817E-2"/>
          <c:w val="0.87692825896762905"/>
          <c:h val="0.7958932459041196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8:$B$8</c:f>
              <c:strCache>
                <c:ptCount val="1"/>
                <c:pt idx="0">
                  <c:v>GI At1g2277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8:$V$8</c:f>
                <c:numCache>
                  <c:formatCode>General</c:formatCode>
                  <c:ptCount val="6"/>
                  <c:pt idx="0">
                    <c:v>0.80069836141217765</c:v>
                  </c:pt>
                  <c:pt idx="1">
                    <c:v>0.20636808095799364</c:v>
                  </c:pt>
                  <c:pt idx="2">
                    <c:v>0.14981726289419692</c:v>
                  </c:pt>
                  <c:pt idx="3">
                    <c:v>0.33631388163227627</c:v>
                  </c:pt>
                  <c:pt idx="4">
                    <c:v>0.30579697342339507</c:v>
                  </c:pt>
                  <c:pt idx="5">
                    <c:v>0.45288551964245538</c:v>
                  </c:pt>
                </c:numCache>
              </c:numRef>
            </c:plus>
            <c:minus>
              <c:numRef>
                <c:f>Sheet4!$Q$8:$V$8</c:f>
                <c:numCache>
                  <c:formatCode>General</c:formatCode>
                  <c:ptCount val="6"/>
                  <c:pt idx="0">
                    <c:v>0.80069836141217765</c:v>
                  </c:pt>
                  <c:pt idx="1">
                    <c:v>0.20636808095799364</c:v>
                  </c:pt>
                  <c:pt idx="2">
                    <c:v>0.14981726289419692</c:v>
                  </c:pt>
                  <c:pt idx="3">
                    <c:v>0.33631388163227627</c:v>
                  </c:pt>
                  <c:pt idx="4">
                    <c:v>0.30579697342339507</c:v>
                  </c:pt>
                  <c:pt idx="5">
                    <c:v>0.45288551964245538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8:$H$8</c:f>
              <c:numCache>
                <c:formatCode>General</c:formatCode>
                <c:ptCount val="6"/>
                <c:pt idx="0">
                  <c:v>4.6666173903333332</c:v>
                </c:pt>
                <c:pt idx="1">
                  <c:v>8.7354660316666788</c:v>
                </c:pt>
                <c:pt idx="2">
                  <c:v>10.838081969999999</c:v>
                </c:pt>
                <c:pt idx="3">
                  <c:v>9.1624014750000047</c:v>
                </c:pt>
                <c:pt idx="4">
                  <c:v>5.7592125769999942</c:v>
                </c:pt>
                <c:pt idx="5">
                  <c:v>5.797982494666671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769408"/>
        <c:axId val="250770944"/>
      </c:scatterChart>
      <c:valAx>
        <c:axId val="25076940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770944"/>
        <c:crosses val="autoZero"/>
        <c:crossBetween val="midCat"/>
        <c:majorUnit val="4"/>
      </c:valAx>
      <c:valAx>
        <c:axId val="250770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76940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4:$J$21</c:f>
                <c:numCache>
                  <c:formatCode>General</c:formatCode>
                  <c:ptCount val="18"/>
                  <c:pt idx="0">
                    <c:v>1.5243424534988766E-4</c:v>
                  </c:pt>
                  <c:pt idx="1">
                    <c:v>3.129718326564096E-5</c:v>
                  </c:pt>
                  <c:pt idx="2">
                    <c:v>6.195471355895741E-4</c:v>
                  </c:pt>
                  <c:pt idx="3">
                    <c:v>3.7958082064683245E-3</c:v>
                  </c:pt>
                  <c:pt idx="4">
                    <c:v>4.7717775794649058E-4</c:v>
                  </c:pt>
                  <c:pt idx="5">
                    <c:v>6.4688997045922564E-5</c:v>
                  </c:pt>
                  <c:pt idx="6">
                    <c:v>1.6736678644151892E-5</c:v>
                  </c:pt>
                  <c:pt idx="7">
                    <c:v>3.6289061477500883E-5</c:v>
                  </c:pt>
                  <c:pt idx="8">
                    <c:v>2.3812764097802603E-4</c:v>
                  </c:pt>
                  <c:pt idx="9">
                    <c:v>1.236416370777796E-3</c:v>
                  </c:pt>
                  <c:pt idx="10">
                    <c:v>8.5552169453310576E-4</c:v>
                  </c:pt>
                  <c:pt idx="11">
                    <c:v>8.8867977564900802E-5</c:v>
                  </c:pt>
                  <c:pt idx="12">
                    <c:v>1.5509071830587912E-5</c:v>
                  </c:pt>
                  <c:pt idx="13">
                    <c:v>7.2592164890372853E-5</c:v>
                  </c:pt>
                  <c:pt idx="14">
                    <c:v>2.1508817012163891E-3</c:v>
                  </c:pt>
                  <c:pt idx="15">
                    <c:v>4.0948541719154445E-4</c:v>
                  </c:pt>
                  <c:pt idx="16">
                    <c:v>1.090277519534613E-4</c:v>
                  </c:pt>
                  <c:pt idx="17">
                    <c:v>3.14884486660438E-4</c:v>
                  </c:pt>
                </c:numCache>
              </c:numRef>
            </c:plus>
            <c:minus>
              <c:numRef>
                <c:f>Sheet4!$J$4:$J$21</c:f>
                <c:numCache>
                  <c:formatCode>General</c:formatCode>
                  <c:ptCount val="18"/>
                  <c:pt idx="0">
                    <c:v>1.5243424534988766E-4</c:v>
                  </c:pt>
                  <c:pt idx="1">
                    <c:v>3.129718326564096E-5</c:v>
                  </c:pt>
                  <c:pt idx="2">
                    <c:v>6.195471355895741E-4</c:v>
                  </c:pt>
                  <c:pt idx="3">
                    <c:v>3.7958082064683245E-3</c:v>
                  </c:pt>
                  <c:pt idx="4">
                    <c:v>4.7717775794649058E-4</c:v>
                  </c:pt>
                  <c:pt idx="5">
                    <c:v>6.4688997045922564E-5</c:v>
                  </c:pt>
                  <c:pt idx="6">
                    <c:v>1.6736678644151892E-5</c:v>
                  </c:pt>
                  <c:pt idx="7">
                    <c:v>3.6289061477500883E-5</c:v>
                  </c:pt>
                  <c:pt idx="8">
                    <c:v>2.3812764097802603E-4</c:v>
                  </c:pt>
                  <c:pt idx="9">
                    <c:v>1.236416370777796E-3</c:v>
                  </c:pt>
                  <c:pt idx="10">
                    <c:v>8.5552169453310576E-4</c:v>
                  </c:pt>
                  <c:pt idx="11">
                    <c:v>8.8867977564900802E-5</c:v>
                  </c:pt>
                  <c:pt idx="12">
                    <c:v>1.5509071830587912E-5</c:v>
                  </c:pt>
                  <c:pt idx="13">
                    <c:v>7.2592164890372853E-5</c:v>
                  </c:pt>
                  <c:pt idx="14">
                    <c:v>2.1508817012163891E-3</c:v>
                  </c:pt>
                  <c:pt idx="15">
                    <c:v>4.0948541719154445E-4</c:v>
                  </c:pt>
                  <c:pt idx="16">
                    <c:v>1.090277519534613E-4</c:v>
                  </c:pt>
                  <c:pt idx="17">
                    <c:v>3.14884486660438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G$4:$G$21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H$4:$H$21</c:f>
              <c:numCache>
                <c:formatCode>General</c:formatCode>
                <c:ptCount val="18"/>
                <c:pt idx="0">
                  <c:v>5.2286894017830783E-4</c:v>
                </c:pt>
                <c:pt idx="1">
                  <c:v>6.4850160753899982E-5</c:v>
                </c:pt>
                <c:pt idx="2">
                  <c:v>5.2118570280247538E-3</c:v>
                </c:pt>
                <c:pt idx="3">
                  <c:v>3.0594427117017261E-2</c:v>
                </c:pt>
                <c:pt idx="4">
                  <c:v>6.4851848913042003E-3</c:v>
                </c:pt>
                <c:pt idx="5">
                  <c:v>1.0823045466004024E-3</c:v>
                </c:pt>
                <c:pt idx="6">
                  <c:v>2.2745785087208002E-4</c:v>
                </c:pt>
                <c:pt idx="7">
                  <c:v>4.6153226435283738E-4</c:v>
                </c:pt>
                <c:pt idx="8">
                  <c:v>5.7292256742436931E-3</c:v>
                </c:pt>
                <c:pt idx="9">
                  <c:v>2.1910961414732408E-2</c:v>
                </c:pt>
                <c:pt idx="10">
                  <c:v>9.6072556931079724E-3</c:v>
                </c:pt>
                <c:pt idx="11">
                  <c:v>1.5304743438508566E-3</c:v>
                </c:pt>
                <c:pt idx="12">
                  <c:v>4.8204926094946518E-4</c:v>
                </c:pt>
                <c:pt idx="13">
                  <c:v>1.2809956767450669E-3</c:v>
                </c:pt>
                <c:pt idx="14">
                  <c:v>2.6705763922116252E-2</c:v>
                </c:pt>
                <c:pt idx="15">
                  <c:v>1.0663529316676358E-2</c:v>
                </c:pt>
                <c:pt idx="16">
                  <c:v>4.427970967379135E-3</c:v>
                </c:pt>
                <c:pt idx="17">
                  <c:v>1.0314803324981327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739200"/>
        <c:axId val="254740736"/>
      </c:scatterChart>
      <c:valAx>
        <c:axId val="254739200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740736"/>
        <c:crosses val="autoZero"/>
        <c:crossBetween val="midCat"/>
        <c:majorUnit val="4"/>
      </c:valAx>
      <c:valAx>
        <c:axId val="2547407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73920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5:$J$22</c:f>
                <c:numCache>
                  <c:formatCode>General</c:formatCode>
                  <c:ptCount val="18"/>
                  <c:pt idx="0">
                    <c:v>1.3932891677345042E-8</c:v>
                  </c:pt>
                  <c:pt idx="1">
                    <c:v>2.1577974572639496E-7</c:v>
                  </c:pt>
                  <c:pt idx="2">
                    <c:v>4.1603232017611787E-4</c:v>
                  </c:pt>
                  <c:pt idx="3">
                    <c:v>1.0802544526559681E-4</c:v>
                  </c:pt>
                  <c:pt idx="4">
                    <c:v>6.543405116198272E-6</c:v>
                  </c:pt>
                  <c:pt idx="5">
                    <c:v>2.5691218576240676E-7</c:v>
                  </c:pt>
                  <c:pt idx="6">
                    <c:v>6.2208037867956764E-8</c:v>
                  </c:pt>
                  <c:pt idx="7">
                    <c:v>4.6687453383629112E-7</c:v>
                  </c:pt>
                  <c:pt idx="8">
                    <c:v>7.4160498997668893E-4</c:v>
                  </c:pt>
                  <c:pt idx="9">
                    <c:v>1.8971297969432805E-4</c:v>
                  </c:pt>
                  <c:pt idx="10">
                    <c:v>5.5375205917822135E-6</c:v>
                  </c:pt>
                  <c:pt idx="11">
                    <c:v>7.9943199051974717E-7</c:v>
                  </c:pt>
                  <c:pt idx="12">
                    <c:v>7.8194212748364863E-7</c:v>
                  </c:pt>
                  <c:pt idx="13">
                    <c:v>1.9864429502104196E-5</c:v>
                  </c:pt>
                  <c:pt idx="14">
                    <c:v>1.9054863083938029E-4</c:v>
                  </c:pt>
                  <c:pt idx="15">
                    <c:v>2.3583113175326673E-4</c:v>
                  </c:pt>
                  <c:pt idx="16">
                    <c:v>7.7052258079637546E-6</c:v>
                  </c:pt>
                  <c:pt idx="17">
                    <c:v>8.2565742276000636E-7</c:v>
                  </c:pt>
                </c:numCache>
              </c:numRef>
            </c:plus>
            <c:minus>
              <c:numRef>
                <c:f>Sheet4!$J$5:$J$22</c:f>
                <c:numCache>
                  <c:formatCode>General</c:formatCode>
                  <c:ptCount val="18"/>
                  <c:pt idx="0">
                    <c:v>1.3932891677345042E-8</c:v>
                  </c:pt>
                  <c:pt idx="1">
                    <c:v>2.1577974572639496E-7</c:v>
                  </c:pt>
                  <c:pt idx="2">
                    <c:v>4.1603232017611787E-4</c:v>
                  </c:pt>
                  <c:pt idx="3">
                    <c:v>1.0802544526559681E-4</c:v>
                  </c:pt>
                  <c:pt idx="4">
                    <c:v>6.543405116198272E-6</c:v>
                  </c:pt>
                  <c:pt idx="5">
                    <c:v>2.5691218576240676E-7</c:v>
                  </c:pt>
                  <c:pt idx="6">
                    <c:v>6.2208037867956764E-8</c:v>
                  </c:pt>
                  <c:pt idx="7">
                    <c:v>4.6687453383629112E-7</c:v>
                  </c:pt>
                  <c:pt idx="8">
                    <c:v>7.4160498997668893E-4</c:v>
                  </c:pt>
                  <c:pt idx="9">
                    <c:v>1.8971297969432805E-4</c:v>
                  </c:pt>
                  <c:pt idx="10">
                    <c:v>5.5375205917822135E-6</c:v>
                  </c:pt>
                  <c:pt idx="11">
                    <c:v>7.9943199051974717E-7</c:v>
                  </c:pt>
                  <c:pt idx="12">
                    <c:v>7.8194212748364863E-7</c:v>
                  </c:pt>
                  <c:pt idx="13">
                    <c:v>1.9864429502104196E-5</c:v>
                  </c:pt>
                  <c:pt idx="14">
                    <c:v>1.9054863083938029E-4</c:v>
                  </c:pt>
                  <c:pt idx="15">
                    <c:v>2.3583113175326673E-4</c:v>
                  </c:pt>
                  <c:pt idx="16">
                    <c:v>7.7052258079637546E-6</c:v>
                  </c:pt>
                  <c:pt idx="17">
                    <c:v>8.2565742276000636E-7</c:v>
                  </c:pt>
                </c:numCache>
              </c:numRef>
            </c:minus>
          </c:errBars>
          <c:xVal>
            <c:numRef>
              <c:f>Sheet4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H$5:$H$22</c:f>
              <c:numCache>
                <c:formatCode>General</c:formatCode>
                <c:ptCount val="18"/>
                <c:pt idx="0">
                  <c:v>2.2050082802264048E-8</c:v>
                </c:pt>
                <c:pt idx="1">
                  <c:v>3.1886591383667214E-7</c:v>
                </c:pt>
                <c:pt idx="2">
                  <c:v>1.9229547602406226E-3</c:v>
                </c:pt>
                <c:pt idx="3">
                  <c:v>4.4395286806217114E-4</c:v>
                </c:pt>
                <c:pt idx="4">
                  <c:v>5.8700940911174004E-5</c:v>
                </c:pt>
                <c:pt idx="5">
                  <c:v>1.3306048652734385E-6</c:v>
                </c:pt>
                <c:pt idx="6">
                  <c:v>2.6890360749186556E-7</c:v>
                </c:pt>
                <c:pt idx="7">
                  <c:v>1.5326222452417193E-6</c:v>
                </c:pt>
                <c:pt idx="8">
                  <c:v>3.5225536483512966E-3</c:v>
                </c:pt>
                <c:pt idx="9">
                  <c:v>4.5730798973233581E-4</c:v>
                </c:pt>
                <c:pt idx="10">
                  <c:v>3.394443580550352E-5</c:v>
                </c:pt>
                <c:pt idx="11">
                  <c:v>3.3217494325062776E-6</c:v>
                </c:pt>
                <c:pt idx="12">
                  <c:v>3.2382147179816071E-6</c:v>
                </c:pt>
                <c:pt idx="13">
                  <c:v>5.7186158892343135E-5</c:v>
                </c:pt>
                <c:pt idx="14">
                  <c:v>5.8852455873820435E-4</c:v>
                </c:pt>
                <c:pt idx="15">
                  <c:v>4.5331630180823768E-4</c:v>
                </c:pt>
                <c:pt idx="16">
                  <c:v>3.9696161496863003E-5</c:v>
                </c:pt>
                <c:pt idx="17">
                  <c:v>3.6464761276623769E-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138112"/>
        <c:axId val="216139648"/>
      </c:scatterChart>
      <c:valAx>
        <c:axId val="216138112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16139648"/>
        <c:crosses val="autoZero"/>
        <c:crossBetween val="midCat"/>
        <c:majorUnit val="4"/>
      </c:valAx>
      <c:valAx>
        <c:axId val="21613964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/>
            </a:pPr>
            <a:endParaRPr lang="ko-KR"/>
          </a:p>
        </c:txPr>
        <c:crossAx val="21613811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24:$J$29</c:f>
                <c:numCache>
                  <c:formatCode>General</c:formatCode>
                  <c:ptCount val="6"/>
                  <c:pt idx="0">
                    <c:v>4.4432691083314163E-9</c:v>
                  </c:pt>
                  <c:pt idx="1">
                    <c:v>3.540430726182687E-8</c:v>
                  </c:pt>
                  <c:pt idx="2">
                    <c:v>1.4688075726345965E-4</c:v>
                  </c:pt>
                  <c:pt idx="3">
                    <c:v>1.4989363594372827E-4</c:v>
                  </c:pt>
                  <c:pt idx="4">
                    <c:v>3.6782334782184323E-5</c:v>
                  </c:pt>
                  <c:pt idx="5">
                    <c:v>2.455332298972288E-6</c:v>
                  </c:pt>
                </c:numCache>
              </c:numRef>
            </c:plus>
            <c:minus>
              <c:numRef>
                <c:f>Sheet4!$J$24:$J$29</c:f>
                <c:numCache>
                  <c:formatCode>General</c:formatCode>
                  <c:ptCount val="6"/>
                  <c:pt idx="0">
                    <c:v>4.4432691083314163E-9</c:v>
                  </c:pt>
                  <c:pt idx="1">
                    <c:v>3.540430726182687E-8</c:v>
                  </c:pt>
                  <c:pt idx="2">
                    <c:v>1.4688075726345965E-4</c:v>
                  </c:pt>
                  <c:pt idx="3">
                    <c:v>1.4989363594372827E-4</c:v>
                  </c:pt>
                  <c:pt idx="4">
                    <c:v>3.6782334782184323E-5</c:v>
                  </c:pt>
                  <c:pt idx="5">
                    <c:v>2.455332298972288E-6</c:v>
                  </c:pt>
                </c:numCache>
              </c:numRef>
            </c:minus>
          </c:errBars>
          <c:xVal>
            <c:numRef>
              <c:f>Sheet4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H$24:$H$29</c:f>
              <c:numCache>
                <c:formatCode>General</c:formatCode>
                <c:ptCount val="6"/>
                <c:pt idx="0">
                  <c:v>2.2891052448592248E-8</c:v>
                </c:pt>
                <c:pt idx="1">
                  <c:v>2.6346885216950329E-7</c:v>
                </c:pt>
                <c:pt idx="2">
                  <c:v>1.2295753911901568E-3</c:v>
                </c:pt>
                <c:pt idx="3">
                  <c:v>1.7219164155967109E-3</c:v>
                </c:pt>
                <c:pt idx="4">
                  <c:v>3.4317675575017695E-4</c:v>
                </c:pt>
                <c:pt idx="5">
                  <c:v>1.0003753243255987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172032"/>
        <c:axId val="216173568"/>
      </c:scatterChart>
      <c:valAx>
        <c:axId val="21617203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173568"/>
        <c:crosses val="autoZero"/>
        <c:crossBetween val="midCat"/>
        <c:majorUnit val="4"/>
      </c:valAx>
      <c:valAx>
        <c:axId val="21617356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1720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J$5:$J$22</c:f>
                <c:numCache>
                  <c:formatCode>General</c:formatCode>
                  <c:ptCount val="18"/>
                  <c:pt idx="0">
                    <c:v>2.044642103513666E-2</c:v>
                  </c:pt>
                  <c:pt idx="1">
                    <c:v>4.0052868990132182E-4</c:v>
                  </c:pt>
                  <c:pt idx="2">
                    <c:v>6.0118837090308499E-6</c:v>
                  </c:pt>
                  <c:pt idx="3">
                    <c:v>8.0677058711985482E-7</c:v>
                  </c:pt>
                  <c:pt idx="4">
                    <c:v>1.4870659752350906E-5</c:v>
                  </c:pt>
                  <c:pt idx="5">
                    <c:v>4.1085655799019699E-4</c:v>
                  </c:pt>
                  <c:pt idx="6">
                    <c:v>4.0942227163681434E-3</c:v>
                  </c:pt>
                  <c:pt idx="7">
                    <c:v>1.3128237337836383E-3</c:v>
                  </c:pt>
                  <c:pt idx="8">
                    <c:v>1.913868957423653E-5</c:v>
                  </c:pt>
                  <c:pt idx="9">
                    <c:v>7.2910341230937669E-6</c:v>
                  </c:pt>
                  <c:pt idx="10">
                    <c:v>6.5559211015438874E-5</c:v>
                  </c:pt>
                  <c:pt idx="11">
                    <c:v>1.055716773894486E-3</c:v>
                  </c:pt>
                  <c:pt idx="12">
                    <c:v>2.9008105416033158E-3</c:v>
                  </c:pt>
                  <c:pt idx="13">
                    <c:v>6.4521218592563897E-4</c:v>
                  </c:pt>
                  <c:pt idx="14">
                    <c:v>1.0415537741674037E-4</c:v>
                  </c:pt>
                  <c:pt idx="15">
                    <c:v>8.6304383331333722E-5</c:v>
                  </c:pt>
                  <c:pt idx="16">
                    <c:v>9.6941428709391086E-4</c:v>
                  </c:pt>
                  <c:pt idx="17">
                    <c:v>2.2017336814464856E-3</c:v>
                  </c:pt>
                </c:numCache>
              </c:numRef>
            </c:plus>
            <c:minus>
              <c:numRef>
                <c:f>Sheet5!$J$5:$J$22</c:f>
                <c:numCache>
                  <c:formatCode>General</c:formatCode>
                  <c:ptCount val="18"/>
                  <c:pt idx="0">
                    <c:v>2.044642103513666E-2</c:v>
                  </c:pt>
                  <c:pt idx="1">
                    <c:v>4.0052868990132182E-4</c:v>
                  </c:pt>
                  <c:pt idx="2">
                    <c:v>6.0118837090308499E-6</c:v>
                  </c:pt>
                  <c:pt idx="3">
                    <c:v>8.0677058711985482E-7</c:v>
                  </c:pt>
                  <c:pt idx="4">
                    <c:v>1.4870659752350906E-5</c:v>
                  </c:pt>
                  <c:pt idx="5">
                    <c:v>4.1085655799019699E-4</c:v>
                  </c:pt>
                  <c:pt idx="6">
                    <c:v>4.0942227163681434E-3</c:v>
                  </c:pt>
                  <c:pt idx="7">
                    <c:v>1.3128237337836383E-3</c:v>
                  </c:pt>
                  <c:pt idx="8">
                    <c:v>1.913868957423653E-5</c:v>
                  </c:pt>
                  <c:pt idx="9">
                    <c:v>7.2910341230937669E-6</c:v>
                  </c:pt>
                  <c:pt idx="10">
                    <c:v>6.5559211015438874E-5</c:v>
                  </c:pt>
                  <c:pt idx="11">
                    <c:v>1.055716773894486E-3</c:v>
                  </c:pt>
                  <c:pt idx="12">
                    <c:v>2.9008105416033158E-3</c:v>
                  </c:pt>
                  <c:pt idx="13">
                    <c:v>6.4521218592563897E-4</c:v>
                  </c:pt>
                  <c:pt idx="14">
                    <c:v>1.0415537741674037E-4</c:v>
                  </c:pt>
                  <c:pt idx="15">
                    <c:v>8.6304383331333722E-5</c:v>
                  </c:pt>
                  <c:pt idx="16">
                    <c:v>9.6941428709391086E-4</c:v>
                  </c:pt>
                  <c:pt idx="17">
                    <c:v>2.2017336814464856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5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5!$H$5:$H$22</c:f>
              <c:numCache>
                <c:formatCode>General</c:formatCode>
                <c:ptCount val="18"/>
                <c:pt idx="0">
                  <c:v>4.6413996500459881E-2</c:v>
                </c:pt>
                <c:pt idx="1">
                  <c:v>6.6400052054479894E-3</c:v>
                </c:pt>
                <c:pt idx="2">
                  <c:v>4.8370207506756514E-5</c:v>
                </c:pt>
                <c:pt idx="3">
                  <c:v>6.5393806923539881E-6</c:v>
                </c:pt>
                <c:pt idx="4">
                  <c:v>4.290077104984928E-5</c:v>
                </c:pt>
                <c:pt idx="5">
                  <c:v>3.8983743780924827E-3</c:v>
                </c:pt>
                <c:pt idx="6">
                  <c:v>1.6348670710864883E-2</c:v>
                </c:pt>
                <c:pt idx="7">
                  <c:v>4.4211551144599324E-3</c:v>
                </c:pt>
                <c:pt idx="8">
                  <c:v>9.4172485984931584E-5</c:v>
                </c:pt>
                <c:pt idx="9">
                  <c:v>2.3662702525282778E-5</c:v>
                </c:pt>
                <c:pt idx="10">
                  <c:v>2.7276808530286861E-4</c:v>
                </c:pt>
                <c:pt idx="11">
                  <c:v>6.9422166457155932E-3</c:v>
                </c:pt>
                <c:pt idx="12">
                  <c:v>1.156828586754112E-2</c:v>
                </c:pt>
                <c:pt idx="13">
                  <c:v>2.2424445753752012E-3</c:v>
                </c:pt>
                <c:pt idx="14">
                  <c:v>3.4419742143804242E-4</c:v>
                </c:pt>
                <c:pt idx="15">
                  <c:v>2.4770322903236387E-4</c:v>
                </c:pt>
                <c:pt idx="16">
                  <c:v>3.9060488974517744E-3</c:v>
                </c:pt>
                <c:pt idx="17">
                  <c:v>1.288617297321938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185856"/>
        <c:axId val="216220416"/>
      </c:scatterChart>
      <c:valAx>
        <c:axId val="21618585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220416"/>
        <c:crosses val="autoZero"/>
        <c:crossBetween val="midCat"/>
        <c:majorUnit val="4"/>
      </c:valAx>
      <c:valAx>
        <c:axId val="21622041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18585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J$24:$J$29</c:f>
                <c:numCache>
                  <c:formatCode>General</c:formatCode>
                  <c:ptCount val="6"/>
                  <c:pt idx="0">
                    <c:v>1.4460109635075617E-3</c:v>
                  </c:pt>
                  <c:pt idx="1">
                    <c:v>1.1598777613039873E-4</c:v>
                  </c:pt>
                  <c:pt idx="2">
                    <c:v>2.4090051408487411E-6</c:v>
                  </c:pt>
                  <c:pt idx="3">
                    <c:v>1.9362505597005252E-7</c:v>
                  </c:pt>
                  <c:pt idx="4">
                    <c:v>8.8969286012920478E-7</c:v>
                  </c:pt>
                  <c:pt idx="5">
                    <c:v>1.1534697912536E-3</c:v>
                  </c:pt>
                </c:numCache>
              </c:numRef>
            </c:plus>
            <c:minus>
              <c:numRef>
                <c:f>Sheet5!$J$24:$J$29</c:f>
                <c:numCache>
                  <c:formatCode>General</c:formatCode>
                  <c:ptCount val="6"/>
                  <c:pt idx="0">
                    <c:v>1.4460109635075617E-3</c:v>
                  </c:pt>
                  <c:pt idx="1">
                    <c:v>1.1598777613039873E-4</c:v>
                  </c:pt>
                  <c:pt idx="2">
                    <c:v>2.4090051408487411E-6</c:v>
                  </c:pt>
                  <c:pt idx="3">
                    <c:v>1.9362505597005252E-7</c:v>
                  </c:pt>
                  <c:pt idx="4">
                    <c:v>8.8969286012920478E-7</c:v>
                  </c:pt>
                  <c:pt idx="5">
                    <c:v>1.1534697912536E-3</c:v>
                  </c:pt>
                </c:numCache>
              </c:numRef>
            </c:minus>
          </c:errBars>
          <c:xVal>
            <c:numRef>
              <c:f>Sheet5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5!$H$24:$H$29</c:f>
              <c:numCache>
                <c:formatCode>General</c:formatCode>
                <c:ptCount val="6"/>
                <c:pt idx="0">
                  <c:v>2.1940961744287155E-2</c:v>
                </c:pt>
                <c:pt idx="1">
                  <c:v>2.2806280243390402E-3</c:v>
                </c:pt>
                <c:pt idx="2">
                  <c:v>3.8078316847187441E-5</c:v>
                </c:pt>
                <c:pt idx="3">
                  <c:v>2.1545965576181356E-6</c:v>
                </c:pt>
                <c:pt idx="4">
                  <c:v>4.1411342202661853E-6</c:v>
                </c:pt>
                <c:pt idx="5">
                  <c:v>5.3985718311996313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232320"/>
        <c:axId val="216233856"/>
      </c:scatterChart>
      <c:valAx>
        <c:axId val="21623232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233856"/>
        <c:crosses val="autoZero"/>
        <c:crossBetween val="midCat"/>
        <c:majorUnit val="4"/>
      </c:valAx>
      <c:valAx>
        <c:axId val="21623385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23232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0800962379702843E-2"/>
          <c:y val="4.0022965879265092E-2"/>
          <c:w val="0.85945603674540683"/>
          <c:h val="0.8736577719451748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K$23:$K$28</c:f>
                <c:numCache>
                  <c:formatCode>General</c:formatCode>
                  <c:ptCount val="6"/>
                  <c:pt idx="0">
                    <c:v>3.6121432185665402E-2</c:v>
                  </c:pt>
                  <c:pt idx="1">
                    <c:v>2.3159467182016404E-4</c:v>
                  </c:pt>
                  <c:pt idx="2">
                    <c:v>8.3076749687549773E-6</c:v>
                  </c:pt>
                  <c:pt idx="3">
                    <c:v>1.3908934286615193E-5</c:v>
                  </c:pt>
                  <c:pt idx="4">
                    <c:v>1.8111435660640762E-5</c:v>
                  </c:pt>
                  <c:pt idx="5">
                    <c:v>4.2696645987935933E-2</c:v>
                  </c:pt>
                </c:numCache>
              </c:numRef>
            </c:plus>
            <c:minus>
              <c:numRef>
                <c:f>Sheet5!$K$23:$K$28</c:f>
                <c:numCache>
                  <c:formatCode>General</c:formatCode>
                  <c:ptCount val="6"/>
                  <c:pt idx="0">
                    <c:v>3.6121432185665402E-2</c:v>
                  </c:pt>
                  <c:pt idx="1">
                    <c:v>2.3159467182016404E-4</c:v>
                  </c:pt>
                  <c:pt idx="2">
                    <c:v>8.3076749687549773E-6</c:v>
                  </c:pt>
                  <c:pt idx="3">
                    <c:v>1.3908934286615193E-5</c:v>
                  </c:pt>
                  <c:pt idx="4">
                    <c:v>1.8111435660640762E-5</c:v>
                  </c:pt>
                  <c:pt idx="5">
                    <c:v>4.2696645987935933E-2</c:v>
                  </c:pt>
                </c:numCache>
              </c:numRef>
            </c:minus>
          </c:errBars>
          <c:xVal>
            <c:numRef>
              <c:f>Sheet5!$H$23:$H$28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5!$I$23:$I$28</c:f>
              <c:numCache>
                <c:formatCode>General</c:formatCode>
                <c:ptCount val="6"/>
                <c:pt idx="0">
                  <c:v>0.52974109130663294</c:v>
                </c:pt>
                <c:pt idx="1">
                  <c:v>4.5722788016954894E-3</c:v>
                </c:pt>
                <c:pt idx="2">
                  <c:v>1.0305140030642021E-4</c:v>
                </c:pt>
                <c:pt idx="3">
                  <c:v>2.8986961158928598E-5</c:v>
                </c:pt>
                <c:pt idx="4">
                  <c:v>6.5303868895971552E-5</c:v>
                </c:pt>
                <c:pt idx="5">
                  <c:v>0.1304082237030862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262144"/>
        <c:axId val="216263680"/>
      </c:scatterChart>
      <c:valAx>
        <c:axId val="21626214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263680"/>
        <c:crosses val="autoZero"/>
        <c:crossBetween val="midCat"/>
        <c:majorUnit val="4"/>
      </c:valAx>
      <c:valAx>
        <c:axId val="216263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2621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K$4:$K$21</c:f>
                <c:numCache>
                  <c:formatCode>General</c:formatCode>
                  <c:ptCount val="18"/>
                  <c:pt idx="0">
                    <c:v>0.35875578237838912</c:v>
                  </c:pt>
                  <c:pt idx="1">
                    <c:v>5.1155520965259884E-3</c:v>
                  </c:pt>
                  <c:pt idx="2">
                    <c:v>1.2108906823440046E-5</c:v>
                  </c:pt>
                  <c:pt idx="3">
                    <c:v>1.9445460704419439E-6</c:v>
                  </c:pt>
                  <c:pt idx="4">
                    <c:v>1.7307907741101441E-3</c:v>
                  </c:pt>
                  <c:pt idx="5">
                    <c:v>1.6182327674911498E-2</c:v>
                  </c:pt>
                  <c:pt idx="6">
                    <c:v>1.494559895634252E-2</c:v>
                  </c:pt>
                  <c:pt idx="7">
                    <c:v>8.9103367162320039E-3</c:v>
                  </c:pt>
                  <c:pt idx="8">
                    <c:v>5.5473869639696813E-4</c:v>
                  </c:pt>
                  <c:pt idx="9">
                    <c:v>5.6708464429722978E-5</c:v>
                  </c:pt>
                  <c:pt idx="10">
                    <c:v>5.9810298105704483E-4</c:v>
                  </c:pt>
                  <c:pt idx="11">
                    <c:v>5.2400386662470374E-3</c:v>
                  </c:pt>
                  <c:pt idx="12">
                    <c:v>1.5056740162768877E-2</c:v>
                  </c:pt>
                  <c:pt idx="13">
                    <c:v>1.3952589649925667E-3</c:v>
                  </c:pt>
                  <c:pt idx="14">
                    <c:v>2.7072675964728545E-4</c:v>
                  </c:pt>
                  <c:pt idx="15">
                    <c:v>6.1289527728248432E-4</c:v>
                  </c:pt>
                  <c:pt idx="16">
                    <c:v>1.0064179482527955E-2</c:v>
                  </c:pt>
                  <c:pt idx="17">
                    <c:v>8.4033463054480808E-3</c:v>
                  </c:pt>
                </c:numCache>
              </c:numRef>
            </c:plus>
            <c:minus>
              <c:numRef>
                <c:f>Sheet5!$K$4:$K$21</c:f>
                <c:numCache>
                  <c:formatCode>General</c:formatCode>
                  <c:ptCount val="18"/>
                  <c:pt idx="0">
                    <c:v>0.35875578237838912</c:v>
                  </c:pt>
                  <c:pt idx="1">
                    <c:v>5.1155520965259884E-3</c:v>
                  </c:pt>
                  <c:pt idx="2">
                    <c:v>1.2108906823440046E-5</c:v>
                  </c:pt>
                  <c:pt idx="3">
                    <c:v>1.9445460704419439E-6</c:v>
                  </c:pt>
                  <c:pt idx="4">
                    <c:v>1.7307907741101441E-3</c:v>
                  </c:pt>
                  <c:pt idx="5">
                    <c:v>1.6182327674911498E-2</c:v>
                  </c:pt>
                  <c:pt idx="6">
                    <c:v>1.494559895634252E-2</c:v>
                  </c:pt>
                  <c:pt idx="7">
                    <c:v>8.9103367162320039E-3</c:v>
                  </c:pt>
                  <c:pt idx="8">
                    <c:v>5.5473869639696813E-4</c:v>
                  </c:pt>
                  <c:pt idx="9">
                    <c:v>5.6708464429722978E-5</c:v>
                  </c:pt>
                  <c:pt idx="10">
                    <c:v>5.9810298105704483E-4</c:v>
                  </c:pt>
                  <c:pt idx="11">
                    <c:v>5.2400386662470374E-3</c:v>
                  </c:pt>
                  <c:pt idx="12">
                    <c:v>1.5056740162768877E-2</c:v>
                  </c:pt>
                  <c:pt idx="13">
                    <c:v>1.3952589649925667E-3</c:v>
                  </c:pt>
                  <c:pt idx="14">
                    <c:v>2.7072675964728545E-4</c:v>
                  </c:pt>
                  <c:pt idx="15">
                    <c:v>6.1289527728248432E-4</c:v>
                  </c:pt>
                  <c:pt idx="16">
                    <c:v>1.0064179482527955E-2</c:v>
                  </c:pt>
                  <c:pt idx="17">
                    <c:v>8.4033463054480808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5!$H$4:$H$21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5!$I$4:$I$21</c:f>
              <c:numCache>
                <c:formatCode>General</c:formatCode>
                <c:ptCount val="18"/>
                <c:pt idx="0">
                  <c:v>0.99568006706099854</c:v>
                </c:pt>
                <c:pt idx="1">
                  <c:v>1.7289998653721311E-2</c:v>
                </c:pt>
                <c:pt idx="2">
                  <c:v>7.4246213718731643E-5</c:v>
                </c:pt>
                <c:pt idx="3">
                  <c:v>3.0501425712427029E-5</c:v>
                </c:pt>
                <c:pt idx="4">
                  <c:v>2.3673258251638886E-3</c:v>
                </c:pt>
                <c:pt idx="5">
                  <c:v>5.998288512238846E-2</c:v>
                </c:pt>
                <c:pt idx="6">
                  <c:v>0.15846417422215681</c:v>
                </c:pt>
                <c:pt idx="7">
                  <c:v>3.2228565316814152E-2</c:v>
                </c:pt>
                <c:pt idx="8">
                  <c:v>7.4538412212550934E-4</c:v>
                </c:pt>
                <c:pt idx="9">
                  <c:v>2.8539821343685317E-4</c:v>
                </c:pt>
                <c:pt idx="10">
                  <c:v>2.1866262980728577E-3</c:v>
                </c:pt>
                <c:pt idx="11">
                  <c:v>5.5064648145453324E-2</c:v>
                </c:pt>
                <c:pt idx="12">
                  <c:v>0.11977152748645224</c:v>
                </c:pt>
                <c:pt idx="13">
                  <c:v>1.0718125734993205E-2</c:v>
                </c:pt>
                <c:pt idx="14">
                  <c:v>1.8483731368974048E-3</c:v>
                </c:pt>
                <c:pt idx="15">
                  <c:v>3.664301238911094E-3</c:v>
                </c:pt>
                <c:pt idx="16">
                  <c:v>4.6995406108487882E-2</c:v>
                </c:pt>
                <c:pt idx="17">
                  <c:v>0.1050966459474751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284160"/>
        <c:axId val="216298240"/>
      </c:scatterChart>
      <c:valAx>
        <c:axId val="216284160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16298240"/>
        <c:crosses val="autoZero"/>
        <c:crossBetween val="midCat"/>
        <c:majorUnit val="4"/>
      </c:valAx>
      <c:valAx>
        <c:axId val="216298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1628416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noFill/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5:$J$22</c:f>
                <c:numCache>
                  <c:formatCode>General</c:formatCode>
                  <c:ptCount val="18"/>
                  <c:pt idx="0">
                    <c:v>2.4667387174631645E-2</c:v>
                  </c:pt>
                  <c:pt idx="1">
                    <c:v>1.5313439600796921E-3</c:v>
                  </c:pt>
                  <c:pt idx="2">
                    <c:v>8.2778394292308465E-5</c:v>
                  </c:pt>
                  <c:pt idx="3">
                    <c:v>8.968093196941107E-6</c:v>
                  </c:pt>
                  <c:pt idx="4">
                    <c:v>6.8272723883349543E-5</c:v>
                  </c:pt>
                  <c:pt idx="5">
                    <c:v>1.3761547205620845E-3</c:v>
                  </c:pt>
                  <c:pt idx="6">
                    <c:v>1.8822159026614556E-3</c:v>
                  </c:pt>
                  <c:pt idx="7">
                    <c:v>7.3911831988787927E-3</c:v>
                  </c:pt>
                  <c:pt idx="8">
                    <c:v>5.8647452591700909E-5</c:v>
                  </c:pt>
                  <c:pt idx="9">
                    <c:v>1.0345654874349373E-5</c:v>
                  </c:pt>
                  <c:pt idx="10">
                    <c:v>9.618482711418007E-5</c:v>
                  </c:pt>
                  <c:pt idx="11">
                    <c:v>7.8493842122653813E-4</c:v>
                  </c:pt>
                  <c:pt idx="12">
                    <c:v>5.5051016190755106E-3</c:v>
                  </c:pt>
                  <c:pt idx="13">
                    <c:v>1.8653014658545992E-3</c:v>
                  </c:pt>
                  <c:pt idx="14">
                    <c:v>5.6213103633410153E-4</c:v>
                  </c:pt>
                  <c:pt idx="15">
                    <c:v>1.6438229501140769E-4</c:v>
                  </c:pt>
                  <c:pt idx="16">
                    <c:v>1.1261255865816077E-3</c:v>
                  </c:pt>
                  <c:pt idx="17">
                    <c:v>2.4236470709817822E-3</c:v>
                  </c:pt>
                </c:numCache>
              </c:numRef>
            </c:plus>
            <c:minus>
              <c:numRef>
                <c:f>Sheet4!$J$5:$J$22</c:f>
                <c:numCache>
                  <c:formatCode>General</c:formatCode>
                  <c:ptCount val="18"/>
                  <c:pt idx="0">
                    <c:v>2.4667387174631645E-2</c:v>
                  </c:pt>
                  <c:pt idx="1">
                    <c:v>1.5313439600796921E-3</c:v>
                  </c:pt>
                  <c:pt idx="2">
                    <c:v>8.2778394292308465E-5</c:v>
                  </c:pt>
                  <c:pt idx="3">
                    <c:v>8.968093196941107E-6</c:v>
                  </c:pt>
                  <c:pt idx="4">
                    <c:v>6.8272723883349543E-5</c:v>
                  </c:pt>
                  <c:pt idx="5">
                    <c:v>1.3761547205620845E-3</c:v>
                  </c:pt>
                  <c:pt idx="6">
                    <c:v>1.8822159026614556E-3</c:v>
                  </c:pt>
                  <c:pt idx="7">
                    <c:v>7.3911831988787927E-3</c:v>
                  </c:pt>
                  <c:pt idx="8">
                    <c:v>5.8647452591700909E-5</c:v>
                  </c:pt>
                  <c:pt idx="9">
                    <c:v>1.0345654874349373E-5</c:v>
                  </c:pt>
                  <c:pt idx="10">
                    <c:v>9.618482711418007E-5</c:v>
                  </c:pt>
                  <c:pt idx="11">
                    <c:v>7.8493842122653813E-4</c:v>
                  </c:pt>
                  <c:pt idx="12">
                    <c:v>5.5051016190755106E-3</c:v>
                  </c:pt>
                  <c:pt idx="13">
                    <c:v>1.8653014658545992E-3</c:v>
                  </c:pt>
                  <c:pt idx="14">
                    <c:v>5.6213103633410153E-4</c:v>
                  </c:pt>
                  <c:pt idx="15">
                    <c:v>1.6438229501140769E-4</c:v>
                  </c:pt>
                  <c:pt idx="16">
                    <c:v>1.1261255865816077E-3</c:v>
                  </c:pt>
                  <c:pt idx="17">
                    <c:v>2.4236470709817822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4!$H$5:$H$22</c:f>
              <c:numCache>
                <c:formatCode>General</c:formatCode>
                <c:ptCount val="18"/>
                <c:pt idx="0">
                  <c:v>0.10150855130707544</c:v>
                </c:pt>
                <c:pt idx="1">
                  <c:v>3.8357307636163643E-2</c:v>
                </c:pt>
                <c:pt idx="2">
                  <c:v>6.4009230916729928E-4</c:v>
                </c:pt>
                <c:pt idx="3">
                  <c:v>6.3999244801949282E-5</c:v>
                </c:pt>
                <c:pt idx="4">
                  <c:v>2.3135737863530612E-4</c:v>
                </c:pt>
                <c:pt idx="5">
                  <c:v>6.7643383030191358E-3</c:v>
                </c:pt>
                <c:pt idx="6">
                  <c:v>4.0847533807352003E-2</c:v>
                </c:pt>
                <c:pt idx="7">
                  <c:v>2.6356637684342672E-2</c:v>
                </c:pt>
                <c:pt idx="8">
                  <c:v>3.8444671303739042E-3</c:v>
                </c:pt>
                <c:pt idx="9">
                  <c:v>1.5274917792524922E-4</c:v>
                </c:pt>
                <c:pt idx="10">
                  <c:v>4.3254296218593521E-4</c:v>
                </c:pt>
                <c:pt idx="11">
                  <c:v>1.0854971702923885E-2</c:v>
                </c:pt>
                <c:pt idx="12">
                  <c:v>5.2376657257494998E-2</c:v>
                </c:pt>
                <c:pt idx="13">
                  <c:v>1.0893229067777174E-2</c:v>
                </c:pt>
                <c:pt idx="14">
                  <c:v>2.2364667090537978E-3</c:v>
                </c:pt>
                <c:pt idx="15">
                  <c:v>6.0910312325580503E-4</c:v>
                </c:pt>
                <c:pt idx="16">
                  <c:v>6.7582548704604728E-3</c:v>
                </c:pt>
                <c:pt idx="17">
                  <c:v>2.7040649992812551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322816"/>
        <c:axId val="216324352"/>
      </c:scatterChart>
      <c:valAx>
        <c:axId val="21632281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/>
            </a:pPr>
            <a:endParaRPr lang="ko-KR"/>
          </a:p>
        </c:txPr>
        <c:crossAx val="216324352"/>
        <c:crosses val="autoZero"/>
        <c:crossBetween val="midCat"/>
        <c:majorUnit val="4"/>
      </c:valAx>
      <c:valAx>
        <c:axId val="21632435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1632281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24:$J$29</c:f>
                <c:numCache>
                  <c:formatCode>General</c:formatCode>
                  <c:ptCount val="6"/>
                  <c:pt idx="0">
                    <c:v>6.2922751173759795E-3</c:v>
                  </c:pt>
                  <c:pt idx="1">
                    <c:v>2.2905776663481045E-3</c:v>
                  </c:pt>
                  <c:pt idx="2">
                    <c:v>7.9018673756832357E-5</c:v>
                  </c:pt>
                  <c:pt idx="3">
                    <c:v>5.1250253216028908E-6</c:v>
                  </c:pt>
                  <c:pt idx="4">
                    <c:v>2.2973132211726406E-6</c:v>
                  </c:pt>
                  <c:pt idx="5">
                    <c:v>1.0644150955955041E-3</c:v>
                  </c:pt>
                </c:numCache>
              </c:numRef>
            </c:plus>
            <c:minus>
              <c:numRef>
                <c:f>Sheet4!$J$24:$J$29</c:f>
                <c:numCache>
                  <c:formatCode>General</c:formatCode>
                  <c:ptCount val="6"/>
                  <c:pt idx="0">
                    <c:v>6.2922751173759795E-3</c:v>
                  </c:pt>
                  <c:pt idx="1">
                    <c:v>2.2905776663481045E-3</c:v>
                  </c:pt>
                  <c:pt idx="2">
                    <c:v>7.9018673756832357E-5</c:v>
                  </c:pt>
                  <c:pt idx="3">
                    <c:v>5.1250253216028908E-6</c:v>
                  </c:pt>
                  <c:pt idx="4">
                    <c:v>2.2973132211726406E-6</c:v>
                  </c:pt>
                  <c:pt idx="5">
                    <c:v>1.0644150955955041E-3</c:v>
                  </c:pt>
                </c:numCache>
              </c:numRef>
            </c:minus>
          </c:errBars>
          <c:xVal>
            <c:numRef>
              <c:f>Sheet4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H$24:$H$29</c:f>
              <c:numCache>
                <c:formatCode>General</c:formatCode>
                <c:ptCount val="6"/>
                <c:pt idx="0">
                  <c:v>8.9442784891408667E-2</c:v>
                </c:pt>
                <c:pt idx="1">
                  <c:v>1.9055907330613502E-2</c:v>
                </c:pt>
                <c:pt idx="2">
                  <c:v>8.7509712292059268E-4</c:v>
                </c:pt>
                <c:pt idx="3">
                  <c:v>1.4236389109977945E-4</c:v>
                </c:pt>
                <c:pt idx="4">
                  <c:v>1.5243210965686119E-5</c:v>
                </c:pt>
                <c:pt idx="5">
                  <c:v>4.3828923077909136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072128"/>
        <c:axId val="255073664"/>
      </c:scatterChart>
      <c:valAx>
        <c:axId val="25507212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5073664"/>
        <c:crosses val="autoZero"/>
        <c:crossBetween val="midCat"/>
        <c:majorUnit val="4"/>
      </c:valAx>
      <c:valAx>
        <c:axId val="25507366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507212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1.2235568635293229E-3</c:v>
                  </c:pt>
                  <c:pt idx="1">
                    <c:v>6.5507977378925471E-4</c:v>
                  </c:pt>
                  <c:pt idx="2">
                    <c:v>6.1912451800899678E-4</c:v>
                  </c:pt>
                  <c:pt idx="3">
                    <c:v>9.2925379046766236E-4</c:v>
                  </c:pt>
                  <c:pt idx="4">
                    <c:v>6.1302161163432939E-4</c:v>
                  </c:pt>
                  <c:pt idx="5">
                    <c:v>6.7834658052614248E-4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1.2235568635293229E-3</c:v>
                  </c:pt>
                  <c:pt idx="1">
                    <c:v>6.5507977378925471E-4</c:v>
                  </c:pt>
                  <c:pt idx="2">
                    <c:v>6.1912451800899678E-4</c:v>
                  </c:pt>
                  <c:pt idx="3">
                    <c:v>9.2925379046766236E-4</c:v>
                  </c:pt>
                  <c:pt idx="4">
                    <c:v>6.1302161163432939E-4</c:v>
                  </c:pt>
                  <c:pt idx="5">
                    <c:v>6.7834658052614248E-4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9.9318587731662897E-3</c:v>
                </c:pt>
                <c:pt idx="1">
                  <c:v>1.1345053434628638E-2</c:v>
                </c:pt>
                <c:pt idx="2">
                  <c:v>1.7519552098692211E-2</c:v>
                </c:pt>
                <c:pt idx="3">
                  <c:v>1.0874207483288248E-2</c:v>
                </c:pt>
                <c:pt idx="4">
                  <c:v>8.1521012795176991E-3</c:v>
                </c:pt>
                <c:pt idx="5">
                  <c:v>1.1908735827542531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122432"/>
        <c:axId val="255132416"/>
      </c:scatterChart>
      <c:valAx>
        <c:axId val="25512243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132416"/>
        <c:crosses val="autoZero"/>
        <c:crossBetween val="midCat"/>
        <c:majorUnit val="4"/>
      </c:valAx>
      <c:valAx>
        <c:axId val="255132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51224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/>
              <a:t>ELF3 </a:t>
            </a:r>
            <a:r>
              <a:rPr lang="en-US" altLang="en-US" dirty="0" smtClean="0"/>
              <a:t>; At2g25930</a:t>
            </a:r>
            <a:endParaRPr lang="en-US" altLang="en-US" dirty="0"/>
          </a:p>
        </c:rich>
      </c:tx>
      <c:layout>
        <c:manualLayout>
          <c:xMode val="edge"/>
          <c:yMode val="edge"/>
          <c:x val="0.2207609973160877"/>
          <c:y val="0.13994519932567898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3270864640770921"/>
          <c:y val="6.5299809682982046E-2"/>
          <c:w val="0.82171849326683066"/>
          <c:h val="0.7812300746776927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9:$B$9</c:f>
              <c:strCache>
                <c:ptCount val="1"/>
                <c:pt idx="0">
                  <c:v>ELF3 At2g2593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9:$V$9</c:f>
                <c:numCache>
                  <c:formatCode>General</c:formatCode>
                  <c:ptCount val="6"/>
                  <c:pt idx="0">
                    <c:v>0.18405005355074519</c:v>
                  </c:pt>
                  <c:pt idx="1">
                    <c:v>0.21495224163786442</c:v>
                  </c:pt>
                  <c:pt idx="2">
                    <c:v>0.15664505195297224</c:v>
                  </c:pt>
                  <c:pt idx="3">
                    <c:v>9.9248213738672569E-3</c:v>
                  </c:pt>
                  <c:pt idx="4">
                    <c:v>0.15128757057177225</c:v>
                  </c:pt>
                  <c:pt idx="5">
                    <c:v>0.12109529517239047</c:v>
                  </c:pt>
                </c:numCache>
              </c:numRef>
            </c:plus>
            <c:minus>
              <c:numRef>
                <c:f>Sheet4!$Q$9:$V$9</c:f>
                <c:numCache>
                  <c:formatCode>General</c:formatCode>
                  <c:ptCount val="6"/>
                  <c:pt idx="0">
                    <c:v>0.18405005355074519</c:v>
                  </c:pt>
                  <c:pt idx="1">
                    <c:v>0.21495224163786442</c:v>
                  </c:pt>
                  <c:pt idx="2">
                    <c:v>0.15664505195297224</c:v>
                  </c:pt>
                  <c:pt idx="3">
                    <c:v>9.9248213738672569E-3</c:v>
                  </c:pt>
                  <c:pt idx="4">
                    <c:v>0.15128757057177225</c:v>
                  </c:pt>
                  <c:pt idx="5">
                    <c:v>0.12109529517239047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9:$H$9</c:f>
              <c:numCache>
                <c:formatCode>General</c:formatCode>
                <c:ptCount val="6"/>
                <c:pt idx="0">
                  <c:v>8.3589496700000048</c:v>
                </c:pt>
                <c:pt idx="1">
                  <c:v>6.4756444240000057</c:v>
                </c:pt>
                <c:pt idx="2">
                  <c:v>9.1082144296666652</c:v>
                </c:pt>
                <c:pt idx="3">
                  <c:v>9.4579893603333325</c:v>
                </c:pt>
                <c:pt idx="4">
                  <c:v>9.8364435276666793</c:v>
                </c:pt>
                <c:pt idx="5">
                  <c:v>9.930488925666672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799616"/>
        <c:axId val="250801152"/>
      </c:scatterChart>
      <c:valAx>
        <c:axId val="25079961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801152"/>
        <c:crosses val="autoZero"/>
        <c:crossBetween val="midCat"/>
        <c:majorUnit val="4"/>
      </c:valAx>
      <c:valAx>
        <c:axId val="250801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79961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5.763655606694847E-4</c:v>
                  </c:pt>
                  <c:pt idx="1">
                    <c:v>1.7088264831893855E-3</c:v>
                  </c:pt>
                  <c:pt idx="2">
                    <c:v>1.5520178082443787E-3</c:v>
                  </c:pt>
                  <c:pt idx="3">
                    <c:v>2.2521475964832741E-3</c:v>
                  </c:pt>
                  <c:pt idx="4">
                    <c:v>3.7670831120710719E-4</c:v>
                  </c:pt>
                  <c:pt idx="5">
                    <c:v>6.8862195565417032E-4</c:v>
                  </c:pt>
                  <c:pt idx="6">
                    <c:v>2.0471965662432197E-3</c:v>
                  </c:pt>
                  <c:pt idx="7">
                    <c:v>9.7120251773973509E-4</c:v>
                  </c:pt>
                  <c:pt idx="8">
                    <c:v>2.0457450994746597E-3</c:v>
                  </c:pt>
                  <c:pt idx="9">
                    <c:v>2.72282209740604E-4</c:v>
                  </c:pt>
                  <c:pt idx="10">
                    <c:v>2.2671291796852168E-4</c:v>
                  </c:pt>
                  <c:pt idx="11">
                    <c:v>4.6283566388821722E-4</c:v>
                  </c:pt>
                  <c:pt idx="12">
                    <c:v>7.7306117669843054E-4</c:v>
                  </c:pt>
                  <c:pt idx="13">
                    <c:v>1.3411508878379617E-3</c:v>
                  </c:pt>
                  <c:pt idx="14">
                    <c:v>6.3101836406091391E-4</c:v>
                  </c:pt>
                  <c:pt idx="15">
                    <c:v>1.6015052496996575E-3</c:v>
                  </c:pt>
                  <c:pt idx="16">
                    <c:v>9.6444598461351667E-4</c:v>
                  </c:pt>
                  <c:pt idx="17">
                    <c:v>3.8255454684125751E-4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5.763655606694847E-4</c:v>
                  </c:pt>
                  <c:pt idx="1">
                    <c:v>1.7088264831893855E-3</c:v>
                  </c:pt>
                  <c:pt idx="2">
                    <c:v>1.5520178082443787E-3</c:v>
                  </c:pt>
                  <c:pt idx="3">
                    <c:v>2.2521475964832741E-3</c:v>
                  </c:pt>
                  <c:pt idx="4">
                    <c:v>3.7670831120710719E-4</c:v>
                  </c:pt>
                  <c:pt idx="5">
                    <c:v>6.8862195565417032E-4</c:v>
                  </c:pt>
                  <c:pt idx="6">
                    <c:v>2.0471965662432197E-3</c:v>
                  </c:pt>
                  <c:pt idx="7">
                    <c:v>9.7120251773973509E-4</c:v>
                  </c:pt>
                  <c:pt idx="8">
                    <c:v>2.0457450994746597E-3</c:v>
                  </c:pt>
                  <c:pt idx="9">
                    <c:v>2.72282209740604E-4</c:v>
                  </c:pt>
                  <c:pt idx="10">
                    <c:v>2.2671291796852168E-4</c:v>
                  </c:pt>
                  <c:pt idx="11">
                    <c:v>4.6283566388821722E-4</c:v>
                  </c:pt>
                  <c:pt idx="12">
                    <c:v>7.7306117669843054E-4</c:v>
                  </c:pt>
                  <c:pt idx="13">
                    <c:v>1.3411508878379617E-3</c:v>
                  </c:pt>
                  <c:pt idx="14">
                    <c:v>6.3101836406091391E-4</c:v>
                  </c:pt>
                  <c:pt idx="15">
                    <c:v>1.6015052496996575E-3</c:v>
                  </c:pt>
                  <c:pt idx="16">
                    <c:v>9.6444598461351667E-4</c:v>
                  </c:pt>
                  <c:pt idx="17">
                    <c:v>3.8255454684125751E-4</c:v>
                  </c:pt>
                </c:numCache>
              </c:numRef>
            </c:minus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9.9683859709800253E-3</c:v>
                </c:pt>
                <c:pt idx="1">
                  <c:v>6.318818741809909E-3</c:v>
                </c:pt>
                <c:pt idx="2">
                  <c:v>8.640073158053322E-3</c:v>
                </c:pt>
                <c:pt idx="3">
                  <c:v>1.7418295073666688E-2</c:v>
                </c:pt>
                <c:pt idx="4">
                  <c:v>9.5885518811691228E-3</c:v>
                </c:pt>
                <c:pt idx="5">
                  <c:v>7.5907328884223437E-3</c:v>
                </c:pt>
                <c:pt idx="6">
                  <c:v>1.8329883105085324E-2</c:v>
                </c:pt>
                <c:pt idx="7">
                  <c:v>9.3429221317967194E-3</c:v>
                </c:pt>
                <c:pt idx="8">
                  <c:v>1.0103917366165761E-2</c:v>
                </c:pt>
                <c:pt idx="9">
                  <c:v>7.7325875077816023E-3</c:v>
                </c:pt>
                <c:pt idx="10">
                  <c:v>6.0256331157382661E-3</c:v>
                </c:pt>
                <c:pt idx="11">
                  <c:v>5.9845668840247746E-3</c:v>
                </c:pt>
                <c:pt idx="12">
                  <c:v>1.1102744041688871E-2</c:v>
                </c:pt>
                <c:pt idx="13">
                  <c:v>9.4745092039817506E-3</c:v>
                </c:pt>
                <c:pt idx="14">
                  <c:v>7.2279748495845874E-3</c:v>
                </c:pt>
                <c:pt idx="15">
                  <c:v>1.4515239899166497E-2</c:v>
                </c:pt>
                <c:pt idx="16">
                  <c:v>8.6897931575003525E-3</c:v>
                </c:pt>
                <c:pt idx="17">
                  <c:v>1.6486791016245162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144320"/>
        <c:axId val="255145856"/>
      </c:scatterChart>
      <c:valAx>
        <c:axId val="255144320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145856"/>
        <c:crosses val="autoZero"/>
        <c:crossBetween val="midCat"/>
        <c:majorUnit val="4"/>
      </c:valAx>
      <c:valAx>
        <c:axId val="255145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14432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5:$J$22</c:f>
                <c:numCache>
                  <c:formatCode>General</c:formatCode>
                  <c:ptCount val="18"/>
                  <c:pt idx="0">
                    <c:v>2.7406176369249805E-4</c:v>
                  </c:pt>
                  <c:pt idx="1">
                    <c:v>1.3477127815740195E-4</c:v>
                  </c:pt>
                  <c:pt idx="2">
                    <c:v>1.6730203106240744E-2</c:v>
                  </c:pt>
                  <c:pt idx="3">
                    <c:v>1.1183304805142383E-2</c:v>
                  </c:pt>
                  <c:pt idx="4">
                    <c:v>7.5485378472795106E-3</c:v>
                  </c:pt>
                  <c:pt idx="5">
                    <c:v>2.0446616990027902E-3</c:v>
                  </c:pt>
                  <c:pt idx="6">
                    <c:v>2.6420434233173439E-4</c:v>
                  </c:pt>
                  <c:pt idx="7">
                    <c:v>2.6718045026184194E-3</c:v>
                  </c:pt>
                  <c:pt idx="8">
                    <c:v>1.0996240819417821E-2</c:v>
                  </c:pt>
                  <c:pt idx="9">
                    <c:v>5.0826206513934484E-2</c:v>
                  </c:pt>
                  <c:pt idx="10">
                    <c:v>1.4840490747092455E-2</c:v>
                  </c:pt>
                  <c:pt idx="11">
                    <c:v>1.0762294100249898E-3</c:v>
                  </c:pt>
                  <c:pt idx="12">
                    <c:v>7.3631265248988583E-4</c:v>
                  </c:pt>
                  <c:pt idx="13">
                    <c:v>1.3614369815738699E-4</c:v>
                  </c:pt>
                  <c:pt idx="14">
                    <c:v>1.6396203846003217E-2</c:v>
                  </c:pt>
                  <c:pt idx="15">
                    <c:v>4.1511863397894075E-2</c:v>
                  </c:pt>
                  <c:pt idx="16">
                    <c:v>5.3129656368026143E-3</c:v>
                  </c:pt>
                  <c:pt idx="17">
                    <c:v>1.0206651433298977E-3</c:v>
                  </c:pt>
                </c:numCache>
              </c:numRef>
            </c:plus>
            <c:minus>
              <c:numRef>
                <c:f>Sheet4!$J$5:$J$22</c:f>
                <c:numCache>
                  <c:formatCode>General</c:formatCode>
                  <c:ptCount val="18"/>
                  <c:pt idx="0">
                    <c:v>2.7406176369249805E-4</c:v>
                  </c:pt>
                  <c:pt idx="1">
                    <c:v>1.3477127815740195E-4</c:v>
                  </c:pt>
                  <c:pt idx="2">
                    <c:v>1.6730203106240744E-2</c:v>
                  </c:pt>
                  <c:pt idx="3">
                    <c:v>1.1183304805142383E-2</c:v>
                  </c:pt>
                  <c:pt idx="4">
                    <c:v>7.5485378472795106E-3</c:v>
                  </c:pt>
                  <c:pt idx="5">
                    <c:v>2.0446616990027902E-3</c:v>
                  </c:pt>
                  <c:pt idx="6">
                    <c:v>2.6420434233173439E-4</c:v>
                  </c:pt>
                  <c:pt idx="7">
                    <c:v>2.6718045026184194E-3</c:v>
                  </c:pt>
                  <c:pt idx="8">
                    <c:v>1.0996240819417821E-2</c:v>
                  </c:pt>
                  <c:pt idx="9">
                    <c:v>5.0826206513934484E-2</c:v>
                  </c:pt>
                  <c:pt idx="10">
                    <c:v>1.4840490747092455E-2</c:v>
                  </c:pt>
                  <c:pt idx="11">
                    <c:v>1.0762294100249898E-3</c:v>
                  </c:pt>
                  <c:pt idx="12">
                    <c:v>7.3631265248988583E-4</c:v>
                  </c:pt>
                  <c:pt idx="13">
                    <c:v>1.3614369815738699E-4</c:v>
                  </c:pt>
                  <c:pt idx="14">
                    <c:v>1.6396203846003217E-2</c:v>
                  </c:pt>
                  <c:pt idx="15">
                    <c:v>4.1511863397894075E-2</c:v>
                  </c:pt>
                  <c:pt idx="16">
                    <c:v>5.3129656368026143E-3</c:v>
                  </c:pt>
                  <c:pt idx="17">
                    <c:v>1.0206651433298977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4!$H$5:$H$22</c:f>
              <c:numCache>
                <c:formatCode>General</c:formatCode>
                <c:ptCount val="18"/>
                <c:pt idx="0">
                  <c:v>1.2228425060168992E-3</c:v>
                </c:pt>
                <c:pt idx="1">
                  <c:v>2.4794565265478679E-3</c:v>
                </c:pt>
                <c:pt idx="2">
                  <c:v>0.13900319554420656</c:v>
                </c:pt>
                <c:pt idx="3">
                  <c:v>0.14649426933038137</c:v>
                </c:pt>
                <c:pt idx="4">
                  <c:v>2.8603074994389206E-2</c:v>
                </c:pt>
                <c:pt idx="5">
                  <c:v>9.0096437110655323E-3</c:v>
                </c:pt>
                <c:pt idx="6">
                  <c:v>4.4917984321522046E-3</c:v>
                </c:pt>
                <c:pt idx="7">
                  <c:v>1.0484956534150073E-2</c:v>
                </c:pt>
                <c:pt idx="8">
                  <c:v>0.29226086199162138</c:v>
                </c:pt>
                <c:pt idx="9">
                  <c:v>0.28073343826678576</c:v>
                </c:pt>
                <c:pt idx="10">
                  <c:v>6.4579606971120099E-2</c:v>
                </c:pt>
                <c:pt idx="11">
                  <c:v>8.8019307880463065E-3</c:v>
                </c:pt>
                <c:pt idx="12">
                  <c:v>6.3979235029906134E-3</c:v>
                </c:pt>
                <c:pt idx="13">
                  <c:v>5.8856315524033823E-2</c:v>
                </c:pt>
                <c:pt idx="14">
                  <c:v>0.29956618945526442</c:v>
                </c:pt>
                <c:pt idx="15">
                  <c:v>0.1286889937875329</c:v>
                </c:pt>
                <c:pt idx="16">
                  <c:v>4.6887701877559987E-2</c:v>
                </c:pt>
                <c:pt idx="17">
                  <c:v>1.3011625387420761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192064"/>
        <c:axId val="255214336"/>
      </c:scatterChart>
      <c:valAx>
        <c:axId val="25519206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3200" b="1"/>
            </a:pPr>
            <a:endParaRPr lang="ko-KR"/>
          </a:p>
        </c:txPr>
        <c:crossAx val="255214336"/>
        <c:crosses val="autoZero"/>
        <c:crossBetween val="midCat"/>
        <c:majorUnit val="4"/>
      </c:valAx>
      <c:valAx>
        <c:axId val="255214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3200" b="1"/>
            </a:pPr>
            <a:endParaRPr lang="ko-KR"/>
          </a:p>
        </c:txPr>
        <c:crossAx val="25519206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24:$J$29</c:f>
                <c:numCache>
                  <c:formatCode>General</c:formatCode>
                  <c:ptCount val="6"/>
                  <c:pt idx="0">
                    <c:v>1.622955385834973E-5</c:v>
                  </c:pt>
                  <c:pt idx="1">
                    <c:v>4.5782059112604375E-5</c:v>
                  </c:pt>
                  <c:pt idx="2">
                    <c:v>1.8935253504524584E-2</c:v>
                  </c:pt>
                  <c:pt idx="3">
                    <c:v>8.0487659068654932E-2</c:v>
                  </c:pt>
                  <c:pt idx="4">
                    <c:v>4.2932619744549894E-3</c:v>
                  </c:pt>
                  <c:pt idx="5">
                    <c:v>3.1598707980682655E-3</c:v>
                  </c:pt>
                </c:numCache>
              </c:numRef>
            </c:plus>
            <c:minus>
              <c:numRef>
                <c:f>Sheet4!$J$24:$J$29</c:f>
                <c:numCache>
                  <c:formatCode>General</c:formatCode>
                  <c:ptCount val="6"/>
                  <c:pt idx="0">
                    <c:v>1.622955385834973E-5</c:v>
                  </c:pt>
                  <c:pt idx="1">
                    <c:v>4.5782059112604375E-5</c:v>
                  </c:pt>
                  <c:pt idx="2">
                    <c:v>1.8935253504524584E-2</c:v>
                  </c:pt>
                  <c:pt idx="3">
                    <c:v>8.0487659068654932E-2</c:v>
                  </c:pt>
                  <c:pt idx="4">
                    <c:v>4.2932619744549894E-3</c:v>
                  </c:pt>
                  <c:pt idx="5">
                    <c:v>3.1598707980682655E-3</c:v>
                  </c:pt>
                </c:numCache>
              </c:numRef>
            </c:minus>
          </c:errBars>
          <c:xVal>
            <c:numRef>
              <c:f>Sheet4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H$24:$H$29</c:f>
              <c:numCache>
                <c:formatCode>General</c:formatCode>
                <c:ptCount val="6"/>
                <c:pt idx="0">
                  <c:v>6.0436022918892171E-4</c:v>
                </c:pt>
                <c:pt idx="1">
                  <c:v>1.3386928910144287E-3</c:v>
                </c:pt>
                <c:pt idx="2">
                  <c:v>0.37812818750476246</c:v>
                </c:pt>
                <c:pt idx="3">
                  <c:v>0.43487543667315298</c:v>
                </c:pt>
                <c:pt idx="4">
                  <c:v>2.501167491677805E-2</c:v>
                </c:pt>
                <c:pt idx="5">
                  <c:v>1.4032958354939186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226240"/>
        <c:axId val="255227776"/>
      </c:scatterChart>
      <c:valAx>
        <c:axId val="25522624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227776"/>
        <c:crosses val="autoZero"/>
        <c:crossBetween val="midCat"/>
        <c:majorUnit val="4"/>
      </c:valAx>
      <c:valAx>
        <c:axId val="255227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22624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3.1602183210518071E-7</c:v>
                  </c:pt>
                  <c:pt idx="1">
                    <c:v>7.7364700925934125E-6</c:v>
                  </c:pt>
                  <c:pt idx="2">
                    <c:v>9.4121428942885339E-4</c:v>
                  </c:pt>
                  <c:pt idx="3">
                    <c:v>2.5361161501094012E-3</c:v>
                  </c:pt>
                  <c:pt idx="4">
                    <c:v>1.3741556100859518E-5</c:v>
                  </c:pt>
                  <c:pt idx="5">
                    <c:v>6.9489224883003771E-7</c:v>
                  </c:pt>
                  <c:pt idx="6">
                    <c:v>2.1684653793297584E-6</c:v>
                  </c:pt>
                  <c:pt idx="7">
                    <c:v>3.8707731765153462E-6</c:v>
                  </c:pt>
                  <c:pt idx="8">
                    <c:v>1.3635844921503591E-4</c:v>
                  </c:pt>
                  <c:pt idx="9">
                    <c:v>3.3453599629204431E-4</c:v>
                  </c:pt>
                  <c:pt idx="10">
                    <c:v>7.1238842582989096E-5</c:v>
                  </c:pt>
                  <c:pt idx="11">
                    <c:v>7.4364330365715775E-6</c:v>
                  </c:pt>
                  <c:pt idx="12">
                    <c:v>1.9471124728570409E-6</c:v>
                  </c:pt>
                  <c:pt idx="13">
                    <c:v>4.6034370537317992E-5</c:v>
                  </c:pt>
                  <c:pt idx="14">
                    <c:v>2.0708457695032267E-3</c:v>
                  </c:pt>
                  <c:pt idx="15">
                    <c:v>6.547092233097476E-4</c:v>
                  </c:pt>
                  <c:pt idx="16">
                    <c:v>2.7650149196774951E-5</c:v>
                  </c:pt>
                  <c:pt idx="17">
                    <c:v>5.2091128682183104E-6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3.1602183210518071E-7</c:v>
                  </c:pt>
                  <c:pt idx="1">
                    <c:v>7.7364700925934125E-6</c:v>
                  </c:pt>
                  <c:pt idx="2">
                    <c:v>9.4121428942885339E-4</c:v>
                  </c:pt>
                  <c:pt idx="3">
                    <c:v>2.5361161501094012E-3</c:v>
                  </c:pt>
                  <c:pt idx="4">
                    <c:v>1.3741556100859518E-5</c:v>
                  </c:pt>
                  <c:pt idx="5">
                    <c:v>6.9489224883003771E-7</c:v>
                  </c:pt>
                  <c:pt idx="6">
                    <c:v>2.1684653793297584E-6</c:v>
                  </c:pt>
                  <c:pt idx="7">
                    <c:v>3.8707731765153462E-6</c:v>
                  </c:pt>
                  <c:pt idx="8">
                    <c:v>1.3635844921503591E-4</c:v>
                  </c:pt>
                  <c:pt idx="9">
                    <c:v>3.3453599629204431E-4</c:v>
                  </c:pt>
                  <c:pt idx="10">
                    <c:v>7.1238842582989096E-5</c:v>
                  </c:pt>
                  <c:pt idx="11">
                    <c:v>7.4364330365715775E-6</c:v>
                  </c:pt>
                  <c:pt idx="12">
                    <c:v>1.9471124728570409E-6</c:v>
                  </c:pt>
                  <c:pt idx="13">
                    <c:v>4.6034370537317992E-5</c:v>
                  </c:pt>
                  <c:pt idx="14">
                    <c:v>2.0708457695032267E-3</c:v>
                  </c:pt>
                  <c:pt idx="15">
                    <c:v>6.547092233097476E-4</c:v>
                  </c:pt>
                  <c:pt idx="16">
                    <c:v>2.7650149196774951E-5</c:v>
                  </c:pt>
                  <c:pt idx="17">
                    <c:v>5.2091128682183104E-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1.3512343880142665E-6</c:v>
                </c:pt>
                <c:pt idx="1">
                  <c:v>4.8963561071886805E-5</c:v>
                </c:pt>
                <c:pt idx="2">
                  <c:v>2.5195016759855652E-3</c:v>
                </c:pt>
                <c:pt idx="3">
                  <c:v>4.4882783589584698E-3</c:v>
                </c:pt>
                <c:pt idx="4">
                  <c:v>6.0836726312785446E-5</c:v>
                </c:pt>
                <c:pt idx="5">
                  <c:v>5.4444777508919927E-6</c:v>
                </c:pt>
                <c:pt idx="6">
                  <c:v>8.0763320618786724E-6</c:v>
                </c:pt>
                <c:pt idx="7">
                  <c:v>2.0719805355297715E-5</c:v>
                </c:pt>
                <c:pt idx="8">
                  <c:v>3.0849763510905274E-3</c:v>
                </c:pt>
                <c:pt idx="9">
                  <c:v>2.4879659968756566E-3</c:v>
                </c:pt>
                <c:pt idx="10">
                  <c:v>3.6596257155383898E-4</c:v>
                </c:pt>
                <c:pt idx="11">
                  <c:v>2.4670007696403559E-5</c:v>
                </c:pt>
                <c:pt idx="12">
                  <c:v>9.9555293195828416E-6</c:v>
                </c:pt>
                <c:pt idx="13">
                  <c:v>5.4341229437904052E-4</c:v>
                </c:pt>
                <c:pt idx="14">
                  <c:v>8.6624106036418246E-3</c:v>
                </c:pt>
                <c:pt idx="15">
                  <c:v>1.6136025622430663E-3</c:v>
                </c:pt>
                <c:pt idx="16">
                  <c:v>1.27433145245972E-4</c:v>
                </c:pt>
                <c:pt idx="17">
                  <c:v>1.883073353072092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272832"/>
        <c:axId val="255274368"/>
      </c:scatterChart>
      <c:valAx>
        <c:axId val="255272832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274368"/>
        <c:crosses val="autoZero"/>
        <c:crossBetween val="midCat"/>
        <c:majorUnit val="4"/>
      </c:valAx>
      <c:valAx>
        <c:axId val="255274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52728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6.630267573519979E-8</c:v>
                  </c:pt>
                  <c:pt idx="1">
                    <c:v>3.8041904746209411E-7</c:v>
                  </c:pt>
                  <c:pt idx="2">
                    <c:v>8.9271897723380679E-5</c:v>
                  </c:pt>
                  <c:pt idx="3">
                    <c:v>5.3834846954821673E-4</c:v>
                  </c:pt>
                  <c:pt idx="4">
                    <c:v>6.9472528410729438E-6</c:v>
                  </c:pt>
                  <c:pt idx="5">
                    <c:v>1.8704836318638337E-5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6.630267573519979E-8</c:v>
                  </c:pt>
                  <c:pt idx="1">
                    <c:v>3.8041904746209411E-7</c:v>
                  </c:pt>
                  <c:pt idx="2">
                    <c:v>8.9271897723380679E-5</c:v>
                  </c:pt>
                  <c:pt idx="3">
                    <c:v>5.3834846954821673E-4</c:v>
                  </c:pt>
                  <c:pt idx="4">
                    <c:v>6.9472528410729438E-6</c:v>
                  </c:pt>
                  <c:pt idx="5">
                    <c:v>1.8704836318638337E-5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2.5533245661128982E-7</c:v>
                </c:pt>
                <c:pt idx="1">
                  <c:v>3.0644895901229843E-6</c:v>
                </c:pt>
                <c:pt idx="2">
                  <c:v>4.0087617351471649E-3</c:v>
                </c:pt>
                <c:pt idx="3">
                  <c:v>7.3787745933724894E-3</c:v>
                </c:pt>
                <c:pt idx="4">
                  <c:v>2.6472094203062397E-5</c:v>
                </c:pt>
                <c:pt idx="5">
                  <c:v>5.8780738061693897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290368"/>
        <c:axId val="255308544"/>
      </c:scatterChart>
      <c:valAx>
        <c:axId val="25529036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308544"/>
        <c:crosses val="autoZero"/>
        <c:crossBetween val="midCat"/>
        <c:majorUnit val="4"/>
      </c:valAx>
      <c:valAx>
        <c:axId val="2553085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29036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1.6125509987917986E-4</c:v>
                  </c:pt>
                  <c:pt idx="1">
                    <c:v>3.7164730310971384E-3</c:v>
                  </c:pt>
                  <c:pt idx="2">
                    <c:v>3.5746792573088642E-3</c:v>
                  </c:pt>
                  <c:pt idx="3">
                    <c:v>1.0800297655694459E-3</c:v>
                  </c:pt>
                  <c:pt idx="4">
                    <c:v>1.942418893870924E-4</c:v>
                  </c:pt>
                  <c:pt idx="5">
                    <c:v>2.9651637644733453E-5</c:v>
                  </c:pt>
                  <c:pt idx="6">
                    <c:v>7.0644336359388133E-5</c:v>
                  </c:pt>
                  <c:pt idx="7">
                    <c:v>4.7480988837334925E-4</c:v>
                  </c:pt>
                  <c:pt idx="8">
                    <c:v>7.3283097621604134E-4</c:v>
                  </c:pt>
                  <c:pt idx="9">
                    <c:v>1.7275678062822642E-3</c:v>
                  </c:pt>
                  <c:pt idx="10">
                    <c:v>7.4415491879564896E-4</c:v>
                  </c:pt>
                  <c:pt idx="11">
                    <c:v>6.6393869348242116E-5</c:v>
                  </c:pt>
                  <c:pt idx="12">
                    <c:v>6.5601034606567693E-4</c:v>
                  </c:pt>
                  <c:pt idx="13">
                    <c:v>2.6502720675293085E-3</c:v>
                  </c:pt>
                  <c:pt idx="14">
                    <c:v>2.8874488737815943E-3</c:v>
                  </c:pt>
                  <c:pt idx="15">
                    <c:v>3.0039479982822215E-3</c:v>
                  </c:pt>
                  <c:pt idx="16">
                    <c:v>4.0784932720174118E-4</c:v>
                  </c:pt>
                  <c:pt idx="17">
                    <c:v>1.4855354844200066E-4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1.6125509987917986E-4</c:v>
                  </c:pt>
                  <c:pt idx="1">
                    <c:v>3.7164730310971384E-3</c:v>
                  </c:pt>
                  <c:pt idx="2">
                    <c:v>3.5746792573088642E-3</c:v>
                  </c:pt>
                  <c:pt idx="3">
                    <c:v>1.0800297655694459E-3</c:v>
                  </c:pt>
                  <c:pt idx="4">
                    <c:v>1.942418893870924E-4</c:v>
                  </c:pt>
                  <c:pt idx="5">
                    <c:v>2.9651637644733453E-5</c:v>
                  </c:pt>
                  <c:pt idx="6">
                    <c:v>7.0644336359388133E-5</c:v>
                  </c:pt>
                  <c:pt idx="7">
                    <c:v>4.7480988837334925E-4</c:v>
                  </c:pt>
                  <c:pt idx="8">
                    <c:v>7.3283097621604134E-4</c:v>
                  </c:pt>
                  <c:pt idx="9">
                    <c:v>1.7275678062822642E-3</c:v>
                  </c:pt>
                  <c:pt idx="10">
                    <c:v>7.4415491879564896E-4</c:v>
                  </c:pt>
                  <c:pt idx="11">
                    <c:v>6.6393869348242116E-5</c:v>
                  </c:pt>
                  <c:pt idx="12">
                    <c:v>6.5601034606567693E-4</c:v>
                  </c:pt>
                  <c:pt idx="13">
                    <c:v>2.6502720675293085E-3</c:v>
                  </c:pt>
                  <c:pt idx="14">
                    <c:v>2.8874488737815943E-3</c:v>
                  </c:pt>
                  <c:pt idx="15">
                    <c:v>3.0039479982822215E-3</c:v>
                  </c:pt>
                  <c:pt idx="16">
                    <c:v>4.0784932720174118E-4</c:v>
                  </c:pt>
                  <c:pt idx="17">
                    <c:v>1.4855354844200066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3.3719860153063398E-4</c:v>
                </c:pt>
                <c:pt idx="1">
                  <c:v>6.3124433413597929E-3</c:v>
                </c:pt>
                <c:pt idx="2">
                  <c:v>1.978830881435233E-2</c:v>
                </c:pt>
                <c:pt idx="3">
                  <c:v>1.459118833859132E-2</c:v>
                </c:pt>
                <c:pt idx="4">
                  <c:v>7.1062926480272408E-4</c:v>
                </c:pt>
                <c:pt idx="5">
                  <c:v>2.4906624962772874E-4</c:v>
                </c:pt>
                <c:pt idx="6">
                  <c:v>4.1853307788208084E-4</c:v>
                </c:pt>
                <c:pt idx="7">
                  <c:v>1.9093491123157997E-3</c:v>
                </c:pt>
                <c:pt idx="8">
                  <c:v>1.5094288279431088E-2</c:v>
                </c:pt>
                <c:pt idx="9">
                  <c:v>4.5981415534163484E-3</c:v>
                </c:pt>
                <c:pt idx="10">
                  <c:v>2.0468584776396994E-3</c:v>
                </c:pt>
                <c:pt idx="11">
                  <c:v>7.1588195903082722E-4</c:v>
                </c:pt>
                <c:pt idx="12">
                  <c:v>1.7676803460954049E-3</c:v>
                </c:pt>
                <c:pt idx="13">
                  <c:v>9.9116512784819914E-3</c:v>
                </c:pt>
                <c:pt idx="14">
                  <c:v>1.2536575095526761E-2</c:v>
                </c:pt>
                <c:pt idx="15">
                  <c:v>7.7754662755245918E-3</c:v>
                </c:pt>
                <c:pt idx="16">
                  <c:v>2.6729922203140451E-3</c:v>
                </c:pt>
                <c:pt idx="17">
                  <c:v>1.7651956460021094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333120"/>
        <c:axId val="255334656"/>
      </c:scatterChart>
      <c:valAx>
        <c:axId val="255333120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5334656"/>
        <c:crosses val="autoZero"/>
        <c:crossBetween val="midCat"/>
        <c:majorUnit val="4"/>
      </c:valAx>
      <c:valAx>
        <c:axId val="2553346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533312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8.8947666892847095E-6</c:v>
                  </c:pt>
                  <c:pt idx="1">
                    <c:v>2.7184585581060299E-4</c:v>
                  </c:pt>
                  <c:pt idx="2">
                    <c:v>3.7989719189876063E-4</c:v>
                  </c:pt>
                  <c:pt idx="3">
                    <c:v>1.0755477563299967E-3</c:v>
                  </c:pt>
                  <c:pt idx="4">
                    <c:v>7.3378266392707685E-5</c:v>
                  </c:pt>
                  <c:pt idx="5">
                    <c:v>4.7268932134440234E-5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8.8947666892847095E-6</c:v>
                  </c:pt>
                  <c:pt idx="1">
                    <c:v>2.7184585581060299E-4</c:v>
                  </c:pt>
                  <c:pt idx="2">
                    <c:v>3.7989719189876063E-4</c:v>
                  </c:pt>
                  <c:pt idx="3">
                    <c:v>1.0755477563299967E-3</c:v>
                  </c:pt>
                  <c:pt idx="4">
                    <c:v>7.3378266392707685E-5</c:v>
                  </c:pt>
                  <c:pt idx="5">
                    <c:v>4.7268932134440234E-5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7.4006036370156963E-5</c:v>
                </c:pt>
                <c:pt idx="1">
                  <c:v>3.7759816112001407E-3</c:v>
                </c:pt>
                <c:pt idx="2">
                  <c:v>7.0615987457508002E-3</c:v>
                </c:pt>
                <c:pt idx="3">
                  <c:v>7.0186010281307843E-3</c:v>
                </c:pt>
                <c:pt idx="4">
                  <c:v>1.8336330761794851E-3</c:v>
                </c:pt>
                <c:pt idx="5">
                  <c:v>3.6017357083474068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354752"/>
        <c:axId val="255356288"/>
      </c:scatterChart>
      <c:valAx>
        <c:axId val="25535475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356288"/>
        <c:crosses val="autoZero"/>
        <c:crossBetween val="midCat"/>
        <c:majorUnit val="4"/>
      </c:valAx>
      <c:valAx>
        <c:axId val="2553562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01600">
            <a:solidFill>
              <a:prstClr val="black"/>
            </a:solidFill>
          </a:ln>
        </c:spPr>
        <c:crossAx val="25535475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6!$I$5:$I$22</c:f>
                <c:numCache>
                  <c:formatCode>General</c:formatCode>
                  <c:ptCount val="18"/>
                  <c:pt idx="0">
                    <c:v>2.0344856021717061E-3</c:v>
                  </c:pt>
                  <c:pt idx="1">
                    <c:v>2.3801968140908996E-2</c:v>
                  </c:pt>
                  <c:pt idx="2">
                    <c:v>2.958535314493397E-3</c:v>
                  </c:pt>
                  <c:pt idx="3">
                    <c:v>1.5147555186821521E-3</c:v>
                  </c:pt>
                  <c:pt idx="4">
                    <c:v>3.5506973309538486E-4</c:v>
                  </c:pt>
                  <c:pt idx="5">
                    <c:v>3.474812741307678E-4</c:v>
                  </c:pt>
                  <c:pt idx="6">
                    <c:v>2.5558075143588778E-3</c:v>
                  </c:pt>
                  <c:pt idx="7">
                    <c:v>7.7713557090719476E-3</c:v>
                  </c:pt>
                  <c:pt idx="8">
                    <c:v>9.2917767474752829E-3</c:v>
                  </c:pt>
                  <c:pt idx="9">
                    <c:v>4.4267516121200374E-3</c:v>
                  </c:pt>
                  <c:pt idx="10">
                    <c:v>7.0400145016970804E-4</c:v>
                  </c:pt>
                  <c:pt idx="11">
                    <c:v>6.8353010109695905E-4</c:v>
                  </c:pt>
                  <c:pt idx="12">
                    <c:v>8.8083176165778525E-3</c:v>
                  </c:pt>
                  <c:pt idx="13">
                    <c:v>2.950603231915551E-3</c:v>
                  </c:pt>
                  <c:pt idx="14">
                    <c:v>2.8969812893371739E-3</c:v>
                  </c:pt>
                  <c:pt idx="15">
                    <c:v>2.0575972331866063E-3</c:v>
                  </c:pt>
                  <c:pt idx="16">
                    <c:v>6.9187890253057173E-5</c:v>
                  </c:pt>
                  <c:pt idx="17">
                    <c:v>5.3075581185734106E-4</c:v>
                  </c:pt>
                </c:numCache>
              </c:numRef>
            </c:plus>
            <c:minus>
              <c:numRef>
                <c:f>Sheet6!$I$5:$I$22</c:f>
                <c:numCache>
                  <c:formatCode>General</c:formatCode>
                  <c:ptCount val="18"/>
                  <c:pt idx="0">
                    <c:v>2.0344856021717061E-3</c:v>
                  </c:pt>
                  <c:pt idx="1">
                    <c:v>2.3801968140908996E-2</c:v>
                  </c:pt>
                  <c:pt idx="2">
                    <c:v>2.958535314493397E-3</c:v>
                  </c:pt>
                  <c:pt idx="3">
                    <c:v>1.5147555186821521E-3</c:v>
                  </c:pt>
                  <c:pt idx="4">
                    <c:v>3.5506973309538486E-4</c:v>
                  </c:pt>
                  <c:pt idx="5">
                    <c:v>3.474812741307678E-4</c:v>
                  </c:pt>
                  <c:pt idx="6">
                    <c:v>2.5558075143588778E-3</c:v>
                  </c:pt>
                  <c:pt idx="7">
                    <c:v>7.7713557090719476E-3</c:v>
                  </c:pt>
                  <c:pt idx="8">
                    <c:v>9.2917767474752829E-3</c:v>
                  </c:pt>
                  <c:pt idx="9">
                    <c:v>4.4267516121200374E-3</c:v>
                  </c:pt>
                  <c:pt idx="10">
                    <c:v>7.0400145016970804E-4</c:v>
                  </c:pt>
                  <c:pt idx="11">
                    <c:v>6.8353010109695905E-4</c:v>
                  </c:pt>
                  <c:pt idx="12">
                    <c:v>8.8083176165778525E-3</c:v>
                  </c:pt>
                  <c:pt idx="13">
                    <c:v>2.950603231915551E-3</c:v>
                  </c:pt>
                  <c:pt idx="14">
                    <c:v>2.8969812893371739E-3</c:v>
                  </c:pt>
                  <c:pt idx="15">
                    <c:v>2.0575972331866063E-3</c:v>
                  </c:pt>
                  <c:pt idx="16">
                    <c:v>6.9187890253057173E-5</c:v>
                  </c:pt>
                  <c:pt idx="17">
                    <c:v>5.3075581185734106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6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6!$G$5:$G$22</c:f>
              <c:numCache>
                <c:formatCode>General</c:formatCode>
                <c:ptCount val="18"/>
                <c:pt idx="0">
                  <c:v>8.7663140024145086E-3</c:v>
                </c:pt>
                <c:pt idx="1">
                  <c:v>0.12943662174740381</c:v>
                </c:pt>
                <c:pt idx="2">
                  <c:v>4.3595631739112094E-2</c:v>
                </c:pt>
                <c:pt idx="3">
                  <c:v>1.4736508414399141E-2</c:v>
                </c:pt>
                <c:pt idx="4">
                  <c:v>1.7994066315139641E-3</c:v>
                </c:pt>
                <c:pt idx="5">
                  <c:v>2.9779265802999163E-3</c:v>
                </c:pt>
                <c:pt idx="6">
                  <c:v>1.9730117170833401E-2</c:v>
                </c:pt>
                <c:pt idx="7">
                  <c:v>4.7028314878862221E-2</c:v>
                </c:pt>
                <c:pt idx="8">
                  <c:v>0.19037116501294787</c:v>
                </c:pt>
                <c:pt idx="9">
                  <c:v>3.0739051004420051E-2</c:v>
                </c:pt>
                <c:pt idx="10">
                  <c:v>3.437239856071442E-3</c:v>
                </c:pt>
                <c:pt idx="11">
                  <c:v>3.827272806912899E-3</c:v>
                </c:pt>
                <c:pt idx="12">
                  <c:v>6.4922943389870938E-2</c:v>
                </c:pt>
                <c:pt idx="13">
                  <c:v>6.3806910560000499E-2</c:v>
                </c:pt>
                <c:pt idx="14">
                  <c:v>5.778698705913804E-2</c:v>
                </c:pt>
                <c:pt idx="15">
                  <c:v>9.8700473628898725E-3</c:v>
                </c:pt>
                <c:pt idx="16">
                  <c:v>3.9346236468379234E-3</c:v>
                </c:pt>
                <c:pt idx="17">
                  <c:v>1.6155755811857388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397248"/>
        <c:axId val="255403136"/>
      </c:scatterChart>
      <c:valAx>
        <c:axId val="255397248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403136"/>
        <c:crosses val="autoZero"/>
        <c:crossBetween val="midCat"/>
        <c:majorUnit val="4"/>
      </c:valAx>
      <c:valAx>
        <c:axId val="255403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39724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6!$I$24:$I$29</c:f>
                <c:numCache>
                  <c:formatCode>General</c:formatCode>
                  <c:ptCount val="6"/>
                  <c:pt idx="0">
                    <c:v>7.5519206036473168E-4</c:v>
                  </c:pt>
                  <c:pt idx="1">
                    <c:v>2.5342544284370195E-3</c:v>
                  </c:pt>
                  <c:pt idx="2">
                    <c:v>7.4088835512589584E-3</c:v>
                  </c:pt>
                  <c:pt idx="3">
                    <c:v>8.4476607734993521E-4</c:v>
                  </c:pt>
                  <c:pt idx="4">
                    <c:v>2.536626593193548E-5</c:v>
                  </c:pt>
                  <c:pt idx="5">
                    <c:v>1.9581589177589316E-5</c:v>
                  </c:pt>
                </c:numCache>
              </c:numRef>
            </c:plus>
            <c:minus>
              <c:numRef>
                <c:f>Sheet6!$I$24:$I$29</c:f>
                <c:numCache>
                  <c:formatCode>General</c:formatCode>
                  <c:ptCount val="6"/>
                  <c:pt idx="0">
                    <c:v>7.5519206036473168E-4</c:v>
                  </c:pt>
                  <c:pt idx="1">
                    <c:v>2.5342544284370195E-3</c:v>
                  </c:pt>
                  <c:pt idx="2">
                    <c:v>7.4088835512589584E-3</c:v>
                  </c:pt>
                  <c:pt idx="3">
                    <c:v>8.4476607734993521E-4</c:v>
                  </c:pt>
                  <c:pt idx="4">
                    <c:v>2.536626593193548E-5</c:v>
                  </c:pt>
                  <c:pt idx="5">
                    <c:v>1.9581589177589316E-5</c:v>
                  </c:pt>
                </c:numCache>
              </c:numRef>
            </c:minus>
          </c:errBars>
          <c:xVal>
            <c:numRef>
              <c:f>Sheet6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6!$G$24:$G$29</c:f>
              <c:numCache>
                <c:formatCode>General</c:formatCode>
                <c:ptCount val="6"/>
                <c:pt idx="0">
                  <c:v>5.6309425882473934E-3</c:v>
                </c:pt>
                <c:pt idx="1">
                  <c:v>4.6418117325610901E-2</c:v>
                </c:pt>
                <c:pt idx="2">
                  <c:v>0.23028114637403421</c:v>
                </c:pt>
                <c:pt idx="3">
                  <c:v>3.6840017871685449E-2</c:v>
                </c:pt>
                <c:pt idx="4">
                  <c:v>3.0141603918580802E-4</c:v>
                </c:pt>
                <c:pt idx="5">
                  <c:v>1.5069115373040045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427328"/>
        <c:axId val="255428864"/>
      </c:scatterChart>
      <c:valAx>
        <c:axId val="25542732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5428864"/>
        <c:crosses val="autoZero"/>
        <c:crossBetween val="midCat"/>
        <c:majorUnit val="4"/>
      </c:valAx>
      <c:valAx>
        <c:axId val="2554288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42732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5:$J$22</c:f>
                <c:numCache>
                  <c:formatCode>General</c:formatCode>
                  <c:ptCount val="18"/>
                  <c:pt idx="0">
                    <c:v>5.5133700866085324E-5</c:v>
                  </c:pt>
                  <c:pt idx="1">
                    <c:v>2.0709630735022281E-4</c:v>
                  </c:pt>
                  <c:pt idx="2">
                    <c:v>4.7043783717940118E-3</c:v>
                  </c:pt>
                  <c:pt idx="3">
                    <c:v>6.311447464480397E-4</c:v>
                  </c:pt>
                  <c:pt idx="4">
                    <c:v>1.7333001204305905E-3</c:v>
                  </c:pt>
                  <c:pt idx="5">
                    <c:v>6.5836295188146494E-4</c:v>
                  </c:pt>
                  <c:pt idx="6">
                    <c:v>9.6579821225161236E-5</c:v>
                  </c:pt>
                  <c:pt idx="7">
                    <c:v>6.2860338437527123E-4</c:v>
                  </c:pt>
                  <c:pt idx="8">
                    <c:v>6.368140291904874E-3</c:v>
                  </c:pt>
                  <c:pt idx="9">
                    <c:v>1.1668390684053149E-3</c:v>
                  </c:pt>
                  <c:pt idx="10">
                    <c:v>2.4163518008698181E-3</c:v>
                  </c:pt>
                  <c:pt idx="11">
                    <c:v>9.7493976227299567E-4</c:v>
                  </c:pt>
                  <c:pt idx="12">
                    <c:v>7.2547514004359733E-4</c:v>
                  </c:pt>
                  <c:pt idx="13">
                    <c:v>5.0251027733877853E-3</c:v>
                  </c:pt>
                  <c:pt idx="14">
                    <c:v>1.6701853200948011E-2</c:v>
                  </c:pt>
                  <c:pt idx="15">
                    <c:v>1.1654483168061421E-2</c:v>
                  </c:pt>
                  <c:pt idx="16">
                    <c:v>1.9578280589724789E-4</c:v>
                  </c:pt>
                  <c:pt idx="17">
                    <c:v>4.451997370643352E-4</c:v>
                  </c:pt>
                </c:numCache>
              </c:numRef>
            </c:plus>
            <c:minus>
              <c:numRef>
                <c:f>Sheet4!$J$5:$J$22</c:f>
                <c:numCache>
                  <c:formatCode>General</c:formatCode>
                  <c:ptCount val="18"/>
                  <c:pt idx="0">
                    <c:v>5.5133700866085324E-5</c:v>
                  </c:pt>
                  <c:pt idx="1">
                    <c:v>2.0709630735022281E-4</c:v>
                  </c:pt>
                  <c:pt idx="2">
                    <c:v>4.7043783717940118E-3</c:v>
                  </c:pt>
                  <c:pt idx="3">
                    <c:v>6.311447464480397E-4</c:v>
                  </c:pt>
                  <c:pt idx="4">
                    <c:v>1.7333001204305905E-3</c:v>
                  </c:pt>
                  <c:pt idx="5">
                    <c:v>6.5836295188146494E-4</c:v>
                  </c:pt>
                  <c:pt idx="6">
                    <c:v>9.6579821225161236E-5</c:v>
                  </c:pt>
                  <c:pt idx="7">
                    <c:v>6.2860338437527123E-4</c:v>
                  </c:pt>
                  <c:pt idx="8">
                    <c:v>6.368140291904874E-3</c:v>
                  </c:pt>
                  <c:pt idx="9">
                    <c:v>1.1668390684053149E-3</c:v>
                  </c:pt>
                  <c:pt idx="10">
                    <c:v>2.4163518008698181E-3</c:v>
                  </c:pt>
                  <c:pt idx="11">
                    <c:v>9.7493976227299567E-4</c:v>
                  </c:pt>
                  <c:pt idx="12">
                    <c:v>7.2547514004359733E-4</c:v>
                  </c:pt>
                  <c:pt idx="13">
                    <c:v>5.0251027733877853E-3</c:v>
                  </c:pt>
                  <c:pt idx="14">
                    <c:v>1.6701853200948011E-2</c:v>
                  </c:pt>
                  <c:pt idx="15">
                    <c:v>1.1654483168061421E-2</c:v>
                  </c:pt>
                  <c:pt idx="16">
                    <c:v>1.9578280589724789E-4</c:v>
                  </c:pt>
                  <c:pt idx="17">
                    <c:v>4.451997370643352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H$5:$H$22</c:f>
              <c:numCache>
                <c:formatCode>General</c:formatCode>
                <c:ptCount val="18"/>
                <c:pt idx="0">
                  <c:v>3.5748011037432808E-4</c:v>
                </c:pt>
                <c:pt idx="1">
                  <c:v>2.3797373103523478E-3</c:v>
                </c:pt>
                <c:pt idx="2">
                  <c:v>2.1249886419776532E-2</c:v>
                </c:pt>
                <c:pt idx="3">
                  <c:v>2.0769863182278393E-3</c:v>
                </c:pt>
                <c:pt idx="4">
                  <c:v>5.1239700129010633E-3</c:v>
                </c:pt>
                <c:pt idx="5">
                  <c:v>4.0031988654837631E-3</c:v>
                </c:pt>
                <c:pt idx="6">
                  <c:v>8.2170937066872206E-4</c:v>
                </c:pt>
                <c:pt idx="7">
                  <c:v>1.5067017120199116E-3</c:v>
                </c:pt>
                <c:pt idx="8">
                  <c:v>8.073921929463039E-2</c:v>
                </c:pt>
                <c:pt idx="9">
                  <c:v>4.1736616114235467E-3</c:v>
                </c:pt>
                <c:pt idx="10">
                  <c:v>7.6219380378122264E-3</c:v>
                </c:pt>
                <c:pt idx="11">
                  <c:v>3.2277475166493752E-3</c:v>
                </c:pt>
                <c:pt idx="12">
                  <c:v>2.6921592813900115E-3</c:v>
                </c:pt>
                <c:pt idx="13">
                  <c:v>2.0700922714999296E-2</c:v>
                </c:pt>
                <c:pt idx="14">
                  <c:v>3.0413938431176207E-2</c:v>
                </c:pt>
                <c:pt idx="15">
                  <c:v>1.6728745354592661E-2</c:v>
                </c:pt>
                <c:pt idx="16">
                  <c:v>4.6320328379432446E-3</c:v>
                </c:pt>
                <c:pt idx="17">
                  <c:v>1.2033476120186124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501056"/>
        <c:axId val="255502592"/>
      </c:scatterChart>
      <c:valAx>
        <c:axId val="25550105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5502592"/>
        <c:crosses val="autoZero"/>
        <c:crossBetween val="midCat"/>
        <c:majorUnit val="4"/>
      </c:valAx>
      <c:valAx>
        <c:axId val="25550259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550105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312719882975965E-2"/>
          <c:y val="6.7301212489799936E-2"/>
          <c:w val="0.90848165439530293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12</c:f>
              <c:strCache>
                <c:ptCount val="1"/>
                <c:pt idx="0">
                  <c:v>Bra005541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2:$K$12</c:f>
              <c:numCache>
                <c:formatCode>General</c:formatCode>
                <c:ptCount val="7"/>
                <c:pt idx="0">
                  <c:v>16.146000000000001</c:v>
                </c:pt>
                <c:pt idx="1">
                  <c:v>31.322000000000003</c:v>
                </c:pt>
                <c:pt idx="2">
                  <c:v>24.891500000000001</c:v>
                </c:pt>
                <c:pt idx="3">
                  <c:v>17.641999999999999</c:v>
                </c:pt>
                <c:pt idx="4">
                  <c:v>13.913</c:v>
                </c:pt>
                <c:pt idx="5">
                  <c:v>17.684999999999999</c:v>
                </c:pt>
                <c:pt idx="6">
                  <c:v>15.77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13</c:f>
              <c:strCache>
                <c:ptCount val="1"/>
                <c:pt idx="0">
                  <c:v>Bra021818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3:$K$13</c:f>
              <c:numCache>
                <c:formatCode>General</c:formatCode>
                <c:ptCount val="7"/>
                <c:pt idx="0">
                  <c:v>2.7500000000000011E-2</c:v>
                </c:pt>
                <c:pt idx="1">
                  <c:v>2.8500000000000001E-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699136"/>
        <c:axId val="250700928"/>
      </c:scatterChart>
      <c:valAx>
        <c:axId val="25069913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700928"/>
        <c:crosses val="autoZero"/>
        <c:crossBetween val="midCat"/>
        <c:majorUnit val="4"/>
      </c:valAx>
      <c:valAx>
        <c:axId val="250700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6991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4105747126436791"/>
          <c:y val="0.50698268546912151"/>
          <c:w val="0.34321777486147581"/>
          <c:h val="0.225074346655582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24:$J$29</c:f>
                <c:numCache>
                  <c:formatCode>General</c:formatCode>
                  <c:ptCount val="6"/>
                  <c:pt idx="0">
                    <c:v>9.7224641112469427E-6</c:v>
                  </c:pt>
                  <c:pt idx="1">
                    <c:v>6.4366593706156395E-4</c:v>
                  </c:pt>
                  <c:pt idx="2">
                    <c:v>9.3380664121119096E-3</c:v>
                  </c:pt>
                  <c:pt idx="3">
                    <c:v>2.8159033571870448E-4</c:v>
                  </c:pt>
                  <c:pt idx="4">
                    <c:v>4.9515302309740921E-4</c:v>
                  </c:pt>
                  <c:pt idx="5">
                    <c:v>4.2668629455083773E-4</c:v>
                  </c:pt>
                </c:numCache>
              </c:numRef>
            </c:plus>
            <c:minus>
              <c:numRef>
                <c:f>Sheet4!$J$24:$J$29</c:f>
                <c:numCache>
                  <c:formatCode>General</c:formatCode>
                  <c:ptCount val="6"/>
                  <c:pt idx="0">
                    <c:v>9.7224641112469427E-6</c:v>
                  </c:pt>
                  <c:pt idx="1">
                    <c:v>6.4366593706156395E-4</c:v>
                  </c:pt>
                  <c:pt idx="2">
                    <c:v>9.3380664121119096E-3</c:v>
                  </c:pt>
                  <c:pt idx="3">
                    <c:v>2.8159033571870448E-4</c:v>
                  </c:pt>
                  <c:pt idx="4">
                    <c:v>4.9515302309740921E-4</c:v>
                  </c:pt>
                  <c:pt idx="5">
                    <c:v>4.2668629455083773E-4</c:v>
                  </c:pt>
                </c:numCache>
              </c:numRef>
            </c:minus>
          </c:errBars>
          <c:xVal>
            <c:numRef>
              <c:f>Sheet4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H$24:$H$29</c:f>
              <c:numCache>
                <c:formatCode>General</c:formatCode>
                <c:ptCount val="6"/>
                <c:pt idx="0">
                  <c:v>1.755987329807272E-4</c:v>
                </c:pt>
                <c:pt idx="1">
                  <c:v>5.065627637348206E-3</c:v>
                </c:pt>
                <c:pt idx="2">
                  <c:v>7.57626426090591E-2</c:v>
                </c:pt>
                <c:pt idx="3">
                  <c:v>8.2107870712294292E-3</c:v>
                </c:pt>
                <c:pt idx="4">
                  <c:v>3.495354144482596E-3</c:v>
                </c:pt>
                <c:pt idx="5">
                  <c:v>3.3369946526278452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523072"/>
        <c:axId val="254808064"/>
      </c:scatterChart>
      <c:valAx>
        <c:axId val="25552307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808064"/>
        <c:crosses val="autoZero"/>
        <c:crossBetween val="midCat"/>
        <c:majorUnit val="4"/>
      </c:valAx>
      <c:valAx>
        <c:axId val="25480806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52307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3.3231980544507432E-6</c:v>
                  </c:pt>
                  <c:pt idx="1">
                    <c:v>1.2539117483630161E-5</c:v>
                  </c:pt>
                  <c:pt idx="2">
                    <c:v>7.6477931007114914E-5</c:v>
                  </c:pt>
                  <c:pt idx="3">
                    <c:v>3.0244563942083866E-6</c:v>
                  </c:pt>
                  <c:pt idx="4">
                    <c:v>7.8771246634498149E-7</c:v>
                  </c:pt>
                  <c:pt idx="5">
                    <c:v>3.0429055971451226E-6</c:v>
                  </c:pt>
                  <c:pt idx="6">
                    <c:v>7.8232921126911538E-7</c:v>
                  </c:pt>
                  <c:pt idx="7">
                    <c:v>1.2879845937392481E-6</c:v>
                  </c:pt>
                  <c:pt idx="8">
                    <c:v>1.8321957337451579E-4</c:v>
                  </c:pt>
                  <c:pt idx="9">
                    <c:v>6.9428987107037876E-6</c:v>
                  </c:pt>
                  <c:pt idx="10">
                    <c:v>8.5167733713559533E-6</c:v>
                  </c:pt>
                  <c:pt idx="11">
                    <c:v>1.1523703175970621E-5</c:v>
                  </c:pt>
                  <c:pt idx="12">
                    <c:v>4.2682166362528912E-5</c:v>
                  </c:pt>
                  <c:pt idx="13">
                    <c:v>1.0720692038284023E-4</c:v>
                  </c:pt>
                  <c:pt idx="14">
                    <c:v>2.6131041807384703E-4</c:v>
                  </c:pt>
                  <c:pt idx="15">
                    <c:v>4.4953106955111896E-5</c:v>
                  </c:pt>
                  <c:pt idx="16">
                    <c:v>7.9372619843756256E-6</c:v>
                  </c:pt>
                  <c:pt idx="17">
                    <c:v>6.8899624669611055E-6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3.3231980544507432E-6</c:v>
                  </c:pt>
                  <c:pt idx="1">
                    <c:v>1.2539117483630161E-5</c:v>
                  </c:pt>
                  <c:pt idx="2">
                    <c:v>7.6477931007114914E-5</c:v>
                  </c:pt>
                  <c:pt idx="3">
                    <c:v>3.0244563942083866E-6</c:v>
                  </c:pt>
                  <c:pt idx="4">
                    <c:v>7.8771246634498149E-7</c:v>
                  </c:pt>
                  <c:pt idx="5">
                    <c:v>3.0429055971451226E-6</c:v>
                  </c:pt>
                  <c:pt idx="6">
                    <c:v>7.8232921126911538E-7</c:v>
                  </c:pt>
                  <c:pt idx="7">
                    <c:v>1.2879845937392481E-6</c:v>
                  </c:pt>
                  <c:pt idx="8">
                    <c:v>1.8321957337451579E-4</c:v>
                  </c:pt>
                  <c:pt idx="9">
                    <c:v>6.9428987107037876E-6</c:v>
                  </c:pt>
                  <c:pt idx="10">
                    <c:v>8.5167733713559533E-6</c:v>
                  </c:pt>
                  <c:pt idx="11">
                    <c:v>1.1523703175970621E-5</c:v>
                  </c:pt>
                  <c:pt idx="12">
                    <c:v>4.2682166362528912E-5</c:v>
                  </c:pt>
                  <c:pt idx="13">
                    <c:v>1.0720692038284023E-4</c:v>
                  </c:pt>
                  <c:pt idx="14">
                    <c:v>2.6131041807384703E-4</c:v>
                  </c:pt>
                  <c:pt idx="15">
                    <c:v>4.4953106955111896E-5</c:v>
                  </c:pt>
                  <c:pt idx="16">
                    <c:v>7.9372619843756256E-6</c:v>
                  </c:pt>
                  <c:pt idx="17">
                    <c:v>6.8899624669611055E-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1.0488220298807717E-5</c:v>
                </c:pt>
                <c:pt idx="1">
                  <c:v>1.4075462699692705E-4</c:v>
                </c:pt>
                <c:pt idx="2">
                  <c:v>5.6151933080654287E-4</c:v>
                </c:pt>
                <c:pt idx="3">
                  <c:v>1.161659941422106E-5</c:v>
                </c:pt>
                <c:pt idx="4">
                  <c:v>3.6037756707351528E-6</c:v>
                </c:pt>
                <c:pt idx="5">
                  <c:v>2.0252045486926314E-5</c:v>
                </c:pt>
                <c:pt idx="6">
                  <c:v>1.1642507879294974E-5</c:v>
                </c:pt>
                <c:pt idx="7">
                  <c:v>1.2088302433662889E-5</c:v>
                </c:pt>
                <c:pt idx="8">
                  <c:v>2.0392348667079866E-3</c:v>
                </c:pt>
                <c:pt idx="9">
                  <c:v>2.836743777768366E-5</c:v>
                </c:pt>
                <c:pt idx="10">
                  <c:v>1.5159390888468166E-5</c:v>
                </c:pt>
                <c:pt idx="11">
                  <c:v>1.9390648358360316E-5</c:v>
                </c:pt>
                <c:pt idx="12">
                  <c:v>7.9126080186715477E-5</c:v>
                </c:pt>
                <c:pt idx="13">
                  <c:v>8.3787999522727346E-4</c:v>
                </c:pt>
                <c:pt idx="14">
                  <c:v>5.4961429842889577E-4</c:v>
                </c:pt>
                <c:pt idx="15">
                  <c:v>9.6818138676630746E-5</c:v>
                </c:pt>
                <c:pt idx="16">
                  <c:v>3.2618629729270132E-5</c:v>
                </c:pt>
                <c:pt idx="17">
                  <c:v>2.0794014732880478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840192"/>
        <c:axId val="254841984"/>
      </c:scatterChart>
      <c:valAx>
        <c:axId val="254840192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841984"/>
        <c:crosses val="autoZero"/>
        <c:crossBetween val="midCat"/>
        <c:majorUnit val="4"/>
      </c:valAx>
      <c:valAx>
        <c:axId val="2548419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txPr>
          <a:bodyPr/>
          <a:lstStyle/>
          <a:p>
            <a:pPr>
              <a:defRPr sz="3200" b="1"/>
            </a:pPr>
            <a:endParaRPr lang="ko-KR"/>
          </a:p>
        </c:txPr>
        <c:crossAx val="25484019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926565699049352"/>
          <c:y val="7.4548702245552642E-2"/>
          <c:w val="0.82496397556356171"/>
          <c:h val="0.8603886605192016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1.366541833567965E-6</c:v>
                  </c:pt>
                  <c:pt idx="1">
                    <c:v>3.1684823215956696E-5</c:v>
                  </c:pt>
                  <c:pt idx="2">
                    <c:v>4.6330908233720142E-4</c:v>
                  </c:pt>
                  <c:pt idx="3">
                    <c:v>2.5687637497168889E-6</c:v>
                  </c:pt>
                  <c:pt idx="4">
                    <c:v>2.3411169036632286E-7</c:v>
                  </c:pt>
                  <c:pt idx="5">
                    <c:v>1.6535392624648058E-6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1.366541833567965E-6</c:v>
                  </c:pt>
                  <c:pt idx="1">
                    <c:v>3.1684823215956696E-5</c:v>
                  </c:pt>
                  <c:pt idx="2">
                    <c:v>4.6330908233720142E-4</c:v>
                  </c:pt>
                  <c:pt idx="3">
                    <c:v>2.5687637497168889E-6</c:v>
                  </c:pt>
                  <c:pt idx="4">
                    <c:v>2.3411169036632286E-7</c:v>
                  </c:pt>
                  <c:pt idx="5">
                    <c:v>1.6535392624648058E-6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1.41976028573368E-5</c:v>
                </c:pt>
                <c:pt idx="1">
                  <c:v>1.9707465952467767E-4</c:v>
                </c:pt>
                <c:pt idx="2">
                  <c:v>2.5438781825661552E-3</c:v>
                </c:pt>
                <c:pt idx="3">
                  <c:v>4.6932495798476761E-5</c:v>
                </c:pt>
                <c:pt idx="4">
                  <c:v>4.7295857325741739E-6</c:v>
                </c:pt>
                <c:pt idx="5">
                  <c:v>1.1341292811155841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862080"/>
        <c:axId val="254863616"/>
      </c:scatterChart>
      <c:valAx>
        <c:axId val="25486208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863616"/>
        <c:crosses val="autoZero"/>
        <c:crossBetween val="midCat"/>
        <c:majorUnit val="4"/>
      </c:valAx>
      <c:valAx>
        <c:axId val="254863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86208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4!$G$22</c:f>
              <c:strCache>
                <c:ptCount val="1"/>
                <c:pt idx="0">
                  <c:v>Aver</c:v>
                </c:pt>
              </c:strCache>
            </c:strRef>
          </c:tx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3:$I$28</c:f>
                <c:numCache>
                  <c:formatCode>General</c:formatCode>
                  <c:ptCount val="6"/>
                  <c:pt idx="0">
                    <c:v>7.5519206036473168E-4</c:v>
                  </c:pt>
                  <c:pt idx="1">
                    <c:v>2.5342544284370195E-3</c:v>
                  </c:pt>
                  <c:pt idx="2">
                    <c:v>7.4088835512589584E-3</c:v>
                  </c:pt>
                  <c:pt idx="3">
                    <c:v>8.4476607734993521E-4</c:v>
                  </c:pt>
                  <c:pt idx="4">
                    <c:v>2.536626593193548E-5</c:v>
                  </c:pt>
                  <c:pt idx="5">
                    <c:v>1.9581589177589316E-5</c:v>
                  </c:pt>
                </c:numCache>
              </c:numRef>
            </c:plus>
            <c:minus>
              <c:numRef>
                <c:f>Sheet4!$I$23:$I$28</c:f>
                <c:numCache>
                  <c:formatCode>General</c:formatCode>
                  <c:ptCount val="6"/>
                  <c:pt idx="0">
                    <c:v>7.5519206036473168E-4</c:v>
                  </c:pt>
                  <c:pt idx="1">
                    <c:v>2.5342544284370195E-3</c:v>
                  </c:pt>
                  <c:pt idx="2">
                    <c:v>7.4088835512589584E-3</c:v>
                  </c:pt>
                  <c:pt idx="3">
                    <c:v>8.4476607734993521E-4</c:v>
                  </c:pt>
                  <c:pt idx="4">
                    <c:v>2.536626593193548E-5</c:v>
                  </c:pt>
                  <c:pt idx="5">
                    <c:v>1.9581589177589316E-5</c:v>
                  </c:pt>
                </c:numCache>
              </c:numRef>
            </c:minus>
          </c:errBars>
          <c:xVal>
            <c:numRef>
              <c:f>Sheet4!$F$23:$F$28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3:$G$28</c:f>
              <c:numCache>
                <c:formatCode>General</c:formatCode>
                <c:ptCount val="6"/>
                <c:pt idx="0">
                  <c:v>5.6309425882473934E-3</c:v>
                </c:pt>
                <c:pt idx="1">
                  <c:v>4.6418117325610901E-2</c:v>
                </c:pt>
                <c:pt idx="2">
                  <c:v>0.23028114637403421</c:v>
                </c:pt>
                <c:pt idx="3">
                  <c:v>3.6840017871685449E-2</c:v>
                </c:pt>
                <c:pt idx="4">
                  <c:v>3.0141603918580802E-4</c:v>
                </c:pt>
                <c:pt idx="5">
                  <c:v>1.5069115373040045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953344"/>
        <c:axId val="254954880"/>
      </c:scatterChart>
      <c:valAx>
        <c:axId val="25495334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954880"/>
        <c:crosses val="autoZero"/>
        <c:crossBetween val="midCat"/>
        <c:majorUnit val="4"/>
      </c:valAx>
      <c:valAx>
        <c:axId val="254954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9533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3503905665071017E-2"/>
          <c:y val="8.8578491278747021E-2"/>
          <c:w val="0.92993871755795254"/>
          <c:h val="0.8463589230826204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4!$I$4:$I$21</c:f>
                <c:numCache>
                  <c:formatCode>General</c:formatCode>
                  <c:ptCount val="18"/>
                  <c:pt idx="0">
                    <c:v>2.0344856021717061E-3</c:v>
                  </c:pt>
                  <c:pt idx="1">
                    <c:v>2.3801968140908996E-2</c:v>
                  </c:pt>
                  <c:pt idx="2">
                    <c:v>2.958535314493397E-3</c:v>
                  </c:pt>
                  <c:pt idx="3">
                    <c:v>1.5147555186821521E-3</c:v>
                  </c:pt>
                  <c:pt idx="4">
                    <c:v>3.5506973309538486E-4</c:v>
                  </c:pt>
                  <c:pt idx="5">
                    <c:v>3.474812741307678E-4</c:v>
                  </c:pt>
                  <c:pt idx="6">
                    <c:v>2.5558075143588778E-3</c:v>
                  </c:pt>
                  <c:pt idx="7">
                    <c:v>7.7713557090719476E-3</c:v>
                  </c:pt>
                  <c:pt idx="8">
                    <c:v>9.2917767474752829E-3</c:v>
                  </c:pt>
                  <c:pt idx="9">
                    <c:v>4.4267516121200374E-3</c:v>
                  </c:pt>
                  <c:pt idx="10">
                    <c:v>7.0400145016970804E-4</c:v>
                  </c:pt>
                  <c:pt idx="11">
                    <c:v>6.8353010109695905E-4</c:v>
                  </c:pt>
                  <c:pt idx="12">
                    <c:v>8.8083176165778525E-3</c:v>
                  </c:pt>
                  <c:pt idx="13">
                    <c:v>2.950603231915551E-3</c:v>
                  </c:pt>
                  <c:pt idx="14">
                    <c:v>2.8969812893371739E-3</c:v>
                  </c:pt>
                  <c:pt idx="15">
                    <c:v>2.0575972331866063E-3</c:v>
                  </c:pt>
                  <c:pt idx="16">
                    <c:v>6.9187890253057173E-5</c:v>
                  </c:pt>
                  <c:pt idx="17">
                    <c:v>5.3075581185734106E-4</c:v>
                  </c:pt>
                </c:numCache>
              </c:numRef>
            </c:plus>
            <c:minus>
              <c:numRef>
                <c:f>Sheet4!$I$4:$I$21</c:f>
                <c:numCache>
                  <c:formatCode>General</c:formatCode>
                  <c:ptCount val="18"/>
                  <c:pt idx="0">
                    <c:v>2.0344856021717061E-3</c:v>
                  </c:pt>
                  <c:pt idx="1">
                    <c:v>2.3801968140908996E-2</c:v>
                  </c:pt>
                  <c:pt idx="2">
                    <c:v>2.958535314493397E-3</c:v>
                  </c:pt>
                  <c:pt idx="3">
                    <c:v>1.5147555186821521E-3</c:v>
                  </c:pt>
                  <c:pt idx="4">
                    <c:v>3.5506973309538486E-4</c:v>
                  </c:pt>
                  <c:pt idx="5">
                    <c:v>3.474812741307678E-4</c:v>
                  </c:pt>
                  <c:pt idx="6">
                    <c:v>2.5558075143588778E-3</c:v>
                  </c:pt>
                  <c:pt idx="7">
                    <c:v>7.7713557090719476E-3</c:v>
                  </c:pt>
                  <c:pt idx="8">
                    <c:v>9.2917767474752829E-3</c:v>
                  </c:pt>
                  <c:pt idx="9">
                    <c:v>4.4267516121200374E-3</c:v>
                  </c:pt>
                  <c:pt idx="10">
                    <c:v>7.0400145016970804E-4</c:v>
                  </c:pt>
                  <c:pt idx="11">
                    <c:v>6.8353010109695905E-4</c:v>
                  </c:pt>
                  <c:pt idx="12">
                    <c:v>8.8083176165778525E-3</c:v>
                  </c:pt>
                  <c:pt idx="13">
                    <c:v>2.950603231915551E-3</c:v>
                  </c:pt>
                  <c:pt idx="14">
                    <c:v>2.8969812893371739E-3</c:v>
                  </c:pt>
                  <c:pt idx="15">
                    <c:v>2.0575972331866063E-3</c:v>
                  </c:pt>
                  <c:pt idx="16">
                    <c:v>6.9187890253057173E-5</c:v>
                  </c:pt>
                  <c:pt idx="17">
                    <c:v>5.3075581185734106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4:$F$21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4:$G$21</c:f>
              <c:numCache>
                <c:formatCode>General</c:formatCode>
                <c:ptCount val="18"/>
                <c:pt idx="0">
                  <c:v>8.7663140024145086E-3</c:v>
                </c:pt>
                <c:pt idx="1">
                  <c:v>0.12943662174740381</c:v>
                </c:pt>
                <c:pt idx="2">
                  <c:v>4.3595631739112094E-2</c:v>
                </c:pt>
                <c:pt idx="3">
                  <c:v>1.4736508414399141E-2</c:v>
                </c:pt>
                <c:pt idx="4">
                  <c:v>1.7994066315139641E-3</c:v>
                </c:pt>
                <c:pt idx="5">
                  <c:v>2.9779265802999163E-3</c:v>
                </c:pt>
                <c:pt idx="6">
                  <c:v>1.9730117170833401E-2</c:v>
                </c:pt>
                <c:pt idx="7">
                  <c:v>4.7028314878862221E-2</c:v>
                </c:pt>
                <c:pt idx="8">
                  <c:v>0.19037116501294787</c:v>
                </c:pt>
                <c:pt idx="9">
                  <c:v>3.0739051004420051E-2</c:v>
                </c:pt>
                <c:pt idx="10">
                  <c:v>3.437239856071442E-3</c:v>
                </c:pt>
                <c:pt idx="11">
                  <c:v>3.827272806912899E-3</c:v>
                </c:pt>
                <c:pt idx="12">
                  <c:v>6.4922943389870938E-2</c:v>
                </c:pt>
                <c:pt idx="13">
                  <c:v>6.3806910560000499E-2</c:v>
                </c:pt>
                <c:pt idx="14">
                  <c:v>5.778698705913804E-2</c:v>
                </c:pt>
                <c:pt idx="15">
                  <c:v>9.8700473628898725E-3</c:v>
                </c:pt>
                <c:pt idx="16">
                  <c:v>3.9346236468379234E-3</c:v>
                </c:pt>
                <c:pt idx="17">
                  <c:v>1.6155755811857388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979456"/>
        <c:axId val="254997632"/>
      </c:scatterChart>
      <c:valAx>
        <c:axId val="25497945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997632"/>
        <c:crosses val="autoZero"/>
        <c:crossBetween val="midCat"/>
        <c:majorUnit val="4"/>
      </c:valAx>
      <c:valAx>
        <c:axId val="254997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97945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I$24:$I$29</c:f>
                <c:numCache>
                  <c:formatCode>General</c:formatCode>
                  <c:ptCount val="6"/>
                  <c:pt idx="0">
                    <c:v>1.1283703427881577E-5</c:v>
                  </c:pt>
                  <c:pt idx="1">
                    <c:v>1.6265390752146841E-3</c:v>
                  </c:pt>
                  <c:pt idx="2">
                    <c:v>3.2851972890397467E-3</c:v>
                  </c:pt>
                  <c:pt idx="3">
                    <c:v>5.1743494214611906E-3</c:v>
                  </c:pt>
                  <c:pt idx="4">
                    <c:v>1.0738331418584041E-4</c:v>
                  </c:pt>
                  <c:pt idx="5">
                    <c:v>1.0597384627792683E-4</c:v>
                  </c:pt>
                </c:numCache>
              </c:numRef>
            </c:plus>
            <c:minus>
              <c:numRef>
                <c:f>Sheet5!$I$24:$I$29</c:f>
                <c:numCache>
                  <c:formatCode>General</c:formatCode>
                  <c:ptCount val="6"/>
                  <c:pt idx="0">
                    <c:v>1.1283703427881577E-5</c:v>
                  </c:pt>
                  <c:pt idx="1">
                    <c:v>1.6265390752146841E-3</c:v>
                  </c:pt>
                  <c:pt idx="2">
                    <c:v>3.2851972890397467E-3</c:v>
                  </c:pt>
                  <c:pt idx="3">
                    <c:v>5.1743494214611906E-3</c:v>
                  </c:pt>
                  <c:pt idx="4">
                    <c:v>1.0738331418584041E-4</c:v>
                  </c:pt>
                  <c:pt idx="5">
                    <c:v>1.0597384627792683E-4</c:v>
                  </c:pt>
                </c:numCache>
              </c:numRef>
            </c:minus>
          </c:errBars>
          <c:xVal>
            <c:numRef>
              <c:f>Sheet5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5!$G$24:$G$29</c:f>
              <c:numCache>
                <c:formatCode>General</c:formatCode>
                <c:ptCount val="6"/>
                <c:pt idx="0">
                  <c:v>1.2908215106567549E-4</c:v>
                </c:pt>
                <c:pt idx="1">
                  <c:v>1.5682448267109052E-2</c:v>
                </c:pt>
                <c:pt idx="2">
                  <c:v>0.10841778896629088</c:v>
                </c:pt>
                <c:pt idx="3">
                  <c:v>5.2016778120268933E-2</c:v>
                </c:pt>
                <c:pt idx="4">
                  <c:v>4.596013675221224E-4</c:v>
                </c:pt>
                <c:pt idx="5">
                  <c:v>3.6185708328053182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550208"/>
        <c:axId val="255551744"/>
      </c:scatterChart>
      <c:valAx>
        <c:axId val="25555020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551744"/>
        <c:crosses val="autoZero"/>
        <c:crossBetween val="midCat"/>
        <c:majorUnit val="4"/>
      </c:valAx>
      <c:valAx>
        <c:axId val="255551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55020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I$5:$I$22</c:f>
                <c:numCache>
                  <c:formatCode>General</c:formatCode>
                  <c:ptCount val="18"/>
                  <c:pt idx="0">
                    <c:v>9.3897986641881394E-5</c:v>
                  </c:pt>
                  <c:pt idx="1">
                    <c:v>1.6090003740467254E-3</c:v>
                  </c:pt>
                  <c:pt idx="2">
                    <c:v>2.7473718261148412E-3</c:v>
                  </c:pt>
                  <c:pt idx="3">
                    <c:v>2.0668356136742667E-3</c:v>
                  </c:pt>
                  <c:pt idx="4">
                    <c:v>4.6818638015938704E-4</c:v>
                  </c:pt>
                  <c:pt idx="5">
                    <c:v>2.5584755811778795E-4</c:v>
                  </c:pt>
                  <c:pt idx="6">
                    <c:v>2.3074106415546286E-4</c:v>
                  </c:pt>
                  <c:pt idx="7">
                    <c:v>1.4693902973540779E-3</c:v>
                  </c:pt>
                  <c:pt idx="8">
                    <c:v>3.849771669620704E-3</c:v>
                  </c:pt>
                  <c:pt idx="9">
                    <c:v>1.669119461768604E-3</c:v>
                  </c:pt>
                  <c:pt idx="10">
                    <c:v>9.6080244555230248E-4</c:v>
                  </c:pt>
                  <c:pt idx="11">
                    <c:v>4.6833040528022912E-4</c:v>
                  </c:pt>
                  <c:pt idx="12">
                    <c:v>1.286803785188699E-3</c:v>
                  </c:pt>
                  <c:pt idx="13">
                    <c:v>8.1196930205383545E-4</c:v>
                  </c:pt>
                  <c:pt idx="14">
                    <c:v>1.3296457845679843E-3</c:v>
                  </c:pt>
                  <c:pt idx="15">
                    <c:v>1.630569163129378E-3</c:v>
                  </c:pt>
                  <c:pt idx="16">
                    <c:v>3.7332468462525207E-4</c:v>
                  </c:pt>
                  <c:pt idx="17">
                    <c:v>3.9548606833524205E-4</c:v>
                  </c:pt>
                </c:numCache>
              </c:numRef>
            </c:plus>
            <c:minus>
              <c:numRef>
                <c:f>Sheet5!$I$5:$I$22</c:f>
                <c:numCache>
                  <c:formatCode>General</c:formatCode>
                  <c:ptCount val="18"/>
                  <c:pt idx="0">
                    <c:v>9.3897986641881394E-5</c:v>
                  </c:pt>
                  <c:pt idx="1">
                    <c:v>1.6090003740467254E-3</c:v>
                  </c:pt>
                  <c:pt idx="2">
                    <c:v>2.7473718261148412E-3</c:v>
                  </c:pt>
                  <c:pt idx="3">
                    <c:v>2.0668356136742667E-3</c:v>
                  </c:pt>
                  <c:pt idx="4">
                    <c:v>4.6818638015938704E-4</c:v>
                  </c:pt>
                  <c:pt idx="5">
                    <c:v>2.5584755811778795E-4</c:v>
                  </c:pt>
                  <c:pt idx="6">
                    <c:v>2.3074106415546286E-4</c:v>
                  </c:pt>
                  <c:pt idx="7">
                    <c:v>1.4693902973540779E-3</c:v>
                  </c:pt>
                  <c:pt idx="8">
                    <c:v>3.849771669620704E-3</c:v>
                  </c:pt>
                  <c:pt idx="9">
                    <c:v>1.669119461768604E-3</c:v>
                  </c:pt>
                  <c:pt idx="10">
                    <c:v>9.6080244555230248E-4</c:v>
                  </c:pt>
                  <c:pt idx="11">
                    <c:v>4.6833040528022912E-4</c:v>
                  </c:pt>
                  <c:pt idx="12">
                    <c:v>1.286803785188699E-3</c:v>
                  </c:pt>
                  <c:pt idx="13">
                    <c:v>8.1196930205383545E-4</c:v>
                  </c:pt>
                  <c:pt idx="14">
                    <c:v>1.3296457845679843E-3</c:v>
                  </c:pt>
                  <c:pt idx="15">
                    <c:v>1.630569163129378E-3</c:v>
                  </c:pt>
                  <c:pt idx="16">
                    <c:v>3.7332468462525207E-4</c:v>
                  </c:pt>
                  <c:pt idx="17">
                    <c:v>3.9548606833524205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5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5!$G$5:$G$22</c:f>
              <c:numCache>
                <c:formatCode>General</c:formatCode>
                <c:ptCount val="18"/>
                <c:pt idx="0">
                  <c:v>3.3877162551700064E-4</c:v>
                </c:pt>
                <c:pt idx="1">
                  <c:v>2.8513651181964497E-2</c:v>
                </c:pt>
                <c:pt idx="2">
                  <c:v>3.9476832178932414E-2</c:v>
                </c:pt>
                <c:pt idx="3">
                  <c:v>1.7773105004731629E-2</c:v>
                </c:pt>
                <c:pt idx="4">
                  <c:v>2.1490695139960571E-3</c:v>
                </c:pt>
                <c:pt idx="5">
                  <c:v>1.5782778242829833E-3</c:v>
                </c:pt>
                <c:pt idx="6">
                  <c:v>2.8251431062705002E-3</c:v>
                </c:pt>
                <c:pt idx="7">
                  <c:v>8.7900057959422757E-3</c:v>
                </c:pt>
                <c:pt idx="8">
                  <c:v>7.1172906879432118E-2</c:v>
                </c:pt>
                <c:pt idx="9">
                  <c:v>1.6732980859176926E-2</c:v>
                </c:pt>
                <c:pt idx="10">
                  <c:v>4.4012756381891253E-3</c:v>
                </c:pt>
                <c:pt idx="11">
                  <c:v>2.7178089640165419E-3</c:v>
                </c:pt>
                <c:pt idx="12">
                  <c:v>7.8790866729228134E-3</c:v>
                </c:pt>
                <c:pt idx="13">
                  <c:v>3.3435519107077802E-2</c:v>
                </c:pt>
                <c:pt idx="14">
                  <c:v>4.6536329257100884E-2</c:v>
                </c:pt>
                <c:pt idx="15">
                  <c:v>9.8004259248729228E-3</c:v>
                </c:pt>
                <c:pt idx="16">
                  <c:v>3.9436522338403193E-3</c:v>
                </c:pt>
                <c:pt idx="17">
                  <c:v>5.5139257133344013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580416"/>
        <c:axId val="255582208"/>
      </c:scatterChart>
      <c:valAx>
        <c:axId val="25558041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582208"/>
        <c:crosses val="autoZero"/>
        <c:crossBetween val="midCat"/>
        <c:majorUnit val="4"/>
      </c:valAx>
      <c:valAx>
        <c:axId val="255582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58041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5500124528288073E-2"/>
          <c:y val="8.4728535064731367E-2"/>
          <c:w val="0.91672920386987111"/>
          <c:h val="0.84351126018677669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K$5:$K$22</c:f>
                <c:numCache>
                  <c:formatCode>General</c:formatCode>
                  <c:ptCount val="18"/>
                  <c:pt idx="0">
                    <c:v>1.5793471254522705E-6</c:v>
                  </c:pt>
                  <c:pt idx="1">
                    <c:v>6.8313662547599284E-5</c:v>
                  </c:pt>
                  <c:pt idx="2">
                    <c:v>7.8577428143254578E-7</c:v>
                  </c:pt>
                  <c:pt idx="3">
                    <c:v>1.3485484047033003E-7</c:v>
                  </c:pt>
                  <c:pt idx="4">
                    <c:v>1.9143374159548094E-8</c:v>
                  </c:pt>
                  <c:pt idx="5">
                    <c:v>1.8352532145550789E-8</c:v>
                  </c:pt>
                  <c:pt idx="6">
                    <c:v>3.1122630865282402E-6</c:v>
                  </c:pt>
                  <c:pt idx="7">
                    <c:v>4.3833685242898616E-5</c:v>
                  </c:pt>
                  <c:pt idx="8">
                    <c:v>1.9238949214796531E-5</c:v>
                  </c:pt>
                  <c:pt idx="9">
                    <c:v>1.1890347427693498E-7</c:v>
                  </c:pt>
                  <c:pt idx="10">
                    <c:v>9.470440814601143E-8</c:v>
                  </c:pt>
                  <c:pt idx="11">
                    <c:v>3.0973198324458664E-7</c:v>
                  </c:pt>
                  <c:pt idx="12">
                    <c:v>3.4410035546330186E-5</c:v>
                  </c:pt>
                  <c:pt idx="13">
                    <c:v>2.2137496085950576E-5</c:v>
                  </c:pt>
                  <c:pt idx="14">
                    <c:v>8.9933604755186654E-6</c:v>
                  </c:pt>
                  <c:pt idx="15">
                    <c:v>6.1895140091572352E-7</c:v>
                  </c:pt>
                  <c:pt idx="16">
                    <c:v>3.263607679559716E-7</c:v>
                  </c:pt>
                  <c:pt idx="17">
                    <c:v>1.6955762297471125E-6</c:v>
                  </c:pt>
                </c:numCache>
              </c:numRef>
            </c:plus>
            <c:minus>
              <c:numRef>
                <c:f>Sheet4!$K$5:$K$22</c:f>
                <c:numCache>
                  <c:formatCode>General</c:formatCode>
                  <c:ptCount val="18"/>
                  <c:pt idx="0">
                    <c:v>1.5793471254522705E-6</c:v>
                  </c:pt>
                  <c:pt idx="1">
                    <c:v>6.8313662547599284E-5</c:v>
                  </c:pt>
                  <c:pt idx="2">
                    <c:v>7.8577428143254578E-7</c:v>
                  </c:pt>
                  <c:pt idx="3">
                    <c:v>1.3485484047033003E-7</c:v>
                  </c:pt>
                  <c:pt idx="4">
                    <c:v>1.9143374159548094E-8</c:v>
                  </c:pt>
                  <c:pt idx="5">
                    <c:v>1.8352532145550789E-8</c:v>
                  </c:pt>
                  <c:pt idx="6">
                    <c:v>3.1122630865282402E-6</c:v>
                  </c:pt>
                  <c:pt idx="7">
                    <c:v>4.3833685242898616E-5</c:v>
                  </c:pt>
                  <c:pt idx="8">
                    <c:v>1.9238949214796531E-5</c:v>
                  </c:pt>
                  <c:pt idx="9">
                    <c:v>1.1890347427693498E-7</c:v>
                  </c:pt>
                  <c:pt idx="10">
                    <c:v>9.470440814601143E-8</c:v>
                  </c:pt>
                  <c:pt idx="11">
                    <c:v>3.0973198324458664E-7</c:v>
                  </c:pt>
                  <c:pt idx="12">
                    <c:v>3.4410035546330186E-5</c:v>
                  </c:pt>
                  <c:pt idx="13">
                    <c:v>2.2137496085950576E-5</c:v>
                  </c:pt>
                  <c:pt idx="14">
                    <c:v>8.9933604755186654E-6</c:v>
                  </c:pt>
                  <c:pt idx="15">
                    <c:v>6.1895140091572352E-7</c:v>
                  </c:pt>
                  <c:pt idx="16">
                    <c:v>3.263607679559716E-7</c:v>
                  </c:pt>
                  <c:pt idx="17">
                    <c:v>1.6955762297471125E-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H$5:$H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4!$I$5:$I$22</c:f>
              <c:numCache>
                <c:formatCode>General</c:formatCode>
                <c:ptCount val="18"/>
                <c:pt idx="0">
                  <c:v>4.2129429994022057E-6</c:v>
                </c:pt>
                <c:pt idx="1">
                  <c:v>1.9645208046987464E-3</c:v>
                </c:pt>
                <c:pt idx="2">
                  <c:v>2.0634558951611686E-5</c:v>
                </c:pt>
                <c:pt idx="3">
                  <c:v>4.2185113571845194E-7</c:v>
                </c:pt>
                <c:pt idx="4">
                  <c:v>5.3102376701261974E-8</c:v>
                </c:pt>
                <c:pt idx="5">
                  <c:v>5.5918930686851907E-8</c:v>
                </c:pt>
                <c:pt idx="6">
                  <c:v>9.6010884506337226E-6</c:v>
                </c:pt>
                <c:pt idx="7">
                  <c:v>2.4142207312365858E-4</c:v>
                </c:pt>
                <c:pt idx="8">
                  <c:v>6.8223592650704093E-5</c:v>
                </c:pt>
                <c:pt idx="9">
                  <c:v>1.8041748273089217E-6</c:v>
                </c:pt>
                <c:pt idx="10">
                  <c:v>3.8712418917878085E-7</c:v>
                </c:pt>
                <c:pt idx="11">
                  <c:v>1.1053084220136589E-6</c:v>
                </c:pt>
                <c:pt idx="12">
                  <c:v>1.180103306854766E-4</c:v>
                </c:pt>
                <c:pt idx="13">
                  <c:v>1.0892820178775656E-4</c:v>
                </c:pt>
                <c:pt idx="14">
                  <c:v>1.76007112470422E-5</c:v>
                </c:pt>
                <c:pt idx="15">
                  <c:v>1.2359657500659919E-6</c:v>
                </c:pt>
                <c:pt idx="16">
                  <c:v>1.3227605893888783E-6</c:v>
                </c:pt>
                <c:pt idx="17">
                  <c:v>9.7315015373058847E-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868928"/>
        <c:axId val="255870464"/>
      </c:scatterChart>
      <c:valAx>
        <c:axId val="255868928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870464"/>
        <c:crosses val="autoZero"/>
        <c:crossBetween val="midCat"/>
        <c:majorUnit val="4"/>
      </c:valAx>
      <c:valAx>
        <c:axId val="2558704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86892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K$24:$K$29</c:f>
                <c:numCache>
                  <c:formatCode>General</c:formatCode>
                  <c:ptCount val="6"/>
                  <c:pt idx="0">
                    <c:v>2.5085311118548159E-7</c:v>
                  </c:pt>
                  <c:pt idx="1">
                    <c:v>1.5760743334886223E-4</c:v>
                  </c:pt>
                  <c:pt idx="2">
                    <c:v>1.4964272369969134E-6</c:v>
                  </c:pt>
                  <c:pt idx="3">
                    <c:v>2.4523855575690805E-7</c:v>
                  </c:pt>
                  <c:pt idx="4">
                    <c:v>4.0726666255582951E-9</c:v>
                  </c:pt>
                  <c:pt idx="5">
                    <c:v>1.6881709286474413E-8</c:v>
                  </c:pt>
                </c:numCache>
              </c:numRef>
            </c:plus>
            <c:minus>
              <c:numRef>
                <c:f>Sheet4!$K$24:$K$29</c:f>
                <c:numCache>
                  <c:formatCode>General</c:formatCode>
                  <c:ptCount val="6"/>
                  <c:pt idx="0">
                    <c:v>2.5085311118548159E-7</c:v>
                  </c:pt>
                  <c:pt idx="1">
                    <c:v>1.5760743334886223E-4</c:v>
                  </c:pt>
                  <c:pt idx="2">
                    <c:v>1.4964272369969134E-6</c:v>
                  </c:pt>
                  <c:pt idx="3">
                    <c:v>2.4523855575690805E-7</c:v>
                  </c:pt>
                  <c:pt idx="4">
                    <c:v>4.0726666255582951E-9</c:v>
                  </c:pt>
                  <c:pt idx="5">
                    <c:v>1.6881709286474413E-8</c:v>
                  </c:pt>
                </c:numCache>
              </c:numRef>
            </c:minus>
          </c:errBars>
          <c:xVal>
            <c:numRef>
              <c:f>Sheet4!$H$24:$H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I$24:$I$29</c:f>
              <c:numCache>
                <c:formatCode>General</c:formatCode>
                <c:ptCount val="6"/>
                <c:pt idx="0">
                  <c:v>1.5442525552736619E-6</c:v>
                </c:pt>
                <c:pt idx="1">
                  <c:v>1.028501919038976E-3</c:v>
                </c:pt>
                <c:pt idx="2">
                  <c:v>3.1589728579913047E-5</c:v>
                </c:pt>
                <c:pt idx="3">
                  <c:v>9.6549234847300955E-7</c:v>
                </c:pt>
                <c:pt idx="4">
                  <c:v>2.3206737422520548E-8</c:v>
                </c:pt>
                <c:pt idx="5">
                  <c:v>2.3874192359889583E-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890560"/>
        <c:axId val="255892096"/>
      </c:scatterChart>
      <c:valAx>
        <c:axId val="25589056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5892096"/>
        <c:crosses val="autoZero"/>
        <c:crossBetween val="midCat"/>
        <c:majorUnit val="4"/>
      </c:valAx>
      <c:valAx>
        <c:axId val="255892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589056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340869891263592"/>
          <c:y val="5.1400554097404488E-2"/>
          <c:w val="0.81403187101612362"/>
          <c:h val="0.83261956838728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14</c:f>
              <c:strCache>
                <c:ptCount val="1"/>
                <c:pt idx="0">
                  <c:v>Bra020017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4:$K$14</c:f>
              <c:numCache>
                <c:formatCode>General</c:formatCode>
                <c:ptCount val="7"/>
                <c:pt idx="0">
                  <c:v>15.444000000000001</c:v>
                </c:pt>
                <c:pt idx="1">
                  <c:v>26.477499999999978</c:v>
                </c:pt>
                <c:pt idx="2">
                  <c:v>12.753</c:v>
                </c:pt>
                <c:pt idx="3">
                  <c:v>12.58</c:v>
                </c:pt>
                <c:pt idx="4">
                  <c:v>8.8795000000000126</c:v>
                </c:pt>
                <c:pt idx="5">
                  <c:v>9.9540000000000006</c:v>
                </c:pt>
                <c:pt idx="6">
                  <c:v>16.69099999999999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15</c:f>
              <c:strCache>
                <c:ptCount val="1"/>
                <c:pt idx="0">
                  <c:v>Bra031668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5:$K$15</c:f>
              <c:numCache>
                <c:formatCode>General</c:formatCode>
                <c:ptCount val="7"/>
                <c:pt idx="0">
                  <c:v>6.2815000000000003</c:v>
                </c:pt>
                <c:pt idx="1">
                  <c:v>11.596</c:v>
                </c:pt>
                <c:pt idx="2">
                  <c:v>5.1029999999999944</c:v>
                </c:pt>
                <c:pt idx="3">
                  <c:v>1.57</c:v>
                </c:pt>
                <c:pt idx="4">
                  <c:v>1.1475</c:v>
                </c:pt>
                <c:pt idx="5">
                  <c:v>1.319</c:v>
                </c:pt>
                <c:pt idx="6">
                  <c:v>6.46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725888"/>
        <c:axId val="250727424"/>
      </c:scatterChart>
      <c:valAx>
        <c:axId val="250725888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727424"/>
        <c:crosses val="autoZero"/>
        <c:crossBetween val="midCat"/>
        <c:majorUnit val="4"/>
      </c:valAx>
      <c:valAx>
        <c:axId val="250727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72588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8538095238095397"/>
          <c:y val="0.18036344415281488"/>
          <c:w val="0.34761904761904788"/>
          <c:h val="0.2369998600864966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48779347787074"/>
          <c:y val="5.1400554097404488E-2"/>
          <c:w val="0.80797576672778915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16</c:f>
              <c:strCache>
                <c:ptCount val="1"/>
                <c:pt idx="0">
                  <c:v>Bra024536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6:$K$16</c:f>
              <c:numCache>
                <c:formatCode>General</c:formatCode>
                <c:ptCount val="7"/>
                <c:pt idx="0">
                  <c:v>0.35400000000000031</c:v>
                </c:pt>
                <c:pt idx="1">
                  <c:v>28.610499999999988</c:v>
                </c:pt>
                <c:pt idx="2">
                  <c:v>99.88</c:v>
                </c:pt>
                <c:pt idx="3">
                  <c:v>11.769500000000004</c:v>
                </c:pt>
                <c:pt idx="4">
                  <c:v>0.30300000000000032</c:v>
                </c:pt>
                <c:pt idx="5">
                  <c:v>0.23450000000000001</c:v>
                </c:pt>
                <c:pt idx="6">
                  <c:v>0.5849999999999999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739328"/>
        <c:axId val="250818944"/>
      </c:scatterChart>
      <c:valAx>
        <c:axId val="250739328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818944"/>
        <c:crosses val="autoZero"/>
        <c:crossBetween val="midCat"/>
        <c:majorUnit val="4"/>
      </c:valAx>
      <c:valAx>
        <c:axId val="250818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73932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9413905450838869"/>
          <c:y val="0.14829579404982651"/>
          <c:w val="0.45242130902971045"/>
          <c:h val="0.1791213682351273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081970522915404"/>
          <c:y val="5.1400554097404488E-2"/>
          <c:w val="0.82695409577299339"/>
          <c:h val="0.83261956838728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17</c:f>
              <c:strCache>
                <c:ptCount val="1"/>
                <c:pt idx="0">
                  <c:v>Bra007774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7:$K$17</c:f>
              <c:numCache>
                <c:formatCode>General</c:formatCode>
                <c:ptCount val="7"/>
                <c:pt idx="0">
                  <c:v>26.540500000000002</c:v>
                </c:pt>
                <c:pt idx="1">
                  <c:v>7.9935</c:v>
                </c:pt>
                <c:pt idx="2">
                  <c:v>17.579499999999989</c:v>
                </c:pt>
                <c:pt idx="3">
                  <c:v>27.008500000000002</c:v>
                </c:pt>
                <c:pt idx="4">
                  <c:v>28.744500000000002</c:v>
                </c:pt>
                <c:pt idx="5">
                  <c:v>30.672000000000001</c:v>
                </c:pt>
                <c:pt idx="6">
                  <c:v>22.424999999999986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18</c:f>
              <c:strCache>
                <c:ptCount val="1"/>
                <c:pt idx="0">
                  <c:v>Bra034284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8:$K$18</c:f>
              <c:numCache>
                <c:formatCode>General</c:formatCode>
                <c:ptCount val="7"/>
                <c:pt idx="0">
                  <c:v>42.282000000000011</c:v>
                </c:pt>
                <c:pt idx="1">
                  <c:v>17.032499999999974</c:v>
                </c:pt>
                <c:pt idx="2">
                  <c:v>12.483000000000002</c:v>
                </c:pt>
                <c:pt idx="3">
                  <c:v>26.679000000000023</c:v>
                </c:pt>
                <c:pt idx="4">
                  <c:v>28.207999999999988</c:v>
                </c:pt>
                <c:pt idx="5">
                  <c:v>30.11800000000002</c:v>
                </c:pt>
                <c:pt idx="6">
                  <c:v>34.78100000000000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856192"/>
        <c:axId val="250857728"/>
      </c:scatterChart>
      <c:valAx>
        <c:axId val="25085619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857728"/>
        <c:crosses val="autoZero"/>
        <c:crossBetween val="midCat"/>
        <c:majorUnit val="4"/>
      </c:valAx>
      <c:valAx>
        <c:axId val="250857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8561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4818682803857992"/>
          <c:y val="0.1014679649721691"/>
          <c:w val="0.34561789916120694"/>
          <c:h val="0.225074346655582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16885389326336"/>
          <c:y val="5.1400554097404488E-2"/>
          <c:w val="0.8533797025371842"/>
          <c:h val="0.83261956838728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D$12</c:f>
              <c:strCache>
                <c:ptCount val="1"/>
                <c:pt idx="0">
                  <c:v>Bra007774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E$2:$E$8</c:f>
                <c:numCache>
                  <c:formatCode>General</c:formatCode>
                  <c:ptCount val="7"/>
                  <c:pt idx="0">
                    <c:v>6.3652130170305504E-5</c:v>
                  </c:pt>
                  <c:pt idx="1">
                    <c:v>3.5309769990096392E-3</c:v>
                  </c:pt>
                  <c:pt idx="2">
                    <c:v>2.402007705962356E-4</c:v>
                  </c:pt>
                  <c:pt idx="3">
                    <c:v>4.4902496634763306E-4</c:v>
                  </c:pt>
                  <c:pt idx="4">
                    <c:v>1.162780776663261E-3</c:v>
                  </c:pt>
                  <c:pt idx="5">
                    <c:v>6.9683309176925344E-4</c:v>
                  </c:pt>
                  <c:pt idx="6">
                    <c:v>4.6390547882870739E-4</c:v>
                  </c:pt>
                </c:numCache>
              </c:numRef>
            </c:plus>
            <c:minus>
              <c:numRef>
                <c:f>Sheet3!$E$2:$E$8</c:f>
                <c:numCache>
                  <c:formatCode>General</c:formatCode>
                  <c:ptCount val="7"/>
                  <c:pt idx="0">
                    <c:v>6.3652130170305504E-5</c:v>
                  </c:pt>
                  <c:pt idx="1">
                    <c:v>3.5309769990096392E-3</c:v>
                  </c:pt>
                  <c:pt idx="2">
                    <c:v>2.402007705962356E-4</c:v>
                  </c:pt>
                  <c:pt idx="3">
                    <c:v>4.4902496634763306E-4</c:v>
                  </c:pt>
                  <c:pt idx="4">
                    <c:v>1.162780776663261E-3</c:v>
                  </c:pt>
                  <c:pt idx="5">
                    <c:v>6.9683309176925344E-4</c:v>
                  </c:pt>
                  <c:pt idx="6">
                    <c:v>4.6390547882870739E-4</c:v>
                  </c:pt>
                </c:numCache>
              </c:numRef>
            </c:minus>
          </c:errBars>
          <c:xVal>
            <c:numRef>
              <c:f>Sheet3!$C$13:$C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D$13:$D$19</c:f>
              <c:numCache>
                <c:formatCode>General</c:formatCode>
                <c:ptCount val="7"/>
                <c:pt idx="0">
                  <c:v>2.8064327151643961E-4</c:v>
                </c:pt>
                <c:pt idx="1">
                  <c:v>1.2389169010695301E-2</c:v>
                </c:pt>
                <c:pt idx="2">
                  <c:v>3.5368226822792741E-3</c:v>
                </c:pt>
                <c:pt idx="3">
                  <c:v>5.9550963085109572E-3</c:v>
                </c:pt>
                <c:pt idx="4">
                  <c:v>5.4138182479662785E-3</c:v>
                </c:pt>
                <c:pt idx="5">
                  <c:v>4.505141453069671E-3</c:v>
                </c:pt>
                <c:pt idx="6">
                  <c:v>1.0210810424250706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E$12</c:f>
              <c:strCache>
                <c:ptCount val="1"/>
                <c:pt idx="0">
                  <c:v>Bra034284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L$2:$L$8</c:f>
                <c:numCache>
                  <c:formatCode>General</c:formatCode>
                  <c:ptCount val="7"/>
                  <c:pt idx="0">
                    <c:v>2.4533088016049157E-3</c:v>
                  </c:pt>
                  <c:pt idx="1">
                    <c:v>7.9459221323360764E-4</c:v>
                  </c:pt>
                  <c:pt idx="2">
                    <c:v>1.7132512517116139E-4</c:v>
                  </c:pt>
                  <c:pt idx="3">
                    <c:v>4.456863499050118E-4</c:v>
                  </c:pt>
                  <c:pt idx="4">
                    <c:v>7.2837816923855352E-4</c:v>
                  </c:pt>
                  <c:pt idx="5">
                    <c:v>4.5497976431467155E-4</c:v>
                  </c:pt>
                  <c:pt idx="6">
                    <c:v>1.2208836772828043E-4</c:v>
                  </c:pt>
                </c:numCache>
              </c:numRef>
            </c:plus>
            <c:minus>
              <c:numRef>
                <c:f>Sheet3!$L$2:$L$8</c:f>
                <c:numCache>
                  <c:formatCode>General</c:formatCode>
                  <c:ptCount val="7"/>
                  <c:pt idx="0">
                    <c:v>2.4533088016049157E-3</c:v>
                  </c:pt>
                  <c:pt idx="1">
                    <c:v>7.9459221323360764E-4</c:v>
                  </c:pt>
                  <c:pt idx="2">
                    <c:v>1.7132512517116139E-4</c:v>
                  </c:pt>
                  <c:pt idx="3">
                    <c:v>4.456863499050118E-4</c:v>
                  </c:pt>
                  <c:pt idx="4">
                    <c:v>7.2837816923855352E-4</c:v>
                  </c:pt>
                  <c:pt idx="5">
                    <c:v>4.5497976431467155E-4</c:v>
                  </c:pt>
                  <c:pt idx="6">
                    <c:v>1.2208836772828043E-4</c:v>
                  </c:pt>
                </c:numCache>
              </c:numRef>
            </c:minus>
          </c:errBars>
          <c:xVal>
            <c:numRef>
              <c:f>Sheet3!$C$13:$C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E$13:$E$19</c:f>
              <c:numCache>
                <c:formatCode>General</c:formatCode>
                <c:ptCount val="7"/>
                <c:pt idx="0">
                  <c:v>6.3758982023041531E-3</c:v>
                </c:pt>
                <c:pt idx="1">
                  <c:v>2.2980465719170348E-3</c:v>
                </c:pt>
                <c:pt idx="2">
                  <c:v>1.2981950243254293E-3</c:v>
                </c:pt>
                <c:pt idx="3">
                  <c:v>2.8525424658532427E-3</c:v>
                </c:pt>
                <c:pt idx="4">
                  <c:v>2.2138488694030266E-3</c:v>
                </c:pt>
                <c:pt idx="5">
                  <c:v>1.5547906177523739E-3</c:v>
                </c:pt>
                <c:pt idx="6">
                  <c:v>1.2708264348255888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875264"/>
        <c:axId val="250893440"/>
      </c:scatterChart>
      <c:valAx>
        <c:axId val="250875264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893440"/>
        <c:crosses val="autoZero"/>
        <c:crossBetween val="midCat"/>
        <c:majorUnit val="4"/>
      </c:valAx>
      <c:valAx>
        <c:axId val="250893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87526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5068618106760111"/>
          <c:y val="0.16087415018402973"/>
          <c:w val="0.38044340102561736"/>
          <c:h val="0.2224312292660433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085739282589702E-2"/>
          <c:y val="6.5289442986293383E-2"/>
          <c:w val="0.87617125984251965"/>
          <c:h val="0.83261956838728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Bra024536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1!$E$2:$E$8</c:f>
                <c:numCache>
                  <c:formatCode>General</c:formatCode>
                  <c:ptCount val="7"/>
                  <c:pt idx="0">
                    <c:v>1.8270174593899386E-6</c:v>
                  </c:pt>
                  <c:pt idx="1">
                    <c:v>1.0139392240381856E-2</c:v>
                  </c:pt>
                  <c:pt idx="2">
                    <c:v>2.6908753364161988E-3</c:v>
                  </c:pt>
                  <c:pt idx="3">
                    <c:v>1.2943427409103029E-3</c:v>
                  </c:pt>
                  <c:pt idx="4">
                    <c:v>2.9028130147021791E-4</c:v>
                  </c:pt>
                  <c:pt idx="5">
                    <c:v>1.3023830759713404E-4</c:v>
                  </c:pt>
                  <c:pt idx="6">
                    <c:v>5.1241607848788993E-4</c:v>
                  </c:pt>
                </c:numCache>
              </c:numRef>
            </c:plus>
            <c:minus>
              <c:numRef>
                <c:f>Sheet1!$E$2:$E$8</c:f>
                <c:numCache>
                  <c:formatCode>General</c:formatCode>
                  <c:ptCount val="7"/>
                  <c:pt idx="0">
                    <c:v>1.8270174593899386E-6</c:v>
                  </c:pt>
                  <c:pt idx="1">
                    <c:v>1.0139392240381856E-2</c:v>
                  </c:pt>
                  <c:pt idx="2">
                    <c:v>2.6908753364161988E-3</c:v>
                  </c:pt>
                  <c:pt idx="3">
                    <c:v>1.2943427409103029E-3</c:v>
                  </c:pt>
                  <c:pt idx="4">
                    <c:v>2.9028130147021791E-4</c:v>
                  </c:pt>
                  <c:pt idx="5">
                    <c:v>1.3023830759713404E-4</c:v>
                  </c:pt>
                  <c:pt idx="6">
                    <c:v>5.1241607848788993E-4</c:v>
                  </c:pt>
                </c:numCache>
              </c:numRef>
            </c:minus>
          </c:errBars>
          <c:xVal>
            <c:numRef>
              <c:f>Sheet1!$B$2:$B$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1!$C$2:$C$8</c:f>
              <c:numCache>
                <c:formatCode>General</c:formatCode>
                <c:ptCount val="7"/>
                <c:pt idx="0">
                  <c:v>9.4436516698864316E-6</c:v>
                </c:pt>
                <c:pt idx="1">
                  <c:v>6.3413600456595609E-2</c:v>
                </c:pt>
                <c:pt idx="2">
                  <c:v>5.6976309973490319E-2</c:v>
                </c:pt>
                <c:pt idx="3">
                  <c:v>1.3389322082915161E-2</c:v>
                </c:pt>
                <c:pt idx="4">
                  <c:v>1.459215042992348E-3</c:v>
                </c:pt>
                <c:pt idx="5">
                  <c:v>6.322160049053693E-4</c:v>
                </c:pt>
                <c:pt idx="6">
                  <c:v>4.0215360935919684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905728"/>
        <c:axId val="250907264"/>
      </c:scatterChart>
      <c:valAx>
        <c:axId val="250905728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907264"/>
        <c:crosses val="autoZero"/>
        <c:crossBetween val="midCat"/>
        <c:majorUnit val="4"/>
      </c:valAx>
      <c:valAx>
        <c:axId val="2509072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90572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1563128151854865"/>
          <c:y val="0.18304149001365441"/>
          <c:w val="0.34957169707375046"/>
          <c:h val="0.2468114355274745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0730974914824316"/>
          <c:y val="5.4218821365527324E-2"/>
          <c:w val="0.80560192475940562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D$12</c:f>
              <c:strCache>
                <c:ptCount val="1"/>
                <c:pt idx="0">
                  <c:v>Bra020017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E$2:$E$8</c:f>
                <c:numCache>
                  <c:formatCode>General</c:formatCode>
                  <c:ptCount val="7"/>
                  <c:pt idx="0">
                    <c:v>2.5657574743393156E-5</c:v>
                  </c:pt>
                  <c:pt idx="1">
                    <c:v>2.3331442496229099E-5</c:v>
                  </c:pt>
                  <c:pt idx="2">
                    <c:v>2.6954698496185328E-6</c:v>
                  </c:pt>
                  <c:pt idx="3">
                    <c:v>8.0326091678721668E-6</c:v>
                  </c:pt>
                  <c:pt idx="4">
                    <c:v>3.1747191257162097E-6</c:v>
                  </c:pt>
                  <c:pt idx="5">
                    <c:v>8.6387274407673208E-6</c:v>
                  </c:pt>
                  <c:pt idx="6">
                    <c:v>4.4219288267607306E-6</c:v>
                  </c:pt>
                </c:numCache>
              </c:numRef>
            </c:plus>
            <c:minus>
              <c:numRef>
                <c:f>Sheet3!$E$2:$E$8</c:f>
                <c:numCache>
                  <c:formatCode>General</c:formatCode>
                  <c:ptCount val="7"/>
                  <c:pt idx="0">
                    <c:v>2.5657574743393156E-5</c:v>
                  </c:pt>
                  <c:pt idx="1">
                    <c:v>2.3331442496229099E-5</c:v>
                  </c:pt>
                  <c:pt idx="2">
                    <c:v>2.6954698496185328E-6</c:v>
                  </c:pt>
                  <c:pt idx="3">
                    <c:v>8.0326091678721668E-6</c:v>
                  </c:pt>
                  <c:pt idx="4">
                    <c:v>3.1747191257162097E-6</c:v>
                  </c:pt>
                  <c:pt idx="5">
                    <c:v>8.6387274407673208E-6</c:v>
                  </c:pt>
                  <c:pt idx="6">
                    <c:v>4.4219288267607306E-6</c:v>
                  </c:pt>
                </c:numCache>
              </c:numRef>
            </c:minus>
          </c:errBars>
          <c:xVal>
            <c:numRef>
              <c:f>Sheet3!$C$13:$C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D$13:$D$19</c:f>
              <c:numCache>
                <c:formatCode>General</c:formatCode>
                <c:ptCount val="7"/>
                <c:pt idx="0">
                  <c:v>1.534463829399733E-4</c:v>
                </c:pt>
                <c:pt idx="1">
                  <c:v>7.9341575605131103E-5</c:v>
                </c:pt>
                <c:pt idx="2">
                  <c:v>1.5387962231249171E-5</c:v>
                </c:pt>
                <c:pt idx="3">
                  <c:v>3.0938878340267327E-5</c:v>
                </c:pt>
                <c:pt idx="4">
                  <c:v>1.3477788314900203E-5</c:v>
                </c:pt>
                <c:pt idx="5">
                  <c:v>7.8162230948577145E-5</c:v>
                </c:pt>
                <c:pt idx="6">
                  <c:v>4.7402407988606818E-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E$12</c:f>
              <c:strCache>
                <c:ptCount val="1"/>
                <c:pt idx="0">
                  <c:v>Bra031668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L$2:$L$8</c:f>
                <c:numCache>
                  <c:formatCode>General</c:formatCode>
                  <c:ptCount val="7"/>
                  <c:pt idx="0">
                    <c:v>2.1620717654795592E-5</c:v>
                  </c:pt>
                  <c:pt idx="1">
                    <c:v>5.4889470250197617E-5</c:v>
                  </c:pt>
                  <c:pt idx="2">
                    <c:v>1.9683724839277894E-6</c:v>
                  </c:pt>
                  <c:pt idx="3">
                    <c:v>1.0852595387258049E-6</c:v>
                  </c:pt>
                  <c:pt idx="4">
                    <c:v>3.0508880601445615E-7</c:v>
                  </c:pt>
                  <c:pt idx="5">
                    <c:v>2.1109367319755048E-7</c:v>
                  </c:pt>
                  <c:pt idx="6">
                    <c:v>1.2579372081672047E-6</c:v>
                  </c:pt>
                </c:numCache>
              </c:numRef>
            </c:plus>
            <c:minus>
              <c:numRef>
                <c:f>Sheet3!$L$2:$L$8</c:f>
                <c:numCache>
                  <c:formatCode>General</c:formatCode>
                  <c:ptCount val="7"/>
                  <c:pt idx="0">
                    <c:v>2.1620717654795592E-5</c:v>
                  </c:pt>
                  <c:pt idx="1">
                    <c:v>5.4889470250197617E-5</c:v>
                  </c:pt>
                  <c:pt idx="2">
                    <c:v>1.9683724839277894E-6</c:v>
                  </c:pt>
                  <c:pt idx="3">
                    <c:v>1.0852595387258049E-6</c:v>
                  </c:pt>
                  <c:pt idx="4">
                    <c:v>3.0508880601445615E-7</c:v>
                  </c:pt>
                  <c:pt idx="5">
                    <c:v>2.1109367319755048E-7</c:v>
                  </c:pt>
                  <c:pt idx="6">
                    <c:v>1.2579372081672047E-6</c:v>
                  </c:pt>
                </c:numCache>
              </c:numRef>
            </c:minus>
          </c:errBars>
          <c:xVal>
            <c:numRef>
              <c:f>Sheet3!$C$13:$C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E$13:$E$19</c:f>
              <c:numCache>
                <c:formatCode>General</c:formatCode>
                <c:ptCount val="7"/>
                <c:pt idx="0">
                  <c:v>9.0545106660908507E-5</c:v>
                </c:pt>
                <c:pt idx="1">
                  <c:v>1.8484953911310957E-4</c:v>
                </c:pt>
                <c:pt idx="2">
                  <c:v>8.6985442081892603E-6</c:v>
                </c:pt>
                <c:pt idx="3">
                  <c:v>3.440997504466921E-6</c:v>
                </c:pt>
                <c:pt idx="4">
                  <c:v>1.0650997916707423E-6</c:v>
                </c:pt>
                <c:pt idx="5">
                  <c:v>5.4532704374935739E-6</c:v>
                </c:pt>
                <c:pt idx="6">
                  <c:v>4.1822421343168472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355712"/>
        <c:axId val="250357248"/>
      </c:scatterChart>
      <c:valAx>
        <c:axId val="25035571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/>
        </c:spPr>
        <c:crossAx val="250357248"/>
        <c:crosses val="autoZero"/>
        <c:crossBetween val="midCat"/>
        <c:majorUnit val="4"/>
      </c:valAx>
      <c:valAx>
        <c:axId val="250357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35571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4684711286089316"/>
          <c:y val="0.23109762321376487"/>
          <c:w val="0.40985767206421542"/>
          <c:h val="0.1674343832021000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PHYB ; </a:t>
            </a:r>
            <a:r>
              <a:rPr lang="en-US" dirty="0"/>
              <a:t>At2g18790</a:t>
            </a:r>
          </a:p>
        </c:rich>
      </c:tx>
      <c:layout>
        <c:manualLayout>
          <c:xMode val="edge"/>
          <c:yMode val="edge"/>
          <c:x val="0.24288134651705384"/>
          <c:y val="1.8762690670303789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753965933609737"/>
          <c:y val="6.3910452030152692E-2"/>
          <c:w val="0.78760488600681866"/>
          <c:h val="0.7765034086047183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3:$B$3</c:f>
              <c:strCache>
                <c:ptCount val="1"/>
                <c:pt idx="0">
                  <c:v>PHYB At2g1879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3:$V$3</c:f>
                <c:numCache>
                  <c:formatCode>General</c:formatCode>
                  <c:ptCount val="6"/>
                  <c:pt idx="0">
                    <c:v>0.13231232949201224</c:v>
                  </c:pt>
                  <c:pt idx="1">
                    <c:v>0.11707760034273565</c:v>
                  </c:pt>
                  <c:pt idx="2">
                    <c:v>0.20922962477263871</c:v>
                  </c:pt>
                  <c:pt idx="3">
                    <c:v>0.19078736702151022</c:v>
                  </c:pt>
                  <c:pt idx="4">
                    <c:v>0.20966469017889044</c:v>
                  </c:pt>
                  <c:pt idx="5">
                    <c:v>0.19899549160220145</c:v>
                  </c:pt>
                </c:numCache>
              </c:numRef>
            </c:plus>
            <c:minus>
              <c:numRef>
                <c:f>Sheet4!$Q$3:$V$3</c:f>
                <c:numCache>
                  <c:formatCode>General</c:formatCode>
                  <c:ptCount val="6"/>
                  <c:pt idx="0">
                    <c:v>0.13231232949201224</c:v>
                  </c:pt>
                  <c:pt idx="1">
                    <c:v>0.11707760034273565</c:v>
                  </c:pt>
                  <c:pt idx="2">
                    <c:v>0.20922962477263871</c:v>
                  </c:pt>
                  <c:pt idx="3">
                    <c:v>0.19078736702151022</c:v>
                  </c:pt>
                  <c:pt idx="4">
                    <c:v>0.20966469017889044</c:v>
                  </c:pt>
                  <c:pt idx="5">
                    <c:v>0.19899549160220145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3:$H$3</c:f>
              <c:numCache>
                <c:formatCode>General</c:formatCode>
                <c:ptCount val="6"/>
                <c:pt idx="0">
                  <c:v>9.5516844733333368</c:v>
                </c:pt>
                <c:pt idx="1">
                  <c:v>9.7645768476666728</c:v>
                </c:pt>
                <c:pt idx="2">
                  <c:v>9.6983297386666649</c:v>
                </c:pt>
                <c:pt idx="3">
                  <c:v>9.5766177580000047</c:v>
                </c:pt>
                <c:pt idx="4">
                  <c:v>9.4550361260000191</c:v>
                </c:pt>
                <c:pt idx="5">
                  <c:v>9.463988246666678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374656"/>
        <c:axId val="216384640"/>
      </c:scatterChart>
      <c:valAx>
        <c:axId val="21637465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384640"/>
        <c:crosses val="autoZero"/>
        <c:crossBetween val="midCat"/>
        <c:majorUnit val="4"/>
      </c:valAx>
      <c:valAx>
        <c:axId val="216384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1637465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9002187226596826E-2"/>
          <c:y val="5.1400554097404488E-2"/>
          <c:w val="0.85654636920384952"/>
          <c:h val="0.83261956838728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C$11</c:f>
              <c:strCache>
                <c:ptCount val="1"/>
                <c:pt idx="0">
                  <c:v>Bra015313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E$2:$E$8</c:f>
                <c:numCache>
                  <c:formatCode>General</c:formatCode>
                  <c:ptCount val="7"/>
                  <c:pt idx="0">
                    <c:v>0.17429280470907371</c:v>
                  </c:pt>
                  <c:pt idx="1">
                    <c:v>2.2246981840619792E-2</c:v>
                  </c:pt>
                  <c:pt idx="2">
                    <c:v>8.4014555833376567E-2</c:v>
                  </c:pt>
                  <c:pt idx="3">
                    <c:v>3.5042119186234524E-2</c:v>
                  </c:pt>
                  <c:pt idx="4">
                    <c:v>6.3872723504191264E-2</c:v>
                  </c:pt>
                  <c:pt idx="5">
                    <c:v>3.4257475023771668E-2</c:v>
                  </c:pt>
                  <c:pt idx="6">
                    <c:v>1.7154367773411786E-2</c:v>
                  </c:pt>
                </c:numCache>
              </c:numRef>
            </c:plus>
            <c:minus>
              <c:numRef>
                <c:f>Sheet2!$E$2:$E$8</c:f>
                <c:numCache>
                  <c:formatCode>General</c:formatCode>
                  <c:ptCount val="7"/>
                  <c:pt idx="0">
                    <c:v>0.17429280470907371</c:v>
                  </c:pt>
                  <c:pt idx="1">
                    <c:v>2.2246981840619792E-2</c:v>
                  </c:pt>
                  <c:pt idx="2">
                    <c:v>8.4014555833376567E-2</c:v>
                  </c:pt>
                  <c:pt idx="3">
                    <c:v>3.5042119186234524E-2</c:v>
                  </c:pt>
                  <c:pt idx="4">
                    <c:v>6.3872723504191264E-2</c:v>
                  </c:pt>
                  <c:pt idx="5">
                    <c:v>3.4257475023771668E-2</c:v>
                  </c:pt>
                  <c:pt idx="6">
                    <c:v>1.7154367773411786E-2</c:v>
                  </c:pt>
                </c:numCache>
              </c:numRef>
            </c:minus>
          </c:errBars>
          <c:xVal>
            <c:numRef>
              <c:f>Sheet2!$B$12:$B$1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C$12:$C$18</c:f>
              <c:numCache>
                <c:formatCode>General</c:formatCode>
                <c:ptCount val="7"/>
                <c:pt idx="0">
                  <c:v>0.59196496776367558</c:v>
                </c:pt>
                <c:pt idx="1">
                  <c:v>0.40180573352170335</c:v>
                </c:pt>
                <c:pt idx="2">
                  <c:v>0.32018595585467291</c:v>
                </c:pt>
                <c:pt idx="3">
                  <c:v>0.2887111409985102</c:v>
                </c:pt>
                <c:pt idx="4">
                  <c:v>0.24016985439593441</c:v>
                </c:pt>
                <c:pt idx="5">
                  <c:v>0.12884423154557859</c:v>
                </c:pt>
                <c:pt idx="6">
                  <c:v>0.17592125215820717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D$11</c:f>
              <c:strCache>
                <c:ptCount val="1"/>
                <c:pt idx="0">
                  <c:v>Bra030568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M$2:$M$8</c:f>
                <c:numCache>
                  <c:formatCode>General</c:formatCode>
                  <c:ptCount val="7"/>
                  <c:pt idx="0">
                    <c:v>2.8329419861032558E-3</c:v>
                  </c:pt>
                  <c:pt idx="1">
                    <c:v>1.6846852869754822E-3</c:v>
                  </c:pt>
                  <c:pt idx="2">
                    <c:v>8.0443671593153701E-3</c:v>
                  </c:pt>
                  <c:pt idx="3">
                    <c:v>2.7349575862505148E-3</c:v>
                  </c:pt>
                  <c:pt idx="4">
                    <c:v>5.0038128706325624E-3</c:v>
                  </c:pt>
                  <c:pt idx="5">
                    <c:v>3.0265506758123807E-3</c:v>
                  </c:pt>
                  <c:pt idx="6">
                    <c:v>3.915935470185491E-3</c:v>
                  </c:pt>
                </c:numCache>
              </c:numRef>
            </c:plus>
            <c:minus>
              <c:numRef>
                <c:f>Sheet2!$M$2:$M$8</c:f>
                <c:numCache>
                  <c:formatCode>General</c:formatCode>
                  <c:ptCount val="7"/>
                  <c:pt idx="0">
                    <c:v>2.8329419861032558E-3</c:v>
                  </c:pt>
                  <c:pt idx="1">
                    <c:v>1.6846852869754822E-3</c:v>
                  </c:pt>
                  <c:pt idx="2">
                    <c:v>8.0443671593153701E-3</c:v>
                  </c:pt>
                  <c:pt idx="3">
                    <c:v>2.7349575862505148E-3</c:v>
                  </c:pt>
                  <c:pt idx="4">
                    <c:v>5.0038128706325624E-3</c:v>
                  </c:pt>
                  <c:pt idx="5">
                    <c:v>3.0265506758123807E-3</c:v>
                  </c:pt>
                  <c:pt idx="6">
                    <c:v>3.915935470185491E-3</c:v>
                  </c:pt>
                </c:numCache>
              </c:numRef>
            </c:minus>
          </c:errBars>
          <c:xVal>
            <c:numRef>
              <c:f>Sheet2!$B$12:$B$1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D$12:$D$18</c:f>
              <c:numCache>
                <c:formatCode>General</c:formatCode>
                <c:ptCount val="7"/>
                <c:pt idx="0">
                  <c:v>8.6767299750686814E-3</c:v>
                </c:pt>
                <c:pt idx="1">
                  <c:v>6.6259947662955884E-2</c:v>
                </c:pt>
                <c:pt idx="2">
                  <c:v>7.2361053590041122E-2</c:v>
                </c:pt>
                <c:pt idx="3">
                  <c:v>3.6280768530772688E-2</c:v>
                </c:pt>
                <c:pt idx="4">
                  <c:v>2.5593322411471237E-2</c:v>
                </c:pt>
                <c:pt idx="5">
                  <c:v>1.6011109005171005E-2</c:v>
                </c:pt>
                <c:pt idx="6">
                  <c:v>4.6719586886119414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387072"/>
        <c:axId val="250397056"/>
      </c:scatterChart>
      <c:valAx>
        <c:axId val="25038707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397056"/>
        <c:crosses val="autoZero"/>
        <c:crossBetween val="midCat"/>
        <c:majorUnit val="4"/>
      </c:valAx>
      <c:valAx>
        <c:axId val="250397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38707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4129155730533637"/>
          <c:y val="0.21720873432487625"/>
          <c:w val="0.4732693443418568"/>
          <c:h val="0.2449593512808712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085739282589702E-2"/>
          <c:y val="8.6706166459401754E-2"/>
          <c:w val="0.87617125984251965"/>
          <c:h val="0.7973138886599215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C$1</c:f>
              <c:strCache>
                <c:ptCount val="1"/>
                <c:pt idx="0">
                  <c:v>Bra037880</c:v>
                </c:pt>
              </c:strCache>
            </c:strRef>
          </c:tx>
          <c:spPr>
            <a:ln w="165100"/>
          </c:spPr>
          <c:xVal>
            <c:numRef>
              <c:f>Sheet3!$B$2:$B$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C$2:$C$8</c:f>
              <c:numCache>
                <c:formatCode>General</c:formatCode>
                <c:ptCount val="7"/>
                <c:pt idx="0">
                  <c:v>8.8547140019439169E-2</c:v>
                </c:pt>
                <c:pt idx="1">
                  <c:v>3.5099297852111404E-2</c:v>
                </c:pt>
                <c:pt idx="2">
                  <c:v>1.7520980722087076E-2</c:v>
                </c:pt>
                <c:pt idx="3">
                  <c:v>5.8120200666532005E-3</c:v>
                </c:pt>
                <c:pt idx="4">
                  <c:v>5.5252770521222452E-3</c:v>
                </c:pt>
                <c:pt idx="5">
                  <c:v>1.1200790389229023E-2</c:v>
                </c:pt>
                <c:pt idx="6">
                  <c:v>1.8439210405785746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203584"/>
        <c:axId val="251205120"/>
      </c:scatterChart>
      <c:valAx>
        <c:axId val="251203584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205120"/>
        <c:crosses val="autoZero"/>
        <c:crossBetween val="midCat"/>
        <c:majorUnit val="4"/>
      </c:valAx>
      <c:valAx>
        <c:axId val="251205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20358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0548851053586676"/>
          <c:y val="0.22663222604895739"/>
          <c:w val="0.52376284000851769"/>
          <c:h val="0.1387141273430789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3085739282589702E-2"/>
          <c:y val="5.1400554097404488E-2"/>
          <c:w val="0.87024059492563444"/>
          <c:h val="0.8557677165354339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D$12</c:f>
              <c:strCache>
                <c:ptCount val="1"/>
                <c:pt idx="0">
                  <c:v>Bra001650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E$2:$E$8</c:f>
                <c:numCache>
                  <c:formatCode>General</c:formatCode>
                  <c:ptCount val="7"/>
                  <c:pt idx="0">
                    <c:v>8.0530188643696092E-6</c:v>
                  </c:pt>
                  <c:pt idx="1">
                    <c:v>2.2389991230324416E-5</c:v>
                  </c:pt>
                  <c:pt idx="2">
                    <c:v>7.6005435259341144E-5</c:v>
                  </c:pt>
                  <c:pt idx="3">
                    <c:v>1.0703589731240734E-4</c:v>
                  </c:pt>
                  <c:pt idx="4">
                    <c:v>1.9903627715670064E-5</c:v>
                  </c:pt>
                  <c:pt idx="5">
                    <c:v>1.4189509353932254E-5</c:v>
                  </c:pt>
                  <c:pt idx="6">
                    <c:v>6.1100611610863273E-6</c:v>
                  </c:pt>
                </c:numCache>
              </c:numRef>
            </c:plus>
            <c:minus>
              <c:numRef>
                <c:f>Sheet2!$E$2:$E$8</c:f>
                <c:numCache>
                  <c:formatCode>General</c:formatCode>
                  <c:ptCount val="7"/>
                  <c:pt idx="0">
                    <c:v>8.0530188643696092E-6</c:v>
                  </c:pt>
                  <c:pt idx="1">
                    <c:v>2.2389991230324416E-5</c:v>
                  </c:pt>
                  <c:pt idx="2">
                    <c:v>7.6005435259341144E-5</c:v>
                  </c:pt>
                  <c:pt idx="3">
                    <c:v>1.0703589731240734E-4</c:v>
                  </c:pt>
                  <c:pt idx="4">
                    <c:v>1.9903627715670064E-5</c:v>
                  </c:pt>
                  <c:pt idx="5">
                    <c:v>1.4189509353932254E-5</c:v>
                  </c:pt>
                  <c:pt idx="6">
                    <c:v>6.1100611610863273E-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C$13:$C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D$13:$D$19</c:f>
              <c:numCache>
                <c:formatCode>General</c:formatCode>
                <c:ptCount val="7"/>
                <c:pt idx="0">
                  <c:v>8.6646654730289878E-5</c:v>
                </c:pt>
                <c:pt idx="1">
                  <c:v>1.2620949037700822E-4</c:v>
                </c:pt>
                <c:pt idx="2">
                  <c:v>2.3223677550222917E-4</c:v>
                </c:pt>
                <c:pt idx="3">
                  <c:v>3.2063453320948826E-4</c:v>
                </c:pt>
                <c:pt idx="4">
                  <c:v>7.6044216576281668E-5</c:v>
                </c:pt>
                <c:pt idx="5">
                  <c:v>6.8062276175371932E-5</c:v>
                </c:pt>
                <c:pt idx="6">
                  <c:v>9.313149786130306E-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E$12</c:f>
              <c:strCache>
                <c:ptCount val="1"/>
                <c:pt idx="0">
                  <c:v>Bra022192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M$2:$M$8</c:f>
                <c:numCache>
                  <c:formatCode>General</c:formatCode>
                  <c:ptCount val="7"/>
                  <c:pt idx="0">
                    <c:v>0.11566708902093056</c:v>
                  </c:pt>
                  <c:pt idx="1">
                    <c:v>0.13202936943134322</c:v>
                  </c:pt>
                  <c:pt idx="2">
                    <c:v>4.7941628752983821E-2</c:v>
                  </c:pt>
                  <c:pt idx="3">
                    <c:v>2.3081428148735584E-2</c:v>
                  </c:pt>
                  <c:pt idx="4">
                    <c:v>5.636571172976608E-2</c:v>
                  </c:pt>
                  <c:pt idx="5">
                    <c:v>6.1927172410534154E-3</c:v>
                  </c:pt>
                  <c:pt idx="6">
                    <c:v>5.7651186332007744E-3</c:v>
                  </c:pt>
                </c:numCache>
              </c:numRef>
            </c:plus>
            <c:minus>
              <c:numRef>
                <c:f>Sheet2!$M$2:$M$8</c:f>
                <c:numCache>
                  <c:formatCode>General</c:formatCode>
                  <c:ptCount val="7"/>
                  <c:pt idx="0">
                    <c:v>0.11566708902093056</c:v>
                  </c:pt>
                  <c:pt idx="1">
                    <c:v>0.13202936943134322</c:v>
                  </c:pt>
                  <c:pt idx="2">
                    <c:v>4.7941628752983821E-2</c:v>
                  </c:pt>
                  <c:pt idx="3">
                    <c:v>2.3081428148735584E-2</c:v>
                  </c:pt>
                  <c:pt idx="4">
                    <c:v>5.636571172976608E-2</c:v>
                  </c:pt>
                  <c:pt idx="5">
                    <c:v>6.1927172410534154E-3</c:v>
                  </c:pt>
                  <c:pt idx="6">
                    <c:v>5.7651186332007744E-3</c:v>
                  </c:pt>
                </c:numCache>
              </c:numRef>
            </c:minus>
          </c:errBars>
          <c:xVal>
            <c:numRef>
              <c:f>Sheet2!$C$13:$C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3:$E$19</c:f>
              <c:numCache>
                <c:formatCode>General</c:formatCode>
                <c:ptCount val="7"/>
                <c:pt idx="0">
                  <c:v>0.32747825642406653</c:v>
                </c:pt>
                <c:pt idx="1">
                  <c:v>0.38779135691633093</c:v>
                </c:pt>
                <c:pt idx="2">
                  <c:v>0.13302959756553479</c:v>
                </c:pt>
                <c:pt idx="3">
                  <c:v>5.6930750307646404E-2</c:v>
                </c:pt>
                <c:pt idx="4">
                  <c:v>0.10011435794173089</c:v>
                </c:pt>
                <c:pt idx="5">
                  <c:v>7.5512430336326528E-2</c:v>
                </c:pt>
                <c:pt idx="6">
                  <c:v>8.5557929255297538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231232"/>
        <c:axId val="251233024"/>
      </c:scatterChart>
      <c:valAx>
        <c:axId val="251231232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233024"/>
        <c:crosses val="autoZero"/>
        <c:crossBetween val="midCat"/>
        <c:majorUnit val="4"/>
      </c:valAx>
      <c:valAx>
        <c:axId val="251233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23123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9488928313520782"/>
          <c:y val="0.19300349543001796"/>
          <c:w val="0.42455511308928662"/>
          <c:h val="0.2693080398474246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3085739282589702E-2"/>
          <c:y val="5.1400554097404488E-2"/>
          <c:w val="0.87579615048119108"/>
          <c:h val="0.83261956838728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5!$I$14</c:f>
              <c:strCache>
                <c:ptCount val="1"/>
                <c:pt idx="0">
                  <c:v>Bra020013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5!$E$2:$E$8</c:f>
                <c:numCache>
                  <c:formatCode>General</c:formatCode>
                  <c:ptCount val="7"/>
                  <c:pt idx="0">
                    <c:v>8.1628693682346092E-3</c:v>
                  </c:pt>
                  <c:pt idx="1">
                    <c:v>3.4736318106038415E-3</c:v>
                  </c:pt>
                  <c:pt idx="2">
                    <c:v>2.0905523093928756E-4</c:v>
                  </c:pt>
                  <c:pt idx="3">
                    <c:v>2.6275296493717394E-4</c:v>
                  </c:pt>
                  <c:pt idx="4">
                    <c:v>2.4154208821017349E-4</c:v>
                  </c:pt>
                  <c:pt idx="5">
                    <c:v>2.0202451179667236E-3</c:v>
                  </c:pt>
                  <c:pt idx="6">
                    <c:v>5.6921383479381562E-4</c:v>
                  </c:pt>
                </c:numCache>
              </c:numRef>
            </c:plus>
            <c:minus>
              <c:numRef>
                <c:f>Sheet5!$E$2:$E$8</c:f>
                <c:numCache>
                  <c:formatCode>General</c:formatCode>
                  <c:ptCount val="7"/>
                  <c:pt idx="0">
                    <c:v>8.1628693682346092E-3</c:v>
                  </c:pt>
                  <c:pt idx="1">
                    <c:v>3.4736318106038415E-3</c:v>
                  </c:pt>
                  <c:pt idx="2">
                    <c:v>2.0905523093928756E-4</c:v>
                  </c:pt>
                  <c:pt idx="3">
                    <c:v>2.6275296493717394E-4</c:v>
                  </c:pt>
                  <c:pt idx="4">
                    <c:v>2.4154208821017349E-4</c:v>
                  </c:pt>
                  <c:pt idx="5">
                    <c:v>2.0202451179667236E-3</c:v>
                  </c:pt>
                  <c:pt idx="6">
                    <c:v>5.6921383479381562E-4</c:v>
                  </c:pt>
                </c:numCache>
              </c:numRef>
            </c:minus>
          </c:errBars>
          <c:xVal>
            <c:numRef>
              <c:f>Sheet5!$H$15:$H$21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5!$I$15:$I$21</c:f>
              <c:numCache>
                <c:formatCode>General</c:formatCode>
                <c:ptCount val="7"/>
                <c:pt idx="0">
                  <c:v>4.2939212284319461E-2</c:v>
                </c:pt>
                <c:pt idx="1">
                  <c:v>2.0244273669381391E-2</c:v>
                </c:pt>
                <c:pt idx="2">
                  <c:v>2.5017352492186376E-3</c:v>
                </c:pt>
                <c:pt idx="3">
                  <c:v>1.3612611943645235E-3</c:v>
                </c:pt>
                <c:pt idx="4">
                  <c:v>1.0184113725966761E-3</c:v>
                </c:pt>
                <c:pt idx="5">
                  <c:v>4.8127767230289878E-3</c:v>
                </c:pt>
                <c:pt idx="6">
                  <c:v>3.8513126404393595E-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5!$J$14</c:f>
              <c:strCache>
                <c:ptCount val="1"/>
                <c:pt idx="0">
                  <c:v>Bra031672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5!$N$2:$N$8</c:f>
                <c:numCache>
                  <c:formatCode>General</c:formatCode>
                  <c:ptCount val="7"/>
                  <c:pt idx="0">
                    <c:v>5.5076694661817076E-3</c:v>
                  </c:pt>
                  <c:pt idx="1">
                    <c:v>8.827633446168992E-4</c:v>
                  </c:pt>
                  <c:pt idx="2">
                    <c:v>5.1103961238096844E-4</c:v>
                  </c:pt>
                  <c:pt idx="3">
                    <c:v>2.3101009715139299E-3</c:v>
                  </c:pt>
                  <c:pt idx="4">
                    <c:v>1.7996734631957401E-3</c:v>
                  </c:pt>
                  <c:pt idx="5">
                    <c:v>6.3001379909132611E-4</c:v>
                  </c:pt>
                  <c:pt idx="6">
                    <c:v>2.0630154525533772E-3</c:v>
                  </c:pt>
                </c:numCache>
              </c:numRef>
            </c:plus>
            <c:minus>
              <c:numRef>
                <c:f>Sheet5!$N$2:$N$8</c:f>
                <c:numCache>
                  <c:formatCode>General</c:formatCode>
                  <c:ptCount val="7"/>
                  <c:pt idx="0">
                    <c:v>5.5076694661817076E-3</c:v>
                  </c:pt>
                  <c:pt idx="1">
                    <c:v>8.827633446168992E-4</c:v>
                  </c:pt>
                  <c:pt idx="2">
                    <c:v>5.1103961238096844E-4</c:v>
                  </c:pt>
                  <c:pt idx="3">
                    <c:v>2.3101009715139299E-3</c:v>
                  </c:pt>
                  <c:pt idx="4">
                    <c:v>1.7996734631957401E-3</c:v>
                  </c:pt>
                  <c:pt idx="5">
                    <c:v>6.3001379909132611E-4</c:v>
                  </c:pt>
                  <c:pt idx="6">
                    <c:v>2.0630154525533772E-3</c:v>
                  </c:pt>
                </c:numCache>
              </c:numRef>
            </c:minus>
          </c:errBars>
          <c:xVal>
            <c:numRef>
              <c:f>Sheet5!$H$15:$H$21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5!$J$15:$J$21</c:f>
              <c:numCache>
                <c:formatCode>General</c:formatCode>
                <c:ptCount val="7"/>
                <c:pt idx="0">
                  <c:v>2.3761557225330961E-2</c:v>
                </c:pt>
                <c:pt idx="1">
                  <c:v>1.8369247998698022E-2</c:v>
                </c:pt>
                <c:pt idx="2">
                  <c:v>9.8473036456825092E-3</c:v>
                </c:pt>
                <c:pt idx="3">
                  <c:v>1.9513905165363114E-2</c:v>
                </c:pt>
                <c:pt idx="4">
                  <c:v>1.020059320854424E-2</c:v>
                </c:pt>
                <c:pt idx="5">
                  <c:v>7.493336419680573E-3</c:v>
                </c:pt>
                <c:pt idx="6">
                  <c:v>1.433137036232926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258752"/>
        <c:axId val="251260288"/>
      </c:scatterChart>
      <c:valAx>
        <c:axId val="25125875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260288"/>
        <c:crosses val="autoZero"/>
        <c:crossBetween val="midCat"/>
        <c:majorUnit val="4"/>
      </c:valAx>
      <c:valAx>
        <c:axId val="2512602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25875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2563716878680147"/>
          <c:y val="0.1294712773849499"/>
          <c:w val="0.44843845475502719"/>
          <c:h val="0.2357063372886883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196872862079653"/>
          <c:y val="6.1952047144104669E-2"/>
          <c:w val="0.76245841105374279"/>
          <c:h val="0.7767458334975927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G$5</c:f>
              <c:strCache>
                <c:ptCount val="1"/>
                <c:pt idx="0">
                  <c:v>Bra005541</c:v>
                </c:pt>
              </c:strCache>
            </c:strRef>
          </c:tx>
          <c:spPr>
            <a:ln w="165100"/>
          </c:spPr>
          <c:xVal>
            <c:numRef>
              <c:f>Sheet2!$F$6:$F$1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G$6:$G$12</c:f>
              <c:numCache>
                <c:formatCode>General</c:formatCode>
                <c:ptCount val="7"/>
                <c:pt idx="0">
                  <c:v>2.2685141035300085E-2</c:v>
                </c:pt>
                <c:pt idx="1">
                  <c:v>1.9742618026895562E-2</c:v>
                </c:pt>
                <c:pt idx="2">
                  <c:v>2.3914657078281703E-2</c:v>
                </c:pt>
                <c:pt idx="3">
                  <c:v>3.6096753741861359E-2</c:v>
                </c:pt>
                <c:pt idx="4">
                  <c:v>2.8580310620946493E-2</c:v>
                </c:pt>
                <c:pt idx="5">
                  <c:v>3.2289714498904339E-2</c:v>
                </c:pt>
                <c:pt idx="6">
                  <c:v>2.4550458004708002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L$5</c:f>
              <c:strCache>
                <c:ptCount val="1"/>
                <c:pt idx="0">
                  <c:v>Bra021818</c:v>
                </c:pt>
              </c:strCache>
            </c:strRef>
          </c:tx>
          <c:spPr>
            <a:ln w="165100"/>
          </c:spPr>
          <c:xVal>
            <c:numRef>
              <c:f>Sheet2!$K$6:$K$1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L$6:$L$12</c:f>
              <c:numCache>
                <c:formatCode>General</c:formatCode>
                <c:ptCount val="7"/>
                <c:pt idx="0">
                  <c:v>4.1719041888331824E-5</c:v>
                </c:pt>
                <c:pt idx="1">
                  <c:v>3.4729941619604431E-5</c:v>
                </c:pt>
                <c:pt idx="2">
                  <c:v>3.9157221992145828E-5</c:v>
                </c:pt>
                <c:pt idx="3">
                  <c:v>7.5278973334499337E-5</c:v>
                </c:pt>
                <c:pt idx="4">
                  <c:v>8.6767069929613577E-5</c:v>
                </c:pt>
                <c:pt idx="5">
                  <c:v>3.1857750714516759E-5</c:v>
                </c:pt>
                <c:pt idx="6">
                  <c:v>4.342886785124427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297792"/>
        <c:axId val="251299328"/>
      </c:scatterChart>
      <c:valAx>
        <c:axId val="25129779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299328"/>
        <c:crosses val="autoZero"/>
        <c:crossBetween val="midCat"/>
        <c:majorUnit val="4"/>
      </c:valAx>
      <c:valAx>
        <c:axId val="2512993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2977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8719089691788644"/>
          <c:y val="0.52602189959777479"/>
          <c:w val="0.52369619749852381"/>
          <c:h val="0.1736330371894163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/>
              <a:t>ELF4 </a:t>
            </a:r>
            <a:r>
              <a:rPr lang="en-US" altLang="en-US" dirty="0" smtClean="0"/>
              <a:t>; At2g40080</a:t>
            </a:r>
            <a:endParaRPr lang="en-US" altLang="en-US" dirty="0"/>
          </a:p>
        </c:rich>
      </c:tx>
      <c:layout>
        <c:manualLayout>
          <c:xMode val="edge"/>
          <c:yMode val="edge"/>
          <c:x val="0.2207609973160877"/>
          <c:y val="9.5689722418549214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199124073933342"/>
          <c:y val="6.3910452030152692E-2"/>
          <c:w val="0.80315330460358292"/>
          <c:h val="0.7765034086047183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0:$B$10</c:f>
              <c:strCache>
                <c:ptCount val="1"/>
                <c:pt idx="0">
                  <c:v>ELF4 At2g4008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0:$V$10</c:f>
                <c:numCache>
                  <c:formatCode>General</c:formatCode>
                  <c:ptCount val="6"/>
                  <c:pt idx="0">
                    <c:v>0.73926435138774549</c:v>
                  </c:pt>
                  <c:pt idx="1">
                    <c:v>0.5739879959841665</c:v>
                  </c:pt>
                  <c:pt idx="2">
                    <c:v>0.12886946269430191</c:v>
                  </c:pt>
                  <c:pt idx="3">
                    <c:v>0.17428212184619107</c:v>
                  </c:pt>
                  <c:pt idx="4">
                    <c:v>0.23729452328237671</c:v>
                  </c:pt>
                  <c:pt idx="5">
                    <c:v>4.9361920237298872E-2</c:v>
                  </c:pt>
                </c:numCache>
              </c:numRef>
            </c:plus>
            <c:minus>
              <c:numRef>
                <c:f>Sheet4!$Q$10:$V$10</c:f>
                <c:numCache>
                  <c:formatCode>General</c:formatCode>
                  <c:ptCount val="6"/>
                  <c:pt idx="0">
                    <c:v>0.73926435138774549</c:v>
                  </c:pt>
                  <c:pt idx="1">
                    <c:v>0.5739879959841665</c:v>
                  </c:pt>
                  <c:pt idx="2">
                    <c:v>0.12886946269430191</c:v>
                  </c:pt>
                  <c:pt idx="3">
                    <c:v>0.17428212184619107</c:v>
                  </c:pt>
                  <c:pt idx="4">
                    <c:v>0.23729452328237671</c:v>
                  </c:pt>
                  <c:pt idx="5">
                    <c:v>4.9361920237298872E-2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0:$H$10</c:f>
              <c:numCache>
                <c:formatCode>General</c:formatCode>
                <c:ptCount val="6"/>
                <c:pt idx="0">
                  <c:v>3.5321027493333332</c:v>
                </c:pt>
                <c:pt idx="1">
                  <c:v>4.3763358293333336</c:v>
                </c:pt>
                <c:pt idx="2">
                  <c:v>10.962651816666687</c:v>
                </c:pt>
                <c:pt idx="3">
                  <c:v>10.959254416666685</c:v>
                </c:pt>
                <c:pt idx="4">
                  <c:v>8.3256161046666808</c:v>
                </c:pt>
                <c:pt idx="5">
                  <c:v>7.006294960999996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385344"/>
        <c:axId val="251386880"/>
      </c:scatterChart>
      <c:valAx>
        <c:axId val="25138534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386880"/>
        <c:crosses val="autoZero"/>
        <c:crossBetween val="midCat"/>
        <c:majorUnit val="4"/>
      </c:valAx>
      <c:valAx>
        <c:axId val="251386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3853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/>
              <a:t>RVE4 </a:t>
            </a:r>
            <a:r>
              <a:rPr lang="en-US" altLang="en-US" dirty="0" smtClean="0"/>
              <a:t>; At5g02840</a:t>
            </a:r>
            <a:endParaRPr lang="en-US" altLang="en-US" dirty="0"/>
          </a:p>
        </c:rich>
      </c:tx>
      <c:layout>
        <c:manualLayout>
          <c:xMode val="edge"/>
          <c:yMode val="edge"/>
          <c:x val="0.25646491741467492"/>
          <c:y val="6.63755401132251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3906358629109941"/>
          <c:y val="5.3218997172357202E-2"/>
          <c:w val="0.80721199935402366"/>
          <c:h val="0.7949611034855147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1:$B$11</c:f>
              <c:strCache>
                <c:ptCount val="1"/>
                <c:pt idx="0">
                  <c:v>RVE4 At5g0284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1:$V$11</c:f>
                <c:numCache>
                  <c:formatCode>General</c:formatCode>
                  <c:ptCount val="6"/>
                  <c:pt idx="0">
                    <c:v>0.12915433902227144</c:v>
                  </c:pt>
                  <c:pt idx="1">
                    <c:v>2.9909658453958089E-2</c:v>
                  </c:pt>
                  <c:pt idx="2">
                    <c:v>0.11806084447203632</c:v>
                  </c:pt>
                  <c:pt idx="3">
                    <c:v>0.17139205545949193</c:v>
                  </c:pt>
                  <c:pt idx="4">
                    <c:v>0.11151773532188825</c:v>
                  </c:pt>
                  <c:pt idx="5">
                    <c:v>0.15919640530052287</c:v>
                  </c:pt>
                </c:numCache>
              </c:numRef>
            </c:plus>
            <c:minus>
              <c:numRef>
                <c:f>Sheet4!$Q$11:$V$11</c:f>
                <c:numCache>
                  <c:formatCode>General</c:formatCode>
                  <c:ptCount val="6"/>
                  <c:pt idx="0">
                    <c:v>0.12915433902227144</c:v>
                  </c:pt>
                  <c:pt idx="1">
                    <c:v>2.9909658453958089E-2</c:v>
                  </c:pt>
                  <c:pt idx="2">
                    <c:v>0.11806084447203632</c:v>
                  </c:pt>
                  <c:pt idx="3">
                    <c:v>0.17139205545949193</c:v>
                  </c:pt>
                  <c:pt idx="4">
                    <c:v>0.11151773532188825</c:v>
                  </c:pt>
                  <c:pt idx="5">
                    <c:v>0.15919640530052287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1:$H$11</c:f>
              <c:numCache>
                <c:formatCode>General</c:formatCode>
                <c:ptCount val="6"/>
                <c:pt idx="0">
                  <c:v>12.722791746666667</c:v>
                </c:pt>
                <c:pt idx="1">
                  <c:v>10.389931233333346</c:v>
                </c:pt>
                <c:pt idx="2">
                  <c:v>9.0241852409999996</c:v>
                </c:pt>
                <c:pt idx="3">
                  <c:v>9.4139734096666672</c:v>
                </c:pt>
                <c:pt idx="4">
                  <c:v>10.727357313333323</c:v>
                </c:pt>
                <c:pt idx="5">
                  <c:v>11.91232211666667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395072"/>
        <c:axId val="250950400"/>
      </c:scatterChart>
      <c:valAx>
        <c:axId val="25139507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950400"/>
        <c:crosses val="autoZero"/>
        <c:crossBetween val="midCat"/>
        <c:majorUnit val="4"/>
      </c:valAx>
      <c:valAx>
        <c:axId val="250950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01600">
            <a:solidFill>
              <a:prstClr val="black"/>
            </a:solidFill>
          </a:ln>
        </c:spPr>
        <c:crossAx val="25139507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1718449107506599"/>
          <c:y val="0.1062008641811602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51216531496499"/>
          <c:y val="7.5976325211177281E-2"/>
          <c:w val="0.80520379101396078"/>
          <c:h val="0.7627215554305211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2:$B$12</c:f>
              <c:strCache>
                <c:ptCount val="1"/>
                <c:pt idx="0">
                  <c:v>RVE8 At3g0960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2:$V$12</c:f>
                <c:numCache>
                  <c:formatCode>General</c:formatCode>
                  <c:ptCount val="6"/>
                  <c:pt idx="0">
                    <c:v>7.9420464437338148E-2</c:v>
                  </c:pt>
                  <c:pt idx="1">
                    <c:v>0.19800596587774574</c:v>
                  </c:pt>
                  <c:pt idx="2">
                    <c:v>0.34938429113847913</c:v>
                  </c:pt>
                  <c:pt idx="3">
                    <c:v>8.0265897683906545E-2</c:v>
                  </c:pt>
                  <c:pt idx="4">
                    <c:v>8.8757134464308343E-2</c:v>
                  </c:pt>
                  <c:pt idx="5">
                    <c:v>0.23716681580583751</c:v>
                  </c:pt>
                </c:numCache>
              </c:numRef>
            </c:plus>
            <c:minus>
              <c:numRef>
                <c:f>Sheet4!$Q$12:$V$12</c:f>
                <c:numCache>
                  <c:formatCode>General</c:formatCode>
                  <c:ptCount val="6"/>
                  <c:pt idx="0">
                    <c:v>7.9420464437338148E-2</c:v>
                  </c:pt>
                  <c:pt idx="1">
                    <c:v>0.19800596587774574</c:v>
                  </c:pt>
                  <c:pt idx="2">
                    <c:v>0.34938429113847913</c:v>
                  </c:pt>
                  <c:pt idx="3">
                    <c:v>8.0265897683906545E-2</c:v>
                  </c:pt>
                  <c:pt idx="4">
                    <c:v>8.8757134464308343E-2</c:v>
                  </c:pt>
                  <c:pt idx="5">
                    <c:v>0.23716681580583751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2:$H$12</c:f>
              <c:numCache>
                <c:formatCode>General</c:formatCode>
                <c:ptCount val="6"/>
                <c:pt idx="0">
                  <c:v>9.4683763983333336</c:v>
                </c:pt>
                <c:pt idx="1">
                  <c:v>7.3148578253333341</c:v>
                </c:pt>
                <c:pt idx="2">
                  <c:v>1.643645560666668</c:v>
                </c:pt>
                <c:pt idx="3">
                  <c:v>0.71880103600000134</c:v>
                </c:pt>
                <c:pt idx="4">
                  <c:v>5.2176602853333423</c:v>
                </c:pt>
                <c:pt idx="5">
                  <c:v>8.359950073666681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974976"/>
        <c:axId val="250976512"/>
      </c:scatterChart>
      <c:valAx>
        <c:axId val="25097497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976512"/>
        <c:crosses val="autoZero"/>
        <c:crossBetween val="midCat"/>
        <c:majorUnit val="4"/>
      </c:valAx>
      <c:valAx>
        <c:axId val="2509765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97497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/>
              <a:t>LUX </a:t>
            </a:r>
            <a:r>
              <a:rPr lang="en-US" altLang="en-US" dirty="0" smtClean="0"/>
              <a:t>; At3g46640</a:t>
            </a:r>
            <a:endParaRPr lang="en-US" altLang="en-US" dirty="0"/>
          </a:p>
        </c:rich>
      </c:tx>
      <c:layout>
        <c:manualLayout>
          <c:xMode val="edge"/>
          <c:yMode val="edge"/>
          <c:x val="0.23260917918609544"/>
          <c:y val="7.831112663196432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01828704608013"/>
          <c:y val="6.8880403554215319E-2"/>
          <c:w val="0.8058884692001087"/>
          <c:h val="0.7686621340361036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3:$B$13</c:f>
              <c:strCache>
                <c:ptCount val="1"/>
                <c:pt idx="0">
                  <c:v>LUX At3g4664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3:$V$13</c:f>
                <c:numCache>
                  <c:formatCode>General</c:formatCode>
                  <c:ptCount val="6"/>
                  <c:pt idx="0">
                    <c:v>0.13256297310454768</c:v>
                  </c:pt>
                  <c:pt idx="1">
                    <c:v>0.44426196934293632</c:v>
                  </c:pt>
                  <c:pt idx="2">
                    <c:v>0.16053763209826979</c:v>
                  </c:pt>
                  <c:pt idx="3">
                    <c:v>0.11811864729228112</c:v>
                  </c:pt>
                  <c:pt idx="4">
                    <c:v>0.21396400450305628</c:v>
                  </c:pt>
                  <c:pt idx="5">
                    <c:v>2.3640014483985596E-2</c:v>
                  </c:pt>
                </c:numCache>
              </c:numRef>
            </c:plus>
            <c:minus>
              <c:numRef>
                <c:f>Sheet4!$Q$13:$V$13</c:f>
                <c:numCache>
                  <c:formatCode>General</c:formatCode>
                  <c:ptCount val="6"/>
                  <c:pt idx="0">
                    <c:v>0.13256297310454768</c:v>
                  </c:pt>
                  <c:pt idx="1">
                    <c:v>0.44426196934293632</c:v>
                  </c:pt>
                  <c:pt idx="2">
                    <c:v>0.16053763209826979</c:v>
                  </c:pt>
                  <c:pt idx="3">
                    <c:v>0.11811864729228112</c:v>
                  </c:pt>
                  <c:pt idx="4">
                    <c:v>0.21396400450305628</c:v>
                  </c:pt>
                  <c:pt idx="5">
                    <c:v>2.3640014483985596E-2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3:$H$13</c:f>
              <c:numCache>
                <c:formatCode>General</c:formatCode>
                <c:ptCount val="6"/>
                <c:pt idx="0">
                  <c:v>6.3367100113333334</c:v>
                </c:pt>
                <c:pt idx="1">
                  <c:v>4.287643207333339</c:v>
                </c:pt>
                <c:pt idx="2">
                  <c:v>9.3953598426666787</c:v>
                </c:pt>
                <c:pt idx="3">
                  <c:v>9.2157328660000104</c:v>
                </c:pt>
                <c:pt idx="4">
                  <c:v>7.301496240333333</c:v>
                </c:pt>
                <c:pt idx="5">
                  <c:v>7.427295370999994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013376"/>
        <c:axId val="251023360"/>
      </c:scatterChart>
      <c:valAx>
        <c:axId val="25101337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023360"/>
        <c:crosses val="autoZero"/>
        <c:crossBetween val="midCat"/>
        <c:majorUnit val="4"/>
      </c:valAx>
      <c:valAx>
        <c:axId val="2510233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01337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/>
              <a:t>LKP2 </a:t>
            </a:r>
            <a:r>
              <a:rPr lang="en-US" altLang="en-US" dirty="0" smtClean="0"/>
              <a:t>; At2g18915</a:t>
            </a:r>
            <a:endParaRPr lang="en-US" altLang="en-US" dirty="0"/>
          </a:p>
        </c:rich>
      </c:tx>
      <c:layout/>
      <c:overlay val="0"/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4!$A$14:$B$14</c:f>
              <c:strCache>
                <c:ptCount val="1"/>
                <c:pt idx="0">
                  <c:v>LKP2 At2g18915</c:v>
                </c:pt>
              </c:strCache>
            </c:strRef>
          </c:tx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4:$V$14</c:f>
                <c:numCache>
                  <c:formatCode>General</c:formatCode>
                  <c:ptCount val="6"/>
                  <c:pt idx="0">
                    <c:v>0.19414777379782186</c:v>
                  </c:pt>
                  <c:pt idx="1">
                    <c:v>8.1181758117210234E-2</c:v>
                  </c:pt>
                  <c:pt idx="2">
                    <c:v>8.9981907571219544E-2</c:v>
                  </c:pt>
                  <c:pt idx="3">
                    <c:v>0.12518175614884824</c:v>
                  </c:pt>
                  <c:pt idx="4">
                    <c:v>9.0035675159110748E-2</c:v>
                  </c:pt>
                  <c:pt idx="5">
                    <c:v>0.12722432579639664</c:v>
                  </c:pt>
                </c:numCache>
              </c:numRef>
            </c:plus>
            <c:minus>
              <c:numRef>
                <c:f>Sheet4!$Q$14:$V$14</c:f>
                <c:numCache>
                  <c:formatCode>General</c:formatCode>
                  <c:ptCount val="6"/>
                  <c:pt idx="0">
                    <c:v>0.19414777379782186</c:v>
                  </c:pt>
                  <c:pt idx="1">
                    <c:v>8.1181758117210234E-2</c:v>
                  </c:pt>
                  <c:pt idx="2">
                    <c:v>8.9981907571219544E-2</c:v>
                  </c:pt>
                  <c:pt idx="3">
                    <c:v>0.12518175614884824</c:v>
                  </c:pt>
                  <c:pt idx="4">
                    <c:v>9.0035675159110748E-2</c:v>
                  </c:pt>
                  <c:pt idx="5">
                    <c:v>0.12722432579639664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4:$H$14</c:f>
              <c:numCache>
                <c:formatCode>General</c:formatCode>
                <c:ptCount val="6"/>
                <c:pt idx="0">
                  <c:v>8.4832843803333322</c:v>
                </c:pt>
                <c:pt idx="1">
                  <c:v>7.9468517426666727</c:v>
                </c:pt>
                <c:pt idx="2">
                  <c:v>8.0557417596666792</c:v>
                </c:pt>
                <c:pt idx="3">
                  <c:v>8.1248037629999939</c:v>
                </c:pt>
                <c:pt idx="4">
                  <c:v>8.1735945290000114</c:v>
                </c:pt>
                <c:pt idx="5">
                  <c:v>8.305415134000011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043840"/>
        <c:axId val="251045376"/>
      </c:scatterChart>
      <c:valAx>
        <c:axId val="25104384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045376"/>
        <c:crosses val="autoZero"/>
        <c:crossBetween val="midCat"/>
        <c:majorUnit val="4"/>
      </c:valAx>
      <c:valAx>
        <c:axId val="251045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04384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698920683771489"/>
          <c:y val="8.9489572894076524E-2"/>
          <c:w val="0.84070167576736898"/>
          <c:h val="0.7536353108998791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7</c:f>
              <c:strCache>
                <c:ptCount val="1"/>
                <c:pt idx="0">
                  <c:v>Bra001650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7:$K$7</c:f>
              <c:numCache>
                <c:formatCode>General</c:formatCode>
                <c:ptCount val="7"/>
                <c:pt idx="0">
                  <c:v>0</c:v>
                </c:pt>
                <c:pt idx="1">
                  <c:v>2.3E-2</c:v>
                </c:pt>
                <c:pt idx="2">
                  <c:v>0.10400000000000002</c:v>
                </c:pt>
                <c:pt idx="3">
                  <c:v>0.27800000000000002</c:v>
                </c:pt>
                <c:pt idx="4">
                  <c:v>5.3000000000000012E-2</c:v>
                </c:pt>
                <c:pt idx="5">
                  <c:v>8.8500000000000134E-2</c:v>
                </c:pt>
                <c:pt idx="6">
                  <c:v>4.3500000000000004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8</c:f>
              <c:strCache>
                <c:ptCount val="1"/>
                <c:pt idx="0">
                  <c:v>Bra022192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8:$K$8</c:f>
              <c:numCache>
                <c:formatCode>General</c:formatCode>
                <c:ptCount val="7"/>
                <c:pt idx="0">
                  <c:v>11.891500000000002</c:v>
                </c:pt>
                <c:pt idx="1">
                  <c:v>22.901999999999987</c:v>
                </c:pt>
                <c:pt idx="2">
                  <c:v>17.868499999999969</c:v>
                </c:pt>
                <c:pt idx="3">
                  <c:v>13.7445</c:v>
                </c:pt>
                <c:pt idx="4">
                  <c:v>10.0265</c:v>
                </c:pt>
                <c:pt idx="5">
                  <c:v>11.850500000000011</c:v>
                </c:pt>
                <c:pt idx="6">
                  <c:v>12.91400000000000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4814592"/>
        <c:axId val="224816128"/>
      </c:scatterChart>
      <c:valAx>
        <c:axId val="22481459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24816128"/>
        <c:crosses val="autoZero"/>
        <c:crossBetween val="midCat"/>
        <c:majorUnit val="4"/>
      </c:valAx>
      <c:valAx>
        <c:axId val="224816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248145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8711886014248291"/>
          <c:y val="0.53413151940033432"/>
          <c:w val="0.40158276360669798"/>
          <c:h val="0.2301412834085152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/>
              <a:t>LHY </a:t>
            </a:r>
            <a:r>
              <a:rPr lang="en-US" altLang="en-US" dirty="0" smtClean="0"/>
              <a:t>; At1g01060</a:t>
            </a:r>
            <a:endParaRPr lang="en-US" altLang="en-US" dirty="0"/>
          </a:p>
        </c:rich>
      </c:tx>
      <c:layout>
        <c:manualLayout>
          <c:xMode val="edge"/>
          <c:yMode val="edge"/>
          <c:x val="0.27808372019785094"/>
          <c:y val="9.825733095059817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1095405082339"/>
          <c:y val="5.6805056651957307E-2"/>
          <c:w val="0.80439522831506904"/>
          <c:h val="0.7824779981095432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7:$B$17</c:f>
              <c:strCache>
                <c:ptCount val="1"/>
                <c:pt idx="0">
                  <c:v>LHY At1g01060</c:v>
                </c:pt>
              </c:strCache>
            </c:strRef>
          </c:tx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7:$V$17</c:f>
                <c:numCache>
                  <c:formatCode>General</c:formatCode>
                  <c:ptCount val="6"/>
                  <c:pt idx="0">
                    <c:v>0.20204644980861949</c:v>
                  </c:pt>
                  <c:pt idx="1">
                    <c:v>6.355050046291405E-2</c:v>
                  </c:pt>
                  <c:pt idx="2">
                    <c:v>7.5365844597391013E-2</c:v>
                  </c:pt>
                  <c:pt idx="3">
                    <c:v>0.89995608786805659</c:v>
                  </c:pt>
                  <c:pt idx="4">
                    <c:v>0.79827147578329305</c:v>
                  </c:pt>
                  <c:pt idx="5">
                    <c:v>0.19623937250605938</c:v>
                  </c:pt>
                </c:numCache>
              </c:numRef>
            </c:plus>
            <c:minus>
              <c:numRef>
                <c:f>Sheet4!$Q$17:$V$17</c:f>
                <c:numCache>
                  <c:formatCode>General</c:formatCode>
                  <c:ptCount val="6"/>
                  <c:pt idx="0">
                    <c:v>0.20204644980861949</c:v>
                  </c:pt>
                  <c:pt idx="1">
                    <c:v>6.355050046291405E-2</c:v>
                  </c:pt>
                  <c:pt idx="2">
                    <c:v>7.5365844597391013E-2</c:v>
                  </c:pt>
                  <c:pt idx="3">
                    <c:v>0.89995608786805659</c:v>
                  </c:pt>
                  <c:pt idx="4">
                    <c:v>0.79827147578329305</c:v>
                  </c:pt>
                  <c:pt idx="5">
                    <c:v>0.19623937250605938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7:$H$17</c:f>
              <c:numCache>
                <c:formatCode>General</c:formatCode>
                <c:ptCount val="6"/>
                <c:pt idx="0">
                  <c:v>13.415037000000011</c:v>
                </c:pt>
                <c:pt idx="1">
                  <c:v>10.003612851333342</c:v>
                </c:pt>
                <c:pt idx="2">
                  <c:v>6.2615651139999997</c:v>
                </c:pt>
                <c:pt idx="3">
                  <c:v>4.611883919666667</c:v>
                </c:pt>
                <c:pt idx="4">
                  <c:v>5.1396418496666714</c:v>
                </c:pt>
                <c:pt idx="5">
                  <c:v>11.72267286000000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872768"/>
        <c:axId val="251874304"/>
      </c:scatterChart>
      <c:valAx>
        <c:axId val="25187276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874304"/>
        <c:crosses val="autoZero"/>
        <c:crossBetween val="midCat"/>
        <c:majorUnit val="4"/>
      </c:valAx>
      <c:valAx>
        <c:axId val="251874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87276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1199538638984992E-2"/>
          <c:y val="5.1400554097404488E-2"/>
          <c:w val="0.85604373847732762"/>
          <c:h val="0.8599291433480423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19</c:f>
              <c:strCache>
                <c:ptCount val="1"/>
                <c:pt idx="0">
                  <c:v>Bra000165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9:$K$19</c:f>
              <c:numCache>
                <c:formatCode>General</c:formatCode>
                <c:ptCount val="7"/>
                <c:pt idx="0">
                  <c:v>0.12000000000000002</c:v>
                </c:pt>
                <c:pt idx="1">
                  <c:v>0.27150000000000002</c:v>
                </c:pt>
                <c:pt idx="2">
                  <c:v>38.112000000000002</c:v>
                </c:pt>
                <c:pt idx="3">
                  <c:v>64.462999999999994</c:v>
                </c:pt>
                <c:pt idx="4">
                  <c:v>18.8705</c:v>
                </c:pt>
                <c:pt idx="5">
                  <c:v>0.82750000000000001</c:v>
                </c:pt>
                <c:pt idx="6">
                  <c:v>0.11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20</c:f>
              <c:strCache>
                <c:ptCount val="1"/>
                <c:pt idx="0">
                  <c:v>Bra004991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0:$K$20</c:f>
              <c:numCache>
                <c:formatCode>General</c:formatCode>
                <c:ptCount val="7"/>
                <c:pt idx="0">
                  <c:v>0.18500000000000016</c:v>
                </c:pt>
                <c:pt idx="1">
                  <c:v>0.20350000000000001</c:v>
                </c:pt>
                <c:pt idx="2">
                  <c:v>21.949499999999972</c:v>
                </c:pt>
                <c:pt idx="3">
                  <c:v>91.254999999999995</c:v>
                </c:pt>
                <c:pt idx="4">
                  <c:v>39.796000000000049</c:v>
                </c:pt>
                <c:pt idx="5">
                  <c:v>7.6214999999999975</c:v>
                </c:pt>
                <c:pt idx="6">
                  <c:v>0.3875000000000004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2!$A$21</c:f>
              <c:strCache>
                <c:ptCount val="1"/>
                <c:pt idx="0">
                  <c:v>Bra017035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1:$K$21</c:f>
              <c:numCache>
                <c:formatCode>General</c:formatCode>
                <c:ptCount val="7"/>
                <c:pt idx="0">
                  <c:v>0.21250000000000016</c:v>
                </c:pt>
                <c:pt idx="1">
                  <c:v>3.4000000000000002E-2</c:v>
                </c:pt>
                <c:pt idx="2">
                  <c:v>70.731499999999997</c:v>
                </c:pt>
                <c:pt idx="3">
                  <c:v>45.097500000000011</c:v>
                </c:pt>
                <c:pt idx="4">
                  <c:v>17.971499999999974</c:v>
                </c:pt>
                <c:pt idx="5">
                  <c:v>0.85400000000000065</c:v>
                </c:pt>
                <c:pt idx="6">
                  <c:v>0.1170000000000000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904384"/>
        <c:axId val="251905920"/>
      </c:scatterChart>
      <c:valAx>
        <c:axId val="251904384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905920"/>
        <c:crosses val="autoZero"/>
        <c:crossBetween val="midCat"/>
        <c:majorUnit val="4"/>
      </c:valAx>
      <c:valAx>
        <c:axId val="251905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90438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4285813481041831"/>
          <c:y val="4.5912514128392139E-2"/>
          <c:w val="0.34203017010416958"/>
          <c:h val="0.3314314576214533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80804146793479"/>
          <c:y val="5.1400554097404488E-2"/>
          <c:w val="0.78691351753073879"/>
          <c:h val="0.8223609952000083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22</c:f>
              <c:strCache>
                <c:ptCount val="1"/>
                <c:pt idx="0">
                  <c:v>Bra005751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2:$K$22</c:f>
              <c:numCache>
                <c:formatCode>General</c:formatCode>
                <c:ptCount val="7"/>
                <c:pt idx="0">
                  <c:v>70.109000000000009</c:v>
                </c:pt>
                <c:pt idx="1">
                  <c:v>22.003</c:v>
                </c:pt>
                <c:pt idx="2">
                  <c:v>3.0754999999999977</c:v>
                </c:pt>
                <c:pt idx="3">
                  <c:v>2.3944999999999972</c:v>
                </c:pt>
                <c:pt idx="4">
                  <c:v>3.387</c:v>
                </c:pt>
                <c:pt idx="5">
                  <c:v>32.889499999999998</c:v>
                </c:pt>
                <c:pt idx="6">
                  <c:v>64.88150000000000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23</c:f>
              <c:strCache>
                <c:ptCount val="1"/>
                <c:pt idx="0">
                  <c:v>Bra005754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3:$K$23</c:f>
              <c:numCache>
                <c:formatCode>General</c:formatCode>
                <c:ptCount val="7"/>
                <c:pt idx="0">
                  <c:v>0.16900000000000001</c:v>
                </c:pt>
                <c:pt idx="1">
                  <c:v>1.7000000000000001E-2</c:v>
                </c:pt>
                <c:pt idx="2">
                  <c:v>0</c:v>
                </c:pt>
                <c:pt idx="3">
                  <c:v>6.5500000000000003E-2</c:v>
                </c:pt>
                <c:pt idx="4">
                  <c:v>0.13700000000000001</c:v>
                </c:pt>
                <c:pt idx="5">
                  <c:v>0.18100000000000016</c:v>
                </c:pt>
                <c:pt idx="6">
                  <c:v>0.1730000000000000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2!$A$24</c:f>
              <c:strCache>
                <c:ptCount val="1"/>
                <c:pt idx="0">
                  <c:v>Bra009562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4:$K$24</c:f>
              <c:numCache>
                <c:formatCode>General</c:formatCode>
                <c:ptCount val="7"/>
                <c:pt idx="0">
                  <c:v>87.570999999999998</c:v>
                </c:pt>
                <c:pt idx="1">
                  <c:v>32.785500000000013</c:v>
                </c:pt>
                <c:pt idx="2">
                  <c:v>11.738</c:v>
                </c:pt>
                <c:pt idx="3">
                  <c:v>12.727500000000001</c:v>
                </c:pt>
                <c:pt idx="4">
                  <c:v>16.070499999999978</c:v>
                </c:pt>
                <c:pt idx="5">
                  <c:v>32.582500000000003</c:v>
                </c:pt>
                <c:pt idx="6">
                  <c:v>62.33300000000000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927552"/>
        <c:axId val="251929344"/>
      </c:scatterChart>
      <c:valAx>
        <c:axId val="25192755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929344"/>
        <c:crosses val="autoZero"/>
        <c:crossBetween val="midCat"/>
        <c:majorUnit val="4"/>
      </c:valAx>
      <c:valAx>
        <c:axId val="251929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92755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261887694145774"/>
          <c:y val="0.13850503062117275"/>
          <c:w val="0.34767025089605735"/>
          <c:h val="0.2922705071944379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9818594104308721E-2"/>
          <c:y val="5.1400554097404488E-2"/>
          <c:w val="0.8699887514060759"/>
          <c:h val="0.8223609952000083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27</c:f>
              <c:strCache>
                <c:ptCount val="1"/>
                <c:pt idx="0">
                  <c:v>Bra018204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7:$K$27</c:f>
              <c:numCache>
                <c:formatCode>General</c:formatCode>
                <c:ptCount val="7"/>
                <c:pt idx="0">
                  <c:v>1.498</c:v>
                </c:pt>
                <c:pt idx="1">
                  <c:v>0.13</c:v>
                </c:pt>
                <c:pt idx="2">
                  <c:v>4.0004999999999997</c:v>
                </c:pt>
                <c:pt idx="3">
                  <c:v>46.655000000000001</c:v>
                </c:pt>
                <c:pt idx="4">
                  <c:v>10.989000000000004</c:v>
                </c:pt>
                <c:pt idx="5">
                  <c:v>4.9660000000000002</c:v>
                </c:pt>
                <c:pt idx="6">
                  <c:v>0.7190000000000006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28</c:f>
              <c:strCache>
                <c:ptCount val="1"/>
                <c:pt idx="0">
                  <c:v>Bra033809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8:$K$28</c:f>
              <c:numCache>
                <c:formatCode>General</c:formatCode>
                <c:ptCount val="7"/>
                <c:pt idx="0">
                  <c:v>0.86100000000000065</c:v>
                </c:pt>
                <c:pt idx="1">
                  <c:v>0.54400000000000004</c:v>
                </c:pt>
                <c:pt idx="2">
                  <c:v>9.468</c:v>
                </c:pt>
                <c:pt idx="3">
                  <c:v>24.944000000000003</c:v>
                </c:pt>
                <c:pt idx="4">
                  <c:v>9.1595000000000066</c:v>
                </c:pt>
                <c:pt idx="5">
                  <c:v>3.3979999999999997</c:v>
                </c:pt>
                <c:pt idx="6">
                  <c:v>0.687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966592"/>
        <c:axId val="251968128"/>
      </c:scatterChart>
      <c:valAx>
        <c:axId val="25196659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968128"/>
        <c:crosses val="autoZero"/>
        <c:crossBetween val="midCat"/>
        <c:majorUnit val="4"/>
      </c:valAx>
      <c:valAx>
        <c:axId val="251968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9665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2780045351474234"/>
          <c:y val="0.14332640711577721"/>
          <c:w val="0.37219948069916631"/>
          <c:h val="0.2457562403514130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0994439254415263E-2"/>
          <c:y val="5.1400554097404488E-2"/>
          <c:w val="0.84752524578495458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25</c:f>
              <c:strCache>
                <c:ptCount val="1"/>
                <c:pt idx="0">
                  <c:v>Bra029778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5:$K$25</c:f>
              <c:numCache>
                <c:formatCode>General</c:formatCode>
                <c:ptCount val="7"/>
                <c:pt idx="0">
                  <c:v>136.16850000000002</c:v>
                </c:pt>
                <c:pt idx="1">
                  <c:v>28.927999999999987</c:v>
                </c:pt>
                <c:pt idx="2">
                  <c:v>2.1805000000000012</c:v>
                </c:pt>
                <c:pt idx="3">
                  <c:v>0.34950000000000031</c:v>
                </c:pt>
                <c:pt idx="4">
                  <c:v>0.68300000000000005</c:v>
                </c:pt>
                <c:pt idx="5">
                  <c:v>28.672499999999989</c:v>
                </c:pt>
                <c:pt idx="6">
                  <c:v>140.3375000000000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26</c:f>
              <c:strCache>
                <c:ptCount val="1"/>
                <c:pt idx="0">
                  <c:v>Bra034074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6:$K$26</c:f>
              <c:numCache>
                <c:formatCode>General</c:formatCode>
                <c:ptCount val="7"/>
                <c:pt idx="0">
                  <c:v>38.900500000000001</c:v>
                </c:pt>
                <c:pt idx="1">
                  <c:v>18.593</c:v>
                </c:pt>
                <c:pt idx="2">
                  <c:v>3.4575</c:v>
                </c:pt>
                <c:pt idx="3">
                  <c:v>0.33950000000000047</c:v>
                </c:pt>
                <c:pt idx="4">
                  <c:v>0.49650000000000033</c:v>
                </c:pt>
                <c:pt idx="5">
                  <c:v>12.622</c:v>
                </c:pt>
                <c:pt idx="6">
                  <c:v>44.50550000000001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984896"/>
        <c:axId val="251138816"/>
      </c:scatterChart>
      <c:valAx>
        <c:axId val="25198489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138816"/>
        <c:crosses val="autoZero"/>
        <c:crossBetween val="midCat"/>
        <c:majorUnit val="4"/>
      </c:valAx>
      <c:valAx>
        <c:axId val="25113881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9848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8555932203389833"/>
          <c:y val="0.22665974044911052"/>
          <c:w val="0.45507744271255085"/>
          <c:h val="0.2398820977873606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345290172061825"/>
          <c:y val="5.1400554097404488E-2"/>
          <c:w val="0.78646617089530235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29</c:f>
              <c:strCache>
                <c:ptCount val="1"/>
                <c:pt idx="0">
                  <c:v>Bra038830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29:$K$29</c:f>
              <c:numCache>
                <c:formatCode>General</c:formatCode>
                <c:ptCount val="7"/>
                <c:pt idx="0">
                  <c:v>12.17550000000001</c:v>
                </c:pt>
                <c:pt idx="1">
                  <c:v>11.690000000000001</c:v>
                </c:pt>
                <c:pt idx="2">
                  <c:v>7.6780000000000008</c:v>
                </c:pt>
                <c:pt idx="3">
                  <c:v>9.3710000000000004</c:v>
                </c:pt>
                <c:pt idx="4">
                  <c:v>6.7674999999999965</c:v>
                </c:pt>
                <c:pt idx="5">
                  <c:v>9.1060000000000034</c:v>
                </c:pt>
                <c:pt idx="6">
                  <c:v>10.93350000000000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30</c:f>
              <c:strCache>
                <c:ptCount val="1"/>
                <c:pt idx="0">
                  <c:v>Bra038831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0:$K$30</c:f>
              <c:numCache>
                <c:formatCode>General</c:formatCode>
                <c:ptCount val="7"/>
                <c:pt idx="0">
                  <c:v>11.788500000000001</c:v>
                </c:pt>
                <c:pt idx="1">
                  <c:v>9.5550000000000068</c:v>
                </c:pt>
                <c:pt idx="2">
                  <c:v>7.8584999999999985</c:v>
                </c:pt>
                <c:pt idx="3">
                  <c:v>8.9095000000000066</c:v>
                </c:pt>
                <c:pt idx="4">
                  <c:v>6.3580000000000005</c:v>
                </c:pt>
                <c:pt idx="5">
                  <c:v>8.5705000000000027</c:v>
                </c:pt>
                <c:pt idx="6">
                  <c:v>10.275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2!$A$31</c:f>
              <c:strCache>
                <c:ptCount val="1"/>
                <c:pt idx="0">
                  <c:v>Bra038832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1:$K$31</c:f>
              <c:numCache>
                <c:formatCode>General</c:formatCode>
                <c:ptCount val="7"/>
                <c:pt idx="0">
                  <c:v>0.10899999999999999</c:v>
                </c:pt>
                <c:pt idx="1">
                  <c:v>0.23750000000000004</c:v>
                </c:pt>
                <c:pt idx="2">
                  <c:v>97.841499999999996</c:v>
                </c:pt>
                <c:pt idx="3">
                  <c:v>24.920999999999989</c:v>
                </c:pt>
                <c:pt idx="4">
                  <c:v>6.1949999999999941</c:v>
                </c:pt>
                <c:pt idx="5">
                  <c:v>0.46850000000000008</c:v>
                </c:pt>
                <c:pt idx="6">
                  <c:v>0.129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172736"/>
        <c:axId val="251174272"/>
      </c:scatterChart>
      <c:valAx>
        <c:axId val="25117273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174272"/>
        <c:crosses val="autoZero"/>
        <c:crossBetween val="midCat"/>
        <c:majorUnit val="4"/>
      </c:valAx>
      <c:valAx>
        <c:axId val="251174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1727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3671296296296045"/>
          <c:y val="0.21319907208684291"/>
          <c:w val="0.34321777486147581"/>
          <c:h val="0.2968279099514556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5527970035774332E-2"/>
          <c:y val="5.1400554097404488E-2"/>
          <c:w val="0.83992863881338931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32</c:f>
              <c:strCache>
                <c:ptCount val="1"/>
                <c:pt idx="0">
                  <c:v>Bra030496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2:$K$32</c:f>
              <c:numCache>
                <c:formatCode>General</c:formatCode>
                <c:ptCount val="7"/>
                <c:pt idx="0">
                  <c:v>193.44200000000001</c:v>
                </c:pt>
                <c:pt idx="1">
                  <c:v>47.642500000000013</c:v>
                </c:pt>
                <c:pt idx="2">
                  <c:v>3.8589999999999987</c:v>
                </c:pt>
                <c:pt idx="3">
                  <c:v>0.52849999999999997</c:v>
                </c:pt>
                <c:pt idx="4">
                  <c:v>0.97300000000000064</c:v>
                </c:pt>
                <c:pt idx="5">
                  <c:v>99.951500000000024</c:v>
                </c:pt>
                <c:pt idx="6">
                  <c:v>196.9360000000000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33</c:f>
              <c:strCache>
                <c:ptCount val="1"/>
                <c:pt idx="0">
                  <c:v>Bra033291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3:$K$33</c:f>
              <c:numCache>
                <c:formatCode>General</c:formatCode>
                <c:ptCount val="7"/>
                <c:pt idx="0">
                  <c:v>1282.7809999999999</c:v>
                </c:pt>
                <c:pt idx="1">
                  <c:v>61.352499999999999</c:v>
                </c:pt>
                <c:pt idx="2">
                  <c:v>3.1989999999999998</c:v>
                </c:pt>
                <c:pt idx="3">
                  <c:v>2.3014999999999977</c:v>
                </c:pt>
                <c:pt idx="4">
                  <c:v>3.8509999999999978</c:v>
                </c:pt>
                <c:pt idx="5">
                  <c:v>331.29349999999954</c:v>
                </c:pt>
                <c:pt idx="6">
                  <c:v>1180.873499999998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990016"/>
        <c:axId val="251991552"/>
      </c:scatterChart>
      <c:valAx>
        <c:axId val="25199001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991552"/>
        <c:crosses val="autoZero"/>
        <c:crossBetween val="midCat"/>
        <c:majorUnit val="4"/>
      </c:valAx>
      <c:valAx>
        <c:axId val="251991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9900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8317912218268132"/>
          <c:y val="0.20814122193059201"/>
          <c:w val="0.34756820877817318"/>
          <c:h val="0.264744851246951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6106517935258082E-2"/>
          <c:y val="4.0022965879265092E-2"/>
          <c:w val="0.87285170603674611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F$35</c:f>
              <c:strCache>
                <c:ptCount val="1"/>
                <c:pt idx="0">
                  <c:v>Bra029778</c:v>
                </c:pt>
              </c:strCache>
            </c:strRef>
          </c:tx>
          <c:spPr>
            <a:ln w="165100"/>
          </c:spPr>
          <c:xVal>
            <c:numRef>
              <c:f>Sheet3!$E$36:$E$4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F$36:$F$42</c:f>
              <c:numCache>
                <c:formatCode>General</c:formatCode>
                <c:ptCount val="7"/>
                <c:pt idx="0">
                  <c:v>8.9179140231300663E-2</c:v>
                </c:pt>
                <c:pt idx="1">
                  <c:v>1.4470454142849715E-2</c:v>
                </c:pt>
                <c:pt idx="2">
                  <c:v>1.1017003430715901E-4</c:v>
                </c:pt>
                <c:pt idx="3">
                  <c:v>3.0361068462640081E-5</c:v>
                </c:pt>
                <c:pt idx="4">
                  <c:v>1.5920050402378862E-3</c:v>
                </c:pt>
                <c:pt idx="5">
                  <c:v>3.0208618188775245E-2</c:v>
                </c:pt>
                <c:pt idx="6">
                  <c:v>4.3203638559072478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G$35</c:f>
              <c:strCache>
                <c:ptCount val="1"/>
                <c:pt idx="0">
                  <c:v>Bra034074</c:v>
                </c:pt>
              </c:strCache>
            </c:strRef>
          </c:tx>
          <c:spPr>
            <a:ln w="165100"/>
          </c:spPr>
          <c:xVal>
            <c:numRef>
              <c:f>Sheet3!$E$36:$E$4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G$36:$G$42</c:f>
              <c:numCache>
                <c:formatCode>General</c:formatCode>
                <c:ptCount val="7"/>
                <c:pt idx="0">
                  <c:v>2.1253777220985514E-3</c:v>
                </c:pt>
                <c:pt idx="1">
                  <c:v>5.4988682519028944E-4</c:v>
                </c:pt>
                <c:pt idx="2">
                  <c:v>2.4869406575579473E-5</c:v>
                </c:pt>
                <c:pt idx="3">
                  <c:v>1.7100764378679001E-6</c:v>
                </c:pt>
                <c:pt idx="4">
                  <c:v>4.1187956862352384E-5</c:v>
                </c:pt>
                <c:pt idx="5">
                  <c:v>7.6355916919979363E-4</c:v>
                </c:pt>
                <c:pt idx="6">
                  <c:v>1.0056755629071275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012416"/>
        <c:axId val="252013952"/>
      </c:scatterChart>
      <c:valAx>
        <c:axId val="25201241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crossAx val="252013952"/>
        <c:crosses val="autoZero"/>
        <c:crossBetween val="midCat"/>
        <c:majorUnit val="4"/>
      </c:valAx>
      <c:valAx>
        <c:axId val="2520139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0124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3289073081714352"/>
          <c:y val="0.14150450674562728"/>
          <c:w val="0.38417628537727561"/>
          <c:h val="0.217277941339851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078315372366041"/>
          <c:y val="5.1911637477632513E-2"/>
          <c:w val="0.87617125984251965"/>
          <c:h val="0.83261956838728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D$11</c:f>
              <c:strCache>
                <c:ptCount val="1"/>
                <c:pt idx="0">
                  <c:v>Bra005751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F$2:$F$8</c:f>
                <c:numCache>
                  <c:formatCode>General</c:formatCode>
                  <c:ptCount val="7"/>
                  <c:pt idx="0">
                    <c:v>5.8487169171354166E-3</c:v>
                  </c:pt>
                  <c:pt idx="1">
                    <c:v>1.068086374909784E-3</c:v>
                  </c:pt>
                  <c:pt idx="2">
                    <c:v>2.5805266926699996E-5</c:v>
                  </c:pt>
                  <c:pt idx="3">
                    <c:v>1.1452394223382585E-4</c:v>
                  </c:pt>
                  <c:pt idx="4">
                    <c:v>4.1525959196278615E-4</c:v>
                  </c:pt>
                  <c:pt idx="5">
                    <c:v>6.8620902693295501E-4</c:v>
                  </c:pt>
                  <c:pt idx="6">
                    <c:v>1.6027759038498254E-3</c:v>
                  </c:pt>
                </c:numCache>
              </c:numRef>
            </c:plus>
            <c:minus>
              <c:numRef>
                <c:f>Sheet3!$F$2:$F$8</c:f>
                <c:numCache>
                  <c:formatCode>General</c:formatCode>
                  <c:ptCount val="7"/>
                  <c:pt idx="0">
                    <c:v>5.8487169171354166E-3</c:v>
                  </c:pt>
                  <c:pt idx="1">
                    <c:v>1.068086374909784E-3</c:v>
                  </c:pt>
                  <c:pt idx="2">
                    <c:v>2.5805266926699996E-5</c:v>
                  </c:pt>
                  <c:pt idx="3">
                    <c:v>1.1452394223382585E-4</c:v>
                  </c:pt>
                  <c:pt idx="4">
                    <c:v>4.1525959196278615E-4</c:v>
                  </c:pt>
                  <c:pt idx="5">
                    <c:v>6.8620902693295501E-4</c:v>
                  </c:pt>
                  <c:pt idx="6">
                    <c:v>1.6027759038498254E-3</c:v>
                  </c:pt>
                </c:numCache>
              </c:numRef>
            </c:minus>
          </c:errBars>
          <c:xVal>
            <c:numRef>
              <c:f>Sheet3!$C$12:$C$1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D$12:$D$18</c:f>
              <c:numCache>
                <c:formatCode>General</c:formatCode>
                <c:ptCount val="7"/>
                <c:pt idx="0">
                  <c:v>4.6591054769103725E-2</c:v>
                </c:pt>
                <c:pt idx="1">
                  <c:v>6.3056905819097809E-3</c:v>
                </c:pt>
                <c:pt idx="2">
                  <c:v>7.6528324687169449E-4</c:v>
                </c:pt>
                <c:pt idx="3">
                  <c:v>7.6155774112535689E-4</c:v>
                </c:pt>
                <c:pt idx="4">
                  <c:v>5.3688819288051108E-3</c:v>
                </c:pt>
                <c:pt idx="5">
                  <c:v>1.4951785143643301E-2</c:v>
                </c:pt>
                <c:pt idx="6">
                  <c:v>1.7559328618175041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E$11</c:f>
              <c:strCache>
                <c:ptCount val="1"/>
                <c:pt idx="0">
                  <c:v>Bra009562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M$2:$M$8</c:f>
                <c:numCache>
                  <c:formatCode>General</c:formatCode>
                  <c:ptCount val="7"/>
                  <c:pt idx="0">
                    <c:v>4.0753071992389381E-2</c:v>
                  </c:pt>
                  <c:pt idx="1">
                    <c:v>1.2581826792074989E-3</c:v>
                  </c:pt>
                  <c:pt idx="2">
                    <c:v>1.7708776455416608E-3</c:v>
                  </c:pt>
                  <c:pt idx="3">
                    <c:v>1.4730765739651781E-3</c:v>
                  </c:pt>
                  <c:pt idx="4">
                    <c:v>4.0818748639573154E-4</c:v>
                  </c:pt>
                  <c:pt idx="5">
                    <c:v>2.5561251607844203E-3</c:v>
                  </c:pt>
                  <c:pt idx="6">
                    <c:v>3.4504173965536752E-3</c:v>
                  </c:pt>
                </c:numCache>
              </c:numRef>
            </c:plus>
            <c:minus>
              <c:numRef>
                <c:f>Sheet3!$M$2:$M$8</c:f>
                <c:numCache>
                  <c:formatCode>General</c:formatCode>
                  <c:ptCount val="7"/>
                  <c:pt idx="0">
                    <c:v>4.0753071992389381E-2</c:v>
                  </c:pt>
                  <c:pt idx="1">
                    <c:v>1.2581826792074989E-3</c:v>
                  </c:pt>
                  <c:pt idx="2">
                    <c:v>1.7708776455416608E-3</c:v>
                  </c:pt>
                  <c:pt idx="3">
                    <c:v>1.4730765739651781E-3</c:v>
                  </c:pt>
                  <c:pt idx="4">
                    <c:v>4.0818748639573154E-4</c:v>
                  </c:pt>
                  <c:pt idx="5">
                    <c:v>2.5561251607844203E-3</c:v>
                  </c:pt>
                  <c:pt idx="6">
                    <c:v>3.4504173965536752E-3</c:v>
                  </c:pt>
                </c:numCache>
              </c:numRef>
            </c:minus>
          </c:errBars>
          <c:xVal>
            <c:numRef>
              <c:f>Sheet3!$C$12:$C$1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E$12:$E$18</c:f>
              <c:numCache>
                <c:formatCode>General</c:formatCode>
                <c:ptCount val="7"/>
                <c:pt idx="0">
                  <c:v>0.16066584428573488</c:v>
                </c:pt>
                <c:pt idx="1">
                  <c:v>3.2401831886951969E-2</c:v>
                </c:pt>
                <c:pt idx="2">
                  <c:v>2.2745223812768806E-2</c:v>
                </c:pt>
                <c:pt idx="3">
                  <c:v>1.4518872227616263E-2</c:v>
                </c:pt>
                <c:pt idx="4">
                  <c:v>2.5155974180216811E-2</c:v>
                </c:pt>
                <c:pt idx="5">
                  <c:v>2.7243599015552598E-2</c:v>
                </c:pt>
                <c:pt idx="6">
                  <c:v>5.2790166262217893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044032"/>
        <c:axId val="252045568"/>
      </c:scatterChart>
      <c:valAx>
        <c:axId val="25204403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045568"/>
        <c:crosses val="autoZero"/>
        <c:crossBetween val="midCat"/>
        <c:majorUnit val="4"/>
      </c:valAx>
      <c:valAx>
        <c:axId val="252045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04403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190693350831148"/>
          <c:y val="0.31906058617672822"/>
          <c:w val="0.45027563488316114"/>
          <c:h val="0.2237224823719352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58573928258985"/>
          <c:y val="5.1400554097404488E-2"/>
          <c:w val="0.85896281714785661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F$12</c:f>
              <c:strCache>
                <c:ptCount val="1"/>
                <c:pt idx="0">
                  <c:v>Bra000165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E$2:$E$8</c:f>
                <c:numCache>
                  <c:formatCode>General</c:formatCode>
                  <c:ptCount val="7"/>
                  <c:pt idx="0">
                    <c:v>3.2231124243059075E-6</c:v>
                  </c:pt>
                  <c:pt idx="1">
                    <c:v>9.046275451216572E-6</c:v>
                  </c:pt>
                  <c:pt idx="2">
                    <c:v>2.1594975174839405E-3</c:v>
                  </c:pt>
                  <c:pt idx="3">
                    <c:v>2.5786527648420911E-2</c:v>
                  </c:pt>
                  <c:pt idx="4">
                    <c:v>4.6946670617745785E-4</c:v>
                  </c:pt>
                  <c:pt idx="5">
                    <c:v>1.0596947699702574E-4</c:v>
                  </c:pt>
                  <c:pt idx="6">
                    <c:v>1.3919639832793691E-5</c:v>
                  </c:pt>
                </c:numCache>
              </c:numRef>
            </c:plus>
            <c:minus>
              <c:numRef>
                <c:f>Sheet3!$E$2:$E$8</c:f>
                <c:numCache>
                  <c:formatCode>General</c:formatCode>
                  <c:ptCount val="7"/>
                  <c:pt idx="0">
                    <c:v>3.2231124243059075E-6</c:v>
                  </c:pt>
                  <c:pt idx="1">
                    <c:v>9.046275451216572E-6</c:v>
                  </c:pt>
                  <c:pt idx="2">
                    <c:v>2.1594975174839405E-3</c:v>
                  </c:pt>
                  <c:pt idx="3">
                    <c:v>2.5786527648420911E-2</c:v>
                  </c:pt>
                  <c:pt idx="4">
                    <c:v>4.6946670617745785E-4</c:v>
                  </c:pt>
                  <c:pt idx="5">
                    <c:v>1.0596947699702574E-4</c:v>
                  </c:pt>
                  <c:pt idx="6">
                    <c:v>1.3919639832793691E-5</c:v>
                  </c:pt>
                </c:numCache>
              </c:numRef>
            </c:minus>
          </c:errBars>
          <c:xVal>
            <c:numRef>
              <c:f>Sheet3!$E$13:$E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F$13:$F$19</c:f>
              <c:numCache>
                <c:formatCode>General</c:formatCode>
                <c:ptCount val="7"/>
                <c:pt idx="0">
                  <c:v>6.4226895511651112E-5</c:v>
                </c:pt>
                <c:pt idx="1">
                  <c:v>1.0751824244553046E-4</c:v>
                </c:pt>
                <c:pt idx="2">
                  <c:v>0.13246771762262421</c:v>
                </c:pt>
                <c:pt idx="3">
                  <c:v>0.18061400289253998</c:v>
                </c:pt>
                <c:pt idx="4">
                  <c:v>2.4640669050648788E-2</c:v>
                </c:pt>
                <c:pt idx="5">
                  <c:v>4.0188451389387763E-3</c:v>
                </c:pt>
                <c:pt idx="6">
                  <c:v>1.0111943090178558E-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G$12</c:f>
              <c:strCache>
                <c:ptCount val="1"/>
                <c:pt idx="0">
                  <c:v>Bra004991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K$2:$K$8</c:f>
                <c:numCache>
                  <c:formatCode>General</c:formatCode>
                  <c:ptCount val="7"/>
                  <c:pt idx="0">
                    <c:v>2.1329106997398604E-5</c:v>
                  </c:pt>
                  <c:pt idx="1">
                    <c:v>2.2013514857050023E-5</c:v>
                  </c:pt>
                  <c:pt idx="2">
                    <c:v>5.7600436631410346E-3</c:v>
                  </c:pt>
                  <c:pt idx="3">
                    <c:v>6.0865971156129933E-2</c:v>
                  </c:pt>
                  <c:pt idx="4">
                    <c:v>1.2906796381307629E-2</c:v>
                  </c:pt>
                  <c:pt idx="5">
                    <c:v>4.1487508231630764E-3</c:v>
                  </c:pt>
                  <c:pt idx="6">
                    <c:v>3.3980059344042738E-5</c:v>
                  </c:pt>
                </c:numCache>
              </c:numRef>
            </c:plus>
            <c:minus>
              <c:numRef>
                <c:f>Sheet3!$K$2:$K$8</c:f>
                <c:numCache>
                  <c:formatCode>General</c:formatCode>
                  <c:ptCount val="7"/>
                  <c:pt idx="0">
                    <c:v>2.1329106997398604E-5</c:v>
                  </c:pt>
                  <c:pt idx="1">
                    <c:v>2.2013514857050023E-5</c:v>
                  </c:pt>
                  <c:pt idx="2">
                    <c:v>5.7600436631410346E-3</c:v>
                  </c:pt>
                  <c:pt idx="3">
                    <c:v>6.0865971156129933E-2</c:v>
                  </c:pt>
                  <c:pt idx="4">
                    <c:v>1.2906796381307629E-2</c:v>
                  </c:pt>
                  <c:pt idx="5">
                    <c:v>4.1487508231630764E-3</c:v>
                  </c:pt>
                  <c:pt idx="6">
                    <c:v>3.3980059344042738E-5</c:v>
                  </c:pt>
                </c:numCache>
              </c:numRef>
            </c:minus>
          </c:errBars>
          <c:xVal>
            <c:numRef>
              <c:f>Sheet3!$E$13:$E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G$13:$G$19</c:f>
              <c:numCache>
                <c:formatCode>General</c:formatCode>
                <c:ptCount val="7"/>
                <c:pt idx="0">
                  <c:v>5.7386437665278933E-5</c:v>
                </c:pt>
                <c:pt idx="1">
                  <c:v>4.6745214904708931E-5</c:v>
                </c:pt>
                <c:pt idx="2">
                  <c:v>4.1816900631450639E-2</c:v>
                </c:pt>
                <c:pt idx="3">
                  <c:v>0.2758627808606462</c:v>
                </c:pt>
                <c:pt idx="4">
                  <c:v>9.9234234329708335E-2</c:v>
                </c:pt>
                <c:pt idx="5">
                  <c:v>2.4743603906729989E-2</c:v>
                </c:pt>
                <c:pt idx="6">
                  <c:v>3.3751583686061204E-4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3!$H$12</c:f>
              <c:strCache>
                <c:ptCount val="1"/>
                <c:pt idx="0">
                  <c:v>Bra017035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S$2:$S$8</c:f>
                <c:numCache>
                  <c:formatCode>General</c:formatCode>
                  <c:ptCount val="7"/>
                  <c:pt idx="0">
                    <c:v>3.8519280248828547E-5</c:v>
                  </c:pt>
                  <c:pt idx="1">
                    <c:v>4.8812649802635426E-5</c:v>
                  </c:pt>
                  <c:pt idx="2">
                    <c:v>7.5583391660392091E-3</c:v>
                  </c:pt>
                  <c:pt idx="3">
                    <c:v>6.1615479499523972E-2</c:v>
                  </c:pt>
                  <c:pt idx="4">
                    <c:v>3.4219647337318292E-3</c:v>
                  </c:pt>
                  <c:pt idx="5">
                    <c:v>7.117341170320891E-4</c:v>
                  </c:pt>
                  <c:pt idx="6">
                    <c:v>2.1603844558206281E-5</c:v>
                  </c:pt>
                </c:numCache>
              </c:numRef>
            </c:plus>
            <c:minus>
              <c:numRef>
                <c:f>Sheet3!$S$2:$S$8</c:f>
                <c:numCache>
                  <c:formatCode>General</c:formatCode>
                  <c:ptCount val="7"/>
                  <c:pt idx="0">
                    <c:v>3.8519280248828547E-5</c:v>
                  </c:pt>
                  <c:pt idx="1">
                    <c:v>4.8812649802635426E-5</c:v>
                  </c:pt>
                  <c:pt idx="2">
                    <c:v>7.5583391660392091E-3</c:v>
                  </c:pt>
                  <c:pt idx="3">
                    <c:v>6.1615479499523972E-2</c:v>
                  </c:pt>
                  <c:pt idx="4">
                    <c:v>3.4219647337318292E-3</c:v>
                  </c:pt>
                  <c:pt idx="5">
                    <c:v>7.117341170320891E-4</c:v>
                  </c:pt>
                  <c:pt idx="6">
                    <c:v>2.1603844558206281E-5</c:v>
                  </c:pt>
                </c:numCache>
              </c:numRef>
            </c:minus>
          </c:errBars>
          <c:xVal>
            <c:numRef>
              <c:f>Sheet3!$E$13:$E$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H$13:$H$19</c:f>
              <c:numCache>
                <c:formatCode>General</c:formatCode>
                <c:ptCount val="7"/>
                <c:pt idx="0">
                  <c:v>9.8916903245332112E-5</c:v>
                </c:pt>
                <c:pt idx="1">
                  <c:v>9.2762067566184029E-5</c:v>
                </c:pt>
                <c:pt idx="2">
                  <c:v>0.2406047852548053</c:v>
                </c:pt>
                <c:pt idx="3">
                  <c:v>0.36077706005356031</c:v>
                </c:pt>
                <c:pt idx="4">
                  <c:v>6.0141911941054484E-2</c:v>
                </c:pt>
                <c:pt idx="5">
                  <c:v>9.1152140066920063E-3</c:v>
                </c:pt>
                <c:pt idx="6">
                  <c:v>3.0483451927856684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080896"/>
        <c:axId val="252082432"/>
      </c:scatterChart>
      <c:valAx>
        <c:axId val="25208089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082432"/>
        <c:crosses val="autoZero"/>
        <c:crossBetween val="midCat"/>
        <c:majorUnit val="4"/>
      </c:valAx>
      <c:valAx>
        <c:axId val="252082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0808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6350893671746916"/>
          <c:y val="2.271674305691803E-2"/>
          <c:w val="0.42683767460181216"/>
          <c:h val="0.2511515748031495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98750347705725"/>
          <c:y val="9.928755738169584E-2"/>
          <c:w val="0.84746045343332865"/>
          <c:h val="0.7438372780010567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2!$A$5</c:f>
              <c:strCache>
                <c:ptCount val="1"/>
                <c:pt idx="0">
                  <c:v>Bra020013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5:$K$5</c:f>
              <c:numCache>
                <c:formatCode>General</c:formatCode>
                <c:ptCount val="7"/>
                <c:pt idx="0">
                  <c:v>35.839000000000006</c:v>
                </c:pt>
                <c:pt idx="1">
                  <c:v>23.396999999999988</c:v>
                </c:pt>
                <c:pt idx="2">
                  <c:v>20.264000000000003</c:v>
                </c:pt>
                <c:pt idx="3">
                  <c:v>11.921000000000001</c:v>
                </c:pt>
                <c:pt idx="4">
                  <c:v>18.035499999999974</c:v>
                </c:pt>
                <c:pt idx="5">
                  <c:v>16.447000000000003</c:v>
                </c:pt>
                <c:pt idx="6">
                  <c:v>29.028499999999973</c:v>
                </c:pt>
              </c:numCache>
            </c:numRef>
          </c:yVal>
          <c:smooth val="1"/>
        </c:ser>
        <c:ser>
          <c:idx val="0"/>
          <c:order val="1"/>
          <c:tx>
            <c:strRef>
              <c:f>Sheet2!$A$6</c:f>
              <c:strCache>
                <c:ptCount val="1"/>
                <c:pt idx="0">
                  <c:v>Bra031672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6:$K$6</c:f>
              <c:numCache>
                <c:formatCode>General</c:formatCode>
                <c:ptCount val="7"/>
                <c:pt idx="0">
                  <c:v>3.5409999999999999</c:v>
                </c:pt>
                <c:pt idx="1">
                  <c:v>3.8354999999999966</c:v>
                </c:pt>
                <c:pt idx="2">
                  <c:v>3.528</c:v>
                </c:pt>
                <c:pt idx="3">
                  <c:v>3.2945000000000002</c:v>
                </c:pt>
                <c:pt idx="4">
                  <c:v>3.6005000000000011</c:v>
                </c:pt>
                <c:pt idx="5">
                  <c:v>3.843</c:v>
                </c:pt>
                <c:pt idx="6">
                  <c:v>4.603999999999996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4836992"/>
        <c:axId val="224851072"/>
      </c:scatterChart>
      <c:valAx>
        <c:axId val="22483699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24851072"/>
        <c:crosses val="autoZero"/>
        <c:crossBetween val="midCat"/>
        <c:majorUnit val="4"/>
      </c:valAx>
      <c:valAx>
        <c:axId val="224851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248369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3396191818384463"/>
          <c:y val="0.1109189997083694"/>
          <c:w val="0.46919598741326152"/>
          <c:h val="0.3006866439035190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  <c:userShapes r:id="rId2"/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58573928258985"/>
          <c:y val="5.1400554097404488E-2"/>
          <c:w val="0.85340726159230051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D$15</c:f>
              <c:strCache>
                <c:ptCount val="1"/>
                <c:pt idx="0">
                  <c:v>Bra018204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E$2:$E$8</c:f>
                <c:numCache>
                  <c:formatCode>General</c:formatCode>
                  <c:ptCount val="7"/>
                  <c:pt idx="0">
                    <c:v>1.524342453498875E-4</c:v>
                  </c:pt>
                  <c:pt idx="1">
                    <c:v>3.1297183265640926E-5</c:v>
                  </c:pt>
                  <c:pt idx="2">
                    <c:v>6.1954713558957388E-4</c:v>
                  </c:pt>
                  <c:pt idx="3">
                    <c:v>3.7958082064683219E-3</c:v>
                  </c:pt>
                  <c:pt idx="4">
                    <c:v>4.7717775794649004E-4</c:v>
                  </c:pt>
                  <c:pt idx="5">
                    <c:v>6.4688997045922469E-5</c:v>
                  </c:pt>
                  <c:pt idx="6">
                    <c:v>1.6736678644151865E-5</c:v>
                  </c:pt>
                </c:numCache>
              </c:numRef>
            </c:plus>
            <c:minus>
              <c:numRef>
                <c:f>Sheet3!$E$2:$E$8</c:f>
                <c:numCache>
                  <c:formatCode>General</c:formatCode>
                  <c:ptCount val="7"/>
                  <c:pt idx="0">
                    <c:v>1.524342453498875E-4</c:v>
                  </c:pt>
                  <c:pt idx="1">
                    <c:v>3.1297183265640926E-5</c:v>
                  </c:pt>
                  <c:pt idx="2">
                    <c:v>6.1954713558957388E-4</c:v>
                  </c:pt>
                  <c:pt idx="3">
                    <c:v>3.7958082064683219E-3</c:v>
                  </c:pt>
                  <c:pt idx="4">
                    <c:v>4.7717775794649004E-4</c:v>
                  </c:pt>
                  <c:pt idx="5">
                    <c:v>6.4688997045922469E-5</c:v>
                  </c:pt>
                  <c:pt idx="6">
                    <c:v>1.6736678644151865E-5</c:v>
                  </c:pt>
                </c:numCache>
              </c:numRef>
            </c:minus>
          </c:errBars>
          <c:xVal>
            <c:numRef>
              <c:f>Sheet3!$C$16:$C$2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D$16:$D$22</c:f>
              <c:numCache>
                <c:formatCode>General</c:formatCode>
                <c:ptCount val="7"/>
                <c:pt idx="0">
                  <c:v>5.2286894017830696E-4</c:v>
                </c:pt>
                <c:pt idx="1">
                  <c:v>6.4850160753899928E-5</c:v>
                </c:pt>
                <c:pt idx="2">
                  <c:v>5.2118570280247538E-3</c:v>
                </c:pt>
                <c:pt idx="3">
                  <c:v>3.0594427117017261E-2</c:v>
                </c:pt>
                <c:pt idx="4">
                  <c:v>6.4851848913042003E-3</c:v>
                </c:pt>
                <c:pt idx="5">
                  <c:v>1.0823045466004015E-3</c:v>
                </c:pt>
                <c:pt idx="6">
                  <c:v>2.2745785087207966E-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E$15</c:f>
              <c:strCache>
                <c:ptCount val="1"/>
                <c:pt idx="0">
                  <c:v>Bra033809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L$2:$L$8</c:f>
                <c:numCache>
                  <c:formatCode>General</c:formatCode>
                  <c:ptCount val="7"/>
                  <c:pt idx="0">
                    <c:v>6.1314059011155703E-4</c:v>
                  </c:pt>
                  <c:pt idx="1">
                    <c:v>7.334642700343398E-4</c:v>
                  </c:pt>
                  <c:pt idx="2">
                    <c:v>4.4113695099489095E-3</c:v>
                  </c:pt>
                  <c:pt idx="3">
                    <c:v>1.0039510057275599E-2</c:v>
                  </c:pt>
                  <c:pt idx="4">
                    <c:v>8.3907729941332544E-4</c:v>
                  </c:pt>
                  <c:pt idx="5">
                    <c:v>1.1550638378105848E-3</c:v>
                  </c:pt>
                  <c:pt idx="6">
                    <c:v>2.3227837110074485E-4</c:v>
                  </c:pt>
                </c:numCache>
              </c:numRef>
            </c:plus>
            <c:minus>
              <c:numRef>
                <c:f>Sheet3!$L$2:$L$8</c:f>
                <c:numCache>
                  <c:formatCode>General</c:formatCode>
                  <c:ptCount val="7"/>
                  <c:pt idx="0">
                    <c:v>6.1314059011155703E-4</c:v>
                  </c:pt>
                  <c:pt idx="1">
                    <c:v>7.334642700343398E-4</c:v>
                  </c:pt>
                  <c:pt idx="2">
                    <c:v>4.4113695099489095E-3</c:v>
                  </c:pt>
                  <c:pt idx="3">
                    <c:v>1.0039510057275599E-2</c:v>
                  </c:pt>
                  <c:pt idx="4">
                    <c:v>8.3907729941332544E-4</c:v>
                  </c:pt>
                  <c:pt idx="5">
                    <c:v>1.1550638378105848E-3</c:v>
                  </c:pt>
                  <c:pt idx="6">
                    <c:v>2.3227837110074485E-4</c:v>
                  </c:pt>
                </c:numCache>
              </c:numRef>
            </c:minus>
          </c:errBars>
          <c:xVal>
            <c:numRef>
              <c:f>Sheet3!$C$16:$C$2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E$16:$E$22</c:f>
              <c:numCache>
                <c:formatCode>General</c:formatCode>
                <c:ptCount val="7"/>
                <c:pt idx="0">
                  <c:v>2.7650769204011537E-3</c:v>
                </c:pt>
                <c:pt idx="1">
                  <c:v>2.4397188265653184E-3</c:v>
                </c:pt>
                <c:pt idx="2">
                  <c:v>0.10242340257052844</c:v>
                </c:pt>
                <c:pt idx="3">
                  <c:v>9.095823141235905E-2</c:v>
                </c:pt>
                <c:pt idx="4">
                  <c:v>2.9587703251247582E-2</c:v>
                </c:pt>
                <c:pt idx="5">
                  <c:v>1.0549813698706386E-2</c:v>
                </c:pt>
                <c:pt idx="6">
                  <c:v>4.7649229935091504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099968"/>
        <c:axId val="252142720"/>
      </c:scatterChart>
      <c:valAx>
        <c:axId val="252099968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142720"/>
        <c:crosses val="autoZero"/>
        <c:crossBetween val="midCat"/>
        <c:majorUnit val="4"/>
      </c:valAx>
      <c:valAx>
        <c:axId val="2521427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09996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5702290388787212"/>
          <c:y val="4.4099719596373384E-2"/>
          <c:w val="0.43056941041638624"/>
          <c:h val="0.1674343832021000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168630386097462"/>
          <c:y val="5.1400554097404488E-2"/>
          <c:w val="0.71274083581356507"/>
          <c:h val="0.8432029482104325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5!$E$14</c:f>
              <c:strCache>
                <c:ptCount val="1"/>
                <c:pt idx="0">
                  <c:v>Bra038830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5!$E$2:$E$8</c:f>
                <c:numCache>
                  <c:formatCode>General</c:formatCode>
                  <c:ptCount val="7"/>
                  <c:pt idx="0">
                    <c:v>5.6702844677772111E-5</c:v>
                  </c:pt>
                  <c:pt idx="1">
                    <c:v>1.9292812941857851E-5</c:v>
                  </c:pt>
                  <c:pt idx="2">
                    <c:v>2.6652336000807301E-5</c:v>
                  </c:pt>
                  <c:pt idx="3">
                    <c:v>8.2922974142321025E-5</c:v>
                  </c:pt>
                  <c:pt idx="4">
                    <c:v>5.4369447707669942E-6</c:v>
                  </c:pt>
                  <c:pt idx="5">
                    <c:v>9.2255623737555204E-6</c:v>
                  </c:pt>
                  <c:pt idx="6">
                    <c:v>2.7512229286357465E-5</c:v>
                  </c:pt>
                </c:numCache>
              </c:numRef>
            </c:plus>
            <c:minus>
              <c:numRef>
                <c:f>Sheet5!$E$2:$E$8</c:f>
                <c:numCache>
                  <c:formatCode>General</c:formatCode>
                  <c:ptCount val="7"/>
                  <c:pt idx="0">
                    <c:v>5.6702844677772111E-5</c:v>
                  </c:pt>
                  <c:pt idx="1">
                    <c:v>1.9292812941857851E-5</c:v>
                  </c:pt>
                  <c:pt idx="2">
                    <c:v>2.6652336000807301E-5</c:v>
                  </c:pt>
                  <c:pt idx="3">
                    <c:v>8.2922974142321025E-5</c:v>
                  </c:pt>
                  <c:pt idx="4">
                    <c:v>5.4369447707669942E-6</c:v>
                  </c:pt>
                  <c:pt idx="5">
                    <c:v>9.2255623737555204E-6</c:v>
                  </c:pt>
                  <c:pt idx="6">
                    <c:v>2.7512229286357465E-5</c:v>
                  </c:pt>
                </c:numCache>
              </c:numRef>
            </c:minus>
          </c:errBars>
          <c:xVal>
            <c:numRef>
              <c:f>Sheet5!$D$15:$D$21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5!$E$15:$E$21</c:f>
              <c:numCache>
                <c:formatCode>General</c:formatCode>
                <c:ptCount val="7"/>
                <c:pt idx="0">
                  <c:v>3.2567726815715292E-4</c:v>
                </c:pt>
                <c:pt idx="1">
                  <c:v>3.3767605496365507E-4</c:v>
                </c:pt>
                <c:pt idx="2">
                  <c:v>6.665480028369685E-4</c:v>
                </c:pt>
                <c:pt idx="3">
                  <c:v>4.8355592614159488E-4</c:v>
                </c:pt>
                <c:pt idx="4">
                  <c:v>4.2026093756854504E-4</c:v>
                </c:pt>
                <c:pt idx="5">
                  <c:v>3.8955965398703086E-4</c:v>
                </c:pt>
                <c:pt idx="6">
                  <c:v>4.6246745671987361E-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5!$F$14</c:f>
              <c:strCache>
                <c:ptCount val="1"/>
                <c:pt idx="0">
                  <c:v>Bra038831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5!$L$2:$L$8</c:f>
                <c:numCache>
                  <c:formatCode>General</c:formatCode>
                  <c:ptCount val="7"/>
                  <c:pt idx="0">
                    <c:v>5.7636556066948449E-4</c:v>
                  </c:pt>
                  <c:pt idx="1">
                    <c:v>1.7088264831893855E-3</c:v>
                  </c:pt>
                  <c:pt idx="2">
                    <c:v>1.5520178082443785E-3</c:v>
                  </c:pt>
                  <c:pt idx="3">
                    <c:v>2.2521475964832741E-3</c:v>
                  </c:pt>
                  <c:pt idx="4">
                    <c:v>3.7670831120710703E-4</c:v>
                  </c:pt>
                  <c:pt idx="5">
                    <c:v>6.8862195565417032E-4</c:v>
                  </c:pt>
                  <c:pt idx="6">
                    <c:v>2.0471965662432192E-3</c:v>
                  </c:pt>
                </c:numCache>
              </c:numRef>
            </c:plus>
            <c:minus>
              <c:numRef>
                <c:f>Sheet5!$L$2:$L$8</c:f>
                <c:numCache>
                  <c:formatCode>General</c:formatCode>
                  <c:ptCount val="7"/>
                  <c:pt idx="0">
                    <c:v>5.7636556066948449E-4</c:v>
                  </c:pt>
                  <c:pt idx="1">
                    <c:v>1.7088264831893855E-3</c:v>
                  </c:pt>
                  <c:pt idx="2">
                    <c:v>1.5520178082443785E-3</c:v>
                  </c:pt>
                  <c:pt idx="3">
                    <c:v>2.2521475964832741E-3</c:v>
                  </c:pt>
                  <c:pt idx="4">
                    <c:v>3.7670831120710703E-4</c:v>
                  </c:pt>
                  <c:pt idx="5">
                    <c:v>6.8862195565417032E-4</c:v>
                  </c:pt>
                  <c:pt idx="6">
                    <c:v>2.0471965662432192E-3</c:v>
                  </c:pt>
                </c:numCache>
              </c:numRef>
            </c:minus>
          </c:errBars>
          <c:xVal>
            <c:numRef>
              <c:f>Sheet5!$D$15:$D$21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5!$F$15:$F$21</c:f>
              <c:numCache>
                <c:formatCode>General</c:formatCode>
                <c:ptCount val="7"/>
                <c:pt idx="0">
                  <c:v>9.9683859709800236E-3</c:v>
                </c:pt>
                <c:pt idx="1">
                  <c:v>6.318818741809909E-3</c:v>
                </c:pt>
                <c:pt idx="2">
                  <c:v>8.6400731580533238E-3</c:v>
                </c:pt>
                <c:pt idx="3">
                  <c:v>1.7418295073666688E-2</c:v>
                </c:pt>
                <c:pt idx="4">
                  <c:v>9.5885518811691228E-3</c:v>
                </c:pt>
                <c:pt idx="5">
                  <c:v>7.5907328884223428E-3</c:v>
                </c:pt>
                <c:pt idx="6">
                  <c:v>1.8329883105085321E-2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5!$G$14</c:f>
              <c:strCache>
                <c:ptCount val="1"/>
                <c:pt idx="0">
                  <c:v>Bra038832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5!$T$2:$T$8</c:f>
                <c:numCache>
                  <c:formatCode>General</c:formatCode>
                  <c:ptCount val="7"/>
                  <c:pt idx="0">
                    <c:v>1.3932891677345007E-8</c:v>
                  </c:pt>
                  <c:pt idx="1">
                    <c:v>2.157797457263943E-7</c:v>
                  </c:pt>
                  <c:pt idx="2">
                    <c:v>4.1603232017611722E-4</c:v>
                  </c:pt>
                  <c:pt idx="3">
                    <c:v>1.0802544526559681E-4</c:v>
                  </c:pt>
                  <c:pt idx="4">
                    <c:v>6.5434051161982619E-6</c:v>
                  </c:pt>
                  <c:pt idx="5">
                    <c:v>2.5691218576240591E-7</c:v>
                  </c:pt>
                  <c:pt idx="6">
                    <c:v>6.2208037867956566E-8</c:v>
                  </c:pt>
                </c:numCache>
              </c:numRef>
            </c:plus>
            <c:minus>
              <c:numRef>
                <c:f>Sheet5!$T$2:$T$8</c:f>
                <c:numCache>
                  <c:formatCode>General</c:formatCode>
                  <c:ptCount val="7"/>
                  <c:pt idx="0">
                    <c:v>1.3932891677345007E-8</c:v>
                  </c:pt>
                  <c:pt idx="1">
                    <c:v>2.157797457263943E-7</c:v>
                  </c:pt>
                  <c:pt idx="2">
                    <c:v>4.1603232017611722E-4</c:v>
                  </c:pt>
                  <c:pt idx="3">
                    <c:v>1.0802544526559681E-4</c:v>
                  </c:pt>
                  <c:pt idx="4">
                    <c:v>6.5434051161982619E-6</c:v>
                  </c:pt>
                  <c:pt idx="5">
                    <c:v>2.5691218576240591E-7</c:v>
                  </c:pt>
                  <c:pt idx="6">
                    <c:v>6.2208037867956566E-8</c:v>
                  </c:pt>
                </c:numCache>
              </c:numRef>
            </c:minus>
          </c:errBars>
          <c:xVal>
            <c:numRef>
              <c:f>Sheet5!$D$15:$D$21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5!$G$15:$G$21</c:f>
              <c:numCache>
                <c:formatCode>General</c:formatCode>
                <c:ptCount val="7"/>
                <c:pt idx="0">
                  <c:v>2.2050082802263989E-8</c:v>
                </c:pt>
                <c:pt idx="1">
                  <c:v>3.1886591383667156E-7</c:v>
                </c:pt>
                <c:pt idx="2">
                  <c:v>1.9229547602406208E-3</c:v>
                </c:pt>
                <c:pt idx="3">
                  <c:v>4.439528680621699E-4</c:v>
                </c:pt>
                <c:pt idx="4">
                  <c:v>5.8700940911173916E-5</c:v>
                </c:pt>
                <c:pt idx="5">
                  <c:v>1.3306048652734368E-6</c:v>
                </c:pt>
                <c:pt idx="6">
                  <c:v>2.6890360749186498E-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169600"/>
        <c:axId val="252183680"/>
      </c:scatterChart>
      <c:valAx>
        <c:axId val="252169600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183680"/>
        <c:crosses val="autoZero"/>
        <c:crossBetween val="midCat"/>
        <c:majorUnit val="4"/>
      </c:valAx>
      <c:valAx>
        <c:axId val="252183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16960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7246327287989353"/>
          <c:y val="1.0796607394500031E-2"/>
          <c:w val="0.34748790538425095"/>
          <c:h val="0.2211318625415888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502187226596681E-2"/>
          <c:y val="5.1400554097404488E-2"/>
          <c:w val="0.87582414698162769"/>
          <c:h val="0.8939197133410734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D$13</c:f>
              <c:strCache>
                <c:ptCount val="1"/>
                <c:pt idx="0">
                  <c:v>Bra030496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4!$E$2:$E$8</c:f>
                <c:numCache>
                  <c:formatCode>General</c:formatCode>
                  <c:ptCount val="7"/>
                  <c:pt idx="0">
                    <c:v>2.0446421035136692E-2</c:v>
                  </c:pt>
                  <c:pt idx="1">
                    <c:v>4.0052868990132182E-4</c:v>
                  </c:pt>
                  <c:pt idx="2">
                    <c:v>6.0118837090308389E-6</c:v>
                  </c:pt>
                  <c:pt idx="3">
                    <c:v>8.0677058711985281E-7</c:v>
                  </c:pt>
                  <c:pt idx="4">
                    <c:v>1.4870659752350889E-5</c:v>
                  </c:pt>
                  <c:pt idx="5">
                    <c:v>4.1085655799019699E-4</c:v>
                  </c:pt>
                  <c:pt idx="6">
                    <c:v>4.0942227163681399E-3</c:v>
                  </c:pt>
                </c:numCache>
              </c:numRef>
            </c:plus>
            <c:minus>
              <c:numRef>
                <c:f>Sheet4!$E$2:$E$8</c:f>
                <c:numCache>
                  <c:formatCode>General</c:formatCode>
                  <c:ptCount val="7"/>
                  <c:pt idx="0">
                    <c:v>2.0446421035136692E-2</c:v>
                  </c:pt>
                  <c:pt idx="1">
                    <c:v>4.0052868990132182E-4</c:v>
                  </c:pt>
                  <c:pt idx="2">
                    <c:v>6.0118837090308389E-6</c:v>
                  </c:pt>
                  <c:pt idx="3">
                    <c:v>8.0677058711985281E-7</c:v>
                  </c:pt>
                  <c:pt idx="4">
                    <c:v>1.4870659752350889E-5</c:v>
                  </c:pt>
                  <c:pt idx="5">
                    <c:v>4.1085655799019699E-4</c:v>
                  </c:pt>
                  <c:pt idx="6">
                    <c:v>4.0942227163681399E-3</c:v>
                  </c:pt>
                </c:numCache>
              </c:numRef>
            </c:minus>
          </c:errBars>
          <c:xVal>
            <c:numRef>
              <c:f>Sheet4!$C$14:$C$20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4!$D$14:$D$20</c:f>
              <c:numCache>
                <c:formatCode>General</c:formatCode>
                <c:ptCount val="7"/>
                <c:pt idx="0">
                  <c:v>4.6413996500459881E-2</c:v>
                </c:pt>
                <c:pt idx="1">
                  <c:v>6.6400052054479894E-3</c:v>
                </c:pt>
                <c:pt idx="2">
                  <c:v>4.8370207506756501E-5</c:v>
                </c:pt>
                <c:pt idx="3">
                  <c:v>6.539380692353972E-6</c:v>
                </c:pt>
                <c:pt idx="4">
                  <c:v>4.2900771049849165E-5</c:v>
                </c:pt>
                <c:pt idx="5">
                  <c:v>3.8983743780924779E-3</c:v>
                </c:pt>
                <c:pt idx="6">
                  <c:v>1.634867071086488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4!$E$13</c:f>
              <c:strCache>
                <c:ptCount val="1"/>
                <c:pt idx="0">
                  <c:v>Bra033291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4!$L$2:$L$8</c:f>
                <c:numCache>
                  <c:formatCode>General</c:formatCode>
                  <c:ptCount val="7"/>
                  <c:pt idx="0">
                    <c:v>0.35875578237838912</c:v>
                  </c:pt>
                  <c:pt idx="1">
                    <c:v>5.1155520965259927E-3</c:v>
                  </c:pt>
                  <c:pt idx="2">
                    <c:v>1.2108906823440046E-5</c:v>
                  </c:pt>
                  <c:pt idx="3">
                    <c:v>1.9445460704419397E-6</c:v>
                  </c:pt>
                  <c:pt idx="4">
                    <c:v>1.7307907741101441E-3</c:v>
                  </c:pt>
                  <c:pt idx="5">
                    <c:v>1.6182327674911481E-2</c:v>
                  </c:pt>
                  <c:pt idx="6">
                    <c:v>1.494559895634252E-2</c:v>
                  </c:pt>
                </c:numCache>
              </c:numRef>
            </c:plus>
            <c:minus>
              <c:numRef>
                <c:f>Sheet4!$L$2:$L$8</c:f>
                <c:numCache>
                  <c:formatCode>General</c:formatCode>
                  <c:ptCount val="7"/>
                  <c:pt idx="0">
                    <c:v>0.35875578237838912</c:v>
                  </c:pt>
                  <c:pt idx="1">
                    <c:v>5.1155520965259927E-3</c:v>
                  </c:pt>
                  <c:pt idx="2">
                    <c:v>1.2108906823440046E-5</c:v>
                  </c:pt>
                  <c:pt idx="3">
                    <c:v>1.9445460704419397E-6</c:v>
                  </c:pt>
                  <c:pt idx="4">
                    <c:v>1.7307907741101441E-3</c:v>
                  </c:pt>
                  <c:pt idx="5">
                    <c:v>1.6182327674911481E-2</c:v>
                  </c:pt>
                  <c:pt idx="6">
                    <c:v>1.494559895634252E-2</c:v>
                  </c:pt>
                </c:numCache>
              </c:numRef>
            </c:minus>
          </c:errBars>
          <c:xVal>
            <c:numRef>
              <c:f>Sheet4!$C$14:$C$20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4!$E$14:$E$20</c:f>
              <c:numCache>
                <c:formatCode>General</c:formatCode>
                <c:ptCount val="7"/>
                <c:pt idx="0">
                  <c:v>0.99568006706099854</c:v>
                </c:pt>
                <c:pt idx="1">
                  <c:v>1.7289998653721311E-2</c:v>
                </c:pt>
                <c:pt idx="2">
                  <c:v>7.4246213718731508E-5</c:v>
                </c:pt>
                <c:pt idx="3">
                  <c:v>3.0501425712426988E-5</c:v>
                </c:pt>
                <c:pt idx="4">
                  <c:v>2.3673258251638886E-3</c:v>
                </c:pt>
                <c:pt idx="5">
                  <c:v>5.9982885122388412E-2</c:v>
                </c:pt>
                <c:pt idx="6">
                  <c:v>0.1584641742221566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201216"/>
        <c:axId val="252219392"/>
      </c:scatterChart>
      <c:valAx>
        <c:axId val="25220121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219392"/>
        <c:crosses val="autoZero"/>
        <c:crossBetween val="midCat"/>
        <c:majorUnit val="4"/>
      </c:valAx>
      <c:valAx>
        <c:axId val="252219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2012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5795822397200397"/>
          <c:y val="0.31443095654709835"/>
          <c:w val="0.39343903308989092"/>
          <c:h val="0.1674343832021000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CCA1 ; </a:t>
            </a:r>
            <a:r>
              <a:rPr lang="en-US" dirty="0"/>
              <a:t>At2g46830</a:t>
            </a:r>
          </a:p>
        </c:rich>
      </c:tx>
      <c:layout>
        <c:manualLayout>
          <c:xMode val="edge"/>
          <c:yMode val="edge"/>
          <c:x val="0.24905956629818907"/>
          <c:y val="0.1007824527433459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51216531496499"/>
          <c:y val="6.6017390009168786E-2"/>
          <c:w val="0.80520379101396078"/>
          <c:h val="0.7691353891081699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8:$B$18</c:f>
              <c:strCache>
                <c:ptCount val="1"/>
                <c:pt idx="0">
                  <c:v>CCA1 At2g46830</c:v>
                </c:pt>
              </c:strCache>
            </c:strRef>
          </c:tx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8:$V$18</c:f>
                <c:numCache>
                  <c:formatCode>General</c:formatCode>
                  <c:ptCount val="6"/>
                  <c:pt idx="0">
                    <c:v>9.4097392603434776E-2</c:v>
                  </c:pt>
                  <c:pt idx="1">
                    <c:v>8.6545557235674947E-2</c:v>
                  </c:pt>
                  <c:pt idx="2">
                    <c:v>0.51352080291595059</c:v>
                  </c:pt>
                  <c:pt idx="3">
                    <c:v>0.95553646053742458</c:v>
                  </c:pt>
                  <c:pt idx="4">
                    <c:v>1.1185783231250581</c:v>
                  </c:pt>
                  <c:pt idx="5">
                    <c:v>0.50766714797161039</c:v>
                  </c:pt>
                </c:numCache>
              </c:numRef>
            </c:plus>
            <c:minus>
              <c:numRef>
                <c:f>Sheet4!$Q$18:$V$18</c:f>
                <c:numCache>
                  <c:formatCode>General</c:formatCode>
                  <c:ptCount val="6"/>
                  <c:pt idx="0">
                    <c:v>9.4097392603434776E-2</c:v>
                  </c:pt>
                  <c:pt idx="1">
                    <c:v>8.6545557235674947E-2</c:v>
                  </c:pt>
                  <c:pt idx="2">
                    <c:v>0.51352080291595059</c:v>
                  </c:pt>
                  <c:pt idx="3">
                    <c:v>0.95553646053742458</c:v>
                  </c:pt>
                  <c:pt idx="4">
                    <c:v>1.1185783231250581</c:v>
                  </c:pt>
                  <c:pt idx="5">
                    <c:v>0.50766714797161039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8:$H$18</c:f>
              <c:numCache>
                <c:formatCode>General</c:formatCode>
                <c:ptCount val="6"/>
                <c:pt idx="0">
                  <c:v>12.127029090000001</c:v>
                </c:pt>
                <c:pt idx="1">
                  <c:v>9.9733457560000005</c:v>
                </c:pt>
                <c:pt idx="2">
                  <c:v>3.6015848196666682</c:v>
                </c:pt>
                <c:pt idx="3">
                  <c:v>3.1772683509999999</c:v>
                </c:pt>
                <c:pt idx="4">
                  <c:v>3.6495913786666718</c:v>
                </c:pt>
                <c:pt idx="5">
                  <c:v>9.600430169000002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248064"/>
        <c:axId val="252249600"/>
      </c:scatterChart>
      <c:valAx>
        <c:axId val="25224806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249600"/>
        <c:crosses val="autoZero"/>
        <c:crossBetween val="midCat"/>
        <c:majorUnit val="4"/>
      </c:valAx>
      <c:valAx>
        <c:axId val="252249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24806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PRR1 </a:t>
            </a:r>
            <a:r>
              <a:rPr lang="en-US" dirty="0" smtClean="0"/>
              <a:t>; At5g61380</a:t>
            </a:r>
            <a:endParaRPr lang="en-US" dirty="0"/>
          </a:p>
        </c:rich>
      </c:tx>
      <c:layout>
        <c:manualLayout>
          <c:xMode val="edge"/>
          <c:yMode val="edge"/>
          <c:x val="0.30145131443728485"/>
          <c:y val="9.884432865212797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51216531496499"/>
          <c:y val="6.6017390009168786E-2"/>
          <c:w val="0.80520379101396078"/>
          <c:h val="0.7788260095642608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9:$B$19</c:f>
              <c:strCache>
                <c:ptCount val="1"/>
                <c:pt idx="0">
                  <c:v>PRR1 At5g61380</c:v>
                </c:pt>
              </c:strCache>
            </c:strRef>
          </c:tx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9:$V$19</c:f>
                <c:numCache>
                  <c:formatCode>General</c:formatCode>
                  <c:ptCount val="6"/>
                  <c:pt idx="0">
                    <c:v>4.1469680140887012E-2</c:v>
                  </c:pt>
                  <c:pt idx="1">
                    <c:v>0.16046092459708239</c:v>
                  </c:pt>
                  <c:pt idx="2">
                    <c:v>0.10049750351144296</c:v>
                  </c:pt>
                  <c:pt idx="3">
                    <c:v>4.9497850853113562E-2</c:v>
                  </c:pt>
                  <c:pt idx="4">
                    <c:v>8.204622603061805E-2</c:v>
                  </c:pt>
                  <c:pt idx="5">
                    <c:v>7.7658088488987229E-3</c:v>
                  </c:pt>
                </c:numCache>
              </c:numRef>
            </c:plus>
            <c:minus>
              <c:numRef>
                <c:f>Sheet4!$Q$19:$V$19</c:f>
                <c:numCache>
                  <c:formatCode>General</c:formatCode>
                  <c:ptCount val="6"/>
                  <c:pt idx="0">
                    <c:v>4.1469680140887012E-2</c:v>
                  </c:pt>
                  <c:pt idx="1">
                    <c:v>0.16046092459708239</c:v>
                  </c:pt>
                  <c:pt idx="2">
                    <c:v>0.10049750351144296</c:v>
                  </c:pt>
                  <c:pt idx="3">
                    <c:v>4.9497850853113562E-2</c:v>
                  </c:pt>
                  <c:pt idx="4">
                    <c:v>8.204622603061805E-2</c:v>
                  </c:pt>
                  <c:pt idx="5">
                    <c:v>7.7658088488987229E-3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9:$H$19</c:f>
              <c:numCache>
                <c:formatCode>General</c:formatCode>
                <c:ptCount val="6"/>
                <c:pt idx="0">
                  <c:v>7.6435131753333332</c:v>
                </c:pt>
                <c:pt idx="1">
                  <c:v>7.6872083213333333</c:v>
                </c:pt>
                <c:pt idx="2">
                  <c:v>10.197728236666666</c:v>
                </c:pt>
                <c:pt idx="3">
                  <c:v>10.341556253333344</c:v>
                </c:pt>
                <c:pt idx="4">
                  <c:v>9.1570274449999989</c:v>
                </c:pt>
                <c:pt idx="5">
                  <c:v>9.256886103333332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274176"/>
        <c:axId val="252275712"/>
      </c:scatterChart>
      <c:valAx>
        <c:axId val="25227417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275712"/>
        <c:crosses val="autoZero"/>
        <c:crossBetween val="midCat"/>
        <c:majorUnit val="4"/>
      </c:valAx>
      <c:valAx>
        <c:axId val="2522757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27417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57579626870967"/>
          <c:y val="5.1400554097404488E-2"/>
          <c:w val="0.81025537348372145"/>
          <c:h val="0.890108749107700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34</c:f>
              <c:strCache>
                <c:ptCount val="1"/>
                <c:pt idx="0">
                  <c:v>Bra004503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4:$K$34</c:f>
              <c:numCache>
                <c:formatCode>General</c:formatCode>
                <c:ptCount val="7"/>
                <c:pt idx="0">
                  <c:v>329.09799999999962</c:v>
                </c:pt>
                <c:pt idx="1">
                  <c:v>152.12200000000001</c:v>
                </c:pt>
                <c:pt idx="2">
                  <c:v>14.060000000000002</c:v>
                </c:pt>
                <c:pt idx="3">
                  <c:v>1.212</c:v>
                </c:pt>
                <c:pt idx="4">
                  <c:v>0.99199999999999999</c:v>
                </c:pt>
                <c:pt idx="5">
                  <c:v>34.367000000000004</c:v>
                </c:pt>
                <c:pt idx="6">
                  <c:v>292.4679999999996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291712"/>
        <c:axId val="252301696"/>
      </c:scatterChart>
      <c:valAx>
        <c:axId val="25229171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301696"/>
        <c:crosses val="autoZero"/>
        <c:crossBetween val="midCat"/>
        <c:majorUnit val="4"/>
      </c:valAx>
      <c:valAx>
        <c:axId val="252301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29171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1409909909909931"/>
          <c:y val="0.19888196267133276"/>
          <c:w val="0.33394161878413847"/>
          <c:h val="8.3717191601050026E-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1199538638984992E-2"/>
          <c:y val="5.1400554097404488E-2"/>
          <c:w val="0.77531090474483366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35</c:f>
              <c:strCache>
                <c:ptCount val="1"/>
                <c:pt idx="0">
                  <c:v>Bra012964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5:$K$35</c:f>
              <c:numCache>
                <c:formatCode>General</c:formatCode>
                <c:ptCount val="7"/>
                <c:pt idx="0">
                  <c:v>0.60500000000000065</c:v>
                </c:pt>
                <c:pt idx="1">
                  <c:v>1.252</c:v>
                </c:pt>
                <c:pt idx="2">
                  <c:v>91.845000000000013</c:v>
                </c:pt>
                <c:pt idx="3">
                  <c:v>71.452000000000012</c:v>
                </c:pt>
                <c:pt idx="4">
                  <c:v>15.373500000000011</c:v>
                </c:pt>
                <c:pt idx="5">
                  <c:v>4.2614999999999998</c:v>
                </c:pt>
                <c:pt idx="6">
                  <c:v>0.3810000000000003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36</c:f>
              <c:strCache>
                <c:ptCount val="1"/>
                <c:pt idx="0">
                  <c:v>Bra035933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6:$K$36</c:f>
              <c:numCache>
                <c:formatCode>General</c:formatCode>
                <c:ptCount val="7"/>
                <c:pt idx="0">
                  <c:v>0.74600000000000066</c:v>
                </c:pt>
                <c:pt idx="1">
                  <c:v>4.5459999999999985</c:v>
                </c:pt>
                <c:pt idx="2">
                  <c:v>83.793499999999995</c:v>
                </c:pt>
                <c:pt idx="3">
                  <c:v>147.37700000000001</c:v>
                </c:pt>
                <c:pt idx="4">
                  <c:v>9.084500000000002</c:v>
                </c:pt>
                <c:pt idx="5">
                  <c:v>3.0364999999999975</c:v>
                </c:pt>
                <c:pt idx="6">
                  <c:v>0.7230000000000006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388096"/>
        <c:axId val="252389632"/>
      </c:scatterChart>
      <c:valAx>
        <c:axId val="25238809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389632"/>
        <c:crosses val="autoZero"/>
        <c:crossBetween val="midCat"/>
        <c:majorUnit val="4"/>
      </c:valAx>
      <c:valAx>
        <c:axId val="252389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3880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1651683604456364"/>
          <c:y val="9.963604349964332E-2"/>
          <c:w val="0.37294023459020031"/>
          <c:h val="0.2270122181487242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58573928258985"/>
          <c:y val="7.8325093508128732E-2"/>
          <c:w val="0.8561850393700795"/>
          <c:h val="0.8674560851263436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C$1</c:f>
              <c:strCache>
                <c:ptCount val="1"/>
                <c:pt idx="0">
                  <c:v>Bra004503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E$2:$E$8</c:f>
                <c:numCache>
                  <c:formatCode>General</c:formatCode>
                  <c:ptCount val="7"/>
                  <c:pt idx="0">
                    <c:v>2.4667387174631645E-2</c:v>
                  </c:pt>
                  <c:pt idx="1">
                    <c:v>1.5313439600796921E-3</c:v>
                  </c:pt>
                  <c:pt idx="2">
                    <c:v>8.2778394292308465E-5</c:v>
                  </c:pt>
                  <c:pt idx="3">
                    <c:v>8.9680931969410918E-6</c:v>
                  </c:pt>
                  <c:pt idx="4">
                    <c:v>6.8272723883349448E-5</c:v>
                  </c:pt>
                  <c:pt idx="5">
                    <c:v>1.3761547205620827E-3</c:v>
                  </c:pt>
                  <c:pt idx="6">
                    <c:v>1.882215902661453E-3</c:v>
                  </c:pt>
                </c:numCache>
              </c:numRef>
            </c:plus>
            <c:minus>
              <c:numRef>
                <c:f>Sheet2!$E$2:$E$8</c:f>
                <c:numCache>
                  <c:formatCode>General</c:formatCode>
                  <c:ptCount val="7"/>
                  <c:pt idx="0">
                    <c:v>2.4667387174631645E-2</c:v>
                  </c:pt>
                  <c:pt idx="1">
                    <c:v>1.5313439600796921E-3</c:v>
                  </c:pt>
                  <c:pt idx="2">
                    <c:v>8.2778394292308465E-5</c:v>
                  </c:pt>
                  <c:pt idx="3">
                    <c:v>8.9680931969410918E-6</c:v>
                  </c:pt>
                  <c:pt idx="4">
                    <c:v>6.8272723883349448E-5</c:v>
                  </c:pt>
                  <c:pt idx="5">
                    <c:v>1.3761547205620827E-3</c:v>
                  </c:pt>
                  <c:pt idx="6">
                    <c:v>1.882215902661453E-3</c:v>
                  </c:pt>
                </c:numCache>
              </c:numRef>
            </c:minus>
          </c:errBars>
          <c:xVal>
            <c:numRef>
              <c:f>Sheet2!$B$2:$B$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C$2:$C$8</c:f>
              <c:numCache>
                <c:formatCode>General</c:formatCode>
                <c:ptCount val="7"/>
                <c:pt idx="0">
                  <c:v>0.10150855130707544</c:v>
                </c:pt>
                <c:pt idx="1">
                  <c:v>3.8357307636163608E-2</c:v>
                </c:pt>
                <c:pt idx="2">
                  <c:v>6.4009230916729819E-4</c:v>
                </c:pt>
                <c:pt idx="3">
                  <c:v>6.3999244801949174E-5</c:v>
                </c:pt>
                <c:pt idx="4">
                  <c:v>2.3135737863530609E-4</c:v>
                </c:pt>
                <c:pt idx="5">
                  <c:v>6.7643383030191288E-3</c:v>
                </c:pt>
                <c:pt idx="6">
                  <c:v>4.0847533807352003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422400"/>
        <c:axId val="252428288"/>
      </c:scatterChart>
      <c:valAx>
        <c:axId val="252422400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428288"/>
        <c:crosses val="autoZero"/>
        <c:crossBetween val="midCat"/>
        <c:majorUnit val="4"/>
      </c:valAx>
      <c:valAx>
        <c:axId val="2524282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42240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2948005777135895"/>
          <c:y val="0.24397952696613959"/>
          <c:w val="0.4505719495922198"/>
          <c:h val="0.1895388166746905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835575543152707"/>
          <c:y val="6.2625438960888402E-2"/>
          <c:w val="0.77701103084766066"/>
          <c:h val="0.8843344097032697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F$3</c:f>
              <c:strCache>
                <c:ptCount val="1"/>
                <c:pt idx="0">
                  <c:v>Bra012964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4!$J$5:$J$10</c:f>
                <c:numCache>
                  <c:formatCode>General</c:formatCode>
                  <c:ptCount val="6"/>
                  <c:pt idx="0">
                    <c:v>1.4546972567517467E-4</c:v>
                  </c:pt>
                  <c:pt idx="1">
                    <c:v>2.7357252692447956E-4</c:v>
                  </c:pt>
                  <c:pt idx="2">
                    <c:v>3.7679865666958592E-2</c:v>
                  </c:pt>
                  <c:pt idx="3">
                    <c:v>2.4681688324384849E-2</c:v>
                  </c:pt>
                  <c:pt idx="4">
                    <c:v>3.2291921786367335E-3</c:v>
                  </c:pt>
                  <c:pt idx="5">
                    <c:v>1.3261939815546076E-3</c:v>
                  </c:pt>
                </c:numCache>
              </c:numRef>
            </c:plus>
            <c:minus>
              <c:numRef>
                <c:f>Sheet4!$J$5:$J$10</c:f>
                <c:numCache>
                  <c:formatCode>General</c:formatCode>
                  <c:ptCount val="6"/>
                  <c:pt idx="0">
                    <c:v>1.4546972567517467E-4</c:v>
                  </c:pt>
                  <c:pt idx="1">
                    <c:v>2.7357252692447956E-4</c:v>
                  </c:pt>
                  <c:pt idx="2">
                    <c:v>3.7679865666958592E-2</c:v>
                  </c:pt>
                  <c:pt idx="3">
                    <c:v>2.4681688324384849E-2</c:v>
                  </c:pt>
                  <c:pt idx="4">
                    <c:v>3.2291921786367335E-3</c:v>
                  </c:pt>
                  <c:pt idx="5">
                    <c:v>1.3261939815546076E-3</c:v>
                  </c:pt>
                </c:numCache>
              </c:numRef>
            </c:minus>
          </c:errBars>
          <c:xVal>
            <c:numRef>
              <c:f>Sheet4!$E$5:$E$10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F$5:$F$10</c:f>
              <c:numCache>
                <c:formatCode>General</c:formatCode>
                <c:ptCount val="6"/>
                <c:pt idx="0">
                  <c:v>8.2283985899634846E-4</c:v>
                </c:pt>
                <c:pt idx="1">
                  <c:v>1.3592361388527797E-3</c:v>
                </c:pt>
                <c:pt idx="2">
                  <c:v>0.32708448027688752</c:v>
                </c:pt>
                <c:pt idx="3">
                  <c:v>0.14451585469351577</c:v>
                </c:pt>
                <c:pt idx="4">
                  <c:v>2.0682567023570259E-2</c:v>
                </c:pt>
                <c:pt idx="5">
                  <c:v>1.4134791834381539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4!$G$3</c:f>
              <c:strCache>
                <c:ptCount val="1"/>
                <c:pt idx="0">
                  <c:v>Bra035933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4!$K$5:$K$10</c:f>
                <c:numCache>
                  <c:formatCode>General</c:formatCode>
                  <c:ptCount val="6"/>
                  <c:pt idx="0">
                    <c:v>6.1467453313612572E-5</c:v>
                  </c:pt>
                  <c:pt idx="1">
                    <c:v>2.2555691303995028E-4</c:v>
                  </c:pt>
                  <c:pt idx="2">
                    <c:v>3.2344076529012833E-2</c:v>
                  </c:pt>
                  <c:pt idx="3">
                    <c:v>1.6366726914200776E-2</c:v>
                  </c:pt>
                  <c:pt idx="4">
                    <c:v>1.0873107581600306E-3</c:v>
                  </c:pt>
                  <c:pt idx="5">
                    <c:v>5.006950500128206E-4</c:v>
                  </c:pt>
                </c:numCache>
              </c:numRef>
            </c:plus>
            <c:minus>
              <c:numRef>
                <c:f>Sheet4!$K$5:$K$10</c:f>
                <c:numCache>
                  <c:formatCode>General</c:formatCode>
                  <c:ptCount val="6"/>
                  <c:pt idx="0">
                    <c:v>6.1467453313612572E-5</c:v>
                  </c:pt>
                  <c:pt idx="1">
                    <c:v>2.2555691303995028E-4</c:v>
                  </c:pt>
                  <c:pt idx="2">
                    <c:v>3.2344076529012833E-2</c:v>
                  </c:pt>
                  <c:pt idx="3">
                    <c:v>1.6366726914200776E-2</c:v>
                  </c:pt>
                  <c:pt idx="4">
                    <c:v>1.0873107581600306E-3</c:v>
                  </c:pt>
                  <c:pt idx="5">
                    <c:v>5.006950500128206E-4</c:v>
                  </c:pt>
                </c:numCache>
              </c:numRef>
            </c:minus>
          </c:errBars>
          <c:xVal>
            <c:numRef>
              <c:f>Sheet4!$E$5:$E$10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5:$G$10</c:f>
              <c:numCache>
                <c:formatCode>General</c:formatCode>
                <c:ptCount val="6"/>
                <c:pt idx="0">
                  <c:v>1.6695433488478231E-4</c:v>
                </c:pt>
                <c:pt idx="1">
                  <c:v>7.1245678848537387E-4</c:v>
                </c:pt>
                <c:pt idx="2">
                  <c:v>9.9525976129562668E-2</c:v>
                </c:pt>
                <c:pt idx="3">
                  <c:v>6.3163792051134302E-2</c:v>
                </c:pt>
                <c:pt idx="4">
                  <c:v>3.0350645422538569E-3</c:v>
                </c:pt>
                <c:pt idx="5">
                  <c:v>1.662218620638814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331136"/>
        <c:axId val="252332672"/>
      </c:scatterChart>
      <c:valAx>
        <c:axId val="252331136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332672"/>
        <c:crosses val="autoZero"/>
        <c:crossBetween val="midCat"/>
        <c:majorUnit val="4"/>
      </c:valAx>
      <c:valAx>
        <c:axId val="252332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3311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8710486921842586"/>
          <c:y val="7.5796227955347961E-2"/>
          <c:w val="0.41289513078157408"/>
          <c:h val="0.1966079855861426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 smtClean="0"/>
              <a:t>ZTL ; </a:t>
            </a:r>
            <a:r>
              <a:rPr lang="en-US" altLang="en-US" dirty="0"/>
              <a:t>At5g57360</a:t>
            </a:r>
          </a:p>
        </c:rich>
      </c:tx>
      <c:layout>
        <c:manualLayout>
          <c:xMode val="edge"/>
          <c:yMode val="edge"/>
          <c:x val="0.24690555574008391"/>
          <c:y val="8.626758862541844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4291275768901"/>
          <c:y val="5.304015133584191E-2"/>
          <c:w val="0.79198430987622126"/>
          <c:h val="0.7934897330248329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5:$B$15</c:f>
              <c:strCache>
                <c:ptCount val="1"/>
                <c:pt idx="0">
                  <c:v>ZTL At5g5736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5:$V$15</c:f>
                <c:numCache>
                  <c:formatCode>General</c:formatCode>
                  <c:ptCount val="6"/>
                  <c:pt idx="0">
                    <c:v>0.13188810456857578</c:v>
                  </c:pt>
                  <c:pt idx="1">
                    <c:v>0.13492610863340729</c:v>
                  </c:pt>
                  <c:pt idx="2">
                    <c:v>8.1405546919496766E-2</c:v>
                  </c:pt>
                  <c:pt idx="3">
                    <c:v>9.7094065778028232E-2</c:v>
                  </c:pt>
                  <c:pt idx="4">
                    <c:v>0.13117760268286452</c:v>
                  </c:pt>
                  <c:pt idx="5">
                    <c:v>0.15732527454444808</c:v>
                  </c:pt>
                </c:numCache>
              </c:numRef>
            </c:plus>
            <c:minus>
              <c:numRef>
                <c:f>Sheet4!$Q$15:$V$15</c:f>
                <c:numCache>
                  <c:formatCode>General</c:formatCode>
                  <c:ptCount val="6"/>
                  <c:pt idx="0">
                    <c:v>0.13188810456857578</c:v>
                  </c:pt>
                  <c:pt idx="1">
                    <c:v>0.13492610863340729</c:v>
                  </c:pt>
                  <c:pt idx="2">
                    <c:v>8.1405546919496766E-2</c:v>
                  </c:pt>
                  <c:pt idx="3">
                    <c:v>9.7094065778028232E-2</c:v>
                  </c:pt>
                  <c:pt idx="4">
                    <c:v>0.13117760268286452</c:v>
                  </c:pt>
                  <c:pt idx="5">
                    <c:v>0.15732527454444808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5:$H$15</c:f>
              <c:numCache>
                <c:formatCode>General</c:formatCode>
                <c:ptCount val="6"/>
                <c:pt idx="0">
                  <c:v>8.9602381833333329</c:v>
                </c:pt>
                <c:pt idx="1">
                  <c:v>8.5020861500000144</c:v>
                </c:pt>
                <c:pt idx="2">
                  <c:v>8.2483143423333107</c:v>
                </c:pt>
                <c:pt idx="3">
                  <c:v>8.2169310213333233</c:v>
                </c:pt>
                <c:pt idx="4">
                  <c:v>8.3618022246666808</c:v>
                </c:pt>
                <c:pt idx="5">
                  <c:v>8.466094507000018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369920"/>
        <c:axId val="251609856"/>
      </c:scatterChart>
      <c:valAx>
        <c:axId val="25236992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609856"/>
        <c:crosses val="autoZero"/>
        <c:crossBetween val="midCat"/>
        <c:majorUnit val="4"/>
      </c:valAx>
      <c:valAx>
        <c:axId val="251609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36992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CRY1 </a:t>
            </a:r>
            <a:r>
              <a:rPr lang="en-US" dirty="0" smtClean="0"/>
              <a:t>; At4g08920</a:t>
            </a:r>
            <a:endParaRPr lang="en-US" dirty="0"/>
          </a:p>
        </c:rich>
      </c:tx>
      <c:layout>
        <c:manualLayout>
          <c:xMode val="edge"/>
          <c:yMode val="edge"/>
          <c:x val="0.28984496514276276"/>
          <c:y val="6.63755401132251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96905436433026"/>
          <c:y val="6.4597661191767325E-2"/>
          <c:w val="0.75744173679776361"/>
          <c:h val="0.7741002194499303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4:$B$4</c:f>
              <c:strCache>
                <c:ptCount val="1"/>
                <c:pt idx="0">
                  <c:v>CRY1 At4g0892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4:$V$4</c:f>
                <c:numCache>
                  <c:formatCode>General</c:formatCode>
                  <c:ptCount val="6"/>
                  <c:pt idx="0">
                    <c:v>6.984678142886451E-2</c:v>
                  </c:pt>
                  <c:pt idx="1">
                    <c:v>9.0846616993953706E-3</c:v>
                  </c:pt>
                  <c:pt idx="2">
                    <c:v>5.2382613672342572E-2</c:v>
                  </c:pt>
                  <c:pt idx="3">
                    <c:v>6.4648422143716772E-2</c:v>
                  </c:pt>
                  <c:pt idx="4">
                    <c:v>3.8481090858883606E-2</c:v>
                  </c:pt>
                  <c:pt idx="5">
                    <c:v>0.10159219472957004</c:v>
                  </c:pt>
                </c:numCache>
              </c:numRef>
            </c:plus>
            <c:minus>
              <c:numRef>
                <c:f>Sheet4!$Q$4:$V$4</c:f>
                <c:numCache>
                  <c:formatCode>General</c:formatCode>
                  <c:ptCount val="6"/>
                  <c:pt idx="0">
                    <c:v>6.984678142886451E-2</c:v>
                  </c:pt>
                  <c:pt idx="1">
                    <c:v>9.0846616993953706E-3</c:v>
                  </c:pt>
                  <c:pt idx="2">
                    <c:v>5.2382613672342572E-2</c:v>
                  </c:pt>
                  <c:pt idx="3">
                    <c:v>6.4648422143716772E-2</c:v>
                  </c:pt>
                  <c:pt idx="4">
                    <c:v>3.8481090858883606E-2</c:v>
                  </c:pt>
                  <c:pt idx="5">
                    <c:v>0.10159219472957004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4:$H$4</c:f>
              <c:numCache>
                <c:formatCode>General</c:formatCode>
                <c:ptCount val="6"/>
                <c:pt idx="0">
                  <c:v>10.133728779999997</c:v>
                </c:pt>
                <c:pt idx="1">
                  <c:v>9.8501749956666789</c:v>
                </c:pt>
                <c:pt idx="2">
                  <c:v>9.3080444819999997</c:v>
                </c:pt>
                <c:pt idx="3">
                  <c:v>8.9070854000000015</c:v>
                </c:pt>
                <c:pt idx="4">
                  <c:v>9.4301763740000002</c:v>
                </c:pt>
                <c:pt idx="5">
                  <c:v>9.950269321333333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439168"/>
        <c:axId val="250440704"/>
      </c:scatterChart>
      <c:valAx>
        <c:axId val="25043916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440704"/>
        <c:crosses val="autoZero"/>
        <c:crossBetween val="midCat"/>
        <c:majorUnit val="4"/>
      </c:valAx>
      <c:valAx>
        <c:axId val="2504407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ko-KR"/>
          </a:p>
        </c:txPr>
        <c:crossAx val="25043916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/>
      </a:pPr>
      <a:endParaRPr lang="ko-KR"/>
    </a:p>
  </c:txPr>
  <c:externalData r:id="rId1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/>
              <a:t>FKF1 </a:t>
            </a:r>
            <a:r>
              <a:rPr lang="en-US" altLang="en-US" dirty="0" smtClean="0"/>
              <a:t>; At1g68050</a:t>
            </a:r>
            <a:endParaRPr lang="en-US" altLang="en-US" dirty="0"/>
          </a:p>
        </c:rich>
      </c:tx>
      <c:layout>
        <c:manualLayout>
          <c:xMode val="edge"/>
          <c:yMode val="edge"/>
          <c:x val="0.22866686687590271"/>
          <c:y val="5.2535533876850574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51216531496499"/>
          <c:y val="6.3910452030152692E-2"/>
          <c:w val="0.80520379101396078"/>
          <c:h val="0.7765034086047183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16:$B$16</c:f>
              <c:strCache>
                <c:ptCount val="1"/>
                <c:pt idx="0">
                  <c:v>FKF1 At1g6805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16:$V$16</c:f>
                <c:numCache>
                  <c:formatCode>General</c:formatCode>
                  <c:ptCount val="6"/>
                  <c:pt idx="0">
                    <c:v>8.366244069641797E-2</c:v>
                  </c:pt>
                  <c:pt idx="1">
                    <c:v>0.17968340921199166</c:v>
                  </c:pt>
                  <c:pt idx="2">
                    <c:v>4.0420712484818613E-2</c:v>
                  </c:pt>
                  <c:pt idx="3">
                    <c:v>0.15180446069402151</c:v>
                  </c:pt>
                  <c:pt idx="4">
                    <c:v>0.10788869516966246</c:v>
                  </c:pt>
                  <c:pt idx="5">
                    <c:v>0.10045220225523989</c:v>
                  </c:pt>
                </c:numCache>
              </c:numRef>
            </c:plus>
            <c:minus>
              <c:numRef>
                <c:f>Sheet4!$Q$16:$V$16</c:f>
                <c:numCache>
                  <c:formatCode>General</c:formatCode>
                  <c:ptCount val="6"/>
                  <c:pt idx="0">
                    <c:v>8.366244069641797E-2</c:v>
                  </c:pt>
                  <c:pt idx="1">
                    <c:v>0.17968340921199166</c:v>
                  </c:pt>
                  <c:pt idx="2">
                    <c:v>4.0420712484818613E-2</c:v>
                  </c:pt>
                  <c:pt idx="3">
                    <c:v>0.15180446069402151</c:v>
                  </c:pt>
                  <c:pt idx="4">
                    <c:v>0.10788869516966246</c:v>
                  </c:pt>
                  <c:pt idx="5">
                    <c:v>0.10045220225523989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16:$H$16</c:f>
              <c:numCache>
                <c:formatCode>General</c:formatCode>
                <c:ptCount val="6"/>
                <c:pt idx="0">
                  <c:v>8.2434061070000002</c:v>
                </c:pt>
                <c:pt idx="1">
                  <c:v>8.0460828730000067</c:v>
                </c:pt>
                <c:pt idx="2">
                  <c:v>10.363406916666699</c:v>
                </c:pt>
                <c:pt idx="3">
                  <c:v>9.5200294153333331</c:v>
                </c:pt>
                <c:pt idx="4">
                  <c:v>9.1161313510000017</c:v>
                </c:pt>
                <c:pt idx="5">
                  <c:v>8.687656958000010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634432"/>
        <c:axId val="251635968"/>
      </c:scatterChart>
      <c:valAx>
        <c:axId val="25163443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635968"/>
        <c:crosses val="autoZero"/>
        <c:crossBetween val="midCat"/>
        <c:majorUnit val="4"/>
      </c:valAx>
      <c:valAx>
        <c:axId val="2516359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6344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PRR3 </a:t>
            </a:r>
            <a:r>
              <a:rPr lang="en-US" dirty="0" smtClean="0"/>
              <a:t>; At5g60100</a:t>
            </a:r>
            <a:endParaRPr lang="en-US" dirty="0"/>
          </a:p>
        </c:rich>
      </c:tx>
      <c:layout>
        <c:manualLayout>
          <c:xMode val="edge"/>
          <c:yMode val="edge"/>
          <c:x val="0.26103335161833807"/>
          <c:y val="0.62601408146347681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51216531496499"/>
          <c:y val="5.3623010141730341E-2"/>
          <c:w val="0.80520379101396078"/>
          <c:h val="0.7904547541115706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20:$B$20</c:f>
              <c:strCache>
                <c:ptCount val="1"/>
                <c:pt idx="0">
                  <c:v>PRR3 At5g6010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20:$V$20</c:f>
                <c:numCache>
                  <c:formatCode>General</c:formatCode>
                  <c:ptCount val="6"/>
                  <c:pt idx="0">
                    <c:v>0.45033441737704566</c:v>
                  </c:pt>
                  <c:pt idx="1">
                    <c:v>0.8930570586636547</c:v>
                  </c:pt>
                  <c:pt idx="2">
                    <c:v>0.11912829059594378</c:v>
                  </c:pt>
                  <c:pt idx="3">
                    <c:v>0.21477370759174075</c:v>
                  </c:pt>
                  <c:pt idx="4">
                    <c:v>0.24326711771639531</c:v>
                  </c:pt>
                  <c:pt idx="5">
                    <c:v>0.4275348312907099</c:v>
                  </c:pt>
                </c:numCache>
              </c:numRef>
            </c:plus>
            <c:minus>
              <c:numRef>
                <c:f>Sheet4!$Q$20:$V$20</c:f>
                <c:numCache>
                  <c:formatCode>General</c:formatCode>
                  <c:ptCount val="6"/>
                  <c:pt idx="0">
                    <c:v>0.45033441737704566</c:v>
                  </c:pt>
                  <c:pt idx="1">
                    <c:v>0.8930570586636547</c:v>
                  </c:pt>
                  <c:pt idx="2">
                    <c:v>0.11912829059594378</c:v>
                  </c:pt>
                  <c:pt idx="3">
                    <c:v>0.21477370759174075</c:v>
                  </c:pt>
                  <c:pt idx="4">
                    <c:v>0.24326711771639531</c:v>
                  </c:pt>
                  <c:pt idx="5">
                    <c:v>0.4275348312907099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20:$H$20</c:f>
              <c:numCache>
                <c:formatCode>General</c:formatCode>
                <c:ptCount val="6"/>
                <c:pt idx="0">
                  <c:v>5.7532051909999993</c:v>
                </c:pt>
                <c:pt idx="1">
                  <c:v>4.1130557959999985</c:v>
                </c:pt>
                <c:pt idx="2">
                  <c:v>8.9418733513333173</c:v>
                </c:pt>
                <c:pt idx="3">
                  <c:v>8.9805433293333348</c:v>
                </c:pt>
                <c:pt idx="4">
                  <c:v>6.9011014150000065</c:v>
                </c:pt>
                <c:pt idx="5">
                  <c:v>6.655578365999994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664640"/>
        <c:axId val="251670528"/>
      </c:scatterChart>
      <c:valAx>
        <c:axId val="25166464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670528"/>
        <c:crosses val="autoZero"/>
        <c:crossBetween val="midCat"/>
        <c:majorUnit val="4"/>
      </c:valAx>
      <c:valAx>
        <c:axId val="251670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66464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PRR5 </a:t>
            </a:r>
            <a:r>
              <a:rPr lang="en-US" dirty="0" smtClean="0"/>
              <a:t>; At5g24470</a:t>
            </a:r>
            <a:endParaRPr lang="en-US" dirty="0"/>
          </a:p>
        </c:rich>
      </c:tx>
      <c:layout>
        <c:manualLayout>
          <c:xMode val="edge"/>
          <c:yMode val="edge"/>
          <c:x val="0.22796410931192851"/>
          <c:y val="6.783434319263673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51216531496499"/>
          <c:y val="5.3623010141730341E-2"/>
          <c:w val="0.80520379101396078"/>
          <c:h val="0.7912203894316992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21:$B$21</c:f>
              <c:strCache>
                <c:ptCount val="1"/>
                <c:pt idx="0">
                  <c:v>PRR5 At5g24470</c:v>
                </c:pt>
              </c:strCache>
            </c:strRef>
          </c:tx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21:$V$21</c:f>
                <c:numCache>
                  <c:formatCode>General</c:formatCode>
                  <c:ptCount val="6"/>
                  <c:pt idx="0">
                    <c:v>1.0790840610666927</c:v>
                  </c:pt>
                  <c:pt idx="1">
                    <c:v>0.32044211045736032</c:v>
                  </c:pt>
                  <c:pt idx="2">
                    <c:v>0.14078516748355638</c:v>
                  </c:pt>
                  <c:pt idx="3">
                    <c:v>0.11019434281154648</c:v>
                  </c:pt>
                  <c:pt idx="4">
                    <c:v>9.389325126912812E-2</c:v>
                  </c:pt>
                  <c:pt idx="5">
                    <c:v>0.32181001588334596</c:v>
                  </c:pt>
                </c:numCache>
              </c:numRef>
            </c:plus>
            <c:minus>
              <c:numRef>
                <c:f>Sheet4!$Q$21:$V$21</c:f>
                <c:numCache>
                  <c:formatCode>General</c:formatCode>
                  <c:ptCount val="6"/>
                  <c:pt idx="0">
                    <c:v>1.0790840610666927</c:v>
                  </c:pt>
                  <c:pt idx="1">
                    <c:v>0.32044211045736032</c:v>
                  </c:pt>
                  <c:pt idx="2">
                    <c:v>0.14078516748355638</c:v>
                  </c:pt>
                  <c:pt idx="3">
                    <c:v>0.11019434281154648</c:v>
                  </c:pt>
                  <c:pt idx="4">
                    <c:v>9.389325126912812E-2</c:v>
                  </c:pt>
                  <c:pt idx="5">
                    <c:v>0.32181001588334596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21:$H$21</c:f>
              <c:numCache>
                <c:formatCode>General</c:formatCode>
                <c:ptCount val="6"/>
                <c:pt idx="0">
                  <c:v>3.4798778559999999</c:v>
                </c:pt>
                <c:pt idx="1">
                  <c:v>5.103828658666667</c:v>
                </c:pt>
                <c:pt idx="2">
                  <c:v>10.878511556666679</c:v>
                </c:pt>
                <c:pt idx="3">
                  <c:v>7.6003590450000003</c:v>
                </c:pt>
                <c:pt idx="4">
                  <c:v>6.5474584169999934</c:v>
                </c:pt>
                <c:pt idx="5">
                  <c:v>7.020932768999991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715584"/>
        <c:axId val="251717120"/>
      </c:scatterChart>
      <c:valAx>
        <c:axId val="25171558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717120"/>
        <c:crosses val="autoZero"/>
        <c:crossBetween val="midCat"/>
        <c:majorUnit val="4"/>
      </c:valAx>
      <c:valAx>
        <c:axId val="251717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71558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PRR7 </a:t>
            </a:r>
            <a:r>
              <a:rPr lang="en-US" dirty="0" smtClean="0"/>
              <a:t>; At5g02810</a:t>
            </a:r>
            <a:endParaRPr lang="en-US" dirty="0"/>
          </a:p>
        </c:rich>
      </c:tx>
      <c:layout>
        <c:manualLayout>
          <c:xMode val="edge"/>
          <c:yMode val="edge"/>
          <c:x val="0.22796410931192851"/>
          <c:y val="8.915370819603703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51216531496499"/>
          <c:y val="5.4388645461859557E-2"/>
          <c:w val="0.80520379101396078"/>
          <c:h val="0.7904547541115706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22:$B$22</c:f>
              <c:strCache>
                <c:ptCount val="1"/>
                <c:pt idx="0">
                  <c:v>PRR7 At5g0281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22:$V$22</c:f>
                <c:numCache>
                  <c:formatCode>General</c:formatCode>
                  <c:ptCount val="6"/>
                  <c:pt idx="0">
                    <c:v>0.24550788113145636</c:v>
                  </c:pt>
                  <c:pt idx="1">
                    <c:v>8.9011870445785818E-2</c:v>
                  </c:pt>
                  <c:pt idx="2">
                    <c:v>0.17166075873732745</c:v>
                  </c:pt>
                  <c:pt idx="3">
                    <c:v>0.3703687101567904</c:v>
                  </c:pt>
                  <c:pt idx="4">
                    <c:v>0.82567426381823361</c:v>
                  </c:pt>
                  <c:pt idx="5">
                    <c:v>0.89916834113307509</c:v>
                  </c:pt>
                </c:numCache>
              </c:numRef>
            </c:plus>
            <c:minus>
              <c:numRef>
                <c:f>Sheet4!$Q$22:$V$22</c:f>
                <c:numCache>
                  <c:formatCode>General</c:formatCode>
                  <c:ptCount val="6"/>
                  <c:pt idx="0">
                    <c:v>0.24550788113145636</c:v>
                  </c:pt>
                  <c:pt idx="1">
                    <c:v>8.9011870445785818E-2</c:v>
                  </c:pt>
                  <c:pt idx="2">
                    <c:v>0.17166075873732745</c:v>
                  </c:pt>
                  <c:pt idx="3">
                    <c:v>0.3703687101567904</c:v>
                  </c:pt>
                  <c:pt idx="4">
                    <c:v>0.82567426381823361</c:v>
                  </c:pt>
                  <c:pt idx="5">
                    <c:v>0.89916834113307509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22:$H$22</c:f>
              <c:numCache>
                <c:formatCode>General</c:formatCode>
                <c:ptCount val="6"/>
                <c:pt idx="0">
                  <c:v>2.8422957183333342</c:v>
                </c:pt>
                <c:pt idx="1">
                  <c:v>10.067671007333333</c:v>
                </c:pt>
                <c:pt idx="2">
                  <c:v>10.171232805000002</c:v>
                </c:pt>
                <c:pt idx="3">
                  <c:v>7.61347912433334</c:v>
                </c:pt>
                <c:pt idx="4">
                  <c:v>3.6601273130000012</c:v>
                </c:pt>
                <c:pt idx="5">
                  <c:v>3.040740408666667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737600"/>
        <c:axId val="251739136"/>
      </c:scatterChart>
      <c:valAx>
        <c:axId val="25173760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739136"/>
        <c:crosses val="autoZero"/>
        <c:crossBetween val="midCat"/>
        <c:majorUnit val="4"/>
      </c:valAx>
      <c:valAx>
        <c:axId val="251739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73760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PRR9 </a:t>
            </a:r>
            <a:r>
              <a:rPr lang="en-US" dirty="0" smtClean="0"/>
              <a:t>; At2g44790</a:t>
            </a:r>
            <a:endParaRPr lang="en-US" dirty="0"/>
          </a:p>
        </c:rich>
      </c:tx>
      <c:layout>
        <c:manualLayout>
          <c:xMode val="edge"/>
          <c:yMode val="edge"/>
          <c:x val="0.37591902404362482"/>
          <c:y val="3.488623364192745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051216531496499"/>
          <c:y val="5.3623010141730341E-2"/>
          <c:w val="0.80520379101396078"/>
          <c:h val="0.7912203894316992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23:$B$23</c:f>
              <c:strCache>
                <c:ptCount val="1"/>
                <c:pt idx="0">
                  <c:v>PRR9 At2g4679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23:$V$23</c:f>
                <c:numCache>
                  <c:formatCode>General</c:formatCode>
                  <c:ptCount val="6"/>
                  <c:pt idx="0">
                    <c:v>0.84475149314624542</c:v>
                  </c:pt>
                  <c:pt idx="1">
                    <c:v>0.21124398848670056</c:v>
                  </c:pt>
                  <c:pt idx="2">
                    <c:v>0.11291753759913133</c:v>
                  </c:pt>
                  <c:pt idx="3">
                    <c:v>1.1026518803941694</c:v>
                  </c:pt>
                  <c:pt idx="4">
                    <c:v>0.60321453719316365</c:v>
                  </c:pt>
                  <c:pt idx="5">
                    <c:v>0.54959286026340171</c:v>
                  </c:pt>
                </c:numCache>
              </c:numRef>
            </c:plus>
            <c:minus>
              <c:numRef>
                <c:f>Sheet4!$Q$23:$V$23</c:f>
                <c:numCache>
                  <c:formatCode>General</c:formatCode>
                  <c:ptCount val="6"/>
                  <c:pt idx="0">
                    <c:v>0.84475149314624542</c:v>
                  </c:pt>
                  <c:pt idx="1">
                    <c:v>0.21124398848670056</c:v>
                  </c:pt>
                  <c:pt idx="2">
                    <c:v>0.11291753759913133</c:v>
                  </c:pt>
                  <c:pt idx="3">
                    <c:v>1.1026518803941694</c:v>
                  </c:pt>
                  <c:pt idx="4">
                    <c:v>0.60321453719316365</c:v>
                  </c:pt>
                  <c:pt idx="5">
                    <c:v>0.54959286026340171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23:$H$23</c:f>
              <c:numCache>
                <c:formatCode>General</c:formatCode>
                <c:ptCount val="6"/>
                <c:pt idx="0">
                  <c:v>1.9562608573333333</c:v>
                </c:pt>
                <c:pt idx="1">
                  <c:v>9.076689775333346</c:v>
                </c:pt>
                <c:pt idx="2">
                  <c:v>5.932384628666667</c:v>
                </c:pt>
                <c:pt idx="3">
                  <c:v>1.7892125926666667</c:v>
                </c:pt>
                <c:pt idx="4">
                  <c:v>2.3637882420000031</c:v>
                </c:pt>
                <c:pt idx="5">
                  <c:v>1.709292164999999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751424"/>
        <c:axId val="251765504"/>
      </c:scatterChart>
      <c:valAx>
        <c:axId val="25175142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1765504"/>
        <c:crosses val="autoZero"/>
        <c:crossBetween val="midCat"/>
        <c:majorUnit val="4"/>
      </c:valAx>
      <c:valAx>
        <c:axId val="251765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175142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98067949839604"/>
          <c:y val="5.1400554097404488E-2"/>
          <c:w val="0.82878098571011949"/>
          <c:h val="0.83261956838728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37</c:f>
              <c:strCache>
                <c:ptCount val="1"/>
                <c:pt idx="0">
                  <c:v>Bra002512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7:$K$37</c:f>
              <c:numCache>
                <c:formatCode>General</c:formatCode>
                <c:ptCount val="7"/>
                <c:pt idx="0">
                  <c:v>2.0314999999999972</c:v>
                </c:pt>
                <c:pt idx="1">
                  <c:v>23.027999999999999</c:v>
                </c:pt>
                <c:pt idx="2">
                  <c:v>61.637500000000003</c:v>
                </c:pt>
                <c:pt idx="3">
                  <c:v>39.184000000000005</c:v>
                </c:pt>
                <c:pt idx="4">
                  <c:v>9.3860000000000028</c:v>
                </c:pt>
                <c:pt idx="5">
                  <c:v>2.3939999999999997</c:v>
                </c:pt>
                <c:pt idx="6">
                  <c:v>2.8959999999999977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38</c:f>
              <c:strCache>
                <c:ptCount val="1"/>
                <c:pt idx="0">
                  <c:v>Bra020263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8:$K$38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781696"/>
        <c:axId val="252783232"/>
      </c:scatterChart>
      <c:valAx>
        <c:axId val="25278169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783232"/>
        <c:crosses val="autoZero"/>
        <c:crossBetween val="midCat"/>
        <c:majorUnit val="4"/>
      </c:valAx>
      <c:valAx>
        <c:axId val="252783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7816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7344889180519165"/>
          <c:y val="0.17091243802857994"/>
          <c:w val="0.42655114344020256"/>
          <c:h val="0.3549736372510620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702646154995749"/>
          <c:y val="5.1400554097404488E-2"/>
          <c:w val="0.80045880385948265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39</c:f>
              <c:strCache>
                <c:ptCount val="1"/>
                <c:pt idx="0">
                  <c:v>Bra009768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39:$K$39</c:f>
              <c:numCache>
                <c:formatCode>General</c:formatCode>
                <c:ptCount val="7"/>
                <c:pt idx="0">
                  <c:v>0.28900000000000031</c:v>
                </c:pt>
                <c:pt idx="1">
                  <c:v>1.1324999999999998</c:v>
                </c:pt>
                <c:pt idx="2">
                  <c:v>162.8075</c:v>
                </c:pt>
                <c:pt idx="3">
                  <c:v>10.567500000000004</c:v>
                </c:pt>
                <c:pt idx="4">
                  <c:v>0.91999999999999993</c:v>
                </c:pt>
                <c:pt idx="5">
                  <c:v>1.0669999999999986</c:v>
                </c:pt>
                <c:pt idx="6">
                  <c:v>0.22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40</c:f>
              <c:strCache>
                <c:ptCount val="1"/>
                <c:pt idx="0">
                  <c:v>Bra029407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40:$K$40</c:f>
              <c:numCache>
                <c:formatCode>General</c:formatCode>
                <c:ptCount val="7"/>
                <c:pt idx="0">
                  <c:v>0.40350000000000008</c:v>
                </c:pt>
                <c:pt idx="1">
                  <c:v>2.4045000000000001</c:v>
                </c:pt>
                <c:pt idx="2">
                  <c:v>68.998500000000007</c:v>
                </c:pt>
                <c:pt idx="3">
                  <c:v>9.5355000000000025</c:v>
                </c:pt>
                <c:pt idx="4">
                  <c:v>2.3895</c:v>
                </c:pt>
                <c:pt idx="5">
                  <c:v>2.5840000000000001</c:v>
                </c:pt>
                <c:pt idx="6">
                  <c:v>0.33050000000000046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2!$A$41</c:f>
              <c:strCache>
                <c:ptCount val="1"/>
                <c:pt idx="0">
                  <c:v>Bra036517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41:$K$41</c:f>
              <c:numCache>
                <c:formatCode>General</c:formatCode>
                <c:ptCount val="7"/>
                <c:pt idx="0">
                  <c:v>0.48450000000000032</c:v>
                </c:pt>
                <c:pt idx="1">
                  <c:v>2.9159999999999977</c:v>
                </c:pt>
                <c:pt idx="2">
                  <c:v>51.991</c:v>
                </c:pt>
                <c:pt idx="3">
                  <c:v>2.0649999999999999</c:v>
                </c:pt>
                <c:pt idx="4">
                  <c:v>0.48350000000000032</c:v>
                </c:pt>
                <c:pt idx="5">
                  <c:v>0.53550000000000009</c:v>
                </c:pt>
                <c:pt idx="6">
                  <c:v>0.5330000000000000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825600"/>
        <c:axId val="252827136"/>
      </c:scatterChart>
      <c:valAx>
        <c:axId val="252825600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827136"/>
        <c:crosses val="autoZero"/>
        <c:crossBetween val="midCat"/>
        <c:majorUnit val="4"/>
      </c:valAx>
      <c:valAx>
        <c:axId val="252827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82560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2117514293860145"/>
          <c:y val="0.1168786878314774"/>
          <c:w val="0.34756820877817318"/>
          <c:h val="0.3676232489601014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57579626870967"/>
          <c:y val="5.1400554097404488E-2"/>
          <c:w val="0.80545789884372554"/>
          <c:h val="0.897198891805191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42</c:f>
              <c:strCache>
                <c:ptCount val="1"/>
                <c:pt idx="0">
                  <c:v>Bra009565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42:$K$42</c:f>
              <c:numCache>
                <c:formatCode>General</c:formatCode>
                <c:ptCount val="7"/>
                <c:pt idx="0">
                  <c:v>13.264000000000001</c:v>
                </c:pt>
                <c:pt idx="1">
                  <c:v>109.99450000000009</c:v>
                </c:pt>
                <c:pt idx="2">
                  <c:v>115.41950000000008</c:v>
                </c:pt>
                <c:pt idx="3">
                  <c:v>24.062499999999975</c:v>
                </c:pt>
                <c:pt idx="4">
                  <c:v>0.78549999999999998</c:v>
                </c:pt>
                <c:pt idx="5">
                  <c:v>0.80549999999999999</c:v>
                </c:pt>
                <c:pt idx="6">
                  <c:v>18.2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43</c:f>
              <c:strCache>
                <c:ptCount val="1"/>
                <c:pt idx="0">
                  <c:v>Bra028861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43:$K$43</c:f>
              <c:numCache>
                <c:formatCode>General</c:formatCode>
                <c:ptCount val="7"/>
                <c:pt idx="0">
                  <c:v>1.0840000000000001</c:v>
                </c:pt>
                <c:pt idx="1">
                  <c:v>40.867500000000007</c:v>
                </c:pt>
                <c:pt idx="2">
                  <c:v>94.708000000000013</c:v>
                </c:pt>
                <c:pt idx="3">
                  <c:v>40.656500000000001</c:v>
                </c:pt>
                <c:pt idx="4">
                  <c:v>1.6680000000000001</c:v>
                </c:pt>
                <c:pt idx="5">
                  <c:v>1.1635</c:v>
                </c:pt>
                <c:pt idx="6">
                  <c:v>1.43749999999999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708736"/>
        <c:axId val="252710272"/>
      </c:scatterChart>
      <c:valAx>
        <c:axId val="25270873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710272"/>
        <c:crosses val="autoZero"/>
        <c:crossBetween val="midCat"/>
        <c:majorUnit val="4"/>
      </c:valAx>
      <c:valAx>
        <c:axId val="252710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7087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7990726983900631"/>
          <c:y val="0.11768200555856073"/>
          <c:w val="0.38848876470770244"/>
          <c:h val="0.2187609197117507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18581423055907"/>
          <c:y val="5.1400554097404488E-2"/>
          <c:w val="0.77955811927329766"/>
          <c:h val="0.7595498161023054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44</c:f>
              <c:strCache>
                <c:ptCount val="1"/>
                <c:pt idx="0">
                  <c:v>Bra004507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44:$K$44</c:f>
              <c:numCache>
                <c:formatCode>General</c:formatCode>
                <c:ptCount val="7"/>
                <c:pt idx="0">
                  <c:v>0.1255</c:v>
                </c:pt>
                <c:pt idx="1">
                  <c:v>38.470500000000001</c:v>
                </c:pt>
                <c:pt idx="2">
                  <c:v>2.274</c:v>
                </c:pt>
                <c:pt idx="3">
                  <c:v>6.6000000000000003E-2</c:v>
                </c:pt>
                <c:pt idx="4">
                  <c:v>2.1000000000000012E-2</c:v>
                </c:pt>
                <c:pt idx="5">
                  <c:v>1.3500000000000015E-2</c:v>
                </c:pt>
                <c:pt idx="6">
                  <c:v>0.2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45</c:f>
              <c:strCache>
                <c:ptCount val="1"/>
                <c:pt idx="0">
                  <c:v>Bra040484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45:$K$45</c:f>
              <c:numCache>
                <c:formatCode>General</c:formatCode>
                <c:ptCount val="7"/>
                <c:pt idx="0">
                  <c:v>44.539500000000011</c:v>
                </c:pt>
                <c:pt idx="1">
                  <c:v>33.789000000000001</c:v>
                </c:pt>
                <c:pt idx="2">
                  <c:v>6.0069999999999997</c:v>
                </c:pt>
                <c:pt idx="3">
                  <c:v>9.5920000000000005</c:v>
                </c:pt>
                <c:pt idx="4">
                  <c:v>12.6425</c:v>
                </c:pt>
                <c:pt idx="5">
                  <c:v>21.3735</c:v>
                </c:pt>
                <c:pt idx="6">
                  <c:v>33.32050000000000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739584"/>
        <c:axId val="252741120"/>
      </c:scatterChart>
      <c:valAx>
        <c:axId val="252739584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741120"/>
        <c:crosses val="autoZero"/>
        <c:crossBetween val="midCat"/>
        <c:majorUnit val="4"/>
      </c:valAx>
      <c:valAx>
        <c:axId val="252741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73958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5064232629123074"/>
          <c:y val="0.10010507793798554"/>
          <c:w val="0.43204322326759032"/>
          <c:h val="0.2029681408666134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5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566885389326334"/>
          <c:y val="5.1400554097404488E-2"/>
          <c:w val="0.85043525809273868"/>
          <c:h val="0.8231454221135932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C$1</c:f>
              <c:strCache>
                <c:ptCount val="1"/>
                <c:pt idx="0">
                  <c:v>Bra002512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E$2:$E$8</c:f>
                <c:numCache>
                  <c:formatCode>General</c:formatCode>
                  <c:ptCount val="7"/>
                  <c:pt idx="0">
                    <c:v>1.6125509987917946E-4</c:v>
                  </c:pt>
                  <c:pt idx="1">
                    <c:v>3.7164730310971358E-3</c:v>
                  </c:pt>
                  <c:pt idx="2">
                    <c:v>3.5746792573088642E-3</c:v>
                  </c:pt>
                  <c:pt idx="3">
                    <c:v>1.0800297655694459E-3</c:v>
                  </c:pt>
                  <c:pt idx="4">
                    <c:v>1.9424188938709208E-4</c:v>
                  </c:pt>
                  <c:pt idx="5">
                    <c:v>2.9651637644733409E-5</c:v>
                  </c:pt>
                  <c:pt idx="6">
                    <c:v>7.0644336359388133E-5</c:v>
                  </c:pt>
                </c:numCache>
              </c:numRef>
            </c:plus>
            <c:minus>
              <c:numRef>
                <c:f>Sheet3!$E$2:$E$8</c:f>
                <c:numCache>
                  <c:formatCode>General</c:formatCode>
                  <c:ptCount val="7"/>
                  <c:pt idx="0">
                    <c:v>1.6125509987917946E-4</c:v>
                  </c:pt>
                  <c:pt idx="1">
                    <c:v>3.7164730310971358E-3</c:v>
                  </c:pt>
                  <c:pt idx="2">
                    <c:v>3.5746792573088642E-3</c:v>
                  </c:pt>
                  <c:pt idx="3">
                    <c:v>1.0800297655694459E-3</c:v>
                  </c:pt>
                  <c:pt idx="4">
                    <c:v>1.9424188938709208E-4</c:v>
                  </c:pt>
                  <c:pt idx="5">
                    <c:v>2.9651637644733409E-5</c:v>
                  </c:pt>
                  <c:pt idx="6">
                    <c:v>7.0644336359388133E-5</c:v>
                  </c:pt>
                </c:numCache>
              </c:numRef>
            </c:minus>
          </c:errBars>
          <c:xVal>
            <c:numRef>
              <c:f>Sheet3!$B$2:$B$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C$2:$C$8</c:f>
              <c:numCache>
                <c:formatCode>General</c:formatCode>
                <c:ptCount val="7"/>
                <c:pt idx="0">
                  <c:v>3.3719860153063355E-4</c:v>
                </c:pt>
                <c:pt idx="1">
                  <c:v>6.3124433413597929E-3</c:v>
                </c:pt>
                <c:pt idx="2">
                  <c:v>1.9788308814352305E-2</c:v>
                </c:pt>
                <c:pt idx="3">
                  <c:v>1.459118833859132E-2</c:v>
                </c:pt>
                <c:pt idx="4">
                  <c:v>7.1062926480272332E-4</c:v>
                </c:pt>
                <c:pt idx="5">
                  <c:v>2.4906624962772874E-4</c:v>
                </c:pt>
                <c:pt idx="6">
                  <c:v>4.1853307788208084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765696"/>
        <c:axId val="252767232"/>
      </c:scatterChart>
      <c:valAx>
        <c:axId val="25276569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767232"/>
        <c:crosses val="autoZero"/>
        <c:crossBetween val="midCat"/>
        <c:majorUnit val="4"/>
      </c:valAx>
      <c:valAx>
        <c:axId val="252767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7656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727274515794547"/>
          <c:y val="8.6936726265779307E-2"/>
          <c:w val="0.42727254842054585"/>
          <c:h val="0.1462999033560190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CRY2 ; </a:t>
            </a:r>
            <a:r>
              <a:rPr lang="en-US" dirty="0"/>
              <a:t>At1g04400</a:t>
            </a:r>
          </a:p>
        </c:rich>
      </c:tx>
      <c:layout>
        <c:manualLayout>
          <c:xMode val="edge"/>
          <c:yMode val="edge"/>
          <c:x val="0.23105520104247698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96905436433026"/>
          <c:y val="7.5976325211177281E-2"/>
          <c:w val="0.75574690196459726"/>
          <c:h val="0.7627215554305211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5:$B$5</c:f>
              <c:strCache>
                <c:ptCount val="1"/>
                <c:pt idx="0">
                  <c:v>CRY2 At1g04400</c:v>
                </c:pt>
              </c:strCache>
            </c:strRef>
          </c:tx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5:$V$5</c:f>
                <c:numCache>
                  <c:formatCode>General</c:formatCode>
                  <c:ptCount val="6"/>
                  <c:pt idx="0">
                    <c:v>0.11432578027887116</c:v>
                  </c:pt>
                  <c:pt idx="1">
                    <c:v>0.1442321105257148</c:v>
                  </c:pt>
                  <c:pt idx="2">
                    <c:v>0.11362465263387762</c:v>
                  </c:pt>
                  <c:pt idx="3">
                    <c:v>2.2661246788843452E-2</c:v>
                  </c:pt>
                  <c:pt idx="4">
                    <c:v>0.10497137210591725</c:v>
                  </c:pt>
                  <c:pt idx="5">
                    <c:v>8.2302068641636528E-2</c:v>
                  </c:pt>
                </c:numCache>
              </c:numRef>
            </c:plus>
            <c:minus>
              <c:numRef>
                <c:f>Sheet4!$Q$5:$V$5</c:f>
                <c:numCache>
                  <c:formatCode>General</c:formatCode>
                  <c:ptCount val="6"/>
                  <c:pt idx="0">
                    <c:v>0.11432578027887116</c:v>
                  </c:pt>
                  <c:pt idx="1">
                    <c:v>0.1442321105257148</c:v>
                  </c:pt>
                  <c:pt idx="2">
                    <c:v>0.11362465263387762</c:v>
                  </c:pt>
                  <c:pt idx="3">
                    <c:v>2.2661246788843452E-2</c:v>
                  </c:pt>
                  <c:pt idx="4">
                    <c:v>0.10497137210591725</c:v>
                  </c:pt>
                  <c:pt idx="5">
                    <c:v>8.2302068641636528E-2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5:$H$5</c:f>
              <c:numCache>
                <c:formatCode>General</c:formatCode>
                <c:ptCount val="6"/>
                <c:pt idx="0">
                  <c:v>10.747470403333317</c:v>
                </c:pt>
                <c:pt idx="1">
                  <c:v>10.60493424666668</c:v>
                </c:pt>
                <c:pt idx="2">
                  <c:v>11.317549043333345</c:v>
                </c:pt>
                <c:pt idx="3">
                  <c:v>10.969502156666689</c:v>
                </c:pt>
                <c:pt idx="4">
                  <c:v>11.271922833333333</c:v>
                </c:pt>
                <c:pt idx="5">
                  <c:v>11.28814359333333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469376"/>
        <c:axId val="250471168"/>
      </c:scatterChart>
      <c:valAx>
        <c:axId val="25046937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471168"/>
        <c:crosses val="autoZero"/>
        <c:crossBetween val="midCat"/>
        <c:majorUnit val="4"/>
      </c:valAx>
      <c:valAx>
        <c:axId val="2504711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46937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323931600192547"/>
          <c:y val="6.6224602119560147E-2"/>
          <c:w val="0.68166254096766976"/>
          <c:h val="0.8756597287402293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C$1</c:f>
              <c:strCache>
                <c:ptCount val="1"/>
                <c:pt idx="0">
                  <c:v>Bra004507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3!$E$2:$E$8</c:f>
                <c:numCache>
                  <c:formatCode>General</c:formatCode>
                  <c:ptCount val="7"/>
                  <c:pt idx="0">
                    <c:v>1.5793471254522658E-6</c:v>
                  </c:pt>
                  <c:pt idx="1">
                    <c:v>6.8313662547599135E-5</c:v>
                  </c:pt>
                  <c:pt idx="2">
                    <c:v>7.8577428143254462E-7</c:v>
                  </c:pt>
                  <c:pt idx="3">
                    <c:v>1.3485484047032952E-7</c:v>
                  </c:pt>
                  <c:pt idx="4">
                    <c:v>1.9143374159548034E-8</c:v>
                  </c:pt>
                  <c:pt idx="5">
                    <c:v>1.8352532145550736E-8</c:v>
                  </c:pt>
                  <c:pt idx="6">
                    <c:v>3.1122630865282402E-6</c:v>
                  </c:pt>
                </c:numCache>
              </c:numRef>
            </c:plus>
            <c:minus>
              <c:numRef>
                <c:f>Sheet3!$E$2:$E$8</c:f>
                <c:numCache>
                  <c:formatCode>General</c:formatCode>
                  <c:ptCount val="7"/>
                  <c:pt idx="0">
                    <c:v>1.5793471254522658E-6</c:v>
                  </c:pt>
                  <c:pt idx="1">
                    <c:v>6.8313662547599135E-5</c:v>
                  </c:pt>
                  <c:pt idx="2">
                    <c:v>7.8577428143254462E-7</c:v>
                  </c:pt>
                  <c:pt idx="3">
                    <c:v>1.3485484047032952E-7</c:v>
                  </c:pt>
                  <c:pt idx="4">
                    <c:v>1.9143374159548034E-8</c:v>
                  </c:pt>
                  <c:pt idx="5">
                    <c:v>1.8352532145550736E-8</c:v>
                  </c:pt>
                  <c:pt idx="6">
                    <c:v>3.1122630865282402E-6</c:v>
                  </c:pt>
                </c:numCache>
              </c:numRef>
            </c:minus>
          </c:errBars>
          <c:xVal>
            <c:numRef>
              <c:f>Sheet3!$B$2:$B$8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3!$C$2:$C$8</c:f>
              <c:numCache>
                <c:formatCode>General</c:formatCode>
                <c:ptCount val="7"/>
                <c:pt idx="0">
                  <c:v>4.2129429994021972E-6</c:v>
                </c:pt>
                <c:pt idx="1">
                  <c:v>1.9645208046987417E-3</c:v>
                </c:pt>
                <c:pt idx="2">
                  <c:v>2.0634558951611686E-5</c:v>
                </c:pt>
                <c:pt idx="3">
                  <c:v>4.2185113571845194E-7</c:v>
                </c:pt>
                <c:pt idx="4">
                  <c:v>5.3102376701261894E-8</c:v>
                </c:pt>
                <c:pt idx="5">
                  <c:v>5.5918930686851748E-8</c:v>
                </c:pt>
                <c:pt idx="6">
                  <c:v>9.6010884506337142E-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853248"/>
        <c:axId val="252875520"/>
      </c:scatterChart>
      <c:valAx>
        <c:axId val="252853248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875520"/>
        <c:crosses val="autoZero"/>
        <c:crossBetween val="midCat"/>
        <c:majorUnit val="4"/>
      </c:valAx>
      <c:valAx>
        <c:axId val="252875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85324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2217693404436549"/>
          <c:y val="0.16116967207985816"/>
          <c:w val="0.45577690441802765"/>
          <c:h val="0.1384166127135299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996905436433006"/>
          <c:y val="6.195204714410469E-2"/>
          <c:w val="0.75742784945191277"/>
          <c:h val="0.7767458334975935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E$13</c:f>
              <c:strCache>
                <c:ptCount val="1"/>
                <c:pt idx="0">
                  <c:v>Bra009565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G$2:$G$8</c:f>
                <c:numCache>
                  <c:formatCode>General</c:formatCode>
                  <c:ptCount val="7"/>
                  <c:pt idx="0">
                    <c:v>2.0344856021717061E-3</c:v>
                  </c:pt>
                  <c:pt idx="1">
                    <c:v>2.3801968140908996E-2</c:v>
                  </c:pt>
                  <c:pt idx="2">
                    <c:v>2.9585353144933936E-3</c:v>
                  </c:pt>
                  <c:pt idx="3">
                    <c:v>1.5147555186821521E-3</c:v>
                  </c:pt>
                  <c:pt idx="4">
                    <c:v>3.5506973309538486E-4</c:v>
                  </c:pt>
                  <c:pt idx="5">
                    <c:v>3.4748127413076688E-4</c:v>
                  </c:pt>
                  <c:pt idx="6">
                    <c:v>2.5558075143588791E-3</c:v>
                  </c:pt>
                </c:numCache>
              </c:numRef>
            </c:plus>
            <c:minus>
              <c:numRef>
                <c:f>Sheet2!$G$2:$G$8</c:f>
                <c:numCache>
                  <c:formatCode>General</c:formatCode>
                  <c:ptCount val="7"/>
                  <c:pt idx="0">
                    <c:v>2.0344856021717061E-3</c:v>
                  </c:pt>
                  <c:pt idx="1">
                    <c:v>2.3801968140908996E-2</c:v>
                  </c:pt>
                  <c:pt idx="2">
                    <c:v>2.9585353144933936E-3</c:v>
                  </c:pt>
                  <c:pt idx="3">
                    <c:v>1.5147555186821521E-3</c:v>
                  </c:pt>
                  <c:pt idx="4">
                    <c:v>3.5506973309538486E-4</c:v>
                  </c:pt>
                  <c:pt idx="5">
                    <c:v>3.4748127413076688E-4</c:v>
                  </c:pt>
                  <c:pt idx="6">
                    <c:v>2.5558075143588791E-3</c:v>
                  </c:pt>
                </c:numCache>
              </c:numRef>
            </c:minus>
          </c:errBars>
          <c:xVal>
            <c:numRef>
              <c:f>Sheet2!$D$14:$D$20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4:$E$20</c:f>
              <c:numCache>
                <c:formatCode>General</c:formatCode>
                <c:ptCount val="7"/>
                <c:pt idx="0">
                  <c:v>8.7663140024145086E-3</c:v>
                </c:pt>
                <c:pt idx="1">
                  <c:v>0.12943662174740356</c:v>
                </c:pt>
                <c:pt idx="2">
                  <c:v>4.3595631739111997E-2</c:v>
                </c:pt>
                <c:pt idx="3">
                  <c:v>1.4736508414399141E-2</c:v>
                </c:pt>
                <c:pt idx="4">
                  <c:v>1.7994066315139634E-3</c:v>
                </c:pt>
                <c:pt idx="5">
                  <c:v>2.9779265802999085E-3</c:v>
                </c:pt>
                <c:pt idx="6">
                  <c:v>1.9730117170833398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F$13</c:f>
              <c:strCache>
                <c:ptCount val="1"/>
                <c:pt idx="0">
                  <c:v>Bra028861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N$2:$N$8</c:f>
                <c:numCache>
                  <c:formatCode>General</c:formatCode>
                  <c:ptCount val="7"/>
                  <c:pt idx="0">
                    <c:v>9.3897986641881123E-5</c:v>
                  </c:pt>
                  <c:pt idx="1">
                    <c:v>1.6090003740467207E-3</c:v>
                  </c:pt>
                  <c:pt idx="2">
                    <c:v>2.7473718261148321E-3</c:v>
                  </c:pt>
                  <c:pt idx="3">
                    <c:v>2.0668356136742702E-3</c:v>
                  </c:pt>
                  <c:pt idx="4">
                    <c:v>4.6818638015938525E-4</c:v>
                  </c:pt>
                  <c:pt idx="5">
                    <c:v>2.5584755811778779E-4</c:v>
                  </c:pt>
                  <c:pt idx="6">
                    <c:v>2.3074106415546237E-4</c:v>
                  </c:pt>
                </c:numCache>
              </c:numRef>
            </c:plus>
            <c:minus>
              <c:numRef>
                <c:f>Sheet2!$N$2:$N$8</c:f>
                <c:numCache>
                  <c:formatCode>General</c:formatCode>
                  <c:ptCount val="7"/>
                  <c:pt idx="0">
                    <c:v>9.3897986641881123E-5</c:v>
                  </c:pt>
                  <c:pt idx="1">
                    <c:v>1.6090003740467207E-3</c:v>
                  </c:pt>
                  <c:pt idx="2">
                    <c:v>2.7473718261148321E-3</c:v>
                  </c:pt>
                  <c:pt idx="3">
                    <c:v>2.0668356136742702E-3</c:v>
                  </c:pt>
                  <c:pt idx="4">
                    <c:v>4.6818638015938525E-4</c:v>
                  </c:pt>
                  <c:pt idx="5">
                    <c:v>2.5584755811778779E-4</c:v>
                  </c:pt>
                  <c:pt idx="6">
                    <c:v>2.3074106415546237E-4</c:v>
                  </c:pt>
                </c:numCache>
              </c:numRef>
            </c:minus>
          </c:errBars>
          <c:xVal>
            <c:numRef>
              <c:f>Sheet2!$D$14:$D$20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F$14:$F$20</c:f>
              <c:numCache>
                <c:formatCode>General</c:formatCode>
                <c:ptCount val="7"/>
                <c:pt idx="0">
                  <c:v>3.387716255169995E-4</c:v>
                </c:pt>
                <c:pt idx="1">
                  <c:v>2.8513651181964497E-2</c:v>
                </c:pt>
                <c:pt idx="2">
                  <c:v>3.9476832178932414E-2</c:v>
                </c:pt>
                <c:pt idx="3">
                  <c:v>1.7773105004731629E-2</c:v>
                </c:pt>
                <c:pt idx="4">
                  <c:v>2.1490695139960536E-3</c:v>
                </c:pt>
                <c:pt idx="5">
                  <c:v>1.578277824282979E-3</c:v>
                </c:pt>
                <c:pt idx="6">
                  <c:v>2.8251431062704985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901248"/>
        <c:axId val="252902784"/>
      </c:scatterChart>
      <c:valAx>
        <c:axId val="252901248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902784"/>
        <c:crosses val="autoZero"/>
        <c:crossBetween val="midCat"/>
        <c:majorUnit val="4"/>
      </c:valAx>
      <c:valAx>
        <c:axId val="252902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90124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1645647590082618"/>
          <c:y val="0.19435594372429349"/>
          <c:w val="0.47882425679554147"/>
          <c:h val="0.1921739878364769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436351706036745"/>
          <c:y val="2.8252405949256338E-2"/>
          <c:w val="0.85340726159230051"/>
          <c:h val="0.7752758654056363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C$10</c:f>
              <c:strCache>
                <c:ptCount val="1"/>
                <c:pt idx="0">
                  <c:v>Bra009768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F$11:$F$17</c:f>
                <c:numCache>
                  <c:formatCode>General</c:formatCode>
                  <c:ptCount val="7"/>
                  <c:pt idx="0">
                    <c:v>7.5519206036473092E-4</c:v>
                  </c:pt>
                  <c:pt idx="1">
                    <c:v>2.5342544284370156E-3</c:v>
                  </c:pt>
                  <c:pt idx="2">
                    <c:v>7.4088835512589584E-3</c:v>
                  </c:pt>
                  <c:pt idx="3">
                    <c:v>8.4476607734993456E-4</c:v>
                  </c:pt>
                  <c:pt idx="4">
                    <c:v>2.536626593193548E-5</c:v>
                  </c:pt>
                  <c:pt idx="5">
                    <c:v>1.9581589177589262E-5</c:v>
                  </c:pt>
                  <c:pt idx="6">
                    <c:v>1.1391188459723521E-2</c:v>
                  </c:pt>
                </c:numCache>
              </c:numRef>
            </c:plus>
            <c:minus>
              <c:numRef>
                <c:f>Sheet2!$F$11:$F$17</c:f>
                <c:numCache>
                  <c:formatCode>General</c:formatCode>
                  <c:ptCount val="7"/>
                  <c:pt idx="0">
                    <c:v>7.5519206036473092E-4</c:v>
                  </c:pt>
                  <c:pt idx="1">
                    <c:v>2.5342544284370156E-3</c:v>
                  </c:pt>
                  <c:pt idx="2">
                    <c:v>7.4088835512589584E-3</c:v>
                  </c:pt>
                  <c:pt idx="3">
                    <c:v>8.4476607734993456E-4</c:v>
                  </c:pt>
                  <c:pt idx="4">
                    <c:v>2.536626593193548E-5</c:v>
                  </c:pt>
                  <c:pt idx="5">
                    <c:v>1.9581589177589262E-5</c:v>
                  </c:pt>
                  <c:pt idx="6">
                    <c:v>1.1391188459723521E-2</c:v>
                  </c:pt>
                </c:numCache>
              </c:numRef>
            </c:minus>
          </c:errBars>
          <c:xVal>
            <c:numRef>
              <c:f>Sheet2!$B$11:$B$17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C$11:$C$17</c:f>
              <c:numCache>
                <c:formatCode>General</c:formatCode>
                <c:ptCount val="7"/>
                <c:pt idx="0">
                  <c:v>5.6309425882473934E-3</c:v>
                </c:pt>
                <c:pt idx="1">
                  <c:v>4.6418117325610901E-2</c:v>
                </c:pt>
                <c:pt idx="2">
                  <c:v>0.23028114637403421</c:v>
                </c:pt>
                <c:pt idx="3">
                  <c:v>3.6840017871685393E-2</c:v>
                </c:pt>
                <c:pt idx="4">
                  <c:v>3.0141603918580791E-4</c:v>
                </c:pt>
                <c:pt idx="5">
                  <c:v>1.5069115373040045E-4</c:v>
                </c:pt>
                <c:pt idx="6">
                  <c:v>1.9730117170833401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D$10</c:f>
              <c:strCache>
                <c:ptCount val="1"/>
                <c:pt idx="0">
                  <c:v>Bra029407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G$11:$G$17</c:f>
                <c:numCache>
                  <c:formatCode>General</c:formatCode>
                  <c:ptCount val="7"/>
                  <c:pt idx="0">
                    <c:v>9.7224641112469156E-6</c:v>
                  </c:pt>
                  <c:pt idx="1">
                    <c:v>6.4366593706156232E-4</c:v>
                  </c:pt>
                  <c:pt idx="2">
                    <c:v>9.3380664121119096E-3</c:v>
                  </c:pt>
                  <c:pt idx="3">
                    <c:v>2.8159033571870405E-4</c:v>
                  </c:pt>
                  <c:pt idx="4">
                    <c:v>4.9515302309740921E-4</c:v>
                  </c:pt>
                  <c:pt idx="5">
                    <c:v>4.2668629455083648E-4</c:v>
                  </c:pt>
                  <c:pt idx="6">
                    <c:v>6.5767057236111393E-3</c:v>
                  </c:pt>
                </c:numCache>
              </c:numRef>
            </c:plus>
            <c:minus>
              <c:numRef>
                <c:f>Sheet2!$G$11:$G$17</c:f>
                <c:numCache>
                  <c:formatCode>General</c:formatCode>
                  <c:ptCount val="7"/>
                  <c:pt idx="0">
                    <c:v>9.7224641112469156E-6</c:v>
                  </c:pt>
                  <c:pt idx="1">
                    <c:v>6.4366593706156232E-4</c:v>
                  </c:pt>
                  <c:pt idx="2">
                    <c:v>9.3380664121119096E-3</c:v>
                  </c:pt>
                  <c:pt idx="3">
                    <c:v>2.8159033571870405E-4</c:v>
                  </c:pt>
                  <c:pt idx="4">
                    <c:v>4.9515302309740921E-4</c:v>
                  </c:pt>
                  <c:pt idx="5">
                    <c:v>4.2668629455083648E-4</c:v>
                  </c:pt>
                  <c:pt idx="6">
                    <c:v>6.5767057236111393E-3</c:v>
                  </c:pt>
                </c:numCache>
              </c:numRef>
            </c:minus>
          </c:errBars>
          <c:xVal>
            <c:numRef>
              <c:f>Sheet2!$B$11:$B$17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D$11:$D$17</c:f>
              <c:numCache>
                <c:formatCode>General</c:formatCode>
                <c:ptCount val="7"/>
                <c:pt idx="0">
                  <c:v>1.7559873298072688E-4</c:v>
                </c:pt>
                <c:pt idx="1">
                  <c:v>5.065627637348206E-3</c:v>
                </c:pt>
                <c:pt idx="2">
                  <c:v>7.57626426090591E-2</c:v>
                </c:pt>
                <c:pt idx="3">
                  <c:v>8.2107870712294171E-3</c:v>
                </c:pt>
                <c:pt idx="4">
                  <c:v>3.4953541444825917E-3</c:v>
                </c:pt>
                <c:pt idx="5">
                  <c:v>3.3369946526278452E-3</c:v>
                </c:pt>
                <c:pt idx="6">
                  <c:v>1.9730117170833401E-2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2!$E$10</c:f>
              <c:strCache>
                <c:ptCount val="1"/>
                <c:pt idx="0">
                  <c:v>Bra036517</c:v>
                </c:pt>
              </c:strCache>
            </c:strRef>
          </c:tx>
          <c:spPr>
            <a:ln w="165100"/>
          </c:spPr>
          <c:errBars>
            <c:errDir val="y"/>
            <c:errBarType val="both"/>
            <c:errValType val="cust"/>
            <c:noEndCap val="0"/>
            <c:plus>
              <c:numRef>
                <c:f>Sheet2!$H$11:$H$17</c:f>
                <c:numCache>
                  <c:formatCode>General</c:formatCode>
                  <c:ptCount val="7"/>
                  <c:pt idx="0">
                    <c:v>1.3665418335679625E-6</c:v>
                  </c:pt>
                  <c:pt idx="1">
                    <c:v>3.1684823215956655E-5</c:v>
                  </c:pt>
                  <c:pt idx="2">
                    <c:v>4.6330908233720093E-4</c:v>
                  </c:pt>
                  <c:pt idx="3">
                    <c:v>2.5687637497168821E-6</c:v>
                  </c:pt>
                  <c:pt idx="4">
                    <c:v>2.3411169036632284E-7</c:v>
                  </c:pt>
                  <c:pt idx="5">
                    <c:v>1.6535392624648043E-6</c:v>
                  </c:pt>
                  <c:pt idx="6">
                    <c:v>3.7970628199078412E-3</c:v>
                  </c:pt>
                </c:numCache>
              </c:numRef>
            </c:plus>
            <c:minus>
              <c:numRef>
                <c:f>Sheet2!$H$11:$H$17</c:f>
                <c:numCache>
                  <c:formatCode>General</c:formatCode>
                  <c:ptCount val="7"/>
                  <c:pt idx="0">
                    <c:v>1.3665418335679625E-6</c:v>
                  </c:pt>
                  <c:pt idx="1">
                    <c:v>3.1684823215956655E-5</c:v>
                  </c:pt>
                  <c:pt idx="2">
                    <c:v>4.6330908233720093E-4</c:v>
                  </c:pt>
                  <c:pt idx="3">
                    <c:v>2.5687637497168821E-6</c:v>
                  </c:pt>
                  <c:pt idx="4">
                    <c:v>2.3411169036632284E-7</c:v>
                  </c:pt>
                  <c:pt idx="5">
                    <c:v>1.6535392624648043E-6</c:v>
                  </c:pt>
                  <c:pt idx="6">
                    <c:v>3.7970628199078412E-3</c:v>
                  </c:pt>
                </c:numCache>
              </c:numRef>
            </c:minus>
          </c:errBars>
          <c:xVal>
            <c:numRef>
              <c:f>Sheet2!$B$11:$B$17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1:$E$17</c:f>
              <c:numCache>
                <c:formatCode>General</c:formatCode>
                <c:ptCount val="7"/>
                <c:pt idx="0">
                  <c:v>1.41976028573368E-5</c:v>
                </c:pt>
                <c:pt idx="1">
                  <c:v>1.9707465952467724E-4</c:v>
                </c:pt>
                <c:pt idx="2">
                  <c:v>2.5438781825661543E-3</c:v>
                </c:pt>
                <c:pt idx="3">
                  <c:v>4.6932495798476666E-5</c:v>
                </c:pt>
                <c:pt idx="4">
                  <c:v>4.7295857325741612E-6</c:v>
                </c:pt>
                <c:pt idx="5">
                  <c:v>1.1341292811155836E-5</c:v>
                </c:pt>
                <c:pt idx="6">
                  <c:v>1.9730117170833401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942208"/>
        <c:axId val="252943744"/>
      </c:scatterChart>
      <c:valAx>
        <c:axId val="252942208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943744"/>
        <c:crosses val="autoZero"/>
        <c:crossBetween val="midCat"/>
        <c:majorUnit val="4"/>
      </c:valAx>
      <c:valAx>
        <c:axId val="252943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94220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3066456157649167"/>
          <c:y val="1.1586824880867484E-2"/>
          <c:w val="0.44660127462689325"/>
          <c:h val="0.3554560245994174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392325004473899"/>
          <c:y val="7.454870224555267E-2"/>
          <c:w val="0.87015206893179531"/>
          <c:h val="0.8326195683872849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H$24:$H$29</c:f>
                <c:numCache>
                  <c:formatCode>General</c:formatCode>
                  <c:ptCount val="6"/>
                  <c:pt idx="0">
                    <c:v>1.1627966910328666E-3</c:v>
                  </c:pt>
                  <c:pt idx="1">
                    <c:v>9.0675185627737596E-4</c:v>
                  </c:pt>
                  <c:pt idx="2">
                    <c:v>3.8174051625692236E-3</c:v>
                  </c:pt>
                  <c:pt idx="3">
                    <c:v>2.8750386730525775E-3</c:v>
                  </c:pt>
                  <c:pt idx="4">
                    <c:v>3.2111149647508887E-3</c:v>
                  </c:pt>
                  <c:pt idx="5">
                    <c:v>1.6937516763737464E-3</c:v>
                  </c:pt>
                </c:numCache>
              </c:numRef>
            </c:plus>
            <c:minus>
              <c:numRef>
                <c:f>Sheet4!$H$24:$H$29</c:f>
                <c:numCache>
                  <c:formatCode>General</c:formatCode>
                  <c:ptCount val="6"/>
                  <c:pt idx="0">
                    <c:v>1.1627966910328666E-3</c:v>
                  </c:pt>
                  <c:pt idx="1">
                    <c:v>9.0675185627737596E-4</c:v>
                  </c:pt>
                  <c:pt idx="2">
                    <c:v>3.8174051625692236E-3</c:v>
                  </c:pt>
                  <c:pt idx="3">
                    <c:v>2.8750386730525775E-3</c:v>
                  </c:pt>
                  <c:pt idx="4">
                    <c:v>3.2111149647508887E-3</c:v>
                  </c:pt>
                  <c:pt idx="5">
                    <c:v>1.6937516763737464E-3</c:v>
                  </c:pt>
                </c:numCache>
              </c:numRef>
            </c:minus>
          </c:errBars>
          <c:xVal>
            <c:numRef>
              <c:f>Sheet4!$E$24:$E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F$24:$F$29</c:f>
              <c:numCache>
                <c:formatCode>General</c:formatCode>
                <c:ptCount val="6"/>
                <c:pt idx="0">
                  <c:v>1.4279485363329686E-2</c:v>
                </c:pt>
                <c:pt idx="1">
                  <c:v>1.0551164180697375E-2</c:v>
                </c:pt>
                <c:pt idx="2">
                  <c:v>2.2829564817775292E-2</c:v>
                </c:pt>
                <c:pt idx="3">
                  <c:v>2.1895820498872294E-2</c:v>
                </c:pt>
                <c:pt idx="4">
                  <c:v>1.7020864844892309E-2</c:v>
                </c:pt>
                <c:pt idx="5">
                  <c:v>2.8330953663264602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972032"/>
        <c:axId val="252998400"/>
      </c:scatterChart>
      <c:valAx>
        <c:axId val="25297203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998400"/>
        <c:crosses val="autoZero"/>
        <c:crossBetween val="midCat"/>
        <c:majorUnit val="4"/>
      </c:valAx>
      <c:valAx>
        <c:axId val="252998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9720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6905899344517284E-2"/>
          <c:y val="6.7414176202644144E-2"/>
          <c:w val="0.93185948558268361"/>
          <c:h val="0.72316483353701533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H$5:$H$22</c:f>
                <c:numCache>
                  <c:formatCode>General</c:formatCode>
                  <c:ptCount val="18"/>
                  <c:pt idx="0">
                    <c:v>8.1628693682346248E-3</c:v>
                  </c:pt>
                  <c:pt idx="1">
                    <c:v>3.4736318106038415E-3</c:v>
                  </c:pt>
                  <c:pt idx="2">
                    <c:v>2.0905523093928756E-4</c:v>
                  </c:pt>
                  <c:pt idx="3">
                    <c:v>2.6275296493717492E-4</c:v>
                  </c:pt>
                  <c:pt idx="4">
                    <c:v>2.4154208821017397E-4</c:v>
                  </c:pt>
                  <c:pt idx="5">
                    <c:v>2.0202451179667236E-3</c:v>
                  </c:pt>
                  <c:pt idx="6">
                    <c:v>5.6921383479381562E-4</c:v>
                  </c:pt>
                  <c:pt idx="7">
                    <c:v>1.6231728788048206E-3</c:v>
                  </c:pt>
                  <c:pt idx="8">
                    <c:v>4.7089947102315734E-3</c:v>
                  </c:pt>
                  <c:pt idx="9">
                    <c:v>1.5033685499956961E-3</c:v>
                  </c:pt>
                  <c:pt idx="10">
                    <c:v>5.2111440772440083E-4</c:v>
                  </c:pt>
                  <c:pt idx="11">
                    <c:v>8.1003883673341033E-4</c:v>
                  </c:pt>
                  <c:pt idx="12">
                    <c:v>1.302133916236452E-3</c:v>
                  </c:pt>
                  <c:pt idx="13">
                    <c:v>2.9712303687666627E-3</c:v>
                  </c:pt>
                  <c:pt idx="14">
                    <c:v>9.5018828109007351E-3</c:v>
                  </c:pt>
                  <c:pt idx="15">
                    <c:v>4.7561516960294391E-3</c:v>
                  </c:pt>
                  <c:pt idx="16">
                    <c:v>3.4088720546501892E-3</c:v>
                  </c:pt>
                  <c:pt idx="17">
                    <c:v>2.6722978118887256E-3</c:v>
                  </c:pt>
                </c:numCache>
              </c:numRef>
            </c:plus>
            <c:minus>
              <c:numRef>
                <c:f>Sheet4!$H$5:$H$22</c:f>
                <c:numCache>
                  <c:formatCode>General</c:formatCode>
                  <c:ptCount val="18"/>
                  <c:pt idx="0">
                    <c:v>8.1628693682346248E-3</c:v>
                  </c:pt>
                  <c:pt idx="1">
                    <c:v>3.4736318106038415E-3</c:v>
                  </c:pt>
                  <c:pt idx="2">
                    <c:v>2.0905523093928756E-4</c:v>
                  </c:pt>
                  <c:pt idx="3">
                    <c:v>2.6275296493717492E-4</c:v>
                  </c:pt>
                  <c:pt idx="4">
                    <c:v>2.4154208821017397E-4</c:v>
                  </c:pt>
                  <c:pt idx="5">
                    <c:v>2.0202451179667236E-3</c:v>
                  </c:pt>
                  <c:pt idx="6">
                    <c:v>5.6921383479381562E-4</c:v>
                  </c:pt>
                  <c:pt idx="7">
                    <c:v>1.6231728788048206E-3</c:v>
                  </c:pt>
                  <c:pt idx="8">
                    <c:v>4.7089947102315734E-3</c:v>
                  </c:pt>
                  <c:pt idx="9">
                    <c:v>1.5033685499956961E-3</c:v>
                  </c:pt>
                  <c:pt idx="10">
                    <c:v>5.2111440772440083E-4</c:v>
                  </c:pt>
                  <c:pt idx="11">
                    <c:v>8.1003883673341033E-4</c:v>
                  </c:pt>
                  <c:pt idx="12">
                    <c:v>1.302133916236452E-3</c:v>
                  </c:pt>
                  <c:pt idx="13">
                    <c:v>2.9712303687666627E-3</c:v>
                  </c:pt>
                  <c:pt idx="14">
                    <c:v>9.5018828109007351E-3</c:v>
                  </c:pt>
                  <c:pt idx="15">
                    <c:v>4.7561516960294391E-3</c:v>
                  </c:pt>
                  <c:pt idx="16">
                    <c:v>3.4088720546501892E-3</c:v>
                  </c:pt>
                  <c:pt idx="17">
                    <c:v>2.6722978118887256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E$5:$E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F$5:$F$22</c:f>
              <c:numCache>
                <c:formatCode>General</c:formatCode>
                <c:ptCount val="18"/>
                <c:pt idx="0">
                  <c:v>4.2939212284319461E-2</c:v>
                </c:pt>
                <c:pt idx="1">
                  <c:v>2.0244273669381412E-2</c:v>
                </c:pt>
                <c:pt idx="2">
                  <c:v>2.5017352492186402E-3</c:v>
                </c:pt>
                <c:pt idx="3">
                  <c:v>1.3612611943645257E-3</c:v>
                </c:pt>
                <c:pt idx="4">
                  <c:v>1.0184113725966761E-3</c:v>
                </c:pt>
                <c:pt idx="5">
                  <c:v>4.8127767230289878E-3</c:v>
                </c:pt>
                <c:pt idx="6">
                  <c:v>3.8513126404393612E-3</c:v>
                </c:pt>
                <c:pt idx="7">
                  <c:v>4.3321033231572314E-3</c:v>
                </c:pt>
                <c:pt idx="8">
                  <c:v>1.5871931946592591E-2</c:v>
                </c:pt>
                <c:pt idx="9">
                  <c:v>4.8604056798425667E-3</c:v>
                </c:pt>
                <c:pt idx="10">
                  <c:v>1.7789305839984147E-3</c:v>
                </c:pt>
                <c:pt idx="11">
                  <c:v>2.0714277360639392E-3</c:v>
                </c:pt>
                <c:pt idx="12">
                  <c:v>3.1959867726898687E-3</c:v>
                </c:pt>
                <c:pt idx="13">
                  <c:v>1.311677306541543E-2</c:v>
                </c:pt>
                <c:pt idx="14">
                  <c:v>1.1183820687458684E-2</c:v>
                </c:pt>
                <c:pt idx="15">
                  <c:v>5.8975924860770104E-3</c:v>
                </c:pt>
                <c:pt idx="16">
                  <c:v>5.7426179984161824E-3</c:v>
                </c:pt>
                <c:pt idx="17">
                  <c:v>5.0043700142942257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035264"/>
        <c:axId val="253036800"/>
      </c:scatterChart>
      <c:valAx>
        <c:axId val="25303526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036800"/>
        <c:crosses val="autoZero"/>
        <c:crossBetween val="midCat"/>
        <c:majorUnit val="4"/>
      </c:valAx>
      <c:valAx>
        <c:axId val="253036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03526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2.8952730588891612E-3</c:v>
                  </c:pt>
                  <c:pt idx="1">
                    <c:v>3.996813385623228E-4</c:v>
                  </c:pt>
                  <c:pt idx="2">
                    <c:v>2.1988970775089598E-3</c:v>
                  </c:pt>
                  <c:pt idx="3">
                    <c:v>1.8148528442427736E-3</c:v>
                  </c:pt>
                  <c:pt idx="4">
                    <c:v>1.7037588808896601E-3</c:v>
                  </c:pt>
                  <c:pt idx="5">
                    <c:v>4.132010654658195E-3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2.8952730588891612E-3</c:v>
                  </c:pt>
                  <c:pt idx="1">
                    <c:v>3.996813385623228E-4</c:v>
                  </c:pt>
                  <c:pt idx="2">
                    <c:v>2.1988970775089598E-3</c:v>
                  </c:pt>
                  <c:pt idx="3">
                    <c:v>1.8148528442427736E-3</c:v>
                  </c:pt>
                  <c:pt idx="4">
                    <c:v>1.7037588808896601E-3</c:v>
                  </c:pt>
                  <c:pt idx="5">
                    <c:v>4.132010654658195E-3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1.7117238397563173E-2</c:v>
                </c:pt>
                <c:pt idx="1">
                  <c:v>4.4634370063494294E-3</c:v>
                </c:pt>
                <c:pt idx="2">
                  <c:v>3.8071474309780411E-2</c:v>
                </c:pt>
                <c:pt idx="3">
                  <c:v>7.6634184172008082E-2</c:v>
                </c:pt>
                <c:pt idx="4">
                  <c:v>1.096464722345898E-2</c:v>
                </c:pt>
                <c:pt idx="5">
                  <c:v>1.8517997826778359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060992"/>
        <c:axId val="253062528"/>
      </c:scatterChart>
      <c:valAx>
        <c:axId val="25306099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062528"/>
        <c:crosses val="autoZero"/>
        <c:crossBetween val="midCat"/>
        <c:majorUnit val="4"/>
      </c:valAx>
      <c:valAx>
        <c:axId val="253062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06099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5.5076694661817163E-3</c:v>
                  </c:pt>
                  <c:pt idx="1">
                    <c:v>8.827633446169017E-4</c:v>
                  </c:pt>
                  <c:pt idx="2">
                    <c:v>5.1103961238096953E-4</c:v>
                  </c:pt>
                  <c:pt idx="3">
                    <c:v>2.3101009715139299E-3</c:v>
                  </c:pt>
                  <c:pt idx="4">
                    <c:v>1.7996734631957427E-3</c:v>
                  </c:pt>
                  <c:pt idx="5">
                    <c:v>6.300137990913273E-4</c:v>
                  </c:pt>
                  <c:pt idx="6">
                    <c:v>2.063015452553382E-3</c:v>
                  </c:pt>
                  <c:pt idx="7">
                    <c:v>3.0914381788959169E-3</c:v>
                  </c:pt>
                  <c:pt idx="8">
                    <c:v>2.8788445246050575E-3</c:v>
                  </c:pt>
                  <c:pt idx="9">
                    <c:v>2.1957867656574701E-3</c:v>
                  </c:pt>
                  <c:pt idx="10">
                    <c:v>2.1979736069871266E-3</c:v>
                  </c:pt>
                  <c:pt idx="11">
                    <c:v>2.0137832198891055E-3</c:v>
                  </c:pt>
                  <c:pt idx="12">
                    <c:v>1.8138653924849538E-3</c:v>
                  </c:pt>
                  <c:pt idx="13">
                    <c:v>1.3486091516817314E-3</c:v>
                  </c:pt>
                  <c:pt idx="14">
                    <c:v>1.8376215161838621E-3</c:v>
                  </c:pt>
                  <c:pt idx="15">
                    <c:v>6.8616240345002934E-3</c:v>
                  </c:pt>
                  <c:pt idx="16">
                    <c:v>1.275581816935192E-3</c:v>
                  </c:pt>
                  <c:pt idx="17">
                    <c:v>4.1866603946032568E-4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5.5076694661817163E-3</c:v>
                  </c:pt>
                  <c:pt idx="1">
                    <c:v>8.827633446169017E-4</c:v>
                  </c:pt>
                  <c:pt idx="2">
                    <c:v>5.1103961238096953E-4</c:v>
                  </c:pt>
                  <c:pt idx="3">
                    <c:v>2.3101009715139299E-3</c:v>
                  </c:pt>
                  <c:pt idx="4">
                    <c:v>1.7996734631957427E-3</c:v>
                  </c:pt>
                  <c:pt idx="5">
                    <c:v>6.300137990913273E-4</c:v>
                  </c:pt>
                  <c:pt idx="6">
                    <c:v>2.063015452553382E-3</c:v>
                  </c:pt>
                  <c:pt idx="7">
                    <c:v>3.0914381788959169E-3</c:v>
                  </c:pt>
                  <c:pt idx="8">
                    <c:v>2.8788445246050575E-3</c:v>
                  </c:pt>
                  <c:pt idx="9">
                    <c:v>2.1957867656574701E-3</c:v>
                  </c:pt>
                  <c:pt idx="10">
                    <c:v>2.1979736069871266E-3</c:v>
                  </c:pt>
                  <c:pt idx="11">
                    <c:v>2.0137832198891055E-3</c:v>
                  </c:pt>
                  <c:pt idx="12">
                    <c:v>1.8138653924849538E-3</c:v>
                  </c:pt>
                  <c:pt idx="13">
                    <c:v>1.3486091516817314E-3</c:v>
                  </c:pt>
                  <c:pt idx="14">
                    <c:v>1.8376215161838621E-3</c:v>
                  </c:pt>
                  <c:pt idx="15">
                    <c:v>6.8616240345002934E-3</c:v>
                  </c:pt>
                  <c:pt idx="16">
                    <c:v>1.275581816935192E-3</c:v>
                  </c:pt>
                  <c:pt idx="17">
                    <c:v>4.1866603946032568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2.3761557225330961E-2</c:v>
                </c:pt>
                <c:pt idx="1">
                  <c:v>1.8369247998698022E-2</c:v>
                </c:pt>
                <c:pt idx="2">
                  <c:v>9.8473036456825092E-3</c:v>
                </c:pt>
                <c:pt idx="3">
                  <c:v>1.9513905165363148E-2</c:v>
                </c:pt>
                <c:pt idx="4">
                  <c:v>1.020059320854424E-2</c:v>
                </c:pt>
                <c:pt idx="5">
                  <c:v>7.4933364196805878E-3</c:v>
                </c:pt>
                <c:pt idx="6">
                  <c:v>1.433137036232926E-2</c:v>
                </c:pt>
                <c:pt idx="7">
                  <c:v>1.8694019538595209E-2</c:v>
                </c:pt>
                <c:pt idx="8">
                  <c:v>5.6213650970801193E-2</c:v>
                </c:pt>
                <c:pt idx="9">
                  <c:v>1.5496145037458523E-2</c:v>
                </c:pt>
                <c:pt idx="10">
                  <c:v>9.7875551587374068E-3</c:v>
                </c:pt>
                <c:pt idx="11">
                  <c:v>1.203991172584461E-2</c:v>
                </c:pt>
                <c:pt idx="12">
                  <c:v>1.2783673003650287E-2</c:v>
                </c:pt>
                <c:pt idx="13">
                  <c:v>2.5050652148542789E-2</c:v>
                </c:pt>
                <c:pt idx="14">
                  <c:v>4.5719165129690167E-2</c:v>
                </c:pt>
                <c:pt idx="15">
                  <c:v>1.7317271563793136E-2</c:v>
                </c:pt>
                <c:pt idx="16">
                  <c:v>1.6685467824643942E-2</c:v>
                </c:pt>
                <c:pt idx="17">
                  <c:v>2.2310191195874293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074816"/>
        <c:axId val="253088896"/>
      </c:scatterChart>
      <c:valAx>
        <c:axId val="25307481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088896"/>
        <c:crosses val="autoZero"/>
        <c:crossBetween val="midCat"/>
        <c:majorUnit val="4"/>
      </c:valAx>
      <c:valAx>
        <c:axId val="253088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07481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813132837520301"/>
          <c:y val="7.3865902364124783E-2"/>
          <c:w val="0.83684311248653975"/>
          <c:h val="0.73381233993943651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9.7071919251941504E-6</c:v>
                  </c:pt>
                  <c:pt idx="1">
                    <c:v>3.8784911215196053E-6</c:v>
                  </c:pt>
                  <c:pt idx="2">
                    <c:v>2.1149551722205411E-5</c:v>
                  </c:pt>
                  <c:pt idx="3">
                    <c:v>1.6512174900055746E-5</c:v>
                  </c:pt>
                  <c:pt idx="4">
                    <c:v>3.0990148012436915E-5</c:v>
                  </c:pt>
                  <c:pt idx="5">
                    <c:v>6.7074378253229057E-6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9.7071919251941504E-6</c:v>
                  </c:pt>
                  <c:pt idx="1">
                    <c:v>3.8784911215196053E-6</c:v>
                  </c:pt>
                  <c:pt idx="2">
                    <c:v>2.1149551722205411E-5</c:v>
                  </c:pt>
                  <c:pt idx="3">
                    <c:v>1.6512174900055746E-5</c:v>
                  </c:pt>
                  <c:pt idx="4">
                    <c:v>3.0990148012436915E-5</c:v>
                  </c:pt>
                  <c:pt idx="5">
                    <c:v>6.7074378253229057E-6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7.7530532957754397E-5</c:v>
                </c:pt>
                <c:pt idx="1">
                  <c:v>4.0101912230229893E-5</c:v>
                </c:pt>
                <c:pt idx="2">
                  <c:v>3.2358066386454598E-4</c:v>
                </c:pt>
                <c:pt idx="3">
                  <c:v>3.2599310973803746E-4</c:v>
                </c:pt>
                <c:pt idx="4">
                  <c:v>1.2609657224025601E-4</c:v>
                </c:pt>
                <c:pt idx="5">
                  <c:v>1.1119658391096901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121280"/>
        <c:axId val="253122816"/>
      </c:scatterChart>
      <c:valAx>
        <c:axId val="25312128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122816"/>
        <c:crosses val="autoZero"/>
        <c:crossBetween val="midCat"/>
        <c:majorUnit val="4"/>
      </c:valAx>
      <c:valAx>
        <c:axId val="2531228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12128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4585729213270604E-2"/>
          <c:y val="7.940622037666821E-2"/>
          <c:w val="0.92371313097343544"/>
          <c:h val="0.73035535734124779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8.0530188643696431E-6</c:v>
                  </c:pt>
                  <c:pt idx="1">
                    <c:v>2.2389991230324467E-5</c:v>
                  </c:pt>
                  <c:pt idx="2">
                    <c:v>7.6005435259341388E-5</c:v>
                  </c:pt>
                  <c:pt idx="3">
                    <c:v>1.0703589731240768E-4</c:v>
                  </c:pt>
                  <c:pt idx="4">
                    <c:v>1.9903627715670135E-5</c:v>
                  </c:pt>
                  <c:pt idx="5">
                    <c:v>1.41895093539323E-5</c:v>
                  </c:pt>
                  <c:pt idx="6">
                    <c:v>6.1100611610863442E-6</c:v>
                  </c:pt>
                  <c:pt idx="7">
                    <c:v>2.3132153525213008E-5</c:v>
                  </c:pt>
                  <c:pt idx="8">
                    <c:v>1.916493402158556E-5</c:v>
                  </c:pt>
                  <c:pt idx="9">
                    <c:v>3.5489234645694698E-5</c:v>
                  </c:pt>
                  <c:pt idx="10">
                    <c:v>5.0380040095853533E-5</c:v>
                  </c:pt>
                  <c:pt idx="11">
                    <c:v>6.8987394231370038E-5</c:v>
                  </c:pt>
                  <c:pt idx="12">
                    <c:v>1.5726718786312834E-5</c:v>
                  </c:pt>
                  <c:pt idx="13">
                    <c:v>3.0689771629527144E-5</c:v>
                  </c:pt>
                  <c:pt idx="14">
                    <c:v>8.5659497271437922E-5</c:v>
                  </c:pt>
                  <c:pt idx="15">
                    <c:v>8.9197469993951343E-5</c:v>
                  </c:pt>
                  <c:pt idx="16">
                    <c:v>7.6787422231268875E-6</c:v>
                  </c:pt>
                  <c:pt idx="17">
                    <c:v>2.547548382896173E-5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8.0530188643696431E-6</c:v>
                  </c:pt>
                  <c:pt idx="1">
                    <c:v>2.2389991230324467E-5</c:v>
                  </c:pt>
                  <c:pt idx="2">
                    <c:v>7.6005435259341388E-5</c:v>
                  </c:pt>
                  <c:pt idx="3">
                    <c:v>1.0703589731240768E-4</c:v>
                  </c:pt>
                  <c:pt idx="4">
                    <c:v>1.9903627715670135E-5</c:v>
                  </c:pt>
                  <c:pt idx="5">
                    <c:v>1.41895093539323E-5</c:v>
                  </c:pt>
                  <c:pt idx="6">
                    <c:v>6.1100611610863442E-6</c:v>
                  </c:pt>
                  <c:pt idx="7">
                    <c:v>2.3132153525213008E-5</c:v>
                  </c:pt>
                  <c:pt idx="8">
                    <c:v>1.916493402158556E-5</c:v>
                  </c:pt>
                  <c:pt idx="9">
                    <c:v>3.5489234645694698E-5</c:v>
                  </c:pt>
                  <c:pt idx="10">
                    <c:v>5.0380040095853533E-5</c:v>
                  </c:pt>
                  <c:pt idx="11">
                    <c:v>6.8987394231370038E-5</c:v>
                  </c:pt>
                  <c:pt idx="12">
                    <c:v>1.5726718786312834E-5</c:v>
                  </c:pt>
                  <c:pt idx="13">
                    <c:v>3.0689771629527144E-5</c:v>
                  </c:pt>
                  <c:pt idx="14">
                    <c:v>8.5659497271437922E-5</c:v>
                  </c:pt>
                  <c:pt idx="15">
                    <c:v>8.9197469993951343E-5</c:v>
                  </c:pt>
                  <c:pt idx="16">
                    <c:v>7.6787422231268875E-6</c:v>
                  </c:pt>
                  <c:pt idx="17">
                    <c:v>2.547548382896173E-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8.6646654730290109E-5</c:v>
                </c:pt>
                <c:pt idx="1">
                  <c:v>1.2620949037700843E-4</c:v>
                </c:pt>
                <c:pt idx="2">
                  <c:v>2.3223677550222985E-4</c:v>
                </c:pt>
                <c:pt idx="3">
                  <c:v>3.2063453320948826E-4</c:v>
                </c:pt>
                <c:pt idx="4">
                  <c:v>7.6044216576281776E-5</c:v>
                </c:pt>
                <c:pt idx="5">
                  <c:v>6.8062276175372095E-5</c:v>
                </c:pt>
                <c:pt idx="6">
                  <c:v>9.3131497861303236E-5</c:v>
                </c:pt>
                <c:pt idx="7">
                  <c:v>6.9230441679071842E-5</c:v>
                </c:pt>
                <c:pt idx="8">
                  <c:v>3.2856249392835651E-4</c:v>
                </c:pt>
                <c:pt idx="9">
                  <c:v>2.1275809013380847E-4</c:v>
                </c:pt>
                <c:pt idx="10">
                  <c:v>1.5648234272362717E-4</c:v>
                </c:pt>
                <c:pt idx="11">
                  <c:v>2.4121255700912416E-4</c:v>
                </c:pt>
                <c:pt idx="12">
                  <c:v>1.2019217402344595E-4</c:v>
                </c:pt>
                <c:pt idx="13">
                  <c:v>4.946784245465557E-4</c:v>
                </c:pt>
                <c:pt idx="14">
                  <c:v>3.4011456414771832E-4</c:v>
                </c:pt>
                <c:pt idx="15">
                  <c:v>2.893005964576549E-4</c:v>
                </c:pt>
                <c:pt idx="16">
                  <c:v>2.7236410414377166E-4</c:v>
                </c:pt>
                <c:pt idx="17">
                  <c:v>6.4433460382483978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139200"/>
        <c:axId val="252510208"/>
      </c:scatterChart>
      <c:valAx>
        <c:axId val="253139200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510208"/>
        <c:crosses val="autoZero"/>
        <c:crossBetween val="midCat"/>
        <c:majorUnit val="4"/>
      </c:valAx>
      <c:valAx>
        <c:axId val="252510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13920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6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0039743058852044E-2"/>
          <c:y val="7.2843998574472962E-2"/>
          <c:w val="0.9483152774882998"/>
          <c:h val="0.73796381931589272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J$5:$J$22</c:f>
                <c:numCache>
                  <c:formatCode>General</c:formatCode>
                  <c:ptCount val="18"/>
                  <c:pt idx="0">
                    <c:v>0.11566708902093056</c:v>
                  </c:pt>
                  <c:pt idx="1">
                    <c:v>0.13202936943134341</c:v>
                  </c:pt>
                  <c:pt idx="2">
                    <c:v>4.7941628752983821E-2</c:v>
                  </c:pt>
                  <c:pt idx="3">
                    <c:v>2.3081428148735584E-2</c:v>
                  </c:pt>
                  <c:pt idx="4">
                    <c:v>5.6365711729766094E-2</c:v>
                  </c:pt>
                  <c:pt idx="5">
                    <c:v>6.1927172410534146E-3</c:v>
                  </c:pt>
                  <c:pt idx="6">
                    <c:v>5.7651186332007744E-3</c:v>
                  </c:pt>
                  <c:pt idx="7">
                    <c:v>6.4666217978884763E-2</c:v>
                  </c:pt>
                  <c:pt idx="8">
                    <c:v>1.9497182966843735E-3</c:v>
                  </c:pt>
                  <c:pt idx="9">
                    <c:v>3.2446137545731016E-2</c:v>
                  </c:pt>
                  <c:pt idx="10">
                    <c:v>7.2426439902529473E-3</c:v>
                  </c:pt>
                  <c:pt idx="11">
                    <c:v>4.4866485545718201E-3</c:v>
                  </c:pt>
                  <c:pt idx="12">
                    <c:v>1.0633298104844318E-2</c:v>
                  </c:pt>
                  <c:pt idx="13">
                    <c:v>1.5034589477761161E-2</c:v>
                  </c:pt>
                  <c:pt idx="14">
                    <c:v>1.6366810606354389E-2</c:v>
                  </c:pt>
                  <c:pt idx="15">
                    <c:v>1.7353255615601307E-2</c:v>
                  </c:pt>
                  <c:pt idx="16">
                    <c:v>8.2842746333886205E-3</c:v>
                  </c:pt>
                  <c:pt idx="17">
                    <c:v>9.0522583318276475E-3</c:v>
                  </c:pt>
                </c:numCache>
              </c:numRef>
            </c:plus>
            <c:minus>
              <c:numRef>
                <c:f>Sheet3!$J$5:$J$22</c:f>
                <c:numCache>
                  <c:formatCode>General</c:formatCode>
                  <c:ptCount val="18"/>
                  <c:pt idx="0">
                    <c:v>0.11566708902093056</c:v>
                  </c:pt>
                  <c:pt idx="1">
                    <c:v>0.13202936943134341</c:v>
                  </c:pt>
                  <c:pt idx="2">
                    <c:v>4.7941628752983821E-2</c:v>
                  </c:pt>
                  <c:pt idx="3">
                    <c:v>2.3081428148735584E-2</c:v>
                  </c:pt>
                  <c:pt idx="4">
                    <c:v>5.6365711729766094E-2</c:v>
                  </c:pt>
                  <c:pt idx="5">
                    <c:v>6.1927172410534146E-3</c:v>
                  </c:pt>
                  <c:pt idx="6">
                    <c:v>5.7651186332007744E-3</c:v>
                  </c:pt>
                  <c:pt idx="7">
                    <c:v>6.4666217978884763E-2</c:v>
                  </c:pt>
                  <c:pt idx="8">
                    <c:v>1.9497182966843735E-3</c:v>
                  </c:pt>
                  <c:pt idx="9">
                    <c:v>3.2446137545731016E-2</c:v>
                  </c:pt>
                  <c:pt idx="10">
                    <c:v>7.2426439902529473E-3</c:v>
                  </c:pt>
                  <c:pt idx="11">
                    <c:v>4.4866485545718201E-3</c:v>
                  </c:pt>
                  <c:pt idx="12">
                    <c:v>1.0633298104844318E-2</c:v>
                  </c:pt>
                  <c:pt idx="13">
                    <c:v>1.5034589477761161E-2</c:v>
                  </c:pt>
                  <c:pt idx="14">
                    <c:v>1.6366810606354389E-2</c:v>
                  </c:pt>
                  <c:pt idx="15">
                    <c:v>1.7353255615601307E-2</c:v>
                  </c:pt>
                  <c:pt idx="16">
                    <c:v>8.2842746333886205E-3</c:v>
                  </c:pt>
                  <c:pt idx="17">
                    <c:v>9.0522583318276475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3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3!$H$5:$H$22</c:f>
              <c:numCache>
                <c:formatCode>General</c:formatCode>
                <c:ptCount val="18"/>
                <c:pt idx="0">
                  <c:v>0.32747825642406725</c:v>
                </c:pt>
                <c:pt idx="1">
                  <c:v>0.38779135691633043</c:v>
                </c:pt>
                <c:pt idx="2">
                  <c:v>0.13302959756553479</c:v>
                </c:pt>
                <c:pt idx="3">
                  <c:v>5.6930750307646404E-2</c:v>
                </c:pt>
                <c:pt idx="4">
                  <c:v>0.100114357941731</c:v>
                </c:pt>
                <c:pt idx="5">
                  <c:v>7.5512430336326763E-2</c:v>
                </c:pt>
                <c:pt idx="6">
                  <c:v>8.5557929255297802E-2</c:v>
                </c:pt>
                <c:pt idx="7">
                  <c:v>0.10646307727016276</c:v>
                </c:pt>
                <c:pt idx="8">
                  <c:v>0.13968785778126094</c:v>
                </c:pt>
                <c:pt idx="9">
                  <c:v>6.7289010813430833E-2</c:v>
                </c:pt>
                <c:pt idx="10">
                  <c:v>0.10729754599445072</c:v>
                </c:pt>
                <c:pt idx="11">
                  <c:v>7.7216779435836824E-2</c:v>
                </c:pt>
                <c:pt idx="12">
                  <c:v>7.9906281967753748E-2</c:v>
                </c:pt>
                <c:pt idx="13">
                  <c:v>0.11932192600099527</c:v>
                </c:pt>
                <c:pt idx="14">
                  <c:v>7.3154860437615918E-2</c:v>
                </c:pt>
                <c:pt idx="15">
                  <c:v>5.8633170548537589E-2</c:v>
                </c:pt>
                <c:pt idx="16">
                  <c:v>0.10334383362753101</c:v>
                </c:pt>
                <c:pt idx="17">
                  <c:v>2.9204828847428626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526592"/>
        <c:axId val="252528128"/>
      </c:scatterChart>
      <c:valAx>
        <c:axId val="252526592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528128"/>
        <c:crosses val="autoZero"/>
        <c:crossBetween val="midCat"/>
        <c:majorUnit val="4"/>
      </c:valAx>
      <c:valAx>
        <c:axId val="252528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52659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100" b="1"/>
      </a:pPr>
      <a:endParaRPr lang="ko-KR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4635713639244"/>
          <c:y val="9.9287526741856577E-2"/>
          <c:w val="0.79713422029142911"/>
          <c:h val="0.7438373570520966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9</c:f>
              <c:strCache>
                <c:ptCount val="1"/>
                <c:pt idx="0">
                  <c:v>Bra037880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9:$K$9</c:f>
              <c:numCache>
                <c:formatCode>General</c:formatCode>
                <c:ptCount val="7"/>
                <c:pt idx="0">
                  <c:v>315.49699999999928</c:v>
                </c:pt>
                <c:pt idx="1">
                  <c:v>141.66349999999997</c:v>
                </c:pt>
                <c:pt idx="2">
                  <c:v>67.632499999999979</c:v>
                </c:pt>
                <c:pt idx="3">
                  <c:v>46.492000000000012</c:v>
                </c:pt>
                <c:pt idx="4">
                  <c:v>71.361999999999995</c:v>
                </c:pt>
                <c:pt idx="5">
                  <c:v>136.96250000000001</c:v>
                </c:pt>
                <c:pt idx="6">
                  <c:v>267.9584999999996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556800"/>
        <c:axId val="250558336"/>
      </c:scatterChart>
      <c:valAx>
        <c:axId val="250556800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558336"/>
        <c:crosses val="autoZero"/>
        <c:crossBetween val="midCat"/>
        <c:majorUnit val="4"/>
      </c:valAx>
      <c:valAx>
        <c:axId val="250558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55680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2841379310345037"/>
          <c:y val="0.15258566637503646"/>
          <c:w val="0.45108153492204595"/>
          <c:h val="0.1319866506060730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  <c:userShapes r:id="rId2"/>
</c:chartSpace>
</file>

<file path=ppt/charts/chart7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015815511797251E-2"/>
          <c:y val="7.6820538458689774E-2"/>
          <c:w val="0.87419880053488419"/>
          <c:h val="0.72316483353701577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J$24:$J$29</c:f>
                <c:numCache>
                  <c:formatCode>General</c:formatCode>
                  <c:ptCount val="6"/>
                  <c:pt idx="0">
                    <c:v>0.10003017346848449</c:v>
                  </c:pt>
                  <c:pt idx="1">
                    <c:v>3.1189100924804967E-3</c:v>
                  </c:pt>
                  <c:pt idx="2">
                    <c:v>1.1608875509284059E-2</c:v>
                  </c:pt>
                  <c:pt idx="3">
                    <c:v>6.2154947369762487E-2</c:v>
                  </c:pt>
                  <c:pt idx="4">
                    <c:v>4.4620956253316564E-3</c:v>
                  </c:pt>
                  <c:pt idx="5">
                    <c:v>1.08924956947651E-2</c:v>
                  </c:pt>
                </c:numCache>
              </c:numRef>
            </c:plus>
            <c:minus>
              <c:numRef>
                <c:f>Sheet3!$J$24:$J$29</c:f>
                <c:numCache>
                  <c:formatCode>General</c:formatCode>
                  <c:ptCount val="6"/>
                  <c:pt idx="0">
                    <c:v>0.10003017346848449</c:v>
                  </c:pt>
                  <c:pt idx="1">
                    <c:v>3.1189100924804967E-3</c:v>
                  </c:pt>
                  <c:pt idx="2">
                    <c:v>1.1608875509284059E-2</c:v>
                  </c:pt>
                  <c:pt idx="3">
                    <c:v>6.2154947369762487E-2</c:v>
                  </c:pt>
                  <c:pt idx="4">
                    <c:v>4.4620956253316564E-3</c:v>
                  </c:pt>
                  <c:pt idx="5">
                    <c:v>1.08924956947651E-2</c:v>
                  </c:pt>
                </c:numCache>
              </c:numRef>
            </c:minus>
          </c:errBars>
          <c:xVal>
            <c:numRef>
              <c:f>Sheet3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3!$H$24:$H$29</c:f>
              <c:numCache>
                <c:formatCode>General</c:formatCode>
                <c:ptCount val="6"/>
                <c:pt idx="0">
                  <c:v>0.29643836790507905</c:v>
                </c:pt>
                <c:pt idx="1">
                  <c:v>0.10915886672337967</c:v>
                </c:pt>
                <c:pt idx="2">
                  <c:v>0.11879358801153418</c:v>
                </c:pt>
                <c:pt idx="3">
                  <c:v>0.21768515012302742</c:v>
                </c:pt>
                <c:pt idx="4">
                  <c:v>9.2996819704743772E-2</c:v>
                </c:pt>
                <c:pt idx="5">
                  <c:v>0.1165562225138674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560512"/>
        <c:axId val="252562048"/>
      </c:scatterChart>
      <c:valAx>
        <c:axId val="25256051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562048"/>
        <c:crosses val="autoZero"/>
        <c:crossBetween val="midCat"/>
        <c:majorUnit val="4"/>
      </c:valAx>
      <c:valAx>
        <c:axId val="252562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56051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69338909746385"/>
          <c:y val="7.580974190002282E-2"/>
          <c:w val="0.87168873083792797"/>
          <c:h val="0.72680740151679168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24:$J$29</c:f>
                <c:numCache>
                  <c:formatCode>General</c:formatCode>
                  <c:ptCount val="6"/>
                  <c:pt idx="0">
                    <c:v>7.9285930246127088E-3</c:v>
                  </c:pt>
                  <c:pt idx="1">
                    <c:v>9.6995776609996246E-4</c:v>
                  </c:pt>
                  <c:pt idx="2">
                    <c:v>3.7514225047012252E-3</c:v>
                  </c:pt>
                  <c:pt idx="3">
                    <c:v>1.9396612120819859E-3</c:v>
                  </c:pt>
                  <c:pt idx="4">
                    <c:v>2.5385398113116926E-3</c:v>
                  </c:pt>
                  <c:pt idx="5">
                    <c:v>1.1982312910111859E-2</c:v>
                  </c:pt>
                </c:numCache>
              </c:numRef>
            </c:plus>
            <c:minus>
              <c:numRef>
                <c:f>Sheet4!$J$24:$J$29</c:f>
                <c:numCache>
                  <c:formatCode>General</c:formatCode>
                  <c:ptCount val="6"/>
                  <c:pt idx="0">
                    <c:v>7.9285930246127088E-3</c:v>
                  </c:pt>
                  <c:pt idx="1">
                    <c:v>9.6995776609996246E-4</c:v>
                  </c:pt>
                  <c:pt idx="2">
                    <c:v>3.7514225047012252E-3</c:v>
                  </c:pt>
                  <c:pt idx="3">
                    <c:v>1.9396612120819859E-3</c:v>
                  </c:pt>
                  <c:pt idx="4">
                    <c:v>2.5385398113116926E-3</c:v>
                  </c:pt>
                  <c:pt idx="5">
                    <c:v>1.1982312910111859E-2</c:v>
                  </c:pt>
                </c:numCache>
              </c:numRef>
            </c:minus>
          </c:errBars>
          <c:xVal>
            <c:numRef>
              <c:f>Sheet4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H$24:$H$29</c:f>
              <c:numCache>
                <c:formatCode>General</c:formatCode>
                <c:ptCount val="6"/>
                <c:pt idx="0">
                  <c:v>7.8152170873560592E-2</c:v>
                </c:pt>
                <c:pt idx="1">
                  <c:v>1.6878799217050409E-2</c:v>
                </c:pt>
                <c:pt idx="2">
                  <c:v>3.4436369846695541E-2</c:v>
                </c:pt>
                <c:pt idx="3">
                  <c:v>2.1464352223549692E-2</c:v>
                </c:pt>
                <c:pt idx="4">
                  <c:v>1.4561132398959347E-2</c:v>
                </c:pt>
                <c:pt idx="5">
                  <c:v>4.8622736634770528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582144"/>
        <c:axId val="252588032"/>
      </c:scatterChart>
      <c:valAx>
        <c:axId val="25258214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588032"/>
        <c:crosses val="autoZero"/>
        <c:crossBetween val="midCat"/>
        <c:majorUnit val="4"/>
      </c:valAx>
      <c:valAx>
        <c:axId val="252588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5821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6653717089976864E-2"/>
          <c:y val="8.7412984814552508E-2"/>
          <c:w val="0.93459638743843276"/>
          <c:h val="0.72680740151679168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5:$J$22</c:f>
                <c:numCache>
                  <c:formatCode>General</c:formatCode>
                  <c:ptCount val="18"/>
                  <c:pt idx="0">
                    <c:v>2.9291768301561216E-2</c:v>
                  </c:pt>
                  <c:pt idx="1">
                    <c:v>6.8520002653753576E-3</c:v>
                  </c:pt>
                  <c:pt idx="2">
                    <c:v>1.046479753877834E-3</c:v>
                  </c:pt>
                  <c:pt idx="3">
                    <c:v>5.519961798807775E-4</c:v>
                  </c:pt>
                  <c:pt idx="4">
                    <c:v>1.5028050721531841E-3</c:v>
                  </c:pt>
                  <c:pt idx="5">
                    <c:v>2.2921725551190066E-3</c:v>
                  </c:pt>
                  <c:pt idx="6">
                    <c:v>7.3789969803889814E-4</c:v>
                  </c:pt>
                  <c:pt idx="7">
                    <c:v>4.0606488668869685E-3</c:v>
                  </c:pt>
                  <c:pt idx="8">
                    <c:v>2.8317595709021742E-3</c:v>
                  </c:pt>
                  <c:pt idx="9">
                    <c:v>5.3504982453575194E-3</c:v>
                  </c:pt>
                  <c:pt idx="10">
                    <c:v>2.8341030961720063E-3</c:v>
                  </c:pt>
                  <c:pt idx="11">
                    <c:v>1.4346205516561341E-3</c:v>
                  </c:pt>
                  <c:pt idx="12">
                    <c:v>6.07289274384818E-3</c:v>
                  </c:pt>
                  <c:pt idx="13">
                    <c:v>7.5759414693139348E-4</c:v>
                  </c:pt>
                  <c:pt idx="14">
                    <c:v>2.5484870502740431E-3</c:v>
                  </c:pt>
                  <c:pt idx="15">
                    <c:v>3.6087730854730818E-3</c:v>
                  </c:pt>
                  <c:pt idx="16">
                    <c:v>7.0023099915690005E-3</c:v>
                  </c:pt>
                  <c:pt idx="17">
                    <c:v>8.1375211557429966E-3</c:v>
                  </c:pt>
                </c:numCache>
              </c:numRef>
            </c:plus>
            <c:minus>
              <c:numRef>
                <c:f>Sheet4!$J$5:$J$22</c:f>
                <c:numCache>
                  <c:formatCode>General</c:formatCode>
                  <c:ptCount val="18"/>
                  <c:pt idx="0">
                    <c:v>2.9291768301561216E-2</c:v>
                  </c:pt>
                  <c:pt idx="1">
                    <c:v>6.8520002653753576E-3</c:v>
                  </c:pt>
                  <c:pt idx="2">
                    <c:v>1.046479753877834E-3</c:v>
                  </c:pt>
                  <c:pt idx="3">
                    <c:v>5.519961798807775E-4</c:v>
                  </c:pt>
                  <c:pt idx="4">
                    <c:v>1.5028050721531841E-3</c:v>
                  </c:pt>
                  <c:pt idx="5">
                    <c:v>2.2921725551190066E-3</c:v>
                  </c:pt>
                  <c:pt idx="6">
                    <c:v>7.3789969803889814E-4</c:v>
                  </c:pt>
                  <c:pt idx="7">
                    <c:v>4.0606488668869685E-3</c:v>
                  </c:pt>
                  <c:pt idx="8">
                    <c:v>2.8317595709021742E-3</c:v>
                  </c:pt>
                  <c:pt idx="9">
                    <c:v>5.3504982453575194E-3</c:v>
                  </c:pt>
                  <c:pt idx="10">
                    <c:v>2.8341030961720063E-3</c:v>
                  </c:pt>
                  <c:pt idx="11">
                    <c:v>1.4346205516561341E-3</c:v>
                  </c:pt>
                  <c:pt idx="12">
                    <c:v>6.07289274384818E-3</c:v>
                  </c:pt>
                  <c:pt idx="13">
                    <c:v>7.5759414693139348E-4</c:v>
                  </c:pt>
                  <c:pt idx="14">
                    <c:v>2.5484870502740431E-3</c:v>
                  </c:pt>
                  <c:pt idx="15">
                    <c:v>3.6087730854730818E-3</c:v>
                  </c:pt>
                  <c:pt idx="16">
                    <c:v>7.0023099915690005E-3</c:v>
                  </c:pt>
                  <c:pt idx="17">
                    <c:v>8.1375211557429966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4!$H$5:$H$22</c:f>
              <c:numCache>
                <c:formatCode>General</c:formatCode>
                <c:ptCount val="18"/>
                <c:pt idx="0">
                  <c:v>8.8547140019439474E-2</c:v>
                </c:pt>
                <c:pt idx="1">
                  <c:v>3.5099297852111452E-2</c:v>
                </c:pt>
                <c:pt idx="2">
                  <c:v>1.7520980722087083E-2</c:v>
                </c:pt>
                <c:pt idx="3">
                  <c:v>5.8120200666532005E-3</c:v>
                </c:pt>
                <c:pt idx="4">
                  <c:v>5.5252770521222504E-3</c:v>
                </c:pt>
                <c:pt idx="5">
                  <c:v>1.120079038922904E-2</c:v>
                </c:pt>
                <c:pt idx="6">
                  <c:v>1.8439210405785746E-2</c:v>
                </c:pt>
                <c:pt idx="7">
                  <c:v>1.4023337511238189E-2</c:v>
                </c:pt>
                <c:pt idx="8">
                  <c:v>3.9480814021349626E-2</c:v>
                </c:pt>
                <c:pt idx="9">
                  <c:v>2.2385799466183739E-2</c:v>
                </c:pt>
                <c:pt idx="10">
                  <c:v>1.2968942728437996E-2</c:v>
                </c:pt>
                <c:pt idx="11">
                  <c:v>8.9117277484783205E-3</c:v>
                </c:pt>
                <c:pt idx="12">
                  <c:v>2.995735613987964E-2</c:v>
                </c:pt>
                <c:pt idx="13">
                  <c:v>3.1196442416062842E-2</c:v>
                </c:pt>
                <c:pt idx="14">
                  <c:v>3.3834476976093285E-2</c:v>
                </c:pt>
                <c:pt idx="15">
                  <c:v>1.4768243489414348E-2</c:v>
                </c:pt>
                <c:pt idx="16">
                  <c:v>3.0925363860224285E-2</c:v>
                </c:pt>
                <c:pt idx="17">
                  <c:v>4.4763968898495106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616704"/>
        <c:axId val="252618240"/>
      </c:scatterChart>
      <c:valAx>
        <c:axId val="25261670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618240"/>
        <c:crosses val="autoZero"/>
        <c:crossBetween val="midCat"/>
        <c:majorUnit val="4"/>
      </c:valAx>
      <c:valAx>
        <c:axId val="252618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61670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24:$J$29</c:f>
                <c:numCache>
                  <c:formatCode>General</c:formatCode>
                  <c:ptCount val="6"/>
                  <c:pt idx="0">
                    <c:v>7.0250313928931302E-2</c:v>
                  </c:pt>
                  <c:pt idx="1">
                    <c:v>1.2115199522433199E-2</c:v>
                  </c:pt>
                  <c:pt idx="2">
                    <c:v>2.4740220323316832E-2</c:v>
                  </c:pt>
                  <c:pt idx="3">
                    <c:v>2.6234465274525959E-2</c:v>
                  </c:pt>
                  <c:pt idx="4">
                    <c:v>3.8560871141211678E-2</c:v>
                  </c:pt>
                  <c:pt idx="5">
                    <c:v>0.11419802622310364</c:v>
                  </c:pt>
                </c:numCache>
              </c:numRef>
            </c:plus>
            <c:minus>
              <c:numRef>
                <c:f>Sheet4!$J$24:$J$29</c:f>
                <c:numCache>
                  <c:formatCode>General</c:formatCode>
                  <c:ptCount val="6"/>
                  <c:pt idx="0">
                    <c:v>7.0250313928931302E-2</c:v>
                  </c:pt>
                  <c:pt idx="1">
                    <c:v>1.2115199522433199E-2</c:v>
                  </c:pt>
                  <c:pt idx="2">
                    <c:v>2.4740220323316832E-2</c:v>
                  </c:pt>
                  <c:pt idx="3">
                    <c:v>2.6234465274525959E-2</c:v>
                  </c:pt>
                  <c:pt idx="4">
                    <c:v>3.8560871141211678E-2</c:v>
                  </c:pt>
                  <c:pt idx="5">
                    <c:v>0.11419802622310364</c:v>
                  </c:pt>
                </c:numCache>
              </c:numRef>
            </c:minus>
          </c:errBars>
          <c:xVal>
            <c:numRef>
              <c:f>Sheet4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H$24:$H$29</c:f>
              <c:numCache>
                <c:formatCode>General</c:formatCode>
                <c:ptCount val="6"/>
                <c:pt idx="0">
                  <c:v>0.30429923102968798</c:v>
                </c:pt>
                <c:pt idx="1">
                  <c:v>0.17358662104683309</c:v>
                </c:pt>
                <c:pt idx="2">
                  <c:v>0.45098079475413105</c:v>
                </c:pt>
                <c:pt idx="3">
                  <c:v>0.39858099101800759</c:v>
                </c:pt>
                <c:pt idx="4">
                  <c:v>0.30130219841002731</c:v>
                </c:pt>
                <c:pt idx="5">
                  <c:v>0.4965874577874874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672256"/>
        <c:axId val="252678144"/>
      </c:scatterChart>
      <c:valAx>
        <c:axId val="25267225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01600">
            <a:solidFill>
              <a:schemeClr val="tx1"/>
            </a:solidFill>
          </a:ln>
        </c:spPr>
        <c:crossAx val="252678144"/>
        <c:crosses val="autoZero"/>
        <c:crossBetween val="midCat"/>
        <c:majorUnit val="4"/>
      </c:valAx>
      <c:valAx>
        <c:axId val="252678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672256"/>
        <c:crosses val="autoZero"/>
        <c:crossBetween val="midCat"/>
      </c:valAx>
      <c:spPr>
        <a:ln w="101600">
          <a:noFill/>
        </a:ln>
      </c:spPr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642037811016167E-2"/>
          <c:y val="6.9261139934223587E-2"/>
          <c:w val="0.94181488892538512"/>
          <c:h val="0.71558030842843945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5:$J$22</c:f>
                <c:numCache>
                  <c:formatCode>General</c:formatCode>
                  <c:ptCount val="18"/>
                  <c:pt idx="0">
                    <c:v>0.17429280470907371</c:v>
                  </c:pt>
                  <c:pt idx="1">
                    <c:v>2.2246981840619792E-2</c:v>
                  </c:pt>
                  <c:pt idx="2">
                    <c:v>8.4014555833376567E-2</c:v>
                  </c:pt>
                  <c:pt idx="3">
                    <c:v>3.504211918623458E-2</c:v>
                  </c:pt>
                  <c:pt idx="4">
                    <c:v>6.3872723504191334E-2</c:v>
                  </c:pt>
                  <c:pt idx="5">
                    <c:v>3.4257475023771723E-2</c:v>
                  </c:pt>
                  <c:pt idx="6">
                    <c:v>1.7154367773411786E-2</c:v>
                  </c:pt>
                  <c:pt idx="7">
                    <c:v>6.5346374506941751E-2</c:v>
                  </c:pt>
                  <c:pt idx="8">
                    <c:v>1.0423158986930718E-2</c:v>
                  </c:pt>
                  <c:pt idx="9">
                    <c:v>3.2204776187374919E-2</c:v>
                  </c:pt>
                  <c:pt idx="10">
                    <c:v>2.8774368178403294E-2</c:v>
                  </c:pt>
                  <c:pt idx="11">
                    <c:v>1.8571186816720927E-2</c:v>
                  </c:pt>
                  <c:pt idx="12">
                    <c:v>4.1511687635904793E-2</c:v>
                  </c:pt>
                  <c:pt idx="13">
                    <c:v>6.5668827072069506E-3</c:v>
                  </c:pt>
                  <c:pt idx="14">
                    <c:v>2.082393718650705E-2</c:v>
                  </c:pt>
                  <c:pt idx="15">
                    <c:v>0.177694660401778</c:v>
                  </c:pt>
                  <c:pt idx="16">
                    <c:v>2.5255424344712778E-2</c:v>
                  </c:pt>
                  <c:pt idx="17">
                    <c:v>7.5868587446709925E-3</c:v>
                  </c:pt>
                </c:numCache>
              </c:numRef>
            </c:plus>
            <c:minus>
              <c:numRef>
                <c:f>Sheet4!$J$5:$J$22</c:f>
                <c:numCache>
                  <c:formatCode>General</c:formatCode>
                  <c:ptCount val="18"/>
                  <c:pt idx="0">
                    <c:v>0.17429280470907371</c:v>
                  </c:pt>
                  <c:pt idx="1">
                    <c:v>2.2246981840619792E-2</c:v>
                  </c:pt>
                  <c:pt idx="2">
                    <c:v>8.4014555833376567E-2</c:v>
                  </c:pt>
                  <c:pt idx="3">
                    <c:v>3.504211918623458E-2</c:v>
                  </c:pt>
                  <c:pt idx="4">
                    <c:v>6.3872723504191334E-2</c:v>
                  </c:pt>
                  <c:pt idx="5">
                    <c:v>3.4257475023771723E-2</c:v>
                  </c:pt>
                  <c:pt idx="6">
                    <c:v>1.7154367773411786E-2</c:v>
                  </c:pt>
                  <c:pt idx="7">
                    <c:v>6.5346374506941751E-2</c:v>
                  </c:pt>
                  <c:pt idx="8">
                    <c:v>1.0423158986930718E-2</c:v>
                  </c:pt>
                  <c:pt idx="9">
                    <c:v>3.2204776187374919E-2</c:v>
                  </c:pt>
                  <c:pt idx="10">
                    <c:v>2.8774368178403294E-2</c:v>
                  </c:pt>
                  <c:pt idx="11">
                    <c:v>1.8571186816720927E-2</c:v>
                  </c:pt>
                  <c:pt idx="12">
                    <c:v>4.1511687635904793E-2</c:v>
                  </c:pt>
                  <c:pt idx="13">
                    <c:v>6.5668827072069506E-3</c:v>
                  </c:pt>
                  <c:pt idx="14">
                    <c:v>2.082393718650705E-2</c:v>
                  </c:pt>
                  <c:pt idx="15">
                    <c:v>0.177694660401778</c:v>
                  </c:pt>
                  <c:pt idx="16">
                    <c:v>2.5255424344712778E-2</c:v>
                  </c:pt>
                  <c:pt idx="17">
                    <c:v>7.5868587446709925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H$5:$H$22</c:f>
              <c:numCache>
                <c:formatCode>General</c:formatCode>
                <c:ptCount val="18"/>
                <c:pt idx="0">
                  <c:v>0.59196496776367558</c:v>
                </c:pt>
                <c:pt idx="1">
                  <c:v>0.40180573352170335</c:v>
                </c:pt>
                <c:pt idx="2">
                  <c:v>0.32018595585467391</c:v>
                </c:pt>
                <c:pt idx="3">
                  <c:v>0.2887111409985102</c:v>
                </c:pt>
                <c:pt idx="4">
                  <c:v>0.24016985439593441</c:v>
                </c:pt>
                <c:pt idx="5">
                  <c:v>0.12884423154557884</c:v>
                </c:pt>
                <c:pt idx="6">
                  <c:v>0.17592125215820742</c:v>
                </c:pt>
                <c:pt idx="7">
                  <c:v>0.22282948693542523</c:v>
                </c:pt>
                <c:pt idx="8">
                  <c:v>0.39529365449439863</c:v>
                </c:pt>
                <c:pt idx="9">
                  <c:v>0.32132957893622405</c:v>
                </c:pt>
                <c:pt idx="10">
                  <c:v>0.18377905731685348</c:v>
                </c:pt>
                <c:pt idx="11">
                  <c:v>0.13879303906784923</c:v>
                </c:pt>
                <c:pt idx="12">
                  <c:v>0.27990190885343746</c:v>
                </c:pt>
                <c:pt idx="13">
                  <c:v>0.26686825044080542</c:v>
                </c:pt>
                <c:pt idx="14">
                  <c:v>0.53795340869894914</c:v>
                </c:pt>
                <c:pt idx="15">
                  <c:v>0.47734041043657399</c:v>
                </c:pt>
                <c:pt idx="16">
                  <c:v>0.43269485090242482</c:v>
                </c:pt>
                <c:pt idx="17">
                  <c:v>0.2164053259024959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694528"/>
        <c:axId val="252696064"/>
      </c:scatterChart>
      <c:valAx>
        <c:axId val="252694528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2696064"/>
        <c:crosses val="autoZero"/>
        <c:crossBetween val="midCat"/>
        <c:majorUnit val="4"/>
      </c:valAx>
      <c:valAx>
        <c:axId val="2526960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269452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noFill/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6!$K$5:$K$22</c:f>
                <c:numCache>
                  <c:formatCode>General</c:formatCode>
                  <c:ptCount val="18"/>
                  <c:pt idx="0">
                    <c:v>2.8329419861032527E-3</c:v>
                  </c:pt>
                  <c:pt idx="1">
                    <c:v>1.684685286975485E-3</c:v>
                  </c:pt>
                  <c:pt idx="2">
                    <c:v>8.0443671593153684E-3</c:v>
                  </c:pt>
                  <c:pt idx="3">
                    <c:v>2.7349575862505205E-3</c:v>
                  </c:pt>
                  <c:pt idx="4">
                    <c:v>5.0038128706325624E-3</c:v>
                  </c:pt>
                  <c:pt idx="5">
                    <c:v>3.0265506758123859E-3</c:v>
                  </c:pt>
                  <c:pt idx="6">
                    <c:v>3.915935470185491E-3</c:v>
                  </c:pt>
                  <c:pt idx="7">
                    <c:v>5.0181406830625743E-3</c:v>
                  </c:pt>
                  <c:pt idx="8">
                    <c:v>2.6240129646607846E-3</c:v>
                  </c:pt>
                  <c:pt idx="9">
                    <c:v>8.411360555228448E-3</c:v>
                  </c:pt>
                  <c:pt idx="10">
                    <c:v>2.5080382922515604E-2</c:v>
                  </c:pt>
                  <c:pt idx="11">
                    <c:v>1.6386741122955857E-2</c:v>
                  </c:pt>
                  <c:pt idx="12">
                    <c:v>1.1680437945113943E-3</c:v>
                  </c:pt>
                  <c:pt idx="13">
                    <c:v>1.5923908336233673E-3</c:v>
                  </c:pt>
                  <c:pt idx="14">
                    <c:v>7.2796520307043047E-2</c:v>
                  </c:pt>
                  <c:pt idx="15">
                    <c:v>2.0372554824318028E-2</c:v>
                  </c:pt>
                  <c:pt idx="16">
                    <c:v>1.9108752553312083E-2</c:v>
                  </c:pt>
                  <c:pt idx="17">
                    <c:v>3.4212992216095407E-3</c:v>
                  </c:pt>
                </c:numCache>
              </c:numRef>
            </c:plus>
            <c:minus>
              <c:numRef>
                <c:f>Sheet6!$K$5:$K$22</c:f>
                <c:numCache>
                  <c:formatCode>General</c:formatCode>
                  <c:ptCount val="18"/>
                  <c:pt idx="0">
                    <c:v>2.8329419861032527E-3</c:v>
                  </c:pt>
                  <c:pt idx="1">
                    <c:v>1.684685286975485E-3</c:v>
                  </c:pt>
                  <c:pt idx="2">
                    <c:v>8.0443671593153684E-3</c:v>
                  </c:pt>
                  <c:pt idx="3">
                    <c:v>2.7349575862505205E-3</c:v>
                  </c:pt>
                  <c:pt idx="4">
                    <c:v>5.0038128706325624E-3</c:v>
                  </c:pt>
                  <c:pt idx="5">
                    <c:v>3.0265506758123859E-3</c:v>
                  </c:pt>
                  <c:pt idx="6">
                    <c:v>3.915935470185491E-3</c:v>
                  </c:pt>
                  <c:pt idx="7">
                    <c:v>5.0181406830625743E-3</c:v>
                  </c:pt>
                  <c:pt idx="8">
                    <c:v>2.6240129646607846E-3</c:v>
                  </c:pt>
                  <c:pt idx="9">
                    <c:v>8.411360555228448E-3</c:v>
                  </c:pt>
                  <c:pt idx="10">
                    <c:v>2.5080382922515604E-2</c:v>
                  </c:pt>
                  <c:pt idx="11">
                    <c:v>1.6386741122955857E-2</c:v>
                  </c:pt>
                  <c:pt idx="12">
                    <c:v>1.1680437945113943E-3</c:v>
                  </c:pt>
                  <c:pt idx="13">
                    <c:v>1.5923908336233673E-3</c:v>
                  </c:pt>
                  <c:pt idx="14">
                    <c:v>7.2796520307043047E-2</c:v>
                  </c:pt>
                  <c:pt idx="15">
                    <c:v>2.0372554824318028E-2</c:v>
                  </c:pt>
                  <c:pt idx="16">
                    <c:v>1.9108752553312083E-2</c:v>
                  </c:pt>
                  <c:pt idx="17">
                    <c:v>3.4212992216095407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6!$H$5:$H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6!$I$5:$I$22</c:f>
              <c:numCache>
                <c:formatCode>General</c:formatCode>
                <c:ptCount val="18"/>
                <c:pt idx="0">
                  <c:v>8.6767299750687074E-3</c:v>
                </c:pt>
                <c:pt idx="1">
                  <c:v>6.6259947662955759E-2</c:v>
                </c:pt>
                <c:pt idx="2">
                  <c:v>7.2361053590041122E-2</c:v>
                </c:pt>
                <c:pt idx="3">
                  <c:v>3.6280768530772695E-2</c:v>
                </c:pt>
                <c:pt idx="4">
                  <c:v>2.55933224114713E-2</c:v>
                </c:pt>
                <c:pt idx="5">
                  <c:v>1.6011109005171005E-2</c:v>
                </c:pt>
                <c:pt idx="6">
                  <c:v>4.6719586886119414E-2</c:v>
                </c:pt>
                <c:pt idx="7">
                  <c:v>2.4396138522526242E-2</c:v>
                </c:pt>
                <c:pt idx="8">
                  <c:v>7.2890312243087133E-2</c:v>
                </c:pt>
                <c:pt idx="9">
                  <c:v>9.6751603630577998E-2</c:v>
                </c:pt>
                <c:pt idx="10">
                  <c:v>0.15769044035066254</c:v>
                </c:pt>
                <c:pt idx="11">
                  <c:v>9.1557226671050568E-2</c:v>
                </c:pt>
                <c:pt idx="12">
                  <c:v>8.3063343716400246E-3</c:v>
                </c:pt>
                <c:pt idx="13">
                  <c:v>6.6254891210833319E-2</c:v>
                </c:pt>
                <c:pt idx="14">
                  <c:v>0.40532524228030092</c:v>
                </c:pt>
                <c:pt idx="15">
                  <c:v>7.2427366904781423E-2</c:v>
                </c:pt>
                <c:pt idx="16">
                  <c:v>0.1012323524806647</c:v>
                </c:pt>
                <c:pt idx="17">
                  <c:v>2.8293003420294716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199872"/>
        <c:axId val="253201408"/>
      </c:scatterChart>
      <c:valAx>
        <c:axId val="253199872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201408"/>
        <c:crosses val="autoZero"/>
        <c:crossBetween val="midCat"/>
        <c:majorUnit val="4"/>
      </c:valAx>
      <c:valAx>
        <c:axId val="253201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19987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6!$K$24:$K$29</c:f>
                <c:numCache>
                  <c:formatCode>General</c:formatCode>
                  <c:ptCount val="6"/>
                  <c:pt idx="0">
                    <c:v>6.9271008615663085E-2</c:v>
                  </c:pt>
                  <c:pt idx="1">
                    <c:v>6.9889999611803472E-3</c:v>
                  </c:pt>
                  <c:pt idx="2">
                    <c:v>8.1313437816271289E-2</c:v>
                  </c:pt>
                  <c:pt idx="3">
                    <c:v>2.9563374776873524E-2</c:v>
                  </c:pt>
                  <c:pt idx="4">
                    <c:v>2.8141286100893316E-2</c:v>
                  </c:pt>
                  <c:pt idx="5">
                    <c:v>3.9886136416645332E-2</c:v>
                  </c:pt>
                </c:numCache>
              </c:numRef>
            </c:plus>
            <c:minus>
              <c:numRef>
                <c:f>Sheet6!$K$24:$K$29</c:f>
                <c:numCache>
                  <c:formatCode>General</c:formatCode>
                  <c:ptCount val="6"/>
                  <c:pt idx="0">
                    <c:v>6.9271008615663085E-2</c:v>
                  </c:pt>
                  <c:pt idx="1">
                    <c:v>6.9889999611803472E-3</c:v>
                  </c:pt>
                  <c:pt idx="2">
                    <c:v>8.1313437816271289E-2</c:v>
                  </c:pt>
                  <c:pt idx="3">
                    <c:v>2.9563374776873524E-2</c:v>
                  </c:pt>
                  <c:pt idx="4">
                    <c:v>2.8141286100893316E-2</c:v>
                  </c:pt>
                  <c:pt idx="5">
                    <c:v>3.9886136416645332E-2</c:v>
                  </c:pt>
                </c:numCache>
              </c:numRef>
            </c:minus>
          </c:errBars>
          <c:xVal>
            <c:numRef>
              <c:f>Sheet6!$H$24:$H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6!$I$24:$I$29</c:f>
              <c:numCache>
                <c:formatCode>General</c:formatCode>
                <c:ptCount val="6"/>
                <c:pt idx="0">
                  <c:v>0.17217603347190641</c:v>
                </c:pt>
                <c:pt idx="1">
                  <c:v>3.1661710546023285E-2</c:v>
                </c:pt>
                <c:pt idx="2">
                  <c:v>0.32698506100143576</c:v>
                </c:pt>
                <c:pt idx="3">
                  <c:v>0.10812757160063508</c:v>
                </c:pt>
                <c:pt idx="4">
                  <c:v>9.8012448702936641E-2</c:v>
                </c:pt>
                <c:pt idx="5">
                  <c:v>0.1177487223679481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213312"/>
        <c:axId val="253501824"/>
      </c:scatterChart>
      <c:valAx>
        <c:axId val="25321331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501824"/>
        <c:crosses val="autoZero"/>
        <c:crossBetween val="midCat"/>
        <c:majorUnit val="4"/>
      </c:valAx>
      <c:valAx>
        <c:axId val="253501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21331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6!$K$5:$K$22</c:f>
                <c:numCache>
                  <c:formatCode>General</c:formatCode>
                  <c:ptCount val="18"/>
                  <c:pt idx="0">
                    <c:v>3.5160721898781559E-5</c:v>
                  </c:pt>
                  <c:pt idx="1">
                    <c:v>5.3217637048418441E-6</c:v>
                  </c:pt>
                  <c:pt idx="2">
                    <c:v>1.1217535018352408E-5</c:v>
                  </c:pt>
                  <c:pt idx="3">
                    <c:v>1.339783747056599E-5</c:v>
                  </c:pt>
                  <c:pt idx="4">
                    <c:v>7.0273350406189114E-6</c:v>
                  </c:pt>
                  <c:pt idx="5">
                    <c:v>1.0141033537123421E-4</c:v>
                  </c:pt>
                  <c:pt idx="6">
                    <c:v>9.3824663582818186E-5</c:v>
                  </c:pt>
                  <c:pt idx="7">
                    <c:v>1.64428330421906E-4</c:v>
                  </c:pt>
                  <c:pt idx="8">
                    <c:v>3.536659816796299E-5</c:v>
                  </c:pt>
                  <c:pt idx="9">
                    <c:v>4.7396769175982095E-5</c:v>
                  </c:pt>
                  <c:pt idx="10">
                    <c:v>1.5549085123378093E-5</c:v>
                  </c:pt>
                  <c:pt idx="11">
                    <c:v>2.2078030045499337E-5</c:v>
                  </c:pt>
                  <c:pt idx="12">
                    <c:v>3.3367291216366804E-5</c:v>
                  </c:pt>
                  <c:pt idx="13">
                    <c:v>2.0964005338803866E-5</c:v>
                  </c:pt>
                  <c:pt idx="14">
                    <c:v>1.9401301262843227E-5</c:v>
                  </c:pt>
                  <c:pt idx="15">
                    <c:v>7.7625826919017106E-6</c:v>
                  </c:pt>
                  <c:pt idx="16">
                    <c:v>4.9723435169334126E-5</c:v>
                  </c:pt>
                  <c:pt idx="17">
                    <c:v>1.180516872026317E-5</c:v>
                  </c:pt>
                </c:numCache>
              </c:numRef>
            </c:plus>
            <c:minus>
              <c:numRef>
                <c:f>Sheet6!$K$5:$K$22</c:f>
                <c:numCache>
                  <c:formatCode>General</c:formatCode>
                  <c:ptCount val="18"/>
                  <c:pt idx="0">
                    <c:v>3.5160721898781559E-5</c:v>
                  </c:pt>
                  <c:pt idx="1">
                    <c:v>5.3217637048418441E-6</c:v>
                  </c:pt>
                  <c:pt idx="2">
                    <c:v>1.1217535018352408E-5</c:v>
                  </c:pt>
                  <c:pt idx="3">
                    <c:v>1.339783747056599E-5</c:v>
                  </c:pt>
                  <c:pt idx="4">
                    <c:v>7.0273350406189114E-6</c:v>
                  </c:pt>
                  <c:pt idx="5">
                    <c:v>1.0141033537123421E-4</c:v>
                  </c:pt>
                  <c:pt idx="6">
                    <c:v>9.3824663582818186E-5</c:v>
                  </c:pt>
                  <c:pt idx="7">
                    <c:v>1.64428330421906E-4</c:v>
                  </c:pt>
                  <c:pt idx="8">
                    <c:v>3.536659816796299E-5</c:v>
                  </c:pt>
                  <c:pt idx="9">
                    <c:v>4.7396769175982095E-5</c:v>
                  </c:pt>
                  <c:pt idx="10">
                    <c:v>1.5549085123378093E-5</c:v>
                  </c:pt>
                  <c:pt idx="11">
                    <c:v>2.2078030045499337E-5</c:v>
                  </c:pt>
                  <c:pt idx="12">
                    <c:v>3.3367291216366804E-5</c:v>
                  </c:pt>
                  <c:pt idx="13">
                    <c:v>2.0964005338803866E-5</c:v>
                  </c:pt>
                  <c:pt idx="14">
                    <c:v>1.9401301262843227E-5</c:v>
                  </c:pt>
                  <c:pt idx="15">
                    <c:v>7.7625826919017106E-6</c:v>
                  </c:pt>
                  <c:pt idx="16">
                    <c:v>4.9723435169334126E-5</c:v>
                  </c:pt>
                  <c:pt idx="17">
                    <c:v>1.180516872026317E-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6!$H$5:$H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6!$I$5:$I$22</c:f>
              <c:numCache>
                <c:formatCode>General</c:formatCode>
                <c:ptCount val="18"/>
                <c:pt idx="0">
                  <c:v>1.5298454446813271E-4</c:v>
                </c:pt>
                <c:pt idx="1">
                  <c:v>1.6198996409093875E-4</c:v>
                </c:pt>
                <c:pt idx="2">
                  <c:v>9.1682324934349766E-5</c:v>
                </c:pt>
                <c:pt idx="3">
                  <c:v>1.4121626493909385E-4</c:v>
                </c:pt>
                <c:pt idx="4">
                  <c:v>2.5958415404169933E-5</c:v>
                </c:pt>
                <c:pt idx="5">
                  <c:v>2.8065808461305775E-4</c:v>
                </c:pt>
                <c:pt idx="6">
                  <c:v>2.6634748388561908E-4</c:v>
                </c:pt>
                <c:pt idx="7">
                  <c:v>3.6102035015084819E-4</c:v>
                </c:pt>
                <c:pt idx="8">
                  <c:v>1.1363604132327168E-4</c:v>
                </c:pt>
                <c:pt idx="9">
                  <c:v>1.0411736710738601E-4</c:v>
                </c:pt>
                <c:pt idx="10">
                  <c:v>8.7278580060601006E-5</c:v>
                </c:pt>
                <c:pt idx="11">
                  <c:v>8.948363560496895E-5</c:v>
                </c:pt>
                <c:pt idx="12">
                  <c:v>1.5978283510863041E-4</c:v>
                </c:pt>
                <c:pt idx="13">
                  <c:v>1.8299808118349198E-4</c:v>
                </c:pt>
                <c:pt idx="14">
                  <c:v>2.1920624574998278E-4</c:v>
                </c:pt>
                <c:pt idx="15">
                  <c:v>9.298077407274501E-5</c:v>
                </c:pt>
                <c:pt idx="16">
                  <c:v>2.2494904644414606E-4</c:v>
                </c:pt>
                <c:pt idx="17">
                  <c:v>1.1800307100970432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522304"/>
        <c:axId val="253523840"/>
      </c:scatterChart>
      <c:valAx>
        <c:axId val="25352230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523840"/>
        <c:crosses val="autoZero"/>
        <c:crossBetween val="midCat"/>
        <c:majorUnit val="4"/>
      </c:valAx>
      <c:valAx>
        <c:axId val="253523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52230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223001061897496E-2"/>
          <c:y val="6.0659813356663754E-2"/>
          <c:w val="0.91744586518810678"/>
          <c:h val="0.84640595489390069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6!$K$24:$K$29</c:f>
                <c:numCache>
                  <c:formatCode>General</c:formatCode>
                  <c:ptCount val="6"/>
                  <c:pt idx="0">
                    <c:v>1.7292780688704522E-5</c:v>
                  </c:pt>
                  <c:pt idx="1">
                    <c:v>9.2126938628354246E-5</c:v>
                  </c:pt>
                  <c:pt idx="2">
                    <c:v>1.6666439334685974E-5</c:v>
                  </c:pt>
                  <c:pt idx="3">
                    <c:v>3.3826499515954286E-5</c:v>
                  </c:pt>
                  <c:pt idx="4">
                    <c:v>1.7166163811371163E-5</c:v>
                  </c:pt>
                  <c:pt idx="5">
                    <c:v>3.4504469018628216E-5</c:v>
                  </c:pt>
                </c:numCache>
              </c:numRef>
            </c:plus>
            <c:minus>
              <c:numRef>
                <c:f>Sheet6!$K$24:$K$29</c:f>
                <c:numCache>
                  <c:formatCode>General</c:formatCode>
                  <c:ptCount val="6"/>
                  <c:pt idx="0">
                    <c:v>1.7292780688704522E-5</c:v>
                  </c:pt>
                  <c:pt idx="1">
                    <c:v>9.2126938628354246E-5</c:v>
                  </c:pt>
                  <c:pt idx="2">
                    <c:v>1.6666439334685974E-5</c:v>
                  </c:pt>
                  <c:pt idx="3">
                    <c:v>3.3826499515954286E-5</c:v>
                  </c:pt>
                  <c:pt idx="4">
                    <c:v>1.7166163811371163E-5</c:v>
                  </c:pt>
                  <c:pt idx="5">
                    <c:v>3.4504469018628216E-5</c:v>
                  </c:pt>
                </c:numCache>
              </c:numRef>
            </c:minus>
          </c:errBars>
          <c:xVal>
            <c:numRef>
              <c:f>Sheet6!$H$24:$H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6!$I$24:$I$29</c:f>
              <c:numCache>
                <c:formatCode>General</c:formatCode>
                <c:ptCount val="6"/>
                <c:pt idx="0">
                  <c:v>1.5866702599371467E-4</c:v>
                </c:pt>
                <c:pt idx="1">
                  <c:v>3.6966753838826155E-4</c:v>
                </c:pt>
                <c:pt idx="2">
                  <c:v>3.1570090886290407E-4</c:v>
                </c:pt>
                <c:pt idx="3">
                  <c:v>2.2991206404220641E-4</c:v>
                </c:pt>
                <c:pt idx="4">
                  <c:v>1.4280975127691241E-4</c:v>
                </c:pt>
                <c:pt idx="5">
                  <c:v>1.2768898578199793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548032"/>
        <c:axId val="253549568"/>
      </c:scatterChart>
      <c:valAx>
        <c:axId val="253548032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549568"/>
        <c:crosses val="autoZero"/>
        <c:crossBetween val="midCat"/>
        <c:majorUnit val="4"/>
      </c:valAx>
      <c:valAx>
        <c:axId val="253549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5480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7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I$5:$I$22</c:f>
                <c:numCache>
                  <c:formatCode>General</c:formatCode>
                  <c:ptCount val="18"/>
                  <c:pt idx="0">
                    <c:v>2.565757474339321E-5</c:v>
                  </c:pt>
                  <c:pt idx="1">
                    <c:v>2.3331442496229193E-5</c:v>
                  </c:pt>
                  <c:pt idx="2">
                    <c:v>2.6954698496185391E-6</c:v>
                  </c:pt>
                  <c:pt idx="3">
                    <c:v>8.0326091678721668E-6</c:v>
                  </c:pt>
                  <c:pt idx="4">
                    <c:v>3.1747191257162164E-6</c:v>
                  </c:pt>
                  <c:pt idx="5">
                    <c:v>8.6387274407673208E-6</c:v>
                  </c:pt>
                  <c:pt idx="6">
                    <c:v>4.4219288267607391E-6</c:v>
                  </c:pt>
                  <c:pt idx="7">
                    <c:v>3.2819564568923789E-5</c:v>
                  </c:pt>
                  <c:pt idx="8">
                    <c:v>5.0579642247466714E-5</c:v>
                  </c:pt>
                  <c:pt idx="9">
                    <c:v>2.816040885949286E-5</c:v>
                  </c:pt>
                  <c:pt idx="10">
                    <c:v>1.4537178810760508E-6</c:v>
                  </c:pt>
                  <c:pt idx="11">
                    <c:v>7.8409667150179019E-7</c:v>
                  </c:pt>
                  <c:pt idx="12">
                    <c:v>2.9453224687929683E-6</c:v>
                  </c:pt>
                  <c:pt idx="13">
                    <c:v>1.8427365910940353E-5</c:v>
                  </c:pt>
                  <c:pt idx="14">
                    <c:v>5.9394786159893892E-6</c:v>
                  </c:pt>
                  <c:pt idx="15">
                    <c:v>6.3876621000067288E-6</c:v>
                  </c:pt>
                  <c:pt idx="16">
                    <c:v>3.8321724371351646E-6</c:v>
                  </c:pt>
                  <c:pt idx="17">
                    <c:v>9.4685374038563837E-6</c:v>
                  </c:pt>
                </c:numCache>
              </c:numRef>
            </c:plus>
            <c:minus>
              <c:numRef>
                <c:f>Sheet5!$I$5:$I$22</c:f>
                <c:numCache>
                  <c:formatCode>General</c:formatCode>
                  <c:ptCount val="18"/>
                  <c:pt idx="0">
                    <c:v>2.565757474339321E-5</c:v>
                  </c:pt>
                  <c:pt idx="1">
                    <c:v>2.3331442496229193E-5</c:v>
                  </c:pt>
                  <c:pt idx="2">
                    <c:v>2.6954698496185391E-6</c:v>
                  </c:pt>
                  <c:pt idx="3">
                    <c:v>8.0326091678721668E-6</c:v>
                  </c:pt>
                  <c:pt idx="4">
                    <c:v>3.1747191257162164E-6</c:v>
                  </c:pt>
                  <c:pt idx="5">
                    <c:v>8.6387274407673208E-6</c:v>
                  </c:pt>
                  <c:pt idx="6">
                    <c:v>4.4219288267607391E-6</c:v>
                  </c:pt>
                  <c:pt idx="7">
                    <c:v>3.2819564568923789E-5</c:v>
                  </c:pt>
                  <c:pt idx="8">
                    <c:v>5.0579642247466714E-5</c:v>
                  </c:pt>
                  <c:pt idx="9">
                    <c:v>2.816040885949286E-5</c:v>
                  </c:pt>
                  <c:pt idx="10">
                    <c:v>1.4537178810760508E-6</c:v>
                  </c:pt>
                  <c:pt idx="11">
                    <c:v>7.8409667150179019E-7</c:v>
                  </c:pt>
                  <c:pt idx="12">
                    <c:v>2.9453224687929683E-6</c:v>
                  </c:pt>
                  <c:pt idx="13">
                    <c:v>1.8427365910940353E-5</c:v>
                  </c:pt>
                  <c:pt idx="14">
                    <c:v>5.9394786159893892E-6</c:v>
                  </c:pt>
                  <c:pt idx="15">
                    <c:v>6.3876621000067288E-6</c:v>
                  </c:pt>
                  <c:pt idx="16">
                    <c:v>3.8321724371351646E-6</c:v>
                  </c:pt>
                  <c:pt idx="17">
                    <c:v>9.4685374038563837E-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5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5!$G$5:$G$22</c:f>
              <c:numCache>
                <c:formatCode>General</c:formatCode>
                <c:ptCount val="18"/>
                <c:pt idx="0">
                  <c:v>1.5344638293997366E-4</c:v>
                </c:pt>
                <c:pt idx="1">
                  <c:v>7.9341575605131211E-5</c:v>
                </c:pt>
                <c:pt idx="2">
                  <c:v>1.5387962231249171E-5</c:v>
                </c:pt>
                <c:pt idx="3">
                  <c:v>3.0938878340267388E-5</c:v>
                </c:pt>
                <c:pt idx="4">
                  <c:v>1.3477788314900242E-5</c:v>
                </c:pt>
                <c:pt idx="5">
                  <c:v>7.8162230948577429E-5</c:v>
                </c:pt>
                <c:pt idx="6">
                  <c:v>4.7402407988607035E-5</c:v>
                </c:pt>
                <c:pt idx="7">
                  <c:v>5.6015777744232316E-5</c:v>
                </c:pt>
                <c:pt idx="8">
                  <c:v>2.0068107664715821E-4</c:v>
                </c:pt>
                <c:pt idx="9">
                  <c:v>6.2484872926154693E-5</c:v>
                </c:pt>
                <c:pt idx="10">
                  <c:v>1.3708592671717396E-5</c:v>
                </c:pt>
                <c:pt idx="11">
                  <c:v>1.5124365206666586E-5</c:v>
                </c:pt>
                <c:pt idx="12">
                  <c:v>1.4444325823813247E-5</c:v>
                </c:pt>
                <c:pt idx="13">
                  <c:v>9.8542751209713066E-5</c:v>
                </c:pt>
                <c:pt idx="14">
                  <c:v>1.9495605725969476E-5</c:v>
                </c:pt>
                <c:pt idx="15">
                  <c:v>2.2296043378475164E-5</c:v>
                </c:pt>
                <c:pt idx="16">
                  <c:v>3.9001806482637652E-5</c:v>
                </c:pt>
                <c:pt idx="17">
                  <c:v>2.5523018396862954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561856"/>
        <c:axId val="253580032"/>
      </c:scatterChart>
      <c:valAx>
        <c:axId val="25356185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580032"/>
        <c:crosses val="autoZero"/>
        <c:crossBetween val="midCat"/>
        <c:majorUnit val="4"/>
      </c:valAx>
      <c:valAx>
        <c:axId val="253580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56185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039868172495062"/>
          <c:y val="0.12280261597652822"/>
          <c:w val="0.80412919463017341"/>
          <c:h val="0.7203222678174245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A$10</c:f>
              <c:strCache>
                <c:ptCount val="1"/>
                <c:pt idx="0">
                  <c:v>Bra015313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0:$K$10</c:f>
              <c:numCache>
                <c:formatCode>General</c:formatCode>
                <c:ptCount val="7"/>
                <c:pt idx="0">
                  <c:v>75.872999999999948</c:v>
                </c:pt>
                <c:pt idx="1">
                  <c:v>62.435000000000002</c:v>
                </c:pt>
                <c:pt idx="2">
                  <c:v>64.798500000000004</c:v>
                </c:pt>
                <c:pt idx="3">
                  <c:v>62.215500000000013</c:v>
                </c:pt>
                <c:pt idx="4">
                  <c:v>46.877499999999998</c:v>
                </c:pt>
                <c:pt idx="5">
                  <c:v>56.384499999999996</c:v>
                </c:pt>
                <c:pt idx="6">
                  <c:v>71.75350000000000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2!$A$11</c:f>
              <c:strCache>
                <c:ptCount val="1"/>
                <c:pt idx="0">
                  <c:v>Bra030568</c:v>
                </c:pt>
              </c:strCache>
            </c:strRef>
          </c:tx>
          <c:spPr>
            <a:ln w="165100"/>
          </c:spPr>
          <c:xVal>
            <c:numRef>
              <c:f>Sheet2!$E$2:$K$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E$11:$K$11</c:f>
              <c:numCache>
                <c:formatCode>General</c:formatCode>
                <c:ptCount val="7"/>
                <c:pt idx="0">
                  <c:v>45.645000000000003</c:v>
                </c:pt>
                <c:pt idx="1">
                  <c:v>39.858499999999999</c:v>
                </c:pt>
                <c:pt idx="2">
                  <c:v>38.062000000000012</c:v>
                </c:pt>
                <c:pt idx="3">
                  <c:v>46.68</c:v>
                </c:pt>
                <c:pt idx="4">
                  <c:v>41.703000000000003</c:v>
                </c:pt>
                <c:pt idx="5">
                  <c:v>46.788500000000013</c:v>
                </c:pt>
                <c:pt idx="6">
                  <c:v>43.60850000000004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604160"/>
        <c:axId val="250614144"/>
      </c:scatterChart>
      <c:valAx>
        <c:axId val="250604160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0614144"/>
        <c:crosses val="autoZero"/>
        <c:crossBetween val="midCat"/>
        <c:majorUnit val="4"/>
      </c:valAx>
      <c:valAx>
        <c:axId val="250614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60416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8178861788617985"/>
          <c:y val="0.56653543580450072"/>
          <c:w val="0.40673769943378979"/>
          <c:h val="0.2673735080300789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  <c:userShapes r:id="rId2"/>
</c:chartSpace>
</file>

<file path=ppt/charts/chart8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I$24:$I$29</c:f>
                <c:numCache>
                  <c:formatCode>General</c:formatCode>
                  <c:ptCount val="6"/>
                  <c:pt idx="0">
                    <c:v>1.0458294828930433E-5</c:v>
                  </c:pt>
                  <c:pt idx="1">
                    <c:v>1.1636938636660635E-5</c:v>
                  </c:pt>
                  <c:pt idx="2">
                    <c:v>2.4889312311551056E-5</c:v>
                  </c:pt>
                  <c:pt idx="3">
                    <c:v>5.5257063544429914E-5</c:v>
                  </c:pt>
                  <c:pt idx="4">
                    <c:v>1.0666038430004019E-5</c:v>
                  </c:pt>
                  <c:pt idx="5">
                    <c:v>1.9101987536614046E-5</c:v>
                  </c:pt>
                </c:numCache>
              </c:numRef>
            </c:plus>
            <c:minus>
              <c:numRef>
                <c:f>Sheet5!$I$24:$I$29</c:f>
                <c:numCache>
                  <c:formatCode>General</c:formatCode>
                  <c:ptCount val="6"/>
                  <c:pt idx="0">
                    <c:v>1.0458294828930433E-5</c:v>
                  </c:pt>
                  <c:pt idx="1">
                    <c:v>1.1636938636660635E-5</c:v>
                  </c:pt>
                  <c:pt idx="2">
                    <c:v>2.4889312311551056E-5</c:v>
                  </c:pt>
                  <c:pt idx="3">
                    <c:v>5.5257063544429914E-5</c:v>
                  </c:pt>
                  <c:pt idx="4">
                    <c:v>1.0666038430004019E-5</c:v>
                  </c:pt>
                  <c:pt idx="5">
                    <c:v>1.9101987536614046E-5</c:v>
                  </c:pt>
                </c:numCache>
              </c:numRef>
            </c:minus>
          </c:errBars>
          <c:xVal>
            <c:numRef>
              <c:f>Sheet5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5!$G$24:$G$29</c:f>
              <c:numCache>
                <c:formatCode>General</c:formatCode>
                <c:ptCount val="6"/>
                <c:pt idx="0">
                  <c:v>7.1359684417188213E-5</c:v>
                </c:pt>
                <c:pt idx="1">
                  <c:v>7.2654268611167488E-5</c:v>
                </c:pt>
                <c:pt idx="2">
                  <c:v>1.9496312442492721E-4</c:v>
                </c:pt>
                <c:pt idx="3">
                  <c:v>2.822618822207684E-4</c:v>
                </c:pt>
                <c:pt idx="4">
                  <c:v>5.153324791491277E-5</c:v>
                </c:pt>
                <c:pt idx="5">
                  <c:v>9.370629983642629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616512"/>
        <c:axId val="253618048"/>
      </c:scatterChart>
      <c:valAx>
        <c:axId val="25361651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618048"/>
        <c:crosses val="autoZero"/>
        <c:crossBetween val="midCat"/>
        <c:majorUnit val="4"/>
      </c:valAx>
      <c:valAx>
        <c:axId val="253618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61651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27664246456278"/>
          <c:y val="7.4825199797425107E-2"/>
          <c:w val="0.86725617088297369"/>
          <c:h val="0.73035535734124779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2!$F$6:$F$1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2!$G$6:$G$11</c:f>
              <c:numCache>
                <c:formatCode>General</c:formatCode>
                <c:ptCount val="6"/>
                <c:pt idx="0">
                  <c:v>2.2685141035300085E-2</c:v>
                </c:pt>
                <c:pt idx="1">
                  <c:v>1.9742618026895562E-2</c:v>
                </c:pt>
                <c:pt idx="2">
                  <c:v>2.3914657078281703E-2</c:v>
                </c:pt>
                <c:pt idx="3">
                  <c:v>3.6096753741861359E-2</c:v>
                </c:pt>
                <c:pt idx="4">
                  <c:v>2.8580310620946493E-2</c:v>
                </c:pt>
                <c:pt idx="5">
                  <c:v>3.2289714498904339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702912"/>
        <c:axId val="253704832"/>
      </c:scatterChart>
      <c:valAx>
        <c:axId val="25370291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704832"/>
        <c:crosses val="autoZero"/>
        <c:crossBetween val="midCat"/>
        <c:majorUnit val="4"/>
      </c:valAx>
      <c:valAx>
        <c:axId val="2537048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70291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xVal>
            <c:numRef>
              <c:f>Sheet2!$F$6:$F$23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2!$G$6:$G$23</c:f>
              <c:numCache>
                <c:formatCode>General</c:formatCode>
                <c:ptCount val="18"/>
                <c:pt idx="0">
                  <c:v>2.2685141035300085E-2</c:v>
                </c:pt>
                <c:pt idx="1">
                  <c:v>1.9742618026895562E-2</c:v>
                </c:pt>
                <c:pt idx="2">
                  <c:v>2.3914657078281703E-2</c:v>
                </c:pt>
                <c:pt idx="3">
                  <c:v>3.6096753741861359E-2</c:v>
                </c:pt>
                <c:pt idx="4">
                  <c:v>2.8580310620946493E-2</c:v>
                </c:pt>
                <c:pt idx="5">
                  <c:v>3.2289714498904339E-2</c:v>
                </c:pt>
                <c:pt idx="6">
                  <c:v>2.4550458004708002E-2</c:v>
                </c:pt>
                <c:pt idx="7">
                  <c:v>6.9827682884403164E-2</c:v>
                </c:pt>
                <c:pt idx="8">
                  <c:v>2.6586289589582878E-2</c:v>
                </c:pt>
                <c:pt idx="9">
                  <c:v>1.984404643213988E-2</c:v>
                </c:pt>
                <c:pt idx="10">
                  <c:v>2.3542313231755457E-2</c:v>
                </c:pt>
                <c:pt idx="11">
                  <c:v>2.7582278129617558E-2</c:v>
                </c:pt>
                <c:pt idx="12">
                  <c:v>2.4299885147491481E-2</c:v>
                </c:pt>
                <c:pt idx="13">
                  <c:v>2.9507658001316304E-2</c:v>
                </c:pt>
                <c:pt idx="14">
                  <c:v>2.8068862119992197E-2</c:v>
                </c:pt>
                <c:pt idx="15">
                  <c:v>3.1789820609906247E-2</c:v>
                </c:pt>
                <c:pt idx="16">
                  <c:v>2.4867150014551177E-2</c:v>
                </c:pt>
                <c:pt idx="17">
                  <c:v>2.5535722014452755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724160"/>
        <c:axId val="253726080"/>
      </c:scatterChart>
      <c:valAx>
        <c:axId val="253724160"/>
        <c:scaling>
          <c:orientation val="minMax"/>
          <c:max val="68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726080"/>
        <c:crosses val="autoZero"/>
        <c:crossBetween val="midCat"/>
        <c:majorUnit val="4"/>
      </c:valAx>
      <c:valAx>
        <c:axId val="253726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72416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I$5:$I$22</c:f>
                <c:numCache>
                  <c:formatCode>General</c:formatCode>
                  <c:ptCount val="18"/>
                  <c:pt idx="0">
                    <c:v>2.1620717654795653E-5</c:v>
                  </c:pt>
                  <c:pt idx="1">
                    <c:v>5.4889470250197793E-5</c:v>
                  </c:pt>
                  <c:pt idx="2">
                    <c:v>1.9683724839277962E-6</c:v>
                  </c:pt>
                  <c:pt idx="3">
                    <c:v>1.0852595387258088E-6</c:v>
                  </c:pt>
                  <c:pt idx="4">
                    <c:v>3.0508880601445679E-7</c:v>
                  </c:pt>
                  <c:pt idx="5">
                    <c:v>2.1109367319755146E-7</c:v>
                  </c:pt>
                  <c:pt idx="6">
                    <c:v>1.2579372081672061E-6</c:v>
                  </c:pt>
                  <c:pt idx="7">
                    <c:v>1.1864723056912206E-5</c:v>
                  </c:pt>
                  <c:pt idx="8">
                    <c:v>8.3861676772606894E-6</c:v>
                  </c:pt>
                  <c:pt idx="9">
                    <c:v>2.4207384135540852E-6</c:v>
                  </c:pt>
                  <c:pt idx="10">
                    <c:v>2.5799043542062194E-7</c:v>
                  </c:pt>
                  <c:pt idx="11">
                    <c:v>1.055228235456506E-6</c:v>
                  </c:pt>
                  <c:pt idx="12">
                    <c:v>4.0905800411027114E-6</c:v>
                  </c:pt>
                  <c:pt idx="13">
                    <c:v>2.0333244401865309E-5</c:v>
                  </c:pt>
                  <c:pt idx="14">
                    <c:v>2.4075027396206796E-6</c:v>
                  </c:pt>
                  <c:pt idx="15">
                    <c:v>1.0178928908011749E-6</c:v>
                  </c:pt>
                  <c:pt idx="16">
                    <c:v>9.6726316651695103E-7</c:v>
                  </c:pt>
                  <c:pt idx="17">
                    <c:v>9.3895665980439661E-6</c:v>
                  </c:pt>
                </c:numCache>
              </c:numRef>
            </c:plus>
            <c:minus>
              <c:numRef>
                <c:f>Sheet5!$I$5:$I$22</c:f>
                <c:numCache>
                  <c:formatCode>General</c:formatCode>
                  <c:ptCount val="18"/>
                  <c:pt idx="0">
                    <c:v>2.1620717654795653E-5</c:v>
                  </c:pt>
                  <c:pt idx="1">
                    <c:v>5.4889470250197793E-5</c:v>
                  </c:pt>
                  <c:pt idx="2">
                    <c:v>1.9683724839277962E-6</c:v>
                  </c:pt>
                  <c:pt idx="3">
                    <c:v>1.0852595387258088E-6</c:v>
                  </c:pt>
                  <c:pt idx="4">
                    <c:v>3.0508880601445679E-7</c:v>
                  </c:pt>
                  <c:pt idx="5">
                    <c:v>2.1109367319755146E-7</c:v>
                  </c:pt>
                  <c:pt idx="6">
                    <c:v>1.2579372081672061E-6</c:v>
                  </c:pt>
                  <c:pt idx="7">
                    <c:v>1.1864723056912206E-5</c:v>
                  </c:pt>
                  <c:pt idx="8">
                    <c:v>8.3861676772606894E-6</c:v>
                  </c:pt>
                  <c:pt idx="9">
                    <c:v>2.4207384135540852E-6</c:v>
                  </c:pt>
                  <c:pt idx="10">
                    <c:v>2.5799043542062194E-7</c:v>
                  </c:pt>
                  <c:pt idx="11">
                    <c:v>1.055228235456506E-6</c:v>
                  </c:pt>
                  <c:pt idx="12">
                    <c:v>4.0905800411027114E-6</c:v>
                  </c:pt>
                  <c:pt idx="13">
                    <c:v>2.0333244401865309E-5</c:v>
                  </c:pt>
                  <c:pt idx="14">
                    <c:v>2.4075027396206796E-6</c:v>
                  </c:pt>
                  <c:pt idx="15">
                    <c:v>1.0178928908011749E-6</c:v>
                  </c:pt>
                  <c:pt idx="16">
                    <c:v>9.6726316651695103E-7</c:v>
                  </c:pt>
                  <c:pt idx="17">
                    <c:v>9.3895665980439661E-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5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5!$G$5:$G$22</c:f>
              <c:numCache>
                <c:formatCode>General</c:formatCode>
                <c:ptCount val="18"/>
                <c:pt idx="0">
                  <c:v>9.0545106660908507E-5</c:v>
                </c:pt>
                <c:pt idx="1">
                  <c:v>1.8484953911310985E-4</c:v>
                </c:pt>
                <c:pt idx="2">
                  <c:v>8.6985442081892976E-6</c:v>
                </c:pt>
                <c:pt idx="3">
                  <c:v>3.4409975044669333E-6</c:v>
                </c:pt>
                <c:pt idx="4">
                  <c:v>1.0650997916707437E-6</c:v>
                </c:pt>
                <c:pt idx="5">
                  <c:v>5.4532704374935925E-6</c:v>
                </c:pt>
                <c:pt idx="6">
                  <c:v>4.1822421343168607E-5</c:v>
                </c:pt>
                <c:pt idx="7">
                  <c:v>2.6664324837287248E-5</c:v>
                </c:pt>
                <c:pt idx="8">
                  <c:v>1.15857819542197E-4</c:v>
                </c:pt>
                <c:pt idx="9">
                  <c:v>8.4582673167478924E-6</c:v>
                </c:pt>
                <c:pt idx="10">
                  <c:v>1.723162896100831E-6</c:v>
                </c:pt>
                <c:pt idx="11">
                  <c:v>6.9218624347315227E-6</c:v>
                </c:pt>
                <c:pt idx="12">
                  <c:v>1.7718306042283308E-5</c:v>
                </c:pt>
                <c:pt idx="13">
                  <c:v>1.3001915936389701E-4</c:v>
                </c:pt>
                <c:pt idx="14">
                  <c:v>1.0079555338281399E-5</c:v>
                </c:pt>
                <c:pt idx="15">
                  <c:v>3.0205777598331351E-6</c:v>
                </c:pt>
                <c:pt idx="16">
                  <c:v>5.3009315930360913E-6</c:v>
                </c:pt>
                <c:pt idx="17">
                  <c:v>2.0613174654111852E-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661952"/>
        <c:axId val="253663488"/>
      </c:scatterChart>
      <c:valAx>
        <c:axId val="253661952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663488"/>
        <c:crosses val="autoZero"/>
        <c:crossBetween val="midCat"/>
        <c:majorUnit val="4"/>
      </c:valAx>
      <c:valAx>
        <c:axId val="25366348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66195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436068972134437"/>
          <c:y val="7.4825199797425107E-2"/>
          <c:w val="0.82104032317116282"/>
          <c:h val="0.73035535734124779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5!$I$24:$I$29</c:f>
                <c:numCache>
                  <c:formatCode>General</c:formatCode>
                  <c:ptCount val="6"/>
                  <c:pt idx="0">
                    <c:v>1.5291879163247473E-6</c:v>
                  </c:pt>
                  <c:pt idx="1">
                    <c:v>7.6288167483420072E-6</c:v>
                  </c:pt>
                  <c:pt idx="2">
                    <c:v>5.3624025524967404E-6</c:v>
                  </c:pt>
                  <c:pt idx="3">
                    <c:v>3.0584896986661695E-6</c:v>
                  </c:pt>
                  <c:pt idx="4">
                    <c:v>1.2457866018682861E-6</c:v>
                  </c:pt>
                  <c:pt idx="5">
                    <c:v>1.339856021650942E-6</c:v>
                  </c:pt>
                </c:numCache>
              </c:numRef>
            </c:plus>
            <c:minus>
              <c:numRef>
                <c:f>Sheet5!$I$24:$I$29</c:f>
                <c:numCache>
                  <c:formatCode>General</c:formatCode>
                  <c:ptCount val="6"/>
                  <c:pt idx="0">
                    <c:v>1.5291879163247473E-6</c:v>
                  </c:pt>
                  <c:pt idx="1">
                    <c:v>7.6288167483420072E-6</c:v>
                  </c:pt>
                  <c:pt idx="2">
                    <c:v>5.3624025524967404E-6</c:v>
                  </c:pt>
                  <c:pt idx="3">
                    <c:v>3.0584896986661695E-6</c:v>
                  </c:pt>
                  <c:pt idx="4">
                    <c:v>1.2457866018682861E-6</c:v>
                  </c:pt>
                  <c:pt idx="5">
                    <c:v>1.339856021650942E-6</c:v>
                  </c:pt>
                </c:numCache>
              </c:numRef>
            </c:minus>
          </c:errBars>
          <c:xVal>
            <c:numRef>
              <c:f>Sheet5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5!$G$24:$G$29</c:f>
              <c:numCache>
                <c:formatCode>General</c:formatCode>
                <c:ptCount val="6"/>
                <c:pt idx="0">
                  <c:v>4.1077534275456369E-5</c:v>
                </c:pt>
                <c:pt idx="1">
                  <c:v>1.0277291837304306E-4</c:v>
                </c:pt>
                <c:pt idx="2">
                  <c:v>6.0266183087366687E-5</c:v>
                </c:pt>
                <c:pt idx="3">
                  <c:v>1.9785633778127958E-5</c:v>
                </c:pt>
                <c:pt idx="4">
                  <c:v>7.618478873523396E-6</c:v>
                </c:pt>
                <c:pt idx="5">
                  <c:v>8.1368483775146727E-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675392"/>
        <c:axId val="253676928"/>
      </c:scatterChart>
      <c:valAx>
        <c:axId val="25367539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676928"/>
        <c:crosses val="autoZero"/>
        <c:crossBetween val="midCat"/>
        <c:majorUnit val="4"/>
      </c:valAx>
      <c:valAx>
        <c:axId val="253676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67539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J$5:$J$22</c:f>
                <c:numCache>
                  <c:formatCode>General</c:formatCode>
                  <c:ptCount val="18"/>
                  <c:pt idx="0">
                    <c:v>1.8270174593899432E-6</c:v>
                  </c:pt>
                  <c:pt idx="1">
                    <c:v>1.0139392240381856E-2</c:v>
                  </c:pt>
                  <c:pt idx="2">
                    <c:v>2.6908753364161988E-3</c:v>
                  </c:pt>
                  <c:pt idx="3">
                    <c:v>1.2943427409103051E-3</c:v>
                  </c:pt>
                  <c:pt idx="4">
                    <c:v>2.9028130147021791E-4</c:v>
                  </c:pt>
                  <c:pt idx="5">
                    <c:v>1.3023830759713442E-4</c:v>
                  </c:pt>
                  <c:pt idx="6">
                    <c:v>5.1241607848788993E-4</c:v>
                  </c:pt>
                  <c:pt idx="7">
                    <c:v>1.6435020242504931E-3</c:v>
                  </c:pt>
                  <c:pt idx="8">
                    <c:v>1.2380243170289258E-3</c:v>
                  </c:pt>
                  <c:pt idx="9">
                    <c:v>2.5687761060165038E-3</c:v>
                  </c:pt>
                  <c:pt idx="10">
                    <c:v>3.7787879720262607E-4</c:v>
                  </c:pt>
                  <c:pt idx="11">
                    <c:v>2.4518134416423446E-4</c:v>
                  </c:pt>
                  <c:pt idx="12">
                    <c:v>3.3942376297108214E-5</c:v>
                  </c:pt>
                  <c:pt idx="13">
                    <c:v>2.7379140124561573E-3</c:v>
                  </c:pt>
                  <c:pt idx="14">
                    <c:v>2.7081762480440103E-2</c:v>
                  </c:pt>
                  <c:pt idx="15">
                    <c:v>6.397631291718487E-3</c:v>
                  </c:pt>
                  <c:pt idx="16">
                    <c:v>1.0250466011780261E-3</c:v>
                  </c:pt>
                  <c:pt idx="17">
                    <c:v>1.4806754139015817E-3</c:v>
                  </c:pt>
                </c:numCache>
              </c:numRef>
            </c:plus>
            <c:minus>
              <c:numRef>
                <c:f>Sheet2!$J$5:$J$22</c:f>
                <c:numCache>
                  <c:formatCode>General</c:formatCode>
                  <c:ptCount val="18"/>
                  <c:pt idx="0">
                    <c:v>1.8270174593899432E-6</c:v>
                  </c:pt>
                  <c:pt idx="1">
                    <c:v>1.0139392240381856E-2</c:v>
                  </c:pt>
                  <c:pt idx="2">
                    <c:v>2.6908753364161988E-3</c:v>
                  </c:pt>
                  <c:pt idx="3">
                    <c:v>1.2943427409103051E-3</c:v>
                  </c:pt>
                  <c:pt idx="4">
                    <c:v>2.9028130147021791E-4</c:v>
                  </c:pt>
                  <c:pt idx="5">
                    <c:v>1.3023830759713442E-4</c:v>
                  </c:pt>
                  <c:pt idx="6">
                    <c:v>5.1241607848788993E-4</c:v>
                  </c:pt>
                  <c:pt idx="7">
                    <c:v>1.6435020242504931E-3</c:v>
                  </c:pt>
                  <c:pt idx="8">
                    <c:v>1.2380243170289258E-3</c:v>
                  </c:pt>
                  <c:pt idx="9">
                    <c:v>2.5687761060165038E-3</c:v>
                  </c:pt>
                  <c:pt idx="10">
                    <c:v>3.7787879720262607E-4</c:v>
                  </c:pt>
                  <c:pt idx="11">
                    <c:v>2.4518134416423446E-4</c:v>
                  </c:pt>
                  <c:pt idx="12">
                    <c:v>3.3942376297108214E-5</c:v>
                  </c:pt>
                  <c:pt idx="13">
                    <c:v>2.7379140124561573E-3</c:v>
                  </c:pt>
                  <c:pt idx="14">
                    <c:v>2.7081762480440103E-2</c:v>
                  </c:pt>
                  <c:pt idx="15">
                    <c:v>6.397631291718487E-3</c:v>
                  </c:pt>
                  <c:pt idx="16">
                    <c:v>1.0250466011780261E-3</c:v>
                  </c:pt>
                  <c:pt idx="17">
                    <c:v>1.4806754139015817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2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2!$H$5:$H$22</c:f>
              <c:numCache>
                <c:formatCode>General</c:formatCode>
                <c:ptCount val="18"/>
                <c:pt idx="0">
                  <c:v>9.4436516698864537E-6</c:v>
                </c:pt>
                <c:pt idx="1">
                  <c:v>6.3413600456595748E-2</c:v>
                </c:pt>
                <c:pt idx="2">
                  <c:v>5.6976309973490319E-2</c:v>
                </c:pt>
                <c:pt idx="3">
                  <c:v>1.3389322082915161E-2</c:v>
                </c:pt>
                <c:pt idx="4">
                  <c:v>1.459215042992348E-3</c:v>
                </c:pt>
                <c:pt idx="5">
                  <c:v>6.322160049053693E-4</c:v>
                </c:pt>
                <c:pt idx="6">
                  <c:v>4.0215360935919684E-3</c:v>
                </c:pt>
                <c:pt idx="7">
                  <c:v>9.2212812313667552E-3</c:v>
                </c:pt>
                <c:pt idx="8">
                  <c:v>0.12272319277132414</c:v>
                </c:pt>
                <c:pt idx="9">
                  <c:v>2.0851275707161648E-2</c:v>
                </c:pt>
                <c:pt idx="10">
                  <c:v>2.5528960656336624E-3</c:v>
                </c:pt>
                <c:pt idx="11">
                  <c:v>2.0527131966051131E-3</c:v>
                </c:pt>
                <c:pt idx="12">
                  <c:v>2.8998190141167829E-4</c:v>
                </c:pt>
                <c:pt idx="13">
                  <c:v>4.4255296177800496E-2</c:v>
                </c:pt>
                <c:pt idx="14">
                  <c:v>0.18514779765445374</c:v>
                </c:pt>
                <c:pt idx="15">
                  <c:v>1.7600518699918584E-2</c:v>
                </c:pt>
                <c:pt idx="16">
                  <c:v>4.8058332374906294E-3</c:v>
                </c:pt>
                <c:pt idx="17">
                  <c:v>5.6529863678087544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250944"/>
        <c:axId val="253256832"/>
      </c:scatterChart>
      <c:valAx>
        <c:axId val="25325094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256832"/>
        <c:crosses val="autoZero"/>
        <c:crossBetween val="midCat"/>
        <c:majorUnit val="4"/>
      </c:valAx>
      <c:valAx>
        <c:axId val="253256832"/>
        <c:scaling>
          <c:orientation val="minMax"/>
          <c:max val="0.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2509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214235999921578"/>
          <c:y val="7.580974190002282E-2"/>
          <c:w val="0.85720312122182507"/>
          <c:h val="0.84838051619995469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J$24:$J$29</c:f>
                <c:numCache>
                  <c:formatCode>General</c:formatCode>
                  <c:ptCount val="6"/>
                  <c:pt idx="0">
                    <c:v>4.4559864077222932E-5</c:v>
                  </c:pt>
                  <c:pt idx="1">
                    <c:v>6.7838254758874534E-4</c:v>
                  </c:pt>
                  <c:pt idx="2">
                    <c:v>2.1851961299428256E-2</c:v>
                  </c:pt>
                  <c:pt idx="3">
                    <c:v>1.5195248831868101E-3</c:v>
                  </c:pt>
                  <c:pt idx="4">
                    <c:v>1.5328139428559769E-5</c:v>
                  </c:pt>
                  <c:pt idx="5">
                    <c:v>1.8848513789985647E-5</c:v>
                  </c:pt>
                </c:numCache>
              </c:numRef>
            </c:plus>
            <c:minus>
              <c:numRef>
                <c:f>Sheet2!$J$24:$J$29</c:f>
                <c:numCache>
                  <c:formatCode>General</c:formatCode>
                  <c:ptCount val="6"/>
                  <c:pt idx="0">
                    <c:v>4.4559864077222932E-5</c:v>
                  </c:pt>
                  <c:pt idx="1">
                    <c:v>6.7838254758874534E-4</c:v>
                  </c:pt>
                  <c:pt idx="2">
                    <c:v>2.1851961299428256E-2</c:v>
                  </c:pt>
                  <c:pt idx="3">
                    <c:v>1.5195248831868101E-3</c:v>
                  </c:pt>
                  <c:pt idx="4">
                    <c:v>1.5328139428559769E-5</c:v>
                  </c:pt>
                  <c:pt idx="5">
                    <c:v>1.8848513789985647E-5</c:v>
                  </c:pt>
                </c:numCache>
              </c:numRef>
            </c:minus>
          </c:errBars>
          <c:xVal>
            <c:numRef>
              <c:f>Sheet2!$G$24:$G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2!$H$24:$H$29</c:f>
              <c:numCache>
                <c:formatCode>General</c:formatCode>
                <c:ptCount val="6"/>
                <c:pt idx="0">
                  <c:v>2.5694698554825431E-4</c:v>
                </c:pt>
                <c:pt idx="1">
                  <c:v>1.7524937796763267E-2</c:v>
                </c:pt>
                <c:pt idx="2">
                  <c:v>0.28553336167756188</c:v>
                </c:pt>
                <c:pt idx="3">
                  <c:v>5.0694268307670799E-2</c:v>
                </c:pt>
                <c:pt idx="4">
                  <c:v>1.6745048991755716E-4</c:v>
                </c:pt>
                <c:pt idx="5">
                  <c:v>1.5038904930815181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305600"/>
        <c:axId val="253307136"/>
      </c:scatterChart>
      <c:valAx>
        <c:axId val="253305600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307136"/>
        <c:crosses val="autoZero"/>
        <c:crossBetween val="midCat"/>
        <c:majorUnit val="4"/>
      </c:valAx>
      <c:valAx>
        <c:axId val="253307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30560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K$4:$K$21</c:f>
                <c:numCache>
                  <c:formatCode>General</c:formatCode>
                  <c:ptCount val="18"/>
                  <c:pt idx="0">
                    <c:v>6.3652130170305504E-5</c:v>
                  </c:pt>
                  <c:pt idx="1">
                    <c:v>3.5309769990096392E-3</c:v>
                  </c:pt>
                  <c:pt idx="2">
                    <c:v>2.4020077059623641E-4</c:v>
                  </c:pt>
                  <c:pt idx="3">
                    <c:v>4.4902496634763452E-4</c:v>
                  </c:pt>
                  <c:pt idx="4">
                    <c:v>1.1627807766632649E-3</c:v>
                  </c:pt>
                  <c:pt idx="5">
                    <c:v>6.9683309176925441E-4</c:v>
                  </c:pt>
                  <c:pt idx="6">
                    <c:v>4.6390547882870815E-4</c:v>
                  </c:pt>
                  <c:pt idx="7">
                    <c:v>7.438575981804609E-4</c:v>
                  </c:pt>
                  <c:pt idx="8">
                    <c:v>4.2242879307878518E-4</c:v>
                  </c:pt>
                  <c:pt idx="9">
                    <c:v>1.2928437032020581E-3</c:v>
                  </c:pt>
                  <c:pt idx="10">
                    <c:v>2.8787951246490987E-3</c:v>
                  </c:pt>
                  <c:pt idx="11">
                    <c:v>2.7935348133354674E-3</c:v>
                  </c:pt>
                  <c:pt idx="12">
                    <c:v>5.3595188064348583E-5</c:v>
                  </c:pt>
                  <c:pt idx="13">
                    <c:v>1.9565995713791821E-3</c:v>
                  </c:pt>
                  <c:pt idx="14">
                    <c:v>1.0886342155610419E-2</c:v>
                  </c:pt>
                  <c:pt idx="15">
                    <c:v>5.4676099295209784E-3</c:v>
                  </c:pt>
                  <c:pt idx="16">
                    <c:v>7.9747730674726743E-3</c:v>
                  </c:pt>
                  <c:pt idx="17">
                    <c:v>8.4386383595776073E-3</c:v>
                  </c:pt>
                </c:numCache>
              </c:numRef>
            </c:plus>
            <c:minus>
              <c:numRef>
                <c:f>Sheet4!$K$4:$K$21</c:f>
                <c:numCache>
                  <c:formatCode>General</c:formatCode>
                  <c:ptCount val="18"/>
                  <c:pt idx="0">
                    <c:v>6.3652130170305504E-5</c:v>
                  </c:pt>
                  <c:pt idx="1">
                    <c:v>3.5309769990096392E-3</c:v>
                  </c:pt>
                  <c:pt idx="2">
                    <c:v>2.4020077059623641E-4</c:v>
                  </c:pt>
                  <c:pt idx="3">
                    <c:v>4.4902496634763452E-4</c:v>
                  </c:pt>
                  <c:pt idx="4">
                    <c:v>1.1627807766632649E-3</c:v>
                  </c:pt>
                  <c:pt idx="5">
                    <c:v>6.9683309176925441E-4</c:v>
                  </c:pt>
                  <c:pt idx="6">
                    <c:v>4.6390547882870815E-4</c:v>
                  </c:pt>
                  <c:pt idx="7">
                    <c:v>7.438575981804609E-4</c:v>
                  </c:pt>
                  <c:pt idx="8">
                    <c:v>4.2242879307878518E-4</c:v>
                  </c:pt>
                  <c:pt idx="9">
                    <c:v>1.2928437032020581E-3</c:v>
                  </c:pt>
                  <c:pt idx="10">
                    <c:v>2.8787951246490987E-3</c:v>
                  </c:pt>
                  <c:pt idx="11">
                    <c:v>2.7935348133354674E-3</c:v>
                  </c:pt>
                  <c:pt idx="12">
                    <c:v>5.3595188064348583E-5</c:v>
                  </c:pt>
                  <c:pt idx="13">
                    <c:v>1.9565995713791821E-3</c:v>
                  </c:pt>
                  <c:pt idx="14">
                    <c:v>1.0886342155610419E-2</c:v>
                  </c:pt>
                  <c:pt idx="15">
                    <c:v>5.4676099295209784E-3</c:v>
                  </c:pt>
                  <c:pt idx="16">
                    <c:v>7.9747730674726743E-3</c:v>
                  </c:pt>
                  <c:pt idx="17">
                    <c:v>8.4386383595776073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H$4:$H$21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I$4:$I$21</c:f>
              <c:numCache>
                <c:formatCode>General</c:formatCode>
                <c:ptCount val="18"/>
                <c:pt idx="0">
                  <c:v>2.806432715164401E-4</c:v>
                </c:pt>
                <c:pt idx="1">
                  <c:v>1.2389169010695301E-2</c:v>
                </c:pt>
                <c:pt idx="2">
                  <c:v>3.5368226822792741E-3</c:v>
                </c:pt>
                <c:pt idx="3">
                  <c:v>5.9550963085109572E-3</c:v>
                </c:pt>
                <c:pt idx="4">
                  <c:v>5.4138182479662785E-3</c:v>
                </c:pt>
                <c:pt idx="5">
                  <c:v>4.5051414530696832E-3</c:v>
                </c:pt>
                <c:pt idx="6">
                  <c:v>1.0210810424250706E-2</c:v>
                </c:pt>
                <c:pt idx="7">
                  <c:v>3.9705411402984891E-3</c:v>
                </c:pt>
                <c:pt idx="8">
                  <c:v>7.3138879977182178E-3</c:v>
                </c:pt>
                <c:pt idx="9">
                  <c:v>1.5913294655507691E-2</c:v>
                </c:pt>
                <c:pt idx="10">
                  <c:v>1.0453765810246637E-2</c:v>
                </c:pt>
                <c:pt idx="11">
                  <c:v>1.0248998028509412E-2</c:v>
                </c:pt>
                <c:pt idx="12">
                  <c:v>1.6427817872023581E-4</c:v>
                </c:pt>
                <c:pt idx="13">
                  <c:v>9.1117584757086523E-3</c:v>
                </c:pt>
                <c:pt idx="14">
                  <c:v>5.3381940218929773E-2</c:v>
                </c:pt>
                <c:pt idx="15">
                  <c:v>1.7203198978433431E-2</c:v>
                </c:pt>
                <c:pt idx="16">
                  <c:v>5.4228128180287348E-2</c:v>
                </c:pt>
                <c:pt idx="17">
                  <c:v>2.4758242506835011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339904"/>
        <c:axId val="253349888"/>
      </c:scatterChart>
      <c:valAx>
        <c:axId val="25333990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349888"/>
        <c:crosses val="autoZero"/>
        <c:crossBetween val="midCat"/>
        <c:majorUnit val="4"/>
      </c:valAx>
      <c:valAx>
        <c:axId val="2533498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33990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664929367822029"/>
          <c:y val="7.6820538458689774E-2"/>
          <c:w val="0.86287545373451235"/>
          <c:h val="0.73492278635707164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K$23:$K$28</c:f>
                <c:numCache>
                  <c:formatCode>General</c:formatCode>
                  <c:ptCount val="6"/>
                  <c:pt idx="0">
                    <c:v>6.6674646905171822E-4</c:v>
                  </c:pt>
                  <c:pt idx="1">
                    <c:v>2.4214935190709492E-4</c:v>
                  </c:pt>
                  <c:pt idx="2">
                    <c:v>3.1936224941954042E-4</c:v>
                  </c:pt>
                  <c:pt idx="3">
                    <c:v>5.318952764353013E-4</c:v>
                  </c:pt>
                  <c:pt idx="4">
                    <c:v>2.5821570013218813E-3</c:v>
                  </c:pt>
                  <c:pt idx="5">
                    <c:v>6.7811763022695938E-3</c:v>
                  </c:pt>
                </c:numCache>
              </c:numRef>
            </c:plus>
            <c:minus>
              <c:numRef>
                <c:f>Sheet4!$K$23:$K$28</c:f>
                <c:numCache>
                  <c:formatCode>General</c:formatCode>
                  <c:ptCount val="6"/>
                  <c:pt idx="0">
                    <c:v>6.6674646905171822E-4</c:v>
                  </c:pt>
                  <c:pt idx="1">
                    <c:v>2.4214935190709492E-4</c:v>
                  </c:pt>
                  <c:pt idx="2">
                    <c:v>3.1936224941954042E-4</c:v>
                  </c:pt>
                  <c:pt idx="3">
                    <c:v>5.318952764353013E-4</c:v>
                  </c:pt>
                  <c:pt idx="4">
                    <c:v>2.5821570013218813E-3</c:v>
                  </c:pt>
                  <c:pt idx="5">
                    <c:v>6.7811763022695938E-3</c:v>
                  </c:pt>
                </c:numCache>
              </c:numRef>
            </c:minus>
          </c:errBars>
          <c:xVal>
            <c:numRef>
              <c:f>Sheet4!$H$23:$H$28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I$23:$I$28</c:f>
              <c:numCache>
                <c:formatCode>General</c:formatCode>
                <c:ptCount val="6"/>
                <c:pt idx="0">
                  <c:v>1.3142133818804767E-2</c:v>
                </c:pt>
                <c:pt idx="1">
                  <c:v>2.4282511253938331E-3</c:v>
                </c:pt>
                <c:pt idx="2">
                  <c:v>2.2880755929458652E-2</c:v>
                </c:pt>
                <c:pt idx="3">
                  <c:v>1.5643210103292251E-2</c:v>
                </c:pt>
                <c:pt idx="4">
                  <c:v>1.7546229134194336E-2</c:v>
                </c:pt>
                <c:pt idx="5">
                  <c:v>4.7714945826654323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365632"/>
        <c:axId val="253367424"/>
      </c:scatterChart>
      <c:valAx>
        <c:axId val="253365632"/>
        <c:scaling>
          <c:orientation val="minMax"/>
          <c:max val="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367424"/>
        <c:crosses val="autoZero"/>
        <c:crossBetween val="midCat"/>
        <c:majorUnit val="4"/>
      </c:valAx>
      <c:valAx>
        <c:axId val="253367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3656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8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3:$I$28</c:f>
                <c:numCache>
                  <c:formatCode>General</c:formatCode>
                  <c:ptCount val="6"/>
                  <c:pt idx="0">
                    <c:v>6.1197288651670305E-4</c:v>
                  </c:pt>
                  <c:pt idx="1">
                    <c:v>7.1927529502445312E-5</c:v>
                  </c:pt>
                  <c:pt idx="2">
                    <c:v>6.8748090181126984E-4</c:v>
                  </c:pt>
                  <c:pt idx="3">
                    <c:v>2.4498247162155983E-3</c:v>
                  </c:pt>
                  <c:pt idx="4">
                    <c:v>1.8019692269188453E-3</c:v>
                  </c:pt>
                  <c:pt idx="5">
                    <c:v>5.0878331773955895E-3</c:v>
                  </c:pt>
                </c:numCache>
              </c:numRef>
            </c:plus>
            <c:minus>
              <c:numRef>
                <c:f>Sheet4!$I$23:$I$28</c:f>
                <c:numCache>
                  <c:formatCode>General</c:formatCode>
                  <c:ptCount val="6"/>
                  <c:pt idx="0">
                    <c:v>6.1197288651670305E-4</c:v>
                  </c:pt>
                  <c:pt idx="1">
                    <c:v>7.1927529502445312E-5</c:v>
                  </c:pt>
                  <c:pt idx="2">
                    <c:v>6.8748090181126984E-4</c:v>
                  </c:pt>
                  <c:pt idx="3">
                    <c:v>2.4498247162155983E-3</c:v>
                  </c:pt>
                  <c:pt idx="4">
                    <c:v>1.8019692269188453E-3</c:v>
                  </c:pt>
                  <c:pt idx="5">
                    <c:v>5.0878331773955895E-3</c:v>
                  </c:pt>
                </c:numCache>
              </c:numRef>
            </c:minus>
          </c:errBars>
          <c:xVal>
            <c:numRef>
              <c:f>Sheet4!$F$23:$F$28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3:$G$28</c:f>
              <c:numCache>
                <c:formatCode>General</c:formatCode>
                <c:ptCount val="6"/>
                <c:pt idx="0">
                  <c:v>7.2735182050801938E-3</c:v>
                </c:pt>
                <c:pt idx="1">
                  <c:v>1.5148217810214235E-3</c:v>
                </c:pt>
                <c:pt idx="2">
                  <c:v>5.5044117803462094E-3</c:v>
                </c:pt>
                <c:pt idx="3">
                  <c:v>1.1113585371586923E-2</c:v>
                </c:pt>
                <c:pt idx="4">
                  <c:v>5.5468669450698636E-3</c:v>
                </c:pt>
                <c:pt idx="5">
                  <c:v>1.240360886212334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391616"/>
        <c:axId val="253393152"/>
      </c:scatterChart>
      <c:valAx>
        <c:axId val="25339161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393152"/>
        <c:crosses val="autoZero"/>
        <c:crossBetween val="midCat"/>
        <c:majorUnit val="4"/>
      </c:valAx>
      <c:valAx>
        <c:axId val="253393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39161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COP1 </a:t>
            </a:r>
            <a:r>
              <a:rPr lang="en-US" dirty="0" smtClean="0"/>
              <a:t>; At2g32950</a:t>
            </a:r>
            <a:endParaRPr lang="en-US" dirty="0"/>
          </a:p>
        </c:rich>
      </c:tx>
      <c:layout>
        <c:manualLayout>
          <c:xMode val="edge"/>
          <c:yMode val="edge"/>
          <c:x val="0.24215730415918699"/>
          <c:y val="3.413599205823009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9196872862079653"/>
          <c:y val="5.3218997172357202E-2"/>
          <c:w val="0.75317581672211975"/>
          <c:h val="0.7854788834693396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4!$A$6:$B$6</c:f>
              <c:strCache>
                <c:ptCount val="1"/>
                <c:pt idx="0">
                  <c:v>COP1 At2g32950</c:v>
                </c:pt>
              </c:strCache>
            </c:strRef>
          </c:tx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Q$6:$V$6</c:f>
                <c:numCache>
                  <c:formatCode>General</c:formatCode>
                  <c:ptCount val="6"/>
                  <c:pt idx="0">
                    <c:v>0.18237867933666838</c:v>
                  </c:pt>
                  <c:pt idx="1">
                    <c:v>3.9444686132299171E-2</c:v>
                  </c:pt>
                  <c:pt idx="2">
                    <c:v>0.13835929504890374</c:v>
                  </c:pt>
                  <c:pt idx="3">
                    <c:v>8.4875034064788371E-2</c:v>
                  </c:pt>
                  <c:pt idx="4">
                    <c:v>0.14692025071049075</c:v>
                  </c:pt>
                  <c:pt idx="5">
                    <c:v>0.12423448113563844</c:v>
                  </c:pt>
                </c:numCache>
              </c:numRef>
            </c:plus>
            <c:minus>
              <c:numRef>
                <c:f>Sheet4!$Q$6:$V$6</c:f>
                <c:numCache>
                  <c:formatCode>General</c:formatCode>
                  <c:ptCount val="6"/>
                  <c:pt idx="0">
                    <c:v>0.18237867933666838</c:v>
                  </c:pt>
                  <c:pt idx="1">
                    <c:v>3.9444686132299171E-2</c:v>
                  </c:pt>
                  <c:pt idx="2">
                    <c:v>0.13835929504890374</c:v>
                  </c:pt>
                  <c:pt idx="3">
                    <c:v>8.4875034064788371E-2</c:v>
                  </c:pt>
                  <c:pt idx="4">
                    <c:v>0.14692025071049075</c:v>
                  </c:pt>
                  <c:pt idx="5">
                    <c:v>0.12423448113563844</c:v>
                  </c:pt>
                </c:numCache>
              </c:numRef>
            </c:minus>
          </c:errBars>
          <c:xVal>
            <c:numRef>
              <c:f>Sheet4!$C$1:$H$1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C$6:$H$6</c:f>
              <c:numCache>
                <c:formatCode>General</c:formatCode>
                <c:ptCount val="6"/>
                <c:pt idx="0">
                  <c:v>9.7540553083333332</c:v>
                </c:pt>
                <c:pt idx="1">
                  <c:v>9.9231215023333217</c:v>
                </c:pt>
                <c:pt idx="2">
                  <c:v>9.4008262140000109</c:v>
                </c:pt>
                <c:pt idx="3">
                  <c:v>9.9818441686666706</c:v>
                </c:pt>
                <c:pt idx="4">
                  <c:v>9.6020750996666706</c:v>
                </c:pt>
                <c:pt idx="5">
                  <c:v>9.94974370266666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0643200"/>
        <c:axId val="250644736"/>
      </c:scatterChart>
      <c:valAx>
        <c:axId val="25064320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644736"/>
        <c:crosses val="autoZero"/>
        <c:crossBetween val="midCat"/>
        <c:majorUnit val="4"/>
      </c:valAx>
      <c:valAx>
        <c:axId val="2506447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064320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4:$I$21</c:f>
                <c:numCache>
                  <c:formatCode>General</c:formatCode>
                  <c:ptCount val="18"/>
                  <c:pt idx="0">
                    <c:v>2.4533088016049196E-3</c:v>
                  </c:pt>
                  <c:pt idx="1">
                    <c:v>7.9459221323360872E-4</c:v>
                  </c:pt>
                  <c:pt idx="2">
                    <c:v>1.7132512517116153E-4</c:v>
                  </c:pt>
                  <c:pt idx="3">
                    <c:v>4.4568634990501348E-4</c:v>
                  </c:pt>
                  <c:pt idx="4">
                    <c:v>7.283781692385545E-4</c:v>
                  </c:pt>
                  <c:pt idx="5">
                    <c:v>4.5497976431467209E-4</c:v>
                  </c:pt>
                  <c:pt idx="6">
                    <c:v>1.2208836772828043E-4</c:v>
                  </c:pt>
                  <c:pt idx="7">
                    <c:v>3.5778780342534945E-4</c:v>
                  </c:pt>
                  <c:pt idx="8">
                    <c:v>1.0045243704170452E-4</c:v>
                  </c:pt>
                  <c:pt idx="9">
                    <c:v>4.8501554536836179E-4</c:v>
                  </c:pt>
                  <c:pt idx="10">
                    <c:v>6.8406915155872785E-4</c:v>
                  </c:pt>
                  <c:pt idx="11">
                    <c:v>3.9579355833523636E-4</c:v>
                  </c:pt>
                  <c:pt idx="12">
                    <c:v>1.4131961522544898E-4</c:v>
                  </c:pt>
                  <c:pt idx="13">
                    <c:v>7.584302659609407E-4</c:v>
                  </c:pt>
                  <c:pt idx="14">
                    <c:v>2.0825818077062767E-4</c:v>
                  </c:pt>
                  <c:pt idx="15">
                    <c:v>1.410019862431326E-3</c:v>
                  </c:pt>
                  <c:pt idx="16">
                    <c:v>1.1482144375093649E-3</c:v>
                  </c:pt>
                  <c:pt idx="17">
                    <c:v>1.1933101679772325E-3</c:v>
                  </c:pt>
                </c:numCache>
              </c:numRef>
            </c:plus>
            <c:minus>
              <c:numRef>
                <c:f>Sheet4!$I$4:$I$21</c:f>
                <c:numCache>
                  <c:formatCode>General</c:formatCode>
                  <c:ptCount val="18"/>
                  <c:pt idx="0">
                    <c:v>2.4533088016049196E-3</c:v>
                  </c:pt>
                  <c:pt idx="1">
                    <c:v>7.9459221323360872E-4</c:v>
                  </c:pt>
                  <c:pt idx="2">
                    <c:v>1.7132512517116153E-4</c:v>
                  </c:pt>
                  <c:pt idx="3">
                    <c:v>4.4568634990501348E-4</c:v>
                  </c:pt>
                  <c:pt idx="4">
                    <c:v>7.283781692385545E-4</c:v>
                  </c:pt>
                  <c:pt idx="5">
                    <c:v>4.5497976431467209E-4</c:v>
                  </c:pt>
                  <c:pt idx="6">
                    <c:v>1.2208836772828043E-4</c:v>
                  </c:pt>
                  <c:pt idx="7">
                    <c:v>3.5778780342534945E-4</c:v>
                  </c:pt>
                  <c:pt idx="8">
                    <c:v>1.0045243704170452E-4</c:v>
                  </c:pt>
                  <c:pt idx="9">
                    <c:v>4.8501554536836179E-4</c:v>
                  </c:pt>
                  <c:pt idx="10">
                    <c:v>6.8406915155872785E-4</c:v>
                  </c:pt>
                  <c:pt idx="11">
                    <c:v>3.9579355833523636E-4</c:v>
                  </c:pt>
                  <c:pt idx="12">
                    <c:v>1.4131961522544898E-4</c:v>
                  </c:pt>
                  <c:pt idx="13">
                    <c:v>7.584302659609407E-4</c:v>
                  </c:pt>
                  <c:pt idx="14">
                    <c:v>2.0825818077062767E-4</c:v>
                  </c:pt>
                  <c:pt idx="15">
                    <c:v>1.410019862431326E-3</c:v>
                  </c:pt>
                  <c:pt idx="16">
                    <c:v>1.1482144375093649E-3</c:v>
                  </c:pt>
                  <c:pt idx="17">
                    <c:v>1.1933101679772325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4:$F$21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68</c:v>
                </c:pt>
              </c:numCache>
            </c:numRef>
          </c:xVal>
          <c:yVal>
            <c:numRef>
              <c:f>Sheet4!$G$4:$G$21</c:f>
              <c:numCache>
                <c:formatCode>General</c:formatCode>
                <c:ptCount val="18"/>
                <c:pt idx="0">
                  <c:v>6.3758982023041626E-3</c:v>
                </c:pt>
                <c:pt idx="1">
                  <c:v>2.2980465719170387E-3</c:v>
                </c:pt>
                <c:pt idx="2">
                  <c:v>1.2981950243254315E-3</c:v>
                </c:pt>
                <c:pt idx="3">
                  <c:v>2.8525424658532392E-3</c:v>
                </c:pt>
                <c:pt idx="4">
                  <c:v>2.2138488694030266E-3</c:v>
                </c:pt>
                <c:pt idx="5">
                  <c:v>1.5547906177523739E-3</c:v>
                </c:pt>
                <c:pt idx="6">
                  <c:v>1.2708264348255899E-3</c:v>
                </c:pt>
                <c:pt idx="7">
                  <c:v>1.5455870404215662E-3</c:v>
                </c:pt>
                <c:pt idx="8">
                  <c:v>3.0540122269342609E-3</c:v>
                </c:pt>
                <c:pt idx="9">
                  <c:v>4.5606668311131172E-3</c:v>
                </c:pt>
                <c:pt idx="10">
                  <c:v>3.247689546968162E-3</c:v>
                </c:pt>
                <c:pt idx="11">
                  <c:v>2.5855599514171671E-3</c:v>
                </c:pt>
                <c:pt idx="12">
                  <c:v>1.472816973083135E-3</c:v>
                </c:pt>
                <c:pt idx="13">
                  <c:v>3.1964689542381347E-3</c:v>
                </c:pt>
                <c:pt idx="14">
                  <c:v>3.3669179329712411E-3</c:v>
                </c:pt>
                <c:pt idx="15">
                  <c:v>4.068876150621503E-3</c:v>
                </c:pt>
                <c:pt idx="16">
                  <c:v>3.1675098151084536E-3</c:v>
                </c:pt>
                <c:pt idx="17">
                  <c:v>4.2748010145341438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413632"/>
        <c:axId val="253419520"/>
      </c:scatterChart>
      <c:valAx>
        <c:axId val="253413632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419520"/>
        <c:crosses val="autoZero"/>
        <c:crossBetween val="midCat"/>
        <c:majorUnit val="4"/>
      </c:valAx>
      <c:valAx>
        <c:axId val="253419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4136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K$5:$K$22</c:f>
                <c:numCache>
                  <c:formatCode>General</c:formatCode>
                  <c:ptCount val="18"/>
                  <c:pt idx="0">
                    <c:v>3.2231124243059143E-6</c:v>
                  </c:pt>
                  <c:pt idx="1">
                    <c:v>9.0462754512165686E-6</c:v>
                  </c:pt>
                  <c:pt idx="2">
                    <c:v>2.1594975174839427E-3</c:v>
                  </c:pt>
                  <c:pt idx="3">
                    <c:v>2.5786527648420911E-2</c:v>
                  </c:pt>
                  <c:pt idx="4">
                    <c:v>4.694667061774584E-4</c:v>
                  </c:pt>
                  <c:pt idx="5">
                    <c:v>1.0596947699702581E-4</c:v>
                  </c:pt>
                  <c:pt idx="6">
                    <c:v>1.3919639832793701E-5</c:v>
                  </c:pt>
                  <c:pt idx="7">
                    <c:v>1.070033665589546E-4</c:v>
                  </c:pt>
                  <c:pt idx="8">
                    <c:v>6.5519094029808074E-3</c:v>
                  </c:pt>
                  <c:pt idx="9">
                    <c:v>2.8489696908819803E-3</c:v>
                  </c:pt>
                  <c:pt idx="10">
                    <c:v>5.0506455714915584E-3</c:v>
                  </c:pt>
                  <c:pt idx="11">
                    <c:v>3.1152523464398745E-4</c:v>
                  </c:pt>
                  <c:pt idx="12">
                    <c:v>1.4518482020811402E-4</c:v>
                  </c:pt>
                  <c:pt idx="13">
                    <c:v>3.646853407213119E-4</c:v>
                  </c:pt>
                  <c:pt idx="14">
                    <c:v>2.5231037274000812E-3</c:v>
                  </c:pt>
                  <c:pt idx="15">
                    <c:v>3.2777768066042717E-3</c:v>
                  </c:pt>
                  <c:pt idx="16">
                    <c:v>8.2398075582163768E-4</c:v>
                  </c:pt>
                  <c:pt idx="17">
                    <c:v>1.9157667649542304E-4</c:v>
                  </c:pt>
                </c:numCache>
              </c:numRef>
            </c:plus>
            <c:minus>
              <c:numRef>
                <c:f>Sheet4!$K$5:$K$22</c:f>
                <c:numCache>
                  <c:formatCode>General</c:formatCode>
                  <c:ptCount val="18"/>
                  <c:pt idx="0">
                    <c:v>3.2231124243059143E-6</c:v>
                  </c:pt>
                  <c:pt idx="1">
                    <c:v>9.0462754512165686E-6</c:v>
                  </c:pt>
                  <c:pt idx="2">
                    <c:v>2.1594975174839427E-3</c:v>
                  </c:pt>
                  <c:pt idx="3">
                    <c:v>2.5786527648420911E-2</c:v>
                  </c:pt>
                  <c:pt idx="4">
                    <c:v>4.694667061774584E-4</c:v>
                  </c:pt>
                  <c:pt idx="5">
                    <c:v>1.0596947699702581E-4</c:v>
                  </c:pt>
                  <c:pt idx="6">
                    <c:v>1.3919639832793701E-5</c:v>
                  </c:pt>
                  <c:pt idx="7">
                    <c:v>1.070033665589546E-4</c:v>
                  </c:pt>
                  <c:pt idx="8">
                    <c:v>6.5519094029808074E-3</c:v>
                  </c:pt>
                  <c:pt idx="9">
                    <c:v>2.8489696908819803E-3</c:v>
                  </c:pt>
                  <c:pt idx="10">
                    <c:v>5.0506455714915584E-3</c:v>
                  </c:pt>
                  <c:pt idx="11">
                    <c:v>3.1152523464398745E-4</c:v>
                  </c:pt>
                  <c:pt idx="12">
                    <c:v>1.4518482020811402E-4</c:v>
                  </c:pt>
                  <c:pt idx="13">
                    <c:v>3.646853407213119E-4</c:v>
                  </c:pt>
                  <c:pt idx="14">
                    <c:v>2.5231037274000812E-3</c:v>
                  </c:pt>
                  <c:pt idx="15">
                    <c:v>3.2777768066042717E-3</c:v>
                  </c:pt>
                  <c:pt idx="16">
                    <c:v>8.2398075582163768E-4</c:v>
                  </c:pt>
                  <c:pt idx="17">
                    <c:v>1.9157667649542304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H$5:$H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I$5:$I$22</c:f>
              <c:numCache>
                <c:formatCode>General</c:formatCode>
                <c:ptCount val="18"/>
                <c:pt idx="0">
                  <c:v>6.4226895511651112E-5</c:v>
                </c:pt>
                <c:pt idx="1">
                  <c:v>1.0751824244553078E-4</c:v>
                </c:pt>
                <c:pt idx="2">
                  <c:v>0.13246771762262421</c:v>
                </c:pt>
                <c:pt idx="3">
                  <c:v>0.18061400289254018</c:v>
                </c:pt>
                <c:pt idx="4">
                  <c:v>2.4640669050648788E-2</c:v>
                </c:pt>
                <c:pt idx="5">
                  <c:v>4.0188451389387763E-3</c:v>
                </c:pt>
                <c:pt idx="6">
                  <c:v>1.0111943090178558E-3</c:v>
                </c:pt>
                <c:pt idx="7">
                  <c:v>3.2355224469631529E-3</c:v>
                </c:pt>
                <c:pt idx="8">
                  <c:v>9.433789458473639E-2</c:v>
                </c:pt>
                <c:pt idx="9">
                  <c:v>0.1262255923113817</c:v>
                </c:pt>
                <c:pt idx="10">
                  <c:v>3.2131833795444452E-2</c:v>
                </c:pt>
                <c:pt idx="11">
                  <c:v>4.7959046376394665E-3</c:v>
                </c:pt>
                <c:pt idx="12">
                  <c:v>2.8084320198922866E-3</c:v>
                </c:pt>
                <c:pt idx="13">
                  <c:v>2.4242174827767349E-2</c:v>
                </c:pt>
                <c:pt idx="14">
                  <c:v>0.21968756656424146</c:v>
                </c:pt>
                <c:pt idx="15">
                  <c:v>5.6522127382090857E-2</c:v>
                </c:pt>
                <c:pt idx="16">
                  <c:v>1.9050782975313776E-2</c:v>
                </c:pt>
                <c:pt idx="17">
                  <c:v>3.3337371690292552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038016"/>
        <c:axId val="254039552"/>
      </c:scatterChart>
      <c:valAx>
        <c:axId val="254038016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039552"/>
        <c:crosses val="autoZero"/>
        <c:crossBetween val="midCat"/>
        <c:majorUnit val="4"/>
      </c:valAx>
      <c:valAx>
        <c:axId val="254039552"/>
        <c:scaling>
          <c:orientation val="minMax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03801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K$24:$K$29</c:f>
                <c:numCache>
                  <c:formatCode>General</c:formatCode>
                  <c:ptCount val="6"/>
                  <c:pt idx="0">
                    <c:v>7.3758924754052662E-6</c:v>
                  </c:pt>
                  <c:pt idx="1">
                    <c:v>9.3031122370862078E-6</c:v>
                  </c:pt>
                  <c:pt idx="2">
                    <c:v>2.1948014196108531E-3</c:v>
                  </c:pt>
                  <c:pt idx="3">
                    <c:v>5.8019678854364124E-3</c:v>
                  </c:pt>
                  <c:pt idx="4">
                    <c:v>5.3746523191150909E-4</c:v>
                  </c:pt>
                  <c:pt idx="5">
                    <c:v>2.7714590315580233E-4</c:v>
                  </c:pt>
                </c:numCache>
              </c:numRef>
            </c:plus>
            <c:minus>
              <c:numRef>
                <c:f>Sheet4!$K$24:$K$29</c:f>
                <c:numCache>
                  <c:formatCode>General</c:formatCode>
                  <c:ptCount val="6"/>
                  <c:pt idx="0">
                    <c:v>7.3758924754052662E-6</c:v>
                  </c:pt>
                  <c:pt idx="1">
                    <c:v>9.3031122370862078E-6</c:v>
                  </c:pt>
                  <c:pt idx="2">
                    <c:v>2.1948014196108531E-3</c:v>
                  </c:pt>
                  <c:pt idx="3">
                    <c:v>5.8019678854364124E-3</c:v>
                  </c:pt>
                  <c:pt idx="4">
                    <c:v>5.3746523191150909E-4</c:v>
                  </c:pt>
                  <c:pt idx="5">
                    <c:v>2.7714590315580233E-4</c:v>
                  </c:pt>
                </c:numCache>
              </c:numRef>
            </c:minus>
          </c:errBars>
          <c:xVal>
            <c:numRef>
              <c:f>Sheet4!$H$24:$H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I$24:$I$29</c:f>
              <c:numCache>
                <c:formatCode>General</c:formatCode>
                <c:ptCount val="6"/>
                <c:pt idx="0">
                  <c:v>6.1996165489291413E-5</c:v>
                </c:pt>
                <c:pt idx="1">
                  <c:v>1.2795709265308371E-4</c:v>
                </c:pt>
                <c:pt idx="2">
                  <c:v>0.10861183788218377</c:v>
                </c:pt>
                <c:pt idx="3">
                  <c:v>0.14249758841321641</c:v>
                </c:pt>
                <c:pt idx="4">
                  <c:v>3.3347209246233474E-2</c:v>
                </c:pt>
                <c:pt idx="5">
                  <c:v>2.5643045116476105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063744"/>
        <c:axId val="254065280"/>
      </c:scatterChart>
      <c:valAx>
        <c:axId val="25406374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065280"/>
        <c:crosses val="autoZero"/>
        <c:crossBetween val="midCat"/>
        <c:majorUnit val="4"/>
      </c:valAx>
      <c:valAx>
        <c:axId val="254065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0637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2.1329106997398604E-5</c:v>
                  </c:pt>
                  <c:pt idx="1">
                    <c:v>2.2013514857050061E-5</c:v>
                  </c:pt>
                  <c:pt idx="2">
                    <c:v>5.7600436631410432E-3</c:v>
                  </c:pt>
                  <c:pt idx="3">
                    <c:v>6.0865971156129989E-2</c:v>
                  </c:pt>
                  <c:pt idx="4">
                    <c:v>1.2906796381307629E-2</c:v>
                  </c:pt>
                  <c:pt idx="5">
                    <c:v>4.1487508231630764E-3</c:v>
                  </c:pt>
                  <c:pt idx="6">
                    <c:v>3.3980059344042738E-5</c:v>
                  </c:pt>
                  <c:pt idx="7">
                    <c:v>3.1059808721054232E-4</c:v>
                  </c:pt>
                  <c:pt idx="8">
                    <c:v>1.4096114322218541E-4</c:v>
                  </c:pt>
                  <c:pt idx="9">
                    <c:v>3.0853931166781201E-2</c:v>
                  </c:pt>
                  <c:pt idx="10">
                    <c:v>3.4598322647749945E-2</c:v>
                  </c:pt>
                  <c:pt idx="11">
                    <c:v>6.9991910928644593E-3</c:v>
                  </c:pt>
                  <c:pt idx="12">
                    <c:v>1.3791812581931455E-4</c:v>
                  </c:pt>
                  <c:pt idx="13">
                    <c:v>1.0978648824772838E-3</c:v>
                  </c:pt>
                  <c:pt idx="14">
                    <c:v>2.0510162445082389E-3</c:v>
                  </c:pt>
                  <c:pt idx="15">
                    <c:v>7.2541069578298104E-4</c:v>
                  </c:pt>
                  <c:pt idx="16">
                    <c:v>2.277498846619987E-3</c:v>
                  </c:pt>
                  <c:pt idx="17">
                    <c:v>3.5901305656756998E-3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2.1329106997398604E-5</c:v>
                  </c:pt>
                  <c:pt idx="1">
                    <c:v>2.2013514857050061E-5</c:v>
                  </c:pt>
                  <c:pt idx="2">
                    <c:v>5.7600436631410432E-3</c:v>
                  </c:pt>
                  <c:pt idx="3">
                    <c:v>6.0865971156129989E-2</c:v>
                  </c:pt>
                  <c:pt idx="4">
                    <c:v>1.2906796381307629E-2</c:v>
                  </c:pt>
                  <c:pt idx="5">
                    <c:v>4.1487508231630764E-3</c:v>
                  </c:pt>
                  <c:pt idx="6">
                    <c:v>3.3980059344042738E-5</c:v>
                  </c:pt>
                  <c:pt idx="7">
                    <c:v>3.1059808721054232E-4</c:v>
                  </c:pt>
                  <c:pt idx="8">
                    <c:v>1.4096114322218541E-4</c:v>
                  </c:pt>
                  <c:pt idx="9">
                    <c:v>3.0853931166781201E-2</c:v>
                  </c:pt>
                  <c:pt idx="10">
                    <c:v>3.4598322647749945E-2</c:v>
                  </c:pt>
                  <c:pt idx="11">
                    <c:v>6.9991910928644593E-3</c:v>
                  </c:pt>
                  <c:pt idx="12">
                    <c:v>1.3791812581931455E-4</c:v>
                  </c:pt>
                  <c:pt idx="13">
                    <c:v>1.0978648824772838E-3</c:v>
                  </c:pt>
                  <c:pt idx="14">
                    <c:v>2.0510162445082389E-3</c:v>
                  </c:pt>
                  <c:pt idx="15">
                    <c:v>7.2541069578298104E-4</c:v>
                  </c:pt>
                  <c:pt idx="16">
                    <c:v>2.277498846619987E-3</c:v>
                  </c:pt>
                  <c:pt idx="17">
                    <c:v>3.5901305656756998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5.7386437665279028E-5</c:v>
                </c:pt>
                <c:pt idx="1">
                  <c:v>4.6745214904709006E-5</c:v>
                </c:pt>
                <c:pt idx="2">
                  <c:v>4.1816900631450687E-2</c:v>
                </c:pt>
                <c:pt idx="3">
                  <c:v>0.27586278086064686</c:v>
                </c:pt>
                <c:pt idx="4">
                  <c:v>9.9234234329708335E-2</c:v>
                </c:pt>
                <c:pt idx="5">
                  <c:v>2.474360390673E-2</c:v>
                </c:pt>
                <c:pt idx="6">
                  <c:v>3.3751583686061231E-4</c:v>
                </c:pt>
                <c:pt idx="7">
                  <c:v>1.5965863377358758E-3</c:v>
                </c:pt>
                <c:pt idx="8">
                  <c:v>3.9112392684468216E-3</c:v>
                </c:pt>
                <c:pt idx="9">
                  <c:v>0.12035126771721302</c:v>
                </c:pt>
                <c:pt idx="10">
                  <c:v>0.11499883202726507</c:v>
                </c:pt>
                <c:pt idx="11">
                  <c:v>4.0699515674812455E-2</c:v>
                </c:pt>
                <c:pt idx="12">
                  <c:v>3.5915661858294911E-3</c:v>
                </c:pt>
                <c:pt idx="13">
                  <c:v>5.8492181283876302E-3</c:v>
                </c:pt>
                <c:pt idx="14">
                  <c:v>5.4113160709861573E-2</c:v>
                </c:pt>
                <c:pt idx="15">
                  <c:v>1.773181158893606E-2</c:v>
                </c:pt>
                <c:pt idx="16">
                  <c:v>2.3418704375878199E-2</c:v>
                </c:pt>
                <c:pt idx="17">
                  <c:v>1.0306376509230801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111744"/>
        <c:axId val="254113280"/>
      </c:scatterChart>
      <c:valAx>
        <c:axId val="25411174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4113280"/>
        <c:crosses val="autoZero"/>
        <c:crossBetween val="midCat"/>
        <c:majorUnit val="4"/>
      </c:valAx>
      <c:valAx>
        <c:axId val="25411328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/>
        </c:spPr>
        <c:crossAx val="2541117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3.8172958683803193E-5</c:v>
                  </c:pt>
                  <c:pt idx="1">
                    <c:v>9.4493970807114146E-6</c:v>
                  </c:pt>
                  <c:pt idx="2">
                    <c:v>2.4253429406949482E-3</c:v>
                  </c:pt>
                  <c:pt idx="3">
                    <c:v>2.7769926404850612E-2</c:v>
                  </c:pt>
                  <c:pt idx="4">
                    <c:v>3.1638741414175851E-2</c:v>
                  </c:pt>
                  <c:pt idx="5">
                    <c:v>2.1350195128430152E-3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3.8172958683803193E-5</c:v>
                  </c:pt>
                  <c:pt idx="1">
                    <c:v>9.4493970807114146E-6</c:v>
                  </c:pt>
                  <c:pt idx="2">
                    <c:v>2.4253429406949482E-3</c:v>
                  </c:pt>
                  <c:pt idx="3">
                    <c:v>2.7769926404850612E-2</c:v>
                  </c:pt>
                  <c:pt idx="4">
                    <c:v>3.1638741414175851E-2</c:v>
                  </c:pt>
                  <c:pt idx="5">
                    <c:v>2.1350195128430152E-3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1.4783498473719907E-4</c:v>
                </c:pt>
                <c:pt idx="1">
                  <c:v>5.2419049435103154E-5</c:v>
                </c:pt>
                <c:pt idx="2">
                  <c:v>1.6437236266488828E-2</c:v>
                </c:pt>
                <c:pt idx="3">
                  <c:v>0.12474059042585088</c:v>
                </c:pt>
                <c:pt idx="4">
                  <c:v>0.10360750384867556</c:v>
                </c:pt>
                <c:pt idx="5">
                  <c:v>7.8494668328046423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760640"/>
        <c:axId val="253762176"/>
      </c:scatterChart>
      <c:valAx>
        <c:axId val="253760640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762176"/>
        <c:crosses val="autoZero"/>
        <c:crossBetween val="midCat"/>
        <c:majorUnit val="4"/>
      </c:valAx>
      <c:valAx>
        <c:axId val="25376217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76064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3.8519280248828587E-5</c:v>
                  </c:pt>
                  <c:pt idx="1">
                    <c:v>4.8812649802635547E-5</c:v>
                  </c:pt>
                  <c:pt idx="2">
                    <c:v>7.5583391660392091E-3</c:v>
                  </c:pt>
                  <c:pt idx="3">
                    <c:v>6.1615479499523972E-2</c:v>
                  </c:pt>
                  <c:pt idx="4">
                    <c:v>3.4219647337318292E-3</c:v>
                  </c:pt>
                  <c:pt idx="5">
                    <c:v>7.1173411703208964E-4</c:v>
                  </c:pt>
                  <c:pt idx="6">
                    <c:v>2.1603844558206335E-5</c:v>
                  </c:pt>
                  <c:pt idx="7">
                    <c:v>1.7592657015194161E-4</c:v>
                  </c:pt>
                  <c:pt idx="8">
                    <c:v>1.1608086734425283E-4</c:v>
                  </c:pt>
                  <c:pt idx="9">
                    <c:v>3.3396662775292726E-2</c:v>
                  </c:pt>
                  <c:pt idx="10">
                    <c:v>3.9333635811107152E-2</c:v>
                  </c:pt>
                  <c:pt idx="11">
                    <c:v>3.7560740674360085E-3</c:v>
                  </c:pt>
                  <c:pt idx="12">
                    <c:v>1.3998586402260325E-3</c:v>
                  </c:pt>
                  <c:pt idx="13">
                    <c:v>2.6179950859347052E-3</c:v>
                  </c:pt>
                  <c:pt idx="14">
                    <c:v>1.4585585314456839E-2</c:v>
                  </c:pt>
                  <c:pt idx="15">
                    <c:v>2.4838906358983482E-3</c:v>
                  </c:pt>
                  <c:pt idx="16">
                    <c:v>6.4444008795131761E-3</c:v>
                  </c:pt>
                  <c:pt idx="17">
                    <c:v>2.6211792892434451E-3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3.8519280248828587E-5</c:v>
                  </c:pt>
                  <c:pt idx="1">
                    <c:v>4.8812649802635547E-5</c:v>
                  </c:pt>
                  <c:pt idx="2">
                    <c:v>7.5583391660392091E-3</c:v>
                  </c:pt>
                  <c:pt idx="3">
                    <c:v>6.1615479499523972E-2</c:v>
                  </c:pt>
                  <c:pt idx="4">
                    <c:v>3.4219647337318292E-3</c:v>
                  </c:pt>
                  <c:pt idx="5">
                    <c:v>7.1173411703208964E-4</c:v>
                  </c:pt>
                  <c:pt idx="6">
                    <c:v>2.1603844558206335E-5</c:v>
                  </c:pt>
                  <c:pt idx="7">
                    <c:v>1.7592657015194161E-4</c:v>
                  </c:pt>
                  <c:pt idx="8">
                    <c:v>1.1608086734425283E-4</c:v>
                  </c:pt>
                  <c:pt idx="9">
                    <c:v>3.3396662775292726E-2</c:v>
                  </c:pt>
                  <c:pt idx="10">
                    <c:v>3.9333635811107152E-2</c:v>
                  </c:pt>
                  <c:pt idx="11">
                    <c:v>3.7560740674360085E-3</c:v>
                  </c:pt>
                  <c:pt idx="12">
                    <c:v>1.3998586402260325E-3</c:v>
                  </c:pt>
                  <c:pt idx="13">
                    <c:v>2.6179950859347052E-3</c:v>
                  </c:pt>
                  <c:pt idx="14">
                    <c:v>1.4585585314456839E-2</c:v>
                  </c:pt>
                  <c:pt idx="15">
                    <c:v>2.4838906358983482E-3</c:v>
                  </c:pt>
                  <c:pt idx="16">
                    <c:v>6.4444008795131761E-3</c:v>
                  </c:pt>
                  <c:pt idx="17">
                    <c:v>2.6211792892434451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9.8916903245332288E-5</c:v>
                </c:pt>
                <c:pt idx="1">
                  <c:v>9.2762067566184192E-5</c:v>
                </c:pt>
                <c:pt idx="2">
                  <c:v>0.2406047852548053</c:v>
                </c:pt>
                <c:pt idx="3">
                  <c:v>0.36077706005356031</c:v>
                </c:pt>
                <c:pt idx="4">
                  <c:v>6.0141911941054484E-2</c:v>
                </c:pt>
                <c:pt idx="5">
                  <c:v>9.1152140066920063E-3</c:v>
                </c:pt>
                <c:pt idx="6">
                  <c:v>3.0483451927856695E-4</c:v>
                </c:pt>
                <c:pt idx="7">
                  <c:v>1.3908209072387922E-3</c:v>
                </c:pt>
                <c:pt idx="8">
                  <c:v>5.0299029084039097E-2</c:v>
                </c:pt>
                <c:pt idx="9">
                  <c:v>0.19034549314817209</c:v>
                </c:pt>
                <c:pt idx="10">
                  <c:v>0.1119692321389205</c:v>
                </c:pt>
                <c:pt idx="11">
                  <c:v>1.6234023299103083E-2</c:v>
                </c:pt>
                <c:pt idx="12">
                  <c:v>2.0286299888852201E-2</c:v>
                </c:pt>
                <c:pt idx="13">
                  <c:v>1.5130028395996201E-2</c:v>
                </c:pt>
                <c:pt idx="14">
                  <c:v>0.11394080055301703</c:v>
                </c:pt>
                <c:pt idx="15">
                  <c:v>6.7700507954203473E-2</c:v>
                </c:pt>
                <c:pt idx="16">
                  <c:v>5.9115759847277266E-2</c:v>
                </c:pt>
                <c:pt idx="17">
                  <c:v>1.6034303475899032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790848"/>
        <c:axId val="253796736"/>
      </c:scatterChart>
      <c:valAx>
        <c:axId val="253790848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796736"/>
        <c:crosses val="autoZero"/>
        <c:crossBetween val="midCat"/>
        <c:majorUnit val="4"/>
      </c:valAx>
      <c:valAx>
        <c:axId val="2537967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79084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3.445109851246791E-5</c:v>
                  </c:pt>
                  <c:pt idx="1">
                    <c:v>1.4446884621225212E-5</c:v>
                  </c:pt>
                  <c:pt idx="2">
                    <c:v>3.8180088248588227E-2</c:v>
                  </c:pt>
                  <c:pt idx="3">
                    <c:v>6.1167109382014466E-2</c:v>
                  </c:pt>
                  <c:pt idx="4">
                    <c:v>1.073312553591256E-2</c:v>
                  </c:pt>
                  <c:pt idx="5">
                    <c:v>4.5836038284011735E-4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3.445109851246791E-5</c:v>
                  </c:pt>
                  <c:pt idx="1">
                    <c:v>1.4446884621225212E-5</c:v>
                  </c:pt>
                  <c:pt idx="2">
                    <c:v>3.8180088248588227E-2</c:v>
                  </c:pt>
                  <c:pt idx="3">
                    <c:v>6.1167109382014466E-2</c:v>
                  </c:pt>
                  <c:pt idx="4">
                    <c:v>1.073312553591256E-2</c:v>
                  </c:pt>
                  <c:pt idx="5">
                    <c:v>4.5836038284011735E-4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8.5262428381465728E-5</c:v>
                </c:pt>
                <c:pt idx="1">
                  <c:v>9.0710498172557504E-5</c:v>
                </c:pt>
                <c:pt idx="2">
                  <c:v>0.17978962710897439</c:v>
                </c:pt>
                <c:pt idx="3">
                  <c:v>0.22108674817628141</c:v>
                </c:pt>
                <c:pt idx="4">
                  <c:v>4.1137838757930915E-2</c:v>
                </c:pt>
                <c:pt idx="5">
                  <c:v>1.6828385024721191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816832"/>
        <c:axId val="253818368"/>
      </c:scatterChart>
      <c:valAx>
        <c:axId val="25381683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818368"/>
        <c:crosses val="autoZero"/>
        <c:crossBetween val="midCat"/>
        <c:majorUnit val="4"/>
      </c:valAx>
      <c:valAx>
        <c:axId val="253818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81683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:$I$22</c:f>
                <c:numCache>
                  <c:formatCode>General</c:formatCode>
                  <c:ptCount val="18"/>
                  <c:pt idx="0">
                    <c:v>5.8487169171354166E-3</c:v>
                  </c:pt>
                  <c:pt idx="1">
                    <c:v>1.0680863749097862E-3</c:v>
                  </c:pt>
                  <c:pt idx="2">
                    <c:v>2.580526692670005E-5</c:v>
                  </c:pt>
                  <c:pt idx="3">
                    <c:v>1.1452394223382602E-4</c:v>
                  </c:pt>
                  <c:pt idx="4">
                    <c:v>4.1525959196278615E-4</c:v>
                  </c:pt>
                  <c:pt idx="5">
                    <c:v>6.8620902693295501E-4</c:v>
                  </c:pt>
                  <c:pt idx="6">
                    <c:v>1.6027759038498277E-3</c:v>
                  </c:pt>
                  <c:pt idx="7">
                    <c:v>5.5417793440549936E-4</c:v>
                  </c:pt>
                  <c:pt idx="8">
                    <c:v>1.1947866199798136E-4</c:v>
                  </c:pt>
                  <c:pt idx="9">
                    <c:v>8.0039369969533576E-5</c:v>
                  </c:pt>
                  <c:pt idx="10">
                    <c:v>5.9949689781156818E-4</c:v>
                  </c:pt>
                  <c:pt idx="11">
                    <c:v>4.639525185026094E-4</c:v>
                  </c:pt>
                  <c:pt idx="12">
                    <c:v>1.406574126812405E-3</c:v>
                  </c:pt>
                  <c:pt idx="13">
                    <c:v>3.4999410714083246E-4</c:v>
                  </c:pt>
                  <c:pt idx="14">
                    <c:v>1.7224039430089947E-5</c:v>
                  </c:pt>
                  <c:pt idx="15">
                    <c:v>8.4398323541119163E-5</c:v>
                  </c:pt>
                  <c:pt idx="16">
                    <c:v>1.0220313078930271E-3</c:v>
                  </c:pt>
                  <c:pt idx="17">
                    <c:v>8.1775609358872379E-4</c:v>
                  </c:pt>
                </c:numCache>
              </c:numRef>
            </c:plus>
            <c:minus>
              <c:numRef>
                <c:f>Sheet4!$I$5:$I$22</c:f>
                <c:numCache>
                  <c:formatCode>General</c:formatCode>
                  <c:ptCount val="18"/>
                  <c:pt idx="0">
                    <c:v>5.8487169171354166E-3</c:v>
                  </c:pt>
                  <c:pt idx="1">
                    <c:v>1.0680863749097862E-3</c:v>
                  </c:pt>
                  <c:pt idx="2">
                    <c:v>2.580526692670005E-5</c:v>
                  </c:pt>
                  <c:pt idx="3">
                    <c:v>1.1452394223382602E-4</c:v>
                  </c:pt>
                  <c:pt idx="4">
                    <c:v>4.1525959196278615E-4</c:v>
                  </c:pt>
                  <c:pt idx="5">
                    <c:v>6.8620902693295501E-4</c:v>
                  </c:pt>
                  <c:pt idx="6">
                    <c:v>1.6027759038498277E-3</c:v>
                  </c:pt>
                  <c:pt idx="7">
                    <c:v>5.5417793440549936E-4</c:v>
                  </c:pt>
                  <c:pt idx="8">
                    <c:v>1.1947866199798136E-4</c:v>
                  </c:pt>
                  <c:pt idx="9">
                    <c:v>8.0039369969533576E-5</c:v>
                  </c:pt>
                  <c:pt idx="10">
                    <c:v>5.9949689781156818E-4</c:v>
                  </c:pt>
                  <c:pt idx="11">
                    <c:v>4.639525185026094E-4</c:v>
                  </c:pt>
                  <c:pt idx="12">
                    <c:v>1.406574126812405E-3</c:v>
                  </c:pt>
                  <c:pt idx="13">
                    <c:v>3.4999410714083246E-4</c:v>
                  </c:pt>
                  <c:pt idx="14">
                    <c:v>1.7224039430089947E-5</c:v>
                  </c:pt>
                  <c:pt idx="15">
                    <c:v>8.4398323541119163E-5</c:v>
                  </c:pt>
                  <c:pt idx="16">
                    <c:v>1.0220313078930271E-3</c:v>
                  </c:pt>
                  <c:pt idx="17">
                    <c:v>8.1775609358872379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F$5:$F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G$5:$G$22</c:f>
              <c:numCache>
                <c:formatCode>General</c:formatCode>
                <c:ptCount val="18"/>
                <c:pt idx="0">
                  <c:v>4.6591054769103725E-2</c:v>
                </c:pt>
                <c:pt idx="1">
                  <c:v>6.3056905819097861E-3</c:v>
                </c:pt>
                <c:pt idx="2">
                  <c:v>7.6528324687169449E-4</c:v>
                </c:pt>
                <c:pt idx="3">
                  <c:v>7.6155774112535764E-4</c:v>
                </c:pt>
                <c:pt idx="4">
                  <c:v>5.3688819288051064E-3</c:v>
                </c:pt>
                <c:pt idx="5">
                  <c:v>1.4951785143643301E-2</c:v>
                </c:pt>
                <c:pt idx="6">
                  <c:v>1.7559328618175041E-2</c:v>
                </c:pt>
                <c:pt idx="7">
                  <c:v>8.3519133938131408E-3</c:v>
                </c:pt>
                <c:pt idx="8">
                  <c:v>2.0998682709628797E-3</c:v>
                </c:pt>
                <c:pt idx="9">
                  <c:v>9.8730211672948503E-4</c:v>
                </c:pt>
                <c:pt idx="10">
                  <c:v>3.715565757602601E-3</c:v>
                </c:pt>
                <c:pt idx="11">
                  <c:v>6.166037419261838E-3</c:v>
                </c:pt>
                <c:pt idx="12">
                  <c:v>3.2042464471440352E-2</c:v>
                </c:pt>
                <c:pt idx="13">
                  <c:v>5.3347216306522194E-3</c:v>
                </c:pt>
                <c:pt idx="14">
                  <c:v>1.4135596669871435E-3</c:v>
                </c:pt>
                <c:pt idx="15">
                  <c:v>4.1022167644912842E-3</c:v>
                </c:pt>
                <c:pt idx="16">
                  <c:v>1.5055048097914275E-2</c:v>
                </c:pt>
                <c:pt idx="17">
                  <c:v>1.4162376781368101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847040"/>
        <c:axId val="253848576"/>
      </c:scatterChart>
      <c:valAx>
        <c:axId val="253847040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848576"/>
        <c:crosses val="autoZero"/>
        <c:crossBetween val="midCat"/>
        <c:majorUnit val="4"/>
      </c:valAx>
      <c:valAx>
        <c:axId val="253848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84704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58573928259003"/>
          <c:y val="5.1400554097404488E-2"/>
          <c:w val="0.85377537182852314"/>
          <c:h val="0.89719889180519163"/>
        </c:manualLayout>
      </c:layout>
      <c:scatterChart>
        <c:scatterStyle val="smoothMarker"/>
        <c:varyColors val="0"/>
        <c:ser>
          <c:idx val="0"/>
          <c:order val="0"/>
          <c:spPr>
            <a:ln w="165100">
              <a:solidFill>
                <a:schemeClr val="tx1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4:$I$29</c:f>
                <c:numCache>
                  <c:formatCode>General</c:formatCode>
                  <c:ptCount val="6"/>
                  <c:pt idx="0">
                    <c:v>9.0194906045166865E-3</c:v>
                  </c:pt>
                  <c:pt idx="1">
                    <c:v>8.325512352374819E-4</c:v>
                  </c:pt>
                  <c:pt idx="2">
                    <c:v>3.8497305077325748E-5</c:v>
                  </c:pt>
                  <c:pt idx="3">
                    <c:v>1.7338477756485783E-4</c:v>
                  </c:pt>
                  <c:pt idx="4">
                    <c:v>4.0833003059383122E-4</c:v>
                  </c:pt>
                  <c:pt idx="5">
                    <c:v>1.6030612171876711E-3</c:v>
                  </c:pt>
                </c:numCache>
              </c:numRef>
            </c:plus>
            <c:minus>
              <c:numRef>
                <c:f>Sheet4!$I$24:$I$29</c:f>
                <c:numCache>
                  <c:formatCode>General</c:formatCode>
                  <c:ptCount val="6"/>
                  <c:pt idx="0">
                    <c:v>9.0194906045166865E-3</c:v>
                  </c:pt>
                  <c:pt idx="1">
                    <c:v>8.325512352374819E-4</c:v>
                  </c:pt>
                  <c:pt idx="2">
                    <c:v>3.8497305077325748E-5</c:v>
                  </c:pt>
                  <c:pt idx="3">
                    <c:v>1.7338477756485783E-4</c:v>
                  </c:pt>
                  <c:pt idx="4">
                    <c:v>4.0833003059383122E-4</c:v>
                  </c:pt>
                  <c:pt idx="5">
                    <c:v>1.6030612171876711E-3</c:v>
                  </c:pt>
                </c:numCache>
              </c:numRef>
            </c:minus>
          </c:errBars>
          <c:xVal>
            <c:numRef>
              <c:f>Sheet4!$F$24:$F$29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Sheet4!$G$24:$G$29</c:f>
              <c:numCache>
                <c:formatCode>General</c:formatCode>
                <c:ptCount val="6"/>
                <c:pt idx="0">
                  <c:v>4.9956569234063192E-2</c:v>
                </c:pt>
                <c:pt idx="1">
                  <c:v>7.2306919173546142E-3</c:v>
                </c:pt>
                <c:pt idx="2">
                  <c:v>4.6714619704749056E-4</c:v>
                </c:pt>
                <c:pt idx="3">
                  <c:v>6.0995596076201207E-4</c:v>
                </c:pt>
                <c:pt idx="4">
                  <c:v>2.6326663935986785E-3</c:v>
                </c:pt>
                <c:pt idx="5">
                  <c:v>2.151963486360647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868672"/>
        <c:axId val="253874560"/>
      </c:scatterChart>
      <c:valAx>
        <c:axId val="253868672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874560"/>
        <c:crosses val="autoZero"/>
        <c:crossBetween val="midCat"/>
        <c:majorUnit val="4"/>
      </c:valAx>
      <c:valAx>
        <c:axId val="25387456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86867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charts/chart9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65100">
              <a:solidFill>
                <a:prstClr val="black"/>
              </a:solidFill>
            </a:ln>
          </c:spPr>
          <c:marker>
            <c:spPr>
              <a:solidFill>
                <a:prstClr val="black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J$5:$J$22</c:f>
                <c:numCache>
                  <c:formatCode>General</c:formatCode>
                  <c:ptCount val="18"/>
                  <c:pt idx="0">
                    <c:v>4.0753071992389436E-2</c:v>
                  </c:pt>
                  <c:pt idx="1">
                    <c:v>1.2581826792075002E-3</c:v>
                  </c:pt>
                  <c:pt idx="2">
                    <c:v>1.7708776455416619E-3</c:v>
                  </c:pt>
                  <c:pt idx="3">
                    <c:v>1.4730765739651781E-3</c:v>
                  </c:pt>
                  <c:pt idx="4">
                    <c:v>4.0818748639573154E-4</c:v>
                  </c:pt>
                  <c:pt idx="5">
                    <c:v>2.5561251607844212E-3</c:v>
                  </c:pt>
                  <c:pt idx="6">
                    <c:v>3.4504173965536752E-3</c:v>
                  </c:pt>
                  <c:pt idx="7">
                    <c:v>1.8385118046018239E-3</c:v>
                  </c:pt>
                  <c:pt idx="8">
                    <c:v>4.1123633688549334E-4</c:v>
                  </c:pt>
                  <c:pt idx="9">
                    <c:v>7.5868950935550194E-3</c:v>
                  </c:pt>
                  <c:pt idx="10">
                    <c:v>3.7642687260496604E-3</c:v>
                  </c:pt>
                  <c:pt idx="11">
                    <c:v>4.2043794009620543E-4</c:v>
                  </c:pt>
                  <c:pt idx="12">
                    <c:v>7.8362376615186604E-3</c:v>
                  </c:pt>
                  <c:pt idx="13">
                    <c:v>2.1425100185650425E-3</c:v>
                  </c:pt>
                  <c:pt idx="14">
                    <c:v>1.1189857936814199E-3</c:v>
                  </c:pt>
                  <c:pt idx="15">
                    <c:v>4.2387801206481583E-3</c:v>
                  </c:pt>
                  <c:pt idx="16">
                    <c:v>4.4661398139263135E-3</c:v>
                  </c:pt>
                  <c:pt idx="17">
                    <c:v>7.1597327475613273E-4</c:v>
                  </c:pt>
                </c:numCache>
              </c:numRef>
            </c:plus>
            <c:minus>
              <c:numRef>
                <c:f>Sheet4!$J$5:$J$22</c:f>
                <c:numCache>
                  <c:formatCode>General</c:formatCode>
                  <c:ptCount val="18"/>
                  <c:pt idx="0">
                    <c:v>4.0753071992389436E-2</c:v>
                  </c:pt>
                  <c:pt idx="1">
                    <c:v>1.2581826792075002E-3</c:v>
                  </c:pt>
                  <c:pt idx="2">
                    <c:v>1.7708776455416619E-3</c:v>
                  </c:pt>
                  <c:pt idx="3">
                    <c:v>1.4730765739651781E-3</c:v>
                  </c:pt>
                  <c:pt idx="4">
                    <c:v>4.0818748639573154E-4</c:v>
                  </c:pt>
                  <c:pt idx="5">
                    <c:v>2.5561251607844212E-3</c:v>
                  </c:pt>
                  <c:pt idx="6">
                    <c:v>3.4504173965536752E-3</c:v>
                  </c:pt>
                  <c:pt idx="7">
                    <c:v>1.8385118046018239E-3</c:v>
                  </c:pt>
                  <c:pt idx="8">
                    <c:v>4.1123633688549334E-4</c:v>
                  </c:pt>
                  <c:pt idx="9">
                    <c:v>7.5868950935550194E-3</c:v>
                  </c:pt>
                  <c:pt idx="10">
                    <c:v>3.7642687260496604E-3</c:v>
                  </c:pt>
                  <c:pt idx="11">
                    <c:v>4.2043794009620543E-4</c:v>
                  </c:pt>
                  <c:pt idx="12">
                    <c:v>7.8362376615186604E-3</c:v>
                  </c:pt>
                  <c:pt idx="13">
                    <c:v>2.1425100185650425E-3</c:v>
                  </c:pt>
                  <c:pt idx="14">
                    <c:v>1.1189857936814199E-3</c:v>
                  </c:pt>
                  <c:pt idx="15">
                    <c:v>4.2387801206481583E-3</c:v>
                  </c:pt>
                  <c:pt idx="16">
                    <c:v>4.4661398139263135E-3</c:v>
                  </c:pt>
                  <c:pt idx="17">
                    <c:v>7.1597327475613273E-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4!$G$5:$G$22</c:f>
              <c:numCache>
                <c:formatCode>General</c:formatCode>
                <c:ptCount val="18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  <c:pt idx="9">
                  <c:v>36</c:v>
                </c:pt>
                <c:pt idx="10">
                  <c:v>40</c:v>
                </c:pt>
                <c:pt idx="11">
                  <c:v>44</c:v>
                </c:pt>
                <c:pt idx="12">
                  <c:v>48</c:v>
                </c:pt>
                <c:pt idx="13">
                  <c:v>52</c:v>
                </c:pt>
                <c:pt idx="14">
                  <c:v>56</c:v>
                </c:pt>
                <c:pt idx="15">
                  <c:v>60</c:v>
                </c:pt>
                <c:pt idx="16">
                  <c:v>64</c:v>
                </c:pt>
                <c:pt idx="17">
                  <c:v>72</c:v>
                </c:pt>
              </c:numCache>
            </c:numRef>
          </c:xVal>
          <c:yVal>
            <c:numRef>
              <c:f>Sheet4!$H$5:$H$22</c:f>
              <c:numCache>
                <c:formatCode>General</c:formatCode>
                <c:ptCount val="18"/>
                <c:pt idx="0">
                  <c:v>0.16066584428573488</c:v>
                </c:pt>
                <c:pt idx="1">
                  <c:v>3.2401831886952025E-2</c:v>
                </c:pt>
                <c:pt idx="2">
                  <c:v>2.2745223812768806E-2</c:v>
                </c:pt>
                <c:pt idx="3">
                  <c:v>1.4518872227616263E-2</c:v>
                </c:pt>
                <c:pt idx="4">
                  <c:v>2.5155974180216811E-2</c:v>
                </c:pt>
                <c:pt idx="5">
                  <c:v>2.7243599015552601E-2</c:v>
                </c:pt>
                <c:pt idx="6">
                  <c:v>5.2790166262217893E-2</c:v>
                </c:pt>
                <c:pt idx="7">
                  <c:v>4.1219675474142875E-2</c:v>
                </c:pt>
                <c:pt idx="8">
                  <c:v>4.0765141323972416E-2</c:v>
                </c:pt>
                <c:pt idx="9">
                  <c:v>2.7033328570802716E-2</c:v>
                </c:pt>
                <c:pt idx="10">
                  <c:v>2.5097151014730371E-2</c:v>
                </c:pt>
                <c:pt idx="11">
                  <c:v>2.3043178816336052E-2</c:v>
                </c:pt>
                <c:pt idx="12">
                  <c:v>0.11268816738488555</c:v>
                </c:pt>
                <c:pt idx="13">
                  <c:v>5.1090959648521124E-2</c:v>
                </c:pt>
                <c:pt idx="14">
                  <c:v>3.0226399709528302E-2</c:v>
                </c:pt>
                <c:pt idx="15">
                  <c:v>6.6487926887676824E-2</c:v>
                </c:pt>
                <c:pt idx="16">
                  <c:v>8.580000577904745E-2</c:v>
                </c:pt>
                <c:pt idx="17">
                  <c:v>4.938789564633727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972864"/>
        <c:axId val="253974400"/>
      </c:scatterChart>
      <c:valAx>
        <c:axId val="253972864"/>
        <c:scaling>
          <c:orientation val="minMax"/>
          <c:max val="6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01600">
            <a:solidFill>
              <a:schemeClr val="tx1"/>
            </a:solidFill>
          </a:ln>
        </c:spPr>
        <c:crossAx val="253974400"/>
        <c:crosses val="autoZero"/>
        <c:crossBetween val="midCat"/>
        <c:majorUnit val="4"/>
      </c:valAx>
      <c:valAx>
        <c:axId val="253974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01600">
            <a:solidFill>
              <a:prstClr val="black"/>
            </a:solidFill>
          </a:ln>
        </c:spPr>
        <c:crossAx val="25397286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3200" b="1"/>
      </a:pPr>
      <a:endParaRPr lang="ko-KR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306</cdr:x>
      <cdr:y>0.01087</cdr:y>
    </cdr:from>
    <cdr:to>
      <cdr:x>0.2959</cdr:x>
      <cdr:y>0.1641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080120" y="72008"/>
          <a:ext cx="1007962" cy="101566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ko-KR"/>
          </a:defPPr>
          <a:lvl1pPr marL="0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2159859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4319718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6479577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8639440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10799299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12959158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15119017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17278876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6000" b="1" dirty="0"/>
            <a:t>A</a:t>
          </a:r>
          <a:endParaRPr lang="ko-KR" altLang="en-US" sz="60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875</cdr:x>
      <cdr:y>0.01053</cdr:y>
    </cdr:from>
    <cdr:to>
      <cdr:x>0.33331</cdr:x>
      <cdr:y>0.159</cdr:y>
    </cdr:to>
    <cdr:sp macro="" textlink="">
      <cdr:nvSpPr>
        <cdr:cNvPr id="2" name="TextBox 25"/>
        <cdr:cNvSpPr txBox="1"/>
      </cdr:nvSpPr>
      <cdr:spPr>
        <a:xfrm xmlns:a="http://schemas.openxmlformats.org/drawingml/2006/main">
          <a:off x="1296144" y="72008"/>
          <a:ext cx="1007962" cy="101566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ko-KR"/>
          </a:defPPr>
          <a:lvl1pPr marL="0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2159859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4319718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6479577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8639440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10799299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12959158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15119017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17278876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6000" b="1" dirty="0"/>
            <a:t>C</a:t>
          </a:r>
          <a:endParaRPr lang="ko-KR" altLang="en-US" sz="60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5855</cdr:x>
      <cdr:y>0.01111</cdr:y>
    </cdr:from>
    <cdr:to>
      <cdr:x>0.30436</cdr:x>
      <cdr:y>0.16783</cdr:y>
    </cdr:to>
    <cdr:sp macro="" textlink="">
      <cdr:nvSpPr>
        <cdr:cNvPr id="2" name="TextBox 26"/>
        <cdr:cNvSpPr txBox="1"/>
      </cdr:nvSpPr>
      <cdr:spPr>
        <a:xfrm xmlns:a="http://schemas.openxmlformats.org/drawingml/2006/main">
          <a:off x="1095993" y="72008"/>
          <a:ext cx="1007962" cy="101566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ko-KR"/>
          </a:defPPr>
          <a:lvl1pPr marL="0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2159859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4319718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6479577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8639440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10799299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12959158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15119017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17278876" algn="l" defTabSz="4319718" rtl="0" eaLnBrk="1" latinLnBrk="1" hangingPunct="1">
            <a:defRPr sz="85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6000" b="1" dirty="0"/>
            <a:t>D</a:t>
          </a:r>
          <a:endParaRPr lang="ko-KR" altLang="en-US" sz="60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D674E5-83D0-4B3B-A0B0-8581E30EC66E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DEB83D-6AC6-45B1-B11A-2E5E75FF168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3759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457115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914226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371341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828452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2285568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742678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3199794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3656904" algn="l" defTabSz="914226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DEB83D-6AC6-45B1-B11A-2E5E75FF1685}" type="slidenum">
              <a:rPr lang="ko-KR" altLang="en-US" smtClean="0"/>
              <a:pPr/>
              <a:t>1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5129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DEB83D-6AC6-45B1-B11A-2E5E75FF1685}" type="slidenum">
              <a:rPr lang="ko-KR" altLang="en-US" smtClean="0"/>
              <a:pPr/>
              <a:t>1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98248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3240405" y="10066265"/>
            <a:ext cx="36724590" cy="694586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6480810" y="18362295"/>
            <a:ext cx="30243780" cy="828103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1598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3197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4795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639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7992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9591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51190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72788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1323915" y="1297671"/>
            <a:ext cx="9721215" cy="276484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160270" y="1297671"/>
            <a:ext cx="28443555" cy="276484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12929" y="20822605"/>
            <a:ext cx="36724590" cy="6435804"/>
          </a:xfrm>
        </p:spPr>
        <p:txBody>
          <a:bodyPr anchor="t"/>
          <a:lstStyle>
            <a:lvl1pPr algn="l">
              <a:defRPr sz="189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12929" y="13734221"/>
            <a:ext cx="36724590" cy="7088384"/>
          </a:xfrm>
        </p:spPr>
        <p:txBody>
          <a:bodyPr anchor="b"/>
          <a:lstStyle>
            <a:lvl1pPr marL="0" indent="0">
              <a:buNone/>
              <a:defRPr sz="9500">
                <a:solidFill>
                  <a:schemeClr val="tx1">
                    <a:tint val="75000"/>
                  </a:schemeClr>
                </a:solidFill>
              </a:defRPr>
            </a:lvl1pPr>
            <a:lvl2pPr marL="2159859" indent="0">
              <a:buNone/>
              <a:defRPr sz="8500">
                <a:solidFill>
                  <a:schemeClr val="tx1">
                    <a:tint val="75000"/>
                  </a:schemeClr>
                </a:solidFill>
              </a:defRPr>
            </a:lvl2pPr>
            <a:lvl3pPr marL="4319718" indent="0">
              <a:buNone/>
              <a:defRPr sz="7600">
                <a:solidFill>
                  <a:schemeClr val="tx1">
                    <a:tint val="75000"/>
                  </a:schemeClr>
                </a:solidFill>
              </a:defRPr>
            </a:lvl3pPr>
            <a:lvl4pPr marL="6479577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4pPr>
            <a:lvl5pPr marL="8639440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5pPr>
            <a:lvl6pPr marL="10799299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6pPr>
            <a:lvl7pPr marL="12959158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7pPr>
            <a:lvl8pPr marL="15119017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8pPr>
            <a:lvl9pPr marL="17278876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160270" y="7560952"/>
            <a:ext cx="19082385" cy="21385175"/>
          </a:xfrm>
        </p:spPr>
        <p:txBody>
          <a:bodyPr/>
          <a:lstStyle>
            <a:lvl1pPr>
              <a:defRPr sz="13200"/>
            </a:lvl1pPr>
            <a:lvl2pPr>
              <a:defRPr sz="11300"/>
            </a:lvl2pPr>
            <a:lvl3pPr>
              <a:defRPr sz="9500"/>
            </a:lvl3pPr>
            <a:lvl4pPr>
              <a:defRPr sz="8500"/>
            </a:lvl4pPr>
            <a:lvl5pPr>
              <a:defRPr sz="8500"/>
            </a:lvl5pPr>
            <a:lvl6pPr>
              <a:defRPr sz="8500"/>
            </a:lvl6pPr>
            <a:lvl7pPr>
              <a:defRPr sz="8500"/>
            </a:lvl7pPr>
            <a:lvl8pPr>
              <a:defRPr sz="8500"/>
            </a:lvl8pPr>
            <a:lvl9pPr>
              <a:defRPr sz="8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1962745" y="7560952"/>
            <a:ext cx="19082385" cy="21385175"/>
          </a:xfrm>
        </p:spPr>
        <p:txBody>
          <a:bodyPr/>
          <a:lstStyle>
            <a:lvl1pPr>
              <a:defRPr sz="13200"/>
            </a:lvl1pPr>
            <a:lvl2pPr>
              <a:defRPr sz="11300"/>
            </a:lvl2pPr>
            <a:lvl3pPr>
              <a:defRPr sz="9500"/>
            </a:lvl3pPr>
            <a:lvl4pPr>
              <a:defRPr sz="8500"/>
            </a:lvl4pPr>
            <a:lvl5pPr>
              <a:defRPr sz="8500"/>
            </a:lvl5pPr>
            <a:lvl6pPr>
              <a:defRPr sz="8500"/>
            </a:lvl6pPr>
            <a:lvl7pPr>
              <a:defRPr sz="8500"/>
            </a:lvl7pPr>
            <a:lvl8pPr>
              <a:defRPr sz="8500"/>
            </a:lvl8pPr>
            <a:lvl9pPr>
              <a:defRPr sz="8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2160270" y="7253409"/>
            <a:ext cx="19089888" cy="3022875"/>
          </a:xfrm>
        </p:spPr>
        <p:txBody>
          <a:bodyPr anchor="b"/>
          <a:lstStyle>
            <a:lvl1pPr marL="0" indent="0">
              <a:buNone/>
              <a:defRPr sz="11300" b="1"/>
            </a:lvl1pPr>
            <a:lvl2pPr marL="2159859" indent="0">
              <a:buNone/>
              <a:defRPr sz="9500" b="1"/>
            </a:lvl2pPr>
            <a:lvl3pPr marL="4319718" indent="0">
              <a:buNone/>
              <a:defRPr sz="8500" b="1"/>
            </a:lvl3pPr>
            <a:lvl4pPr marL="6479577" indent="0">
              <a:buNone/>
              <a:defRPr sz="7600" b="1"/>
            </a:lvl4pPr>
            <a:lvl5pPr marL="8639440" indent="0">
              <a:buNone/>
              <a:defRPr sz="7600" b="1"/>
            </a:lvl5pPr>
            <a:lvl6pPr marL="10799299" indent="0">
              <a:buNone/>
              <a:defRPr sz="7600" b="1"/>
            </a:lvl6pPr>
            <a:lvl7pPr marL="12959158" indent="0">
              <a:buNone/>
              <a:defRPr sz="7600" b="1"/>
            </a:lvl7pPr>
            <a:lvl8pPr marL="15119017" indent="0">
              <a:buNone/>
              <a:defRPr sz="7600" b="1"/>
            </a:lvl8pPr>
            <a:lvl9pPr marL="17278876" indent="0">
              <a:buNone/>
              <a:defRPr sz="7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160270" y="10276284"/>
            <a:ext cx="19089888" cy="18669836"/>
          </a:xfrm>
        </p:spPr>
        <p:txBody>
          <a:bodyPr/>
          <a:lstStyle>
            <a:lvl1pPr>
              <a:defRPr sz="11300"/>
            </a:lvl1pPr>
            <a:lvl2pPr>
              <a:defRPr sz="9500"/>
            </a:lvl2pPr>
            <a:lvl3pPr>
              <a:defRPr sz="8500"/>
            </a:lvl3pPr>
            <a:lvl4pPr>
              <a:defRPr sz="7600"/>
            </a:lvl4pPr>
            <a:lvl5pPr>
              <a:defRPr sz="7600"/>
            </a:lvl5pPr>
            <a:lvl6pPr>
              <a:defRPr sz="7600"/>
            </a:lvl6pPr>
            <a:lvl7pPr>
              <a:defRPr sz="7600"/>
            </a:lvl7pPr>
            <a:lvl8pPr>
              <a:defRPr sz="7600"/>
            </a:lvl8pPr>
            <a:lvl9pPr>
              <a:defRPr sz="7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21947750" y="7253409"/>
            <a:ext cx="19097387" cy="3022875"/>
          </a:xfrm>
        </p:spPr>
        <p:txBody>
          <a:bodyPr anchor="b"/>
          <a:lstStyle>
            <a:lvl1pPr marL="0" indent="0">
              <a:buNone/>
              <a:defRPr sz="11300" b="1"/>
            </a:lvl1pPr>
            <a:lvl2pPr marL="2159859" indent="0">
              <a:buNone/>
              <a:defRPr sz="9500" b="1"/>
            </a:lvl2pPr>
            <a:lvl3pPr marL="4319718" indent="0">
              <a:buNone/>
              <a:defRPr sz="8500" b="1"/>
            </a:lvl3pPr>
            <a:lvl4pPr marL="6479577" indent="0">
              <a:buNone/>
              <a:defRPr sz="7600" b="1"/>
            </a:lvl4pPr>
            <a:lvl5pPr marL="8639440" indent="0">
              <a:buNone/>
              <a:defRPr sz="7600" b="1"/>
            </a:lvl5pPr>
            <a:lvl6pPr marL="10799299" indent="0">
              <a:buNone/>
              <a:defRPr sz="7600" b="1"/>
            </a:lvl6pPr>
            <a:lvl7pPr marL="12959158" indent="0">
              <a:buNone/>
              <a:defRPr sz="7600" b="1"/>
            </a:lvl7pPr>
            <a:lvl8pPr marL="15119017" indent="0">
              <a:buNone/>
              <a:defRPr sz="7600" b="1"/>
            </a:lvl8pPr>
            <a:lvl9pPr marL="17278876" indent="0">
              <a:buNone/>
              <a:defRPr sz="7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21947750" y="10276284"/>
            <a:ext cx="19097387" cy="18669836"/>
          </a:xfrm>
        </p:spPr>
        <p:txBody>
          <a:bodyPr/>
          <a:lstStyle>
            <a:lvl1pPr>
              <a:defRPr sz="11300"/>
            </a:lvl1pPr>
            <a:lvl2pPr>
              <a:defRPr sz="9500"/>
            </a:lvl2pPr>
            <a:lvl3pPr>
              <a:defRPr sz="8500"/>
            </a:lvl3pPr>
            <a:lvl4pPr>
              <a:defRPr sz="7600"/>
            </a:lvl4pPr>
            <a:lvl5pPr>
              <a:defRPr sz="7600"/>
            </a:lvl5pPr>
            <a:lvl6pPr>
              <a:defRPr sz="7600"/>
            </a:lvl6pPr>
            <a:lvl7pPr>
              <a:defRPr sz="7600"/>
            </a:lvl7pPr>
            <a:lvl8pPr>
              <a:defRPr sz="7600"/>
            </a:lvl8pPr>
            <a:lvl9pPr>
              <a:defRPr sz="7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160277" y="1290161"/>
            <a:ext cx="14214279" cy="5490686"/>
          </a:xfrm>
        </p:spPr>
        <p:txBody>
          <a:bodyPr anchor="b"/>
          <a:lstStyle>
            <a:lvl1pPr algn="l">
              <a:defRPr sz="95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6892111" y="1290168"/>
            <a:ext cx="24153019" cy="27655959"/>
          </a:xfrm>
        </p:spPr>
        <p:txBody>
          <a:bodyPr/>
          <a:lstStyle>
            <a:lvl1pPr>
              <a:defRPr sz="15100"/>
            </a:lvl1pPr>
            <a:lvl2pPr>
              <a:defRPr sz="13200"/>
            </a:lvl2pPr>
            <a:lvl3pPr>
              <a:defRPr sz="11300"/>
            </a:lvl3pPr>
            <a:lvl4pPr>
              <a:defRPr sz="9500"/>
            </a:lvl4pPr>
            <a:lvl5pPr>
              <a:defRPr sz="9500"/>
            </a:lvl5pPr>
            <a:lvl6pPr>
              <a:defRPr sz="9500"/>
            </a:lvl6pPr>
            <a:lvl7pPr>
              <a:defRPr sz="9500"/>
            </a:lvl7pPr>
            <a:lvl8pPr>
              <a:defRPr sz="9500"/>
            </a:lvl8pPr>
            <a:lvl9pPr>
              <a:defRPr sz="9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160277" y="6780854"/>
            <a:ext cx="14214279" cy="22165273"/>
          </a:xfrm>
        </p:spPr>
        <p:txBody>
          <a:bodyPr/>
          <a:lstStyle>
            <a:lvl1pPr marL="0" indent="0">
              <a:buNone/>
              <a:defRPr sz="6600"/>
            </a:lvl1pPr>
            <a:lvl2pPr marL="2159859" indent="0">
              <a:buNone/>
              <a:defRPr sz="5700"/>
            </a:lvl2pPr>
            <a:lvl3pPr marL="4319718" indent="0">
              <a:buNone/>
              <a:defRPr sz="4700"/>
            </a:lvl3pPr>
            <a:lvl4pPr marL="6479577" indent="0">
              <a:buNone/>
              <a:defRPr sz="4300"/>
            </a:lvl4pPr>
            <a:lvl5pPr marL="8639440" indent="0">
              <a:buNone/>
              <a:defRPr sz="4300"/>
            </a:lvl5pPr>
            <a:lvl6pPr marL="10799299" indent="0">
              <a:buNone/>
              <a:defRPr sz="4300"/>
            </a:lvl6pPr>
            <a:lvl7pPr marL="12959158" indent="0">
              <a:buNone/>
              <a:defRPr sz="4300"/>
            </a:lvl7pPr>
            <a:lvl8pPr marL="15119017" indent="0">
              <a:buNone/>
              <a:defRPr sz="4300"/>
            </a:lvl8pPr>
            <a:lvl9pPr marL="17278876" indent="0">
              <a:buNone/>
              <a:defRPr sz="4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468561" y="22682835"/>
            <a:ext cx="25923240" cy="2677837"/>
          </a:xfrm>
        </p:spPr>
        <p:txBody>
          <a:bodyPr anchor="b"/>
          <a:lstStyle>
            <a:lvl1pPr algn="l">
              <a:defRPr sz="95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8468561" y="2895362"/>
            <a:ext cx="25923240" cy="19442430"/>
          </a:xfrm>
        </p:spPr>
        <p:txBody>
          <a:bodyPr/>
          <a:lstStyle>
            <a:lvl1pPr marL="0" indent="0">
              <a:buNone/>
              <a:defRPr sz="15100"/>
            </a:lvl1pPr>
            <a:lvl2pPr marL="2159859" indent="0">
              <a:buNone/>
              <a:defRPr sz="13200"/>
            </a:lvl2pPr>
            <a:lvl3pPr marL="4319718" indent="0">
              <a:buNone/>
              <a:defRPr sz="11300"/>
            </a:lvl3pPr>
            <a:lvl4pPr marL="6479577" indent="0">
              <a:buNone/>
              <a:defRPr sz="9500"/>
            </a:lvl4pPr>
            <a:lvl5pPr marL="8639440" indent="0">
              <a:buNone/>
              <a:defRPr sz="9500"/>
            </a:lvl5pPr>
            <a:lvl6pPr marL="10799299" indent="0">
              <a:buNone/>
              <a:defRPr sz="9500"/>
            </a:lvl6pPr>
            <a:lvl7pPr marL="12959158" indent="0">
              <a:buNone/>
              <a:defRPr sz="9500"/>
            </a:lvl7pPr>
            <a:lvl8pPr marL="15119017" indent="0">
              <a:buNone/>
              <a:defRPr sz="9500"/>
            </a:lvl8pPr>
            <a:lvl9pPr marL="17278876" indent="0">
              <a:buNone/>
              <a:defRPr sz="95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468561" y="25360672"/>
            <a:ext cx="25923240" cy="3802973"/>
          </a:xfrm>
        </p:spPr>
        <p:txBody>
          <a:bodyPr/>
          <a:lstStyle>
            <a:lvl1pPr marL="0" indent="0">
              <a:buNone/>
              <a:defRPr sz="6600"/>
            </a:lvl1pPr>
            <a:lvl2pPr marL="2159859" indent="0">
              <a:buNone/>
              <a:defRPr sz="5700"/>
            </a:lvl2pPr>
            <a:lvl3pPr marL="4319718" indent="0">
              <a:buNone/>
              <a:defRPr sz="4700"/>
            </a:lvl3pPr>
            <a:lvl4pPr marL="6479577" indent="0">
              <a:buNone/>
              <a:defRPr sz="4300"/>
            </a:lvl4pPr>
            <a:lvl5pPr marL="8639440" indent="0">
              <a:buNone/>
              <a:defRPr sz="4300"/>
            </a:lvl5pPr>
            <a:lvl6pPr marL="10799299" indent="0">
              <a:buNone/>
              <a:defRPr sz="4300"/>
            </a:lvl6pPr>
            <a:lvl7pPr marL="12959158" indent="0">
              <a:buNone/>
              <a:defRPr sz="4300"/>
            </a:lvl7pPr>
            <a:lvl8pPr marL="15119017" indent="0">
              <a:buNone/>
              <a:defRPr sz="4300"/>
            </a:lvl8pPr>
            <a:lvl9pPr marL="17278876" indent="0">
              <a:buNone/>
              <a:defRPr sz="4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2160270" y="1297665"/>
            <a:ext cx="38884860" cy="5400675"/>
          </a:xfrm>
          <a:prstGeom prst="rect">
            <a:avLst/>
          </a:prstGeom>
        </p:spPr>
        <p:txBody>
          <a:bodyPr vert="horz" lIns="431974" tIns="215984" rIns="431974" bIns="215984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2160270" y="7560952"/>
            <a:ext cx="38884860" cy="21385175"/>
          </a:xfrm>
          <a:prstGeom prst="rect">
            <a:avLst/>
          </a:prstGeom>
        </p:spPr>
        <p:txBody>
          <a:bodyPr vert="horz" lIns="431974" tIns="215984" rIns="431974" bIns="215984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2160270" y="30033761"/>
            <a:ext cx="10081260" cy="1725216"/>
          </a:xfrm>
          <a:prstGeom prst="rect">
            <a:avLst/>
          </a:prstGeom>
        </p:spPr>
        <p:txBody>
          <a:bodyPr vert="horz" lIns="431974" tIns="215984" rIns="431974" bIns="215984" rtlCol="0" anchor="ctr"/>
          <a:lstStyle>
            <a:lvl1pPr algn="l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15592F-E446-4EEE-BD9A-97C855CB8F8D}" type="datetimeFigureOut">
              <a:rPr lang="ko-KR" altLang="en-US" smtClean="0"/>
              <a:pPr/>
              <a:t>2019-01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14761845" y="30033761"/>
            <a:ext cx="13681710" cy="1725216"/>
          </a:xfrm>
          <a:prstGeom prst="rect">
            <a:avLst/>
          </a:prstGeom>
        </p:spPr>
        <p:txBody>
          <a:bodyPr vert="horz" lIns="431974" tIns="215984" rIns="431974" bIns="215984" rtlCol="0" anchor="ctr"/>
          <a:lstStyle>
            <a:lvl1pPr algn="ctr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30963870" y="30033761"/>
            <a:ext cx="10081260" cy="1725216"/>
          </a:xfrm>
          <a:prstGeom prst="rect">
            <a:avLst/>
          </a:prstGeom>
        </p:spPr>
        <p:txBody>
          <a:bodyPr vert="horz" lIns="431974" tIns="215984" rIns="431974" bIns="215984" rtlCol="0" anchor="ctr"/>
          <a:lstStyle>
            <a:lvl1pPr algn="r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E9A70-8E76-424F-9D0F-2500B674B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319718" rtl="0" eaLnBrk="1" latinLnBrk="1" hangingPunct="1">
        <a:spcBef>
          <a:spcPct val="0"/>
        </a:spcBef>
        <a:buNone/>
        <a:defRPr sz="20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19895" indent="-1619895" algn="l" defTabSz="4319718" rtl="0" eaLnBrk="1" latinLnBrk="1" hangingPunct="1">
        <a:spcBef>
          <a:spcPct val="20000"/>
        </a:spcBef>
        <a:buFont typeface="Arial" pitchFamily="34" charset="0"/>
        <a:buChar char="•"/>
        <a:defRPr sz="15100" kern="1200">
          <a:solidFill>
            <a:schemeClr val="tx1"/>
          </a:solidFill>
          <a:latin typeface="+mn-lt"/>
          <a:ea typeface="+mn-ea"/>
          <a:cs typeface="+mn-cs"/>
        </a:defRPr>
      </a:lvl1pPr>
      <a:lvl2pPr marL="3509773" indent="-1349914" algn="l" defTabSz="4319718" rtl="0" eaLnBrk="1" latinLnBrk="1" hangingPunct="1">
        <a:spcBef>
          <a:spcPct val="20000"/>
        </a:spcBef>
        <a:buFont typeface="Arial" pitchFamily="34" charset="0"/>
        <a:buChar char="–"/>
        <a:defRPr sz="13200" kern="1200">
          <a:solidFill>
            <a:schemeClr val="tx1"/>
          </a:solidFill>
          <a:latin typeface="+mn-lt"/>
          <a:ea typeface="+mn-ea"/>
          <a:cs typeface="+mn-cs"/>
        </a:defRPr>
      </a:lvl2pPr>
      <a:lvl3pPr marL="5399650" indent="-1079932" algn="l" defTabSz="4319718" rtl="0" eaLnBrk="1" latinLnBrk="1" hangingPunct="1">
        <a:spcBef>
          <a:spcPct val="20000"/>
        </a:spcBef>
        <a:buFont typeface="Arial" pitchFamily="34" charset="0"/>
        <a:buChar char="•"/>
        <a:defRPr sz="11300" kern="1200">
          <a:solidFill>
            <a:schemeClr val="tx1"/>
          </a:solidFill>
          <a:latin typeface="+mn-lt"/>
          <a:ea typeface="+mn-ea"/>
          <a:cs typeface="+mn-cs"/>
        </a:defRPr>
      </a:lvl3pPr>
      <a:lvl4pPr marL="7559509" indent="-1079932" algn="l" defTabSz="4319718" rtl="0" eaLnBrk="1" latinLnBrk="1" hangingPunct="1">
        <a:spcBef>
          <a:spcPct val="20000"/>
        </a:spcBef>
        <a:buFont typeface="Arial" pitchFamily="34" charset="0"/>
        <a:buChar char="–"/>
        <a:defRPr sz="9500" kern="1200">
          <a:solidFill>
            <a:schemeClr val="tx1"/>
          </a:solidFill>
          <a:latin typeface="+mn-lt"/>
          <a:ea typeface="+mn-ea"/>
          <a:cs typeface="+mn-cs"/>
        </a:defRPr>
      </a:lvl4pPr>
      <a:lvl5pPr marL="9719368" indent="-1079932" algn="l" defTabSz="4319718" rtl="0" eaLnBrk="1" latinLnBrk="1" hangingPunct="1">
        <a:spcBef>
          <a:spcPct val="20000"/>
        </a:spcBef>
        <a:buFont typeface="Arial" pitchFamily="34" charset="0"/>
        <a:buChar char="»"/>
        <a:defRPr sz="9500" kern="1200">
          <a:solidFill>
            <a:schemeClr val="tx1"/>
          </a:solidFill>
          <a:latin typeface="+mn-lt"/>
          <a:ea typeface="+mn-ea"/>
          <a:cs typeface="+mn-cs"/>
        </a:defRPr>
      </a:lvl5pPr>
      <a:lvl6pPr marL="11879226" indent="-1079932" algn="l" defTabSz="4319718" rtl="0" eaLnBrk="1" latinLnBrk="1" hangingPunct="1">
        <a:spcBef>
          <a:spcPct val="20000"/>
        </a:spcBef>
        <a:buFont typeface="Arial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6pPr>
      <a:lvl7pPr marL="14039085" indent="-1079932" algn="l" defTabSz="4319718" rtl="0" eaLnBrk="1" latinLnBrk="1" hangingPunct="1">
        <a:spcBef>
          <a:spcPct val="20000"/>
        </a:spcBef>
        <a:buFont typeface="Arial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7pPr>
      <a:lvl8pPr marL="16198944" indent="-1079932" algn="l" defTabSz="4319718" rtl="0" eaLnBrk="1" latinLnBrk="1" hangingPunct="1">
        <a:spcBef>
          <a:spcPct val="20000"/>
        </a:spcBef>
        <a:buFont typeface="Arial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8pPr>
      <a:lvl9pPr marL="18358808" indent="-1079932" algn="l" defTabSz="4319718" rtl="0" eaLnBrk="1" latinLnBrk="1" hangingPunct="1">
        <a:spcBef>
          <a:spcPct val="20000"/>
        </a:spcBef>
        <a:buFont typeface="Arial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1pPr>
      <a:lvl2pPr marL="2159859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2pPr>
      <a:lvl3pPr marL="4319718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3pPr>
      <a:lvl4pPr marL="6479577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4pPr>
      <a:lvl5pPr marL="8639440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5pPr>
      <a:lvl6pPr marL="10799299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6pPr>
      <a:lvl7pPr marL="12959158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7pPr>
      <a:lvl8pPr marL="15119017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8pPr>
      <a:lvl9pPr marL="17278876" algn="l" defTabSz="4319718" rtl="0" eaLnBrk="1" latinLnBrk="1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9.xml"/><Relationship Id="rId3" Type="http://schemas.openxmlformats.org/officeDocument/2006/relationships/chart" Target="../charts/chart84.xml"/><Relationship Id="rId7" Type="http://schemas.openxmlformats.org/officeDocument/2006/relationships/chart" Target="../charts/chart88.xml"/><Relationship Id="rId2" Type="http://schemas.openxmlformats.org/officeDocument/2006/relationships/chart" Target="../charts/chart8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87.xml"/><Relationship Id="rId11" Type="http://schemas.openxmlformats.org/officeDocument/2006/relationships/chart" Target="../charts/chart92.xml"/><Relationship Id="rId5" Type="http://schemas.openxmlformats.org/officeDocument/2006/relationships/chart" Target="../charts/chart86.xml"/><Relationship Id="rId10" Type="http://schemas.openxmlformats.org/officeDocument/2006/relationships/chart" Target="../charts/chart91.xml"/><Relationship Id="rId4" Type="http://schemas.openxmlformats.org/officeDocument/2006/relationships/chart" Target="../charts/chart85.xml"/><Relationship Id="rId9" Type="http://schemas.openxmlformats.org/officeDocument/2006/relationships/chart" Target="../charts/chart90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99.xml"/><Relationship Id="rId3" Type="http://schemas.openxmlformats.org/officeDocument/2006/relationships/chart" Target="../charts/chart94.xml"/><Relationship Id="rId7" Type="http://schemas.openxmlformats.org/officeDocument/2006/relationships/chart" Target="../charts/chart98.xml"/><Relationship Id="rId2" Type="http://schemas.openxmlformats.org/officeDocument/2006/relationships/chart" Target="../charts/chart9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97.xml"/><Relationship Id="rId5" Type="http://schemas.openxmlformats.org/officeDocument/2006/relationships/chart" Target="../charts/chart96.xml"/><Relationship Id="rId4" Type="http://schemas.openxmlformats.org/officeDocument/2006/relationships/chart" Target="../charts/chart95.xml"/><Relationship Id="rId9" Type="http://schemas.openxmlformats.org/officeDocument/2006/relationships/chart" Target="../charts/chart100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06.xml"/><Relationship Id="rId3" Type="http://schemas.openxmlformats.org/officeDocument/2006/relationships/chart" Target="../charts/chart101.xml"/><Relationship Id="rId7" Type="http://schemas.openxmlformats.org/officeDocument/2006/relationships/chart" Target="../charts/chart105.xml"/><Relationship Id="rId12" Type="http://schemas.openxmlformats.org/officeDocument/2006/relationships/chart" Target="../charts/chart110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04.xml"/><Relationship Id="rId11" Type="http://schemas.openxmlformats.org/officeDocument/2006/relationships/chart" Target="../charts/chart109.xml"/><Relationship Id="rId5" Type="http://schemas.openxmlformats.org/officeDocument/2006/relationships/chart" Target="../charts/chart103.xml"/><Relationship Id="rId10" Type="http://schemas.openxmlformats.org/officeDocument/2006/relationships/chart" Target="../charts/chart108.xml"/><Relationship Id="rId4" Type="http://schemas.openxmlformats.org/officeDocument/2006/relationships/chart" Target="../charts/chart102.xml"/><Relationship Id="rId9" Type="http://schemas.openxmlformats.org/officeDocument/2006/relationships/chart" Target="../charts/chart107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17.xml"/><Relationship Id="rId3" Type="http://schemas.openxmlformats.org/officeDocument/2006/relationships/chart" Target="../charts/chart112.xml"/><Relationship Id="rId7" Type="http://schemas.openxmlformats.org/officeDocument/2006/relationships/chart" Target="../charts/chart116.xml"/><Relationship Id="rId2" Type="http://schemas.openxmlformats.org/officeDocument/2006/relationships/chart" Target="../charts/chart11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5.xml"/><Relationship Id="rId11" Type="http://schemas.openxmlformats.org/officeDocument/2006/relationships/chart" Target="../charts/chart120.xml"/><Relationship Id="rId5" Type="http://schemas.openxmlformats.org/officeDocument/2006/relationships/chart" Target="../charts/chart114.xml"/><Relationship Id="rId10" Type="http://schemas.openxmlformats.org/officeDocument/2006/relationships/chart" Target="../charts/chart119.xml"/><Relationship Id="rId4" Type="http://schemas.openxmlformats.org/officeDocument/2006/relationships/chart" Target="../charts/chart113.xml"/><Relationship Id="rId9" Type="http://schemas.openxmlformats.org/officeDocument/2006/relationships/chart" Target="../charts/chart118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26.xml"/><Relationship Id="rId3" Type="http://schemas.openxmlformats.org/officeDocument/2006/relationships/chart" Target="../charts/chart121.xml"/><Relationship Id="rId7" Type="http://schemas.openxmlformats.org/officeDocument/2006/relationships/chart" Target="../charts/chart125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4.xml"/><Relationship Id="rId5" Type="http://schemas.openxmlformats.org/officeDocument/2006/relationships/chart" Target="../charts/chart123.xml"/><Relationship Id="rId10" Type="http://schemas.openxmlformats.org/officeDocument/2006/relationships/chart" Target="../charts/chart128.xml"/><Relationship Id="rId4" Type="http://schemas.openxmlformats.org/officeDocument/2006/relationships/chart" Target="../charts/chart122.xml"/><Relationship Id="rId9" Type="http://schemas.openxmlformats.org/officeDocument/2006/relationships/chart" Target="../charts/chart127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5.xml"/><Relationship Id="rId3" Type="http://schemas.openxmlformats.org/officeDocument/2006/relationships/chart" Target="../charts/chart130.xml"/><Relationship Id="rId7" Type="http://schemas.openxmlformats.org/officeDocument/2006/relationships/chart" Target="../charts/chart134.xml"/><Relationship Id="rId2" Type="http://schemas.openxmlformats.org/officeDocument/2006/relationships/chart" Target="../charts/chart12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33.xml"/><Relationship Id="rId11" Type="http://schemas.openxmlformats.org/officeDocument/2006/relationships/chart" Target="../charts/chart138.xml"/><Relationship Id="rId5" Type="http://schemas.openxmlformats.org/officeDocument/2006/relationships/chart" Target="../charts/chart132.xml"/><Relationship Id="rId10" Type="http://schemas.openxmlformats.org/officeDocument/2006/relationships/chart" Target="../charts/chart137.xml"/><Relationship Id="rId4" Type="http://schemas.openxmlformats.org/officeDocument/2006/relationships/chart" Target="../charts/chart131.xml"/><Relationship Id="rId9" Type="http://schemas.openxmlformats.org/officeDocument/2006/relationships/chart" Target="../charts/chart136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18" Type="http://schemas.openxmlformats.org/officeDocument/2006/relationships/image" Target="../media/image18.png"/><Relationship Id="rId3" Type="http://schemas.openxmlformats.org/officeDocument/2006/relationships/image" Target="../media/image3.png"/><Relationship Id="rId21" Type="http://schemas.openxmlformats.org/officeDocument/2006/relationships/image" Target="../media/image21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" Type="http://schemas.openxmlformats.org/officeDocument/2006/relationships/image" Target="../media/image2.png"/><Relationship Id="rId16" Type="http://schemas.openxmlformats.org/officeDocument/2006/relationships/image" Target="../media/image16.png"/><Relationship Id="rId20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19" Type="http://schemas.openxmlformats.org/officeDocument/2006/relationships/image" Target="../media/image19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Relationship Id="rId22" Type="http://schemas.openxmlformats.org/officeDocument/2006/relationships/image" Target="../media/image2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5" Type="http://schemas.openxmlformats.org/officeDocument/2006/relationships/chart" Target="../charts/chart24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24" Type="http://schemas.openxmlformats.org/officeDocument/2006/relationships/chart" Target="../charts/chart23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23" Type="http://schemas.openxmlformats.org/officeDocument/2006/relationships/chart" Target="../charts/chart22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1.xml"/><Relationship Id="rId13" Type="http://schemas.openxmlformats.org/officeDocument/2006/relationships/chart" Target="../charts/chart36.xml"/><Relationship Id="rId18" Type="http://schemas.openxmlformats.org/officeDocument/2006/relationships/chart" Target="../charts/chart41.xml"/><Relationship Id="rId3" Type="http://schemas.openxmlformats.org/officeDocument/2006/relationships/chart" Target="../charts/chart26.xml"/><Relationship Id="rId21" Type="http://schemas.openxmlformats.org/officeDocument/2006/relationships/chart" Target="../charts/chart44.xml"/><Relationship Id="rId7" Type="http://schemas.openxmlformats.org/officeDocument/2006/relationships/chart" Target="../charts/chart30.xml"/><Relationship Id="rId12" Type="http://schemas.openxmlformats.org/officeDocument/2006/relationships/chart" Target="../charts/chart35.xml"/><Relationship Id="rId17" Type="http://schemas.openxmlformats.org/officeDocument/2006/relationships/chart" Target="../charts/chart40.xml"/><Relationship Id="rId25" Type="http://schemas.openxmlformats.org/officeDocument/2006/relationships/chart" Target="../charts/chart48.xml"/><Relationship Id="rId2" Type="http://schemas.openxmlformats.org/officeDocument/2006/relationships/chart" Target="../charts/chart25.xml"/><Relationship Id="rId16" Type="http://schemas.openxmlformats.org/officeDocument/2006/relationships/chart" Target="../charts/chart39.xml"/><Relationship Id="rId20" Type="http://schemas.openxmlformats.org/officeDocument/2006/relationships/chart" Target="../charts/chart4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9.xml"/><Relationship Id="rId11" Type="http://schemas.openxmlformats.org/officeDocument/2006/relationships/chart" Target="../charts/chart34.xml"/><Relationship Id="rId24" Type="http://schemas.openxmlformats.org/officeDocument/2006/relationships/chart" Target="../charts/chart47.xml"/><Relationship Id="rId5" Type="http://schemas.openxmlformats.org/officeDocument/2006/relationships/chart" Target="../charts/chart28.xml"/><Relationship Id="rId15" Type="http://schemas.openxmlformats.org/officeDocument/2006/relationships/chart" Target="../charts/chart38.xml"/><Relationship Id="rId23" Type="http://schemas.openxmlformats.org/officeDocument/2006/relationships/chart" Target="../charts/chart46.xml"/><Relationship Id="rId10" Type="http://schemas.openxmlformats.org/officeDocument/2006/relationships/chart" Target="../charts/chart33.xml"/><Relationship Id="rId19" Type="http://schemas.openxmlformats.org/officeDocument/2006/relationships/chart" Target="../charts/chart42.xml"/><Relationship Id="rId4" Type="http://schemas.openxmlformats.org/officeDocument/2006/relationships/chart" Target="../charts/chart27.xml"/><Relationship Id="rId9" Type="http://schemas.openxmlformats.org/officeDocument/2006/relationships/chart" Target="../charts/chart32.xml"/><Relationship Id="rId14" Type="http://schemas.openxmlformats.org/officeDocument/2006/relationships/chart" Target="../charts/chart37.xml"/><Relationship Id="rId22" Type="http://schemas.openxmlformats.org/officeDocument/2006/relationships/chart" Target="../charts/chart45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5.xml"/><Relationship Id="rId13" Type="http://schemas.openxmlformats.org/officeDocument/2006/relationships/chart" Target="../charts/chart60.xml"/><Relationship Id="rId3" Type="http://schemas.openxmlformats.org/officeDocument/2006/relationships/chart" Target="../charts/chart50.xml"/><Relationship Id="rId7" Type="http://schemas.openxmlformats.org/officeDocument/2006/relationships/chart" Target="../charts/chart54.xml"/><Relationship Id="rId12" Type="http://schemas.openxmlformats.org/officeDocument/2006/relationships/chart" Target="../charts/chart59.xml"/><Relationship Id="rId2" Type="http://schemas.openxmlformats.org/officeDocument/2006/relationships/chart" Target="../charts/chart4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3.xml"/><Relationship Id="rId11" Type="http://schemas.openxmlformats.org/officeDocument/2006/relationships/chart" Target="../charts/chart58.xml"/><Relationship Id="rId5" Type="http://schemas.openxmlformats.org/officeDocument/2006/relationships/chart" Target="../charts/chart52.xml"/><Relationship Id="rId15" Type="http://schemas.openxmlformats.org/officeDocument/2006/relationships/chart" Target="../charts/chart62.xml"/><Relationship Id="rId10" Type="http://schemas.openxmlformats.org/officeDocument/2006/relationships/chart" Target="../charts/chart57.xml"/><Relationship Id="rId4" Type="http://schemas.openxmlformats.org/officeDocument/2006/relationships/chart" Target="../charts/chart51.xml"/><Relationship Id="rId9" Type="http://schemas.openxmlformats.org/officeDocument/2006/relationships/chart" Target="../charts/chart56.xml"/><Relationship Id="rId14" Type="http://schemas.openxmlformats.org/officeDocument/2006/relationships/chart" Target="../charts/chart61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9.xml"/><Relationship Id="rId3" Type="http://schemas.openxmlformats.org/officeDocument/2006/relationships/chart" Target="../charts/chart64.xml"/><Relationship Id="rId7" Type="http://schemas.openxmlformats.org/officeDocument/2006/relationships/chart" Target="../charts/chart68.xml"/><Relationship Id="rId2" Type="http://schemas.openxmlformats.org/officeDocument/2006/relationships/chart" Target="../charts/chart6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67.xml"/><Relationship Id="rId11" Type="http://schemas.openxmlformats.org/officeDocument/2006/relationships/chart" Target="../charts/chart72.xml"/><Relationship Id="rId5" Type="http://schemas.openxmlformats.org/officeDocument/2006/relationships/chart" Target="../charts/chart66.xml"/><Relationship Id="rId10" Type="http://schemas.openxmlformats.org/officeDocument/2006/relationships/chart" Target="../charts/chart71.xml"/><Relationship Id="rId4" Type="http://schemas.openxmlformats.org/officeDocument/2006/relationships/chart" Target="../charts/chart65.xml"/><Relationship Id="rId9" Type="http://schemas.openxmlformats.org/officeDocument/2006/relationships/chart" Target="../charts/chart70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9.xml"/><Relationship Id="rId3" Type="http://schemas.openxmlformats.org/officeDocument/2006/relationships/chart" Target="../charts/chart74.xml"/><Relationship Id="rId7" Type="http://schemas.openxmlformats.org/officeDocument/2006/relationships/chart" Target="../charts/chart78.xml"/><Relationship Id="rId2" Type="http://schemas.openxmlformats.org/officeDocument/2006/relationships/chart" Target="../charts/chart7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7.xml"/><Relationship Id="rId11" Type="http://schemas.openxmlformats.org/officeDocument/2006/relationships/chart" Target="../charts/chart82.xml"/><Relationship Id="rId5" Type="http://schemas.openxmlformats.org/officeDocument/2006/relationships/chart" Target="../charts/chart76.xml"/><Relationship Id="rId10" Type="http://schemas.openxmlformats.org/officeDocument/2006/relationships/chart" Target="../charts/chart81.xml"/><Relationship Id="rId4" Type="http://schemas.openxmlformats.org/officeDocument/2006/relationships/chart" Target="../charts/chart75.xml"/><Relationship Id="rId9" Type="http://schemas.openxmlformats.org/officeDocument/2006/relationships/chart" Target="../charts/chart8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008412" y="288257"/>
            <a:ext cx="12313368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1.</a:t>
            </a:r>
            <a:endParaRPr lang="ko-KR" altLang="en-US" dirty="0"/>
          </a:p>
        </p:txBody>
      </p:sp>
      <p:grpSp>
        <p:nvGrpSpPr>
          <p:cNvPr id="119" name="그룹 118"/>
          <p:cNvGrpSpPr/>
          <p:nvPr/>
        </p:nvGrpSpPr>
        <p:grpSpPr>
          <a:xfrm>
            <a:off x="5888645" y="3249198"/>
            <a:ext cx="27897170" cy="28108840"/>
            <a:chOff x="458868" y="-228308"/>
            <a:chExt cx="23087663" cy="32297814"/>
          </a:xfrm>
        </p:grpSpPr>
        <p:grpSp>
          <p:nvGrpSpPr>
            <p:cNvPr id="2" name="그룹 1"/>
            <p:cNvGrpSpPr/>
            <p:nvPr/>
          </p:nvGrpSpPr>
          <p:grpSpPr>
            <a:xfrm>
              <a:off x="594568" y="1694952"/>
              <a:ext cx="22951963" cy="30374554"/>
              <a:chOff x="10153428" y="1512393"/>
              <a:chExt cx="30459384" cy="30374554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153428" y="1512393"/>
                <a:ext cx="30459384" cy="282277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36868396" y="13117875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04_rep1</a:t>
                </a:r>
                <a:endParaRPr lang="ko-KR" altLang="en-US" sz="4000" b="1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6868396" y="14212660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04_rep2</a:t>
                </a:r>
                <a:endParaRPr lang="ko-KR" altLang="en-US" sz="4000" b="1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6868396" y="15272341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08_rep1</a:t>
                </a:r>
                <a:endParaRPr lang="ko-KR" altLang="en-US" sz="4000" b="1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6868396" y="16300892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08_rep2</a:t>
                </a:r>
                <a:endParaRPr lang="ko-KR" altLang="en-US" sz="4000" b="1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6868396" y="17397283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16_rep1</a:t>
                </a:r>
                <a:endParaRPr lang="ko-KR" altLang="en-US" sz="4000" b="1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6868396" y="18489597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16_rep2</a:t>
                </a:r>
                <a:endParaRPr lang="ko-KR" altLang="en-US" sz="40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6868396" y="19549278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12_rep1</a:t>
                </a:r>
                <a:endParaRPr lang="ko-KR" altLang="en-US" sz="4000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6868396" y="20577829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12_rep2</a:t>
                </a:r>
                <a:endParaRPr lang="ko-KR" altLang="en-US" sz="4000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6868396" y="21674220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20_rep1</a:t>
                </a:r>
                <a:endParaRPr lang="ko-KR" altLang="en-US" sz="4000" b="1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6868396" y="22766534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20_rep2</a:t>
                </a:r>
                <a:endParaRPr lang="ko-KR" altLang="en-US" sz="40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6868396" y="23826215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00_rep1</a:t>
                </a:r>
                <a:endParaRPr lang="ko-KR" altLang="en-US" sz="40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6868396" y="24854766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00_rep2</a:t>
                </a:r>
                <a:endParaRPr lang="ko-KR" altLang="en-US" sz="40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6868396" y="26073541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24_rep1</a:t>
                </a:r>
                <a:endParaRPr lang="ko-KR" altLang="en-US" sz="40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6868396" y="27102092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4000" b="1" dirty="0" smtClean="0"/>
                  <a:t>ZT24_rep2</a:t>
                </a:r>
                <a:endParaRPr lang="ko-KR" altLang="en-US" sz="40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6200000">
                <a:off x="33113806" y="29609994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04_rep1</a:t>
                </a:r>
                <a:endParaRPr lang="ko-KR" altLang="en-US" sz="400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6200000">
                <a:off x="34210197" y="29609995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04_rep2</a:t>
                </a:r>
                <a:endParaRPr lang="ko-KR" altLang="en-US" sz="40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30978536" y="29660796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08_rep1</a:t>
                </a:r>
                <a:endParaRPr lang="ko-KR" altLang="en-US" sz="40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31956741" y="29660796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08_rep2</a:t>
                </a:r>
                <a:endParaRPr lang="ko-KR" altLang="en-US" sz="40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6200000">
                <a:off x="28809596" y="29609994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16_rep1</a:t>
                </a:r>
                <a:endParaRPr lang="ko-KR" altLang="en-US" sz="4000" b="1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6200000">
                <a:off x="29937881" y="29609994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16_rep2</a:t>
                </a:r>
                <a:endParaRPr lang="ko-KR" altLang="en-US" sz="40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26624917" y="29609996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12_rep1</a:t>
                </a:r>
                <a:endParaRPr lang="ko-KR" altLang="en-US" sz="40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6200000">
                <a:off x="27705037" y="29609997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12_rep2</a:t>
                </a:r>
                <a:endParaRPr lang="ko-KR" altLang="en-US" sz="4000" b="1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6200000">
                <a:off x="24480103" y="29609994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20_rep1</a:t>
                </a:r>
                <a:endParaRPr lang="ko-KR" altLang="en-US" sz="4000" b="1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6200000">
                <a:off x="25488215" y="29609996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20_rep2</a:t>
                </a:r>
                <a:endParaRPr lang="ko-KR" altLang="en-US" sz="4000" b="1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6200000">
                <a:off x="22318930" y="29601613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00_rep1</a:t>
                </a:r>
                <a:endParaRPr lang="ko-KR" altLang="en-US" sz="4000" b="1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6200000">
                <a:off x="23377842" y="29601612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00_rep2</a:t>
                </a:r>
                <a:endParaRPr lang="ko-KR" altLang="en-US" sz="4000" b="1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16200000">
                <a:off x="20310333" y="29601613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24_rep1</a:t>
                </a:r>
                <a:endParaRPr lang="ko-KR" altLang="en-US" sz="4000" b="1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6200000">
                <a:off x="21361988" y="29601611"/>
                <a:ext cx="3744416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4000" b="1" dirty="0" smtClean="0"/>
                  <a:t>ZT24_rep2</a:t>
                </a:r>
                <a:endParaRPr lang="ko-KR" altLang="en-US" sz="4000" b="1" dirty="0"/>
              </a:p>
            </p:txBody>
          </p:sp>
        </p:grpSp>
        <p:sp>
          <p:nvSpPr>
            <p:cNvPr id="34" name="TextBox 33"/>
            <p:cNvSpPr txBox="1"/>
            <p:nvPr/>
          </p:nvSpPr>
          <p:spPr>
            <a:xfrm>
              <a:off x="8022188" y="9308636"/>
              <a:ext cx="1152000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08</a:t>
              </a:r>
              <a:endParaRPr lang="ko-KR" altLang="en-US" sz="28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993188" y="9831856"/>
              <a:ext cx="1152000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04</a:t>
              </a:r>
              <a:endParaRPr lang="ko-KR" altLang="en-US" sz="28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7993188" y="10360291"/>
              <a:ext cx="1152000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24</a:t>
              </a:r>
              <a:endParaRPr lang="ko-KR" altLang="en-US" sz="28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022188" y="10892812"/>
              <a:ext cx="1152000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20</a:t>
              </a:r>
              <a:endParaRPr lang="ko-KR" altLang="en-US" sz="28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993188" y="11353325"/>
              <a:ext cx="1152000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16</a:t>
              </a:r>
              <a:endParaRPr lang="ko-KR" altLang="en-US" sz="2800" b="1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022188" y="11828916"/>
              <a:ext cx="1152000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12</a:t>
              </a:r>
              <a:endParaRPr lang="ko-KR" altLang="en-US" sz="2800" b="1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993188" y="12361437"/>
              <a:ext cx="1152000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00</a:t>
              </a:r>
              <a:endParaRPr lang="ko-KR" altLang="en-US" sz="2800" b="1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8287399" y="29074370"/>
              <a:ext cx="1260000" cy="42008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08</a:t>
              </a:r>
              <a:endParaRPr lang="ko-KR" altLang="en-US" sz="2800" b="1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7867318" y="29038505"/>
              <a:ext cx="1260000" cy="42008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04</a:t>
              </a:r>
              <a:endParaRPr lang="ko-KR" altLang="en-US" sz="2800" b="1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7478010" y="29045905"/>
              <a:ext cx="1260000" cy="42008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24</a:t>
              </a:r>
              <a:endParaRPr lang="ko-KR" altLang="en-US" sz="2800" b="1" dirty="0"/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7131129" y="29045905"/>
              <a:ext cx="1260000" cy="42008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20</a:t>
              </a:r>
              <a:endParaRPr lang="ko-KR" altLang="en-US" sz="2800" b="1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6703581" y="29045905"/>
              <a:ext cx="1260000" cy="42008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16</a:t>
              </a:r>
              <a:endParaRPr lang="ko-KR" altLang="en-US" sz="2800" b="1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6267207" y="29045905"/>
              <a:ext cx="1260000" cy="42008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12</a:t>
              </a:r>
              <a:endParaRPr lang="ko-KR" altLang="en-US" sz="2800" b="1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5917045" y="29045905"/>
              <a:ext cx="1260000" cy="42008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800" b="1" dirty="0" smtClean="0"/>
                <a:t>ZT00</a:t>
              </a:r>
              <a:endParaRPr lang="ko-KR" altLang="en-US" sz="28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2450075" y="2487040"/>
              <a:ext cx="8437035" cy="132343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4000" b="1" dirty="0"/>
                <a:t>sample correlation matrix</a:t>
              </a:r>
            </a:p>
            <a:p>
              <a:r>
                <a:rPr lang="en-US" altLang="ko-KR" sz="4000" b="1" dirty="0"/>
                <a:t>diffExpr.P0.001_C2.matrix.log2</a:t>
              </a:r>
              <a:endParaRPr lang="ko-KR" altLang="en-US" sz="40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58868" y="-228308"/>
              <a:ext cx="2358061" cy="1400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 smtClean="0"/>
                <a:t>A</a:t>
              </a:r>
              <a:endParaRPr lang="ko-KR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3210301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직사각형 12"/>
          <p:cNvSpPr/>
          <p:nvPr/>
        </p:nvSpPr>
        <p:spPr>
          <a:xfrm>
            <a:off x="37843364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4" name="직사각형 13"/>
          <p:cNvSpPr/>
          <p:nvPr/>
        </p:nvSpPr>
        <p:spPr>
          <a:xfrm>
            <a:off x="29065244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5" name="직사각형 14"/>
          <p:cNvSpPr/>
          <p:nvPr/>
        </p:nvSpPr>
        <p:spPr>
          <a:xfrm>
            <a:off x="20234548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3" name="차트 2"/>
          <p:cNvGraphicFramePr/>
          <p:nvPr/>
        </p:nvGraphicFramePr>
        <p:xfrm>
          <a:off x="14329892" y="2520505"/>
          <a:ext cx="26714968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차트 3"/>
          <p:cNvGraphicFramePr/>
          <p:nvPr/>
        </p:nvGraphicFramePr>
        <p:xfrm>
          <a:off x="1656484" y="2520505"/>
          <a:ext cx="12673408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차트 4"/>
          <p:cNvGraphicFramePr/>
          <p:nvPr/>
        </p:nvGraphicFramePr>
        <p:xfrm>
          <a:off x="14329892" y="8137129"/>
          <a:ext cx="26642960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차트 5"/>
          <p:cNvGraphicFramePr/>
          <p:nvPr/>
        </p:nvGraphicFramePr>
        <p:xfrm>
          <a:off x="1872508" y="8137129"/>
          <a:ext cx="12313368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차트 6"/>
          <p:cNvGraphicFramePr/>
          <p:nvPr/>
        </p:nvGraphicFramePr>
        <p:xfrm>
          <a:off x="14401900" y="13753753"/>
          <a:ext cx="26498944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차트 7"/>
          <p:cNvGraphicFramePr/>
          <p:nvPr/>
        </p:nvGraphicFramePr>
        <p:xfrm>
          <a:off x="1872508" y="13825761"/>
          <a:ext cx="12313368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차트 8"/>
          <p:cNvGraphicFramePr/>
          <p:nvPr/>
        </p:nvGraphicFramePr>
        <p:xfrm>
          <a:off x="1728492" y="19298369"/>
          <a:ext cx="12601400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차트 9"/>
          <p:cNvGraphicFramePr/>
          <p:nvPr/>
        </p:nvGraphicFramePr>
        <p:xfrm>
          <a:off x="14329892" y="19370377"/>
          <a:ext cx="26642960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1" name="차트 10"/>
          <p:cNvGraphicFramePr/>
          <p:nvPr/>
        </p:nvGraphicFramePr>
        <p:xfrm>
          <a:off x="14329892" y="24914993"/>
          <a:ext cx="26714968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2" name="차트 11"/>
          <p:cNvGraphicFramePr/>
          <p:nvPr/>
        </p:nvGraphicFramePr>
        <p:xfrm>
          <a:off x="1728492" y="24914993"/>
          <a:ext cx="12529392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6" name="직사각형 15"/>
          <p:cNvSpPr/>
          <p:nvPr/>
        </p:nvSpPr>
        <p:spPr>
          <a:xfrm>
            <a:off x="9649372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/>
          <p:cNvSpPr/>
          <p:nvPr/>
        </p:nvSpPr>
        <p:spPr>
          <a:xfrm>
            <a:off x="3614417" y="2765104"/>
            <a:ext cx="622478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1668 (BrPIF3b)</a:t>
            </a:r>
            <a:endParaRPr lang="ko-KR" altLang="en-US" sz="4800" b="1" dirty="0"/>
          </a:p>
        </p:txBody>
      </p:sp>
      <p:sp>
        <p:nvSpPr>
          <p:cNvPr id="19" name="직사각형 18"/>
          <p:cNvSpPr/>
          <p:nvPr/>
        </p:nvSpPr>
        <p:spPr>
          <a:xfrm>
            <a:off x="3312668" y="8425161"/>
            <a:ext cx="5224507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24536 (</a:t>
            </a:r>
            <a:r>
              <a:rPr lang="en-US" altLang="ko-KR" sz="4800" b="1" dirty="0" err="1" smtClean="0"/>
              <a:t>BrGI</a:t>
            </a:r>
            <a:r>
              <a:rPr lang="en-US" altLang="ko-KR" sz="4800" b="1" dirty="0" smtClean="0"/>
              <a:t>)</a:t>
            </a:r>
            <a:endParaRPr lang="ko-KR" altLang="en-US" sz="4800" b="1" dirty="0"/>
          </a:p>
        </p:txBody>
      </p:sp>
      <p:sp>
        <p:nvSpPr>
          <p:cNvPr id="20" name="직사각형 19"/>
          <p:cNvSpPr/>
          <p:nvPr/>
        </p:nvSpPr>
        <p:spPr>
          <a:xfrm>
            <a:off x="3240660" y="14113793"/>
            <a:ext cx="6252033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7774 (BrELF3a)</a:t>
            </a:r>
            <a:endParaRPr lang="ko-KR" altLang="en-US" sz="4800" b="1" dirty="0"/>
          </a:p>
        </p:txBody>
      </p:sp>
      <p:sp>
        <p:nvSpPr>
          <p:cNvPr id="21" name="직사각형 20"/>
          <p:cNvSpPr/>
          <p:nvPr/>
        </p:nvSpPr>
        <p:spPr>
          <a:xfrm>
            <a:off x="3346043" y="19514393"/>
            <a:ext cx="6303329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4284 (BrELF3b)</a:t>
            </a:r>
            <a:endParaRPr lang="ko-KR" altLang="en-US" sz="4800" b="1" dirty="0"/>
          </a:p>
        </p:txBody>
      </p:sp>
      <p:sp>
        <p:nvSpPr>
          <p:cNvPr id="22" name="직사각형 21"/>
          <p:cNvSpPr/>
          <p:nvPr/>
        </p:nvSpPr>
        <p:spPr>
          <a:xfrm>
            <a:off x="3240660" y="25203025"/>
            <a:ext cx="6252033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0165 (BrELF4a)</a:t>
            </a:r>
            <a:endParaRPr lang="ko-KR" altLang="en-US" sz="4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6. continue</a:t>
            </a:r>
            <a:endParaRPr lang="ko-KR" altLang="en-US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직사각형 11"/>
          <p:cNvSpPr/>
          <p:nvPr/>
        </p:nvSpPr>
        <p:spPr>
          <a:xfrm>
            <a:off x="37569044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3" name="직사각형 12"/>
          <p:cNvSpPr/>
          <p:nvPr/>
        </p:nvSpPr>
        <p:spPr>
          <a:xfrm>
            <a:off x="28790924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4" name="직사각형 13"/>
          <p:cNvSpPr/>
          <p:nvPr/>
        </p:nvSpPr>
        <p:spPr>
          <a:xfrm>
            <a:off x="19960228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3" name="차트 2"/>
          <p:cNvGraphicFramePr/>
          <p:nvPr/>
        </p:nvGraphicFramePr>
        <p:xfrm>
          <a:off x="14329892" y="2520505"/>
          <a:ext cx="26642960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차트 3"/>
          <p:cNvGraphicFramePr/>
          <p:nvPr/>
        </p:nvGraphicFramePr>
        <p:xfrm>
          <a:off x="1800500" y="2520505"/>
          <a:ext cx="12313368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차트 4"/>
          <p:cNvGraphicFramePr/>
          <p:nvPr/>
        </p:nvGraphicFramePr>
        <p:xfrm>
          <a:off x="14401900" y="8209137"/>
          <a:ext cx="26426936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차트 5"/>
          <p:cNvGraphicFramePr/>
          <p:nvPr/>
        </p:nvGraphicFramePr>
        <p:xfrm>
          <a:off x="1800500" y="8209137"/>
          <a:ext cx="12313368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차트 6"/>
          <p:cNvGraphicFramePr/>
          <p:nvPr/>
        </p:nvGraphicFramePr>
        <p:xfrm>
          <a:off x="14401900" y="13897769"/>
          <a:ext cx="26426936" cy="5184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차트 7"/>
          <p:cNvGraphicFramePr/>
          <p:nvPr/>
        </p:nvGraphicFramePr>
        <p:xfrm>
          <a:off x="1872508" y="13825761"/>
          <a:ext cx="12241360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차트 8"/>
          <p:cNvGraphicFramePr/>
          <p:nvPr/>
        </p:nvGraphicFramePr>
        <p:xfrm>
          <a:off x="14401900" y="24987001"/>
          <a:ext cx="26498944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차트 9"/>
          <p:cNvGraphicFramePr/>
          <p:nvPr/>
        </p:nvGraphicFramePr>
        <p:xfrm>
          <a:off x="1728492" y="24987001"/>
          <a:ext cx="12385376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5" name="직사각형 14"/>
          <p:cNvSpPr/>
          <p:nvPr/>
        </p:nvSpPr>
        <p:spPr>
          <a:xfrm>
            <a:off x="9512212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/>
          <p:cNvSpPr/>
          <p:nvPr/>
        </p:nvSpPr>
        <p:spPr>
          <a:xfrm>
            <a:off x="3130019" y="2880545"/>
            <a:ext cx="6303329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4991 (BrELF4b)</a:t>
            </a:r>
            <a:endParaRPr lang="ko-KR" altLang="en-US" sz="4800" b="1" dirty="0"/>
          </a:p>
        </p:txBody>
      </p:sp>
      <p:sp>
        <p:nvSpPr>
          <p:cNvPr id="18" name="직사각형 17"/>
          <p:cNvSpPr/>
          <p:nvPr/>
        </p:nvSpPr>
        <p:spPr>
          <a:xfrm>
            <a:off x="3096644" y="8569177"/>
            <a:ext cx="6216766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17035 (BrELF4c)</a:t>
            </a:r>
            <a:endParaRPr lang="ko-KR" altLang="en-US" sz="4800" b="1" dirty="0"/>
          </a:p>
        </p:txBody>
      </p:sp>
      <p:sp>
        <p:nvSpPr>
          <p:cNvPr id="19" name="직사각형 18"/>
          <p:cNvSpPr/>
          <p:nvPr/>
        </p:nvSpPr>
        <p:spPr>
          <a:xfrm>
            <a:off x="3168652" y="14113793"/>
            <a:ext cx="6429965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5751 (BrRVE4a)</a:t>
            </a:r>
            <a:endParaRPr lang="ko-KR" altLang="en-US" sz="4800" b="1" dirty="0"/>
          </a:p>
        </p:txBody>
      </p:sp>
      <p:sp>
        <p:nvSpPr>
          <p:cNvPr id="20" name="직사각형 19"/>
          <p:cNvSpPr/>
          <p:nvPr/>
        </p:nvSpPr>
        <p:spPr>
          <a:xfrm>
            <a:off x="3168652" y="21674633"/>
            <a:ext cx="7760458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5754 (BrRVE4b); fail</a:t>
            </a:r>
            <a:endParaRPr lang="ko-KR" altLang="en-US" sz="4800" b="1" dirty="0"/>
          </a:p>
        </p:txBody>
      </p:sp>
      <p:sp>
        <p:nvSpPr>
          <p:cNvPr id="21" name="직사각형 20"/>
          <p:cNvSpPr/>
          <p:nvPr/>
        </p:nvSpPr>
        <p:spPr>
          <a:xfrm>
            <a:off x="3096644" y="25347041"/>
            <a:ext cx="6394699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9562 (BrRVE4c)</a:t>
            </a:r>
            <a:endParaRPr lang="ko-KR" altLang="en-US" sz="48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6. continue</a:t>
            </a:r>
            <a:endParaRPr lang="ko-KR" altLang="en-US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직사각형 21"/>
          <p:cNvSpPr/>
          <p:nvPr/>
        </p:nvSpPr>
        <p:spPr>
          <a:xfrm>
            <a:off x="37660484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3" name="직사각형 22"/>
          <p:cNvSpPr/>
          <p:nvPr/>
        </p:nvSpPr>
        <p:spPr>
          <a:xfrm>
            <a:off x="28882364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4" name="직사각형 23"/>
          <p:cNvSpPr/>
          <p:nvPr/>
        </p:nvSpPr>
        <p:spPr>
          <a:xfrm>
            <a:off x="20051668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12" name="차트 11"/>
          <p:cNvGraphicFramePr/>
          <p:nvPr/>
        </p:nvGraphicFramePr>
        <p:xfrm>
          <a:off x="14545916" y="2664521"/>
          <a:ext cx="26354928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차트 12"/>
          <p:cNvGraphicFramePr/>
          <p:nvPr/>
        </p:nvGraphicFramePr>
        <p:xfrm>
          <a:off x="1728492" y="2736529"/>
          <a:ext cx="12385376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차트 13"/>
          <p:cNvGraphicFramePr/>
          <p:nvPr/>
        </p:nvGraphicFramePr>
        <p:xfrm>
          <a:off x="14329892" y="8353153"/>
          <a:ext cx="26426936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차트 14"/>
          <p:cNvGraphicFramePr/>
          <p:nvPr/>
        </p:nvGraphicFramePr>
        <p:xfrm>
          <a:off x="1800500" y="8209137"/>
          <a:ext cx="12241360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0" name="차트 19"/>
          <p:cNvGraphicFramePr/>
          <p:nvPr/>
        </p:nvGraphicFramePr>
        <p:xfrm>
          <a:off x="14257884" y="25131017"/>
          <a:ext cx="26282920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1" name="차트 20"/>
          <p:cNvGraphicFramePr/>
          <p:nvPr/>
        </p:nvGraphicFramePr>
        <p:xfrm>
          <a:off x="1656484" y="25059009"/>
          <a:ext cx="12457384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5" name="직사각형 24"/>
          <p:cNvSpPr/>
          <p:nvPr/>
        </p:nvSpPr>
        <p:spPr>
          <a:xfrm>
            <a:off x="9512212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직사각형 27"/>
          <p:cNvSpPr/>
          <p:nvPr/>
        </p:nvSpPr>
        <p:spPr>
          <a:xfrm>
            <a:off x="3024636" y="3024561"/>
            <a:ext cx="6429965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29778 (BrRVE8a)</a:t>
            </a:r>
            <a:endParaRPr lang="ko-KR" altLang="en-US" sz="4800" b="1" dirty="0"/>
          </a:p>
        </p:txBody>
      </p:sp>
      <p:sp>
        <p:nvSpPr>
          <p:cNvPr id="29" name="직사각형 28"/>
          <p:cNvSpPr/>
          <p:nvPr/>
        </p:nvSpPr>
        <p:spPr>
          <a:xfrm>
            <a:off x="3384676" y="8569177"/>
            <a:ext cx="648126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4074 (BrRVE8b)</a:t>
            </a:r>
            <a:endParaRPr lang="ko-KR" altLang="en-US" sz="4800" b="1" dirty="0"/>
          </a:p>
        </p:txBody>
      </p:sp>
      <p:sp>
        <p:nvSpPr>
          <p:cNvPr id="30" name="직사각형 29"/>
          <p:cNvSpPr/>
          <p:nvPr/>
        </p:nvSpPr>
        <p:spPr>
          <a:xfrm>
            <a:off x="3208628" y="14113793"/>
            <a:ext cx="6080704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18204 (</a:t>
            </a:r>
            <a:r>
              <a:rPr lang="en-US" altLang="ko-KR" sz="4800" b="1" dirty="0" err="1" smtClean="0"/>
              <a:t>BrLUXa</a:t>
            </a:r>
            <a:r>
              <a:rPr lang="en-US" altLang="ko-KR" sz="4800" b="1" dirty="0" smtClean="0"/>
              <a:t>)</a:t>
            </a:r>
            <a:endParaRPr lang="ko-KR" altLang="en-US" sz="4800" b="1" dirty="0"/>
          </a:p>
        </p:txBody>
      </p:sp>
      <p:sp>
        <p:nvSpPr>
          <p:cNvPr id="31" name="직사각형 30"/>
          <p:cNvSpPr/>
          <p:nvPr/>
        </p:nvSpPr>
        <p:spPr>
          <a:xfrm>
            <a:off x="3229340" y="19658409"/>
            <a:ext cx="6132000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3809 (</a:t>
            </a:r>
            <a:r>
              <a:rPr lang="en-US" altLang="ko-KR" sz="4800" b="1" dirty="0" err="1" smtClean="0"/>
              <a:t>BrLUXb</a:t>
            </a:r>
            <a:r>
              <a:rPr lang="en-US" altLang="ko-KR" sz="4800" b="1" dirty="0" smtClean="0"/>
              <a:t>)</a:t>
            </a:r>
            <a:endParaRPr lang="ko-KR" altLang="en-US" sz="4800" b="1" dirty="0"/>
          </a:p>
        </p:txBody>
      </p:sp>
      <p:graphicFrame>
        <p:nvGraphicFramePr>
          <p:cNvPr id="32" name="차트 31"/>
          <p:cNvGraphicFramePr/>
          <p:nvPr/>
        </p:nvGraphicFramePr>
        <p:xfrm>
          <a:off x="1728492" y="19298369"/>
          <a:ext cx="12529392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3" name="차트 32"/>
          <p:cNvGraphicFramePr/>
          <p:nvPr/>
        </p:nvGraphicFramePr>
        <p:xfrm>
          <a:off x="14257884" y="19298369"/>
          <a:ext cx="26714968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4" name="차트 33"/>
          <p:cNvGraphicFramePr/>
          <p:nvPr/>
        </p:nvGraphicFramePr>
        <p:xfrm>
          <a:off x="1656484" y="13681745"/>
          <a:ext cx="12601400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5" name="차트 34"/>
          <p:cNvGraphicFramePr/>
          <p:nvPr/>
        </p:nvGraphicFramePr>
        <p:xfrm>
          <a:off x="14257884" y="13681745"/>
          <a:ext cx="26714968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26" name="직사각형 25"/>
          <p:cNvSpPr/>
          <p:nvPr/>
        </p:nvSpPr>
        <p:spPr>
          <a:xfrm>
            <a:off x="3456684" y="25308132"/>
            <a:ext cx="6338595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8830 (BrLKP2c)</a:t>
            </a:r>
            <a:endParaRPr lang="ko-KR" altLang="en-US" sz="4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6. continue</a:t>
            </a:r>
            <a:endParaRPr lang="ko-KR" alt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직사각형 11"/>
          <p:cNvSpPr/>
          <p:nvPr/>
        </p:nvSpPr>
        <p:spPr>
          <a:xfrm>
            <a:off x="37797644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3" name="직사각형 12"/>
          <p:cNvSpPr/>
          <p:nvPr/>
        </p:nvSpPr>
        <p:spPr>
          <a:xfrm>
            <a:off x="29019524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4" name="직사각형 13"/>
          <p:cNvSpPr/>
          <p:nvPr/>
        </p:nvSpPr>
        <p:spPr>
          <a:xfrm>
            <a:off x="20188828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22" name="차트 21"/>
          <p:cNvGraphicFramePr/>
          <p:nvPr/>
        </p:nvGraphicFramePr>
        <p:xfrm>
          <a:off x="14401900" y="8281145"/>
          <a:ext cx="26498944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차트 22"/>
          <p:cNvGraphicFramePr/>
          <p:nvPr/>
        </p:nvGraphicFramePr>
        <p:xfrm>
          <a:off x="1800500" y="8281145"/>
          <a:ext cx="12241360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차트 24"/>
          <p:cNvGraphicFramePr/>
          <p:nvPr/>
        </p:nvGraphicFramePr>
        <p:xfrm>
          <a:off x="14473908" y="13897769"/>
          <a:ext cx="26426936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6" name="차트 25"/>
          <p:cNvGraphicFramePr/>
          <p:nvPr/>
        </p:nvGraphicFramePr>
        <p:xfrm>
          <a:off x="1800500" y="13897769"/>
          <a:ext cx="12313368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7" name="차트 26"/>
          <p:cNvGraphicFramePr/>
          <p:nvPr/>
        </p:nvGraphicFramePr>
        <p:xfrm>
          <a:off x="1872508" y="19442385"/>
          <a:ext cx="12241360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8" name="차트 27"/>
          <p:cNvGraphicFramePr/>
          <p:nvPr/>
        </p:nvGraphicFramePr>
        <p:xfrm>
          <a:off x="14401900" y="19442385"/>
          <a:ext cx="26498944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9" name="차트 28"/>
          <p:cNvGraphicFramePr/>
          <p:nvPr/>
        </p:nvGraphicFramePr>
        <p:xfrm>
          <a:off x="14473908" y="25059009"/>
          <a:ext cx="26498944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0" name="차트 29"/>
          <p:cNvGraphicFramePr/>
          <p:nvPr/>
        </p:nvGraphicFramePr>
        <p:xfrm>
          <a:off x="1872508" y="24987001"/>
          <a:ext cx="12241360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5" name="직사각형 14"/>
          <p:cNvSpPr/>
          <p:nvPr/>
        </p:nvSpPr>
        <p:spPr>
          <a:xfrm>
            <a:off x="9649372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/>
          <p:cNvSpPr/>
          <p:nvPr/>
        </p:nvSpPr>
        <p:spPr>
          <a:xfrm>
            <a:off x="3600700" y="8353153"/>
            <a:ext cx="637386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8830 (BrLKP2a)</a:t>
            </a:r>
            <a:endParaRPr lang="ko-KR" altLang="en-US" sz="4800" b="1" dirty="0"/>
          </a:p>
        </p:txBody>
      </p:sp>
      <p:sp>
        <p:nvSpPr>
          <p:cNvPr id="18" name="직사각형 17"/>
          <p:cNvSpPr/>
          <p:nvPr/>
        </p:nvSpPr>
        <p:spPr>
          <a:xfrm>
            <a:off x="3456684" y="13897769"/>
            <a:ext cx="6028125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0496 (</a:t>
            </a:r>
            <a:r>
              <a:rPr lang="en-US" altLang="ko-KR" sz="4800" b="1" dirty="0" err="1" smtClean="0"/>
              <a:t>BrLHYa</a:t>
            </a:r>
            <a:r>
              <a:rPr lang="en-US" altLang="ko-KR" sz="4800" b="1" dirty="0" smtClean="0"/>
              <a:t>)</a:t>
            </a:r>
            <a:endParaRPr lang="ko-KR" altLang="en-US" sz="4800" b="1" dirty="0"/>
          </a:p>
        </p:txBody>
      </p:sp>
      <p:sp>
        <p:nvSpPr>
          <p:cNvPr id="19" name="직사각형 18"/>
          <p:cNvSpPr/>
          <p:nvPr/>
        </p:nvSpPr>
        <p:spPr>
          <a:xfrm>
            <a:off x="3240660" y="19514393"/>
            <a:ext cx="6139822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3291 (</a:t>
            </a:r>
            <a:r>
              <a:rPr lang="en-US" altLang="ko-KR" sz="4800" b="1" dirty="0" err="1" smtClean="0"/>
              <a:t>BrLHYb</a:t>
            </a:r>
            <a:r>
              <a:rPr lang="en-US" altLang="ko-KR" sz="4800" b="1" dirty="0" smtClean="0"/>
              <a:t>)</a:t>
            </a:r>
            <a:endParaRPr lang="en-US" altLang="ko-KR" sz="4800" b="1" dirty="0"/>
          </a:p>
        </p:txBody>
      </p:sp>
      <p:sp>
        <p:nvSpPr>
          <p:cNvPr id="20" name="직사각형 19"/>
          <p:cNvSpPr/>
          <p:nvPr/>
        </p:nvSpPr>
        <p:spPr>
          <a:xfrm>
            <a:off x="3168652" y="25203025"/>
            <a:ext cx="6145913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4503 (BrCCA1)</a:t>
            </a:r>
            <a:endParaRPr lang="ko-KR" altLang="en-US" sz="4800" b="1" dirty="0"/>
          </a:p>
        </p:txBody>
      </p:sp>
      <p:graphicFrame>
        <p:nvGraphicFramePr>
          <p:cNvPr id="21" name="차트 20"/>
          <p:cNvGraphicFramePr/>
          <p:nvPr/>
        </p:nvGraphicFramePr>
        <p:xfrm>
          <a:off x="1656484" y="2592513"/>
          <a:ext cx="12529392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1" name="차트 30"/>
          <p:cNvGraphicFramePr/>
          <p:nvPr/>
        </p:nvGraphicFramePr>
        <p:xfrm>
          <a:off x="14329892" y="2520505"/>
          <a:ext cx="26570952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32" name="직사각형 31"/>
          <p:cNvSpPr/>
          <p:nvPr/>
        </p:nvSpPr>
        <p:spPr>
          <a:xfrm>
            <a:off x="3312668" y="2592513"/>
            <a:ext cx="6425157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8831 (BrLKP2b)</a:t>
            </a:r>
            <a:endParaRPr lang="ko-KR" altLang="en-US" sz="48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6. continue</a:t>
            </a:r>
            <a:endParaRPr lang="ko-KR" alt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직사각형 20"/>
          <p:cNvSpPr/>
          <p:nvPr/>
        </p:nvSpPr>
        <p:spPr>
          <a:xfrm>
            <a:off x="37797644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2" name="직사각형 21"/>
          <p:cNvSpPr/>
          <p:nvPr/>
        </p:nvSpPr>
        <p:spPr>
          <a:xfrm>
            <a:off x="29019524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3" name="직사각형 22"/>
          <p:cNvSpPr/>
          <p:nvPr/>
        </p:nvSpPr>
        <p:spPr>
          <a:xfrm>
            <a:off x="20188828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12" name="차트 11"/>
          <p:cNvGraphicFramePr/>
          <p:nvPr/>
        </p:nvGraphicFramePr>
        <p:xfrm>
          <a:off x="14545916" y="2664521"/>
          <a:ext cx="26354928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차트 12"/>
          <p:cNvGraphicFramePr/>
          <p:nvPr/>
        </p:nvGraphicFramePr>
        <p:xfrm>
          <a:off x="1944516" y="2736529"/>
          <a:ext cx="12385376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차트 13"/>
          <p:cNvGraphicFramePr/>
          <p:nvPr/>
        </p:nvGraphicFramePr>
        <p:xfrm>
          <a:off x="14401900" y="8209137"/>
          <a:ext cx="26498944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차트 14"/>
          <p:cNvGraphicFramePr/>
          <p:nvPr/>
        </p:nvGraphicFramePr>
        <p:xfrm>
          <a:off x="1944516" y="8281145"/>
          <a:ext cx="12169352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6" name="차트 15"/>
          <p:cNvGraphicFramePr/>
          <p:nvPr/>
        </p:nvGraphicFramePr>
        <p:xfrm>
          <a:off x="14473908" y="13825761"/>
          <a:ext cx="26282920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7" name="차트 16"/>
          <p:cNvGraphicFramePr/>
          <p:nvPr/>
        </p:nvGraphicFramePr>
        <p:xfrm>
          <a:off x="1728492" y="13897769"/>
          <a:ext cx="12601400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9" name="차트 18"/>
          <p:cNvGraphicFramePr/>
          <p:nvPr/>
        </p:nvGraphicFramePr>
        <p:xfrm>
          <a:off x="14401900" y="25131017"/>
          <a:ext cx="26498944" cy="5112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0" name="차트 19"/>
          <p:cNvGraphicFramePr/>
          <p:nvPr/>
        </p:nvGraphicFramePr>
        <p:xfrm>
          <a:off x="1800500" y="25059009"/>
          <a:ext cx="12241360" cy="5184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4" name="직사각형 23"/>
          <p:cNvSpPr/>
          <p:nvPr/>
        </p:nvSpPr>
        <p:spPr>
          <a:xfrm>
            <a:off x="9649372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직사각형 24"/>
          <p:cNvSpPr/>
          <p:nvPr/>
        </p:nvSpPr>
        <p:spPr>
          <a:xfrm>
            <a:off x="3168652" y="2592513"/>
            <a:ext cx="646523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12964 (BrPRR1a)</a:t>
            </a:r>
            <a:endParaRPr lang="ko-KR" altLang="en-US" sz="4800" b="1" dirty="0"/>
          </a:p>
        </p:txBody>
      </p:sp>
      <p:sp>
        <p:nvSpPr>
          <p:cNvPr id="26" name="직사각형 25"/>
          <p:cNvSpPr/>
          <p:nvPr/>
        </p:nvSpPr>
        <p:spPr>
          <a:xfrm>
            <a:off x="3744716" y="8425161"/>
            <a:ext cx="6516528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5933 (BrPRR1b)</a:t>
            </a:r>
            <a:endParaRPr lang="ko-KR" altLang="en-US" sz="4800" b="1" dirty="0"/>
          </a:p>
        </p:txBody>
      </p:sp>
      <p:sp>
        <p:nvSpPr>
          <p:cNvPr id="27" name="직사각형 26"/>
          <p:cNvSpPr/>
          <p:nvPr/>
        </p:nvSpPr>
        <p:spPr>
          <a:xfrm>
            <a:off x="3600700" y="13969777"/>
            <a:ext cx="646523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2512 (BrPRR3a)</a:t>
            </a:r>
            <a:endParaRPr lang="ko-KR" altLang="en-US" sz="4800" b="1" dirty="0"/>
          </a:p>
        </p:txBody>
      </p:sp>
      <p:sp>
        <p:nvSpPr>
          <p:cNvPr id="28" name="직사각형 27"/>
          <p:cNvSpPr/>
          <p:nvPr/>
        </p:nvSpPr>
        <p:spPr>
          <a:xfrm>
            <a:off x="1728492" y="20810537"/>
            <a:ext cx="8012130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20263 (BrPRR3b) ; fail</a:t>
            </a:r>
            <a:endParaRPr lang="ko-KR" altLang="en-US" sz="4800" b="1" dirty="0"/>
          </a:p>
        </p:txBody>
      </p:sp>
      <p:sp>
        <p:nvSpPr>
          <p:cNvPr id="29" name="직사각형 28"/>
          <p:cNvSpPr/>
          <p:nvPr/>
        </p:nvSpPr>
        <p:spPr>
          <a:xfrm>
            <a:off x="3024636" y="24987001"/>
            <a:ext cx="646523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9768 (BrPRR5a)</a:t>
            </a:r>
            <a:endParaRPr lang="ko-KR" altLang="en-US" sz="48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6. continue</a:t>
            </a:r>
            <a:endParaRPr lang="ko-KR" alt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직사각형 21"/>
          <p:cNvSpPr/>
          <p:nvPr/>
        </p:nvSpPr>
        <p:spPr>
          <a:xfrm>
            <a:off x="37797644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3" name="직사각형 22"/>
          <p:cNvSpPr/>
          <p:nvPr/>
        </p:nvSpPr>
        <p:spPr>
          <a:xfrm>
            <a:off x="29019524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4" name="직사각형 23"/>
          <p:cNvSpPr/>
          <p:nvPr/>
        </p:nvSpPr>
        <p:spPr>
          <a:xfrm>
            <a:off x="20188828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12" name="차트 11"/>
          <p:cNvGraphicFramePr/>
          <p:nvPr/>
        </p:nvGraphicFramePr>
        <p:xfrm>
          <a:off x="14473908" y="2736529"/>
          <a:ext cx="26354928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차트 12"/>
          <p:cNvGraphicFramePr/>
          <p:nvPr/>
        </p:nvGraphicFramePr>
        <p:xfrm>
          <a:off x="1800500" y="2736529"/>
          <a:ext cx="12529392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차트 13"/>
          <p:cNvGraphicFramePr/>
          <p:nvPr/>
        </p:nvGraphicFramePr>
        <p:xfrm>
          <a:off x="14473908" y="8209137"/>
          <a:ext cx="26426936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차트 14"/>
          <p:cNvGraphicFramePr/>
          <p:nvPr/>
        </p:nvGraphicFramePr>
        <p:xfrm>
          <a:off x="1440460" y="8281145"/>
          <a:ext cx="12817424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차트 15"/>
          <p:cNvGraphicFramePr/>
          <p:nvPr/>
        </p:nvGraphicFramePr>
        <p:xfrm>
          <a:off x="1800500" y="13681745"/>
          <a:ext cx="12529392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" name="차트 16"/>
          <p:cNvGraphicFramePr/>
          <p:nvPr/>
        </p:nvGraphicFramePr>
        <p:xfrm>
          <a:off x="14401900" y="13825761"/>
          <a:ext cx="26498944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8" name="차트 17"/>
          <p:cNvGraphicFramePr/>
          <p:nvPr/>
        </p:nvGraphicFramePr>
        <p:xfrm>
          <a:off x="1800500" y="19442385"/>
          <a:ext cx="12457384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9" name="차트 18"/>
          <p:cNvGraphicFramePr/>
          <p:nvPr/>
        </p:nvGraphicFramePr>
        <p:xfrm>
          <a:off x="14545916" y="19442385"/>
          <a:ext cx="26570952" cy="5328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0" name="차트 19"/>
          <p:cNvGraphicFramePr/>
          <p:nvPr/>
        </p:nvGraphicFramePr>
        <p:xfrm>
          <a:off x="14185876" y="25131017"/>
          <a:ext cx="26858984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1" name="차트 20"/>
          <p:cNvGraphicFramePr/>
          <p:nvPr/>
        </p:nvGraphicFramePr>
        <p:xfrm>
          <a:off x="1584476" y="25059009"/>
          <a:ext cx="12673408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25" name="직사각형 24"/>
          <p:cNvSpPr/>
          <p:nvPr/>
        </p:nvSpPr>
        <p:spPr>
          <a:xfrm>
            <a:off x="9649372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직사각형 25"/>
          <p:cNvSpPr/>
          <p:nvPr/>
        </p:nvSpPr>
        <p:spPr>
          <a:xfrm>
            <a:off x="3168652" y="2592513"/>
            <a:ext cx="6516528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29407 (BrPRR5b)</a:t>
            </a:r>
            <a:endParaRPr lang="ko-KR" altLang="en-US" sz="4800" b="1" dirty="0"/>
          </a:p>
        </p:txBody>
      </p:sp>
      <p:sp>
        <p:nvSpPr>
          <p:cNvPr id="27" name="직사각형 26"/>
          <p:cNvSpPr/>
          <p:nvPr/>
        </p:nvSpPr>
        <p:spPr>
          <a:xfrm>
            <a:off x="3528692" y="8425161"/>
            <a:ext cx="6429965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6517 (BrPRR5c)</a:t>
            </a:r>
            <a:endParaRPr lang="ko-KR" altLang="en-US" sz="4800" b="1" dirty="0"/>
          </a:p>
        </p:txBody>
      </p:sp>
      <p:sp>
        <p:nvSpPr>
          <p:cNvPr id="28" name="직사각형 27"/>
          <p:cNvSpPr/>
          <p:nvPr/>
        </p:nvSpPr>
        <p:spPr>
          <a:xfrm>
            <a:off x="3168652" y="13969777"/>
            <a:ext cx="646523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9565 (BrPRR7a)</a:t>
            </a:r>
            <a:endParaRPr lang="ko-KR" altLang="en-US" sz="4800" b="1" dirty="0"/>
          </a:p>
        </p:txBody>
      </p:sp>
      <p:sp>
        <p:nvSpPr>
          <p:cNvPr id="29" name="직사각형 28"/>
          <p:cNvSpPr/>
          <p:nvPr/>
        </p:nvSpPr>
        <p:spPr>
          <a:xfrm>
            <a:off x="3240660" y="19586401"/>
            <a:ext cx="6516528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28861 (BrPRR7b)</a:t>
            </a:r>
            <a:endParaRPr lang="ko-KR" altLang="en-US" sz="4800" b="1" dirty="0"/>
          </a:p>
        </p:txBody>
      </p:sp>
      <p:sp>
        <p:nvSpPr>
          <p:cNvPr id="30" name="직사각형 29"/>
          <p:cNvSpPr/>
          <p:nvPr/>
        </p:nvSpPr>
        <p:spPr>
          <a:xfrm>
            <a:off x="3600700" y="25164116"/>
            <a:ext cx="646523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4507 (BrPRR9a)</a:t>
            </a:r>
            <a:endParaRPr lang="ko-KR" altLang="en-US" sz="48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6. continue</a:t>
            </a:r>
            <a:endParaRPr lang="ko-KR" altLang="en-US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37797644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" name="직사각형 6"/>
          <p:cNvSpPr/>
          <p:nvPr/>
        </p:nvSpPr>
        <p:spPr>
          <a:xfrm>
            <a:off x="29019524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" name="직사각형 7"/>
          <p:cNvSpPr/>
          <p:nvPr/>
        </p:nvSpPr>
        <p:spPr>
          <a:xfrm>
            <a:off x="20188828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직사각형 3"/>
          <p:cNvSpPr/>
          <p:nvPr/>
        </p:nvSpPr>
        <p:spPr>
          <a:xfrm>
            <a:off x="3240660" y="4536729"/>
            <a:ext cx="8983550" cy="9233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5400" b="1" dirty="0" smtClean="0"/>
              <a:t>Bra040484 (BrPRR9b) ; fail</a:t>
            </a:r>
          </a:p>
        </p:txBody>
      </p:sp>
      <p:sp>
        <p:nvSpPr>
          <p:cNvPr id="6" name="직사각형 5"/>
          <p:cNvSpPr/>
          <p:nvPr/>
        </p:nvSpPr>
        <p:spPr>
          <a:xfrm>
            <a:off x="9786532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</a:t>
            </a:r>
            <a:r>
              <a:rPr lang="en-US" altLang="ko-KR" dirty="0"/>
              <a:t>6</a:t>
            </a:r>
            <a:r>
              <a:rPr lang="en-US" altLang="ko-KR" dirty="0" smtClean="0"/>
              <a:t>. continue</a:t>
            </a:r>
            <a:endParaRPr lang="ko-KR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3253661" y="4104681"/>
            <a:ext cx="34514628" cy="27795088"/>
            <a:chOff x="35496" y="343689"/>
            <a:chExt cx="6840640" cy="5877010"/>
          </a:xfrm>
        </p:grpSpPr>
        <p:sp>
          <p:nvSpPr>
            <p:cNvPr id="3" name="TextBox 3"/>
            <p:cNvSpPr txBox="1"/>
            <p:nvPr/>
          </p:nvSpPr>
          <p:spPr>
            <a:xfrm>
              <a:off x="35496" y="836712"/>
              <a:ext cx="164120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0h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4" name="TextBox 4"/>
            <p:cNvSpPr txBox="1"/>
            <p:nvPr/>
          </p:nvSpPr>
          <p:spPr>
            <a:xfrm>
              <a:off x="827584" y="343689"/>
              <a:ext cx="214977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4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5" name="TextBox 5"/>
            <p:cNvSpPr txBox="1"/>
            <p:nvPr/>
          </p:nvSpPr>
          <p:spPr>
            <a:xfrm>
              <a:off x="1913032" y="343689"/>
              <a:ext cx="214977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8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6" name="TextBox 6"/>
            <p:cNvSpPr txBox="1"/>
            <p:nvPr/>
          </p:nvSpPr>
          <p:spPr>
            <a:xfrm>
              <a:off x="2915816" y="343689"/>
              <a:ext cx="279051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12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7" name="TextBox 7"/>
            <p:cNvSpPr txBox="1"/>
            <p:nvPr/>
          </p:nvSpPr>
          <p:spPr>
            <a:xfrm>
              <a:off x="3995936" y="343689"/>
              <a:ext cx="279051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16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8" name="TextBox 8"/>
            <p:cNvSpPr txBox="1"/>
            <p:nvPr/>
          </p:nvSpPr>
          <p:spPr>
            <a:xfrm>
              <a:off x="6156176" y="343689"/>
              <a:ext cx="279051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24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pic>
          <p:nvPicPr>
            <p:cNvPr id="9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5656" y="620688"/>
              <a:ext cx="1080000" cy="916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6016" y="620689"/>
              <a:ext cx="1080000" cy="919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11"/>
            <p:cNvSpPr txBox="1"/>
            <p:nvPr/>
          </p:nvSpPr>
          <p:spPr>
            <a:xfrm>
              <a:off x="5076056" y="343689"/>
              <a:ext cx="279051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20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pic>
          <p:nvPicPr>
            <p:cNvPr id="12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5896" y="620689"/>
              <a:ext cx="1080000" cy="9283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" name="Picture 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6136" y="620689"/>
              <a:ext cx="1080000" cy="924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Picture 6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75656" y="630749"/>
              <a:ext cx="1080000" cy="9260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Picture 7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5776" y="620688"/>
              <a:ext cx="1080000" cy="908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Picture 8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5776" y="1556792"/>
              <a:ext cx="1080000" cy="9222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Picture 9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6016" y="3429000"/>
              <a:ext cx="1080000" cy="922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TextBox 18"/>
            <p:cNvSpPr txBox="1"/>
            <p:nvPr/>
          </p:nvSpPr>
          <p:spPr>
            <a:xfrm>
              <a:off x="1048936" y="1772816"/>
              <a:ext cx="214977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4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19" name="TextBox 19"/>
            <p:cNvSpPr txBox="1"/>
            <p:nvPr/>
          </p:nvSpPr>
          <p:spPr>
            <a:xfrm>
              <a:off x="2129056" y="2708920"/>
              <a:ext cx="214977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8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20" name="TextBox 20"/>
            <p:cNvSpPr txBox="1"/>
            <p:nvPr/>
          </p:nvSpPr>
          <p:spPr>
            <a:xfrm>
              <a:off x="3124217" y="3645024"/>
              <a:ext cx="279051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12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21" name="TextBox 21"/>
            <p:cNvSpPr txBox="1"/>
            <p:nvPr/>
          </p:nvSpPr>
          <p:spPr>
            <a:xfrm>
              <a:off x="4204337" y="4592161"/>
              <a:ext cx="279051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16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sp>
          <p:nvSpPr>
            <p:cNvPr id="22" name="TextBox 23"/>
            <p:cNvSpPr txBox="1"/>
            <p:nvPr/>
          </p:nvSpPr>
          <p:spPr>
            <a:xfrm>
              <a:off x="5292080" y="5528265"/>
              <a:ext cx="279051" cy="246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800" b="1" i="0" u="none" strike="noStrike" kern="120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맑은 고딕"/>
                  <a:ea typeface="맑은 고딕"/>
                  <a:cs typeface="+mn-cs"/>
                </a:rPr>
                <a:t>20hs</a:t>
              </a:r>
              <a:endParaRPr kumimoji="0" lang="ko-KR" altLang="en-US" sz="4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맑은 고딕"/>
                <a:ea typeface="맑은 고딕"/>
                <a:cs typeface="+mn-cs"/>
              </a:endParaRPr>
            </a:p>
          </p:txBody>
        </p:sp>
        <p:pic>
          <p:nvPicPr>
            <p:cNvPr id="23" name="Picture 10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5896" y="2492896"/>
              <a:ext cx="1080000" cy="914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" name="Picture 11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6016" y="3429000"/>
              <a:ext cx="1080000" cy="919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5" name="Picture 12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75656" y="1556792"/>
              <a:ext cx="1080000" cy="9260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6" name="Picture 13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6136" y="3438735"/>
              <a:ext cx="1080000" cy="9263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" name="Picture 14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5896" y="1556792"/>
              <a:ext cx="1080000" cy="917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8" name="Picture 15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6016" y="1556792"/>
              <a:ext cx="1080000" cy="9171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9" name="Picture 16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6136" y="1556792"/>
              <a:ext cx="1080000" cy="9217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" name="Picture 17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5896" y="2492896"/>
              <a:ext cx="1080000" cy="9201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" name="Picture 18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6136" y="2492896"/>
              <a:ext cx="1080000" cy="9190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" name="Picture 19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6016" y="2492896"/>
              <a:ext cx="1080000" cy="9217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3" name="Picture 20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6136" y="4365104"/>
              <a:ext cx="1080000" cy="9215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Picture 21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6136" y="4365104"/>
              <a:ext cx="1080000" cy="9217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5" name="Picture 22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6136" y="5301208"/>
              <a:ext cx="1080000" cy="919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62" name="그룹 61"/>
          <p:cNvGrpSpPr/>
          <p:nvPr/>
        </p:nvGrpSpPr>
        <p:grpSpPr>
          <a:xfrm>
            <a:off x="4888656" y="5364103"/>
            <a:ext cx="5546254" cy="4490013"/>
            <a:chOff x="2284188" y="14915075"/>
            <a:chExt cx="9576330" cy="7147473"/>
          </a:xfrm>
        </p:grpSpPr>
        <p:sp>
          <p:nvSpPr>
            <p:cNvPr id="64" name="TextBox 63"/>
            <p:cNvSpPr txBox="1"/>
            <p:nvPr/>
          </p:nvSpPr>
          <p:spPr>
            <a:xfrm>
              <a:off x="5622531" y="21131668"/>
              <a:ext cx="4863415" cy="9308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3200" b="1" dirty="0" err="1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logCounts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65" name="직사각형 64"/>
            <p:cNvSpPr/>
            <p:nvPr/>
          </p:nvSpPr>
          <p:spPr>
            <a:xfrm>
              <a:off x="4536099" y="15091461"/>
              <a:ext cx="7324419" cy="5112568"/>
            </a:xfrm>
            <a:prstGeom prst="rect">
              <a:avLst/>
            </a:prstGeom>
            <a:noFill/>
            <a:ln w="635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3200" b="1"/>
            </a:p>
          </p:txBody>
        </p:sp>
        <p:cxnSp>
          <p:nvCxnSpPr>
            <p:cNvPr id="66" name="직선 연결선 65"/>
            <p:cNvCxnSpPr/>
            <p:nvPr/>
          </p:nvCxnSpPr>
          <p:spPr>
            <a:xfrm>
              <a:off x="4262100" y="15625021"/>
              <a:ext cx="288031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4244957" y="16751938"/>
              <a:ext cx="288031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>
              <a:off x="4229194" y="17868044"/>
              <a:ext cx="288031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연결선 68"/>
            <p:cNvCxnSpPr/>
            <p:nvPr/>
          </p:nvCxnSpPr>
          <p:spPr>
            <a:xfrm>
              <a:off x="4230099" y="18991608"/>
              <a:ext cx="288031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 rot="10800000">
              <a:off x="3111219" y="14915075"/>
              <a:ext cx="1169115" cy="998918"/>
            </a:xfrm>
            <a:prstGeom prst="rect">
              <a:avLst/>
            </a:prstGeom>
            <a:solidFill>
              <a:schemeClr val="bg1"/>
            </a:solidFill>
          </p:spPr>
          <p:txBody>
            <a:bodyPr vert="eaVert" wrap="square" rtlCol="0">
              <a:spAutoFit/>
            </a:bodyPr>
            <a:lstStyle/>
            <a:p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0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 rot="10800000">
              <a:off x="3026180" y="16313491"/>
              <a:ext cx="1169115" cy="837946"/>
            </a:xfrm>
            <a:prstGeom prst="rect">
              <a:avLst/>
            </a:prstGeom>
            <a:solidFill>
              <a:schemeClr val="bg1"/>
            </a:solidFill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5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 rot="10800000">
              <a:off x="3019471" y="17211411"/>
              <a:ext cx="1169115" cy="1193691"/>
            </a:xfrm>
            <a:prstGeom prst="rect">
              <a:avLst/>
            </a:prstGeom>
            <a:solidFill>
              <a:schemeClr val="bg1"/>
            </a:solidFill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 rot="10800000">
              <a:off x="3044227" y="18355930"/>
              <a:ext cx="1169115" cy="1224136"/>
            </a:xfrm>
            <a:prstGeom prst="rect">
              <a:avLst/>
            </a:prstGeom>
            <a:solidFill>
              <a:schemeClr val="bg1"/>
            </a:solidFill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5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 rot="10800000">
              <a:off x="2980592" y="19300093"/>
              <a:ext cx="1169115" cy="1672453"/>
            </a:xfrm>
            <a:prstGeom prst="rect">
              <a:avLst/>
            </a:prstGeom>
            <a:solidFill>
              <a:schemeClr val="bg1"/>
            </a:solidFill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10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cxnSp>
          <p:nvCxnSpPr>
            <p:cNvPr id="75" name="직선 연결선 74"/>
            <p:cNvCxnSpPr/>
            <p:nvPr/>
          </p:nvCxnSpPr>
          <p:spPr>
            <a:xfrm>
              <a:off x="4176763" y="20121897"/>
              <a:ext cx="288031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연결선 75"/>
            <p:cNvCxnSpPr/>
            <p:nvPr/>
          </p:nvCxnSpPr>
          <p:spPr>
            <a:xfrm rot="5400000">
              <a:off x="4582134" y="20378489"/>
              <a:ext cx="288033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직선 연결선 76"/>
            <p:cNvCxnSpPr/>
            <p:nvPr/>
          </p:nvCxnSpPr>
          <p:spPr>
            <a:xfrm rot="5400000">
              <a:off x="6402904" y="20378489"/>
              <a:ext cx="288033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직선 연결선 77"/>
            <p:cNvCxnSpPr/>
            <p:nvPr/>
          </p:nvCxnSpPr>
          <p:spPr>
            <a:xfrm rot="5400000">
              <a:off x="8221435" y="20378489"/>
              <a:ext cx="288033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직선 연결선 78"/>
            <p:cNvCxnSpPr/>
            <p:nvPr/>
          </p:nvCxnSpPr>
          <p:spPr>
            <a:xfrm rot="5400000">
              <a:off x="10032304" y="20378489"/>
              <a:ext cx="288033" cy="0"/>
            </a:xfrm>
            <a:prstGeom prst="line">
              <a:avLst/>
            </a:prstGeom>
            <a:ln w="635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/>
            <p:cNvSpPr txBox="1"/>
            <p:nvPr/>
          </p:nvSpPr>
          <p:spPr>
            <a:xfrm>
              <a:off x="3959332" y="20462690"/>
              <a:ext cx="1153536" cy="80774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5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5687525" y="20450496"/>
              <a:ext cx="1153536" cy="80774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7631740" y="20450496"/>
              <a:ext cx="1153536" cy="80774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5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9503948" y="20450496"/>
              <a:ext cx="1153536" cy="80774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32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0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rot="10800000">
              <a:off x="2284188" y="16807558"/>
              <a:ext cx="760125" cy="2011998"/>
            </a:xfrm>
            <a:prstGeom prst="rect">
              <a:avLst/>
            </a:prstGeom>
            <a:solidFill>
              <a:schemeClr val="bg1"/>
            </a:solidFill>
          </p:spPr>
          <p:txBody>
            <a:bodyPr vert="eaVert" wrap="square" rtlCol="0">
              <a:spAutoFit/>
            </a:bodyPr>
            <a:lstStyle/>
            <a:p>
              <a:r>
                <a:rPr lang="en-US" altLang="ko-KR" sz="3200" b="1" dirty="0" err="1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logFC</a:t>
              </a:r>
              <a:endParaRPr lang="ko-KR" altLang="en-US" sz="3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110" name="TextBox 109"/>
          <p:cNvSpPr txBox="1"/>
          <p:nvPr/>
        </p:nvSpPr>
        <p:spPr>
          <a:xfrm>
            <a:off x="1008412" y="288257"/>
            <a:ext cx="12313368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2.</a:t>
            </a:r>
            <a:endParaRPr lang="ko-KR" alt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1829020" y="2885925"/>
            <a:ext cx="2849281" cy="12187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69997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40"/>
          <p:cNvGrpSpPr/>
          <p:nvPr/>
        </p:nvGrpSpPr>
        <p:grpSpPr>
          <a:xfrm>
            <a:off x="304975" y="7201025"/>
            <a:ext cx="22305837" cy="18895132"/>
            <a:chOff x="447518" y="44624"/>
            <a:chExt cx="8068068" cy="4677527"/>
          </a:xfrm>
        </p:grpSpPr>
        <p:sp>
          <p:nvSpPr>
            <p:cNvPr id="6" name="해 5"/>
            <p:cNvSpPr/>
            <p:nvPr/>
          </p:nvSpPr>
          <p:spPr>
            <a:xfrm>
              <a:off x="2186543" y="44624"/>
              <a:ext cx="1377344" cy="1008112"/>
            </a:xfrm>
            <a:prstGeom prst="sun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100" dirty="0"/>
            </a:p>
          </p:txBody>
        </p:sp>
        <p:sp>
          <p:nvSpPr>
            <p:cNvPr id="7" name="구름 6"/>
            <p:cNvSpPr/>
            <p:nvPr/>
          </p:nvSpPr>
          <p:spPr>
            <a:xfrm rot="477378">
              <a:off x="2914058" y="205938"/>
              <a:ext cx="1445306" cy="819472"/>
            </a:xfrm>
            <a:prstGeom prst="cloud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100" dirty="0"/>
            </a:p>
          </p:txBody>
        </p:sp>
        <p:cxnSp>
          <p:nvCxnSpPr>
            <p:cNvPr id="9" name="직선 화살표 연결선 8"/>
            <p:cNvCxnSpPr/>
            <p:nvPr/>
          </p:nvCxnSpPr>
          <p:spPr>
            <a:xfrm flipH="1">
              <a:off x="2316771" y="1196752"/>
              <a:ext cx="815069" cy="48783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화살표 연결선 10"/>
            <p:cNvCxnSpPr/>
            <p:nvPr/>
          </p:nvCxnSpPr>
          <p:spPr>
            <a:xfrm>
              <a:off x="3707904" y="1124744"/>
              <a:ext cx="864096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1040544" y="1774150"/>
              <a:ext cx="2943135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B050"/>
                  </a:solidFill>
                </a:rPr>
                <a:t>PHYA(</a:t>
              </a:r>
              <a:r>
                <a:rPr lang="en-US" altLang="ko-KR" sz="3800" dirty="0"/>
                <a:t>AT1G09570 </a:t>
              </a:r>
              <a:r>
                <a:rPr lang="en-US" altLang="ko-KR" sz="3800" b="1" dirty="0">
                  <a:solidFill>
                    <a:srgbClr val="00B050"/>
                  </a:solidFill>
                </a:rPr>
                <a:t>)/B(AT2G18790)</a:t>
              </a:r>
              <a:endParaRPr lang="ko-KR" altLang="en-US" sz="3800" b="1" dirty="0">
                <a:solidFill>
                  <a:srgbClr val="00B050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499993" y="1486303"/>
              <a:ext cx="2973777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B050"/>
                  </a:solidFill>
                </a:rPr>
                <a:t>CRY1(</a:t>
              </a:r>
              <a:r>
                <a:rPr lang="en-US" altLang="ko-KR" sz="3800" dirty="0"/>
                <a:t>AT4G08920 </a:t>
              </a:r>
              <a:r>
                <a:rPr lang="en-US" altLang="ko-KR" sz="3800" b="1" dirty="0">
                  <a:solidFill>
                    <a:srgbClr val="00B050"/>
                  </a:solidFill>
                </a:rPr>
                <a:t>)/2(</a:t>
              </a:r>
              <a:r>
                <a:rPr lang="en-US" altLang="ko-KR" sz="3800" dirty="0"/>
                <a:t>AT1G04400 </a:t>
              </a:r>
              <a:r>
                <a:rPr lang="en-US" altLang="ko-KR" sz="3800" b="1" dirty="0">
                  <a:solidFill>
                    <a:srgbClr val="00B050"/>
                  </a:solidFill>
                </a:rPr>
                <a:t>)</a:t>
              </a:r>
              <a:endParaRPr lang="ko-KR" altLang="en-US" sz="3800" b="1" dirty="0">
                <a:solidFill>
                  <a:srgbClr val="00B050"/>
                </a:solidFill>
              </a:endParaRPr>
            </a:p>
          </p:txBody>
        </p:sp>
        <p:cxnSp>
          <p:nvCxnSpPr>
            <p:cNvPr id="15" name="직선 화살표 연결선 14"/>
            <p:cNvCxnSpPr/>
            <p:nvPr/>
          </p:nvCxnSpPr>
          <p:spPr>
            <a:xfrm>
              <a:off x="1763688" y="2060848"/>
              <a:ext cx="0" cy="1008112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447518" y="2348880"/>
              <a:ext cx="1556707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B050"/>
                  </a:solidFill>
                </a:rPr>
                <a:t>PIF3(</a:t>
              </a:r>
              <a:r>
                <a:rPr lang="en-US" altLang="ko-KR" sz="3800" dirty="0"/>
                <a:t>AT1G09530 </a:t>
              </a:r>
              <a:r>
                <a:rPr lang="en-US" altLang="ko-KR" sz="3800" b="1" dirty="0">
                  <a:solidFill>
                    <a:srgbClr val="00B050"/>
                  </a:solidFill>
                </a:rPr>
                <a:t>)</a:t>
              </a:r>
              <a:endParaRPr lang="ko-KR" altLang="en-US" sz="3800" b="1" dirty="0">
                <a:solidFill>
                  <a:srgbClr val="00B05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00372" y="3059669"/>
              <a:ext cx="1511388" cy="4571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LHY(</a:t>
              </a:r>
              <a:r>
                <a:rPr lang="en-US" altLang="ko-KR" sz="3800" dirty="0"/>
                <a:t>AT1G01060 </a:t>
              </a:r>
              <a:r>
                <a:rPr lang="en-US" altLang="ko-KR" sz="3800" b="1" dirty="0">
                  <a:solidFill>
                    <a:srgbClr val="FFC000"/>
                  </a:solidFill>
                </a:rPr>
                <a:t>)/CCA1(</a:t>
              </a:r>
              <a:r>
                <a:rPr lang="en-US" altLang="ko-KR" sz="3800" dirty="0"/>
                <a:t>AT2G46830 </a:t>
              </a:r>
              <a:r>
                <a:rPr lang="en-US" altLang="ko-KR" sz="3800" b="1" dirty="0">
                  <a:solidFill>
                    <a:srgbClr val="FFC000"/>
                  </a:solidFill>
                </a:rPr>
                <a:t>)</a:t>
              </a:r>
              <a:endParaRPr lang="ko-KR" altLang="en-US" sz="3800" b="1" dirty="0">
                <a:solidFill>
                  <a:srgbClr val="FFC00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67545" y="4180193"/>
              <a:ext cx="1953408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PRR7(</a:t>
              </a:r>
              <a:r>
                <a:rPr lang="en-US" altLang="ko-KR" sz="3800" dirty="0"/>
                <a:t>AT5G02810 </a:t>
              </a:r>
              <a:r>
                <a:rPr lang="en-US" altLang="ko-KR" sz="3800" b="1" dirty="0">
                  <a:solidFill>
                    <a:srgbClr val="FFC000"/>
                  </a:solidFill>
                </a:rPr>
                <a:t>)</a:t>
              </a:r>
              <a:endParaRPr lang="ko-KR" altLang="en-US" sz="3800" b="1" dirty="0">
                <a:solidFill>
                  <a:srgbClr val="FFC00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35407" y="4554532"/>
              <a:ext cx="1771089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PRR9(</a:t>
              </a:r>
              <a:r>
                <a:rPr lang="en-US" altLang="ko-KR" sz="3800" dirty="0"/>
                <a:t>AT2G46790 </a:t>
              </a:r>
              <a:r>
                <a:rPr lang="en-US" altLang="ko-KR" sz="3800" b="1" dirty="0">
                  <a:solidFill>
                    <a:srgbClr val="FFC000"/>
                  </a:solidFill>
                </a:rPr>
                <a:t>)</a:t>
              </a:r>
              <a:endParaRPr lang="ko-KR" altLang="en-US" sz="3800" b="1" dirty="0">
                <a:solidFill>
                  <a:srgbClr val="FFC00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452497" y="3235428"/>
              <a:ext cx="1588772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70C0"/>
                  </a:solidFill>
                </a:rPr>
                <a:t>TOC1(</a:t>
              </a:r>
              <a:r>
                <a:rPr lang="en-US" altLang="ko-KR" sz="3800" dirty="0"/>
                <a:t>AT5G61380 </a:t>
              </a:r>
              <a:r>
                <a:rPr lang="en-US" altLang="ko-KR" sz="3800" b="1" dirty="0">
                  <a:solidFill>
                    <a:srgbClr val="0070C0"/>
                  </a:solidFill>
                </a:rPr>
                <a:t>)</a:t>
              </a:r>
              <a:endParaRPr lang="ko-KR" altLang="en-US" sz="3800" b="1" dirty="0">
                <a:solidFill>
                  <a:srgbClr val="0070C0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699792" y="4365103"/>
              <a:ext cx="1570388" cy="312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PRR5(</a:t>
              </a:r>
              <a:r>
                <a:rPr lang="en-US" altLang="ko-KR" sz="3800" dirty="0"/>
                <a:t>AT5G24470 </a:t>
              </a:r>
              <a:r>
                <a:rPr lang="en-US" altLang="ko-KR" sz="3800" b="1" dirty="0">
                  <a:solidFill>
                    <a:srgbClr val="FFC000"/>
                  </a:solidFill>
                </a:rPr>
                <a:t>)</a:t>
              </a:r>
              <a:endParaRPr lang="ko-KR" altLang="en-US" sz="3800" b="1" dirty="0">
                <a:solidFill>
                  <a:srgbClr val="FFC000"/>
                </a:solidFill>
              </a:endParaRPr>
            </a:p>
          </p:txBody>
        </p:sp>
        <p:cxnSp>
          <p:nvCxnSpPr>
            <p:cNvPr id="24" name="직선 화살표 연결선 23"/>
            <p:cNvCxnSpPr/>
            <p:nvPr/>
          </p:nvCxnSpPr>
          <p:spPr>
            <a:xfrm flipH="1">
              <a:off x="1043608" y="3501008"/>
              <a:ext cx="432048" cy="72008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화살표 연결선 25"/>
            <p:cNvCxnSpPr>
              <a:endCxn id="20" idx="0"/>
            </p:cNvCxnSpPr>
            <p:nvPr/>
          </p:nvCxnSpPr>
          <p:spPr>
            <a:xfrm>
              <a:off x="1978179" y="3467163"/>
              <a:ext cx="442773" cy="108736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/>
            <p:cNvCxnSpPr/>
            <p:nvPr/>
          </p:nvCxnSpPr>
          <p:spPr>
            <a:xfrm flipH="1" flipV="1">
              <a:off x="1763688" y="3501008"/>
              <a:ext cx="474946" cy="946570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29"/>
            <p:cNvCxnSpPr/>
            <p:nvPr/>
          </p:nvCxnSpPr>
          <p:spPr>
            <a:xfrm flipV="1">
              <a:off x="683568" y="3501008"/>
              <a:ext cx="648072" cy="648072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5292079" y="2069796"/>
              <a:ext cx="2077507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COP1(</a:t>
              </a:r>
              <a:r>
                <a:rPr lang="en-US" altLang="ko-KR" sz="3800" dirty="0"/>
                <a:t>AT2G32950 </a:t>
              </a:r>
              <a:r>
                <a:rPr lang="en-US" altLang="ko-KR" sz="3800" b="1" dirty="0">
                  <a:solidFill>
                    <a:srgbClr val="FFC000"/>
                  </a:solidFill>
                </a:rPr>
                <a:t>)</a:t>
              </a:r>
              <a:endParaRPr lang="ko-KR" altLang="en-US" sz="3800" b="1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267744" y="2433702"/>
              <a:ext cx="1637799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70C0"/>
                  </a:solidFill>
                </a:rPr>
                <a:t>ELF3(</a:t>
              </a:r>
              <a:r>
                <a:rPr lang="en-US" altLang="ko-KR" sz="3800" dirty="0"/>
                <a:t>AT2G25930 </a:t>
              </a:r>
              <a:r>
                <a:rPr lang="en-US" altLang="ko-KR" sz="3800" b="1" dirty="0">
                  <a:solidFill>
                    <a:srgbClr val="0070C0"/>
                  </a:solidFill>
                </a:rPr>
                <a:t>)</a:t>
              </a:r>
              <a:endParaRPr lang="ko-KR" altLang="en-US" sz="38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42" name="직선 연결선 41"/>
            <p:cNvCxnSpPr/>
            <p:nvPr/>
          </p:nvCxnSpPr>
          <p:spPr>
            <a:xfrm flipV="1">
              <a:off x="2195736" y="2852936"/>
              <a:ext cx="360040" cy="288032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직선 연결선 43"/>
            <p:cNvCxnSpPr>
              <a:endCxn id="40" idx="0"/>
            </p:cNvCxnSpPr>
            <p:nvPr/>
          </p:nvCxnSpPr>
          <p:spPr>
            <a:xfrm>
              <a:off x="2446999" y="2023280"/>
              <a:ext cx="639645" cy="410422"/>
            </a:xfrm>
            <a:prstGeom prst="line">
              <a:avLst/>
            </a:prstGeom>
            <a:ln>
              <a:head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직선 연결선 47"/>
            <p:cNvCxnSpPr>
              <a:stCxn id="13" idx="2"/>
            </p:cNvCxnSpPr>
            <p:nvPr/>
          </p:nvCxnSpPr>
          <p:spPr>
            <a:xfrm flipH="1">
              <a:off x="5580113" y="1653922"/>
              <a:ext cx="406768" cy="343867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5796135" y="2789786"/>
              <a:ext cx="1495315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70C0"/>
                  </a:solidFill>
                </a:rPr>
                <a:t>GI(</a:t>
              </a:r>
              <a:r>
                <a:rPr lang="en-US" altLang="ko-KR" sz="3800" dirty="0"/>
                <a:t>AT1G22770) </a:t>
              </a:r>
              <a:endParaRPr lang="ko-KR" altLang="en-US" sz="38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55" name="직선 화살표 연결선 54"/>
            <p:cNvCxnSpPr/>
            <p:nvPr/>
          </p:nvCxnSpPr>
          <p:spPr>
            <a:xfrm flipH="1">
              <a:off x="6015224" y="2368102"/>
              <a:ext cx="32940" cy="401888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화살표 연결선 60"/>
            <p:cNvCxnSpPr/>
            <p:nvPr/>
          </p:nvCxnSpPr>
          <p:spPr>
            <a:xfrm flipH="1">
              <a:off x="5292080" y="3068960"/>
              <a:ext cx="648072" cy="216024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직선 연결선 62"/>
            <p:cNvCxnSpPr>
              <a:stCxn id="21" idx="3"/>
            </p:cNvCxnSpPr>
            <p:nvPr/>
          </p:nvCxnSpPr>
          <p:spPr>
            <a:xfrm flipV="1">
              <a:off x="6041269" y="3021522"/>
              <a:ext cx="312546" cy="297715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>
              <a:stCxn id="18" idx="3"/>
              <a:endCxn id="21" idx="1"/>
            </p:cNvCxnSpPr>
            <p:nvPr/>
          </p:nvCxnSpPr>
          <p:spPr>
            <a:xfrm>
              <a:off x="2411760" y="3288241"/>
              <a:ext cx="2040737" cy="30996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화살표 연결선 68"/>
            <p:cNvCxnSpPr/>
            <p:nvPr/>
          </p:nvCxnSpPr>
          <p:spPr>
            <a:xfrm flipH="1" flipV="1">
              <a:off x="2195736" y="3429000"/>
              <a:ext cx="2736304" cy="216024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7030996" y="3717154"/>
              <a:ext cx="1484590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B050"/>
                  </a:solidFill>
                </a:rPr>
                <a:t>ZTL(</a:t>
              </a:r>
              <a:r>
                <a:rPr lang="en-US" altLang="ko-KR" sz="3800" dirty="0"/>
                <a:t>AT5G57360 </a:t>
              </a:r>
              <a:r>
                <a:rPr lang="en-US" altLang="ko-KR" sz="3800" b="1" dirty="0">
                  <a:solidFill>
                    <a:srgbClr val="00B050"/>
                  </a:solidFill>
                </a:rPr>
                <a:t>)</a:t>
              </a:r>
              <a:endParaRPr lang="ko-KR" altLang="en-US" sz="3800" b="1" dirty="0">
                <a:solidFill>
                  <a:srgbClr val="00B050"/>
                </a:solidFill>
              </a:endParaRPr>
            </a:p>
          </p:txBody>
        </p:sp>
        <p:cxnSp>
          <p:nvCxnSpPr>
            <p:cNvPr id="81" name="직선 화살표 연결선 80"/>
            <p:cNvCxnSpPr/>
            <p:nvPr/>
          </p:nvCxnSpPr>
          <p:spPr>
            <a:xfrm>
              <a:off x="6444208" y="3212976"/>
              <a:ext cx="720080" cy="50405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직선 연결선 82"/>
            <p:cNvCxnSpPr>
              <a:endCxn id="21" idx="2"/>
            </p:cNvCxnSpPr>
            <p:nvPr/>
          </p:nvCxnSpPr>
          <p:spPr>
            <a:xfrm flipH="1" flipV="1">
              <a:off x="5246883" y="3403047"/>
              <a:ext cx="1773391" cy="385994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/>
          </p:nvSpPr>
          <p:spPr>
            <a:xfrm>
              <a:off x="1331640" y="1124743"/>
              <a:ext cx="1656183" cy="2552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100" b="1" dirty="0">
                  <a:solidFill>
                    <a:srgbClr val="FF0000"/>
                  </a:solidFill>
                </a:rPr>
                <a:t>Red/Far-red</a:t>
              </a:r>
              <a:endParaRPr lang="ko-KR" altLang="en-US" sz="6100" b="1" dirty="0">
                <a:solidFill>
                  <a:srgbClr val="FF0000"/>
                </a:solidFill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4067943" y="980728"/>
              <a:ext cx="1728192" cy="2552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100" b="1" dirty="0">
                  <a:solidFill>
                    <a:srgbClr val="0070C0"/>
                  </a:solidFill>
                </a:rPr>
                <a:t>Blue light</a:t>
              </a:r>
              <a:endParaRPr lang="ko-KR" altLang="en-US" sz="61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88" name="직선 연결선 87"/>
            <p:cNvCxnSpPr/>
            <p:nvPr/>
          </p:nvCxnSpPr>
          <p:spPr>
            <a:xfrm flipH="1" flipV="1">
              <a:off x="2267744" y="3573016"/>
              <a:ext cx="720080" cy="720080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직선 화살표 연결선 89"/>
            <p:cNvCxnSpPr/>
            <p:nvPr/>
          </p:nvCxnSpPr>
          <p:spPr>
            <a:xfrm flipV="1">
              <a:off x="3540907" y="4005064"/>
              <a:ext cx="3767397" cy="463342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/>
            <p:cNvSpPr txBox="1"/>
            <p:nvPr/>
          </p:nvSpPr>
          <p:spPr>
            <a:xfrm>
              <a:off x="3619043" y="3877155"/>
              <a:ext cx="1601029" cy="16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70C0"/>
                  </a:solidFill>
                </a:rPr>
                <a:t>PRR3(</a:t>
              </a:r>
              <a:r>
                <a:rPr lang="en-US" altLang="ko-KR" sz="3800" dirty="0"/>
                <a:t>AT5G60100 </a:t>
              </a:r>
              <a:r>
                <a:rPr lang="en-US" altLang="ko-KR" sz="3800" b="1" dirty="0">
                  <a:solidFill>
                    <a:srgbClr val="0070C0"/>
                  </a:solidFill>
                </a:rPr>
                <a:t>)</a:t>
              </a:r>
              <a:endParaRPr lang="ko-KR" altLang="en-US" sz="38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97" name="직선 연결선 96"/>
            <p:cNvCxnSpPr/>
            <p:nvPr/>
          </p:nvCxnSpPr>
          <p:spPr>
            <a:xfrm flipV="1">
              <a:off x="5025497" y="3877155"/>
              <a:ext cx="2083636" cy="142606"/>
            </a:xfrm>
            <a:prstGeom prst="line">
              <a:avLst/>
            </a:prstGeom>
            <a:ln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직선 연결선 100"/>
            <p:cNvCxnSpPr/>
            <p:nvPr/>
          </p:nvCxnSpPr>
          <p:spPr>
            <a:xfrm flipV="1">
              <a:off x="4947361" y="3658696"/>
              <a:ext cx="216024" cy="2160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TextBox 40"/>
          <p:cNvSpPr txBox="1"/>
          <p:nvPr/>
        </p:nvSpPr>
        <p:spPr>
          <a:xfrm>
            <a:off x="4250572" y="2932751"/>
            <a:ext cx="4082854" cy="1745094"/>
          </a:xfrm>
          <a:prstGeom prst="rect">
            <a:avLst/>
          </a:prstGeom>
          <a:noFill/>
        </p:spPr>
        <p:txBody>
          <a:bodyPr wrap="square" lIns="431974" tIns="215984" rIns="431974" bIns="215984" rtlCol="0">
            <a:spAutoFit/>
          </a:bodyPr>
          <a:lstStyle/>
          <a:p>
            <a:r>
              <a:rPr lang="en-US" altLang="ko-KR" dirty="0"/>
              <a:t>At</a:t>
            </a:r>
            <a:endParaRPr lang="ko-KR" altLang="en-US" dirty="0"/>
          </a:p>
        </p:txBody>
      </p:sp>
      <p:grpSp>
        <p:nvGrpSpPr>
          <p:cNvPr id="49" name="그룹 40"/>
          <p:cNvGrpSpPr/>
          <p:nvPr/>
        </p:nvGrpSpPr>
        <p:grpSpPr>
          <a:xfrm>
            <a:off x="21013606" y="6766494"/>
            <a:ext cx="20993818" cy="20170689"/>
            <a:chOff x="118108" y="356074"/>
            <a:chExt cx="6939409" cy="4643487"/>
          </a:xfrm>
        </p:grpSpPr>
        <p:sp>
          <p:nvSpPr>
            <p:cNvPr id="50" name="해 49"/>
            <p:cNvSpPr/>
            <p:nvPr/>
          </p:nvSpPr>
          <p:spPr>
            <a:xfrm>
              <a:off x="2326526" y="356074"/>
              <a:ext cx="1237364" cy="848231"/>
            </a:xfrm>
            <a:prstGeom prst="sun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100" dirty="0"/>
            </a:p>
          </p:txBody>
        </p:sp>
        <p:sp>
          <p:nvSpPr>
            <p:cNvPr id="51" name="구름 50"/>
            <p:cNvSpPr/>
            <p:nvPr/>
          </p:nvSpPr>
          <p:spPr>
            <a:xfrm rot="477378">
              <a:off x="2893239" y="468885"/>
              <a:ext cx="1091791" cy="689509"/>
            </a:xfrm>
            <a:prstGeom prst="cloud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100" dirty="0"/>
            </a:p>
          </p:txBody>
        </p:sp>
        <p:cxnSp>
          <p:nvCxnSpPr>
            <p:cNvPr id="52" name="직선 화살표 연결선 51"/>
            <p:cNvCxnSpPr>
              <a:stCxn id="89" idx="3"/>
            </p:cNvCxnSpPr>
            <p:nvPr/>
          </p:nvCxnSpPr>
          <p:spPr>
            <a:xfrm flipH="1">
              <a:off x="2317407" y="1243423"/>
              <a:ext cx="670418" cy="443131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화살표 연결선 53"/>
            <p:cNvCxnSpPr/>
            <p:nvPr/>
          </p:nvCxnSpPr>
          <p:spPr>
            <a:xfrm>
              <a:off x="3707904" y="1124744"/>
              <a:ext cx="864096" cy="360040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284721" y="1700808"/>
              <a:ext cx="3475079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B050"/>
                  </a:solidFill>
                </a:rPr>
                <a:t>BrPHYA1 BrPHYA2/B1 B2</a:t>
              </a:r>
            </a:p>
            <a:p>
              <a:r>
                <a:rPr lang="en-US" altLang="ko-KR" sz="3800" dirty="0"/>
                <a:t>Bra020013 Bra031672 /Bra001650 Bra022192 </a:t>
              </a:r>
              <a:endParaRPr lang="ko-KR" altLang="en-US" sz="3800" b="1" dirty="0">
                <a:solidFill>
                  <a:srgbClr val="00B050"/>
                </a:solidFill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783602" y="1466729"/>
              <a:ext cx="2546804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B050"/>
                  </a:solidFill>
                </a:rPr>
                <a:t>BrCRY1/ BrCRY2a BrCRY2b</a:t>
              </a:r>
            </a:p>
            <a:p>
              <a:r>
                <a:rPr lang="en-US" altLang="ko-KR" sz="3800" dirty="0"/>
                <a:t>Bra037880 /Bra015313 Bra030568 </a:t>
              </a:r>
              <a:endParaRPr lang="ko-KR" altLang="en-US" sz="3800" b="1" dirty="0">
                <a:solidFill>
                  <a:srgbClr val="00B050"/>
                </a:solidFill>
              </a:endParaRPr>
            </a:p>
          </p:txBody>
        </p:sp>
        <p:cxnSp>
          <p:nvCxnSpPr>
            <p:cNvPr id="58" name="직선 화살표 연결선 57"/>
            <p:cNvCxnSpPr/>
            <p:nvPr/>
          </p:nvCxnSpPr>
          <p:spPr>
            <a:xfrm>
              <a:off x="1892403" y="2060848"/>
              <a:ext cx="0" cy="1008112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213315" y="2262422"/>
              <a:ext cx="1713736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B050"/>
                  </a:solidFill>
                </a:rPr>
                <a:t>BrPIF3a BrPIF3b</a:t>
              </a:r>
            </a:p>
            <a:p>
              <a:r>
                <a:rPr lang="en-US" altLang="ko-KR" sz="3800" dirty="0"/>
                <a:t>Bra020017 Bra031668 </a:t>
              </a:r>
              <a:endParaRPr lang="ko-KR" altLang="en-US" sz="3800" b="1" dirty="0">
                <a:solidFill>
                  <a:srgbClr val="00B050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18108" y="3074691"/>
              <a:ext cx="2546804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BrLHY1 BrLHY2/BrCCA1</a:t>
              </a:r>
            </a:p>
            <a:p>
              <a:r>
                <a:rPr lang="en-US" altLang="ko-KR" sz="3800" dirty="0"/>
                <a:t>Bra030496 Bra033291 /Bra004503 </a:t>
              </a:r>
              <a:endParaRPr lang="ko-KR" altLang="en-US" sz="3800" b="1" dirty="0">
                <a:solidFill>
                  <a:srgbClr val="FFC000"/>
                </a:solidFill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13315" y="4141763"/>
              <a:ext cx="1210188" cy="559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BrPRR7a</a:t>
              </a:r>
            </a:p>
            <a:p>
              <a:r>
                <a:rPr lang="en-US" altLang="ko-KR" sz="3800" b="1" dirty="0">
                  <a:solidFill>
                    <a:srgbClr val="FFC000"/>
                  </a:solidFill>
                </a:rPr>
                <a:t>BrPRR7b</a:t>
              </a:r>
            </a:p>
            <a:p>
              <a:r>
                <a:rPr lang="en-US" altLang="ko-KR" sz="3800" dirty="0"/>
                <a:t>Bra009565 Bra028861 </a:t>
              </a:r>
              <a:endParaRPr lang="ko-KR" altLang="en-US" sz="3800" b="1" dirty="0">
                <a:solidFill>
                  <a:srgbClr val="FFC000"/>
                </a:solidFill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403410" y="4201504"/>
              <a:ext cx="1112431" cy="559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BrPRR9a</a:t>
              </a:r>
            </a:p>
            <a:p>
              <a:r>
                <a:rPr lang="en-US" altLang="ko-KR" sz="3800" b="1" dirty="0">
                  <a:solidFill>
                    <a:srgbClr val="FFC000"/>
                  </a:solidFill>
                </a:rPr>
                <a:t>BrPRR9b</a:t>
              </a:r>
            </a:p>
            <a:p>
              <a:r>
                <a:rPr lang="en-US" altLang="ko-KR" sz="3800" dirty="0"/>
                <a:t>Bra004507 Bra040484 </a:t>
              </a:r>
              <a:endParaRPr lang="ko-KR" altLang="en-US" sz="3800" b="1" dirty="0">
                <a:solidFill>
                  <a:srgbClr val="FFC000"/>
                </a:solidFill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393223" y="3341934"/>
              <a:ext cx="2413222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70C0"/>
                  </a:solidFill>
                </a:rPr>
                <a:t>BrPRR1a BrPRR1b</a:t>
              </a:r>
            </a:p>
            <a:p>
              <a:r>
                <a:rPr lang="en-US" altLang="ko-KR" sz="3800" dirty="0"/>
                <a:t>Bra012964 Bra035933 </a:t>
              </a:r>
              <a:endParaRPr lang="ko-KR" altLang="en-US" sz="3800" b="1" dirty="0">
                <a:solidFill>
                  <a:srgbClr val="0070C0"/>
                </a:solidFill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641110" y="4170579"/>
              <a:ext cx="1211319" cy="828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FFC000"/>
                  </a:solidFill>
                </a:rPr>
                <a:t>BrPRR5a</a:t>
              </a:r>
            </a:p>
            <a:p>
              <a:r>
                <a:rPr lang="en-US" altLang="ko-KR" sz="3800" b="1" dirty="0">
                  <a:solidFill>
                    <a:srgbClr val="FFC000"/>
                  </a:solidFill>
                </a:rPr>
                <a:t>BrPRR5b</a:t>
              </a:r>
            </a:p>
            <a:p>
              <a:r>
                <a:rPr lang="en-US" altLang="ko-KR" sz="3800" b="1" dirty="0">
                  <a:solidFill>
                    <a:srgbClr val="FFC000"/>
                  </a:solidFill>
                </a:rPr>
                <a:t>BrPRR5c</a:t>
              </a:r>
            </a:p>
            <a:p>
              <a:r>
                <a:rPr lang="en-US" altLang="ko-KR" sz="3800" dirty="0"/>
                <a:t>Bra009768 Bra029407 Bra036517 </a:t>
              </a:r>
              <a:endParaRPr lang="ko-KR" altLang="en-US" sz="3800" b="1" dirty="0">
                <a:solidFill>
                  <a:srgbClr val="FFC000"/>
                </a:solidFill>
              </a:endParaRPr>
            </a:p>
          </p:txBody>
        </p:sp>
        <p:cxnSp>
          <p:nvCxnSpPr>
            <p:cNvPr id="68" name="직선 연결선 67"/>
            <p:cNvCxnSpPr/>
            <p:nvPr/>
          </p:nvCxnSpPr>
          <p:spPr>
            <a:xfrm flipH="1" flipV="1">
              <a:off x="1892403" y="3402104"/>
              <a:ext cx="64593" cy="773374"/>
            </a:xfrm>
            <a:prstGeom prst="line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/>
            <p:cNvCxnSpPr/>
            <p:nvPr/>
          </p:nvCxnSpPr>
          <p:spPr>
            <a:xfrm flipV="1">
              <a:off x="856776" y="3348811"/>
              <a:ext cx="777257" cy="800270"/>
            </a:xfrm>
            <a:prstGeom prst="line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/>
            <p:cNvSpPr txBox="1"/>
            <p:nvPr/>
          </p:nvSpPr>
          <p:spPr>
            <a:xfrm>
              <a:off x="4963078" y="2069796"/>
              <a:ext cx="2094439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 smtClean="0">
                  <a:solidFill>
                    <a:srgbClr val="FFC000"/>
                  </a:solidFill>
                </a:rPr>
                <a:t>BrCOP1a BrCOP1b</a:t>
              </a:r>
              <a:endParaRPr lang="en-US" altLang="ko-KR" sz="3800" b="1" dirty="0">
                <a:solidFill>
                  <a:srgbClr val="FFC000"/>
                </a:solidFill>
              </a:endParaRPr>
            </a:p>
            <a:p>
              <a:r>
                <a:rPr lang="en-US" altLang="ko-KR" sz="3800" dirty="0"/>
                <a:t>Bra005541 Bra021818 </a:t>
              </a:r>
              <a:endParaRPr lang="ko-KR" altLang="en-US" sz="38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177113" y="2477922"/>
              <a:ext cx="1677896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 smtClean="0">
                  <a:solidFill>
                    <a:srgbClr val="0070C0"/>
                  </a:solidFill>
                </a:rPr>
                <a:t>BrELF3a BrELF3b</a:t>
              </a:r>
              <a:endParaRPr lang="en-US" altLang="ko-KR" sz="3800" b="1" dirty="0">
                <a:solidFill>
                  <a:srgbClr val="0070C0"/>
                </a:solidFill>
              </a:endParaRPr>
            </a:p>
            <a:p>
              <a:r>
                <a:rPr lang="en-US" altLang="ko-KR" sz="3800" dirty="0"/>
                <a:t>Bra007774 Bra034284 </a:t>
              </a:r>
              <a:endParaRPr lang="ko-KR" altLang="en-US" sz="38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74" name="직선 연결선 73"/>
            <p:cNvCxnSpPr/>
            <p:nvPr/>
          </p:nvCxnSpPr>
          <p:spPr>
            <a:xfrm flipV="1">
              <a:off x="2522101" y="2768970"/>
              <a:ext cx="360040" cy="288032"/>
            </a:xfrm>
            <a:prstGeom prst="line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직선 연결선 74"/>
            <p:cNvCxnSpPr>
              <a:endCxn id="73" idx="0"/>
            </p:cNvCxnSpPr>
            <p:nvPr/>
          </p:nvCxnSpPr>
          <p:spPr>
            <a:xfrm>
              <a:off x="2240431" y="2069771"/>
              <a:ext cx="775630" cy="408151"/>
            </a:xfrm>
            <a:prstGeom prst="line">
              <a:avLst/>
            </a:prstGeom>
            <a:ln>
              <a:head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연결선 75"/>
            <p:cNvCxnSpPr/>
            <p:nvPr/>
          </p:nvCxnSpPr>
          <p:spPr>
            <a:xfrm>
              <a:off x="5026395" y="1740176"/>
              <a:ext cx="633174" cy="373053"/>
            </a:xfrm>
            <a:prstGeom prst="line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5913067" y="2835503"/>
              <a:ext cx="845775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 err="1">
                  <a:solidFill>
                    <a:srgbClr val="0070C0"/>
                  </a:solidFill>
                </a:rPr>
                <a:t>BrGI</a:t>
              </a:r>
              <a:endParaRPr lang="en-US" altLang="ko-KR" sz="3800" b="1" dirty="0">
                <a:solidFill>
                  <a:srgbClr val="0070C0"/>
                </a:solidFill>
              </a:endParaRPr>
            </a:p>
            <a:p>
              <a:r>
                <a:rPr lang="en-US" altLang="ko-KR" sz="3800" dirty="0"/>
                <a:t>Bra024536 </a:t>
              </a:r>
              <a:endParaRPr lang="ko-KR" altLang="en-US" sz="38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78" name="직선 화살표 연결선 77"/>
            <p:cNvCxnSpPr>
              <a:stCxn id="72" idx="2"/>
            </p:cNvCxnSpPr>
            <p:nvPr/>
          </p:nvCxnSpPr>
          <p:spPr>
            <a:xfrm>
              <a:off x="6010297" y="2360294"/>
              <a:ext cx="255135" cy="49264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직선 화살표 연결선 78"/>
            <p:cNvCxnSpPr>
              <a:endCxn id="65" idx="0"/>
            </p:cNvCxnSpPr>
            <p:nvPr/>
          </p:nvCxnSpPr>
          <p:spPr>
            <a:xfrm flipH="1">
              <a:off x="5599834" y="3068960"/>
              <a:ext cx="340322" cy="272974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직선 연결선 79"/>
            <p:cNvCxnSpPr>
              <a:endCxn id="65" idx="1"/>
            </p:cNvCxnSpPr>
            <p:nvPr/>
          </p:nvCxnSpPr>
          <p:spPr>
            <a:xfrm>
              <a:off x="2664912" y="3240461"/>
              <a:ext cx="1728311" cy="246722"/>
            </a:xfrm>
            <a:prstGeom prst="line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6667965" y="3775158"/>
              <a:ext cx="268167" cy="237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100" b="1" dirty="0"/>
                <a:t>?</a:t>
              </a:r>
              <a:endParaRPr lang="ko-KR" altLang="en-US" sz="6100" b="1" dirty="0"/>
            </a:p>
          </p:txBody>
        </p:sp>
        <p:cxnSp>
          <p:nvCxnSpPr>
            <p:cNvPr id="84" name="직선 화살표 연결선 83"/>
            <p:cNvCxnSpPr/>
            <p:nvPr/>
          </p:nvCxnSpPr>
          <p:spPr>
            <a:xfrm>
              <a:off x="6444208" y="3212976"/>
              <a:ext cx="223757" cy="508889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직선 연결선 86"/>
            <p:cNvCxnSpPr>
              <a:endCxn id="65" idx="2"/>
            </p:cNvCxnSpPr>
            <p:nvPr/>
          </p:nvCxnSpPr>
          <p:spPr>
            <a:xfrm flipH="1" flipV="1">
              <a:off x="5599834" y="3632432"/>
              <a:ext cx="1003183" cy="196021"/>
            </a:xfrm>
            <a:prstGeom prst="line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/>
            <p:cNvSpPr txBox="1"/>
            <p:nvPr/>
          </p:nvSpPr>
          <p:spPr>
            <a:xfrm>
              <a:off x="1331640" y="1124744"/>
              <a:ext cx="1656185" cy="237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100" b="1" dirty="0">
                  <a:solidFill>
                    <a:srgbClr val="FF0000"/>
                  </a:solidFill>
                </a:rPr>
                <a:t>Red/Far-red</a:t>
              </a:r>
              <a:endParaRPr lang="ko-KR" altLang="en-US" sz="6100" b="1" dirty="0">
                <a:solidFill>
                  <a:srgbClr val="FF0000"/>
                </a:solidFill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067945" y="980728"/>
              <a:ext cx="1728193" cy="237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100" b="1" dirty="0">
                  <a:solidFill>
                    <a:srgbClr val="0070C0"/>
                  </a:solidFill>
                </a:rPr>
                <a:t>Blue light</a:t>
              </a:r>
              <a:endParaRPr lang="ko-KR" altLang="en-US" sz="61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93" name="직선 연결선 92"/>
            <p:cNvCxnSpPr/>
            <p:nvPr/>
          </p:nvCxnSpPr>
          <p:spPr>
            <a:xfrm flipH="1" flipV="1">
              <a:off x="2279958" y="3348811"/>
              <a:ext cx="720284" cy="799401"/>
            </a:xfrm>
            <a:prstGeom prst="line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직선 화살표 연결선 93"/>
            <p:cNvCxnSpPr/>
            <p:nvPr/>
          </p:nvCxnSpPr>
          <p:spPr>
            <a:xfrm flipV="1">
              <a:off x="3878809" y="4041625"/>
              <a:ext cx="2724207" cy="554759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>
              <a:off x="3745259" y="3874867"/>
              <a:ext cx="1772887" cy="290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3800" b="1" dirty="0">
                  <a:solidFill>
                    <a:srgbClr val="0070C0"/>
                  </a:solidFill>
                </a:rPr>
                <a:t>BrPRR3a BrPRR3b</a:t>
              </a:r>
            </a:p>
            <a:p>
              <a:r>
                <a:rPr lang="en-US" altLang="ko-KR" sz="3800" dirty="0"/>
                <a:t>Bra002512 Bra020263 </a:t>
              </a:r>
              <a:endParaRPr lang="ko-KR" altLang="en-US" sz="38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96" name="직선 연결선 95"/>
            <p:cNvCxnSpPr/>
            <p:nvPr/>
          </p:nvCxnSpPr>
          <p:spPr>
            <a:xfrm flipV="1">
              <a:off x="4830886" y="3935038"/>
              <a:ext cx="1772131" cy="253282"/>
            </a:xfrm>
            <a:prstGeom prst="line">
              <a:avLst/>
            </a:prstGeom>
            <a:ln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직선 연결선 97"/>
            <p:cNvCxnSpPr/>
            <p:nvPr/>
          </p:nvCxnSpPr>
          <p:spPr>
            <a:xfrm flipV="1">
              <a:off x="4902292" y="3704615"/>
              <a:ext cx="404632" cy="32245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4" name="TextBox 103"/>
          <p:cNvSpPr txBox="1"/>
          <p:nvPr/>
        </p:nvSpPr>
        <p:spPr>
          <a:xfrm>
            <a:off x="24050973" y="3312593"/>
            <a:ext cx="4082854" cy="1745094"/>
          </a:xfrm>
          <a:prstGeom prst="rect">
            <a:avLst/>
          </a:prstGeom>
          <a:noFill/>
        </p:spPr>
        <p:txBody>
          <a:bodyPr wrap="square" lIns="431974" tIns="215984" rIns="431974" bIns="215984" rtlCol="0">
            <a:spAutoFit/>
          </a:bodyPr>
          <a:lstStyle/>
          <a:p>
            <a:r>
              <a:rPr lang="en-US" altLang="ko-KR" dirty="0"/>
              <a:t>Br</a:t>
            </a:r>
            <a:endParaRPr lang="ko-KR" altLang="en-US" dirty="0"/>
          </a:p>
        </p:txBody>
      </p:sp>
      <p:sp>
        <p:nvSpPr>
          <p:cNvPr id="99" name="TextBox 98"/>
          <p:cNvSpPr txBox="1"/>
          <p:nvPr/>
        </p:nvSpPr>
        <p:spPr>
          <a:xfrm>
            <a:off x="1656484" y="1368377"/>
            <a:ext cx="12313368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3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463007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Grp="1" noChangeAspect="1" noChangeArrowheads="1"/>
          </p:cNvPicPr>
          <p:nvPr>
            <p:ph idx="4294967295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324" y="4577445"/>
            <a:ext cx="26642960" cy="23907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08412" y="288257"/>
            <a:ext cx="12313368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4.</a:t>
            </a:r>
            <a:endParaRPr lang="ko-KR" alt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5400900" y="27180406"/>
            <a:ext cx="1691108" cy="7694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4400" b="1" dirty="0" smtClean="0"/>
              <a:t>ZT0</a:t>
            </a:r>
            <a:endParaRPr lang="ko-KR" altLang="en-US" sz="4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7912796" y="27187957"/>
            <a:ext cx="1691108" cy="7694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4400" b="1" dirty="0" smtClean="0"/>
              <a:t>ZT4</a:t>
            </a:r>
            <a:endParaRPr lang="ko-KR" altLang="en-US" sz="4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9763364" y="27187957"/>
            <a:ext cx="1691108" cy="7694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4400" b="1" dirty="0" smtClean="0"/>
              <a:t>ZT8</a:t>
            </a:r>
            <a:endParaRPr lang="ko-KR" altLang="en-US" sz="4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1570624" y="27187957"/>
            <a:ext cx="2123156" cy="7694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4400" b="1" dirty="0" smtClean="0"/>
              <a:t>ZT12</a:t>
            </a:r>
            <a:endParaRPr lang="ko-KR" altLang="en-US" sz="4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3591748" y="27187957"/>
            <a:ext cx="2195164" cy="7694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4400" b="1" dirty="0" smtClean="0"/>
              <a:t>ZT16</a:t>
            </a:r>
            <a:endParaRPr lang="ko-KR" altLang="en-US" sz="4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5679980" y="27187957"/>
            <a:ext cx="2195164" cy="7694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4400" b="1" dirty="0" smtClean="0"/>
              <a:t>ZT20</a:t>
            </a:r>
            <a:endParaRPr lang="ko-KR" altLang="en-US" sz="4400" b="1" dirty="0"/>
          </a:p>
        </p:txBody>
      </p:sp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9386002"/>
              </p:ext>
            </p:extLst>
          </p:nvPr>
        </p:nvGraphicFramePr>
        <p:xfrm>
          <a:off x="27651372" y="5256809"/>
          <a:ext cx="14617624" cy="23906660"/>
        </p:xfrm>
        <a:graphic>
          <a:graphicData uri="http://schemas.openxmlformats.org/drawingml/2006/table">
            <a:tbl>
              <a:tblPr/>
              <a:tblGrid>
                <a:gridCol w="3654406"/>
                <a:gridCol w="3654406"/>
                <a:gridCol w="3654406"/>
                <a:gridCol w="3654406"/>
              </a:tblGrid>
              <a:tr h="786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lia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rabidopsi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ssic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CC valu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HYB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2G1879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2219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9602566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LH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0106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04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9285332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8A8C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R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5G0281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0956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9178644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9497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R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5G0281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2886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8996693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1B3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R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2G4679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045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7752805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DC0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IF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0953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16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7294789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2C4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ELF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2G2593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0777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6809529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7C9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R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5G2447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294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489777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ADD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TOC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5G6138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1296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394151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E6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CRY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4G0892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78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346117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8EB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CCA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2G4683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045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294614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EF1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R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5G2447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097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242169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3F6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I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2277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245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18909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8FB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IF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0953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2001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107129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E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R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5G2447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651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8056878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BFE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LH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01060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329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78924103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D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TOC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5G6138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59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78825882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9FD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HY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0957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200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7552698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7FC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R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5G6010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025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6364348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DF7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HY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0957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167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43388805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CEF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ELF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2G2593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42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24682406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CDE7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R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2G4679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404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1142636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AC2E2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COP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2G3295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0554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1299234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EBADE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HYB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2G1879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0165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-0.06498334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5B3DA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CRY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0440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305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-0.06796473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B3DA"/>
                    </a:solidFill>
                  </a:tcPr>
                </a:tc>
              </a:tr>
              <a:tr h="889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CRY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1G0440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Bra0153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40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-0.57150478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56903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68452" y="576289"/>
            <a:ext cx="12313368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5.</a:t>
            </a:r>
            <a:endParaRPr lang="ko-KR" altLang="en-US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/>
        </p:nvGraphicFramePr>
        <p:xfrm>
          <a:off x="576366" y="2592512"/>
          <a:ext cx="42052668" cy="2916324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008778"/>
                <a:gridCol w="7008778"/>
                <a:gridCol w="7008778"/>
                <a:gridCol w="7008778"/>
                <a:gridCol w="7008778"/>
                <a:gridCol w="7008778"/>
              </a:tblGrid>
              <a:tr h="21664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Arabidopsis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RNAseq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qRT</a:t>
                      </a:r>
                      <a:r>
                        <a:rPr lang="en-US" altLang="ko-KR" dirty="0" smtClean="0"/>
                        <a:t>-PCR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Arabidopsis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RNAseq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qRT</a:t>
                      </a:r>
                      <a:r>
                        <a:rPr lang="en-US" altLang="ko-KR" dirty="0" smtClean="0"/>
                        <a:t>-PCR</a:t>
                      </a:r>
                      <a:endParaRPr lang="ko-KR" altLang="en-US" dirty="0"/>
                    </a:p>
                  </a:txBody>
                  <a:tcPr anchor="ctr"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9" name="차트 8"/>
          <p:cNvGraphicFramePr/>
          <p:nvPr>
            <p:extLst>
              <p:ext uri="{D42A27DB-BD31-4B8C-83A1-F6EECF244321}">
                <p14:modId xmlns:p14="http://schemas.microsoft.com/office/powerpoint/2010/main" val="2859054538"/>
              </p:ext>
            </p:extLst>
          </p:nvPr>
        </p:nvGraphicFramePr>
        <p:xfrm>
          <a:off x="576364" y="4752753"/>
          <a:ext cx="7056784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차트 9"/>
          <p:cNvGraphicFramePr/>
          <p:nvPr/>
        </p:nvGraphicFramePr>
        <p:xfrm>
          <a:off x="21674708" y="4752753"/>
          <a:ext cx="6840760" cy="6768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차트 10"/>
          <p:cNvGraphicFramePr/>
          <p:nvPr/>
        </p:nvGraphicFramePr>
        <p:xfrm>
          <a:off x="28659484" y="4824761"/>
          <a:ext cx="6840760" cy="6768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차트 11"/>
          <p:cNvGraphicFramePr/>
          <p:nvPr>
            <p:extLst>
              <p:ext uri="{D42A27DB-BD31-4B8C-83A1-F6EECF244321}">
                <p14:modId xmlns:p14="http://schemas.microsoft.com/office/powerpoint/2010/main" val="2881966568"/>
              </p:ext>
            </p:extLst>
          </p:nvPr>
        </p:nvGraphicFramePr>
        <p:xfrm>
          <a:off x="8269026" y="4752753"/>
          <a:ext cx="6420905" cy="6624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차트 12"/>
          <p:cNvGraphicFramePr/>
          <p:nvPr/>
        </p:nvGraphicFramePr>
        <p:xfrm>
          <a:off x="576364" y="11521505"/>
          <a:ext cx="6912768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차트 13"/>
          <p:cNvGraphicFramePr/>
          <p:nvPr/>
        </p:nvGraphicFramePr>
        <p:xfrm>
          <a:off x="21674708" y="11665521"/>
          <a:ext cx="6912768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5" name="차트 14"/>
          <p:cNvGraphicFramePr/>
          <p:nvPr>
            <p:extLst>
              <p:ext uri="{D42A27DB-BD31-4B8C-83A1-F6EECF244321}">
                <p14:modId xmlns:p14="http://schemas.microsoft.com/office/powerpoint/2010/main" val="2904351027"/>
              </p:ext>
            </p:extLst>
          </p:nvPr>
        </p:nvGraphicFramePr>
        <p:xfrm>
          <a:off x="7705156" y="11521505"/>
          <a:ext cx="6912768" cy="6840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6" name="차트 15"/>
          <p:cNvGraphicFramePr/>
          <p:nvPr>
            <p:extLst>
              <p:ext uri="{D42A27DB-BD31-4B8C-83A1-F6EECF244321}">
                <p14:modId xmlns:p14="http://schemas.microsoft.com/office/powerpoint/2010/main" val="2444220726"/>
              </p:ext>
            </p:extLst>
          </p:nvPr>
        </p:nvGraphicFramePr>
        <p:xfrm>
          <a:off x="28659484" y="11593513"/>
          <a:ext cx="6912768" cy="6480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7" name="차트 16"/>
          <p:cNvGraphicFramePr/>
          <p:nvPr/>
        </p:nvGraphicFramePr>
        <p:xfrm>
          <a:off x="648372" y="18290257"/>
          <a:ext cx="6840760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8" name="차트 17"/>
          <p:cNvGraphicFramePr/>
          <p:nvPr/>
        </p:nvGraphicFramePr>
        <p:xfrm>
          <a:off x="21610636" y="18362265"/>
          <a:ext cx="6976839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9" name="차트 18"/>
          <p:cNvGraphicFramePr/>
          <p:nvPr/>
        </p:nvGraphicFramePr>
        <p:xfrm>
          <a:off x="576364" y="24987001"/>
          <a:ext cx="6984776" cy="6768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0" name="차트 19"/>
          <p:cNvGraphicFramePr/>
          <p:nvPr/>
        </p:nvGraphicFramePr>
        <p:xfrm>
          <a:off x="21674708" y="25059009"/>
          <a:ext cx="6840760" cy="6624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21" name="차트 20"/>
          <p:cNvGraphicFramePr/>
          <p:nvPr/>
        </p:nvGraphicFramePr>
        <p:xfrm>
          <a:off x="7633148" y="18290257"/>
          <a:ext cx="6984776" cy="6840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22" name="차트 21"/>
          <p:cNvGraphicFramePr/>
          <p:nvPr/>
        </p:nvGraphicFramePr>
        <p:xfrm>
          <a:off x="28749041" y="18290257"/>
          <a:ext cx="6895220" cy="6389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23" name="차트 22"/>
          <p:cNvGraphicFramePr/>
          <p:nvPr/>
        </p:nvGraphicFramePr>
        <p:xfrm>
          <a:off x="7705155" y="24987001"/>
          <a:ext cx="6912769" cy="6389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24" name="차트 23"/>
          <p:cNvGraphicFramePr/>
          <p:nvPr/>
        </p:nvGraphicFramePr>
        <p:xfrm>
          <a:off x="28659484" y="24987001"/>
          <a:ext cx="6984776" cy="6389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25" name="차트 24"/>
          <p:cNvGraphicFramePr/>
          <p:nvPr/>
        </p:nvGraphicFramePr>
        <p:xfrm>
          <a:off x="35716268" y="25059009"/>
          <a:ext cx="6840760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26" name="차트 25"/>
          <p:cNvGraphicFramePr/>
          <p:nvPr/>
        </p:nvGraphicFramePr>
        <p:xfrm>
          <a:off x="14617924" y="25059009"/>
          <a:ext cx="6984776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28" name="차트 27"/>
          <p:cNvGraphicFramePr/>
          <p:nvPr/>
        </p:nvGraphicFramePr>
        <p:xfrm>
          <a:off x="35644260" y="18362265"/>
          <a:ext cx="6912768" cy="6480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31" name="차트 30"/>
          <p:cNvGraphicFramePr/>
          <p:nvPr/>
        </p:nvGraphicFramePr>
        <p:xfrm>
          <a:off x="35716268" y="11593513"/>
          <a:ext cx="6840760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32" name="차트 31"/>
          <p:cNvGraphicFramePr/>
          <p:nvPr/>
        </p:nvGraphicFramePr>
        <p:xfrm>
          <a:off x="14689932" y="11521505"/>
          <a:ext cx="6912768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33" name="차트 32"/>
          <p:cNvGraphicFramePr/>
          <p:nvPr/>
        </p:nvGraphicFramePr>
        <p:xfrm>
          <a:off x="35644260" y="4752753"/>
          <a:ext cx="6912768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34" name="차트 33"/>
          <p:cNvGraphicFramePr/>
          <p:nvPr/>
        </p:nvGraphicFramePr>
        <p:xfrm>
          <a:off x="14617924" y="4824761"/>
          <a:ext cx="6912768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35" name="차트 34"/>
          <p:cNvGraphicFramePr/>
          <p:nvPr/>
        </p:nvGraphicFramePr>
        <p:xfrm>
          <a:off x="14689932" y="18290257"/>
          <a:ext cx="6840760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337004" y="9577289"/>
            <a:ext cx="8640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0" b="1" dirty="0" smtClean="0"/>
              <a:t>ZT</a:t>
            </a:r>
            <a:endParaRPr lang="ko-KR" altLang="en-US" sz="40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29739754" y="4752753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B</a:t>
            </a:r>
            <a:endParaRPr lang="ko-KR" altLang="en-US" sz="60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8497244" y="18290257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E</a:t>
            </a:r>
            <a:endParaRPr lang="ko-KR" altLang="en-US" sz="60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29739754" y="18290257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F</a:t>
            </a:r>
            <a:endParaRPr lang="ko-KR" altLang="en-US" sz="60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8817149" y="25275033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G</a:t>
            </a:r>
            <a:endParaRPr lang="ko-KR" altLang="en-US" sz="60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29739754" y="25275033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H</a:t>
            </a:r>
            <a:endParaRPr lang="ko-KR" altLang="en-US" sz="6000" b="1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6351845" y="6045832"/>
            <a:ext cx="3126476" cy="70788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4000" b="1" dirty="0"/>
              <a:t>FPKM value</a:t>
            </a:r>
            <a:endParaRPr lang="ko-KR" altLang="en-US" sz="40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68452" y="576289"/>
            <a:ext cx="17209912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5. continue</a:t>
            </a:r>
            <a:endParaRPr lang="ko-KR" altLang="en-US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7355774"/>
              </p:ext>
            </p:extLst>
          </p:nvPr>
        </p:nvGraphicFramePr>
        <p:xfrm>
          <a:off x="576366" y="2592512"/>
          <a:ext cx="42052668" cy="2916324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008778"/>
                <a:gridCol w="7008778"/>
                <a:gridCol w="7008778"/>
                <a:gridCol w="7008778"/>
                <a:gridCol w="7008778"/>
                <a:gridCol w="7008778"/>
              </a:tblGrid>
              <a:tr h="21664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Arabidopsis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RNAseq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qRT</a:t>
                      </a:r>
                      <a:r>
                        <a:rPr lang="en-US" altLang="ko-KR" dirty="0" smtClean="0"/>
                        <a:t>-PCR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Arabidopsis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RNAseq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qRT</a:t>
                      </a:r>
                      <a:r>
                        <a:rPr lang="en-US" altLang="ko-KR" dirty="0" smtClean="0"/>
                        <a:t>-PCR</a:t>
                      </a:r>
                      <a:endParaRPr lang="ko-KR" altLang="en-US" dirty="0"/>
                    </a:p>
                  </a:txBody>
                  <a:tcPr anchor="ctr"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25" name="차트 24"/>
          <p:cNvGraphicFramePr/>
          <p:nvPr/>
        </p:nvGraphicFramePr>
        <p:xfrm>
          <a:off x="648372" y="4752753"/>
          <a:ext cx="6840760" cy="6768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6" name="차트 25"/>
          <p:cNvGraphicFramePr/>
          <p:nvPr/>
        </p:nvGraphicFramePr>
        <p:xfrm>
          <a:off x="21746716" y="4824761"/>
          <a:ext cx="6768752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차트 26"/>
          <p:cNvGraphicFramePr/>
          <p:nvPr/>
        </p:nvGraphicFramePr>
        <p:xfrm>
          <a:off x="576364" y="11521505"/>
          <a:ext cx="6912768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8" name="차트 27"/>
          <p:cNvGraphicFramePr/>
          <p:nvPr/>
        </p:nvGraphicFramePr>
        <p:xfrm>
          <a:off x="21578316" y="11569129"/>
          <a:ext cx="6937151" cy="66491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9" name="차트 28"/>
          <p:cNvGraphicFramePr/>
          <p:nvPr/>
        </p:nvGraphicFramePr>
        <p:xfrm>
          <a:off x="648372" y="18362265"/>
          <a:ext cx="6912768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2" name="차트 31"/>
          <p:cNvGraphicFramePr/>
          <p:nvPr>
            <p:extLst>
              <p:ext uri="{D42A27DB-BD31-4B8C-83A1-F6EECF244321}">
                <p14:modId xmlns:p14="http://schemas.microsoft.com/office/powerpoint/2010/main" val="522864844"/>
              </p:ext>
            </p:extLst>
          </p:nvPr>
        </p:nvGraphicFramePr>
        <p:xfrm>
          <a:off x="21674708" y="18409890"/>
          <a:ext cx="6884193" cy="67211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3" name="차트 32"/>
          <p:cNvGraphicFramePr/>
          <p:nvPr>
            <p:extLst>
              <p:ext uri="{D42A27DB-BD31-4B8C-83A1-F6EECF244321}">
                <p14:modId xmlns:p14="http://schemas.microsoft.com/office/powerpoint/2010/main" val="122020954"/>
              </p:ext>
            </p:extLst>
          </p:nvPr>
        </p:nvGraphicFramePr>
        <p:xfrm>
          <a:off x="7633148" y="4824761"/>
          <a:ext cx="7056784" cy="64860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4" name="차트 33"/>
          <p:cNvGraphicFramePr/>
          <p:nvPr/>
        </p:nvGraphicFramePr>
        <p:xfrm>
          <a:off x="28587476" y="4752753"/>
          <a:ext cx="7056784" cy="64860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5" name="차트 34"/>
          <p:cNvGraphicFramePr/>
          <p:nvPr/>
        </p:nvGraphicFramePr>
        <p:xfrm>
          <a:off x="28587476" y="11665521"/>
          <a:ext cx="6984776" cy="64860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6" name="차트 35"/>
          <p:cNvGraphicFramePr/>
          <p:nvPr>
            <p:extLst>
              <p:ext uri="{D42A27DB-BD31-4B8C-83A1-F6EECF244321}">
                <p14:modId xmlns:p14="http://schemas.microsoft.com/office/powerpoint/2010/main" val="1816809757"/>
              </p:ext>
            </p:extLst>
          </p:nvPr>
        </p:nvGraphicFramePr>
        <p:xfrm>
          <a:off x="7633149" y="11521505"/>
          <a:ext cx="6984776" cy="64860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7" name="차트 36"/>
          <p:cNvGraphicFramePr/>
          <p:nvPr/>
        </p:nvGraphicFramePr>
        <p:xfrm>
          <a:off x="7633149" y="18362265"/>
          <a:ext cx="7056784" cy="63949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38" name="차트 37"/>
          <p:cNvGraphicFramePr/>
          <p:nvPr>
            <p:extLst>
              <p:ext uri="{D42A27DB-BD31-4B8C-83A1-F6EECF244321}">
                <p14:modId xmlns:p14="http://schemas.microsoft.com/office/powerpoint/2010/main" val="2375469374"/>
              </p:ext>
            </p:extLst>
          </p:nvPr>
        </p:nvGraphicFramePr>
        <p:xfrm>
          <a:off x="28630910" y="18434274"/>
          <a:ext cx="7056784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22" name="차트 21"/>
          <p:cNvGraphicFramePr/>
          <p:nvPr/>
        </p:nvGraphicFramePr>
        <p:xfrm>
          <a:off x="14689932" y="11593513"/>
          <a:ext cx="6768752" cy="6624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23" name="차트 22"/>
          <p:cNvGraphicFramePr/>
          <p:nvPr/>
        </p:nvGraphicFramePr>
        <p:xfrm>
          <a:off x="35716268" y="4752753"/>
          <a:ext cx="6912768" cy="6768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24" name="차트 23"/>
          <p:cNvGraphicFramePr/>
          <p:nvPr/>
        </p:nvGraphicFramePr>
        <p:xfrm>
          <a:off x="14545916" y="4752753"/>
          <a:ext cx="7128792" cy="6768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40" name="차트 39"/>
          <p:cNvGraphicFramePr/>
          <p:nvPr/>
        </p:nvGraphicFramePr>
        <p:xfrm>
          <a:off x="35644260" y="11593513"/>
          <a:ext cx="6840760" cy="6624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42" name="차트 41"/>
          <p:cNvGraphicFramePr/>
          <p:nvPr/>
        </p:nvGraphicFramePr>
        <p:xfrm>
          <a:off x="14473908" y="18362265"/>
          <a:ext cx="7128792" cy="6840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43" name="차트 42"/>
          <p:cNvGraphicFramePr/>
          <p:nvPr>
            <p:extLst>
              <p:ext uri="{D42A27DB-BD31-4B8C-83A1-F6EECF244321}">
                <p14:modId xmlns:p14="http://schemas.microsoft.com/office/powerpoint/2010/main" val="462473396"/>
              </p:ext>
            </p:extLst>
          </p:nvPr>
        </p:nvGraphicFramePr>
        <p:xfrm>
          <a:off x="35759702" y="18362265"/>
          <a:ext cx="6840760" cy="66247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8757784" y="4896769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I</a:t>
            </a:r>
            <a:endParaRPr lang="ko-KR" altLang="en-US" sz="60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29883620" y="4896768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J</a:t>
            </a:r>
            <a:endParaRPr lang="ko-KR" altLang="en-US" sz="60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8929897" y="11748256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K</a:t>
            </a:r>
            <a:endParaRPr lang="ko-KR" altLang="en-US" sz="60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29606187" y="11702033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L</a:t>
            </a:r>
            <a:endParaRPr lang="ko-KR" altLang="en-US" sz="60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8713418" y="18428168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M</a:t>
            </a:r>
            <a:endParaRPr lang="ko-KR" altLang="en-US" sz="60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30195798" y="18506282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N</a:t>
            </a:r>
            <a:endParaRPr lang="ko-KR" altLang="en-US" sz="6000" b="1" dirty="0"/>
          </a:p>
        </p:txBody>
      </p:sp>
      <p:graphicFrame>
        <p:nvGraphicFramePr>
          <p:cNvPr id="49" name="차트 48"/>
          <p:cNvGraphicFramePr/>
          <p:nvPr>
            <p:extLst>
              <p:ext uri="{D42A27DB-BD31-4B8C-83A1-F6EECF244321}">
                <p14:modId xmlns:p14="http://schemas.microsoft.com/office/powerpoint/2010/main" val="1467686116"/>
              </p:ext>
            </p:extLst>
          </p:nvPr>
        </p:nvGraphicFramePr>
        <p:xfrm>
          <a:off x="576364" y="25131017"/>
          <a:ext cx="6912768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50" name="차트 49"/>
          <p:cNvGraphicFramePr/>
          <p:nvPr>
            <p:extLst>
              <p:ext uri="{D42A27DB-BD31-4B8C-83A1-F6EECF244321}">
                <p14:modId xmlns:p14="http://schemas.microsoft.com/office/powerpoint/2010/main" val="1495195912"/>
              </p:ext>
            </p:extLst>
          </p:nvPr>
        </p:nvGraphicFramePr>
        <p:xfrm>
          <a:off x="21674708" y="25131017"/>
          <a:ext cx="6912768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51" name="차트 50"/>
          <p:cNvGraphicFramePr/>
          <p:nvPr>
            <p:extLst>
              <p:ext uri="{D42A27DB-BD31-4B8C-83A1-F6EECF244321}">
                <p14:modId xmlns:p14="http://schemas.microsoft.com/office/powerpoint/2010/main" val="4068398172"/>
              </p:ext>
            </p:extLst>
          </p:nvPr>
        </p:nvGraphicFramePr>
        <p:xfrm>
          <a:off x="7561140" y="25131017"/>
          <a:ext cx="7128792" cy="63949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52" name="차트 51"/>
          <p:cNvGraphicFramePr/>
          <p:nvPr>
            <p:extLst>
              <p:ext uri="{D42A27DB-BD31-4B8C-83A1-F6EECF244321}">
                <p14:modId xmlns:p14="http://schemas.microsoft.com/office/powerpoint/2010/main" val="2271210673"/>
              </p:ext>
            </p:extLst>
          </p:nvPr>
        </p:nvGraphicFramePr>
        <p:xfrm>
          <a:off x="28731492" y="25131017"/>
          <a:ext cx="6984776" cy="63949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53" name="차트 52"/>
          <p:cNvGraphicFramePr/>
          <p:nvPr>
            <p:extLst>
              <p:ext uri="{D42A27DB-BD31-4B8C-83A1-F6EECF244321}">
                <p14:modId xmlns:p14="http://schemas.microsoft.com/office/powerpoint/2010/main" val="3901306923"/>
              </p:ext>
            </p:extLst>
          </p:nvPr>
        </p:nvGraphicFramePr>
        <p:xfrm>
          <a:off x="14761940" y="25275033"/>
          <a:ext cx="6696744" cy="6480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54" name="차트 53"/>
          <p:cNvGraphicFramePr/>
          <p:nvPr>
            <p:extLst>
              <p:ext uri="{D42A27DB-BD31-4B8C-83A1-F6EECF244321}">
                <p14:modId xmlns:p14="http://schemas.microsoft.com/office/powerpoint/2010/main" val="1284548558"/>
              </p:ext>
            </p:extLst>
          </p:nvPr>
        </p:nvGraphicFramePr>
        <p:xfrm>
          <a:off x="35572252" y="25203025"/>
          <a:ext cx="6984776" cy="6624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sp>
        <p:nvSpPr>
          <p:cNvPr id="55" name="TextBox 54"/>
          <p:cNvSpPr txBox="1"/>
          <p:nvPr/>
        </p:nvSpPr>
        <p:spPr>
          <a:xfrm>
            <a:off x="8929897" y="25203025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O</a:t>
            </a:r>
            <a:endParaRPr lang="ko-KR" altLang="en-US" sz="60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30011522" y="25170908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P</a:t>
            </a:r>
            <a:endParaRPr lang="ko-KR" altLang="en-US" sz="60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68452" y="576289"/>
            <a:ext cx="25778864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5. </a:t>
            </a:r>
            <a:r>
              <a:rPr lang="en-US" altLang="ko-KR" dirty="0"/>
              <a:t>continue</a:t>
            </a:r>
            <a:endParaRPr lang="ko-KR" altLang="en-US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7749646"/>
              </p:ext>
            </p:extLst>
          </p:nvPr>
        </p:nvGraphicFramePr>
        <p:xfrm>
          <a:off x="576366" y="2592512"/>
          <a:ext cx="42052668" cy="2241403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008778"/>
                <a:gridCol w="7008778"/>
                <a:gridCol w="7008778"/>
                <a:gridCol w="7008778"/>
                <a:gridCol w="7008778"/>
                <a:gridCol w="7008778"/>
              </a:tblGrid>
              <a:tr h="21664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Arabidopsis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RNAseq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qRT</a:t>
                      </a:r>
                      <a:r>
                        <a:rPr lang="en-US" altLang="ko-KR" dirty="0" smtClean="0"/>
                        <a:t>-PCR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Arabidopsis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RNAseq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/>
                        <a:t>qRT</a:t>
                      </a:r>
                      <a:r>
                        <a:rPr lang="en-US" altLang="ko-KR" dirty="0" smtClean="0"/>
                        <a:t>-PCR</a:t>
                      </a:r>
                      <a:endParaRPr lang="ko-KR" altLang="en-US" dirty="0"/>
                    </a:p>
                  </a:txBody>
                  <a:tcPr anchor="ctr"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6749208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23" name="차트 22"/>
          <p:cNvGraphicFramePr/>
          <p:nvPr>
            <p:extLst>
              <p:ext uri="{D42A27DB-BD31-4B8C-83A1-F6EECF244321}">
                <p14:modId xmlns:p14="http://schemas.microsoft.com/office/powerpoint/2010/main" val="3786841484"/>
              </p:ext>
            </p:extLst>
          </p:nvPr>
        </p:nvGraphicFramePr>
        <p:xfrm>
          <a:off x="504356" y="18146241"/>
          <a:ext cx="6984776" cy="6624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5" name="차트 24"/>
          <p:cNvGraphicFramePr/>
          <p:nvPr>
            <p:extLst>
              <p:ext uri="{D42A27DB-BD31-4B8C-83A1-F6EECF244321}">
                <p14:modId xmlns:p14="http://schemas.microsoft.com/office/powerpoint/2010/main" val="4217254664"/>
              </p:ext>
            </p:extLst>
          </p:nvPr>
        </p:nvGraphicFramePr>
        <p:xfrm>
          <a:off x="21602700" y="18146241"/>
          <a:ext cx="6912768" cy="6840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0" name="차트 29"/>
          <p:cNvGraphicFramePr/>
          <p:nvPr>
            <p:extLst>
              <p:ext uri="{D42A27DB-BD31-4B8C-83A1-F6EECF244321}">
                <p14:modId xmlns:p14="http://schemas.microsoft.com/office/powerpoint/2010/main" val="3168203324"/>
              </p:ext>
            </p:extLst>
          </p:nvPr>
        </p:nvGraphicFramePr>
        <p:xfrm>
          <a:off x="576364" y="4752753"/>
          <a:ext cx="6912768" cy="6768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1" name="차트 30"/>
          <p:cNvGraphicFramePr/>
          <p:nvPr>
            <p:extLst>
              <p:ext uri="{D42A27DB-BD31-4B8C-83A1-F6EECF244321}">
                <p14:modId xmlns:p14="http://schemas.microsoft.com/office/powerpoint/2010/main" val="2187988653"/>
              </p:ext>
            </p:extLst>
          </p:nvPr>
        </p:nvGraphicFramePr>
        <p:xfrm>
          <a:off x="21602700" y="4824761"/>
          <a:ext cx="6912768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2" name="차트 31"/>
          <p:cNvGraphicFramePr/>
          <p:nvPr>
            <p:extLst>
              <p:ext uri="{D42A27DB-BD31-4B8C-83A1-F6EECF244321}">
                <p14:modId xmlns:p14="http://schemas.microsoft.com/office/powerpoint/2010/main" val="727100961"/>
              </p:ext>
            </p:extLst>
          </p:nvPr>
        </p:nvGraphicFramePr>
        <p:xfrm>
          <a:off x="576364" y="11593513"/>
          <a:ext cx="6912768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3" name="차트 32"/>
          <p:cNvGraphicFramePr/>
          <p:nvPr>
            <p:extLst>
              <p:ext uri="{D42A27DB-BD31-4B8C-83A1-F6EECF244321}">
                <p14:modId xmlns:p14="http://schemas.microsoft.com/office/powerpoint/2010/main" val="169973994"/>
              </p:ext>
            </p:extLst>
          </p:nvPr>
        </p:nvGraphicFramePr>
        <p:xfrm>
          <a:off x="21530692" y="11593513"/>
          <a:ext cx="6912768" cy="655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6" name="차트 45"/>
          <p:cNvGraphicFramePr/>
          <p:nvPr>
            <p:extLst>
              <p:ext uri="{D42A27DB-BD31-4B8C-83A1-F6EECF244321}">
                <p14:modId xmlns:p14="http://schemas.microsoft.com/office/powerpoint/2010/main" val="2250879269"/>
              </p:ext>
            </p:extLst>
          </p:nvPr>
        </p:nvGraphicFramePr>
        <p:xfrm>
          <a:off x="7777164" y="4680745"/>
          <a:ext cx="6696744" cy="6624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7" name="차트 46"/>
          <p:cNvGraphicFramePr/>
          <p:nvPr>
            <p:extLst>
              <p:ext uri="{D42A27DB-BD31-4B8C-83A1-F6EECF244321}">
                <p14:modId xmlns:p14="http://schemas.microsoft.com/office/powerpoint/2010/main" val="555994180"/>
              </p:ext>
            </p:extLst>
          </p:nvPr>
        </p:nvGraphicFramePr>
        <p:xfrm>
          <a:off x="28515469" y="4824761"/>
          <a:ext cx="6984776" cy="6433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8" name="차트 47"/>
          <p:cNvGraphicFramePr/>
          <p:nvPr>
            <p:extLst>
              <p:ext uri="{D42A27DB-BD31-4B8C-83A1-F6EECF244321}">
                <p14:modId xmlns:p14="http://schemas.microsoft.com/office/powerpoint/2010/main" val="4239105125"/>
              </p:ext>
            </p:extLst>
          </p:nvPr>
        </p:nvGraphicFramePr>
        <p:xfrm>
          <a:off x="7489132" y="11593513"/>
          <a:ext cx="6984776" cy="6433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9" name="차트 48"/>
          <p:cNvGraphicFramePr/>
          <p:nvPr>
            <p:extLst>
              <p:ext uri="{D42A27DB-BD31-4B8C-83A1-F6EECF244321}">
                <p14:modId xmlns:p14="http://schemas.microsoft.com/office/powerpoint/2010/main" val="3029650754"/>
              </p:ext>
            </p:extLst>
          </p:nvPr>
        </p:nvGraphicFramePr>
        <p:xfrm>
          <a:off x="28659484" y="11665521"/>
          <a:ext cx="6840760" cy="6840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50" name="차트 49"/>
          <p:cNvGraphicFramePr/>
          <p:nvPr>
            <p:extLst>
              <p:ext uri="{D42A27DB-BD31-4B8C-83A1-F6EECF244321}">
                <p14:modId xmlns:p14="http://schemas.microsoft.com/office/powerpoint/2010/main" val="2401321677"/>
              </p:ext>
            </p:extLst>
          </p:nvPr>
        </p:nvGraphicFramePr>
        <p:xfrm>
          <a:off x="14545916" y="4752753"/>
          <a:ext cx="6912768" cy="6480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51" name="차트 50"/>
          <p:cNvGraphicFramePr/>
          <p:nvPr>
            <p:extLst>
              <p:ext uri="{D42A27DB-BD31-4B8C-83A1-F6EECF244321}">
                <p14:modId xmlns:p14="http://schemas.microsoft.com/office/powerpoint/2010/main" val="4031565864"/>
              </p:ext>
            </p:extLst>
          </p:nvPr>
        </p:nvGraphicFramePr>
        <p:xfrm>
          <a:off x="35644260" y="11737529"/>
          <a:ext cx="6912768" cy="62646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52" name="차트 51"/>
          <p:cNvGraphicFramePr/>
          <p:nvPr>
            <p:extLst>
              <p:ext uri="{D42A27DB-BD31-4B8C-83A1-F6EECF244321}">
                <p14:modId xmlns:p14="http://schemas.microsoft.com/office/powerpoint/2010/main" val="198864949"/>
              </p:ext>
            </p:extLst>
          </p:nvPr>
        </p:nvGraphicFramePr>
        <p:xfrm>
          <a:off x="14545916" y="11521505"/>
          <a:ext cx="6912768" cy="6696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53" name="차트 52"/>
          <p:cNvGraphicFramePr/>
          <p:nvPr>
            <p:extLst>
              <p:ext uri="{D42A27DB-BD31-4B8C-83A1-F6EECF244321}">
                <p14:modId xmlns:p14="http://schemas.microsoft.com/office/powerpoint/2010/main" val="831258960"/>
              </p:ext>
            </p:extLst>
          </p:nvPr>
        </p:nvGraphicFramePr>
        <p:xfrm>
          <a:off x="35644260" y="4824761"/>
          <a:ext cx="6912768" cy="6912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54" name="TextBox 53"/>
          <p:cNvSpPr txBox="1"/>
          <p:nvPr/>
        </p:nvSpPr>
        <p:spPr>
          <a:xfrm>
            <a:off x="8785276" y="4968777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Q</a:t>
            </a:r>
            <a:endParaRPr lang="ko-KR" altLang="en-US" sz="60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29739604" y="5003760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R</a:t>
            </a:r>
            <a:endParaRPr lang="ko-KR" altLang="en-US" sz="60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8713418" y="11593513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S</a:t>
            </a:r>
            <a:endParaRPr lang="ko-KR" altLang="en-US" sz="60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30006772" y="11593512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T</a:t>
            </a:r>
            <a:endParaRPr lang="ko-KR" altLang="en-US" sz="6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7705456" y="18434273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 smtClean="0"/>
              <a:t>U</a:t>
            </a:r>
            <a:endParaRPr lang="ko-KR" altLang="en-US" sz="60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8731642" y="18414894"/>
            <a:ext cx="10079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0" b="1" dirty="0"/>
              <a:t>V</a:t>
            </a:r>
            <a:endParaRPr lang="ko-KR" altLang="en-US" sz="6000" b="1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직사각형 21"/>
          <p:cNvSpPr/>
          <p:nvPr/>
        </p:nvSpPr>
        <p:spPr>
          <a:xfrm>
            <a:off x="37797644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1" name="직사각형 20"/>
          <p:cNvSpPr/>
          <p:nvPr/>
        </p:nvSpPr>
        <p:spPr>
          <a:xfrm>
            <a:off x="29019524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7" name="직사각형 16"/>
          <p:cNvSpPr/>
          <p:nvPr/>
        </p:nvSpPr>
        <p:spPr>
          <a:xfrm>
            <a:off x="20188828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6. </a:t>
            </a:r>
            <a:endParaRPr lang="ko-KR" altLang="en-US" dirty="0"/>
          </a:p>
        </p:txBody>
      </p:sp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5" name="차트 4"/>
          <p:cNvGraphicFramePr/>
          <p:nvPr/>
        </p:nvGraphicFramePr>
        <p:xfrm>
          <a:off x="1872508" y="2592513"/>
          <a:ext cx="12385376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차트 5"/>
          <p:cNvGraphicFramePr/>
          <p:nvPr/>
        </p:nvGraphicFramePr>
        <p:xfrm>
          <a:off x="14401900" y="2664521"/>
          <a:ext cx="26642960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차트 6"/>
          <p:cNvGraphicFramePr/>
          <p:nvPr/>
        </p:nvGraphicFramePr>
        <p:xfrm>
          <a:off x="2232548" y="8137129"/>
          <a:ext cx="11953328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차트 7"/>
          <p:cNvGraphicFramePr/>
          <p:nvPr/>
        </p:nvGraphicFramePr>
        <p:xfrm>
          <a:off x="14401900" y="8137129"/>
          <a:ext cx="26570952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차트 8"/>
          <p:cNvGraphicFramePr/>
          <p:nvPr/>
        </p:nvGraphicFramePr>
        <p:xfrm>
          <a:off x="1728492" y="13681745"/>
          <a:ext cx="12457384" cy="5616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차트 9"/>
          <p:cNvGraphicFramePr/>
          <p:nvPr/>
        </p:nvGraphicFramePr>
        <p:xfrm>
          <a:off x="14329892" y="13681745"/>
          <a:ext cx="26642960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차트 10"/>
          <p:cNvGraphicFramePr/>
          <p:nvPr/>
        </p:nvGraphicFramePr>
        <p:xfrm>
          <a:off x="14761940" y="19442385"/>
          <a:ext cx="26138904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차트 11"/>
          <p:cNvGraphicFramePr/>
          <p:nvPr/>
        </p:nvGraphicFramePr>
        <p:xfrm>
          <a:off x="2304556" y="19370377"/>
          <a:ext cx="11953328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3" name="차트 12"/>
          <p:cNvGraphicFramePr/>
          <p:nvPr/>
        </p:nvGraphicFramePr>
        <p:xfrm>
          <a:off x="2088532" y="24914993"/>
          <a:ext cx="12169352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4" name="차트 13"/>
          <p:cNvGraphicFramePr/>
          <p:nvPr/>
        </p:nvGraphicFramePr>
        <p:xfrm>
          <a:off x="14257884" y="24914993"/>
          <a:ext cx="26786976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5" name="직사각형 14"/>
          <p:cNvSpPr/>
          <p:nvPr/>
        </p:nvSpPr>
        <p:spPr>
          <a:xfrm>
            <a:off x="9649372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직사각형 23"/>
          <p:cNvSpPr/>
          <p:nvPr/>
        </p:nvSpPr>
        <p:spPr>
          <a:xfrm>
            <a:off x="3453002" y="2664521"/>
            <a:ext cx="6556410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20013 (BrPHYA1)</a:t>
            </a:r>
            <a:endParaRPr lang="ko-KR" altLang="en-US" sz="4800" b="1" dirty="0"/>
          </a:p>
        </p:txBody>
      </p:sp>
      <p:sp>
        <p:nvSpPr>
          <p:cNvPr id="25" name="직사각형 24"/>
          <p:cNvSpPr/>
          <p:nvPr/>
        </p:nvSpPr>
        <p:spPr>
          <a:xfrm>
            <a:off x="3600700" y="8273594"/>
            <a:ext cx="6556410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1672 (BrPHYA2)</a:t>
            </a:r>
            <a:endParaRPr lang="ko-KR" altLang="en-US" sz="4800" b="1" dirty="0"/>
          </a:p>
        </p:txBody>
      </p:sp>
      <p:sp>
        <p:nvSpPr>
          <p:cNvPr id="26" name="직사각형 25"/>
          <p:cNvSpPr/>
          <p:nvPr/>
        </p:nvSpPr>
        <p:spPr>
          <a:xfrm>
            <a:off x="3600700" y="13825761"/>
            <a:ext cx="656622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1650 (BrPHYB1)</a:t>
            </a:r>
            <a:endParaRPr lang="ko-KR" altLang="en-US" sz="4800" b="1" dirty="0"/>
          </a:p>
        </p:txBody>
      </p:sp>
      <p:sp>
        <p:nvSpPr>
          <p:cNvPr id="27" name="직사각형 26"/>
          <p:cNvSpPr/>
          <p:nvPr/>
        </p:nvSpPr>
        <p:spPr>
          <a:xfrm>
            <a:off x="3528692" y="19802425"/>
            <a:ext cx="6349815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22192(BrPHYB2)</a:t>
            </a:r>
            <a:endParaRPr lang="ko-KR" altLang="en-US" sz="4800" b="1" dirty="0"/>
          </a:p>
        </p:txBody>
      </p:sp>
      <p:sp>
        <p:nvSpPr>
          <p:cNvPr id="28" name="직사각형 27"/>
          <p:cNvSpPr/>
          <p:nvPr/>
        </p:nvSpPr>
        <p:spPr>
          <a:xfrm>
            <a:off x="3456684" y="25275033"/>
            <a:ext cx="6108275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7880 (BrCRY1)</a:t>
            </a:r>
            <a:endParaRPr lang="ko-KR" altLang="en-US" sz="48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직사각형 11"/>
          <p:cNvSpPr/>
          <p:nvPr/>
        </p:nvSpPr>
        <p:spPr>
          <a:xfrm>
            <a:off x="37836508" y="2520505"/>
            <a:ext cx="3024336" cy="27886528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3" name="직사각형 12"/>
          <p:cNvSpPr/>
          <p:nvPr/>
        </p:nvSpPr>
        <p:spPr>
          <a:xfrm>
            <a:off x="29012668" y="2592513"/>
            <a:ext cx="4392488" cy="2785452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4" name="직사각형 13"/>
          <p:cNvSpPr/>
          <p:nvPr/>
        </p:nvSpPr>
        <p:spPr>
          <a:xfrm>
            <a:off x="20227692" y="2546793"/>
            <a:ext cx="4392488" cy="27867096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56484" y="2520505"/>
          <a:ext cx="39388376" cy="27939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01400"/>
                <a:gridCol w="26786976"/>
              </a:tblGrid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4800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5587821"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3" name="차트 2"/>
          <p:cNvGraphicFramePr/>
          <p:nvPr/>
        </p:nvGraphicFramePr>
        <p:xfrm>
          <a:off x="1728492" y="2592513"/>
          <a:ext cx="12457384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차트 3"/>
          <p:cNvGraphicFramePr/>
          <p:nvPr/>
        </p:nvGraphicFramePr>
        <p:xfrm>
          <a:off x="14545916" y="2736529"/>
          <a:ext cx="26498944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차트 4"/>
          <p:cNvGraphicFramePr/>
          <p:nvPr/>
        </p:nvGraphicFramePr>
        <p:xfrm>
          <a:off x="14401900" y="8209137"/>
          <a:ext cx="26498944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차트 5"/>
          <p:cNvGraphicFramePr/>
          <p:nvPr/>
        </p:nvGraphicFramePr>
        <p:xfrm>
          <a:off x="1800500" y="8209137"/>
          <a:ext cx="12385376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차트 6"/>
          <p:cNvGraphicFramePr/>
          <p:nvPr/>
        </p:nvGraphicFramePr>
        <p:xfrm>
          <a:off x="14329892" y="19226361"/>
          <a:ext cx="26570952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차트 7"/>
          <p:cNvGraphicFramePr/>
          <p:nvPr/>
        </p:nvGraphicFramePr>
        <p:xfrm>
          <a:off x="1800500" y="19370377"/>
          <a:ext cx="12385376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차트 9"/>
          <p:cNvGraphicFramePr/>
          <p:nvPr/>
        </p:nvGraphicFramePr>
        <p:xfrm>
          <a:off x="14257884" y="24914993"/>
          <a:ext cx="26858984" cy="547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차트 10"/>
          <p:cNvGraphicFramePr/>
          <p:nvPr/>
        </p:nvGraphicFramePr>
        <p:xfrm>
          <a:off x="1656484" y="24914993"/>
          <a:ext cx="12601400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5" name="직사각형 14"/>
          <p:cNvSpPr/>
          <p:nvPr/>
        </p:nvSpPr>
        <p:spPr>
          <a:xfrm>
            <a:off x="9551076" y="2611945"/>
            <a:ext cx="4320480" cy="27795088"/>
          </a:xfrm>
          <a:prstGeom prst="rect">
            <a:avLst/>
          </a:prstGeom>
          <a:solidFill>
            <a:schemeClr val="bg1">
              <a:lumMod val="50000"/>
              <a:alpha val="6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7" name="직사각형 16"/>
          <p:cNvSpPr/>
          <p:nvPr/>
        </p:nvSpPr>
        <p:spPr>
          <a:xfrm>
            <a:off x="3312668" y="2808537"/>
            <a:ext cx="6443302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15313 (BrCRY2a)</a:t>
            </a:r>
            <a:endParaRPr lang="ko-KR" altLang="en-US" sz="4800" b="1" dirty="0"/>
          </a:p>
        </p:txBody>
      </p:sp>
      <p:sp>
        <p:nvSpPr>
          <p:cNvPr id="18" name="직사각형 17"/>
          <p:cNvSpPr/>
          <p:nvPr/>
        </p:nvSpPr>
        <p:spPr>
          <a:xfrm>
            <a:off x="3096644" y="8281145"/>
            <a:ext cx="6494598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30568 (BrCRY2b)</a:t>
            </a:r>
            <a:endParaRPr lang="ko-KR" altLang="en-US" sz="4800" b="1" dirty="0"/>
          </a:p>
        </p:txBody>
      </p:sp>
      <p:sp>
        <p:nvSpPr>
          <p:cNvPr id="21" name="직사각형 20"/>
          <p:cNvSpPr/>
          <p:nvPr/>
        </p:nvSpPr>
        <p:spPr>
          <a:xfrm>
            <a:off x="3600700" y="19370377"/>
            <a:ext cx="676875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4800" b="1" dirty="0" smtClean="0"/>
              <a:t>Bra021818 (BrCOP1b)</a:t>
            </a:r>
            <a:endParaRPr lang="ko-KR" altLang="en-US" sz="4800" dirty="0"/>
          </a:p>
        </p:txBody>
      </p:sp>
      <p:sp>
        <p:nvSpPr>
          <p:cNvPr id="22" name="직사각형 21"/>
          <p:cNvSpPr/>
          <p:nvPr/>
        </p:nvSpPr>
        <p:spPr>
          <a:xfrm>
            <a:off x="3054171" y="13681745"/>
            <a:ext cx="6739217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05541 (BrCOP1a) </a:t>
            </a:r>
            <a:endParaRPr lang="ko-KR" altLang="en-US" sz="4800" b="1" dirty="0" smtClean="0"/>
          </a:p>
        </p:txBody>
      </p:sp>
      <p:sp>
        <p:nvSpPr>
          <p:cNvPr id="23" name="직사각형 22"/>
          <p:cNvSpPr/>
          <p:nvPr/>
        </p:nvSpPr>
        <p:spPr>
          <a:xfrm>
            <a:off x="3528692" y="25131017"/>
            <a:ext cx="6173485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4800" b="1" dirty="0" smtClean="0"/>
              <a:t>Bra020017 (BrPIF3a)</a:t>
            </a:r>
            <a:endParaRPr lang="ko-KR" altLang="en-US" sz="4800" b="1" dirty="0"/>
          </a:p>
        </p:txBody>
      </p:sp>
      <p:graphicFrame>
        <p:nvGraphicFramePr>
          <p:cNvPr id="20" name="차트 19"/>
          <p:cNvGraphicFramePr/>
          <p:nvPr/>
        </p:nvGraphicFramePr>
        <p:xfrm>
          <a:off x="1728492" y="13753753"/>
          <a:ext cx="12241360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4" name="차트 23"/>
          <p:cNvGraphicFramePr/>
          <p:nvPr/>
        </p:nvGraphicFramePr>
        <p:xfrm>
          <a:off x="14329892" y="13681745"/>
          <a:ext cx="26714968" cy="5544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1368452" y="576289"/>
            <a:ext cx="18820376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 </a:t>
            </a:r>
            <a:r>
              <a:rPr lang="en-US" altLang="ko-KR" dirty="0" smtClean="0"/>
              <a:t>figure 6. continue</a:t>
            </a:r>
            <a:endParaRPr lang="ko-KR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33</TotalTime>
  <Words>642</Words>
  <Application>Microsoft Office PowerPoint</Application>
  <PresentationFormat>사용자 지정</PresentationFormat>
  <Paragraphs>354</Paragraphs>
  <Slides>16</Slides>
  <Notes>2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6</vt:i4>
      </vt:variant>
    </vt:vector>
  </HeadingPairs>
  <TitlesOfParts>
    <vt:vector size="17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Windows 사용자</cp:lastModifiedBy>
  <cp:revision>726</cp:revision>
  <dcterms:created xsi:type="dcterms:W3CDTF">2013-10-09T05:29:33Z</dcterms:created>
  <dcterms:modified xsi:type="dcterms:W3CDTF">2019-01-18T08:10:32Z</dcterms:modified>
</cp:coreProperties>
</file>